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ppt/charts/chart7.xml" ContentType="application/vnd.openxmlformats-officedocument.drawingml.chart+xml"/>
  <Override PartName="/ppt/charts/style6.xml" ContentType="application/vnd.ms-office.chartstyle+xml"/>
  <Override PartName="/ppt/charts/colors6.xml" ContentType="application/vnd.ms-office.chartcolorstyle+xml"/>
  <Override PartName="/ppt/charts/chart8.xml" ContentType="application/vnd.openxmlformats-officedocument.drawingml.chart+xml"/>
  <Override PartName="/ppt/charts/style7.xml" ContentType="application/vnd.ms-office.chartstyle+xml"/>
  <Override PartName="/ppt/charts/colors7.xml" ContentType="application/vnd.ms-office.chartcolorstyle+xml"/>
  <Override PartName="/ppt/charts/chart9.xml" ContentType="application/vnd.openxmlformats-officedocument.drawingml.chart+xml"/>
  <Override PartName="/ppt/charts/style8.xml" ContentType="application/vnd.ms-office.chartstyle+xml"/>
  <Override PartName="/ppt/charts/colors8.xml" ContentType="application/vnd.ms-office.chartcolorstyle+xml"/>
  <Override PartName="/ppt/charts/chart10.xml" ContentType="application/vnd.openxmlformats-officedocument.drawingml.chart+xml"/>
  <Override PartName="/ppt/charts/style9.xml" ContentType="application/vnd.ms-office.chartstyle+xml"/>
  <Override PartName="/ppt/charts/colors9.xml" ContentType="application/vnd.ms-office.chartcolorstyle+xml"/>
  <Override PartName="/ppt/charts/chart11.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2.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3.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4.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5.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6.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7.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8.xml" ContentType="application/vnd.openxmlformats-officedocument.drawingml.chart+xml"/>
  <Override PartName="/ppt/charts/style17.xml" ContentType="application/vnd.ms-office.chartstyle+xml"/>
  <Override PartName="/ppt/charts/colors1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604" r:id="rId2"/>
    <p:sldId id="605" r:id="rId3"/>
    <p:sldId id="566" r:id="rId4"/>
    <p:sldId id="603" r:id="rId5"/>
    <p:sldId id="445" r:id="rId6"/>
    <p:sldId id="258"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CC"/>
    <a:srgbClr val="ED8137"/>
    <a:srgbClr val="EF8D4B"/>
    <a:srgbClr val="A43700"/>
    <a:srgbClr val="8037B7"/>
    <a:srgbClr val="B83D00"/>
    <a:srgbClr val="EE853E"/>
    <a:srgbClr val="C15811"/>
    <a:srgbClr val="FF99CC"/>
    <a:srgbClr val="FFCC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716" autoAdjust="0"/>
    <p:restoredTop sz="94660"/>
  </p:normalViewPr>
  <p:slideViewPr>
    <p:cSldViewPr snapToGrid="0">
      <p:cViewPr varScale="1">
        <p:scale>
          <a:sx n="81" d="100"/>
          <a:sy n="81" d="100"/>
        </p:scale>
        <p:origin x="2316" y="102"/>
      </p:cViewPr>
      <p:guideLst>
        <p:guide orient="horz" pos="2880"/>
        <p:guide pos="2160"/>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10.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9.xml"/><Relationship Id="rId1" Type="http://schemas.microsoft.com/office/2011/relationships/chartStyle" Target="style9.xml"/></Relationships>
</file>

<file path=ppt/charts/_rels/chart11.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0.xml"/><Relationship Id="rId1" Type="http://schemas.microsoft.com/office/2011/relationships/chartStyle" Target="style10.xml"/></Relationships>
</file>

<file path=ppt/charts/_rels/chart12.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1.xml"/><Relationship Id="rId1" Type="http://schemas.microsoft.com/office/2011/relationships/chartStyle" Target="style11.xml"/></Relationships>
</file>

<file path=ppt/charts/_rels/chart13.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2.xml"/><Relationship Id="rId1" Type="http://schemas.microsoft.com/office/2011/relationships/chartStyle" Target="style12.xml"/></Relationships>
</file>

<file path=ppt/charts/_rels/chart14.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3.xml"/><Relationship Id="rId1" Type="http://schemas.microsoft.com/office/2011/relationships/chartStyle" Target="style13.xml"/></Relationships>
</file>

<file path=ppt/charts/_rels/chart15.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4.xml"/><Relationship Id="rId1" Type="http://schemas.microsoft.com/office/2011/relationships/chartStyle" Target="style14.xml"/></Relationships>
</file>

<file path=ppt/charts/_rels/chart16.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5.xml"/><Relationship Id="rId1" Type="http://schemas.microsoft.com/office/2011/relationships/chartStyle" Target="style15.xml"/></Relationships>
</file>

<file path=ppt/charts/_rels/chart17.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6.xml"/><Relationship Id="rId1" Type="http://schemas.microsoft.com/office/2011/relationships/chartStyle" Target="style16.xml"/></Relationships>
</file>

<file path=ppt/charts/_rels/chart18.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17.xml"/><Relationship Id="rId1" Type="http://schemas.microsoft.com/office/2011/relationships/chartStyle" Target="style17.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5.xml"/><Relationship Id="rId1" Type="http://schemas.microsoft.com/office/2011/relationships/chartStyle" Target="style5.xml"/></Relationships>
</file>

<file path=ppt/charts/_rels/chart7.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6.xml"/><Relationship Id="rId1" Type="http://schemas.microsoft.com/office/2011/relationships/chartStyle" Target="style6.xml"/></Relationships>
</file>

<file path=ppt/charts/_rels/chart8.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7.xml"/><Relationship Id="rId1" Type="http://schemas.microsoft.com/office/2011/relationships/chartStyle" Target="style7.xml"/></Relationships>
</file>

<file path=ppt/charts/_rels/chart9.xml.rels><?xml version="1.0" encoding="UTF-8" standalone="yes"?>
<Relationships xmlns="http://schemas.openxmlformats.org/package/2006/relationships"><Relationship Id="rId3" Type="http://schemas.openxmlformats.org/officeDocument/2006/relationships/oleObject" Target="file:///\\fsmresfiles.fsm.northwestern.edu\fsmresfiles\Basic_Sciences\BMG\LiLab\Zhiqiang\RNAseq\2nd%20RNA%20sequencing%20results\190910_analysis%20to%20correct%20earlier%20mistakes_FC2%20adjP0.001\for%20making%20plots%20of%20DEs.xlsb.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122021299029945"/>
          <c:y val="2.7739998409289746E-2"/>
          <c:w val="0.9302055993000875"/>
          <c:h val="0.88034955857790509"/>
        </c:manualLayout>
      </c:layout>
      <c:barChart>
        <c:barDir val="col"/>
        <c:grouping val="clustered"/>
        <c:varyColors val="0"/>
        <c:ser>
          <c:idx val="0"/>
          <c:order val="0"/>
          <c:tx>
            <c:strRef>
              <c:f>'result 2'!$J$1</c:f>
              <c:strCache>
                <c:ptCount val="1"/>
                <c:pt idx="0">
                  <c:v>deletion</c:v>
                </c:pt>
              </c:strCache>
            </c:strRef>
          </c:tx>
          <c:spPr>
            <a:solidFill>
              <a:schemeClr val="accent1"/>
            </a:solidFill>
            <a:ln>
              <a:noFill/>
            </a:ln>
            <a:effectLst/>
          </c:spPr>
          <c:invertIfNegative val="0"/>
          <c:cat>
            <c:strRef>
              <c:f>'result 2'!$I$2:$I$18</c:f>
              <c:strCache>
                <c:ptCount val="17"/>
                <c:pt idx="0">
                  <c:v>chrI</c:v>
                </c:pt>
                <c:pt idx="1">
                  <c:v>chrII</c:v>
                </c:pt>
                <c:pt idx="2">
                  <c:v>chrIII</c:v>
                </c:pt>
                <c:pt idx="3">
                  <c:v>chrIV</c:v>
                </c:pt>
                <c:pt idx="4">
                  <c:v>chrV</c:v>
                </c:pt>
                <c:pt idx="5">
                  <c:v>chrVI</c:v>
                </c:pt>
                <c:pt idx="6">
                  <c:v>chrVII</c:v>
                </c:pt>
                <c:pt idx="7">
                  <c:v>chrVIII</c:v>
                </c:pt>
                <c:pt idx="8">
                  <c:v>chrIX</c:v>
                </c:pt>
                <c:pt idx="9">
                  <c:v>chrX</c:v>
                </c:pt>
                <c:pt idx="10">
                  <c:v>chrXI</c:v>
                </c:pt>
                <c:pt idx="11">
                  <c:v>chrXII</c:v>
                </c:pt>
                <c:pt idx="12">
                  <c:v>chrXIII</c:v>
                </c:pt>
                <c:pt idx="13">
                  <c:v>chrXIV</c:v>
                </c:pt>
                <c:pt idx="14">
                  <c:v>chrXV</c:v>
                </c:pt>
                <c:pt idx="15">
                  <c:v>chrXVI</c:v>
                </c:pt>
                <c:pt idx="16">
                  <c:v>chrmt</c:v>
                </c:pt>
              </c:strCache>
            </c:strRef>
          </c:cat>
          <c:val>
            <c:numRef>
              <c:f>'result 2'!$J$2:$J$18</c:f>
              <c:numCache>
                <c:formatCode>General</c:formatCode>
                <c:ptCount val="17"/>
                <c:pt idx="0">
                  <c:v>20781.773474105277</c:v>
                </c:pt>
                <c:pt idx="1">
                  <c:v>70759.156602526127</c:v>
                </c:pt>
                <c:pt idx="2">
                  <c:v>38918.146355715835</c:v>
                </c:pt>
                <c:pt idx="3">
                  <c:v>122965.31538155716</c:v>
                </c:pt>
                <c:pt idx="4">
                  <c:v>43984.851332318678</c:v>
                </c:pt>
                <c:pt idx="5">
                  <c:v>27505.355771863968</c:v>
                </c:pt>
                <c:pt idx="6">
                  <c:v>108248.77609409942</c:v>
                </c:pt>
                <c:pt idx="7">
                  <c:v>39424.665979469428</c:v>
                </c:pt>
                <c:pt idx="8">
                  <c:v>27260.835392487174</c:v>
                </c:pt>
                <c:pt idx="9">
                  <c:v>56693.824516023422</c:v>
                </c:pt>
                <c:pt idx="10">
                  <c:v>73604.339446244485</c:v>
                </c:pt>
                <c:pt idx="11">
                  <c:v>90718.81428562013</c:v>
                </c:pt>
                <c:pt idx="12">
                  <c:v>73205.042365025118</c:v>
                </c:pt>
                <c:pt idx="13">
                  <c:v>50878.812510488031</c:v>
                </c:pt>
                <c:pt idx="14">
                  <c:v>88354.360417110351</c:v>
                </c:pt>
                <c:pt idx="15">
                  <c:v>66433.263272367694</c:v>
                </c:pt>
                <c:pt idx="16">
                  <c:v>28.308190679103486</c:v>
                </c:pt>
              </c:numCache>
            </c:numRef>
          </c:val>
          <c:extLst>
            <c:ext xmlns:c16="http://schemas.microsoft.com/office/drawing/2014/chart" uri="{C3380CC4-5D6E-409C-BE32-E72D297353CC}">
              <c16:uniqueId val="{00000000-CC48-4570-8EAD-1C4D9A361D44}"/>
            </c:ext>
          </c:extLst>
        </c:ser>
        <c:ser>
          <c:idx val="1"/>
          <c:order val="1"/>
          <c:tx>
            <c:strRef>
              <c:f>'result 2'!$K$1</c:f>
              <c:strCache>
                <c:ptCount val="1"/>
                <c:pt idx="0">
                  <c:v>prion</c:v>
                </c:pt>
              </c:strCache>
            </c:strRef>
          </c:tx>
          <c:spPr>
            <a:solidFill>
              <a:schemeClr val="accent2"/>
            </a:solidFill>
            <a:ln>
              <a:noFill/>
            </a:ln>
            <a:effectLst/>
          </c:spPr>
          <c:invertIfNegative val="0"/>
          <c:cat>
            <c:strRef>
              <c:f>'result 2'!$I$2:$I$18</c:f>
              <c:strCache>
                <c:ptCount val="17"/>
                <c:pt idx="0">
                  <c:v>chrI</c:v>
                </c:pt>
                <c:pt idx="1">
                  <c:v>chrII</c:v>
                </c:pt>
                <c:pt idx="2">
                  <c:v>chrIII</c:v>
                </c:pt>
                <c:pt idx="3">
                  <c:v>chrIV</c:v>
                </c:pt>
                <c:pt idx="4">
                  <c:v>chrV</c:v>
                </c:pt>
                <c:pt idx="5">
                  <c:v>chrVI</c:v>
                </c:pt>
                <c:pt idx="6">
                  <c:v>chrVII</c:v>
                </c:pt>
                <c:pt idx="7">
                  <c:v>chrVIII</c:v>
                </c:pt>
                <c:pt idx="8">
                  <c:v>chrIX</c:v>
                </c:pt>
                <c:pt idx="9">
                  <c:v>chrX</c:v>
                </c:pt>
                <c:pt idx="10">
                  <c:v>chrXI</c:v>
                </c:pt>
                <c:pt idx="11">
                  <c:v>chrXII</c:v>
                </c:pt>
                <c:pt idx="12">
                  <c:v>chrXIII</c:v>
                </c:pt>
                <c:pt idx="13">
                  <c:v>chrXIV</c:v>
                </c:pt>
                <c:pt idx="14">
                  <c:v>chrXV</c:v>
                </c:pt>
                <c:pt idx="15">
                  <c:v>chrXVI</c:v>
                </c:pt>
                <c:pt idx="16">
                  <c:v>chrmt</c:v>
                </c:pt>
              </c:strCache>
            </c:strRef>
          </c:cat>
          <c:val>
            <c:numRef>
              <c:f>'result 2'!$K$2:$K$18</c:f>
              <c:numCache>
                <c:formatCode>General</c:formatCode>
                <c:ptCount val="17"/>
                <c:pt idx="0">
                  <c:v>20533.852207295349</c:v>
                </c:pt>
                <c:pt idx="1">
                  <c:v>65085.500679885197</c:v>
                </c:pt>
                <c:pt idx="2">
                  <c:v>34035.146205904079</c:v>
                </c:pt>
                <c:pt idx="3">
                  <c:v>121479.03190336295</c:v>
                </c:pt>
                <c:pt idx="4">
                  <c:v>42404.908294966532</c:v>
                </c:pt>
                <c:pt idx="5">
                  <c:v>17495.800477029254</c:v>
                </c:pt>
                <c:pt idx="6">
                  <c:v>117425.63556153055</c:v>
                </c:pt>
                <c:pt idx="7">
                  <c:v>51292.417608991978</c:v>
                </c:pt>
                <c:pt idx="8">
                  <c:v>23637.119822081819</c:v>
                </c:pt>
                <c:pt idx="9">
                  <c:v>55806.967948181598</c:v>
                </c:pt>
                <c:pt idx="10">
                  <c:v>77671.340201230196</c:v>
                </c:pt>
                <c:pt idx="11">
                  <c:v>103918.99939355401</c:v>
                </c:pt>
                <c:pt idx="12">
                  <c:v>65897.007213420031</c:v>
                </c:pt>
                <c:pt idx="13">
                  <c:v>45799.185072342909</c:v>
                </c:pt>
                <c:pt idx="14">
                  <c:v>91790.595593544</c:v>
                </c:pt>
                <c:pt idx="15">
                  <c:v>65476.051286678165</c:v>
                </c:pt>
                <c:pt idx="16">
                  <c:v>34.409191688019973</c:v>
                </c:pt>
              </c:numCache>
            </c:numRef>
          </c:val>
          <c:extLst>
            <c:ext xmlns:c16="http://schemas.microsoft.com/office/drawing/2014/chart" uri="{C3380CC4-5D6E-409C-BE32-E72D297353CC}">
              <c16:uniqueId val="{00000001-CC48-4570-8EAD-1C4D9A361D44}"/>
            </c:ext>
          </c:extLst>
        </c:ser>
        <c:ser>
          <c:idx val="2"/>
          <c:order val="2"/>
          <c:tx>
            <c:strRef>
              <c:f>'result 2'!$L$1</c:f>
              <c:strCache>
                <c:ptCount val="1"/>
                <c:pt idx="0">
                  <c:v> wt</c:v>
                </c:pt>
              </c:strCache>
            </c:strRef>
          </c:tx>
          <c:spPr>
            <a:solidFill>
              <a:schemeClr val="accent3"/>
            </a:solidFill>
            <a:ln>
              <a:noFill/>
            </a:ln>
            <a:effectLst/>
          </c:spPr>
          <c:invertIfNegative val="0"/>
          <c:cat>
            <c:strRef>
              <c:f>'result 2'!$I$2:$I$18</c:f>
              <c:strCache>
                <c:ptCount val="17"/>
                <c:pt idx="0">
                  <c:v>chrI</c:v>
                </c:pt>
                <c:pt idx="1">
                  <c:v>chrII</c:v>
                </c:pt>
                <c:pt idx="2">
                  <c:v>chrIII</c:v>
                </c:pt>
                <c:pt idx="3">
                  <c:v>chrIV</c:v>
                </c:pt>
                <c:pt idx="4">
                  <c:v>chrV</c:v>
                </c:pt>
                <c:pt idx="5">
                  <c:v>chrVI</c:v>
                </c:pt>
                <c:pt idx="6">
                  <c:v>chrVII</c:v>
                </c:pt>
                <c:pt idx="7">
                  <c:v>chrVIII</c:v>
                </c:pt>
                <c:pt idx="8">
                  <c:v>chrIX</c:v>
                </c:pt>
                <c:pt idx="9">
                  <c:v>chrX</c:v>
                </c:pt>
                <c:pt idx="10">
                  <c:v>chrXI</c:v>
                </c:pt>
                <c:pt idx="11">
                  <c:v>chrXII</c:v>
                </c:pt>
                <c:pt idx="12">
                  <c:v>chrXIII</c:v>
                </c:pt>
                <c:pt idx="13">
                  <c:v>chrXIV</c:v>
                </c:pt>
                <c:pt idx="14">
                  <c:v>chrXV</c:v>
                </c:pt>
                <c:pt idx="15">
                  <c:v>chrXVI</c:v>
                </c:pt>
                <c:pt idx="16">
                  <c:v>chrmt</c:v>
                </c:pt>
              </c:strCache>
            </c:strRef>
          </c:cat>
          <c:val>
            <c:numRef>
              <c:f>'result 2'!$L$2:$L$18</c:f>
              <c:numCache>
                <c:formatCode>General</c:formatCode>
                <c:ptCount val="17"/>
                <c:pt idx="0">
                  <c:v>20264.501653970576</c:v>
                </c:pt>
                <c:pt idx="1">
                  <c:v>66002.730865757301</c:v>
                </c:pt>
                <c:pt idx="2">
                  <c:v>28689.325197766553</c:v>
                </c:pt>
                <c:pt idx="3">
                  <c:v>122510.03336066642</c:v>
                </c:pt>
                <c:pt idx="4">
                  <c:v>45977.731094969495</c:v>
                </c:pt>
                <c:pt idx="5">
                  <c:v>31062.195941173115</c:v>
                </c:pt>
                <c:pt idx="6">
                  <c:v>104619.18308539229</c:v>
                </c:pt>
                <c:pt idx="7">
                  <c:v>43627.530040343641</c:v>
                </c:pt>
                <c:pt idx="8">
                  <c:v>27044.560064309582</c:v>
                </c:pt>
                <c:pt idx="9">
                  <c:v>54517.446382225258</c:v>
                </c:pt>
                <c:pt idx="10">
                  <c:v>69060.953054537516</c:v>
                </c:pt>
                <c:pt idx="11">
                  <c:v>100688.62871440036</c:v>
                </c:pt>
                <c:pt idx="12">
                  <c:v>77294.655039959602</c:v>
                </c:pt>
                <c:pt idx="13">
                  <c:v>53632.846508014853</c:v>
                </c:pt>
                <c:pt idx="14">
                  <c:v>84278.389062309128</c:v>
                </c:pt>
                <c:pt idx="15">
                  <c:v>70507.744613613773</c:v>
                </c:pt>
                <c:pt idx="16">
                  <c:v>31.883087739005802</c:v>
                </c:pt>
              </c:numCache>
            </c:numRef>
          </c:val>
          <c:extLst>
            <c:ext xmlns:c16="http://schemas.microsoft.com/office/drawing/2014/chart" uri="{C3380CC4-5D6E-409C-BE32-E72D297353CC}">
              <c16:uniqueId val="{00000002-CC48-4570-8EAD-1C4D9A361D44}"/>
            </c:ext>
          </c:extLst>
        </c:ser>
        <c:dLbls>
          <c:showLegendKey val="0"/>
          <c:showVal val="0"/>
          <c:showCatName val="0"/>
          <c:showSerName val="0"/>
          <c:showPercent val="0"/>
          <c:showBubbleSize val="0"/>
        </c:dLbls>
        <c:gapWidth val="219"/>
        <c:overlap val="-27"/>
        <c:axId val="183617408"/>
        <c:axId val="183618944"/>
      </c:barChart>
      <c:catAx>
        <c:axId val="183617408"/>
        <c:scaling>
          <c:orientation val="minMax"/>
        </c:scaling>
        <c:delete val="0"/>
        <c:axPos val="b"/>
        <c:numFmt formatCode="General" sourceLinked="1"/>
        <c:majorTickMark val="none"/>
        <c:minorTickMark val="none"/>
        <c:tickLblPos val="nextTo"/>
        <c:spPr>
          <a:noFill/>
          <a:ln w="15875" cap="flat" cmpd="sng" algn="ctr">
            <a:solidFill>
              <a:schemeClr val="tx1"/>
            </a:solidFill>
            <a:round/>
          </a:ln>
          <a:effectLst/>
        </c:spPr>
        <c:txPr>
          <a:bodyPr rot="-60000000" vert="horz"/>
          <a:lstStyle/>
          <a:p>
            <a:pPr>
              <a:defRPr/>
            </a:pPr>
            <a:endParaRPr lang="en-US"/>
          </a:p>
        </c:txPr>
        <c:crossAx val="183618944"/>
        <c:crosses val="autoZero"/>
        <c:auto val="1"/>
        <c:lblAlgn val="ctr"/>
        <c:lblOffset val="100"/>
        <c:noMultiLvlLbl val="0"/>
      </c:catAx>
      <c:valAx>
        <c:axId val="183618944"/>
        <c:scaling>
          <c:orientation val="minMax"/>
          <c:max val="150000"/>
          <c:min val="0"/>
        </c:scaling>
        <c:delete val="0"/>
        <c:axPos val="l"/>
        <c:numFmt formatCode="General" sourceLinked="1"/>
        <c:majorTickMark val="none"/>
        <c:minorTickMark val="none"/>
        <c:tickLblPos val="nextTo"/>
        <c:spPr>
          <a:noFill/>
          <a:ln w="15875">
            <a:solidFill>
              <a:schemeClr val="tx1"/>
            </a:solidFill>
          </a:ln>
          <a:effectLst/>
        </c:spPr>
        <c:txPr>
          <a:bodyPr rot="-60000000" vert="horz"/>
          <a:lstStyle/>
          <a:p>
            <a:pPr>
              <a:defRPr/>
            </a:pPr>
            <a:endParaRPr lang="en-US"/>
          </a:p>
        </c:txPr>
        <c:crossAx val="183617408"/>
        <c:crosses val="autoZero"/>
        <c:crossBetween val="between"/>
        <c:majorUnit val="50000"/>
        <c:minorUnit val="10000"/>
      </c:valAx>
      <c:spPr>
        <a:noFill/>
        <a:ln>
          <a:noFill/>
        </a:ln>
        <a:effectLst/>
      </c:spPr>
    </c:plotArea>
    <c:legend>
      <c:legendPos val="b"/>
      <c:layout>
        <c:manualLayout>
          <c:xMode val="edge"/>
          <c:yMode val="edge"/>
          <c:x val="0.50469326506055179"/>
          <c:y val="3.7427196600424942E-2"/>
          <c:w val="0.47865263681335313"/>
          <c:h val="8.5227869243617277E-2"/>
        </c:manualLayout>
      </c:layout>
      <c:overlay val="0"/>
      <c:spPr>
        <a:noFill/>
        <a:ln>
          <a:noFill/>
        </a:ln>
        <a:effectLst/>
      </c:spPr>
      <c:txPr>
        <a:bodyPr rot="0" vert="horz"/>
        <a:lstStyle/>
        <a:p>
          <a:pPr>
            <a:defRPr/>
          </a:pPr>
          <a:endParaRPr lang="en-US"/>
        </a:p>
      </c:txPr>
    </c:legend>
    <c:plotVisOnly val="1"/>
    <c:dispBlanksAs val="gap"/>
    <c:showDLblsOverMax val="0"/>
  </c:chart>
  <c:spPr>
    <a:noFill/>
    <a:ln w="9525" cap="flat" cmpd="sng" algn="ctr">
      <a:noFill/>
      <a:round/>
    </a:ln>
    <a:effectLst/>
  </c:spPr>
  <c:txPr>
    <a:bodyPr/>
    <a:lstStyle/>
    <a:p>
      <a:pPr>
        <a:defRPr sz="1100">
          <a:latin typeface="Arial" panose="020B0604020202020204" pitchFamily="34" charset="0"/>
          <a:cs typeface="Arial" panose="020B0604020202020204" pitchFamily="34" charset="0"/>
        </a:defRPr>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08 dn prion no change del'!$E$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308 dn prion no change del'!$D$2:$D$152</c:f>
              <c:numCache>
                <c:formatCode>General</c:formatCode>
                <c:ptCount val="151"/>
                <c:pt idx="0">
                  <c:v>35155</c:v>
                </c:pt>
                <c:pt idx="1">
                  <c:v>31567</c:v>
                </c:pt>
                <c:pt idx="2">
                  <c:v>190193</c:v>
                </c:pt>
                <c:pt idx="3">
                  <c:v>273495</c:v>
                </c:pt>
                <c:pt idx="4">
                  <c:v>477228</c:v>
                </c:pt>
                <c:pt idx="5">
                  <c:v>532162</c:v>
                </c:pt>
                <c:pt idx="6">
                  <c:v>697466</c:v>
                </c:pt>
                <c:pt idx="7">
                  <c:v>745882</c:v>
                </c:pt>
                <c:pt idx="8">
                  <c:v>826333</c:v>
                </c:pt>
                <c:pt idx="9">
                  <c:v>859386</c:v>
                </c:pt>
                <c:pt idx="10">
                  <c:v>878104</c:v>
                </c:pt>
                <c:pt idx="11">
                  <c:v>881633</c:v>
                </c:pt>
                <c:pt idx="12">
                  <c:v>1268965</c:v>
                </c:pt>
                <c:pt idx="13">
                  <c:v>1317806</c:v>
                </c:pt>
                <c:pt idx="14">
                  <c:v>1731262</c:v>
                </c:pt>
                <c:pt idx="15">
                  <c:v>1663233</c:v>
                </c:pt>
                <c:pt idx="16">
                  <c:v>1600281</c:v>
                </c:pt>
                <c:pt idx="17">
                  <c:v>1589193</c:v>
                </c:pt>
                <c:pt idx="18">
                  <c:v>1471602</c:v>
                </c:pt>
                <c:pt idx="19">
                  <c:v>1422033</c:v>
                </c:pt>
                <c:pt idx="20">
                  <c:v>1396819</c:v>
                </c:pt>
                <c:pt idx="21">
                  <c:v>1823456</c:v>
                </c:pt>
                <c:pt idx="22">
                  <c:v>1953915</c:v>
                </c:pt>
                <c:pt idx="23">
                  <c:v>1997161</c:v>
                </c:pt>
                <c:pt idx="24">
                  <c:v>2060337</c:v>
                </c:pt>
                <c:pt idx="25">
                  <c:v>2166643</c:v>
                </c:pt>
                <c:pt idx="26">
                  <c:v>2172132</c:v>
                </c:pt>
                <c:pt idx="27">
                  <c:v>2177972</c:v>
                </c:pt>
                <c:pt idx="28">
                  <c:v>2255057</c:v>
                </c:pt>
                <c:pt idx="29">
                  <c:v>2365697</c:v>
                </c:pt>
                <c:pt idx="30">
                  <c:v>2487894</c:v>
                </c:pt>
                <c:pt idx="31">
                  <c:v>3025075</c:v>
                </c:pt>
                <c:pt idx="32">
                  <c:v>2911544</c:v>
                </c:pt>
                <c:pt idx="33">
                  <c:v>3076496</c:v>
                </c:pt>
                <c:pt idx="34">
                  <c:v>3087123</c:v>
                </c:pt>
                <c:pt idx="35">
                  <c:v>3182197</c:v>
                </c:pt>
                <c:pt idx="36">
                  <c:v>3210875</c:v>
                </c:pt>
                <c:pt idx="37">
                  <c:v>3243653</c:v>
                </c:pt>
                <c:pt idx="38">
                  <c:v>3247421</c:v>
                </c:pt>
                <c:pt idx="39">
                  <c:v>3545660</c:v>
                </c:pt>
                <c:pt idx="40">
                  <c:v>3497061</c:v>
                </c:pt>
                <c:pt idx="41">
                  <c:v>3485833</c:v>
                </c:pt>
                <c:pt idx="42">
                  <c:v>4224911</c:v>
                </c:pt>
                <c:pt idx="43">
                  <c:v>4214535</c:v>
                </c:pt>
                <c:pt idx="44">
                  <c:v>4153092</c:v>
                </c:pt>
                <c:pt idx="45">
                  <c:v>4124186</c:v>
                </c:pt>
                <c:pt idx="46">
                  <c:v>4111002</c:v>
                </c:pt>
                <c:pt idx="47">
                  <c:v>3949406</c:v>
                </c:pt>
                <c:pt idx="48">
                  <c:v>3847148</c:v>
                </c:pt>
                <c:pt idx="49">
                  <c:v>3774643</c:v>
                </c:pt>
                <c:pt idx="50">
                  <c:v>4264219</c:v>
                </c:pt>
                <c:pt idx="51">
                  <c:v>4268254</c:v>
                </c:pt>
                <c:pt idx="52">
                  <c:v>4287254</c:v>
                </c:pt>
                <c:pt idx="53">
                  <c:v>4366796</c:v>
                </c:pt>
                <c:pt idx="54">
                  <c:v>4446600</c:v>
                </c:pt>
                <c:pt idx="55">
                  <c:v>4452699</c:v>
                </c:pt>
                <c:pt idx="56">
                  <c:v>4585645</c:v>
                </c:pt>
                <c:pt idx="57">
                  <c:v>4716326</c:v>
                </c:pt>
                <c:pt idx="58">
                  <c:v>4815589</c:v>
                </c:pt>
                <c:pt idx="59">
                  <c:v>5275643</c:v>
                </c:pt>
                <c:pt idx="60">
                  <c:v>5349367</c:v>
                </c:pt>
                <c:pt idx="61">
                  <c:v>5663734</c:v>
                </c:pt>
                <c:pt idx="62">
                  <c:v>5570577</c:v>
                </c:pt>
                <c:pt idx="63">
                  <c:v>5515262</c:v>
                </c:pt>
                <c:pt idx="64">
                  <c:v>5486192</c:v>
                </c:pt>
                <c:pt idx="65">
                  <c:v>5773659</c:v>
                </c:pt>
                <c:pt idx="66">
                  <c:v>5775201</c:v>
                </c:pt>
                <c:pt idx="67">
                  <c:v>6113646</c:v>
                </c:pt>
                <c:pt idx="68">
                  <c:v>6111302</c:v>
                </c:pt>
                <c:pt idx="69">
                  <c:v>6098387</c:v>
                </c:pt>
                <c:pt idx="70">
                  <c:v>5978820</c:v>
                </c:pt>
                <c:pt idx="71">
                  <c:v>5949706</c:v>
                </c:pt>
                <c:pt idx="72">
                  <c:v>6284891</c:v>
                </c:pt>
                <c:pt idx="73">
                  <c:v>6378248</c:v>
                </c:pt>
                <c:pt idx="74">
                  <c:v>6442234</c:v>
                </c:pt>
                <c:pt idx="75">
                  <c:v>6443656</c:v>
                </c:pt>
                <c:pt idx="76">
                  <c:v>6538205</c:v>
                </c:pt>
                <c:pt idx="77">
                  <c:v>6857335</c:v>
                </c:pt>
                <c:pt idx="78">
                  <c:v>6814353</c:v>
                </c:pt>
                <c:pt idx="79">
                  <c:v>6749995</c:v>
                </c:pt>
                <c:pt idx="80">
                  <c:v>6705687</c:v>
                </c:pt>
                <c:pt idx="81">
                  <c:v>7130982</c:v>
                </c:pt>
                <c:pt idx="82">
                  <c:v>7146130</c:v>
                </c:pt>
                <c:pt idx="83">
                  <c:v>7160495</c:v>
                </c:pt>
                <c:pt idx="84">
                  <c:v>7189737</c:v>
                </c:pt>
                <c:pt idx="85">
                  <c:v>7357875</c:v>
                </c:pt>
                <c:pt idx="86">
                  <c:v>7326489</c:v>
                </c:pt>
                <c:pt idx="87">
                  <c:v>7275137</c:v>
                </c:pt>
                <c:pt idx="88">
                  <c:v>7565729</c:v>
                </c:pt>
                <c:pt idx="89">
                  <c:v>7613809</c:v>
                </c:pt>
                <c:pt idx="90">
                  <c:v>7738911</c:v>
                </c:pt>
                <c:pt idx="91">
                  <c:v>7756082</c:v>
                </c:pt>
                <c:pt idx="92">
                  <c:v>7923240</c:v>
                </c:pt>
                <c:pt idx="93">
                  <c:v>7926214</c:v>
                </c:pt>
                <c:pt idx="94">
                  <c:v>8035704</c:v>
                </c:pt>
                <c:pt idx="95">
                  <c:v>8073758</c:v>
                </c:pt>
                <c:pt idx="96">
                  <c:v>8515993</c:v>
                </c:pt>
                <c:pt idx="97">
                  <c:v>8393829</c:v>
                </c:pt>
                <c:pt idx="98">
                  <c:v>8355539</c:v>
                </c:pt>
                <c:pt idx="99">
                  <c:v>8333403</c:v>
                </c:pt>
                <c:pt idx="100">
                  <c:v>8611284</c:v>
                </c:pt>
                <c:pt idx="101">
                  <c:v>8653998</c:v>
                </c:pt>
                <c:pt idx="102">
                  <c:v>8759833</c:v>
                </c:pt>
                <c:pt idx="103">
                  <c:v>8760696</c:v>
                </c:pt>
                <c:pt idx="104">
                  <c:v>8762413</c:v>
                </c:pt>
                <c:pt idx="105">
                  <c:v>8772450</c:v>
                </c:pt>
                <c:pt idx="106">
                  <c:v>8864404</c:v>
                </c:pt>
                <c:pt idx="107">
                  <c:v>8869330</c:v>
                </c:pt>
                <c:pt idx="108">
                  <c:v>8931894</c:v>
                </c:pt>
                <c:pt idx="109">
                  <c:v>8932102</c:v>
                </c:pt>
                <c:pt idx="110">
                  <c:v>8968861</c:v>
                </c:pt>
                <c:pt idx="111">
                  <c:v>8978281</c:v>
                </c:pt>
                <c:pt idx="112">
                  <c:v>8999101</c:v>
                </c:pt>
                <c:pt idx="113">
                  <c:v>9096120</c:v>
                </c:pt>
                <c:pt idx="114">
                  <c:v>9121723</c:v>
                </c:pt>
                <c:pt idx="115">
                  <c:v>9155544</c:v>
                </c:pt>
                <c:pt idx="116">
                  <c:v>9175835</c:v>
                </c:pt>
                <c:pt idx="117">
                  <c:v>9853955</c:v>
                </c:pt>
                <c:pt idx="118">
                  <c:v>9827216</c:v>
                </c:pt>
                <c:pt idx="119">
                  <c:v>9790599</c:v>
                </c:pt>
                <c:pt idx="120">
                  <c:v>9729027</c:v>
                </c:pt>
                <c:pt idx="121">
                  <c:v>9727404</c:v>
                </c:pt>
                <c:pt idx="122">
                  <c:v>9697504</c:v>
                </c:pt>
                <c:pt idx="123">
                  <c:v>9524138</c:v>
                </c:pt>
                <c:pt idx="124">
                  <c:v>9502054</c:v>
                </c:pt>
                <c:pt idx="125">
                  <c:v>9452824</c:v>
                </c:pt>
                <c:pt idx="126">
                  <c:v>9324582</c:v>
                </c:pt>
                <c:pt idx="127">
                  <c:v>9935271</c:v>
                </c:pt>
                <c:pt idx="128">
                  <c:v>9956159</c:v>
                </c:pt>
                <c:pt idx="129">
                  <c:v>10197683</c:v>
                </c:pt>
                <c:pt idx="130">
                  <c:v>10075663</c:v>
                </c:pt>
                <c:pt idx="131">
                  <c:v>10400096</c:v>
                </c:pt>
                <c:pt idx="132">
                  <c:v>10421182</c:v>
                </c:pt>
                <c:pt idx="133">
                  <c:v>10583083</c:v>
                </c:pt>
                <c:pt idx="134">
                  <c:v>10689233</c:v>
                </c:pt>
                <c:pt idx="135">
                  <c:v>10715080</c:v>
                </c:pt>
                <c:pt idx="136">
                  <c:v>10787297</c:v>
                </c:pt>
                <c:pt idx="137">
                  <c:v>10963772</c:v>
                </c:pt>
                <c:pt idx="138">
                  <c:v>11071809</c:v>
                </c:pt>
                <c:pt idx="139">
                  <c:v>11091500</c:v>
                </c:pt>
                <c:pt idx="140">
                  <c:v>11420813</c:v>
                </c:pt>
                <c:pt idx="141">
                  <c:v>11304663</c:v>
                </c:pt>
                <c:pt idx="142">
                  <c:v>11289516</c:v>
                </c:pt>
                <c:pt idx="143">
                  <c:v>11253422</c:v>
                </c:pt>
                <c:pt idx="144">
                  <c:v>11681645</c:v>
                </c:pt>
                <c:pt idx="145">
                  <c:v>11738639</c:v>
                </c:pt>
                <c:pt idx="146">
                  <c:v>11751140</c:v>
                </c:pt>
                <c:pt idx="147">
                  <c:v>11878137</c:v>
                </c:pt>
                <c:pt idx="148">
                  <c:v>11957825</c:v>
                </c:pt>
                <c:pt idx="149">
                  <c:v>12025304</c:v>
                </c:pt>
                <c:pt idx="150">
                  <c:v>12045120</c:v>
                </c:pt>
              </c:numCache>
            </c:numRef>
          </c:xVal>
          <c:yVal>
            <c:numRef>
              <c:f>'308 dn prion no change del'!$E$2:$E$152</c:f>
              <c:numCache>
                <c:formatCode>General</c:formatCode>
                <c:ptCount val="151"/>
                <c:pt idx="0">
                  <c:v>-1.7975799220827731</c:v>
                </c:pt>
                <c:pt idx="1">
                  <c:v>-1.6351013987364613</c:v>
                </c:pt>
                <c:pt idx="2">
                  <c:v>-2.7411216599182442</c:v>
                </c:pt>
                <c:pt idx="3">
                  <c:v>-1.1965947979770923</c:v>
                </c:pt>
                <c:pt idx="4">
                  <c:v>-1.6268536536350982</c:v>
                </c:pt>
                <c:pt idx="5">
                  <c:v>-2.4932907637354482</c:v>
                </c:pt>
                <c:pt idx="6">
                  <c:v>-1.3719449598178461</c:v>
                </c:pt>
                <c:pt idx="7">
                  <c:v>-1.1919054620625518</c:v>
                </c:pt>
                <c:pt idx="8">
                  <c:v>-1.4566746931089118</c:v>
                </c:pt>
                <c:pt idx="9">
                  <c:v>-1.936412560208489</c:v>
                </c:pt>
                <c:pt idx="10">
                  <c:v>-1.2786021664157785</c:v>
                </c:pt>
                <c:pt idx="11">
                  <c:v>-1.2927902432835223</c:v>
                </c:pt>
                <c:pt idx="12">
                  <c:v>-1.2410209038904563</c:v>
                </c:pt>
                <c:pt idx="13">
                  <c:v>-2.0516942882213418</c:v>
                </c:pt>
                <c:pt idx="14">
                  <c:v>-1.1888817659263977</c:v>
                </c:pt>
                <c:pt idx="15">
                  <c:v>-4.3592742301218852</c:v>
                </c:pt>
                <c:pt idx="16">
                  <c:v>-1.0767161025519307</c:v>
                </c:pt>
                <c:pt idx="17">
                  <c:v>-1.436278307984199</c:v>
                </c:pt>
                <c:pt idx="18">
                  <c:v>-1.5684289227571904</c:v>
                </c:pt>
                <c:pt idx="19">
                  <c:v>-2.1308229568925898</c:v>
                </c:pt>
                <c:pt idx="20">
                  <c:v>-1.1790577532866566</c:v>
                </c:pt>
                <c:pt idx="21">
                  <c:v>-1.325217024662831</c:v>
                </c:pt>
                <c:pt idx="22">
                  <c:v>-1.4644850075217977</c:v>
                </c:pt>
                <c:pt idx="23">
                  <c:v>-1.7504164537375519</c:v>
                </c:pt>
                <c:pt idx="24">
                  <c:v>-1.6509123157348136</c:v>
                </c:pt>
                <c:pt idx="25">
                  <c:v>-1.3075570998155632</c:v>
                </c:pt>
                <c:pt idx="26">
                  <c:v>-1.1693260200081972</c:v>
                </c:pt>
                <c:pt idx="27">
                  <c:v>-1.3031939580590919</c:v>
                </c:pt>
                <c:pt idx="28">
                  <c:v>-3.6716099657954935</c:v>
                </c:pt>
                <c:pt idx="29">
                  <c:v>-1.5978776393608742</c:v>
                </c:pt>
                <c:pt idx="30">
                  <c:v>-1.1054725558760505</c:v>
                </c:pt>
                <c:pt idx="31">
                  <c:v>-3.2523002376130989</c:v>
                </c:pt>
                <c:pt idx="32">
                  <c:v>-3.6472788430989622</c:v>
                </c:pt>
                <c:pt idx="33">
                  <c:v>-1.6922763708045971</c:v>
                </c:pt>
                <c:pt idx="34">
                  <c:v>-1.045440430972711</c:v>
                </c:pt>
                <c:pt idx="35">
                  <c:v>-1.0520998411045479</c:v>
                </c:pt>
                <c:pt idx="36">
                  <c:v>-1.3407117778232114</c:v>
                </c:pt>
                <c:pt idx="37">
                  <c:v>-1.8340867347222143</c:v>
                </c:pt>
                <c:pt idx="38">
                  <c:v>-1.2064809673979824</c:v>
                </c:pt>
                <c:pt idx="39">
                  <c:v>-2.5995962100536518</c:v>
                </c:pt>
                <c:pt idx="40">
                  <c:v>-1.6704817780462831</c:v>
                </c:pt>
                <c:pt idx="41">
                  <c:v>-1.6189683385046907</c:v>
                </c:pt>
                <c:pt idx="42">
                  <c:v>-1.3120936145231712</c:v>
                </c:pt>
                <c:pt idx="43">
                  <c:v>-1.2455656030706104</c:v>
                </c:pt>
                <c:pt idx="44">
                  <c:v>-1.0665354104989366</c:v>
                </c:pt>
                <c:pt idx="45">
                  <c:v>-1.9581998524275381</c:v>
                </c:pt>
                <c:pt idx="46">
                  <c:v>-1.7364412507847777</c:v>
                </c:pt>
                <c:pt idx="47">
                  <c:v>-1.5557091903587015</c:v>
                </c:pt>
                <c:pt idx="48">
                  <c:v>-2.4308220163995551</c:v>
                </c:pt>
                <c:pt idx="49">
                  <c:v>-1.0395893684350126</c:v>
                </c:pt>
                <c:pt idx="50">
                  <c:v>-1.1006846951821658</c:v>
                </c:pt>
                <c:pt idx="51">
                  <c:v>-1.9113841920040713</c:v>
                </c:pt>
                <c:pt idx="52">
                  <c:v>-1.4036544769767794</c:v>
                </c:pt>
                <c:pt idx="53">
                  <c:v>-1.2855021953401726</c:v>
                </c:pt>
                <c:pt idx="54">
                  <c:v>-1.1916700757500287</c:v>
                </c:pt>
                <c:pt idx="55">
                  <c:v>-3.1096079467443531</c:v>
                </c:pt>
                <c:pt idx="56">
                  <c:v>-1.2929084511990552</c:v>
                </c:pt>
                <c:pt idx="57">
                  <c:v>-3.0788213552054411</c:v>
                </c:pt>
                <c:pt idx="58">
                  <c:v>-1.7375744691065578</c:v>
                </c:pt>
                <c:pt idx="59">
                  <c:v>-1.34291108164141</c:v>
                </c:pt>
                <c:pt idx="60">
                  <c:v>-1.9634136717585982</c:v>
                </c:pt>
                <c:pt idx="61">
                  <c:v>-1.0834572000402138</c:v>
                </c:pt>
                <c:pt idx="62">
                  <c:v>-1.1780386794083104</c:v>
                </c:pt>
                <c:pt idx="63">
                  <c:v>-1.1695490917472935</c:v>
                </c:pt>
                <c:pt idx="64">
                  <c:v>-2.9734385446770797</c:v>
                </c:pt>
                <c:pt idx="65">
                  <c:v>-1.2137475991472118</c:v>
                </c:pt>
                <c:pt idx="66">
                  <c:v>-1.606087128076835</c:v>
                </c:pt>
                <c:pt idx="67">
                  <c:v>-1.0669303654408928</c:v>
                </c:pt>
                <c:pt idx="68">
                  <c:v>-1.4667847663084765</c:v>
                </c:pt>
                <c:pt idx="69">
                  <c:v>-3.1826209241331842</c:v>
                </c:pt>
                <c:pt idx="70">
                  <c:v>-1.0354347701179121</c:v>
                </c:pt>
                <c:pt idx="71">
                  <c:v>-1.9987092256103032</c:v>
                </c:pt>
                <c:pt idx="72">
                  <c:v>-1.3477721664053259</c:v>
                </c:pt>
                <c:pt idx="73">
                  <c:v>-1.0983966872740312</c:v>
                </c:pt>
                <c:pt idx="74">
                  <c:v>-2.0227666878626533</c:v>
                </c:pt>
                <c:pt idx="75">
                  <c:v>-2.0703663714586873</c:v>
                </c:pt>
                <c:pt idx="76">
                  <c:v>-1.7478063374491026</c:v>
                </c:pt>
                <c:pt idx="77">
                  <c:v>-1.1015981754771209</c:v>
                </c:pt>
                <c:pt idx="78">
                  <c:v>-1.7884143624497135</c:v>
                </c:pt>
                <c:pt idx="79">
                  <c:v>-1.0872759083649592</c:v>
                </c:pt>
                <c:pt idx="80">
                  <c:v>-1.3767780285890623</c:v>
                </c:pt>
                <c:pt idx="81">
                  <c:v>-1.6978242173317764</c:v>
                </c:pt>
                <c:pt idx="82">
                  <c:v>-1.5696323673076311</c:v>
                </c:pt>
                <c:pt idx="83">
                  <c:v>-2.0746822927026711</c:v>
                </c:pt>
                <c:pt idx="84">
                  <c:v>-1.9459228270119233</c:v>
                </c:pt>
                <c:pt idx="85">
                  <c:v>-1.068593573045389</c:v>
                </c:pt>
                <c:pt idx="86">
                  <c:v>-1.0728896822412353</c:v>
                </c:pt>
                <c:pt idx="87">
                  <c:v>-1.1171193172008185</c:v>
                </c:pt>
                <c:pt idx="88">
                  <c:v>-1.4182241881522508</c:v>
                </c:pt>
                <c:pt idx="89">
                  <c:v>-1.3239119917631226</c:v>
                </c:pt>
                <c:pt idx="90">
                  <c:v>-1.9806870893562543</c:v>
                </c:pt>
                <c:pt idx="91">
                  <c:v>-1.0668813745047505</c:v>
                </c:pt>
                <c:pt idx="92">
                  <c:v>-2.7909362918389484</c:v>
                </c:pt>
                <c:pt idx="93">
                  <c:v>-1.282185646180352</c:v>
                </c:pt>
                <c:pt idx="94">
                  <c:v>-1.2788412301530363</c:v>
                </c:pt>
                <c:pt idx="95">
                  <c:v>-1.2637115804002492</c:v>
                </c:pt>
                <c:pt idx="96">
                  <c:v>-2.2255299301646727</c:v>
                </c:pt>
                <c:pt idx="97">
                  <c:v>-1.7301776264583066</c:v>
                </c:pt>
                <c:pt idx="98">
                  <c:v>-1.5745627941614682</c:v>
                </c:pt>
                <c:pt idx="99">
                  <c:v>-2.2938729462353118</c:v>
                </c:pt>
                <c:pt idx="100">
                  <c:v>-3.4724801145823108</c:v>
                </c:pt>
                <c:pt idx="101">
                  <c:v>-1.0953337231433038</c:v>
                </c:pt>
                <c:pt idx="102">
                  <c:v>-1.5036438249485051</c:v>
                </c:pt>
                <c:pt idx="103">
                  <c:v>-1.9517025623502346</c:v>
                </c:pt>
                <c:pt idx="104">
                  <c:v>-1.1334191763804771</c:v>
                </c:pt>
                <c:pt idx="105">
                  <c:v>-1.6417560844223014</c:v>
                </c:pt>
                <c:pt idx="106">
                  <c:v>-1.1001669688221531</c:v>
                </c:pt>
                <c:pt idx="107">
                  <c:v>-1.0564882291281725</c:v>
                </c:pt>
                <c:pt idx="108">
                  <c:v>-2.6504307933236531</c:v>
                </c:pt>
                <c:pt idx="109">
                  <c:v>-2.7653815602579748</c:v>
                </c:pt>
                <c:pt idx="110">
                  <c:v>-1.3495656718708222</c:v>
                </c:pt>
                <c:pt idx="111">
                  <c:v>-1.7762668018769645</c:v>
                </c:pt>
                <c:pt idx="112">
                  <c:v>-4.0554652909768967</c:v>
                </c:pt>
                <c:pt idx="113">
                  <c:v>-2.3538395760953463</c:v>
                </c:pt>
                <c:pt idx="114">
                  <c:v>-1.2090939851124654</c:v>
                </c:pt>
                <c:pt idx="115">
                  <c:v>-1.0867689274923462</c:v>
                </c:pt>
                <c:pt idx="116">
                  <c:v>-1.1497054371794759</c:v>
                </c:pt>
                <c:pt idx="117">
                  <c:v>-1.3851265805483786</c:v>
                </c:pt>
                <c:pt idx="118">
                  <c:v>-1.0642819527319145</c:v>
                </c:pt>
                <c:pt idx="119">
                  <c:v>-1.1123209304780717</c:v>
                </c:pt>
                <c:pt idx="120">
                  <c:v>-1.6592380977824692</c:v>
                </c:pt>
                <c:pt idx="121">
                  <c:v>-1.2127827193515563</c:v>
                </c:pt>
                <c:pt idx="122">
                  <c:v>-2.1794257925416036</c:v>
                </c:pt>
                <c:pt idx="123">
                  <c:v>-1.5558582232350868</c:v>
                </c:pt>
                <c:pt idx="124">
                  <c:v>-1.5076064053613614</c:v>
                </c:pt>
                <c:pt idx="125">
                  <c:v>-2.1833334522670143</c:v>
                </c:pt>
                <c:pt idx="126">
                  <c:v>-1.1559812429159064</c:v>
                </c:pt>
                <c:pt idx="127">
                  <c:v>-1.1204795180919165</c:v>
                </c:pt>
                <c:pt idx="128">
                  <c:v>-1.1339537940635795</c:v>
                </c:pt>
                <c:pt idx="129">
                  <c:v>-1.6966726723466039</c:v>
                </c:pt>
                <c:pt idx="130">
                  <c:v>-1.2360899215957737</c:v>
                </c:pt>
                <c:pt idx="131">
                  <c:v>-3.5646514632421495</c:v>
                </c:pt>
                <c:pt idx="132">
                  <c:v>-1.3287109823062024</c:v>
                </c:pt>
                <c:pt idx="133">
                  <c:v>-2.741484190064293</c:v>
                </c:pt>
                <c:pt idx="134">
                  <c:v>-2.6409929870864643</c:v>
                </c:pt>
                <c:pt idx="135">
                  <c:v>-2.208337891501214</c:v>
                </c:pt>
                <c:pt idx="136">
                  <c:v>-1.1679326165779775</c:v>
                </c:pt>
                <c:pt idx="137">
                  <c:v>-2.0523216996789841</c:v>
                </c:pt>
                <c:pt idx="138">
                  <c:v>-2.2730194787145099</c:v>
                </c:pt>
                <c:pt idx="139">
                  <c:v>-3.2689467534541059</c:v>
                </c:pt>
                <c:pt idx="140">
                  <c:v>-1.6434448491464051</c:v>
                </c:pt>
                <c:pt idx="141">
                  <c:v>-1.1027130343230052</c:v>
                </c:pt>
                <c:pt idx="142">
                  <c:v>-1.2400289936662643</c:v>
                </c:pt>
                <c:pt idx="143">
                  <c:v>-2.0290288111342649</c:v>
                </c:pt>
                <c:pt idx="144">
                  <c:v>-1.2408922358160215</c:v>
                </c:pt>
                <c:pt idx="145">
                  <c:v>-1.6492494561183362</c:v>
                </c:pt>
                <c:pt idx="146">
                  <c:v>-4.1875540057454739</c:v>
                </c:pt>
                <c:pt idx="147">
                  <c:v>-1.3193569150127855</c:v>
                </c:pt>
                <c:pt idx="148">
                  <c:v>-1.4448311051190117</c:v>
                </c:pt>
                <c:pt idx="149">
                  <c:v>-3.4554346882312568</c:v>
                </c:pt>
                <c:pt idx="150">
                  <c:v>-1.6922885622481374</c:v>
                </c:pt>
              </c:numCache>
            </c:numRef>
          </c:yVal>
          <c:smooth val="0"/>
          <c:extLst>
            <c:ext xmlns:c16="http://schemas.microsoft.com/office/drawing/2014/chart" uri="{C3380CC4-5D6E-409C-BE32-E72D297353CC}">
              <c16:uniqueId val="{00000000-3A6B-4D69-93F6-F9A7BD8FF452}"/>
            </c:ext>
          </c:extLst>
        </c:ser>
        <c:ser>
          <c:idx val="1"/>
          <c:order val="1"/>
          <c:tx>
            <c:strRef>
              <c:f>'308 dn prion no change del'!$F$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308 dn prion no change del'!$D$2:$D$152</c:f>
              <c:numCache>
                <c:formatCode>General</c:formatCode>
                <c:ptCount val="151"/>
                <c:pt idx="0">
                  <c:v>35155</c:v>
                </c:pt>
                <c:pt idx="1">
                  <c:v>31567</c:v>
                </c:pt>
                <c:pt idx="2">
                  <c:v>190193</c:v>
                </c:pt>
                <c:pt idx="3">
                  <c:v>273495</c:v>
                </c:pt>
                <c:pt idx="4">
                  <c:v>477228</c:v>
                </c:pt>
                <c:pt idx="5">
                  <c:v>532162</c:v>
                </c:pt>
                <c:pt idx="6">
                  <c:v>697466</c:v>
                </c:pt>
                <c:pt idx="7">
                  <c:v>745882</c:v>
                </c:pt>
                <c:pt idx="8">
                  <c:v>826333</c:v>
                </c:pt>
                <c:pt idx="9">
                  <c:v>859386</c:v>
                </c:pt>
                <c:pt idx="10">
                  <c:v>878104</c:v>
                </c:pt>
                <c:pt idx="11">
                  <c:v>881633</c:v>
                </c:pt>
                <c:pt idx="12">
                  <c:v>1268965</c:v>
                </c:pt>
                <c:pt idx="13">
                  <c:v>1317806</c:v>
                </c:pt>
                <c:pt idx="14">
                  <c:v>1731262</c:v>
                </c:pt>
                <c:pt idx="15">
                  <c:v>1663233</c:v>
                </c:pt>
                <c:pt idx="16">
                  <c:v>1600281</c:v>
                </c:pt>
                <c:pt idx="17">
                  <c:v>1589193</c:v>
                </c:pt>
                <c:pt idx="18">
                  <c:v>1471602</c:v>
                </c:pt>
                <c:pt idx="19">
                  <c:v>1422033</c:v>
                </c:pt>
                <c:pt idx="20">
                  <c:v>1396819</c:v>
                </c:pt>
                <c:pt idx="21">
                  <c:v>1823456</c:v>
                </c:pt>
                <c:pt idx="22">
                  <c:v>1953915</c:v>
                </c:pt>
                <c:pt idx="23">
                  <c:v>1997161</c:v>
                </c:pt>
                <c:pt idx="24">
                  <c:v>2060337</c:v>
                </c:pt>
                <c:pt idx="25">
                  <c:v>2166643</c:v>
                </c:pt>
                <c:pt idx="26">
                  <c:v>2172132</c:v>
                </c:pt>
                <c:pt idx="27">
                  <c:v>2177972</c:v>
                </c:pt>
                <c:pt idx="28">
                  <c:v>2255057</c:v>
                </c:pt>
                <c:pt idx="29">
                  <c:v>2365697</c:v>
                </c:pt>
                <c:pt idx="30">
                  <c:v>2487894</c:v>
                </c:pt>
                <c:pt idx="31">
                  <c:v>3025075</c:v>
                </c:pt>
                <c:pt idx="32">
                  <c:v>2911544</c:v>
                </c:pt>
                <c:pt idx="33">
                  <c:v>3076496</c:v>
                </c:pt>
                <c:pt idx="34">
                  <c:v>3087123</c:v>
                </c:pt>
                <c:pt idx="35">
                  <c:v>3182197</c:v>
                </c:pt>
                <c:pt idx="36">
                  <c:v>3210875</c:v>
                </c:pt>
                <c:pt idx="37">
                  <c:v>3243653</c:v>
                </c:pt>
                <c:pt idx="38">
                  <c:v>3247421</c:v>
                </c:pt>
                <c:pt idx="39">
                  <c:v>3545660</c:v>
                </c:pt>
                <c:pt idx="40">
                  <c:v>3497061</c:v>
                </c:pt>
                <c:pt idx="41">
                  <c:v>3485833</c:v>
                </c:pt>
                <c:pt idx="42">
                  <c:v>4224911</c:v>
                </c:pt>
                <c:pt idx="43">
                  <c:v>4214535</c:v>
                </c:pt>
                <c:pt idx="44">
                  <c:v>4153092</c:v>
                </c:pt>
                <c:pt idx="45">
                  <c:v>4124186</c:v>
                </c:pt>
                <c:pt idx="46">
                  <c:v>4111002</c:v>
                </c:pt>
                <c:pt idx="47">
                  <c:v>3949406</c:v>
                </c:pt>
                <c:pt idx="48">
                  <c:v>3847148</c:v>
                </c:pt>
                <c:pt idx="49">
                  <c:v>3774643</c:v>
                </c:pt>
                <c:pt idx="50">
                  <c:v>4264219</c:v>
                </c:pt>
                <c:pt idx="51">
                  <c:v>4268254</c:v>
                </c:pt>
                <c:pt idx="52">
                  <c:v>4287254</c:v>
                </c:pt>
                <c:pt idx="53">
                  <c:v>4366796</c:v>
                </c:pt>
                <c:pt idx="54">
                  <c:v>4446600</c:v>
                </c:pt>
                <c:pt idx="55">
                  <c:v>4452699</c:v>
                </c:pt>
                <c:pt idx="56">
                  <c:v>4585645</c:v>
                </c:pt>
                <c:pt idx="57">
                  <c:v>4716326</c:v>
                </c:pt>
                <c:pt idx="58">
                  <c:v>4815589</c:v>
                </c:pt>
                <c:pt idx="59">
                  <c:v>5275643</c:v>
                </c:pt>
                <c:pt idx="60">
                  <c:v>5349367</c:v>
                </c:pt>
                <c:pt idx="61">
                  <c:v>5663734</c:v>
                </c:pt>
                <c:pt idx="62">
                  <c:v>5570577</c:v>
                </c:pt>
                <c:pt idx="63">
                  <c:v>5515262</c:v>
                </c:pt>
                <c:pt idx="64">
                  <c:v>5486192</c:v>
                </c:pt>
                <c:pt idx="65">
                  <c:v>5773659</c:v>
                </c:pt>
                <c:pt idx="66">
                  <c:v>5775201</c:v>
                </c:pt>
                <c:pt idx="67">
                  <c:v>6113646</c:v>
                </c:pt>
                <c:pt idx="68">
                  <c:v>6111302</c:v>
                </c:pt>
                <c:pt idx="69">
                  <c:v>6098387</c:v>
                </c:pt>
                <c:pt idx="70">
                  <c:v>5978820</c:v>
                </c:pt>
                <c:pt idx="71">
                  <c:v>5949706</c:v>
                </c:pt>
                <c:pt idx="72">
                  <c:v>6284891</c:v>
                </c:pt>
                <c:pt idx="73">
                  <c:v>6378248</c:v>
                </c:pt>
                <c:pt idx="74">
                  <c:v>6442234</c:v>
                </c:pt>
                <c:pt idx="75">
                  <c:v>6443656</c:v>
                </c:pt>
                <c:pt idx="76">
                  <c:v>6538205</c:v>
                </c:pt>
                <c:pt idx="77">
                  <c:v>6857335</c:v>
                </c:pt>
                <c:pt idx="78">
                  <c:v>6814353</c:v>
                </c:pt>
                <c:pt idx="79">
                  <c:v>6749995</c:v>
                </c:pt>
                <c:pt idx="80">
                  <c:v>6705687</c:v>
                </c:pt>
                <c:pt idx="81">
                  <c:v>7130982</c:v>
                </c:pt>
                <c:pt idx="82">
                  <c:v>7146130</c:v>
                </c:pt>
                <c:pt idx="83">
                  <c:v>7160495</c:v>
                </c:pt>
                <c:pt idx="84">
                  <c:v>7189737</c:v>
                </c:pt>
                <c:pt idx="85">
                  <c:v>7357875</c:v>
                </c:pt>
                <c:pt idx="86">
                  <c:v>7326489</c:v>
                </c:pt>
                <c:pt idx="87">
                  <c:v>7275137</c:v>
                </c:pt>
                <c:pt idx="88">
                  <c:v>7565729</c:v>
                </c:pt>
                <c:pt idx="89">
                  <c:v>7613809</c:v>
                </c:pt>
                <c:pt idx="90">
                  <c:v>7738911</c:v>
                </c:pt>
                <c:pt idx="91">
                  <c:v>7756082</c:v>
                </c:pt>
                <c:pt idx="92">
                  <c:v>7923240</c:v>
                </c:pt>
                <c:pt idx="93">
                  <c:v>7926214</c:v>
                </c:pt>
                <c:pt idx="94">
                  <c:v>8035704</c:v>
                </c:pt>
                <c:pt idx="95">
                  <c:v>8073758</c:v>
                </c:pt>
                <c:pt idx="96">
                  <c:v>8515993</c:v>
                </c:pt>
                <c:pt idx="97">
                  <c:v>8393829</c:v>
                </c:pt>
                <c:pt idx="98">
                  <c:v>8355539</c:v>
                </c:pt>
                <c:pt idx="99">
                  <c:v>8333403</c:v>
                </c:pt>
                <c:pt idx="100">
                  <c:v>8611284</c:v>
                </c:pt>
                <c:pt idx="101">
                  <c:v>8653998</c:v>
                </c:pt>
                <c:pt idx="102">
                  <c:v>8759833</c:v>
                </c:pt>
                <c:pt idx="103">
                  <c:v>8760696</c:v>
                </c:pt>
                <c:pt idx="104">
                  <c:v>8762413</c:v>
                </c:pt>
                <c:pt idx="105">
                  <c:v>8772450</c:v>
                </c:pt>
                <c:pt idx="106">
                  <c:v>8864404</c:v>
                </c:pt>
                <c:pt idx="107">
                  <c:v>8869330</c:v>
                </c:pt>
                <c:pt idx="108">
                  <c:v>8931894</c:v>
                </c:pt>
                <c:pt idx="109">
                  <c:v>8932102</c:v>
                </c:pt>
                <c:pt idx="110">
                  <c:v>8968861</c:v>
                </c:pt>
                <c:pt idx="111">
                  <c:v>8978281</c:v>
                </c:pt>
                <c:pt idx="112">
                  <c:v>8999101</c:v>
                </c:pt>
                <c:pt idx="113">
                  <c:v>9096120</c:v>
                </c:pt>
                <c:pt idx="114">
                  <c:v>9121723</c:v>
                </c:pt>
                <c:pt idx="115">
                  <c:v>9155544</c:v>
                </c:pt>
                <c:pt idx="116">
                  <c:v>9175835</c:v>
                </c:pt>
                <c:pt idx="117">
                  <c:v>9853955</c:v>
                </c:pt>
                <c:pt idx="118">
                  <c:v>9827216</c:v>
                </c:pt>
                <c:pt idx="119">
                  <c:v>9790599</c:v>
                </c:pt>
                <c:pt idx="120">
                  <c:v>9729027</c:v>
                </c:pt>
                <c:pt idx="121">
                  <c:v>9727404</c:v>
                </c:pt>
                <c:pt idx="122">
                  <c:v>9697504</c:v>
                </c:pt>
                <c:pt idx="123">
                  <c:v>9524138</c:v>
                </c:pt>
                <c:pt idx="124">
                  <c:v>9502054</c:v>
                </c:pt>
                <c:pt idx="125">
                  <c:v>9452824</c:v>
                </c:pt>
                <c:pt idx="126">
                  <c:v>9324582</c:v>
                </c:pt>
                <c:pt idx="127">
                  <c:v>9935271</c:v>
                </c:pt>
                <c:pt idx="128">
                  <c:v>9956159</c:v>
                </c:pt>
                <c:pt idx="129">
                  <c:v>10197683</c:v>
                </c:pt>
                <c:pt idx="130">
                  <c:v>10075663</c:v>
                </c:pt>
                <c:pt idx="131">
                  <c:v>10400096</c:v>
                </c:pt>
                <c:pt idx="132">
                  <c:v>10421182</c:v>
                </c:pt>
                <c:pt idx="133">
                  <c:v>10583083</c:v>
                </c:pt>
                <c:pt idx="134">
                  <c:v>10689233</c:v>
                </c:pt>
                <c:pt idx="135">
                  <c:v>10715080</c:v>
                </c:pt>
                <c:pt idx="136">
                  <c:v>10787297</c:v>
                </c:pt>
                <c:pt idx="137">
                  <c:v>10963772</c:v>
                </c:pt>
                <c:pt idx="138">
                  <c:v>11071809</c:v>
                </c:pt>
                <c:pt idx="139">
                  <c:v>11091500</c:v>
                </c:pt>
                <c:pt idx="140">
                  <c:v>11420813</c:v>
                </c:pt>
                <c:pt idx="141">
                  <c:v>11304663</c:v>
                </c:pt>
                <c:pt idx="142">
                  <c:v>11289516</c:v>
                </c:pt>
                <c:pt idx="143">
                  <c:v>11253422</c:v>
                </c:pt>
                <c:pt idx="144">
                  <c:v>11681645</c:v>
                </c:pt>
                <c:pt idx="145">
                  <c:v>11738639</c:v>
                </c:pt>
                <c:pt idx="146">
                  <c:v>11751140</c:v>
                </c:pt>
                <c:pt idx="147">
                  <c:v>11878137</c:v>
                </c:pt>
                <c:pt idx="148">
                  <c:v>11957825</c:v>
                </c:pt>
                <c:pt idx="149">
                  <c:v>12025304</c:v>
                </c:pt>
                <c:pt idx="150">
                  <c:v>12045120</c:v>
                </c:pt>
              </c:numCache>
            </c:numRef>
          </c:xVal>
          <c:yVal>
            <c:numRef>
              <c:f>'308 dn prion no change del'!$F$2:$F$152</c:f>
              <c:numCache>
                <c:formatCode>General</c:formatCode>
                <c:ptCount val="151"/>
                <c:pt idx="0">
                  <c:v>0.36010400403226067</c:v>
                </c:pt>
                <c:pt idx="1">
                  <c:v>0.43056767380334832</c:v>
                </c:pt>
                <c:pt idx="2">
                  <c:v>-0.20454062354172278</c:v>
                </c:pt>
                <c:pt idx="3">
                  <c:v>2.1429634588427719E-2</c:v>
                </c:pt>
                <c:pt idx="4">
                  <c:v>-0.4904436619775368</c:v>
                </c:pt>
                <c:pt idx="5">
                  <c:v>0.139644443389557</c:v>
                </c:pt>
                <c:pt idx="6">
                  <c:v>-0.85751873352196206</c:v>
                </c:pt>
                <c:pt idx="7">
                  <c:v>-0.22222517037150441</c:v>
                </c:pt>
                <c:pt idx="8">
                  <c:v>0.2045495713576487</c:v>
                </c:pt>
                <c:pt idx="9">
                  <c:v>0.51791534454360577</c:v>
                </c:pt>
                <c:pt idx="10">
                  <c:v>0.57795184386979714</c:v>
                </c:pt>
                <c:pt idx="11">
                  <c:v>0.1106938093458821</c:v>
                </c:pt>
                <c:pt idx="12">
                  <c:v>-0.63045791192990341</c:v>
                </c:pt>
                <c:pt idx="13">
                  <c:v>-0.38211795717641378</c:v>
                </c:pt>
                <c:pt idx="14">
                  <c:v>-0.47590972617086286</c:v>
                </c:pt>
                <c:pt idx="15">
                  <c:v>-0.98416545049373116</c:v>
                </c:pt>
                <c:pt idx="16">
                  <c:v>-0.97628509377383654</c:v>
                </c:pt>
                <c:pt idx="17">
                  <c:v>-0.50884830555555349</c:v>
                </c:pt>
                <c:pt idx="18">
                  <c:v>-7.6889886626292425E-2</c:v>
                </c:pt>
                <c:pt idx="19">
                  <c:v>0.99811839799257362</c:v>
                </c:pt>
                <c:pt idx="20">
                  <c:v>-0.19510861310895886</c:v>
                </c:pt>
                <c:pt idx="21">
                  <c:v>0.72909167131986696</c:v>
                </c:pt>
                <c:pt idx="22">
                  <c:v>-0.77951369727776032</c:v>
                </c:pt>
                <c:pt idx="23">
                  <c:v>-0.53758238682199377</c:v>
                </c:pt>
                <c:pt idx="24">
                  <c:v>-0.21415301351517796</c:v>
                </c:pt>
                <c:pt idx="25">
                  <c:v>0.38412656109916804</c:v>
                </c:pt>
                <c:pt idx="26">
                  <c:v>-0.91138980925664603</c:v>
                </c:pt>
                <c:pt idx="27">
                  <c:v>4.6063468385690781E-2</c:v>
                </c:pt>
                <c:pt idx="28">
                  <c:v>2.1786581138629909E-2</c:v>
                </c:pt>
                <c:pt idx="29">
                  <c:v>-0.49780901031183311</c:v>
                </c:pt>
                <c:pt idx="30">
                  <c:v>-1.5072239133662103E-2</c:v>
                </c:pt>
                <c:pt idx="31">
                  <c:v>-0.49736865587849249</c:v>
                </c:pt>
                <c:pt idx="32">
                  <c:v>-0.79118117100026475</c:v>
                </c:pt>
                <c:pt idx="33">
                  <c:v>0.2701269948940439</c:v>
                </c:pt>
                <c:pt idx="34">
                  <c:v>-0.294170555313988</c:v>
                </c:pt>
                <c:pt idx="35">
                  <c:v>0.50855069968888478</c:v>
                </c:pt>
                <c:pt idx="36">
                  <c:v>0.2660635516628474</c:v>
                </c:pt>
                <c:pt idx="37">
                  <c:v>0.91259336263579438</c:v>
                </c:pt>
                <c:pt idx="38">
                  <c:v>-0.15345168732628339</c:v>
                </c:pt>
                <c:pt idx="39">
                  <c:v>-0.64340876713193162</c:v>
                </c:pt>
                <c:pt idx="40">
                  <c:v>0.6909319741004829</c:v>
                </c:pt>
                <c:pt idx="41">
                  <c:v>0.84978552126590345</c:v>
                </c:pt>
                <c:pt idx="42">
                  <c:v>-0.67650788612462998</c:v>
                </c:pt>
                <c:pt idx="43">
                  <c:v>-0.71996581704845231</c:v>
                </c:pt>
                <c:pt idx="44">
                  <c:v>-4.6067426009063772E-2</c:v>
                </c:pt>
                <c:pt idx="45">
                  <c:v>-0.2949385563625867</c:v>
                </c:pt>
                <c:pt idx="46">
                  <c:v>-0.61722294212232365</c:v>
                </c:pt>
                <c:pt idx="47">
                  <c:v>0.70608705080941947</c:v>
                </c:pt>
                <c:pt idx="48">
                  <c:v>0.76319888973336647</c:v>
                </c:pt>
                <c:pt idx="49">
                  <c:v>0.44610149332747556</c:v>
                </c:pt>
                <c:pt idx="50">
                  <c:v>0.42008518414039991</c:v>
                </c:pt>
                <c:pt idx="51">
                  <c:v>-0.37285042241669508</c:v>
                </c:pt>
                <c:pt idx="52">
                  <c:v>0.13243321015151391</c:v>
                </c:pt>
                <c:pt idx="53">
                  <c:v>2.8640065974640468E-2</c:v>
                </c:pt>
                <c:pt idx="54">
                  <c:v>-0.29890630256858464</c:v>
                </c:pt>
                <c:pt idx="55">
                  <c:v>0.29903498284559904</c:v>
                </c:pt>
                <c:pt idx="56">
                  <c:v>-0.84519603584248171</c:v>
                </c:pt>
                <c:pt idx="57">
                  <c:v>-0.24791938018133916</c:v>
                </c:pt>
                <c:pt idx="58">
                  <c:v>4.762151090800984E-2</c:v>
                </c:pt>
                <c:pt idx="59">
                  <c:v>0.14548880669836481</c:v>
                </c:pt>
                <c:pt idx="60">
                  <c:v>-0.27213196115130411</c:v>
                </c:pt>
                <c:pt idx="61">
                  <c:v>-7.3412574647775522E-2</c:v>
                </c:pt>
                <c:pt idx="62">
                  <c:v>-0.18531306830065933</c:v>
                </c:pt>
                <c:pt idx="63">
                  <c:v>-0.43251253553802449</c:v>
                </c:pt>
                <c:pt idx="64">
                  <c:v>-0.72368195932886559</c:v>
                </c:pt>
                <c:pt idx="65">
                  <c:v>2.2100199094025875E-2</c:v>
                </c:pt>
                <c:pt idx="66">
                  <c:v>-0.51387013087920641</c:v>
                </c:pt>
                <c:pt idx="67">
                  <c:v>-0.56391346918274377</c:v>
                </c:pt>
                <c:pt idx="68">
                  <c:v>-0.46293323811676701</c:v>
                </c:pt>
                <c:pt idx="69">
                  <c:v>-0.93960302633749315</c:v>
                </c:pt>
                <c:pt idx="70">
                  <c:v>0.6941992364122771</c:v>
                </c:pt>
                <c:pt idx="71">
                  <c:v>-0.42867632287125895</c:v>
                </c:pt>
                <c:pt idx="72">
                  <c:v>0.39716509430205527</c:v>
                </c:pt>
                <c:pt idx="73">
                  <c:v>-0.89681722831056521</c:v>
                </c:pt>
                <c:pt idx="74">
                  <c:v>0.21221523049086616</c:v>
                </c:pt>
                <c:pt idx="75">
                  <c:v>-0.32528773647851805</c:v>
                </c:pt>
                <c:pt idx="76">
                  <c:v>2.9330546468681586E-2</c:v>
                </c:pt>
                <c:pt idx="77">
                  <c:v>-0.68638664629464774</c:v>
                </c:pt>
                <c:pt idx="78">
                  <c:v>0.58988824715193422</c:v>
                </c:pt>
                <c:pt idx="79">
                  <c:v>-0.1617180132826522</c:v>
                </c:pt>
                <c:pt idx="80">
                  <c:v>0.3284513891792179</c:v>
                </c:pt>
                <c:pt idx="81">
                  <c:v>-0.60763223557461077</c:v>
                </c:pt>
                <c:pt idx="82">
                  <c:v>-0.64959404122023123</c:v>
                </c:pt>
                <c:pt idx="83">
                  <c:v>0.18733909816210112</c:v>
                </c:pt>
                <c:pt idx="84">
                  <c:v>-0.67446204073205274</c:v>
                </c:pt>
                <c:pt idx="85">
                  <c:v>-4.8504026422450532E-2</c:v>
                </c:pt>
                <c:pt idx="86">
                  <c:v>0.21025531831713293</c:v>
                </c:pt>
                <c:pt idx="87">
                  <c:v>8.749794738749473E-3</c:v>
                </c:pt>
                <c:pt idx="88">
                  <c:v>-0.31639102064649899</c:v>
                </c:pt>
                <c:pt idx="89">
                  <c:v>-0.51498171252662417</c:v>
                </c:pt>
                <c:pt idx="90">
                  <c:v>-0.91468625298318684</c:v>
                </c:pt>
                <c:pt idx="91">
                  <c:v>9.9994474227048782E-2</c:v>
                </c:pt>
                <c:pt idx="92">
                  <c:v>-0.51117523105940976</c:v>
                </c:pt>
                <c:pt idx="93">
                  <c:v>-0.12202013227572733</c:v>
                </c:pt>
                <c:pt idx="94">
                  <c:v>-0.26577540954494455</c:v>
                </c:pt>
                <c:pt idx="95">
                  <c:v>6.0713013990946064E-2</c:v>
                </c:pt>
                <c:pt idx="96">
                  <c:v>8.853350876617784E-2</c:v>
                </c:pt>
                <c:pt idx="97">
                  <c:v>8.4226226039299142E-3</c:v>
                </c:pt>
                <c:pt idx="98">
                  <c:v>-4.9138655719547598E-2</c:v>
                </c:pt>
                <c:pt idx="99">
                  <c:v>-0.20096596311097284</c:v>
                </c:pt>
                <c:pt idx="100">
                  <c:v>-0.9244814181943134</c:v>
                </c:pt>
                <c:pt idx="101">
                  <c:v>0.1583829811273168</c:v>
                </c:pt>
                <c:pt idx="102">
                  <c:v>-0.47403912352414829</c:v>
                </c:pt>
                <c:pt idx="103">
                  <c:v>-0.34321672563480682</c:v>
                </c:pt>
                <c:pt idx="104">
                  <c:v>-0.33596656934748853</c:v>
                </c:pt>
                <c:pt idx="105">
                  <c:v>-0.40553630711666944</c:v>
                </c:pt>
                <c:pt idx="106">
                  <c:v>-0.57642410128890531</c:v>
                </c:pt>
                <c:pt idx="107">
                  <c:v>-5.8302791580431869E-2</c:v>
                </c:pt>
                <c:pt idx="108">
                  <c:v>-0.8856118663064585</c:v>
                </c:pt>
                <c:pt idx="109">
                  <c:v>-0.89031613328701342</c:v>
                </c:pt>
                <c:pt idx="110">
                  <c:v>0.65432076395078709</c:v>
                </c:pt>
                <c:pt idx="111">
                  <c:v>-0.24371455871381861</c:v>
                </c:pt>
                <c:pt idx="112">
                  <c:v>-0.36383810170722919</c:v>
                </c:pt>
                <c:pt idx="113">
                  <c:v>-0.14589039444010543</c:v>
                </c:pt>
                <c:pt idx="114">
                  <c:v>-0.33139575107704955</c:v>
                </c:pt>
                <c:pt idx="115">
                  <c:v>-1.6117398883256306E-2</c:v>
                </c:pt>
                <c:pt idx="116">
                  <c:v>-0.44866502305887224</c:v>
                </c:pt>
                <c:pt idx="117">
                  <c:v>0.59447569103722164</c:v>
                </c:pt>
                <c:pt idx="118">
                  <c:v>-0.6425371594031194</c:v>
                </c:pt>
                <c:pt idx="119">
                  <c:v>-0.17934353348709856</c:v>
                </c:pt>
                <c:pt idx="120">
                  <c:v>-0.3160177131480964</c:v>
                </c:pt>
                <c:pt idx="121">
                  <c:v>-0.4642704134814154</c:v>
                </c:pt>
                <c:pt idx="122">
                  <c:v>-0.19538268934925201</c:v>
                </c:pt>
                <c:pt idx="123">
                  <c:v>-0.6574873011028578</c:v>
                </c:pt>
                <c:pt idx="124">
                  <c:v>-0.81525731308788962</c:v>
                </c:pt>
                <c:pt idx="125">
                  <c:v>-0.69711746931901153</c:v>
                </c:pt>
                <c:pt idx="126">
                  <c:v>-5.7560194126409767E-2</c:v>
                </c:pt>
                <c:pt idx="127">
                  <c:v>-0.14565050848506017</c:v>
                </c:pt>
                <c:pt idx="128">
                  <c:v>-0.26703749553711054</c:v>
                </c:pt>
                <c:pt idx="129">
                  <c:v>0.27874695296944502</c:v>
                </c:pt>
                <c:pt idx="130">
                  <c:v>-1.1882220429287375E-3</c:v>
                </c:pt>
                <c:pt idx="131">
                  <c:v>-0.18511591007368855</c:v>
                </c:pt>
                <c:pt idx="132">
                  <c:v>-0.17825522816700923</c:v>
                </c:pt>
                <c:pt idx="133">
                  <c:v>-0.47687216131250759</c:v>
                </c:pt>
                <c:pt idx="134">
                  <c:v>-0.40450133531174365</c:v>
                </c:pt>
                <c:pt idx="135">
                  <c:v>0.11349401474599664</c:v>
                </c:pt>
                <c:pt idx="136">
                  <c:v>0.29657933553471932</c:v>
                </c:pt>
                <c:pt idx="137">
                  <c:v>0.71189385784926451</c:v>
                </c:pt>
                <c:pt idx="138">
                  <c:v>-0.25838457607165249</c:v>
                </c:pt>
                <c:pt idx="139">
                  <c:v>-0.68562461899886162</c:v>
                </c:pt>
                <c:pt idx="140">
                  <c:v>0.40757077037831174</c:v>
                </c:pt>
                <c:pt idx="141">
                  <c:v>-0.28711447837947596</c:v>
                </c:pt>
                <c:pt idx="142">
                  <c:v>-5.3835122628932405E-2</c:v>
                </c:pt>
                <c:pt idx="143">
                  <c:v>0.33195365949760836</c:v>
                </c:pt>
                <c:pt idx="144">
                  <c:v>0.39268428405667366</c:v>
                </c:pt>
                <c:pt idx="145">
                  <c:v>-0.27632502165879869</c:v>
                </c:pt>
                <c:pt idx="146">
                  <c:v>-0.66376622499286064</c:v>
                </c:pt>
                <c:pt idx="147">
                  <c:v>0.48106215953838666</c:v>
                </c:pt>
                <c:pt idx="148">
                  <c:v>-0.9707978866006759</c:v>
                </c:pt>
                <c:pt idx="149">
                  <c:v>-0.86759392457743267</c:v>
                </c:pt>
                <c:pt idx="150">
                  <c:v>-0.42774864844001359</c:v>
                </c:pt>
              </c:numCache>
            </c:numRef>
          </c:yVal>
          <c:smooth val="0"/>
          <c:extLst>
            <c:ext xmlns:c16="http://schemas.microsoft.com/office/drawing/2014/chart" uri="{C3380CC4-5D6E-409C-BE32-E72D297353CC}">
              <c16:uniqueId val="{00000001-3A6B-4D69-93F6-F9A7BD8FF452}"/>
            </c:ext>
          </c:extLst>
        </c:ser>
        <c:dLbls>
          <c:showLegendKey val="0"/>
          <c:showVal val="0"/>
          <c:showCatName val="0"/>
          <c:showSerName val="0"/>
          <c:showPercent val="0"/>
          <c:showBubbleSize val="0"/>
        </c:dLbls>
        <c:axId val="171843584"/>
        <c:axId val="171845120"/>
      </c:scatterChart>
      <c:valAx>
        <c:axId val="171843584"/>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845120"/>
        <c:crosses val="autoZero"/>
        <c:crossBetween val="midCat"/>
      </c:valAx>
      <c:valAx>
        <c:axId val="171845120"/>
        <c:scaling>
          <c:orientation val="minMax"/>
          <c:max val="1"/>
          <c:min val="-3"/>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1843584"/>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38 up de no change prion'!$H$176</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round/>
              </a:ln>
              <a:effectLst/>
            </c:spPr>
          </c:errBars>
          <c:xVal>
            <c:numRef>
              <c:f>'338 up de no change prion'!$G$177:$G$340</c:f>
              <c:numCache>
                <c:formatCode>General</c:formatCode>
                <c:ptCount val="164"/>
                <c:pt idx="0">
                  <c:v>21566</c:v>
                </c:pt>
                <c:pt idx="1">
                  <c:v>535148</c:v>
                </c:pt>
                <c:pt idx="2">
                  <c:v>623341</c:v>
                </c:pt>
                <c:pt idx="3">
                  <c:v>644404</c:v>
                </c:pt>
                <c:pt idx="4">
                  <c:v>657916</c:v>
                </c:pt>
                <c:pt idx="5">
                  <c:v>779989</c:v>
                </c:pt>
                <c:pt idx="6">
                  <c:v>854711</c:v>
                </c:pt>
                <c:pt idx="7">
                  <c:v>956836</c:v>
                </c:pt>
                <c:pt idx="8">
                  <c:v>1017224</c:v>
                </c:pt>
                <c:pt idx="9">
                  <c:v>1019453</c:v>
                </c:pt>
                <c:pt idx="10">
                  <c:v>1027016</c:v>
                </c:pt>
                <c:pt idx="11">
                  <c:v>1066986</c:v>
                </c:pt>
                <c:pt idx="12">
                  <c:v>1198722</c:v>
                </c:pt>
                <c:pt idx="13">
                  <c:v>1233994</c:v>
                </c:pt>
                <c:pt idx="14">
                  <c:v>1254120</c:v>
                </c:pt>
                <c:pt idx="15">
                  <c:v>1420894</c:v>
                </c:pt>
                <c:pt idx="16">
                  <c:v>1426515</c:v>
                </c:pt>
                <c:pt idx="17">
                  <c:v>1529388</c:v>
                </c:pt>
                <c:pt idx="18">
                  <c:v>1577622</c:v>
                </c:pt>
                <c:pt idx="19">
                  <c:v>1666948</c:v>
                </c:pt>
                <c:pt idx="20">
                  <c:v>1690688</c:v>
                </c:pt>
                <c:pt idx="21">
                  <c:v>1701641</c:v>
                </c:pt>
                <c:pt idx="22">
                  <c:v>1773975</c:v>
                </c:pt>
                <c:pt idx="23">
                  <c:v>1881336</c:v>
                </c:pt>
                <c:pt idx="24">
                  <c:v>1939480</c:v>
                </c:pt>
                <c:pt idx="25">
                  <c:v>2051571</c:v>
                </c:pt>
                <c:pt idx="26">
                  <c:v>2341484</c:v>
                </c:pt>
                <c:pt idx="27">
                  <c:v>2522028</c:v>
                </c:pt>
                <c:pt idx="28">
                  <c:v>2522979</c:v>
                </c:pt>
                <c:pt idx="29">
                  <c:v>2634624</c:v>
                </c:pt>
                <c:pt idx="30">
                  <c:v>2654715</c:v>
                </c:pt>
                <c:pt idx="31">
                  <c:v>2854608</c:v>
                </c:pt>
                <c:pt idx="32">
                  <c:v>2861469</c:v>
                </c:pt>
                <c:pt idx="33">
                  <c:v>2918622</c:v>
                </c:pt>
                <c:pt idx="34">
                  <c:v>2944676</c:v>
                </c:pt>
                <c:pt idx="35">
                  <c:v>2955683</c:v>
                </c:pt>
                <c:pt idx="36">
                  <c:v>2977631</c:v>
                </c:pt>
                <c:pt idx="37">
                  <c:v>3129525</c:v>
                </c:pt>
                <c:pt idx="38">
                  <c:v>3154007</c:v>
                </c:pt>
                <c:pt idx="39">
                  <c:v>3161378</c:v>
                </c:pt>
                <c:pt idx="40">
                  <c:v>3360325</c:v>
                </c:pt>
                <c:pt idx="41">
                  <c:v>3432605</c:v>
                </c:pt>
                <c:pt idx="42">
                  <c:v>3517563</c:v>
                </c:pt>
                <c:pt idx="43">
                  <c:v>3744302</c:v>
                </c:pt>
                <c:pt idx="44">
                  <c:v>3910405</c:v>
                </c:pt>
                <c:pt idx="45">
                  <c:v>3993631</c:v>
                </c:pt>
                <c:pt idx="46">
                  <c:v>4011510</c:v>
                </c:pt>
                <c:pt idx="47">
                  <c:v>4019767</c:v>
                </c:pt>
                <c:pt idx="48">
                  <c:v>4096367</c:v>
                </c:pt>
                <c:pt idx="49">
                  <c:v>4175560</c:v>
                </c:pt>
                <c:pt idx="50">
                  <c:v>4176457</c:v>
                </c:pt>
                <c:pt idx="51">
                  <c:v>4215303</c:v>
                </c:pt>
                <c:pt idx="52">
                  <c:v>4222250</c:v>
                </c:pt>
                <c:pt idx="53">
                  <c:v>4282543</c:v>
                </c:pt>
                <c:pt idx="54">
                  <c:v>4332586</c:v>
                </c:pt>
                <c:pt idx="55">
                  <c:v>4374605</c:v>
                </c:pt>
                <c:pt idx="56">
                  <c:v>4390280</c:v>
                </c:pt>
                <c:pt idx="57">
                  <c:v>4441657</c:v>
                </c:pt>
                <c:pt idx="58">
                  <c:v>4541430</c:v>
                </c:pt>
                <c:pt idx="59">
                  <c:v>4609222</c:v>
                </c:pt>
                <c:pt idx="60">
                  <c:v>4649833</c:v>
                </c:pt>
                <c:pt idx="61">
                  <c:v>4654231</c:v>
                </c:pt>
                <c:pt idx="62">
                  <c:v>4718755</c:v>
                </c:pt>
                <c:pt idx="63">
                  <c:v>4800842</c:v>
                </c:pt>
                <c:pt idx="64">
                  <c:v>4964484</c:v>
                </c:pt>
                <c:pt idx="65">
                  <c:v>5051464</c:v>
                </c:pt>
                <c:pt idx="66">
                  <c:v>5111425</c:v>
                </c:pt>
                <c:pt idx="67">
                  <c:v>5132691</c:v>
                </c:pt>
                <c:pt idx="68">
                  <c:v>5205639</c:v>
                </c:pt>
                <c:pt idx="69">
                  <c:v>5207285</c:v>
                </c:pt>
                <c:pt idx="70">
                  <c:v>5211470</c:v>
                </c:pt>
                <c:pt idx="71">
                  <c:v>5273758</c:v>
                </c:pt>
                <c:pt idx="72">
                  <c:v>5284159</c:v>
                </c:pt>
                <c:pt idx="73">
                  <c:v>5426660</c:v>
                </c:pt>
                <c:pt idx="74">
                  <c:v>5429472</c:v>
                </c:pt>
                <c:pt idx="75">
                  <c:v>5453586</c:v>
                </c:pt>
                <c:pt idx="76">
                  <c:v>5564324</c:v>
                </c:pt>
                <c:pt idx="77">
                  <c:v>5613654</c:v>
                </c:pt>
                <c:pt idx="78">
                  <c:v>5630672</c:v>
                </c:pt>
                <c:pt idx="79">
                  <c:v>5642564</c:v>
                </c:pt>
                <c:pt idx="80">
                  <c:v>5657688</c:v>
                </c:pt>
                <c:pt idx="81">
                  <c:v>5700774</c:v>
                </c:pt>
                <c:pt idx="82">
                  <c:v>5701175</c:v>
                </c:pt>
                <c:pt idx="83">
                  <c:v>5709341</c:v>
                </c:pt>
                <c:pt idx="84">
                  <c:v>5786457</c:v>
                </c:pt>
                <c:pt idx="85">
                  <c:v>5801041</c:v>
                </c:pt>
                <c:pt idx="86">
                  <c:v>5854434</c:v>
                </c:pt>
                <c:pt idx="87">
                  <c:v>5923247</c:v>
                </c:pt>
                <c:pt idx="88">
                  <c:v>5933611</c:v>
                </c:pt>
                <c:pt idx="89">
                  <c:v>5939355</c:v>
                </c:pt>
                <c:pt idx="90">
                  <c:v>5972027</c:v>
                </c:pt>
                <c:pt idx="91">
                  <c:v>6022177</c:v>
                </c:pt>
                <c:pt idx="92">
                  <c:v>6057516</c:v>
                </c:pt>
                <c:pt idx="93">
                  <c:v>6122336</c:v>
                </c:pt>
                <c:pt idx="94">
                  <c:v>6123797</c:v>
                </c:pt>
                <c:pt idx="95">
                  <c:v>6226428</c:v>
                </c:pt>
                <c:pt idx="96">
                  <c:v>6411321</c:v>
                </c:pt>
                <c:pt idx="97">
                  <c:v>6497679</c:v>
                </c:pt>
                <c:pt idx="98">
                  <c:v>6534488</c:v>
                </c:pt>
                <c:pt idx="99">
                  <c:v>6603427</c:v>
                </c:pt>
                <c:pt idx="100">
                  <c:v>6691427</c:v>
                </c:pt>
                <c:pt idx="101">
                  <c:v>6747419</c:v>
                </c:pt>
                <c:pt idx="102">
                  <c:v>6843001</c:v>
                </c:pt>
                <c:pt idx="103">
                  <c:v>6887418</c:v>
                </c:pt>
                <c:pt idx="104">
                  <c:v>7190877</c:v>
                </c:pt>
                <c:pt idx="105">
                  <c:v>7217113</c:v>
                </c:pt>
                <c:pt idx="106">
                  <c:v>7266166</c:v>
                </c:pt>
                <c:pt idx="107">
                  <c:v>7372551</c:v>
                </c:pt>
                <c:pt idx="108">
                  <c:v>7474405</c:v>
                </c:pt>
                <c:pt idx="109">
                  <c:v>7474994</c:v>
                </c:pt>
                <c:pt idx="110">
                  <c:v>7568572</c:v>
                </c:pt>
                <c:pt idx="111">
                  <c:v>7581259</c:v>
                </c:pt>
                <c:pt idx="112">
                  <c:v>7615419</c:v>
                </c:pt>
                <c:pt idx="113">
                  <c:v>7635982</c:v>
                </c:pt>
                <c:pt idx="114">
                  <c:v>7660829</c:v>
                </c:pt>
                <c:pt idx="115">
                  <c:v>7744606</c:v>
                </c:pt>
                <c:pt idx="116">
                  <c:v>7788996</c:v>
                </c:pt>
                <c:pt idx="117">
                  <c:v>7824346</c:v>
                </c:pt>
                <c:pt idx="118">
                  <c:v>8040601</c:v>
                </c:pt>
                <c:pt idx="119">
                  <c:v>8050915</c:v>
                </c:pt>
                <c:pt idx="120">
                  <c:v>8112382</c:v>
                </c:pt>
                <c:pt idx="121">
                  <c:v>8143679</c:v>
                </c:pt>
                <c:pt idx="122">
                  <c:v>8144208</c:v>
                </c:pt>
                <c:pt idx="123">
                  <c:v>8198381</c:v>
                </c:pt>
                <c:pt idx="124">
                  <c:v>8251406</c:v>
                </c:pt>
                <c:pt idx="125">
                  <c:v>8347242</c:v>
                </c:pt>
                <c:pt idx="126">
                  <c:v>8579297</c:v>
                </c:pt>
                <c:pt idx="127">
                  <c:v>8872941</c:v>
                </c:pt>
                <c:pt idx="128">
                  <c:v>8875133</c:v>
                </c:pt>
                <c:pt idx="129">
                  <c:v>9094006</c:v>
                </c:pt>
                <c:pt idx="130">
                  <c:v>9255966</c:v>
                </c:pt>
                <c:pt idx="131">
                  <c:v>9262468</c:v>
                </c:pt>
                <c:pt idx="132">
                  <c:v>9578958</c:v>
                </c:pt>
                <c:pt idx="133">
                  <c:v>9660407</c:v>
                </c:pt>
                <c:pt idx="134">
                  <c:v>9661275</c:v>
                </c:pt>
                <c:pt idx="135">
                  <c:v>9758176</c:v>
                </c:pt>
                <c:pt idx="136">
                  <c:v>9801016</c:v>
                </c:pt>
                <c:pt idx="137">
                  <c:v>9847572</c:v>
                </c:pt>
                <c:pt idx="138">
                  <c:v>9910549</c:v>
                </c:pt>
                <c:pt idx="139">
                  <c:v>9987587</c:v>
                </c:pt>
                <c:pt idx="140">
                  <c:v>10038144</c:v>
                </c:pt>
                <c:pt idx="141">
                  <c:v>10054494</c:v>
                </c:pt>
                <c:pt idx="142">
                  <c:v>10057242</c:v>
                </c:pt>
                <c:pt idx="143">
                  <c:v>10072717</c:v>
                </c:pt>
                <c:pt idx="144">
                  <c:v>10141145</c:v>
                </c:pt>
                <c:pt idx="145">
                  <c:v>10142266</c:v>
                </c:pt>
                <c:pt idx="146">
                  <c:v>10283236</c:v>
                </c:pt>
                <c:pt idx="147">
                  <c:v>10285118</c:v>
                </c:pt>
                <c:pt idx="148">
                  <c:v>10286266</c:v>
                </c:pt>
                <c:pt idx="149">
                  <c:v>10381648</c:v>
                </c:pt>
                <c:pt idx="150">
                  <c:v>10404767</c:v>
                </c:pt>
                <c:pt idx="151">
                  <c:v>10448316</c:v>
                </c:pt>
                <c:pt idx="152">
                  <c:v>10601898</c:v>
                </c:pt>
                <c:pt idx="153">
                  <c:v>10761977</c:v>
                </c:pt>
                <c:pt idx="154">
                  <c:v>10791295</c:v>
                </c:pt>
                <c:pt idx="155">
                  <c:v>10873302</c:v>
                </c:pt>
                <c:pt idx="156">
                  <c:v>10991171</c:v>
                </c:pt>
                <c:pt idx="157">
                  <c:v>11057225</c:v>
                </c:pt>
                <c:pt idx="158">
                  <c:v>11256303</c:v>
                </c:pt>
                <c:pt idx="159">
                  <c:v>11262880</c:v>
                </c:pt>
                <c:pt idx="160">
                  <c:v>11296412</c:v>
                </c:pt>
                <c:pt idx="161">
                  <c:v>11705633</c:v>
                </c:pt>
                <c:pt idx="162">
                  <c:v>11713543</c:v>
                </c:pt>
                <c:pt idx="163">
                  <c:v>12000107</c:v>
                </c:pt>
              </c:numCache>
            </c:numRef>
          </c:xVal>
          <c:yVal>
            <c:numRef>
              <c:f>'338 up de no change prion'!$H$177:$H$340</c:f>
              <c:numCache>
                <c:formatCode>General</c:formatCode>
                <c:ptCount val="164"/>
                <c:pt idx="0">
                  <c:v>-0.27469189839709957</c:v>
                </c:pt>
                <c:pt idx="1">
                  <c:v>0.67382555551883883</c:v>
                </c:pt>
                <c:pt idx="2">
                  <c:v>0.66128223391015528</c:v>
                </c:pt>
                <c:pt idx="3">
                  <c:v>0.14093179402404257</c:v>
                </c:pt>
                <c:pt idx="4">
                  <c:v>9.1415799410341669E-2</c:v>
                </c:pt>
                <c:pt idx="5">
                  <c:v>-7.4642669735747597E-2</c:v>
                </c:pt>
                <c:pt idx="6">
                  <c:v>-0.23970146137893647</c:v>
                </c:pt>
                <c:pt idx="7">
                  <c:v>0.45618377780240782</c:v>
                </c:pt>
                <c:pt idx="8">
                  <c:v>0.67077160105173605</c:v>
                </c:pt>
                <c:pt idx="9">
                  <c:v>-0.30351817293713934</c:v>
                </c:pt>
                <c:pt idx="10">
                  <c:v>0.19891651329339108</c:v>
                </c:pt>
                <c:pt idx="11">
                  <c:v>-8.1415370791117908E-2</c:v>
                </c:pt>
                <c:pt idx="12">
                  <c:v>1.6872003809915031E-2</c:v>
                </c:pt>
                <c:pt idx="13">
                  <c:v>-0.51020369465019411</c:v>
                </c:pt>
                <c:pt idx="14">
                  <c:v>0.72653340979355396</c:v>
                </c:pt>
                <c:pt idx="15">
                  <c:v>-0.20976018041406139</c:v>
                </c:pt>
                <c:pt idx="16">
                  <c:v>0.61552898246453158</c:v>
                </c:pt>
                <c:pt idx="17">
                  <c:v>-0.77905680880124384</c:v>
                </c:pt>
                <c:pt idx="18">
                  <c:v>0.32236054788184021</c:v>
                </c:pt>
                <c:pt idx="19">
                  <c:v>0.29278183798661178</c:v>
                </c:pt>
                <c:pt idx="20">
                  <c:v>0.87881192500084704</c:v>
                </c:pt>
                <c:pt idx="21">
                  <c:v>0.59500384125861872</c:v>
                </c:pt>
                <c:pt idx="22">
                  <c:v>-0.1634732237980259</c:v>
                </c:pt>
                <c:pt idx="23">
                  <c:v>0.94498783749871917</c:v>
                </c:pt>
                <c:pt idx="24">
                  <c:v>0.35242688347835593</c:v>
                </c:pt>
                <c:pt idx="25">
                  <c:v>0.23141357872493201</c:v>
                </c:pt>
                <c:pt idx="26">
                  <c:v>0.86147716423989817</c:v>
                </c:pt>
                <c:pt idx="27">
                  <c:v>0.25248171945795261</c:v>
                </c:pt>
                <c:pt idx="28">
                  <c:v>-0.61463770263935769</c:v>
                </c:pt>
                <c:pt idx="29">
                  <c:v>0.51047977063604599</c:v>
                </c:pt>
                <c:pt idx="30">
                  <c:v>0.40740405226871307</c:v>
                </c:pt>
                <c:pt idx="31">
                  <c:v>0.81281771804438041</c:v>
                </c:pt>
                <c:pt idx="32">
                  <c:v>0.43874277013759089</c:v>
                </c:pt>
                <c:pt idx="33">
                  <c:v>1.1219303067882753</c:v>
                </c:pt>
                <c:pt idx="34">
                  <c:v>0.37260588001208722</c:v>
                </c:pt>
                <c:pt idx="35">
                  <c:v>0.84303372289704481</c:v>
                </c:pt>
                <c:pt idx="36">
                  <c:v>0.41830771863280319</c:v>
                </c:pt>
                <c:pt idx="37">
                  <c:v>0.49204158409795679</c:v>
                </c:pt>
                <c:pt idx="38">
                  <c:v>0.70293548423267094</c:v>
                </c:pt>
                <c:pt idx="39">
                  <c:v>1.2239494916789084</c:v>
                </c:pt>
                <c:pt idx="40">
                  <c:v>0.47177859053669463</c:v>
                </c:pt>
                <c:pt idx="41">
                  <c:v>-0.670779382918964</c:v>
                </c:pt>
                <c:pt idx="42">
                  <c:v>1.1238884141366443</c:v>
                </c:pt>
                <c:pt idx="43">
                  <c:v>0.35165304660828028</c:v>
                </c:pt>
                <c:pt idx="44">
                  <c:v>0.20082433539050429</c:v>
                </c:pt>
                <c:pt idx="45">
                  <c:v>0.39301754830107272</c:v>
                </c:pt>
                <c:pt idx="46">
                  <c:v>0.18495548629990874</c:v>
                </c:pt>
                <c:pt idx="47">
                  <c:v>-0.36074461737032582</c:v>
                </c:pt>
                <c:pt idx="48">
                  <c:v>0.21958472391032127</c:v>
                </c:pt>
                <c:pt idx="49">
                  <c:v>0.71686799430845782</c:v>
                </c:pt>
                <c:pt idx="50">
                  <c:v>0.78428015325697031</c:v>
                </c:pt>
                <c:pt idx="51">
                  <c:v>-1.5347103995255975</c:v>
                </c:pt>
                <c:pt idx="52">
                  <c:v>0.47942114638454975</c:v>
                </c:pt>
                <c:pt idx="53">
                  <c:v>-0.56414237170688619</c:v>
                </c:pt>
                <c:pt idx="54">
                  <c:v>-9.0989196308229242E-2</c:v>
                </c:pt>
                <c:pt idx="55">
                  <c:v>0.19037586911007048</c:v>
                </c:pt>
                <c:pt idx="56">
                  <c:v>1.0570980763751925</c:v>
                </c:pt>
                <c:pt idx="57">
                  <c:v>-2.3124853990374419</c:v>
                </c:pt>
                <c:pt idx="58">
                  <c:v>-0.51855203036659947</c:v>
                </c:pt>
                <c:pt idx="59">
                  <c:v>3.8999561171946293E-2</c:v>
                </c:pt>
                <c:pt idx="60">
                  <c:v>0.76419911938846052</c:v>
                </c:pt>
                <c:pt idx="61">
                  <c:v>0.75022027978758454</c:v>
                </c:pt>
                <c:pt idx="62">
                  <c:v>0.22020810690077894</c:v>
                </c:pt>
                <c:pt idx="63">
                  <c:v>1.2691113218692165</c:v>
                </c:pt>
                <c:pt idx="64">
                  <c:v>0.57565504042752591</c:v>
                </c:pt>
                <c:pt idx="65">
                  <c:v>-1.1349068517261429</c:v>
                </c:pt>
                <c:pt idx="66">
                  <c:v>1.1457782652150968E-2</c:v>
                </c:pt>
                <c:pt idx="67">
                  <c:v>0.81801524733297848</c:v>
                </c:pt>
                <c:pt idx="68">
                  <c:v>0.85882972581575268</c:v>
                </c:pt>
                <c:pt idx="69">
                  <c:v>-0.27230727061598126</c:v>
                </c:pt>
                <c:pt idx="70">
                  <c:v>-0.4220334851965773</c:v>
                </c:pt>
                <c:pt idx="71">
                  <c:v>0.81755587435027954</c:v>
                </c:pt>
                <c:pt idx="72">
                  <c:v>0.45293245349634514</c:v>
                </c:pt>
                <c:pt idx="73">
                  <c:v>0.26839282512720386</c:v>
                </c:pt>
                <c:pt idx="74">
                  <c:v>0.38001925192656344</c:v>
                </c:pt>
                <c:pt idx="75">
                  <c:v>0.39990062399465104</c:v>
                </c:pt>
                <c:pt idx="76">
                  <c:v>-0.20712066683988903</c:v>
                </c:pt>
                <c:pt idx="77">
                  <c:v>-0.54849623659245228</c:v>
                </c:pt>
                <c:pt idx="78">
                  <c:v>0.56687783838689998</c:v>
                </c:pt>
                <c:pt idx="79">
                  <c:v>0.49546755395555503</c:v>
                </c:pt>
                <c:pt idx="80">
                  <c:v>0.28454411415393716</c:v>
                </c:pt>
                <c:pt idx="81">
                  <c:v>-0.305014914872142</c:v>
                </c:pt>
                <c:pt idx="82">
                  <c:v>0.56322517355914203</c:v>
                </c:pt>
                <c:pt idx="83">
                  <c:v>0.83960307021205194</c:v>
                </c:pt>
                <c:pt idx="84">
                  <c:v>-0.21542829378919603</c:v>
                </c:pt>
                <c:pt idx="85">
                  <c:v>0.64467450455347675</c:v>
                </c:pt>
                <c:pt idx="86">
                  <c:v>-0.63331607478008822</c:v>
                </c:pt>
                <c:pt idx="87">
                  <c:v>1.2264923561180625</c:v>
                </c:pt>
                <c:pt idx="88">
                  <c:v>-2.3619368176684519E-3</c:v>
                </c:pt>
                <c:pt idx="89">
                  <c:v>-0.1403510616165046</c:v>
                </c:pt>
                <c:pt idx="90">
                  <c:v>0.71974797466838691</c:v>
                </c:pt>
                <c:pt idx="91">
                  <c:v>1.0047181620660479</c:v>
                </c:pt>
                <c:pt idx="92">
                  <c:v>-0.51976954719625401</c:v>
                </c:pt>
                <c:pt idx="93">
                  <c:v>0.20297780120109427</c:v>
                </c:pt>
                <c:pt idx="94">
                  <c:v>1.2550003960503517</c:v>
                </c:pt>
                <c:pt idx="95">
                  <c:v>1.4184559782759745</c:v>
                </c:pt>
                <c:pt idx="96">
                  <c:v>-0.62435193077032802</c:v>
                </c:pt>
                <c:pt idx="97">
                  <c:v>-0.88686874299700935</c:v>
                </c:pt>
                <c:pt idx="98">
                  <c:v>0.44204440832280251</c:v>
                </c:pt>
                <c:pt idx="99">
                  <c:v>-0.22264255134538394</c:v>
                </c:pt>
                <c:pt idx="100">
                  <c:v>-0.37744373982940121</c:v>
                </c:pt>
                <c:pt idx="101">
                  <c:v>0.21424609546783113</c:v>
                </c:pt>
                <c:pt idx="102">
                  <c:v>-1.2007093589070063E-2</c:v>
                </c:pt>
                <c:pt idx="103">
                  <c:v>-9.9427360645373566E-2</c:v>
                </c:pt>
                <c:pt idx="104">
                  <c:v>9.9932604582843851E-2</c:v>
                </c:pt>
                <c:pt idx="105">
                  <c:v>-0.43854327486147499</c:v>
                </c:pt>
                <c:pt idx="106">
                  <c:v>1.1834735173732069</c:v>
                </c:pt>
                <c:pt idx="107">
                  <c:v>-3.8752904419736708E-2</c:v>
                </c:pt>
                <c:pt idx="108">
                  <c:v>-0.93166637811408959</c:v>
                </c:pt>
                <c:pt idx="109">
                  <c:v>1.8284095921860882E-3</c:v>
                </c:pt>
                <c:pt idx="110">
                  <c:v>-0.48073975654847373</c:v>
                </c:pt>
                <c:pt idx="111">
                  <c:v>0.14208784600738106</c:v>
                </c:pt>
                <c:pt idx="112">
                  <c:v>3.0005392385986054E-2</c:v>
                </c:pt>
                <c:pt idx="113">
                  <c:v>-1.5978183176915213</c:v>
                </c:pt>
                <c:pt idx="114">
                  <c:v>0.57119895884005312</c:v>
                </c:pt>
                <c:pt idx="115">
                  <c:v>-0.35656003753102089</c:v>
                </c:pt>
                <c:pt idx="116">
                  <c:v>-0.10273807162627077</c:v>
                </c:pt>
                <c:pt idx="117">
                  <c:v>-0.81291693879772853</c:v>
                </c:pt>
                <c:pt idx="118">
                  <c:v>0.10333204951309959</c:v>
                </c:pt>
                <c:pt idx="119">
                  <c:v>-1.008836497278951</c:v>
                </c:pt>
                <c:pt idx="120">
                  <c:v>0.3546163132764919</c:v>
                </c:pt>
                <c:pt idx="121">
                  <c:v>1.2337808830674706</c:v>
                </c:pt>
                <c:pt idx="122">
                  <c:v>1.0199621163752186</c:v>
                </c:pt>
                <c:pt idx="123">
                  <c:v>-0.96795884423682554</c:v>
                </c:pt>
                <c:pt idx="124">
                  <c:v>-0.64230958938341265</c:v>
                </c:pt>
                <c:pt idx="125">
                  <c:v>-0.36944001144615546</c:v>
                </c:pt>
                <c:pt idx="126">
                  <c:v>0.56839701218005279</c:v>
                </c:pt>
                <c:pt idx="127">
                  <c:v>0.44250578859923745</c:v>
                </c:pt>
                <c:pt idx="128">
                  <c:v>-1.4054770454455192</c:v>
                </c:pt>
                <c:pt idx="129">
                  <c:v>0.74570712832101527</c:v>
                </c:pt>
                <c:pt idx="130">
                  <c:v>-0.23606329885043648</c:v>
                </c:pt>
                <c:pt idx="131">
                  <c:v>-0.4405647004841815</c:v>
                </c:pt>
                <c:pt idx="132">
                  <c:v>1.6691665047768942</c:v>
                </c:pt>
                <c:pt idx="133">
                  <c:v>-1.2444640729917533</c:v>
                </c:pt>
                <c:pt idx="134">
                  <c:v>0.9042154464169776</c:v>
                </c:pt>
                <c:pt idx="135">
                  <c:v>0.58388264031483628</c:v>
                </c:pt>
                <c:pt idx="136">
                  <c:v>0.44304743455237217</c:v>
                </c:pt>
                <c:pt idx="137">
                  <c:v>-1.1324311624090353</c:v>
                </c:pt>
                <c:pt idx="138">
                  <c:v>8.3598550514977513E-2</c:v>
                </c:pt>
                <c:pt idx="139">
                  <c:v>0.29223949333939858</c:v>
                </c:pt>
                <c:pt idx="140">
                  <c:v>1.2248510648183095</c:v>
                </c:pt>
                <c:pt idx="141">
                  <c:v>0.3456955217392631</c:v>
                </c:pt>
                <c:pt idx="142">
                  <c:v>0.59446253181310205</c:v>
                </c:pt>
                <c:pt idx="143">
                  <c:v>0.56343827609519337</c:v>
                </c:pt>
                <c:pt idx="144">
                  <c:v>-0.76383491867073761</c:v>
                </c:pt>
                <c:pt idx="145">
                  <c:v>-0.47032345628411504</c:v>
                </c:pt>
                <c:pt idx="146">
                  <c:v>0.16247390290809502</c:v>
                </c:pt>
                <c:pt idx="147">
                  <c:v>-0.13525019266511948</c:v>
                </c:pt>
                <c:pt idx="148">
                  <c:v>-0.99044298434300571</c:v>
                </c:pt>
                <c:pt idx="149">
                  <c:v>0.22283355588427597</c:v>
                </c:pt>
                <c:pt idx="150">
                  <c:v>0.22664213676063308</c:v>
                </c:pt>
                <c:pt idx="151">
                  <c:v>2.2003470807602334</c:v>
                </c:pt>
                <c:pt idx="152">
                  <c:v>-0.51738914468632291</c:v>
                </c:pt>
                <c:pt idx="153">
                  <c:v>0.19734995951152084</c:v>
                </c:pt>
                <c:pt idx="154">
                  <c:v>-0.12178175195238597</c:v>
                </c:pt>
                <c:pt idx="155">
                  <c:v>0.5585109392932075</c:v>
                </c:pt>
                <c:pt idx="156">
                  <c:v>0.9048023266808809</c:v>
                </c:pt>
                <c:pt idx="157">
                  <c:v>-0.30075129691858321</c:v>
                </c:pt>
                <c:pt idx="158">
                  <c:v>0.12352280843759805</c:v>
                </c:pt>
                <c:pt idx="159">
                  <c:v>1.784089468871312</c:v>
                </c:pt>
                <c:pt idx="160">
                  <c:v>0.37692199305552787</c:v>
                </c:pt>
                <c:pt idx="161">
                  <c:v>0.38752246694278142</c:v>
                </c:pt>
                <c:pt idx="162">
                  <c:v>-0.40782802217694814</c:v>
                </c:pt>
                <c:pt idx="163">
                  <c:v>0.83151525406087201</c:v>
                </c:pt>
              </c:numCache>
            </c:numRef>
          </c:yVal>
          <c:smooth val="0"/>
          <c:extLst>
            <c:ext xmlns:c16="http://schemas.microsoft.com/office/drawing/2014/chart" uri="{C3380CC4-5D6E-409C-BE32-E72D297353CC}">
              <c16:uniqueId val="{00000000-6C76-4294-9F0D-47CCD1310791}"/>
            </c:ext>
          </c:extLst>
        </c:ser>
        <c:ser>
          <c:idx val="1"/>
          <c:order val="1"/>
          <c:tx>
            <c:strRef>
              <c:f>'338 up de no change prion'!$I$176</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C00000"/>
                </a:solidFill>
                <a:round/>
              </a:ln>
              <a:effectLst/>
            </c:spPr>
          </c:errBars>
          <c:xVal>
            <c:numRef>
              <c:f>'338 up de no change prion'!$G$177:$G$340</c:f>
              <c:numCache>
                <c:formatCode>General</c:formatCode>
                <c:ptCount val="164"/>
                <c:pt idx="0">
                  <c:v>21566</c:v>
                </c:pt>
                <c:pt idx="1">
                  <c:v>535148</c:v>
                </c:pt>
                <c:pt idx="2">
                  <c:v>623341</c:v>
                </c:pt>
                <c:pt idx="3">
                  <c:v>644404</c:v>
                </c:pt>
                <c:pt idx="4">
                  <c:v>657916</c:v>
                </c:pt>
                <c:pt idx="5">
                  <c:v>779989</c:v>
                </c:pt>
                <c:pt idx="6">
                  <c:v>854711</c:v>
                </c:pt>
                <c:pt idx="7">
                  <c:v>956836</c:v>
                </c:pt>
                <c:pt idx="8">
                  <c:v>1017224</c:v>
                </c:pt>
                <c:pt idx="9">
                  <c:v>1019453</c:v>
                </c:pt>
                <c:pt idx="10">
                  <c:v>1027016</c:v>
                </c:pt>
                <c:pt idx="11">
                  <c:v>1066986</c:v>
                </c:pt>
                <c:pt idx="12">
                  <c:v>1198722</c:v>
                </c:pt>
                <c:pt idx="13">
                  <c:v>1233994</c:v>
                </c:pt>
                <c:pt idx="14">
                  <c:v>1254120</c:v>
                </c:pt>
                <c:pt idx="15">
                  <c:v>1420894</c:v>
                </c:pt>
                <c:pt idx="16">
                  <c:v>1426515</c:v>
                </c:pt>
                <c:pt idx="17">
                  <c:v>1529388</c:v>
                </c:pt>
                <c:pt idx="18">
                  <c:v>1577622</c:v>
                </c:pt>
                <c:pt idx="19">
                  <c:v>1666948</c:v>
                </c:pt>
                <c:pt idx="20">
                  <c:v>1690688</c:v>
                </c:pt>
                <c:pt idx="21">
                  <c:v>1701641</c:v>
                </c:pt>
                <c:pt idx="22">
                  <c:v>1773975</c:v>
                </c:pt>
                <c:pt idx="23">
                  <c:v>1881336</c:v>
                </c:pt>
                <c:pt idx="24">
                  <c:v>1939480</c:v>
                </c:pt>
                <c:pt idx="25">
                  <c:v>2051571</c:v>
                </c:pt>
                <c:pt idx="26">
                  <c:v>2341484</c:v>
                </c:pt>
                <c:pt idx="27">
                  <c:v>2522028</c:v>
                </c:pt>
                <c:pt idx="28">
                  <c:v>2522979</c:v>
                </c:pt>
                <c:pt idx="29">
                  <c:v>2634624</c:v>
                </c:pt>
                <c:pt idx="30">
                  <c:v>2654715</c:v>
                </c:pt>
                <c:pt idx="31">
                  <c:v>2854608</c:v>
                </c:pt>
                <c:pt idx="32">
                  <c:v>2861469</c:v>
                </c:pt>
                <c:pt idx="33">
                  <c:v>2918622</c:v>
                </c:pt>
                <c:pt idx="34">
                  <c:v>2944676</c:v>
                </c:pt>
                <c:pt idx="35">
                  <c:v>2955683</c:v>
                </c:pt>
                <c:pt idx="36">
                  <c:v>2977631</c:v>
                </c:pt>
                <c:pt idx="37">
                  <c:v>3129525</c:v>
                </c:pt>
                <c:pt idx="38">
                  <c:v>3154007</c:v>
                </c:pt>
                <c:pt idx="39">
                  <c:v>3161378</c:v>
                </c:pt>
                <c:pt idx="40">
                  <c:v>3360325</c:v>
                </c:pt>
                <c:pt idx="41">
                  <c:v>3432605</c:v>
                </c:pt>
                <c:pt idx="42">
                  <c:v>3517563</c:v>
                </c:pt>
                <c:pt idx="43">
                  <c:v>3744302</c:v>
                </c:pt>
                <c:pt idx="44">
                  <c:v>3910405</c:v>
                </c:pt>
                <c:pt idx="45">
                  <c:v>3993631</c:v>
                </c:pt>
                <c:pt idx="46">
                  <c:v>4011510</c:v>
                </c:pt>
                <c:pt idx="47">
                  <c:v>4019767</c:v>
                </c:pt>
                <c:pt idx="48">
                  <c:v>4096367</c:v>
                </c:pt>
                <c:pt idx="49">
                  <c:v>4175560</c:v>
                </c:pt>
                <c:pt idx="50">
                  <c:v>4176457</c:v>
                </c:pt>
                <c:pt idx="51">
                  <c:v>4215303</c:v>
                </c:pt>
                <c:pt idx="52">
                  <c:v>4222250</c:v>
                </c:pt>
                <c:pt idx="53">
                  <c:v>4282543</c:v>
                </c:pt>
                <c:pt idx="54">
                  <c:v>4332586</c:v>
                </c:pt>
                <c:pt idx="55">
                  <c:v>4374605</c:v>
                </c:pt>
                <c:pt idx="56">
                  <c:v>4390280</c:v>
                </c:pt>
                <c:pt idx="57">
                  <c:v>4441657</c:v>
                </c:pt>
                <c:pt idx="58">
                  <c:v>4541430</c:v>
                </c:pt>
                <c:pt idx="59">
                  <c:v>4609222</c:v>
                </c:pt>
                <c:pt idx="60">
                  <c:v>4649833</c:v>
                </c:pt>
                <c:pt idx="61">
                  <c:v>4654231</c:v>
                </c:pt>
                <c:pt idx="62">
                  <c:v>4718755</c:v>
                </c:pt>
                <c:pt idx="63">
                  <c:v>4800842</c:v>
                </c:pt>
                <c:pt idx="64">
                  <c:v>4964484</c:v>
                </c:pt>
                <c:pt idx="65">
                  <c:v>5051464</c:v>
                </c:pt>
                <c:pt idx="66">
                  <c:v>5111425</c:v>
                </c:pt>
                <c:pt idx="67">
                  <c:v>5132691</c:v>
                </c:pt>
                <c:pt idx="68">
                  <c:v>5205639</c:v>
                </c:pt>
                <c:pt idx="69">
                  <c:v>5207285</c:v>
                </c:pt>
                <c:pt idx="70">
                  <c:v>5211470</c:v>
                </c:pt>
                <c:pt idx="71">
                  <c:v>5273758</c:v>
                </c:pt>
                <c:pt idx="72">
                  <c:v>5284159</c:v>
                </c:pt>
                <c:pt idx="73">
                  <c:v>5426660</c:v>
                </c:pt>
                <c:pt idx="74">
                  <c:v>5429472</c:v>
                </c:pt>
                <c:pt idx="75">
                  <c:v>5453586</c:v>
                </c:pt>
                <c:pt idx="76">
                  <c:v>5564324</c:v>
                </c:pt>
                <c:pt idx="77">
                  <c:v>5613654</c:v>
                </c:pt>
                <c:pt idx="78">
                  <c:v>5630672</c:v>
                </c:pt>
                <c:pt idx="79">
                  <c:v>5642564</c:v>
                </c:pt>
                <c:pt idx="80">
                  <c:v>5657688</c:v>
                </c:pt>
                <c:pt idx="81">
                  <c:v>5700774</c:v>
                </c:pt>
                <c:pt idx="82">
                  <c:v>5701175</c:v>
                </c:pt>
                <c:pt idx="83">
                  <c:v>5709341</c:v>
                </c:pt>
                <c:pt idx="84">
                  <c:v>5786457</c:v>
                </c:pt>
                <c:pt idx="85">
                  <c:v>5801041</c:v>
                </c:pt>
                <c:pt idx="86">
                  <c:v>5854434</c:v>
                </c:pt>
                <c:pt idx="87">
                  <c:v>5923247</c:v>
                </c:pt>
                <c:pt idx="88">
                  <c:v>5933611</c:v>
                </c:pt>
                <c:pt idx="89">
                  <c:v>5939355</c:v>
                </c:pt>
                <c:pt idx="90">
                  <c:v>5972027</c:v>
                </c:pt>
                <c:pt idx="91">
                  <c:v>6022177</c:v>
                </c:pt>
                <c:pt idx="92">
                  <c:v>6057516</c:v>
                </c:pt>
                <c:pt idx="93">
                  <c:v>6122336</c:v>
                </c:pt>
                <c:pt idx="94">
                  <c:v>6123797</c:v>
                </c:pt>
                <c:pt idx="95">
                  <c:v>6226428</c:v>
                </c:pt>
                <c:pt idx="96">
                  <c:v>6411321</c:v>
                </c:pt>
                <c:pt idx="97">
                  <c:v>6497679</c:v>
                </c:pt>
                <c:pt idx="98">
                  <c:v>6534488</c:v>
                </c:pt>
                <c:pt idx="99">
                  <c:v>6603427</c:v>
                </c:pt>
                <c:pt idx="100">
                  <c:v>6691427</c:v>
                </c:pt>
                <c:pt idx="101">
                  <c:v>6747419</c:v>
                </c:pt>
                <c:pt idx="102">
                  <c:v>6843001</c:v>
                </c:pt>
                <c:pt idx="103">
                  <c:v>6887418</c:v>
                </c:pt>
                <c:pt idx="104">
                  <c:v>7190877</c:v>
                </c:pt>
                <c:pt idx="105">
                  <c:v>7217113</c:v>
                </c:pt>
                <c:pt idx="106">
                  <c:v>7266166</c:v>
                </c:pt>
                <c:pt idx="107">
                  <c:v>7372551</c:v>
                </c:pt>
                <c:pt idx="108">
                  <c:v>7474405</c:v>
                </c:pt>
                <c:pt idx="109">
                  <c:v>7474994</c:v>
                </c:pt>
                <c:pt idx="110">
                  <c:v>7568572</c:v>
                </c:pt>
                <c:pt idx="111">
                  <c:v>7581259</c:v>
                </c:pt>
                <c:pt idx="112">
                  <c:v>7615419</c:v>
                </c:pt>
                <c:pt idx="113">
                  <c:v>7635982</c:v>
                </c:pt>
                <c:pt idx="114">
                  <c:v>7660829</c:v>
                </c:pt>
                <c:pt idx="115">
                  <c:v>7744606</c:v>
                </c:pt>
                <c:pt idx="116">
                  <c:v>7788996</c:v>
                </c:pt>
                <c:pt idx="117">
                  <c:v>7824346</c:v>
                </c:pt>
                <c:pt idx="118">
                  <c:v>8040601</c:v>
                </c:pt>
                <c:pt idx="119">
                  <c:v>8050915</c:v>
                </c:pt>
                <c:pt idx="120">
                  <c:v>8112382</c:v>
                </c:pt>
                <c:pt idx="121">
                  <c:v>8143679</c:v>
                </c:pt>
                <c:pt idx="122">
                  <c:v>8144208</c:v>
                </c:pt>
                <c:pt idx="123">
                  <c:v>8198381</c:v>
                </c:pt>
                <c:pt idx="124">
                  <c:v>8251406</c:v>
                </c:pt>
                <c:pt idx="125">
                  <c:v>8347242</c:v>
                </c:pt>
                <c:pt idx="126">
                  <c:v>8579297</c:v>
                </c:pt>
                <c:pt idx="127">
                  <c:v>8872941</c:v>
                </c:pt>
                <c:pt idx="128">
                  <c:v>8875133</c:v>
                </c:pt>
                <c:pt idx="129">
                  <c:v>9094006</c:v>
                </c:pt>
                <c:pt idx="130">
                  <c:v>9255966</c:v>
                </c:pt>
                <c:pt idx="131">
                  <c:v>9262468</c:v>
                </c:pt>
                <c:pt idx="132">
                  <c:v>9578958</c:v>
                </c:pt>
                <c:pt idx="133">
                  <c:v>9660407</c:v>
                </c:pt>
                <c:pt idx="134">
                  <c:v>9661275</c:v>
                </c:pt>
                <c:pt idx="135">
                  <c:v>9758176</c:v>
                </c:pt>
                <c:pt idx="136">
                  <c:v>9801016</c:v>
                </c:pt>
                <c:pt idx="137">
                  <c:v>9847572</c:v>
                </c:pt>
                <c:pt idx="138">
                  <c:v>9910549</c:v>
                </c:pt>
                <c:pt idx="139">
                  <c:v>9987587</c:v>
                </c:pt>
                <c:pt idx="140">
                  <c:v>10038144</c:v>
                </c:pt>
                <c:pt idx="141">
                  <c:v>10054494</c:v>
                </c:pt>
                <c:pt idx="142">
                  <c:v>10057242</c:v>
                </c:pt>
                <c:pt idx="143">
                  <c:v>10072717</c:v>
                </c:pt>
                <c:pt idx="144">
                  <c:v>10141145</c:v>
                </c:pt>
                <c:pt idx="145">
                  <c:v>10142266</c:v>
                </c:pt>
                <c:pt idx="146">
                  <c:v>10283236</c:v>
                </c:pt>
                <c:pt idx="147">
                  <c:v>10285118</c:v>
                </c:pt>
                <c:pt idx="148">
                  <c:v>10286266</c:v>
                </c:pt>
                <c:pt idx="149">
                  <c:v>10381648</c:v>
                </c:pt>
                <c:pt idx="150">
                  <c:v>10404767</c:v>
                </c:pt>
                <c:pt idx="151">
                  <c:v>10448316</c:v>
                </c:pt>
                <c:pt idx="152">
                  <c:v>10601898</c:v>
                </c:pt>
                <c:pt idx="153">
                  <c:v>10761977</c:v>
                </c:pt>
                <c:pt idx="154">
                  <c:v>10791295</c:v>
                </c:pt>
                <c:pt idx="155">
                  <c:v>10873302</c:v>
                </c:pt>
                <c:pt idx="156">
                  <c:v>10991171</c:v>
                </c:pt>
                <c:pt idx="157">
                  <c:v>11057225</c:v>
                </c:pt>
                <c:pt idx="158">
                  <c:v>11256303</c:v>
                </c:pt>
                <c:pt idx="159">
                  <c:v>11262880</c:v>
                </c:pt>
                <c:pt idx="160">
                  <c:v>11296412</c:v>
                </c:pt>
                <c:pt idx="161">
                  <c:v>11705633</c:v>
                </c:pt>
                <c:pt idx="162">
                  <c:v>11713543</c:v>
                </c:pt>
                <c:pt idx="163">
                  <c:v>12000107</c:v>
                </c:pt>
              </c:numCache>
            </c:numRef>
          </c:xVal>
          <c:yVal>
            <c:numRef>
              <c:f>'338 up de no change prion'!$I$177:$I$340</c:f>
              <c:numCache>
                <c:formatCode>General</c:formatCode>
                <c:ptCount val="164"/>
                <c:pt idx="0">
                  <c:v>1.267338847696317</c:v>
                </c:pt>
                <c:pt idx="1">
                  <c:v>2.1785677417975431</c:v>
                </c:pt>
                <c:pt idx="2">
                  <c:v>1.7956088925931379</c:v>
                </c:pt>
                <c:pt idx="3">
                  <c:v>3.2033504945555809</c:v>
                </c:pt>
                <c:pt idx="4">
                  <c:v>1.6418980673492405</c:v>
                </c:pt>
                <c:pt idx="5">
                  <c:v>1.2047557616766045</c:v>
                </c:pt>
                <c:pt idx="6">
                  <c:v>1.1318068721990315</c:v>
                </c:pt>
                <c:pt idx="7">
                  <c:v>1.3974322115725948</c:v>
                </c:pt>
                <c:pt idx="8">
                  <c:v>1.0135489784495775</c:v>
                </c:pt>
                <c:pt idx="9">
                  <c:v>1.3843906051456463</c:v>
                </c:pt>
                <c:pt idx="10">
                  <c:v>3.2363755075862306</c:v>
                </c:pt>
                <c:pt idx="11">
                  <c:v>1.025301842747395</c:v>
                </c:pt>
                <c:pt idx="12">
                  <c:v>1.2220038521885388</c:v>
                </c:pt>
                <c:pt idx="13">
                  <c:v>1.4449249217571418</c:v>
                </c:pt>
                <c:pt idx="14">
                  <c:v>1.0317058087694775</c:v>
                </c:pt>
                <c:pt idx="15">
                  <c:v>1.1984498583622185</c:v>
                </c:pt>
                <c:pt idx="16">
                  <c:v>1.3370685500424304</c:v>
                </c:pt>
                <c:pt idx="17">
                  <c:v>1.1278702175928437</c:v>
                </c:pt>
                <c:pt idx="18">
                  <c:v>1.0286098050051631</c:v>
                </c:pt>
                <c:pt idx="19">
                  <c:v>1.3971226456789356</c:v>
                </c:pt>
                <c:pt idx="20">
                  <c:v>1.2323484570628613</c:v>
                </c:pt>
                <c:pt idx="21">
                  <c:v>1.0217283707040998</c:v>
                </c:pt>
                <c:pt idx="22">
                  <c:v>1.0941057483522907</c:v>
                </c:pt>
                <c:pt idx="23">
                  <c:v>1.0476114103961891</c:v>
                </c:pt>
                <c:pt idx="24">
                  <c:v>2.6024871504435985</c:v>
                </c:pt>
                <c:pt idx="25">
                  <c:v>1.0406883593286642</c:v>
                </c:pt>
                <c:pt idx="26">
                  <c:v>2.2711123154292743</c:v>
                </c:pt>
                <c:pt idx="27">
                  <c:v>1.0336760557436961</c:v>
                </c:pt>
                <c:pt idx="28">
                  <c:v>1.0620812589205664</c:v>
                </c:pt>
                <c:pt idx="29">
                  <c:v>1.0326976742946763</c:v>
                </c:pt>
                <c:pt idx="30">
                  <c:v>1.602786711596079</c:v>
                </c:pt>
                <c:pt idx="31">
                  <c:v>1.3295236284865546</c:v>
                </c:pt>
                <c:pt idx="32">
                  <c:v>1.2145247580591416</c:v>
                </c:pt>
                <c:pt idx="33">
                  <c:v>2.4784619336948288</c:v>
                </c:pt>
                <c:pt idx="34">
                  <c:v>1.3588601374130824</c:v>
                </c:pt>
                <c:pt idx="35">
                  <c:v>1.0191069197338238</c:v>
                </c:pt>
                <c:pt idx="36">
                  <c:v>1.249866245564671</c:v>
                </c:pt>
                <c:pt idx="37">
                  <c:v>1.6650865404784574</c:v>
                </c:pt>
                <c:pt idx="38">
                  <c:v>1.6411352283010587</c:v>
                </c:pt>
                <c:pt idx="39">
                  <c:v>1.9394746801550462</c:v>
                </c:pt>
                <c:pt idx="40">
                  <c:v>1.0293119933187405</c:v>
                </c:pt>
                <c:pt idx="41">
                  <c:v>1.3819039140851428</c:v>
                </c:pt>
                <c:pt idx="42">
                  <c:v>1.4207814799759708</c:v>
                </c:pt>
                <c:pt idx="43">
                  <c:v>1.0342249450543182</c:v>
                </c:pt>
                <c:pt idx="44">
                  <c:v>1.5360688313892898</c:v>
                </c:pt>
                <c:pt idx="45">
                  <c:v>2.4275612571416016</c:v>
                </c:pt>
                <c:pt idx="46">
                  <c:v>1.3918759955754139</c:v>
                </c:pt>
                <c:pt idx="47">
                  <c:v>1.2718525546102011</c:v>
                </c:pt>
                <c:pt idx="48">
                  <c:v>3.3808158002571456</c:v>
                </c:pt>
                <c:pt idx="49">
                  <c:v>2.6624058479589516</c:v>
                </c:pt>
                <c:pt idx="50">
                  <c:v>1.088266831460345</c:v>
                </c:pt>
                <c:pt idx="51">
                  <c:v>3.4345500465377476</c:v>
                </c:pt>
                <c:pt idx="52">
                  <c:v>2.5037638519291074</c:v>
                </c:pt>
                <c:pt idx="53">
                  <c:v>1.2115866449961838</c:v>
                </c:pt>
                <c:pt idx="54">
                  <c:v>1.0769287500799793</c:v>
                </c:pt>
                <c:pt idx="55">
                  <c:v>1.0069060119178472</c:v>
                </c:pt>
                <c:pt idx="56">
                  <c:v>2.213182766457515</c:v>
                </c:pt>
                <c:pt idx="57">
                  <c:v>4.709387057727743</c:v>
                </c:pt>
                <c:pt idx="58">
                  <c:v>2.5623295056035409</c:v>
                </c:pt>
                <c:pt idx="59">
                  <c:v>1.1688084122708156</c:v>
                </c:pt>
                <c:pt idx="60">
                  <c:v>1.2411139256065946</c:v>
                </c:pt>
                <c:pt idx="61">
                  <c:v>1.1198880918363388</c:v>
                </c:pt>
                <c:pt idx="62">
                  <c:v>2.6180404415823064</c:v>
                </c:pt>
                <c:pt idx="63">
                  <c:v>1.3214332760314169</c:v>
                </c:pt>
                <c:pt idx="64">
                  <c:v>1.0314280720193061</c:v>
                </c:pt>
                <c:pt idx="65">
                  <c:v>1.9203052258850957</c:v>
                </c:pt>
                <c:pt idx="66">
                  <c:v>1.1043609706001178</c:v>
                </c:pt>
                <c:pt idx="67">
                  <c:v>1.2297860387220221</c:v>
                </c:pt>
                <c:pt idx="68">
                  <c:v>2.3001279819034903</c:v>
                </c:pt>
                <c:pt idx="69">
                  <c:v>1.3584093830332207</c:v>
                </c:pt>
                <c:pt idx="70">
                  <c:v>2.3366220824010768</c:v>
                </c:pt>
                <c:pt idx="71">
                  <c:v>1.5749232735383196</c:v>
                </c:pt>
                <c:pt idx="72">
                  <c:v>1.7231116726767286</c:v>
                </c:pt>
                <c:pt idx="73">
                  <c:v>1.1278139833342788</c:v>
                </c:pt>
                <c:pt idx="74">
                  <c:v>1.2907630470672236</c:v>
                </c:pt>
                <c:pt idx="75">
                  <c:v>3.713698540802215</c:v>
                </c:pt>
                <c:pt idx="76">
                  <c:v>1.5091403697870061</c:v>
                </c:pt>
                <c:pt idx="77">
                  <c:v>1.0127930326467709</c:v>
                </c:pt>
                <c:pt idx="78">
                  <c:v>1.7911644068198662</c:v>
                </c:pt>
                <c:pt idx="79">
                  <c:v>1.4521843600172681</c:v>
                </c:pt>
                <c:pt idx="80">
                  <c:v>1.5765763407200155</c:v>
                </c:pt>
                <c:pt idx="81">
                  <c:v>1.7345678283129631</c:v>
                </c:pt>
                <c:pt idx="82">
                  <c:v>2.3720011131237828</c:v>
                </c:pt>
                <c:pt idx="83">
                  <c:v>2.0670575216230263</c:v>
                </c:pt>
                <c:pt idx="84">
                  <c:v>1.1134903336124644</c:v>
                </c:pt>
                <c:pt idx="85">
                  <c:v>1.0356906094289797</c:v>
                </c:pt>
                <c:pt idx="86">
                  <c:v>4.6869818573813298</c:v>
                </c:pt>
                <c:pt idx="87">
                  <c:v>3.7795507895685034</c:v>
                </c:pt>
                <c:pt idx="88">
                  <c:v>1.752442576219547</c:v>
                </c:pt>
                <c:pt idx="89">
                  <c:v>1.60595072882653</c:v>
                </c:pt>
                <c:pt idx="90">
                  <c:v>1.0438764039937896</c:v>
                </c:pt>
                <c:pt idx="91">
                  <c:v>1.910504164378845</c:v>
                </c:pt>
                <c:pt idx="92">
                  <c:v>1.3387033769642225</c:v>
                </c:pt>
                <c:pt idx="93">
                  <c:v>1.339109713939705</c:v>
                </c:pt>
                <c:pt idx="94">
                  <c:v>1.4509307327756338</c:v>
                </c:pt>
                <c:pt idx="95">
                  <c:v>1.9217304215747604</c:v>
                </c:pt>
                <c:pt idx="96">
                  <c:v>3.2553022999620951</c:v>
                </c:pt>
                <c:pt idx="97">
                  <c:v>1.5574734335866789</c:v>
                </c:pt>
                <c:pt idx="98">
                  <c:v>1.1747920439885065</c:v>
                </c:pt>
                <c:pt idx="99">
                  <c:v>1.101379842007959</c:v>
                </c:pt>
                <c:pt idx="100">
                  <c:v>1.432167496754357</c:v>
                </c:pt>
                <c:pt idx="101">
                  <c:v>1.0824578278904555</c:v>
                </c:pt>
                <c:pt idx="102">
                  <c:v>2.047282529396047</c:v>
                </c:pt>
                <c:pt idx="103">
                  <c:v>1.1128783076041178</c:v>
                </c:pt>
                <c:pt idx="104">
                  <c:v>2.4966200895967257</c:v>
                </c:pt>
                <c:pt idx="105">
                  <c:v>2.3155307247932955</c:v>
                </c:pt>
                <c:pt idx="106">
                  <c:v>2.2144804528446156</c:v>
                </c:pt>
                <c:pt idx="107">
                  <c:v>1.0818653384528953</c:v>
                </c:pt>
                <c:pt idx="108">
                  <c:v>1.0734660397771001</c:v>
                </c:pt>
                <c:pt idx="109">
                  <c:v>1.0677205941788885</c:v>
                </c:pt>
                <c:pt idx="110">
                  <c:v>1.5092017376999625</c:v>
                </c:pt>
                <c:pt idx="111">
                  <c:v>1.3782545131532864</c:v>
                </c:pt>
                <c:pt idx="112">
                  <c:v>2.1806887841349991</c:v>
                </c:pt>
                <c:pt idx="113">
                  <c:v>1.3448610177103986</c:v>
                </c:pt>
                <c:pt idx="114">
                  <c:v>2.1712460141086685</c:v>
                </c:pt>
                <c:pt idx="115">
                  <c:v>1.3413015071158541</c:v>
                </c:pt>
                <c:pt idx="116">
                  <c:v>1.0970574318885244</c:v>
                </c:pt>
                <c:pt idx="117">
                  <c:v>1.4219197098122949</c:v>
                </c:pt>
                <c:pt idx="118">
                  <c:v>1.086491167270011</c:v>
                </c:pt>
                <c:pt idx="119">
                  <c:v>1.2114749930385638</c:v>
                </c:pt>
                <c:pt idx="120">
                  <c:v>4.2176017942483517</c:v>
                </c:pt>
                <c:pt idx="121">
                  <c:v>2.3940326210854548</c:v>
                </c:pt>
                <c:pt idx="122">
                  <c:v>1.8637786488569448</c:v>
                </c:pt>
                <c:pt idx="123">
                  <c:v>1.5459559177241828</c:v>
                </c:pt>
                <c:pt idx="124">
                  <c:v>2.0475265317563105</c:v>
                </c:pt>
                <c:pt idx="125">
                  <c:v>1.2593627970840873</c:v>
                </c:pt>
                <c:pt idx="126">
                  <c:v>1.3197928334354239</c:v>
                </c:pt>
                <c:pt idx="127">
                  <c:v>1.4551008267204428</c:v>
                </c:pt>
                <c:pt idx="128">
                  <c:v>1.1508272316256163</c:v>
                </c:pt>
                <c:pt idx="129">
                  <c:v>1.2258192653103313</c:v>
                </c:pt>
                <c:pt idx="130">
                  <c:v>1.1537001489193834</c:v>
                </c:pt>
                <c:pt idx="131">
                  <c:v>1.6745623966553458</c:v>
                </c:pt>
                <c:pt idx="132">
                  <c:v>2.1225242146867731</c:v>
                </c:pt>
                <c:pt idx="133">
                  <c:v>4.4141459088068116</c:v>
                </c:pt>
                <c:pt idx="134">
                  <c:v>1.4444247628514355</c:v>
                </c:pt>
                <c:pt idx="135">
                  <c:v>1.6380620245595459</c:v>
                </c:pt>
                <c:pt idx="136">
                  <c:v>1.6598792700783991</c:v>
                </c:pt>
                <c:pt idx="137">
                  <c:v>1.9581383115028936</c:v>
                </c:pt>
                <c:pt idx="138">
                  <c:v>1.3298799773938461</c:v>
                </c:pt>
                <c:pt idx="139">
                  <c:v>2.5446819720983633</c:v>
                </c:pt>
                <c:pt idx="140">
                  <c:v>1.9139395656077058</c:v>
                </c:pt>
                <c:pt idx="141">
                  <c:v>1.559526809617827</c:v>
                </c:pt>
                <c:pt idx="142">
                  <c:v>1.5042362921983197</c:v>
                </c:pt>
                <c:pt idx="143">
                  <c:v>1.1145677593405565</c:v>
                </c:pt>
                <c:pt idx="144">
                  <c:v>1.2053824630790493</c:v>
                </c:pt>
                <c:pt idx="145">
                  <c:v>1.2669205039770413</c:v>
                </c:pt>
                <c:pt idx="146">
                  <c:v>1.8800373317136665</c:v>
                </c:pt>
                <c:pt idx="147">
                  <c:v>1.6946164873043361</c:v>
                </c:pt>
                <c:pt idx="148">
                  <c:v>1.3076825635028004</c:v>
                </c:pt>
                <c:pt idx="149">
                  <c:v>1.799883890232066</c:v>
                </c:pt>
                <c:pt idx="150">
                  <c:v>1.173380651100612</c:v>
                </c:pt>
                <c:pt idx="151">
                  <c:v>5.6271934072936869</c:v>
                </c:pt>
                <c:pt idx="152">
                  <c:v>1.3498103583562262</c:v>
                </c:pt>
                <c:pt idx="153">
                  <c:v>1.5129857649832426</c:v>
                </c:pt>
                <c:pt idx="154">
                  <c:v>1.2309335765683593</c:v>
                </c:pt>
                <c:pt idx="155">
                  <c:v>1.7057591361393594</c:v>
                </c:pt>
                <c:pt idx="156">
                  <c:v>1.1346562858723508</c:v>
                </c:pt>
                <c:pt idx="157">
                  <c:v>1.3177883809279871</c:v>
                </c:pt>
                <c:pt idx="158">
                  <c:v>1.209773733958887</c:v>
                </c:pt>
                <c:pt idx="159">
                  <c:v>2.1677754828627651</c:v>
                </c:pt>
                <c:pt idx="160">
                  <c:v>1.1536897043348626</c:v>
                </c:pt>
                <c:pt idx="161">
                  <c:v>1.4795757775319114</c:v>
                </c:pt>
                <c:pt idx="162">
                  <c:v>2.6495810271069136</c:v>
                </c:pt>
                <c:pt idx="163">
                  <c:v>1.6383493076833937</c:v>
                </c:pt>
              </c:numCache>
            </c:numRef>
          </c:yVal>
          <c:smooth val="0"/>
          <c:extLst>
            <c:ext xmlns:c16="http://schemas.microsoft.com/office/drawing/2014/chart" uri="{C3380CC4-5D6E-409C-BE32-E72D297353CC}">
              <c16:uniqueId val="{00000001-6C76-4294-9F0D-47CCD1310791}"/>
            </c:ext>
          </c:extLst>
        </c:ser>
        <c:dLbls>
          <c:showLegendKey val="0"/>
          <c:showVal val="0"/>
          <c:showCatName val="0"/>
          <c:showSerName val="0"/>
          <c:showPercent val="0"/>
          <c:showBubbleSize val="0"/>
        </c:dLbls>
        <c:axId val="171871616"/>
        <c:axId val="171889792"/>
      </c:scatterChart>
      <c:valAx>
        <c:axId val="171871616"/>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889792"/>
        <c:crossesAt val="0"/>
        <c:crossBetween val="midCat"/>
      </c:valAx>
      <c:valAx>
        <c:axId val="171889792"/>
        <c:scaling>
          <c:orientation val="minMax"/>
          <c:max val="4"/>
          <c:min val="-1"/>
        </c:scaling>
        <c:delete val="0"/>
        <c:axPos val="l"/>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1871616"/>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38 up de no change prion'!$H$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338 up de no change prion'!$G$2:$G$175</c:f>
              <c:numCache>
                <c:formatCode>General</c:formatCode>
                <c:ptCount val="174"/>
                <c:pt idx="0">
                  <c:v>7235</c:v>
                </c:pt>
                <c:pt idx="1">
                  <c:v>641272</c:v>
                </c:pt>
                <c:pt idx="2">
                  <c:v>723299</c:v>
                </c:pt>
                <c:pt idx="3">
                  <c:v>834726</c:v>
                </c:pt>
                <c:pt idx="4">
                  <c:v>1030741</c:v>
                </c:pt>
                <c:pt idx="5">
                  <c:v>1035569</c:v>
                </c:pt>
                <c:pt idx="6">
                  <c:v>1102428</c:v>
                </c:pt>
                <c:pt idx="7">
                  <c:v>1220585</c:v>
                </c:pt>
                <c:pt idx="8">
                  <c:v>1220902</c:v>
                </c:pt>
                <c:pt idx="9">
                  <c:v>1263859</c:v>
                </c:pt>
                <c:pt idx="10">
                  <c:v>1344673</c:v>
                </c:pt>
                <c:pt idx="11">
                  <c:v>1447534</c:v>
                </c:pt>
                <c:pt idx="12">
                  <c:v>1454627</c:v>
                </c:pt>
                <c:pt idx="13">
                  <c:v>1493459</c:v>
                </c:pt>
                <c:pt idx="14">
                  <c:v>1495201</c:v>
                </c:pt>
                <c:pt idx="15">
                  <c:v>1538356</c:v>
                </c:pt>
                <c:pt idx="16">
                  <c:v>1589928</c:v>
                </c:pt>
                <c:pt idx="17">
                  <c:v>1787386</c:v>
                </c:pt>
                <c:pt idx="18">
                  <c:v>1851537</c:v>
                </c:pt>
                <c:pt idx="19">
                  <c:v>2051036</c:v>
                </c:pt>
                <c:pt idx="20">
                  <c:v>2318703</c:v>
                </c:pt>
                <c:pt idx="21">
                  <c:v>2601226</c:v>
                </c:pt>
                <c:pt idx="22">
                  <c:v>2630090</c:v>
                </c:pt>
                <c:pt idx="23">
                  <c:v>2719945</c:v>
                </c:pt>
                <c:pt idx="24">
                  <c:v>2725094</c:v>
                </c:pt>
                <c:pt idx="25">
                  <c:v>2753358</c:v>
                </c:pt>
                <c:pt idx="26">
                  <c:v>2801455</c:v>
                </c:pt>
                <c:pt idx="27">
                  <c:v>2872116</c:v>
                </c:pt>
                <c:pt idx="28">
                  <c:v>2971591</c:v>
                </c:pt>
                <c:pt idx="29">
                  <c:v>3094147</c:v>
                </c:pt>
                <c:pt idx="30">
                  <c:v>3152888</c:v>
                </c:pt>
                <c:pt idx="31">
                  <c:v>3184021</c:v>
                </c:pt>
                <c:pt idx="32">
                  <c:v>3231819</c:v>
                </c:pt>
                <c:pt idx="33">
                  <c:v>3255055</c:v>
                </c:pt>
                <c:pt idx="34">
                  <c:v>3288724</c:v>
                </c:pt>
                <c:pt idx="35">
                  <c:v>3358163</c:v>
                </c:pt>
                <c:pt idx="36">
                  <c:v>3643094</c:v>
                </c:pt>
                <c:pt idx="37">
                  <c:v>3741780</c:v>
                </c:pt>
                <c:pt idx="38">
                  <c:v>3912275</c:v>
                </c:pt>
                <c:pt idx="39">
                  <c:v>3937128</c:v>
                </c:pt>
                <c:pt idx="40">
                  <c:v>3946023</c:v>
                </c:pt>
                <c:pt idx="41">
                  <c:v>3954268</c:v>
                </c:pt>
                <c:pt idx="42">
                  <c:v>4016607</c:v>
                </c:pt>
                <c:pt idx="43">
                  <c:v>4027502</c:v>
                </c:pt>
                <c:pt idx="44">
                  <c:v>4049957</c:v>
                </c:pt>
                <c:pt idx="45">
                  <c:v>4053621</c:v>
                </c:pt>
                <c:pt idx="46">
                  <c:v>4103325</c:v>
                </c:pt>
                <c:pt idx="47">
                  <c:v>4104153</c:v>
                </c:pt>
                <c:pt idx="48">
                  <c:v>4172204</c:v>
                </c:pt>
                <c:pt idx="49">
                  <c:v>4316477</c:v>
                </c:pt>
                <c:pt idx="50">
                  <c:v>4335683</c:v>
                </c:pt>
                <c:pt idx="51">
                  <c:v>4355318</c:v>
                </c:pt>
                <c:pt idx="52">
                  <c:v>4470439</c:v>
                </c:pt>
                <c:pt idx="53">
                  <c:v>4472402</c:v>
                </c:pt>
                <c:pt idx="54">
                  <c:v>4474620</c:v>
                </c:pt>
                <c:pt idx="55">
                  <c:v>4475652</c:v>
                </c:pt>
                <c:pt idx="56">
                  <c:v>4502752</c:v>
                </c:pt>
                <c:pt idx="57">
                  <c:v>4587819</c:v>
                </c:pt>
                <c:pt idx="58">
                  <c:v>4751471</c:v>
                </c:pt>
                <c:pt idx="59">
                  <c:v>4789900</c:v>
                </c:pt>
                <c:pt idx="60">
                  <c:v>4855708</c:v>
                </c:pt>
                <c:pt idx="61">
                  <c:v>4908866</c:v>
                </c:pt>
                <c:pt idx="62">
                  <c:v>5112611</c:v>
                </c:pt>
                <c:pt idx="63">
                  <c:v>5120843</c:v>
                </c:pt>
                <c:pt idx="64">
                  <c:v>5205668</c:v>
                </c:pt>
                <c:pt idx="65">
                  <c:v>5223464</c:v>
                </c:pt>
                <c:pt idx="66">
                  <c:v>5574690</c:v>
                </c:pt>
                <c:pt idx="67">
                  <c:v>5639487</c:v>
                </c:pt>
                <c:pt idx="68">
                  <c:v>5657672</c:v>
                </c:pt>
                <c:pt idx="69">
                  <c:v>5660882</c:v>
                </c:pt>
                <c:pt idx="70">
                  <c:v>5707666</c:v>
                </c:pt>
                <c:pt idx="71">
                  <c:v>5714915</c:v>
                </c:pt>
                <c:pt idx="72">
                  <c:v>5726300</c:v>
                </c:pt>
                <c:pt idx="73">
                  <c:v>5782145</c:v>
                </c:pt>
                <c:pt idx="74">
                  <c:v>5797446</c:v>
                </c:pt>
                <c:pt idx="75">
                  <c:v>5851958</c:v>
                </c:pt>
                <c:pt idx="76">
                  <c:v>5858873</c:v>
                </c:pt>
                <c:pt idx="77">
                  <c:v>5952910</c:v>
                </c:pt>
                <c:pt idx="78">
                  <c:v>5954726</c:v>
                </c:pt>
                <c:pt idx="79">
                  <c:v>6026321</c:v>
                </c:pt>
                <c:pt idx="80">
                  <c:v>6101260</c:v>
                </c:pt>
                <c:pt idx="81">
                  <c:v>6174983</c:v>
                </c:pt>
                <c:pt idx="82">
                  <c:v>6246746</c:v>
                </c:pt>
                <c:pt idx="83">
                  <c:v>6250023</c:v>
                </c:pt>
                <c:pt idx="84">
                  <c:v>6296912</c:v>
                </c:pt>
                <c:pt idx="85">
                  <c:v>6303599</c:v>
                </c:pt>
                <c:pt idx="86">
                  <c:v>6511418</c:v>
                </c:pt>
                <c:pt idx="87">
                  <c:v>6536657</c:v>
                </c:pt>
                <c:pt idx="88">
                  <c:v>6539621</c:v>
                </c:pt>
                <c:pt idx="89">
                  <c:v>6625369</c:v>
                </c:pt>
                <c:pt idx="90">
                  <c:v>6667496</c:v>
                </c:pt>
                <c:pt idx="91">
                  <c:v>6672711</c:v>
                </c:pt>
                <c:pt idx="92">
                  <c:v>6687481</c:v>
                </c:pt>
                <c:pt idx="93">
                  <c:v>6720006</c:v>
                </c:pt>
                <c:pt idx="94">
                  <c:v>6804782</c:v>
                </c:pt>
                <c:pt idx="95">
                  <c:v>6839344</c:v>
                </c:pt>
                <c:pt idx="96">
                  <c:v>6934534</c:v>
                </c:pt>
                <c:pt idx="97">
                  <c:v>7169718</c:v>
                </c:pt>
                <c:pt idx="98">
                  <c:v>7211238</c:v>
                </c:pt>
                <c:pt idx="99">
                  <c:v>7235048</c:v>
                </c:pt>
                <c:pt idx="100">
                  <c:v>7270784</c:v>
                </c:pt>
                <c:pt idx="101">
                  <c:v>7292887</c:v>
                </c:pt>
                <c:pt idx="102">
                  <c:v>7357262</c:v>
                </c:pt>
                <c:pt idx="103">
                  <c:v>7411565</c:v>
                </c:pt>
                <c:pt idx="104">
                  <c:v>7487260</c:v>
                </c:pt>
                <c:pt idx="105">
                  <c:v>7490615</c:v>
                </c:pt>
                <c:pt idx="106">
                  <c:v>7491352</c:v>
                </c:pt>
                <c:pt idx="107">
                  <c:v>7493745</c:v>
                </c:pt>
                <c:pt idx="108">
                  <c:v>7633772</c:v>
                </c:pt>
                <c:pt idx="109">
                  <c:v>7636628</c:v>
                </c:pt>
                <c:pt idx="110">
                  <c:v>7638512</c:v>
                </c:pt>
                <c:pt idx="111">
                  <c:v>7649538</c:v>
                </c:pt>
                <c:pt idx="112">
                  <c:v>7785837</c:v>
                </c:pt>
                <c:pt idx="113">
                  <c:v>7791125</c:v>
                </c:pt>
                <c:pt idx="114">
                  <c:v>7854811</c:v>
                </c:pt>
                <c:pt idx="115">
                  <c:v>7857395</c:v>
                </c:pt>
                <c:pt idx="116">
                  <c:v>7940074</c:v>
                </c:pt>
                <c:pt idx="117">
                  <c:v>8089310</c:v>
                </c:pt>
                <c:pt idx="118">
                  <c:v>8196184</c:v>
                </c:pt>
                <c:pt idx="119">
                  <c:v>8485399</c:v>
                </c:pt>
                <c:pt idx="120">
                  <c:v>8806219</c:v>
                </c:pt>
                <c:pt idx="121">
                  <c:v>8823189</c:v>
                </c:pt>
                <c:pt idx="122">
                  <c:v>8825349</c:v>
                </c:pt>
                <c:pt idx="123">
                  <c:v>8877998</c:v>
                </c:pt>
                <c:pt idx="124">
                  <c:v>8922557</c:v>
                </c:pt>
                <c:pt idx="125">
                  <c:v>9097957</c:v>
                </c:pt>
                <c:pt idx="126">
                  <c:v>9102150</c:v>
                </c:pt>
                <c:pt idx="127">
                  <c:v>9204364</c:v>
                </c:pt>
                <c:pt idx="128">
                  <c:v>9218921</c:v>
                </c:pt>
                <c:pt idx="129">
                  <c:v>9309594</c:v>
                </c:pt>
                <c:pt idx="130">
                  <c:v>9356103</c:v>
                </c:pt>
                <c:pt idx="131">
                  <c:v>9358553</c:v>
                </c:pt>
                <c:pt idx="132">
                  <c:v>9506011</c:v>
                </c:pt>
                <c:pt idx="133">
                  <c:v>9555037</c:v>
                </c:pt>
                <c:pt idx="134">
                  <c:v>9622957</c:v>
                </c:pt>
                <c:pt idx="135">
                  <c:v>9653994</c:v>
                </c:pt>
                <c:pt idx="136">
                  <c:v>9741592</c:v>
                </c:pt>
                <c:pt idx="137">
                  <c:v>9853020</c:v>
                </c:pt>
                <c:pt idx="138">
                  <c:v>9890326</c:v>
                </c:pt>
                <c:pt idx="139">
                  <c:v>9979254</c:v>
                </c:pt>
                <c:pt idx="140">
                  <c:v>9981927</c:v>
                </c:pt>
                <c:pt idx="141">
                  <c:v>10003382</c:v>
                </c:pt>
                <c:pt idx="142">
                  <c:v>10041566</c:v>
                </c:pt>
                <c:pt idx="143">
                  <c:v>10042088</c:v>
                </c:pt>
                <c:pt idx="144">
                  <c:v>10060672</c:v>
                </c:pt>
                <c:pt idx="145">
                  <c:v>10123995</c:v>
                </c:pt>
                <c:pt idx="146">
                  <c:v>10125364</c:v>
                </c:pt>
                <c:pt idx="147">
                  <c:v>10177303</c:v>
                </c:pt>
                <c:pt idx="148">
                  <c:v>10251180</c:v>
                </c:pt>
                <c:pt idx="149">
                  <c:v>10273583</c:v>
                </c:pt>
                <c:pt idx="150">
                  <c:v>10331662</c:v>
                </c:pt>
                <c:pt idx="151">
                  <c:v>10365561</c:v>
                </c:pt>
                <c:pt idx="152">
                  <c:v>10378164</c:v>
                </c:pt>
                <c:pt idx="153">
                  <c:v>10415502</c:v>
                </c:pt>
                <c:pt idx="154">
                  <c:v>10421740</c:v>
                </c:pt>
                <c:pt idx="155">
                  <c:v>10439917</c:v>
                </c:pt>
                <c:pt idx="156">
                  <c:v>10730737</c:v>
                </c:pt>
                <c:pt idx="157">
                  <c:v>10759481</c:v>
                </c:pt>
                <c:pt idx="158">
                  <c:v>10813963</c:v>
                </c:pt>
                <c:pt idx="159">
                  <c:v>10874372</c:v>
                </c:pt>
                <c:pt idx="160">
                  <c:v>10928667</c:v>
                </c:pt>
                <c:pt idx="161">
                  <c:v>11087514</c:v>
                </c:pt>
                <c:pt idx="162">
                  <c:v>11093533</c:v>
                </c:pt>
                <c:pt idx="163">
                  <c:v>11106182</c:v>
                </c:pt>
                <c:pt idx="164">
                  <c:v>11208846</c:v>
                </c:pt>
                <c:pt idx="165">
                  <c:v>11276755</c:v>
                </c:pt>
                <c:pt idx="166">
                  <c:v>11365178</c:v>
                </c:pt>
                <c:pt idx="167">
                  <c:v>11569102</c:v>
                </c:pt>
                <c:pt idx="168">
                  <c:v>11579019</c:v>
                </c:pt>
                <c:pt idx="169">
                  <c:v>11700845</c:v>
                </c:pt>
                <c:pt idx="170">
                  <c:v>11905305</c:v>
                </c:pt>
                <c:pt idx="171">
                  <c:v>11918225</c:v>
                </c:pt>
                <c:pt idx="172">
                  <c:v>12054636</c:v>
                </c:pt>
                <c:pt idx="173">
                  <c:v>12063182</c:v>
                </c:pt>
              </c:numCache>
            </c:numRef>
          </c:xVal>
          <c:yVal>
            <c:numRef>
              <c:f>'338 up de no change prion'!$H$2:$H$175</c:f>
              <c:numCache>
                <c:formatCode>General</c:formatCode>
                <c:ptCount val="174"/>
                <c:pt idx="0">
                  <c:v>0.70411746808874554</c:v>
                </c:pt>
                <c:pt idx="1">
                  <c:v>0.50932077177988322</c:v>
                </c:pt>
                <c:pt idx="2">
                  <c:v>-1.2394116327978257</c:v>
                </c:pt>
                <c:pt idx="3">
                  <c:v>-0.80438939328179315</c:v>
                </c:pt>
                <c:pt idx="4">
                  <c:v>-8.6310718449254253E-2</c:v>
                </c:pt>
                <c:pt idx="5">
                  <c:v>0.86667099397153002</c:v>
                </c:pt>
                <c:pt idx="6">
                  <c:v>0.34295506699847933</c:v>
                </c:pt>
                <c:pt idx="7">
                  <c:v>0.57407607361416557</c:v>
                </c:pt>
                <c:pt idx="8">
                  <c:v>0.40258663516353527</c:v>
                </c:pt>
                <c:pt idx="9">
                  <c:v>0.89081901747448755</c:v>
                </c:pt>
                <c:pt idx="10">
                  <c:v>-0.46324276532201147</c:v>
                </c:pt>
                <c:pt idx="11">
                  <c:v>-7.4078804823805536E-2</c:v>
                </c:pt>
                <c:pt idx="12">
                  <c:v>-1.0581802093951784</c:v>
                </c:pt>
                <c:pt idx="13">
                  <c:v>-1.3701177906125381</c:v>
                </c:pt>
                <c:pt idx="14">
                  <c:v>-7.121676648634423E-2</c:v>
                </c:pt>
                <c:pt idx="15">
                  <c:v>-0.73343699076644342</c:v>
                </c:pt>
                <c:pt idx="16">
                  <c:v>0.63547583313278422</c:v>
                </c:pt>
                <c:pt idx="17">
                  <c:v>1.3566898376651344</c:v>
                </c:pt>
                <c:pt idx="18">
                  <c:v>0.12772092498123769</c:v>
                </c:pt>
                <c:pt idx="19">
                  <c:v>0.60170954051805359</c:v>
                </c:pt>
                <c:pt idx="20">
                  <c:v>-0.20864244896336442</c:v>
                </c:pt>
                <c:pt idx="21">
                  <c:v>-7.4987117121969385E-2</c:v>
                </c:pt>
                <c:pt idx="22">
                  <c:v>-8.4630863763774461E-2</c:v>
                </c:pt>
                <c:pt idx="23">
                  <c:v>-0.39741699979503814</c:v>
                </c:pt>
                <c:pt idx="24">
                  <c:v>0.33800917870991343</c:v>
                </c:pt>
                <c:pt idx="25">
                  <c:v>0.42196836266028132</c:v>
                </c:pt>
                <c:pt idx="26">
                  <c:v>0.48177504996514497</c:v>
                </c:pt>
                <c:pt idx="27">
                  <c:v>0.25030190541008951</c:v>
                </c:pt>
                <c:pt idx="28">
                  <c:v>0.69461225540332727</c:v>
                </c:pt>
                <c:pt idx="29">
                  <c:v>-1.7369108933643536</c:v>
                </c:pt>
                <c:pt idx="30">
                  <c:v>0.27672561266379353</c:v>
                </c:pt>
                <c:pt idx="31">
                  <c:v>1.0092115827139294</c:v>
                </c:pt>
                <c:pt idx="32">
                  <c:v>0.22789771112526075</c:v>
                </c:pt>
                <c:pt idx="33">
                  <c:v>-4.9184654048894889E-2</c:v>
                </c:pt>
                <c:pt idx="34">
                  <c:v>0.27580079667840113</c:v>
                </c:pt>
                <c:pt idx="35">
                  <c:v>0.33930812691694523</c:v>
                </c:pt>
                <c:pt idx="36">
                  <c:v>0.16974609954572434</c:v>
                </c:pt>
                <c:pt idx="37">
                  <c:v>0.34466929449980788</c:v>
                </c:pt>
                <c:pt idx="38">
                  <c:v>0.74671290544556157</c:v>
                </c:pt>
                <c:pt idx="39">
                  <c:v>1.1897231663539791</c:v>
                </c:pt>
                <c:pt idx="40">
                  <c:v>-0.63986178910277614</c:v>
                </c:pt>
                <c:pt idx="41">
                  <c:v>9.0300542447958349E-2</c:v>
                </c:pt>
                <c:pt idx="42">
                  <c:v>-0.64743171209764605</c:v>
                </c:pt>
                <c:pt idx="43">
                  <c:v>-0.46878844904744416</c:v>
                </c:pt>
                <c:pt idx="44">
                  <c:v>0.72138277634291625</c:v>
                </c:pt>
                <c:pt idx="45">
                  <c:v>-2.0666556582197831E-2</c:v>
                </c:pt>
                <c:pt idx="46">
                  <c:v>0.16256482875161607</c:v>
                </c:pt>
                <c:pt idx="47">
                  <c:v>0.36635950625156605</c:v>
                </c:pt>
                <c:pt idx="48">
                  <c:v>1.8263806724287184</c:v>
                </c:pt>
                <c:pt idx="49">
                  <c:v>-0.22874875294010866</c:v>
                </c:pt>
                <c:pt idx="50">
                  <c:v>0.57646356241908747</c:v>
                </c:pt>
                <c:pt idx="51">
                  <c:v>0.18109325086046768</c:v>
                </c:pt>
                <c:pt idx="52">
                  <c:v>-1.1716602119154285</c:v>
                </c:pt>
                <c:pt idx="53">
                  <c:v>-0.49089566359277947</c:v>
                </c:pt>
                <c:pt idx="54">
                  <c:v>-0.22079992560561357</c:v>
                </c:pt>
                <c:pt idx="55">
                  <c:v>1.220831022290036</c:v>
                </c:pt>
                <c:pt idx="56">
                  <c:v>0.93355274061233295</c:v>
                </c:pt>
                <c:pt idx="57">
                  <c:v>0.24330330082053991</c:v>
                </c:pt>
                <c:pt idx="58">
                  <c:v>1.3238157857133526</c:v>
                </c:pt>
                <c:pt idx="59">
                  <c:v>1.8275619179109777</c:v>
                </c:pt>
                <c:pt idx="60">
                  <c:v>-0.36835808177481799</c:v>
                </c:pt>
                <c:pt idx="61">
                  <c:v>9.6590934114929833E-2</c:v>
                </c:pt>
                <c:pt idx="62">
                  <c:v>-0.56716256036365931</c:v>
                </c:pt>
                <c:pt idx="63">
                  <c:v>0.39822057368322578</c:v>
                </c:pt>
                <c:pt idx="64">
                  <c:v>0.92333092903118186</c:v>
                </c:pt>
                <c:pt idx="65">
                  <c:v>1.1336176250256265</c:v>
                </c:pt>
                <c:pt idx="66">
                  <c:v>-0.14010910969293383</c:v>
                </c:pt>
                <c:pt idx="67">
                  <c:v>0.10820670192909881</c:v>
                </c:pt>
                <c:pt idx="68">
                  <c:v>0.11678138518515574</c:v>
                </c:pt>
                <c:pt idx="69">
                  <c:v>-0.30937855173204998</c:v>
                </c:pt>
                <c:pt idx="70">
                  <c:v>-1.0072034081031052</c:v>
                </c:pt>
                <c:pt idx="71">
                  <c:v>1.2673548322638177</c:v>
                </c:pt>
                <c:pt idx="72">
                  <c:v>-0.43960249402332735</c:v>
                </c:pt>
                <c:pt idx="73">
                  <c:v>0.94733713119981944</c:v>
                </c:pt>
                <c:pt idx="74">
                  <c:v>-8.4938086830319698E-2</c:v>
                </c:pt>
                <c:pt idx="75">
                  <c:v>0.93268769164817777</c:v>
                </c:pt>
                <c:pt idx="76">
                  <c:v>1.50500641720027E-2</c:v>
                </c:pt>
                <c:pt idx="77">
                  <c:v>0.18540907344530028</c:v>
                </c:pt>
                <c:pt idx="78">
                  <c:v>-3.1366315515610289E-2</c:v>
                </c:pt>
                <c:pt idx="79">
                  <c:v>0.59418704578290205</c:v>
                </c:pt>
                <c:pt idx="80">
                  <c:v>0.63655653872005302</c:v>
                </c:pt>
                <c:pt idx="81">
                  <c:v>-9.1825865584064484E-2</c:v>
                </c:pt>
                <c:pt idx="82">
                  <c:v>0.90659178842026789</c:v>
                </c:pt>
                <c:pt idx="83">
                  <c:v>-0.25518353475588806</c:v>
                </c:pt>
                <c:pt idx="84">
                  <c:v>1.2538536258008175</c:v>
                </c:pt>
                <c:pt idx="85">
                  <c:v>1.30832527820761</c:v>
                </c:pt>
                <c:pt idx="86">
                  <c:v>-0.86975814921492045</c:v>
                </c:pt>
                <c:pt idx="87">
                  <c:v>0.10788707666099831</c:v>
                </c:pt>
                <c:pt idx="88">
                  <c:v>0.22314728403563544</c:v>
                </c:pt>
                <c:pt idx="89">
                  <c:v>-0.20315259870113919</c:v>
                </c:pt>
                <c:pt idx="90">
                  <c:v>-0.72811081696945446</c:v>
                </c:pt>
                <c:pt idx="91">
                  <c:v>-1.6173719229389882</c:v>
                </c:pt>
                <c:pt idx="92">
                  <c:v>5.9508213234483777E-2</c:v>
                </c:pt>
                <c:pt idx="93">
                  <c:v>0.9410017225017473</c:v>
                </c:pt>
                <c:pt idx="94">
                  <c:v>-8.5918314165916124E-2</c:v>
                </c:pt>
                <c:pt idx="95">
                  <c:v>1.0919133406581216</c:v>
                </c:pt>
                <c:pt idx="96">
                  <c:v>0.82504325088788388</c:v>
                </c:pt>
                <c:pt idx="97">
                  <c:v>0.8960915222134066</c:v>
                </c:pt>
                <c:pt idx="98">
                  <c:v>0.34846474933395422</c:v>
                </c:pt>
                <c:pt idx="99">
                  <c:v>-0.44247554695611185</c:v>
                </c:pt>
                <c:pt idx="100">
                  <c:v>0.53578154575998271</c:v>
                </c:pt>
                <c:pt idx="101">
                  <c:v>0.15510876698891823</c:v>
                </c:pt>
                <c:pt idx="102">
                  <c:v>0.39297520857554502</c:v>
                </c:pt>
                <c:pt idx="103">
                  <c:v>-0.84123561253669421</c:v>
                </c:pt>
                <c:pt idx="104">
                  <c:v>0.64829165086858764</c:v>
                </c:pt>
                <c:pt idx="105">
                  <c:v>0.75721561120799774</c:v>
                </c:pt>
                <c:pt idx="106">
                  <c:v>0.42034520428976713</c:v>
                </c:pt>
                <c:pt idx="107">
                  <c:v>-0.1558183385465414</c:v>
                </c:pt>
                <c:pt idx="108">
                  <c:v>0.24503572104864599</c:v>
                </c:pt>
                <c:pt idx="109">
                  <c:v>-1.0038115274023283</c:v>
                </c:pt>
                <c:pt idx="110">
                  <c:v>-0.79820237954156537</c:v>
                </c:pt>
                <c:pt idx="111">
                  <c:v>0.3706090145583873</c:v>
                </c:pt>
                <c:pt idx="112">
                  <c:v>0.70880696677117883</c:v>
                </c:pt>
                <c:pt idx="113">
                  <c:v>-1.9821213304370405E-2</c:v>
                </c:pt>
                <c:pt idx="114">
                  <c:v>0.23950828274063138</c:v>
                </c:pt>
                <c:pt idx="115">
                  <c:v>-0.45485306589805358</c:v>
                </c:pt>
                <c:pt idx="116">
                  <c:v>-7.5225980947867122</c:v>
                </c:pt>
                <c:pt idx="117">
                  <c:v>0.20077538959657601</c:v>
                </c:pt>
                <c:pt idx="118">
                  <c:v>0.49760242970145641</c:v>
                </c:pt>
                <c:pt idx="119">
                  <c:v>0.17527442179192956</c:v>
                </c:pt>
                <c:pt idx="120">
                  <c:v>4.3179930510247801E-2</c:v>
                </c:pt>
                <c:pt idx="121">
                  <c:v>0.92619782350716706</c:v>
                </c:pt>
                <c:pt idx="122">
                  <c:v>0.59923679639594962</c:v>
                </c:pt>
                <c:pt idx="123">
                  <c:v>-0.62753272372539193</c:v>
                </c:pt>
                <c:pt idx="124">
                  <c:v>0.44112437168840507</c:v>
                </c:pt>
                <c:pt idx="125">
                  <c:v>-0.15494720360445846</c:v>
                </c:pt>
                <c:pt idx="126">
                  <c:v>0.51238896149074165</c:v>
                </c:pt>
                <c:pt idx="127">
                  <c:v>0.22382467112214188</c:v>
                </c:pt>
                <c:pt idx="128">
                  <c:v>1.3821230251442431</c:v>
                </c:pt>
                <c:pt idx="129">
                  <c:v>0.75578380834487169</c:v>
                </c:pt>
                <c:pt idx="130">
                  <c:v>0.78540775840404808</c:v>
                </c:pt>
                <c:pt idx="131">
                  <c:v>-1.5415133596881712</c:v>
                </c:pt>
                <c:pt idx="132">
                  <c:v>0.78594850674806171</c:v>
                </c:pt>
                <c:pt idx="133">
                  <c:v>0.5279640950489336</c:v>
                </c:pt>
                <c:pt idx="134">
                  <c:v>0.87542965272938467</c:v>
                </c:pt>
                <c:pt idx="135">
                  <c:v>-2.2520804210772241</c:v>
                </c:pt>
                <c:pt idx="136">
                  <c:v>0.39250722347365669</c:v>
                </c:pt>
                <c:pt idx="137">
                  <c:v>0.91638730207219665</c:v>
                </c:pt>
                <c:pt idx="138">
                  <c:v>9.7745274557542949E-2</c:v>
                </c:pt>
                <c:pt idx="139">
                  <c:v>1.5379434339739708</c:v>
                </c:pt>
                <c:pt idx="140">
                  <c:v>0.41391126106543735</c:v>
                </c:pt>
                <c:pt idx="141">
                  <c:v>0.30812247165238332</c:v>
                </c:pt>
                <c:pt idx="142">
                  <c:v>0.56603673814220645</c:v>
                </c:pt>
                <c:pt idx="143">
                  <c:v>-0.99718431596096624</c:v>
                </c:pt>
                <c:pt idx="144">
                  <c:v>6.3750678013511031E-2</c:v>
                </c:pt>
                <c:pt idx="145">
                  <c:v>0.8038336005269674</c:v>
                </c:pt>
                <c:pt idx="146">
                  <c:v>-0.12494204686163544</c:v>
                </c:pt>
                <c:pt idx="147">
                  <c:v>0.7890761173497759</c:v>
                </c:pt>
                <c:pt idx="148">
                  <c:v>1.3674614815986834</c:v>
                </c:pt>
                <c:pt idx="149">
                  <c:v>0.27161312686558481</c:v>
                </c:pt>
                <c:pt idx="150">
                  <c:v>-7.3777553760275089E-2</c:v>
                </c:pt>
                <c:pt idx="151">
                  <c:v>0.72393333793666803</c:v>
                </c:pt>
                <c:pt idx="152">
                  <c:v>0.15875485674456927</c:v>
                </c:pt>
                <c:pt idx="153">
                  <c:v>0.69163018003040977</c:v>
                </c:pt>
                <c:pt idx="154">
                  <c:v>0.58390967358235135</c:v>
                </c:pt>
                <c:pt idx="155">
                  <c:v>0.35684530711270812</c:v>
                </c:pt>
                <c:pt idx="156">
                  <c:v>1.6706930607092536</c:v>
                </c:pt>
                <c:pt idx="157">
                  <c:v>1.5658883160618764</c:v>
                </c:pt>
                <c:pt idx="158">
                  <c:v>-0.41319317490260427</c:v>
                </c:pt>
                <c:pt idx="159">
                  <c:v>1.246775006480883E-2</c:v>
                </c:pt>
                <c:pt idx="160">
                  <c:v>0.55872855380407771</c:v>
                </c:pt>
                <c:pt idx="161">
                  <c:v>4.6450363755688971E-2</c:v>
                </c:pt>
                <c:pt idx="162">
                  <c:v>0.84533156600079062</c:v>
                </c:pt>
                <c:pt idx="163">
                  <c:v>2.9712159181266323E-2</c:v>
                </c:pt>
                <c:pt idx="164">
                  <c:v>-0.24333512777989486</c:v>
                </c:pt>
                <c:pt idx="165">
                  <c:v>-0.11905567312483556</c:v>
                </c:pt>
                <c:pt idx="166">
                  <c:v>2.5102537390962949</c:v>
                </c:pt>
                <c:pt idx="167">
                  <c:v>-0.38315504898066854</c:v>
                </c:pt>
                <c:pt idx="168">
                  <c:v>-0.53079363639991572</c:v>
                </c:pt>
                <c:pt idx="169">
                  <c:v>-0.57910534082784904</c:v>
                </c:pt>
                <c:pt idx="170">
                  <c:v>-0.40791949950526446</c:v>
                </c:pt>
                <c:pt idx="171">
                  <c:v>0.36255804124541574</c:v>
                </c:pt>
                <c:pt idx="172">
                  <c:v>0.64932595270322202</c:v>
                </c:pt>
                <c:pt idx="173">
                  <c:v>0.22899763597819248</c:v>
                </c:pt>
              </c:numCache>
            </c:numRef>
          </c:yVal>
          <c:smooth val="0"/>
          <c:extLst>
            <c:ext xmlns:c16="http://schemas.microsoft.com/office/drawing/2014/chart" uri="{C3380CC4-5D6E-409C-BE32-E72D297353CC}">
              <c16:uniqueId val="{00000000-40B6-4BD4-83C7-D1F1D09F5F52}"/>
            </c:ext>
          </c:extLst>
        </c:ser>
        <c:ser>
          <c:idx val="1"/>
          <c:order val="1"/>
          <c:tx>
            <c:strRef>
              <c:f>'338 up de no change prion'!$I$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338 up de no change prion'!$G$2:$G$175</c:f>
              <c:numCache>
                <c:formatCode>General</c:formatCode>
                <c:ptCount val="174"/>
                <c:pt idx="0">
                  <c:v>7235</c:v>
                </c:pt>
                <c:pt idx="1">
                  <c:v>641272</c:v>
                </c:pt>
                <c:pt idx="2">
                  <c:v>723299</c:v>
                </c:pt>
                <c:pt idx="3">
                  <c:v>834726</c:v>
                </c:pt>
                <c:pt idx="4">
                  <c:v>1030741</c:v>
                </c:pt>
                <c:pt idx="5">
                  <c:v>1035569</c:v>
                </c:pt>
                <c:pt idx="6">
                  <c:v>1102428</c:v>
                </c:pt>
                <c:pt idx="7">
                  <c:v>1220585</c:v>
                </c:pt>
                <c:pt idx="8">
                  <c:v>1220902</c:v>
                </c:pt>
                <c:pt idx="9">
                  <c:v>1263859</c:v>
                </c:pt>
                <c:pt idx="10">
                  <c:v>1344673</c:v>
                </c:pt>
                <c:pt idx="11">
                  <c:v>1447534</c:v>
                </c:pt>
                <c:pt idx="12">
                  <c:v>1454627</c:v>
                </c:pt>
                <c:pt idx="13">
                  <c:v>1493459</c:v>
                </c:pt>
                <c:pt idx="14">
                  <c:v>1495201</c:v>
                </c:pt>
                <c:pt idx="15">
                  <c:v>1538356</c:v>
                </c:pt>
                <c:pt idx="16">
                  <c:v>1589928</c:v>
                </c:pt>
                <c:pt idx="17">
                  <c:v>1787386</c:v>
                </c:pt>
                <c:pt idx="18">
                  <c:v>1851537</c:v>
                </c:pt>
                <c:pt idx="19">
                  <c:v>2051036</c:v>
                </c:pt>
                <c:pt idx="20">
                  <c:v>2318703</c:v>
                </c:pt>
                <c:pt idx="21">
                  <c:v>2601226</c:v>
                </c:pt>
                <c:pt idx="22">
                  <c:v>2630090</c:v>
                </c:pt>
                <c:pt idx="23">
                  <c:v>2719945</c:v>
                </c:pt>
                <c:pt idx="24">
                  <c:v>2725094</c:v>
                </c:pt>
                <c:pt idx="25">
                  <c:v>2753358</c:v>
                </c:pt>
                <c:pt idx="26">
                  <c:v>2801455</c:v>
                </c:pt>
                <c:pt idx="27">
                  <c:v>2872116</c:v>
                </c:pt>
                <c:pt idx="28">
                  <c:v>2971591</c:v>
                </c:pt>
                <c:pt idx="29">
                  <c:v>3094147</c:v>
                </c:pt>
                <c:pt idx="30">
                  <c:v>3152888</c:v>
                </c:pt>
                <c:pt idx="31">
                  <c:v>3184021</c:v>
                </c:pt>
                <c:pt idx="32">
                  <c:v>3231819</c:v>
                </c:pt>
                <c:pt idx="33">
                  <c:v>3255055</c:v>
                </c:pt>
                <c:pt idx="34">
                  <c:v>3288724</c:v>
                </c:pt>
                <c:pt idx="35">
                  <c:v>3358163</c:v>
                </c:pt>
                <c:pt idx="36">
                  <c:v>3643094</c:v>
                </c:pt>
                <c:pt idx="37">
                  <c:v>3741780</c:v>
                </c:pt>
                <c:pt idx="38">
                  <c:v>3912275</c:v>
                </c:pt>
                <c:pt idx="39">
                  <c:v>3937128</c:v>
                </c:pt>
                <c:pt idx="40">
                  <c:v>3946023</c:v>
                </c:pt>
                <c:pt idx="41">
                  <c:v>3954268</c:v>
                </c:pt>
                <c:pt idx="42">
                  <c:v>4016607</c:v>
                </c:pt>
                <c:pt idx="43">
                  <c:v>4027502</c:v>
                </c:pt>
                <c:pt idx="44">
                  <c:v>4049957</c:v>
                </c:pt>
                <c:pt idx="45">
                  <c:v>4053621</c:v>
                </c:pt>
                <c:pt idx="46">
                  <c:v>4103325</c:v>
                </c:pt>
                <c:pt idx="47">
                  <c:v>4104153</c:v>
                </c:pt>
                <c:pt idx="48">
                  <c:v>4172204</c:v>
                </c:pt>
                <c:pt idx="49">
                  <c:v>4316477</c:v>
                </c:pt>
                <c:pt idx="50">
                  <c:v>4335683</c:v>
                </c:pt>
                <c:pt idx="51">
                  <c:v>4355318</c:v>
                </c:pt>
                <c:pt idx="52">
                  <c:v>4470439</c:v>
                </c:pt>
                <c:pt idx="53">
                  <c:v>4472402</c:v>
                </c:pt>
                <c:pt idx="54">
                  <c:v>4474620</c:v>
                </c:pt>
                <c:pt idx="55">
                  <c:v>4475652</c:v>
                </c:pt>
                <c:pt idx="56">
                  <c:v>4502752</c:v>
                </c:pt>
                <c:pt idx="57">
                  <c:v>4587819</c:v>
                </c:pt>
                <c:pt idx="58">
                  <c:v>4751471</c:v>
                </c:pt>
                <c:pt idx="59">
                  <c:v>4789900</c:v>
                </c:pt>
                <c:pt idx="60">
                  <c:v>4855708</c:v>
                </c:pt>
                <c:pt idx="61">
                  <c:v>4908866</c:v>
                </c:pt>
                <c:pt idx="62">
                  <c:v>5112611</c:v>
                </c:pt>
                <c:pt idx="63">
                  <c:v>5120843</c:v>
                </c:pt>
                <c:pt idx="64">
                  <c:v>5205668</c:v>
                </c:pt>
                <c:pt idx="65">
                  <c:v>5223464</c:v>
                </c:pt>
                <c:pt idx="66">
                  <c:v>5574690</c:v>
                </c:pt>
                <c:pt idx="67">
                  <c:v>5639487</c:v>
                </c:pt>
                <c:pt idx="68">
                  <c:v>5657672</c:v>
                </c:pt>
                <c:pt idx="69">
                  <c:v>5660882</c:v>
                </c:pt>
                <c:pt idx="70">
                  <c:v>5707666</c:v>
                </c:pt>
                <c:pt idx="71">
                  <c:v>5714915</c:v>
                </c:pt>
                <c:pt idx="72">
                  <c:v>5726300</c:v>
                </c:pt>
                <c:pt idx="73">
                  <c:v>5782145</c:v>
                </c:pt>
                <c:pt idx="74">
                  <c:v>5797446</c:v>
                </c:pt>
                <c:pt idx="75">
                  <c:v>5851958</c:v>
                </c:pt>
                <c:pt idx="76">
                  <c:v>5858873</c:v>
                </c:pt>
                <c:pt idx="77">
                  <c:v>5952910</c:v>
                </c:pt>
                <c:pt idx="78">
                  <c:v>5954726</c:v>
                </c:pt>
                <c:pt idx="79">
                  <c:v>6026321</c:v>
                </c:pt>
                <c:pt idx="80">
                  <c:v>6101260</c:v>
                </c:pt>
                <c:pt idx="81">
                  <c:v>6174983</c:v>
                </c:pt>
                <c:pt idx="82">
                  <c:v>6246746</c:v>
                </c:pt>
                <c:pt idx="83">
                  <c:v>6250023</c:v>
                </c:pt>
                <c:pt idx="84">
                  <c:v>6296912</c:v>
                </c:pt>
                <c:pt idx="85">
                  <c:v>6303599</c:v>
                </c:pt>
                <c:pt idx="86">
                  <c:v>6511418</c:v>
                </c:pt>
                <c:pt idx="87">
                  <c:v>6536657</c:v>
                </c:pt>
                <c:pt idx="88">
                  <c:v>6539621</c:v>
                </c:pt>
                <c:pt idx="89">
                  <c:v>6625369</c:v>
                </c:pt>
                <c:pt idx="90">
                  <c:v>6667496</c:v>
                </c:pt>
                <c:pt idx="91">
                  <c:v>6672711</c:v>
                </c:pt>
                <c:pt idx="92">
                  <c:v>6687481</c:v>
                </c:pt>
                <c:pt idx="93">
                  <c:v>6720006</c:v>
                </c:pt>
                <c:pt idx="94">
                  <c:v>6804782</c:v>
                </c:pt>
                <c:pt idx="95">
                  <c:v>6839344</c:v>
                </c:pt>
                <c:pt idx="96">
                  <c:v>6934534</c:v>
                </c:pt>
                <c:pt idx="97">
                  <c:v>7169718</c:v>
                </c:pt>
                <c:pt idx="98">
                  <c:v>7211238</c:v>
                </c:pt>
                <c:pt idx="99">
                  <c:v>7235048</c:v>
                </c:pt>
                <c:pt idx="100">
                  <c:v>7270784</c:v>
                </c:pt>
                <c:pt idx="101">
                  <c:v>7292887</c:v>
                </c:pt>
                <c:pt idx="102">
                  <c:v>7357262</c:v>
                </c:pt>
                <c:pt idx="103">
                  <c:v>7411565</c:v>
                </c:pt>
                <c:pt idx="104">
                  <c:v>7487260</c:v>
                </c:pt>
                <c:pt idx="105">
                  <c:v>7490615</c:v>
                </c:pt>
                <c:pt idx="106">
                  <c:v>7491352</c:v>
                </c:pt>
                <c:pt idx="107">
                  <c:v>7493745</c:v>
                </c:pt>
                <c:pt idx="108">
                  <c:v>7633772</c:v>
                </c:pt>
                <c:pt idx="109">
                  <c:v>7636628</c:v>
                </c:pt>
                <c:pt idx="110">
                  <c:v>7638512</c:v>
                </c:pt>
                <c:pt idx="111">
                  <c:v>7649538</c:v>
                </c:pt>
                <c:pt idx="112">
                  <c:v>7785837</c:v>
                </c:pt>
                <c:pt idx="113">
                  <c:v>7791125</c:v>
                </c:pt>
                <c:pt idx="114">
                  <c:v>7854811</c:v>
                </c:pt>
                <c:pt idx="115">
                  <c:v>7857395</c:v>
                </c:pt>
                <c:pt idx="116">
                  <c:v>7940074</c:v>
                </c:pt>
                <c:pt idx="117">
                  <c:v>8089310</c:v>
                </c:pt>
                <c:pt idx="118">
                  <c:v>8196184</c:v>
                </c:pt>
                <c:pt idx="119">
                  <c:v>8485399</c:v>
                </c:pt>
                <c:pt idx="120">
                  <c:v>8806219</c:v>
                </c:pt>
                <c:pt idx="121">
                  <c:v>8823189</c:v>
                </c:pt>
                <c:pt idx="122">
                  <c:v>8825349</c:v>
                </c:pt>
                <c:pt idx="123">
                  <c:v>8877998</c:v>
                </c:pt>
                <c:pt idx="124">
                  <c:v>8922557</c:v>
                </c:pt>
                <c:pt idx="125">
                  <c:v>9097957</c:v>
                </c:pt>
                <c:pt idx="126">
                  <c:v>9102150</c:v>
                </c:pt>
                <c:pt idx="127">
                  <c:v>9204364</c:v>
                </c:pt>
                <c:pt idx="128">
                  <c:v>9218921</c:v>
                </c:pt>
                <c:pt idx="129">
                  <c:v>9309594</c:v>
                </c:pt>
                <c:pt idx="130">
                  <c:v>9356103</c:v>
                </c:pt>
                <c:pt idx="131">
                  <c:v>9358553</c:v>
                </c:pt>
                <c:pt idx="132">
                  <c:v>9506011</c:v>
                </c:pt>
                <c:pt idx="133">
                  <c:v>9555037</c:v>
                </c:pt>
                <c:pt idx="134">
                  <c:v>9622957</c:v>
                </c:pt>
                <c:pt idx="135">
                  <c:v>9653994</c:v>
                </c:pt>
                <c:pt idx="136">
                  <c:v>9741592</c:v>
                </c:pt>
                <c:pt idx="137">
                  <c:v>9853020</c:v>
                </c:pt>
                <c:pt idx="138">
                  <c:v>9890326</c:v>
                </c:pt>
                <c:pt idx="139">
                  <c:v>9979254</c:v>
                </c:pt>
                <c:pt idx="140">
                  <c:v>9981927</c:v>
                </c:pt>
                <c:pt idx="141">
                  <c:v>10003382</c:v>
                </c:pt>
                <c:pt idx="142">
                  <c:v>10041566</c:v>
                </c:pt>
                <c:pt idx="143">
                  <c:v>10042088</c:v>
                </c:pt>
                <c:pt idx="144">
                  <c:v>10060672</c:v>
                </c:pt>
                <c:pt idx="145">
                  <c:v>10123995</c:v>
                </c:pt>
                <c:pt idx="146">
                  <c:v>10125364</c:v>
                </c:pt>
                <c:pt idx="147">
                  <c:v>10177303</c:v>
                </c:pt>
                <c:pt idx="148">
                  <c:v>10251180</c:v>
                </c:pt>
                <c:pt idx="149">
                  <c:v>10273583</c:v>
                </c:pt>
                <c:pt idx="150">
                  <c:v>10331662</c:v>
                </c:pt>
                <c:pt idx="151">
                  <c:v>10365561</c:v>
                </c:pt>
                <c:pt idx="152">
                  <c:v>10378164</c:v>
                </c:pt>
                <c:pt idx="153">
                  <c:v>10415502</c:v>
                </c:pt>
                <c:pt idx="154">
                  <c:v>10421740</c:v>
                </c:pt>
                <c:pt idx="155">
                  <c:v>10439917</c:v>
                </c:pt>
                <c:pt idx="156">
                  <c:v>10730737</c:v>
                </c:pt>
                <c:pt idx="157">
                  <c:v>10759481</c:v>
                </c:pt>
                <c:pt idx="158">
                  <c:v>10813963</c:v>
                </c:pt>
                <c:pt idx="159">
                  <c:v>10874372</c:v>
                </c:pt>
                <c:pt idx="160">
                  <c:v>10928667</c:v>
                </c:pt>
                <c:pt idx="161">
                  <c:v>11087514</c:v>
                </c:pt>
                <c:pt idx="162">
                  <c:v>11093533</c:v>
                </c:pt>
                <c:pt idx="163">
                  <c:v>11106182</c:v>
                </c:pt>
                <c:pt idx="164">
                  <c:v>11208846</c:v>
                </c:pt>
                <c:pt idx="165">
                  <c:v>11276755</c:v>
                </c:pt>
                <c:pt idx="166">
                  <c:v>11365178</c:v>
                </c:pt>
                <c:pt idx="167">
                  <c:v>11569102</c:v>
                </c:pt>
                <c:pt idx="168">
                  <c:v>11579019</c:v>
                </c:pt>
                <c:pt idx="169">
                  <c:v>11700845</c:v>
                </c:pt>
                <c:pt idx="170">
                  <c:v>11905305</c:v>
                </c:pt>
                <c:pt idx="171">
                  <c:v>11918225</c:v>
                </c:pt>
                <c:pt idx="172">
                  <c:v>12054636</c:v>
                </c:pt>
                <c:pt idx="173">
                  <c:v>12063182</c:v>
                </c:pt>
              </c:numCache>
            </c:numRef>
          </c:xVal>
          <c:yVal>
            <c:numRef>
              <c:f>'338 up de no change prion'!$I$2:$I$175</c:f>
              <c:numCache>
                <c:formatCode>General</c:formatCode>
                <c:ptCount val="174"/>
                <c:pt idx="0">
                  <c:v>3.4026664977643728</c:v>
                </c:pt>
                <c:pt idx="1">
                  <c:v>1.3262086021671373</c:v>
                </c:pt>
                <c:pt idx="2">
                  <c:v>3.2449967222744371</c:v>
                </c:pt>
                <c:pt idx="3">
                  <c:v>1.5148908264077448</c:v>
                </c:pt>
                <c:pt idx="4">
                  <c:v>1.551337058202882</c:v>
                </c:pt>
                <c:pt idx="5">
                  <c:v>2.137528281628819</c:v>
                </c:pt>
                <c:pt idx="6">
                  <c:v>2.1780504154738249</c:v>
                </c:pt>
                <c:pt idx="7">
                  <c:v>1.2775321180228452</c:v>
                </c:pt>
                <c:pt idx="8">
                  <c:v>1.4513291549146685</c:v>
                </c:pt>
                <c:pt idx="9">
                  <c:v>1.9780075555632524</c:v>
                </c:pt>
                <c:pt idx="10">
                  <c:v>1.442491813895822</c:v>
                </c:pt>
                <c:pt idx="11">
                  <c:v>2.5515437590258512</c:v>
                </c:pt>
                <c:pt idx="12">
                  <c:v>3.9072800373664465</c:v>
                </c:pt>
                <c:pt idx="13">
                  <c:v>1.5496464786250328</c:v>
                </c:pt>
                <c:pt idx="14">
                  <c:v>1.0816979440953558</c:v>
                </c:pt>
                <c:pt idx="15">
                  <c:v>2.4053456874647479</c:v>
                </c:pt>
                <c:pt idx="16">
                  <c:v>1.8778832600806965</c:v>
                </c:pt>
                <c:pt idx="17">
                  <c:v>2.1799963458554235</c:v>
                </c:pt>
                <c:pt idx="18">
                  <c:v>1.1888690851348676</c:v>
                </c:pt>
                <c:pt idx="19">
                  <c:v>1.9126361644716086</c:v>
                </c:pt>
                <c:pt idx="20">
                  <c:v>1.9305573417073385</c:v>
                </c:pt>
                <c:pt idx="21">
                  <c:v>1.0619564950600033</c:v>
                </c:pt>
                <c:pt idx="22">
                  <c:v>2.9210609022277794</c:v>
                </c:pt>
                <c:pt idx="23">
                  <c:v>1.7252851758915104</c:v>
                </c:pt>
                <c:pt idx="24">
                  <c:v>1.2688950038814979</c:v>
                </c:pt>
                <c:pt idx="25">
                  <c:v>1.3372821392335446</c:v>
                </c:pt>
                <c:pt idx="26">
                  <c:v>1.7519459675962488</c:v>
                </c:pt>
                <c:pt idx="27">
                  <c:v>1.4483518355410347</c:v>
                </c:pt>
                <c:pt idx="28">
                  <c:v>1.97806197417734</c:v>
                </c:pt>
                <c:pt idx="29">
                  <c:v>4.5733834978684573</c:v>
                </c:pt>
                <c:pt idx="30">
                  <c:v>1.5153024741395718</c:v>
                </c:pt>
                <c:pt idx="31">
                  <c:v>1.5322287196364091</c:v>
                </c:pt>
                <c:pt idx="32">
                  <c:v>1.3374916479484926</c:v>
                </c:pt>
                <c:pt idx="33">
                  <c:v>2.920939950964816</c:v>
                </c:pt>
                <c:pt idx="34">
                  <c:v>1.3292448479266561</c:v>
                </c:pt>
                <c:pt idx="35">
                  <c:v>1.0395002588495281</c:v>
                </c:pt>
                <c:pt idx="36">
                  <c:v>1.4105110847156994</c:v>
                </c:pt>
                <c:pt idx="37">
                  <c:v>1.7014703212811297</c:v>
                </c:pt>
                <c:pt idx="38">
                  <c:v>1.5850410612248034</c:v>
                </c:pt>
                <c:pt idx="39">
                  <c:v>1.7483475626159801</c:v>
                </c:pt>
                <c:pt idx="40">
                  <c:v>1.6036286008665841</c:v>
                </c:pt>
                <c:pt idx="41">
                  <c:v>1.9158528134825661</c:v>
                </c:pt>
                <c:pt idx="42">
                  <c:v>3.9272556147982289</c:v>
                </c:pt>
                <c:pt idx="43">
                  <c:v>1.013644938201409</c:v>
                </c:pt>
                <c:pt idx="44">
                  <c:v>4.1093648998606973</c:v>
                </c:pt>
                <c:pt idx="45">
                  <c:v>3.5911757004024407</c:v>
                </c:pt>
                <c:pt idx="46">
                  <c:v>1.7208926130035298</c:v>
                </c:pt>
                <c:pt idx="47">
                  <c:v>1.833159123875773</c:v>
                </c:pt>
                <c:pt idx="48">
                  <c:v>2.8849202786161046</c:v>
                </c:pt>
                <c:pt idx="49">
                  <c:v>1.1793543175267305</c:v>
                </c:pt>
                <c:pt idx="50">
                  <c:v>1.2074537568626087</c:v>
                </c:pt>
                <c:pt idx="51">
                  <c:v>1.3947019847486639</c:v>
                </c:pt>
                <c:pt idx="52">
                  <c:v>1.1419559833530359</c:v>
                </c:pt>
                <c:pt idx="53">
                  <c:v>1.4479105858097316</c:v>
                </c:pt>
                <c:pt idx="54">
                  <c:v>3.0894405633870461</c:v>
                </c:pt>
                <c:pt idx="55">
                  <c:v>1.4991717210472597</c:v>
                </c:pt>
                <c:pt idx="56">
                  <c:v>1.0746279811623789</c:v>
                </c:pt>
                <c:pt idx="57">
                  <c:v>1.482314904702823</c:v>
                </c:pt>
                <c:pt idx="58">
                  <c:v>1.7746209675985634</c:v>
                </c:pt>
                <c:pt idx="59">
                  <c:v>2.2205433774012078</c:v>
                </c:pt>
                <c:pt idx="60">
                  <c:v>1.4063456694110659</c:v>
                </c:pt>
                <c:pt idx="61">
                  <c:v>1.5552665869850291</c:v>
                </c:pt>
                <c:pt idx="62">
                  <c:v>2.2950233271859131</c:v>
                </c:pt>
                <c:pt idx="63">
                  <c:v>4.6254887554761019</c:v>
                </c:pt>
                <c:pt idx="64">
                  <c:v>1.4680843045139969</c:v>
                </c:pt>
                <c:pt idx="65">
                  <c:v>1.151803580231427</c:v>
                </c:pt>
                <c:pt idx="66">
                  <c:v>1.2283023050131969</c:v>
                </c:pt>
                <c:pt idx="67">
                  <c:v>2.0887760411504956</c:v>
                </c:pt>
                <c:pt idx="68">
                  <c:v>3.0602812119625438</c:v>
                </c:pt>
                <c:pt idx="69">
                  <c:v>3.2894750909720347</c:v>
                </c:pt>
                <c:pt idx="70">
                  <c:v>1.6030289144763525</c:v>
                </c:pt>
                <c:pt idx="71">
                  <c:v>2.1839596412956706</c:v>
                </c:pt>
                <c:pt idx="72">
                  <c:v>1.0431304757202577</c:v>
                </c:pt>
                <c:pt idx="73">
                  <c:v>2.9398360178773038</c:v>
                </c:pt>
                <c:pt idx="74">
                  <c:v>1.4185925317034864</c:v>
                </c:pt>
                <c:pt idx="75">
                  <c:v>1.818092579005498</c:v>
                </c:pt>
                <c:pt idx="76">
                  <c:v>1.0654119619513289</c:v>
                </c:pt>
                <c:pt idx="77">
                  <c:v>1.1704928993708184</c:v>
                </c:pt>
                <c:pt idx="78">
                  <c:v>1.2782466163628536</c:v>
                </c:pt>
                <c:pt idx="79">
                  <c:v>1.59512251167366</c:v>
                </c:pt>
                <c:pt idx="80">
                  <c:v>2.8589848198061816</c:v>
                </c:pt>
                <c:pt idx="81">
                  <c:v>1.4777746328067285</c:v>
                </c:pt>
                <c:pt idx="82">
                  <c:v>1.512898470261604</c:v>
                </c:pt>
                <c:pt idx="83">
                  <c:v>1.1422616116302597</c:v>
                </c:pt>
                <c:pt idx="84">
                  <c:v>3.5206374233515043</c:v>
                </c:pt>
                <c:pt idx="85">
                  <c:v>1.9915115298860804</c:v>
                </c:pt>
                <c:pt idx="86">
                  <c:v>1.1287357695255973</c:v>
                </c:pt>
                <c:pt idx="87">
                  <c:v>1.0661531080965401</c:v>
                </c:pt>
                <c:pt idx="88">
                  <c:v>1.70657269468241</c:v>
                </c:pt>
                <c:pt idx="89">
                  <c:v>1.8346740295268156</c:v>
                </c:pt>
                <c:pt idx="90">
                  <c:v>1.3861731221967644</c:v>
                </c:pt>
                <c:pt idx="91">
                  <c:v>5.9060687775917158</c:v>
                </c:pt>
                <c:pt idx="92">
                  <c:v>5.7553552406075053</c:v>
                </c:pt>
                <c:pt idx="93">
                  <c:v>1.3788811771303471</c:v>
                </c:pt>
                <c:pt idx="94">
                  <c:v>1.1405361383711154</c:v>
                </c:pt>
                <c:pt idx="95">
                  <c:v>1.6812003073421999</c:v>
                </c:pt>
                <c:pt idx="96">
                  <c:v>1.6666952908365278</c:v>
                </c:pt>
                <c:pt idx="97">
                  <c:v>3.9780808023871725</c:v>
                </c:pt>
                <c:pt idx="98">
                  <c:v>1.0902827715441064</c:v>
                </c:pt>
                <c:pt idx="99">
                  <c:v>1.4801810215185509</c:v>
                </c:pt>
                <c:pt idx="100">
                  <c:v>2.3908691605475525</c:v>
                </c:pt>
                <c:pt idx="101">
                  <c:v>1.4469924316757223</c:v>
                </c:pt>
                <c:pt idx="102">
                  <c:v>1.180660120543906</c:v>
                </c:pt>
                <c:pt idx="103">
                  <c:v>2.2245465492288554</c:v>
                </c:pt>
                <c:pt idx="104">
                  <c:v>1.0819530768505676</c:v>
                </c:pt>
                <c:pt idx="105">
                  <c:v>1.1372409585686554</c:v>
                </c:pt>
                <c:pt idx="106">
                  <c:v>1.5205193284645817</c:v>
                </c:pt>
                <c:pt idx="107">
                  <c:v>1.9753311630487638</c:v>
                </c:pt>
                <c:pt idx="108">
                  <c:v>1.3936619132574357</c:v>
                </c:pt>
                <c:pt idx="109">
                  <c:v>3.4636774489866959</c:v>
                </c:pt>
                <c:pt idx="110">
                  <c:v>2.8494762746112632</c:v>
                </c:pt>
                <c:pt idx="111">
                  <c:v>2.1053144853508803</c:v>
                </c:pt>
                <c:pt idx="112">
                  <c:v>1.7626220094079368</c:v>
                </c:pt>
                <c:pt idx="113">
                  <c:v>1.4662748748156798</c:v>
                </c:pt>
                <c:pt idx="114">
                  <c:v>2.3752551672669102</c:v>
                </c:pt>
                <c:pt idx="115">
                  <c:v>1.5726189046823633</c:v>
                </c:pt>
                <c:pt idx="116">
                  <c:v>1.9176042487508322</c:v>
                </c:pt>
                <c:pt idx="117">
                  <c:v>1.1537072540796092</c:v>
                </c:pt>
                <c:pt idx="118">
                  <c:v>2.9122783172984748</c:v>
                </c:pt>
                <c:pt idx="119">
                  <c:v>1.0807625926098223</c:v>
                </c:pt>
                <c:pt idx="120">
                  <c:v>1.0651285150109293</c:v>
                </c:pt>
                <c:pt idx="121">
                  <c:v>1.4347672839668351</c:v>
                </c:pt>
                <c:pt idx="122">
                  <c:v>1.2797612807507117</c:v>
                </c:pt>
                <c:pt idx="123">
                  <c:v>1.8115246172704138</c:v>
                </c:pt>
                <c:pt idx="124">
                  <c:v>1.6807600538560654</c:v>
                </c:pt>
                <c:pt idx="125">
                  <c:v>1.0700070788961766</c:v>
                </c:pt>
                <c:pt idx="126">
                  <c:v>1.0818645061370837</c:v>
                </c:pt>
                <c:pt idx="127">
                  <c:v>2.1746161417869785</c:v>
                </c:pt>
                <c:pt idx="128">
                  <c:v>2.1882053644395998</c:v>
                </c:pt>
                <c:pt idx="129">
                  <c:v>1.3941252242646709</c:v>
                </c:pt>
                <c:pt idx="130">
                  <c:v>1.6919416792663413</c:v>
                </c:pt>
                <c:pt idx="131">
                  <c:v>1.5570610169230026</c:v>
                </c:pt>
                <c:pt idx="132">
                  <c:v>1.3469286756184389</c:v>
                </c:pt>
                <c:pt idx="133">
                  <c:v>1.4864428112529942</c:v>
                </c:pt>
                <c:pt idx="134">
                  <c:v>1.4591116475649046</c:v>
                </c:pt>
                <c:pt idx="135">
                  <c:v>5.4525462082674911</c:v>
                </c:pt>
                <c:pt idx="136">
                  <c:v>1.1013401764401287</c:v>
                </c:pt>
                <c:pt idx="137">
                  <c:v>1.8650571933048674</c:v>
                </c:pt>
                <c:pt idx="138">
                  <c:v>1.6507914297496131</c:v>
                </c:pt>
                <c:pt idx="139">
                  <c:v>3.9520552899975772</c:v>
                </c:pt>
                <c:pt idx="140">
                  <c:v>3.2154087720054334</c:v>
                </c:pt>
                <c:pt idx="141">
                  <c:v>1.0360370157967733</c:v>
                </c:pt>
                <c:pt idx="142">
                  <c:v>1.0677456097049189</c:v>
                </c:pt>
                <c:pt idx="143">
                  <c:v>1.380905234883814</c:v>
                </c:pt>
                <c:pt idx="144">
                  <c:v>1.9018533890278482</c:v>
                </c:pt>
                <c:pt idx="145">
                  <c:v>1.2853394447524369</c:v>
                </c:pt>
                <c:pt idx="146">
                  <c:v>1.7462753442444137</c:v>
                </c:pt>
                <c:pt idx="147">
                  <c:v>1.5479254058778711</c:v>
                </c:pt>
                <c:pt idx="148">
                  <c:v>1.612598386142841</c:v>
                </c:pt>
                <c:pt idx="149">
                  <c:v>1.082081174386095</c:v>
                </c:pt>
                <c:pt idx="150">
                  <c:v>1.189703630752581</c:v>
                </c:pt>
                <c:pt idx="151">
                  <c:v>1.9495559696610638</c:v>
                </c:pt>
                <c:pt idx="152">
                  <c:v>1.43115649688371</c:v>
                </c:pt>
                <c:pt idx="153">
                  <c:v>2.4988439962590281</c:v>
                </c:pt>
                <c:pt idx="154">
                  <c:v>2.8944900231044697</c:v>
                </c:pt>
                <c:pt idx="155">
                  <c:v>1.3605784725295049</c:v>
                </c:pt>
                <c:pt idx="156">
                  <c:v>3.004134046253609</c:v>
                </c:pt>
                <c:pt idx="157">
                  <c:v>3.459600436395025</c:v>
                </c:pt>
                <c:pt idx="158">
                  <c:v>2.4491492876473582</c:v>
                </c:pt>
                <c:pt idx="159">
                  <c:v>1.62728364500431</c:v>
                </c:pt>
                <c:pt idx="160">
                  <c:v>1.3665595665665511</c:v>
                </c:pt>
                <c:pt idx="161">
                  <c:v>1.5206606163087708</c:v>
                </c:pt>
                <c:pt idx="162">
                  <c:v>1.1199171688592202</c:v>
                </c:pt>
                <c:pt idx="163">
                  <c:v>1.0988910569751291</c:v>
                </c:pt>
                <c:pt idx="164">
                  <c:v>1.5886697524256974</c:v>
                </c:pt>
                <c:pt idx="165">
                  <c:v>1.5816491583978587</c:v>
                </c:pt>
                <c:pt idx="166">
                  <c:v>4.1036999589671135</c:v>
                </c:pt>
                <c:pt idx="167">
                  <c:v>2.057260249811427</c:v>
                </c:pt>
                <c:pt idx="168">
                  <c:v>1.0119646906056783</c:v>
                </c:pt>
                <c:pt idx="169">
                  <c:v>2.0648304510273232</c:v>
                </c:pt>
                <c:pt idx="170">
                  <c:v>1.0895676740357485</c:v>
                </c:pt>
                <c:pt idx="171">
                  <c:v>3.5362518574191544</c:v>
                </c:pt>
                <c:pt idx="172">
                  <c:v>1.3172087909386023</c:v>
                </c:pt>
                <c:pt idx="173">
                  <c:v>1.8506187028847758</c:v>
                </c:pt>
              </c:numCache>
            </c:numRef>
          </c:yVal>
          <c:smooth val="0"/>
          <c:extLst>
            <c:ext xmlns:c16="http://schemas.microsoft.com/office/drawing/2014/chart" uri="{C3380CC4-5D6E-409C-BE32-E72D297353CC}">
              <c16:uniqueId val="{00000001-40B6-4BD4-83C7-D1F1D09F5F52}"/>
            </c:ext>
          </c:extLst>
        </c:ser>
        <c:dLbls>
          <c:showLegendKey val="0"/>
          <c:showVal val="0"/>
          <c:showCatName val="0"/>
          <c:showSerName val="0"/>
          <c:showPercent val="0"/>
          <c:showBubbleSize val="0"/>
        </c:dLbls>
        <c:axId val="171912192"/>
        <c:axId val="171913984"/>
      </c:scatterChart>
      <c:valAx>
        <c:axId val="171912192"/>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913984"/>
        <c:crosses val="autoZero"/>
        <c:crossBetween val="midCat"/>
      </c:valAx>
      <c:valAx>
        <c:axId val="171913984"/>
        <c:scaling>
          <c:orientation val="minMax"/>
          <c:max val="4"/>
          <c:min val="-1"/>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191219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211 up prion no change del'!$J$107</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round/>
              </a:ln>
              <a:effectLst/>
            </c:spPr>
          </c:errBars>
          <c:xVal>
            <c:numRef>
              <c:f>'211 up prion no change del'!$I$108:$I$213</c:f>
              <c:numCache>
                <c:formatCode>General</c:formatCode>
                <c:ptCount val="106"/>
                <c:pt idx="0">
                  <c:v>465612</c:v>
                </c:pt>
                <c:pt idx="1">
                  <c:v>381711</c:v>
                </c:pt>
                <c:pt idx="2">
                  <c:v>586542</c:v>
                </c:pt>
                <c:pt idx="3">
                  <c:v>600255</c:v>
                </c:pt>
                <c:pt idx="4">
                  <c:v>655208</c:v>
                </c:pt>
                <c:pt idx="5">
                  <c:v>699966</c:v>
                </c:pt>
                <c:pt idx="6">
                  <c:v>778580</c:v>
                </c:pt>
                <c:pt idx="7">
                  <c:v>800060</c:v>
                </c:pt>
                <c:pt idx="8">
                  <c:v>845421</c:v>
                </c:pt>
                <c:pt idx="9">
                  <c:v>866921</c:v>
                </c:pt>
                <c:pt idx="10">
                  <c:v>945025</c:v>
                </c:pt>
                <c:pt idx="11">
                  <c:v>953954</c:v>
                </c:pt>
                <c:pt idx="12">
                  <c:v>981574</c:v>
                </c:pt>
                <c:pt idx="13">
                  <c:v>1662486</c:v>
                </c:pt>
                <c:pt idx="14">
                  <c:v>1640329</c:v>
                </c:pt>
                <c:pt idx="15">
                  <c:v>1521017</c:v>
                </c:pt>
                <c:pt idx="16">
                  <c:v>1509225</c:v>
                </c:pt>
                <c:pt idx="17">
                  <c:v>1845768</c:v>
                </c:pt>
                <c:pt idx="18">
                  <c:v>1908000</c:v>
                </c:pt>
                <c:pt idx="19">
                  <c:v>1986730</c:v>
                </c:pt>
                <c:pt idx="20">
                  <c:v>2655620</c:v>
                </c:pt>
                <c:pt idx="21">
                  <c:v>2789210</c:v>
                </c:pt>
                <c:pt idx="22">
                  <c:v>2822380</c:v>
                </c:pt>
                <c:pt idx="23">
                  <c:v>2831570</c:v>
                </c:pt>
                <c:pt idx="24">
                  <c:v>3014753</c:v>
                </c:pt>
                <c:pt idx="25">
                  <c:v>3000459</c:v>
                </c:pt>
                <c:pt idx="26">
                  <c:v>2988813</c:v>
                </c:pt>
                <c:pt idx="27">
                  <c:v>3148330</c:v>
                </c:pt>
                <c:pt idx="28">
                  <c:v>3156847</c:v>
                </c:pt>
                <c:pt idx="29">
                  <c:v>4218900</c:v>
                </c:pt>
                <c:pt idx="30">
                  <c:v>4127958</c:v>
                </c:pt>
                <c:pt idx="31">
                  <c:v>3893605</c:v>
                </c:pt>
                <c:pt idx="32">
                  <c:v>4421556</c:v>
                </c:pt>
                <c:pt idx="33">
                  <c:v>4544259</c:v>
                </c:pt>
                <c:pt idx="34">
                  <c:v>4572342</c:v>
                </c:pt>
                <c:pt idx="35">
                  <c:v>4585923</c:v>
                </c:pt>
                <c:pt idx="36">
                  <c:v>4676114</c:v>
                </c:pt>
                <c:pt idx="37">
                  <c:v>4950021</c:v>
                </c:pt>
                <c:pt idx="38">
                  <c:v>5027328</c:v>
                </c:pt>
                <c:pt idx="39">
                  <c:v>5217718</c:v>
                </c:pt>
                <c:pt idx="40">
                  <c:v>5224385</c:v>
                </c:pt>
                <c:pt idx="41">
                  <c:v>5232016</c:v>
                </c:pt>
                <c:pt idx="42">
                  <c:v>5583603</c:v>
                </c:pt>
                <c:pt idx="43">
                  <c:v>5529227</c:v>
                </c:pt>
                <c:pt idx="44">
                  <c:v>5493354</c:v>
                </c:pt>
                <c:pt idx="45">
                  <c:v>5805588</c:v>
                </c:pt>
                <c:pt idx="46">
                  <c:v>6044461</c:v>
                </c:pt>
                <c:pt idx="47">
                  <c:v>5998184</c:v>
                </c:pt>
                <c:pt idx="48">
                  <c:v>5888905</c:v>
                </c:pt>
                <c:pt idx="49">
                  <c:v>6273455</c:v>
                </c:pt>
                <c:pt idx="50">
                  <c:v>6319047</c:v>
                </c:pt>
                <c:pt idx="51">
                  <c:v>6342700</c:v>
                </c:pt>
                <c:pt idx="52">
                  <c:v>6401267</c:v>
                </c:pt>
                <c:pt idx="53">
                  <c:v>6462046</c:v>
                </c:pt>
                <c:pt idx="54">
                  <c:v>6989831</c:v>
                </c:pt>
                <c:pt idx="55">
                  <c:v>6960928</c:v>
                </c:pt>
                <c:pt idx="56">
                  <c:v>6754055</c:v>
                </c:pt>
                <c:pt idx="57">
                  <c:v>6716144</c:v>
                </c:pt>
                <c:pt idx="58">
                  <c:v>6712721</c:v>
                </c:pt>
                <c:pt idx="59">
                  <c:v>6614911</c:v>
                </c:pt>
                <c:pt idx="60">
                  <c:v>7099109</c:v>
                </c:pt>
                <c:pt idx="61">
                  <c:v>7139001</c:v>
                </c:pt>
                <c:pt idx="62">
                  <c:v>7165001</c:v>
                </c:pt>
                <c:pt idx="63">
                  <c:v>7322180</c:v>
                </c:pt>
                <c:pt idx="64">
                  <c:v>7476730</c:v>
                </c:pt>
                <c:pt idx="65">
                  <c:v>7589017</c:v>
                </c:pt>
                <c:pt idx="66">
                  <c:v>7765571</c:v>
                </c:pt>
                <c:pt idx="67">
                  <c:v>7928700</c:v>
                </c:pt>
                <c:pt idx="68">
                  <c:v>7956019</c:v>
                </c:pt>
                <c:pt idx="69">
                  <c:v>7964817</c:v>
                </c:pt>
                <c:pt idx="70">
                  <c:v>8083094</c:v>
                </c:pt>
                <c:pt idx="71">
                  <c:v>8286827</c:v>
                </c:pt>
                <c:pt idx="72">
                  <c:v>8557976</c:v>
                </c:pt>
                <c:pt idx="73">
                  <c:v>8382144</c:v>
                </c:pt>
                <c:pt idx="74">
                  <c:v>8592224</c:v>
                </c:pt>
                <c:pt idx="75">
                  <c:v>8739401</c:v>
                </c:pt>
                <c:pt idx="76">
                  <c:v>8745708</c:v>
                </c:pt>
                <c:pt idx="77">
                  <c:v>8845534</c:v>
                </c:pt>
                <c:pt idx="78">
                  <c:v>8858149</c:v>
                </c:pt>
                <c:pt idx="79">
                  <c:v>8995092</c:v>
                </c:pt>
                <c:pt idx="80">
                  <c:v>9107826</c:v>
                </c:pt>
                <c:pt idx="81">
                  <c:v>9187617</c:v>
                </c:pt>
                <c:pt idx="82">
                  <c:v>9188764</c:v>
                </c:pt>
                <c:pt idx="83">
                  <c:v>9753504</c:v>
                </c:pt>
                <c:pt idx="84">
                  <c:v>9664576</c:v>
                </c:pt>
                <c:pt idx="85">
                  <c:v>9593305</c:v>
                </c:pt>
                <c:pt idx="86">
                  <c:v>9569855</c:v>
                </c:pt>
                <c:pt idx="87">
                  <c:v>9478704</c:v>
                </c:pt>
                <c:pt idx="88">
                  <c:v>9292944</c:v>
                </c:pt>
                <c:pt idx="89">
                  <c:v>9970992</c:v>
                </c:pt>
                <c:pt idx="90">
                  <c:v>10238072</c:v>
                </c:pt>
                <c:pt idx="91">
                  <c:v>10369649</c:v>
                </c:pt>
                <c:pt idx="92">
                  <c:v>10456815</c:v>
                </c:pt>
                <c:pt idx="93">
                  <c:v>10633352</c:v>
                </c:pt>
                <c:pt idx="94">
                  <c:v>10827770</c:v>
                </c:pt>
                <c:pt idx="95">
                  <c:v>10863028</c:v>
                </c:pt>
                <c:pt idx="96">
                  <c:v>10882906</c:v>
                </c:pt>
                <c:pt idx="97">
                  <c:v>11322755</c:v>
                </c:pt>
                <c:pt idx="98">
                  <c:v>11274775</c:v>
                </c:pt>
                <c:pt idx="99">
                  <c:v>11243423</c:v>
                </c:pt>
                <c:pt idx="100">
                  <c:v>11218632</c:v>
                </c:pt>
                <c:pt idx="101">
                  <c:v>11210274</c:v>
                </c:pt>
                <c:pt idx="102">
                  <c:v>11188237</c:v>
                </c:pt>
                <c:pt idx="103">
                  <c:v>11166543</c:v>
                </c:pt>
                <c:pt idx="104">
                  <c:v>11816056</c:v>
                </c:pt>
                <c:pt idx="105">
                  <c:v>11961169</c:v>
                </c:pt>
              </c:numCache>
            </c:numRef>
          </c:xVal>
          <c:yVal>
            <c:numRef>
              <c:f>'211 up prion no change del'!$J$108:$J$213</c:f>
              <c:numCache>
                <c:formatCode>General</c:formatCode>
                <c:ptCount val="106"/>
                <c:pt idx="0">
                  <c:v>1.0973160905718389</c:v>
                </c:pt>
                <c:pt idx="1">
                  <c:v>0.98308481591906516</c:v>
                </c:pt>
                <c:pt idx="2">
                  <c:v>1.3749110794340167</c:v>
                </c:pt>
                <c:pt idx="3">
                  <c:v>1.2214166519696084</c:v>
                </c:pt>
                <c:pt idx="4">
                  <c:v>1.0888583732969013</c:v>
                </c:pt>
                <c:pt idx="5">
                  <c:v>1.0969744027260067</c:v>
                </c:pt>
                <c:pt idx="6">
                  <c:v>0.97459069529355624</c:v>
                </c:pt>
                <c:pt idx="7">
                  <c:v>1.1516681623862444</c:v>
                </c:pt>
                <c:pt idx="8">
                  <c:v>1.2109811784203128</c:v>
                </c:pt>
                <c:pt idx="9">
                  <c:v>1.006540257531807</c:v>
                </c:pt>
                <c:pt idx="10">
                  <c:v>1.3224479978323112</c:v>
                </c:pt>
                <c:pt idx="11">
                  <c:v>1.1826647125283052</c:v>
                </c:pt>
                <c:pt idx="12">
                  <c:v>1.0183839160767663</c:v>
                </c:pt>
                <c:pt idx="13">
                  <c:v>1.7767452337874305</c:v>
                </c:pt>
                <c:pt idx="14">
                  <c:v>1.0500041624931862</c:v>
                </c:pt>
                <c:pt idx="15">
                  <c:v>1.9443783401400283</c:v>
                </c:pt>
                <c:pt idx="16">
                  <c:v>1.0028972748929641</c:v>
                </c:pt>
                <c:pt idx="17">
                  <c:v>1.0024312358734755</c:v>
                </c:pt>
                <c:pt idx="18">
                  <c:v>1.6076574168704014</c:v>
                </c:pt>
                <c:pt idx="19">
                  <c:v>1.0893313191041338</c:v>
                </c:pt>
                <c:pt idx="20">
                  <c:v>1.1607372974432493</c:v>
                </c:pt>
                <c:pt idx="21">
                  <c:v>1.1218745851409699</c:v>
                </c:pt>
                <c:pt idx="22">
                  <c:v>0.96486192057121734</c:v>
                </c:pt>
                <c:pt idx="23">
                  <c:v>1.1490855246575635</c:v>
                </c:pt>
                <c:pt idx="24">
                  <c:v>1.3414985443074348</c:v>
                </c:pt>
                <c:pt idx="25">
                  <c:v>1.2727424984333509</c:v>
                </c:pt>
                <c:pt idx="26">
                  <c:v>1.5693146035389032</c:v>
                </c:pt>
                <c:pt idx="27">
                  <c:v>1.2973426555832732</c:v>
                </c:pt>
                <c:pt idx="28">
                  <c:v>1.7405154575915016</c:v>
                </c:pt>
                <c:pt idx="29">
                  <c:v>1.4684907919872643</c:v>
                </c:pt>
                <c:pt idx="30">
                  <c:v>1.0914008814916496</c:v>
                </c:pt>
                <c:pt idx="31">
                  <c:v>1.2590501114254053</c:v>
                </c:pt>
                <c:pt idx="32">
                  <c:v>1.0469094909543666</c:v>
                </c:pt>
                <c:pt idx="33">
                  <c:v>1.3045799734038284</c:v>
                </c:pt>
                <c:pt idx="34">
                  <c:v>0.99805347035311132</c:v>
                </c:pt>
                <c:pt idx="35">
                  <c:v>1.4879695211641411</c:v>
                </c:pt>
                <c:pt idx="36">
                  <c:v>1.059231063133538</c:v>
                </c:pt>
                <c:pt idx="37">
                  <c:v>1.7086593189612935</c:v>
                </c:pt>
                <c:pt idx="38">
                  <c:v>1.919584602404707</c:v>
                </c:pt>
                <c:pt idx="39">
                  <c:v>1.0313799932553476</c:v>
                </c:pt>
                <c:pt idx="40">
                  <c:v>1.2408766252916896</c:v>
                </c:pt>
                <c:pt idx="41">
                  <c:v>1.7214477159960808</c:v>
                </c:pt>
                <c:pt idx="42">
                  <c:v>1.0007262606465626</c:v>
                </c:pt>
                <c:pt idx="43">
                  <c:v>2.0287374279092694</c:v>
                </c:pt>
                <c:pt idx="44">
                  <c:v>1.4565109335167072</c:v>
                </c:pt>
                <c:pt idx="45">
                  <c:v>1.0824702497771692</c:v>
                </c:pt>
                <c:pt idx="46">
                  <c:v>1.2450589611901908</c:v>
                </c:pt>
                <c:pt idx="47">
                  <c:v>1.1575497085695949</c:v>
                </c:pt>
                <c:pt idx="48">
                  <c:v>1.1113004075336348</c:v>
                </c:pt>
                <c:pt idx="49">
                  <c:v>0.99896245962093344</c:v>
                </c:pt>
                <c:pt idx="50">
                  <c:v>1.1291567392630939</c:v>
                </c:pt>
                <c:pt idx="51">
                  <c:v>1.3558609675056352</c:v>
                </c:pt>
                <c:pt idx="52">
                  <c:v>1.5083268936746277</c:v>
                </c:pt>
                <c:pt idx="53">
                  <c:v>1.2592421726873537</c:v>
                </c:pt>
                <c:pt idx="54">
                  <c:v>1.3980386930256885</c:v>
                </c:pt>
                <c:pt idx="55">
                  <c:v>1.980568279341874</c:v>
                </c:pt>
                <c:pt idx="56">
                  <c:v>1.6170573578873748</c:v>
                </c:pt>
                <c:pt idx="57">
                  <c:v>1.2724997774108977</c:v>
                </c:pt>
                <c:pt idx="58">
                  <c:v>1.3766143517207423</c:v>
                </c:pt>
                <c:pt idx="59">
                  <c:v>1.1817848427112898</c:v>
                </c:pt>
                <c:pt idx="60">
                  <c:v>1.1155718028766695</c:v>
                </c:pt>
                <c:pt idx="61">
                  <c:v>1.0288960551076576</c:v>
                </c:pt>
                <c:pt idx="62">
                  <c:v>1.0993503318504161</c:v>
                </c:pt>
                <c:pt idx="63">
                  <c:v>0.97487796578059316</c:v>
                </c:pt>
                <c:pt idx="64">
                  <c:v>1.3056939540002912</c:v>
                </c:pt>
                <c:pt idx="65">
                  <c:v>1.0243574530125552</c:v>
                </c:pt>
                <c:pt idx="66">
                  <c:v>0.97552244809427791</c:v>
                </c:pt>
                <c:pt idx="67">
                  <c:v>0.99605938807012451</c:v>
                </c:pt>
                <c:pt idx="68">
                  <c:v>1.0804268735021219</c:v>
                </c:pt>
                <c:pt idx="69">
                  <c:v>1.4205190946648374</c:v>
                </c:pt>
                <c:pt idx="70">
                  <c:v>1.077131851144002</c:v>
                </c:pt>
                <c:pt idx="71">
                  <c:v>1.1557795974488396</c:v>
                </c:pt>
                <c:pt idx="72">
                  <c:v>1.350642038704835</c:v>
                </c:pt>
                <c:pt idx="73">
                  <c:v>0.98564735498394263</c:v>
                </c:pt>
                <c:pt idx="74">
                  <c:v>1.2650182234694292</c:v>
                </c:pt>
                <c:pt idx="75">
                  <c:v>1.0227663185292735</c:v>
                </c:pt>
                <c:pt idx="76">
                  <c:v>1.1348837110921142</c:v>
                </c:pt>
                <c:pt idx="77">
                  <c:v>1.3628123918861497</c:v>
                </c:pt>
                <c:pt idx="78">
                  <c:v>1.4675491007559589</c:v>
                </c:pt>
                <c:pt idx="79">
                  <c:v>1.1916374709753661</c:v>
                </c:pt>
                <c:pt idx="80">
                  <c:v>1.3489761960212223</c:v>
                </c:pt>
                <c:pt idx="81">
                  <c:v>1.0987737546723642</c:v>
                </c:pt>
                <c:pt idx="82">
                  <c:v>1.0166289521474874</c:v>
                </c:pt>
                <c:pt idx="83">
                  <c:v>0.95980426074681502</c:v>
                </c:pt>
                <c:pt idx="84">
                  <c:v>1.4312379867634304</c:v>
                </c:pt>
                <c:pt idx="85">
                  <c:v>1.5637782020207989</c:v>
                </c:pt>
                <c:pt idx="86">
                  <c:v>1.0966009581440472</c:v>
                </c:pt>
                <c:pt idx="87">
                  <c:v>0.95886569212883721</c:v>
                </c:pt>
                <c:pt idx="88">
                  <c:v>1.088767781023064</c:v>
                </c:pt>
                <c:pt idx="89">
                  <c:v>1.0795172472215862</c:v>
                </c:pt>
                <c:pt idx="90">
                  <c:v>1.0769025383393298</c:v>
                </c:pt>
                <c:pt idx="91">
                  <c:v>1.211699090313058</c:v>
                </c:pt>
                <c:pt idx="92">
                  <c:v>1.1091711235983428</c:v>
                </c:pt>
                <c:pt idx="93">
                  <c:v>1.0877034153334104</c:v>
                </c:pt>
                <c:pt idx="94">
                  <c:v>0.99996609580305984</c:v>
                </c:pt>
                <c:pt idx="95">
                  <c:v>0.99247464406662655</c:v>
                </c:pt>
                <c:pt idx="96">
                  <c:v>1.9162718112855641</c:v>
                </c:pt>
                <c:pt idx="97">
                  <c:v>1.6910631423142946</c:v>
                </c:pt>
                <c:pt idx="98">
                  <c:v>1.7124918449931881</c:v>
                </c:pt>
                <c:pt idx="99">
                  <c:v>1.1834337475129642</c:v>
                </c:pt>
                <c:pt idx="100">
                  <c:v>1.340216560152335</c:v>
                </c:pt>
                <c:pt idx="101">
                  <c:v>0.98869375953627137</c:v>
                </c:pt>
                <c:pt idx="102">
                  <c:v>1.3507444745982278</c:v>
                </c:pt>
                <c:pt idx="103">
                  <c:v>1.0435606233744275</c:v>
                </c:pt>
                <c:pt idx="104">
                  <c:v>1.0719542209773179</c:v>
                </c:pt>
                <c:pt idx="105">
                  <c:v>1.1503526435625908</c:v>
                </c:pt>
              </c:numCache>
            </c:numRef>
          </c:yVal>
          <c:smooth val="0"/>
          <c:extLst>
            <c:ext xmlns:c16="http://schemas.microsoft.com/office/drawing/2014/chart" uri="{C3380CC4-5D6E-409C-BE32-E72D297353CC}">
              <c16:uniqueId val="{00000000-74E7-4CDF-AA81-30F2A14DEE0C}"/>
            </c:ext>
          </c:extLst>
        </c:ser>
        <c:ser>
          <c:idx val="1"/>
          <c:order val="1"/>
          <c:tx>
            <c:strRef>
              <c:f>'211 up prion no change del'!$K$107</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C00000"/>
                </a:solidFill>
                <a:round/>
              </a:ln>
              <a:effectLst/>
            </c:spPr>
          </c:errBars>
          <c:xVal>
            <c:numRef>
              <c:f>'211 up prion no change del'!$I$108:$I$213</c:f>
              <c:numCache>
                <c:formatCode>General</c:formatCode>
                <c:ptCount val="106"/>
                <c:pt idx="0">
                  <c:v>465612</c:v>
                </c:pt>
                <c:pt idx="1">
                  <c:v>381711</c:v>
                </c:pt>
                <c:pt idx="2">
                  <c:v>586542</c:v>
                </c:pt>
                <c:pt idx="3">
                  <c:v>600255</c:v>
                </c:pt>
                <c:pt idx="4">
                  <c:v>655208</c:v>
                </c:pt>
                <c:pt idx="5">
                  <c:v>699966</c:v>
                </c:pt>
                <c:pt idx="6">
                  <c:v>778580</c:v>
                </c:pt>
                <c:pt idx="7">
                  <c:v>800060</c:v>
                </c:pt>
                <c:pt idx="8">
                  <c:v>845421</c:v>
                </c:pt>
                <c:pt idx="9">
                  <c:v>866921</c:v>
                </c:pt>
                <c:pt idx="10">
                  <c:v>945025</c:v>
                </c:pt>
                <c:pt idx="11">
                  <c:v>953954</c:v>
                </c:pt>
                <c:pt idx="12">
                  <c:v>981574</c:v>
                </c:pt>
                <c:pt idx="13">
                  <c:v>1662486</c:v>
                </c:pt>
                <c:pt idx="14">
                  <c:v>1640329</c:v>
                </c:pt>
                <c:pt idx="15">
                  <c:v>1521017</c:v>
                </c:pt>
                <c:pt idx="16">
                  <c:v>1509225</c:v>
                </c:pt>
                <c:pt idx="17">
                  <c:v>1845768</c:v>
                </c:pt>
                <c:pt idx="18">
                  <c:v>1908000</c:v>
                </c:pt>
                <c:pt idx="19">
                  <c:v>1986730</c:v>
                </c:pt>
                <c:pt idx="20">
                  <c:v>2655620</c:v>
                </c:pt>
                <c:pt idx="21">
                  <c:v>2789210</c:v>
                </c:pt>
                <c:pt idx="22">
                  <c:v>2822380</c:v>
                </c:pt>
                <c:pt idx="23">
                  <c:v>2831570</c:v>
                </c:pt>
                <c:pt idx="24">
                  <c:v>3014753</c:v>
                </c:pt>
                <c:pt idx="25">
                  <c:v>3000459</c:v>
                </c:pt>
                <c:pt idx="26">
                  <c:v>2988813</c:v>
                </c:pt>
                <c:pt idx="27">
                  <c:v>3148330</c:v>
                </c:pt>
                <c:pt idx="28">
                  <c:v>3156847</c:v>
                </c:pt>
                <c:pt idx="29">
                  <c:v>4218900</c:v>
                </c:pt>
                <c:pt idx="30">
                  <c:v>4127958</c:v>
                </c:pt>
                <c:pt idx="31">
                  <c:v>3893605</c:v>
                </c:pt>
                <c:pt idx="32">
                  <c:v>4421556</c:v>
                </c:pt>
                <c:pt idx="33">
                  <c:v>4544259</c:v>
                </c:pt>
                <c:pt idx="34">
                  <c:v>4572342</c:v>
                </c:pt>
                <c:pt idx="35">
                  <c:v>4585923</c:v>
                </c:pt>
                <c:pt idx="36">
                  <c:v>4676114</c:v>
                </c:pt>
                <c:pt idx="37">
                  <c:v>4950021</c:v>
                </c:pt>
                <c:pt idx="38">
                  <c:v>5027328</c:v>
                </c:pt>
                <c:pt idx="39">
                  <c:v>5217718</c:v>
                </c:pt>
                <c:pt idx="40">
                  <c:v>5224385</c:v>
                </c:pt>
                <c:pt idx="41">
                  <c:v>5232016</c:v>
                </c:pt>
                <c:pt idx="42">
                  <c:v>5583603</c:v>
                </c:pt>
                <c:pt idx="43">
                  <c:v>5529227</c:v>
                </c:pt>
                <c:pt idx="44">
                  <c:v>5493354</c:v>
                </c:pt>
                <c:pt idx="45">
                  <c:v>5805588</c:v>
                </c:pt>
                <c:pt idx="46">
                  <c:v>6044461</c:v>
                </c:pt>
                <c:pt idx="47">
                  <c:v>5998184</c:v>
                </c:pt>
                <c:pt idx="48">
                  <c:v>5888905</c:v>
                </c:pt>
                <c:pt idx="49">
                  <c:v>6273455</c:v>
                </c:pt>
                <c:pt idx="50">
                  <c:v>6319047</c:v>
                </c:pt>
                <c:pt idx="51">
                  <c:v>6342700</c:v>
                </c:pt>
                <c:pt idx="52">
                  <c:v>6401267</c:v>
                </c:pt>
                <c:pt idx="53">
                  <c:v>6462046</c:v>
                </c:pt>
                <c:pt idx="54">
                  <c:v>6989831</c:v>
                </c:pt>
                <c:pt idx="55">
                  <c:v>6960928</c:v>
                </c:pt>
                <c:pt idx="56">
                  <c:v>6754055</c:v>
                </c:pt>
                <c:pt idx="57">
                  <c:v>6716144</c:v>
                </c:pt>
                <c:pt idx="58">
                  <c:v>6712721</c:v>
                </c:pt>
                <c:pt idx="59">
                  <c:v>6614911</c:v>
                </c:pt>
                <c:pt idx="60">
                  <c:v>7099109</c:v>
                </c:pt>
                <c:pt idx="61">
                  <c:v>7139001</c:v>
                </c:pt>
                <c:pt idx="62">
                  <c:v>7165001</c:v>
                </c:pt>
                <c:pt idx="63">
                  <c:v>7322180</c:v>
                </c:pt>
                <c:pt idx="64">
                  <c:v>7476730</c:v>
                </c:pt>
                <c:pt idx="65">
                  <c:v>7589017</c:v>
                </c:pt>
                <c:pt idx="66">
                  <c:v>7765571</c:v>
                </c:pt>
                <c:pt idx="67">
                  <c:v>7928700</c:v>
                </c:pt>
                <c:pt idx="68">
                  <c:v>7956019</c:v>
                </c:pt>
                <c:pt idx="69">
                  <c:v>7964817</c:v>
                </c:pt>
                <c:pt idx="70">
                  <c:v>8083094</c:v>
                </c:pt>
                <c:pt idx="71">
                  <c:v>8286827</c:v>
                </c:pt>
                <c:pt idx="72">
                  <c:v>8557976</c:v>
                </c:pt>
                <c:pt idx="73">
                  <c:v>8382144</c:v>
                </c:pt>
                <c:pt idx="74">
                  <c:v>8592224</c:v>
                </c:pt>
                <c:pt idx="75">
                  <c:v>8739401</c:v>
                </c:pt>
                <c:pt idx="76">
                  <c:v>8745708</c:v>
                </c:pt>
                <c:pt idx="77">
                  <c:v>8845534</c:v>
                </c:pt>
                <c:pt idx="78">
                  <c:v>8858149</c:v>
                </c:pt>
                <c:pt idx="79">
                  <c:v>8995092</c:v>
                </c:pt>
                <c:pt idx="80">
                  <c:v>9107826</c:v>
                </c:pt>
                <c:pt idx="81">
                  <c:v>9187617</c:v>
                </c:pt>
                <c:pt idx="82">
                  <c:v>9188764</c:v>
                </c:pt>
                <c:pt idx="83">
                  <c:v>9753504</c:v>
                </c:pt>
                <c:pt idx="84">
                  <c:v>9664576</c:v>
                </c:pt>
                <c:pt idx="85">
                  <c:v>9593305</c:v>
                </c:pt>
                <c:pt idx="86">
                  <c:v>9569855</c:v>
                </c:pt>
                <c:pt idx="87">
                  <c:v>9478704</c:v>
                </c:pt>
                <c:pt idx="88">
                  <c:v>9292944</c:v>
                </c:pt>
                <c:pt idx="89">
                  <c:v>9970992</c:v>
                </c:pt>
                <c:pt idx="90">
                  <c:v>10238072</c:v>
                </c:pt>
                <c:pt idx="91">
                  <c:v>10369649</c:v>
                </c:pt>
                <c:pt idx="92">
                  <c:v>10456815</c:v>
                </c:pt>
                <c:pt idx="93">
                  <c:v>10633352</c:v>
                </c:pt>
                <c:pt idx="94">
                  <c:v>10827770</c:v>
                </c:pt>
                <c:pt idx="95">
                  <c:v>10863028</c:v>
                </c:pt>
                <c:pt idx="96">
                  <c:v>10882906</c:v>
                </c:pt>
                <c:pt idx="97">
                  <c:v>11322755</c:v>
                </c:pt>
                <c:pt idx="98">
                  <c:v>11274775</c:v>
                </c:pt>
                <c:pt idx="99">
                  <c:v>11243423</c:v>
                </c:pt>
                <c:pt idx="100">
                  <c:v>11218632</c:v>
                </c:pt>
                <c:pt idx="101">
                  <c:v>11210274</c:v>
                </c:pt>
                <c:pt idx="102">
                  <c:v>11188237</c:v>
                </c:pt>
                <c:pt idx="103">
                  <c:v>11166543</c:v>
                </c:pt>
                <c:pt idx="104">
                  <c:v>11816056</c:v>
                </c:pt>
                <c:pt idx="105">
                  <c:v>11961169</c:v>
                </c:pt>
              </c:numCache>
            </c:numRef>
          </c:xVal>
          <c:yVal>
            <c:numRef>
              <c:f>'211 up prion no change del'!$K$108:$K$213</c:f>
              <c:numCache>
                <c:formatCode>General</c:formatCode>
                <c:ptCount val="106"/>
                <c:pt idx="0">
                  <c:v>-0.19823669710787487</c:v>
                </c:pt>
                <c:pt idx="1">
                  <c:v>-0.21014901622164284</c:v>
                </c:pt>
                <c:pt idx="2">
                  <c:v>-0.42710919888819582</c:v>
                </c:pt>
                <c:pt idx="3">
                  <c:v>-0.40800726396116305</c:v>
                </c:pt>
                <c:pt idx="4">
                  <c:v>-0.9153855340542234</c:v>
                </c:pt>
                <c:pt idx="5">
                  <c:v>0.85419497363762475</c:v>
                </c:pt>
                <c:pt idx="6">
                  <c:v>-0.57227506002521911</c:v>
                </c:pt>
                <c:pt idx="7">
                  <c:v>0.69890288852361215</c:v>
                </c:pt>
                <c:pt idx="8">
                  <c:v>0.39965913235468026</c:v>
                </c:pt>
                <c:pt idx="9">
                  <c:v>-1.1466657027355767E-2</c:v>
                </c:pt>
                <c:pt idx="10">
                  <c:v>0.29187994141958373</c:v>
                </c:pt>
                <c:pt idx="11">
                  <c:v>-0.33802326726143334</c:v>
                </c:pt>
                <c:pt idx="12">
                  <c:v>8.3261717610730937E-3</c:v>
                </c:pt>
                <c:pt idx="13">
                  <c:v>-9.32813719320114E-2</c:v>
                </c:pt>
                <c:pt idx="14">
                  <c:v>0.31007879487621059</c:v>
                </c:pt>
                <c:pt idx="15">
                  <c:v>-0.64173051016745819</c:v>
                </c:pt>
                <c:pt idx="16">
                  <c:v>0.57250589509301664</c:v>
                </c:pt>
                <c:pt idx="17">
                  <c:v>-0.17339579682584588</c:v>
                </c:pt>
                <c:pt idx="18">
                  <c:v>-0.40689461261418819</c:v>
                </c:pt>
                <c:pt idx="19">
                  <c:v>-0.82493105032474512</c:v>
                </c:pt>
                <c:pt idx="20">
                  <c:v>-0.76408280229227787</c:v>
                </c:pt>
                <c:pt idx="21">
                  <c:v>0.58971687496940006</c:v>
                </c:pt>
                <c:pt idx="22">
                  <c:v>0.12484631648070628</c:v>
                </c:pt>
                <c:pt idx="23">
                  <c:v>-0.24421298368157859</c:v>
                </c:pt>
                <c:pt idx="24">
                  <c:v>0.49104827213343638</c:v>
                </c:pt>
                <c:pt idx="25">
                  <c:v>0.89249174728227487</c:v>
                </c:pt>
                <c:pt idx="26">
                  <c:v>-0.12079828101500777</c:v>
                </c:pt>
                <c:pt idx="27">
                  <c:v>-0.76795687866408102</c:v>
                </c:pt>
                <c:pt idx="28">
                  <c:v>-0.52118417115145022</c:v>
                </c:pt>
                <c:pt idx="29">
                  <c:v>-0.60839835741760251</c:v>
                </c:pt>
                <c:pt idx="30">
                  <c:v>6.9306097832038203E-3</c:v>
                </c:pt>
                <c:pt idx="31">
                  <c:v>0.35805342815786362</c:v>
                </c:pt>
                <c:pt idx="32">
                  <c:v>-0.55659215609574364</c:v>
                </c:pt>
                <c:pt idx="33">
                  <c:v>-0.64489706781424971</c:v>
                </c:pt>
                <c:pt idx="34">
                  <c:v>0.43374607237962148</c:v>
                </c:pt>
                <c:pt idx="35">
                  <c:v>0.48324803442347569</c:v>
                </c:pt>
                <c:pt idx="36">
                  <c:v>0.10032125553302999</c:v>
                </c:pt>
                <c:pt idx="37">
                  <c:v>-0.97422634807813357</c:v>
                </c:pt>
                <c:pt idx="38">
                  <c:v>0.9051824873151576</c:v>
                </c:pt>
                <c:pt idx="39">
                  <c:v>-0.609296873775235</c:v>
                </c:pt>
                <c:pt idx="40">
                  <c:v>-0.84282367279443016</c:v>
                </c:pt>
                <c:pt idx="41">
                  <c:v>0.72174742419967042</c:v>
                </c:pt>
                <c:pt idx="42">
                  <c:v>-0.78256988888411527</c:v>
                </c:pt>
                <c:pt idx="43">
                  <c:v>0.49747366988743186</c:v>
                </c:pt>
                <c:pt idx="44">
                  <c:v>-0.10007587452700335</c:v>
                </c:pt>
                <c:pt idx="45">
                  <c:v>0.45701239380742736</c:v>
                </c:pt>
                <c:pt idx="46">
                  <c:v>-0.77796223523203223</c:v>
                </c:pt>
                <c:pt idx="47">
                  <c:v>0.4702759979437775</c:v>
                </c:pt>
                <c:pt idx="48">
                  <c:v>-0.21173890672977527</c:v>
                </c:pt>
                <c:pt idx="49">
                  <c:v>-0.12249674435588132</c:v>
                </c:pt>
                <c:pt idx="50">
                  <c:v>4.116533462560789E-2</c:v>
                </c:pt>
                <c:pt idx="51">
                  <c:v>-0.62308770528796975</c:v>
                </c:pt>
                <c:pt idx="52">
                  <c:v>0.1686999719334886</c:v>
                </c:pt>
                <c:pt idx="53">
                  <c:v>0.78992927506971844</c:v>
                </c:pt>
                <c:pt idx="54">
                  <c:v>-0.90972991882389154</c:v>
                </c:pt>
                <c:pt idx="55">
                  <c:v>0.65688866250709743</c:v>
                </c:pt>
                <c:pt idx="56">
                  <c:v>-0.44846403995702511</c:v>
                </c:pt>
                <c:pt idx="57">
                  <c:v>-0.44070517201198761</c:v>
                </c:pt>
                <c:pt idx="58">
                  <c:v>-0.14640551816229522</c:v>
                </c:pt>
                <c:pt idx="59">
                  <c:v>0.68651979742763047</c:v>
                </c:pt>
                <c:pt idx="60">
                  <c:v>-0.15164027728655166</c:v>
                </c:pt>
                <c:pt idx="61">
                  <c:v>0.39599020570093629</c:v>
                </c:pt>
                <c:pt idx="62">
                  <c:v>-0.32192767931204269</c:v>
                </c:pt>
                <c:pt idx="63">
                  <c:v>0.34733091118770887</c:v>
                </c:pt>
                <c:pt idx="64">
                  <c:v>-8.3219562371314046E-2</c:v>
                </c:pt>
                <c:pt idx="65">
                  <c:v>-1.4117149464019225E-2</c:v>
                </c:pt>
                <c:pt idx="66">
                  <c:v>-0.82517734294254097</c:v>
                </c:pt>
                <c:pt idx="67">
                  <c:v>-0.40964083443457616</c:v>
                </c:pt>
                <c:pt idx="68">
                  <c:v>-0.78175931157007506</c:v>
                </c:pt>
                <c:pt idx="69">
                  <c:v>0.2689320153572895</c:v>
                </c:pt>
                <c:pt idx="70">
                  <c:v>0.95012924589648717</c:v>
                </c:pt>
                <c:pt idx="71">
                  <c:v>0.76721180048974946</c:v>
                </c:pt>
                <c:pt idx="72">
                  <c:v>-0.61065085605486991</c:v>
                </c:pt>
                <c:pt idx="73">
                  <c:v>0.47949112161310803</c:v>
                </c:pt>
                <c:pt idx="74">
                  <c:v>0.23511679396042651</c:v>
                </c:pt>
                <c:pt idx="75">
                  <c:v>8.6634654728713675E-3</c:v>
                </c:pt>
                <c:pt idx="76">
                  <c:v>-3.4237060307163898E-3</c:v>
                </c:pt>
                <c:pt idx="77">
                  <c:v>0.17819296301104046</c:v>
                </c:pt>
                <c:pt idx="78">
                  <c:v>0.75134442628655884</c:v>
                </c:pt>
                <c:pt idx="79">
                  <c:v>0.40308728537859045</c:v>
                </c:pt>
                <c:pt idx="80">
                  <c:v>-0.65036317079549455</c:v>
                </c:pt>
                <c:pt idx="81">
                  <c:v>0.17775832033435668</c:v>
                </c:pt>
                <c:pt idx="82">
                  <c:v>-0.93633054167439744</c:v>
                </c:pt>
                <c:pt idx="83">
                  <c:v>0.54677766859729915</c:v>
                </c:pt>
                <c:pt idx="84">
                  <c:v>-9.6452309004874198E-2</c:v>
                </c:pt>
                <c:pt idx="85">
                  <c:v>0.99395843560598029</c:v>
                </c:pt>
                <c:pt idx="86">
                  <c:v>-6.8376288516944744E-2</c:v>
                </c:pt>
                <c:pt idx="87">
                  <c:v>0.1162814282379504</c:v>
                </c:pt>
                <c:pt idx="88">
                  <c:v>-0.59412437900025106</c:v>
                </c:pt>
                <c:pt idx="89">
                  <c:v>-0.57933848718222036</c:v>
                </c:pt>
                <c:pt idx="90">
                  <c:v>0.4857395090646609</c:v>
                </c:pt>
                <c:pt idx="91">
                  <c:v>-3.6722926452909289E-2</c:v>
                </c:pt>
                <c:pt idx="92">
                  <c:v>-0.43881942925926409</c:v>
                </c:pt>
                <c:pt idx="93">
                  <c:v>-0.18544320323463839</c:v>
                </c:pt>
                <c:pt idx="94">
                  <c:v>-2.1259942094111011E-2</c:v>
                </c:pt>
                <c:pt idx="95">
                  <c:v>0.72446653528182225</c:v>
                </c:pt>
                <c:pt idx="96">
                  <c:v>-0.88751895125592928</c:v>
                </c:pt>
                <c:pt idx="97">
                  <c:v>-0.47369576518008977</c:v>
                </c:pt>
                <c:pt idx="98">
                  <c:v>0.17118249294764984</c:v>
                </c:pt>
                <c:pt idx="99">
                  <c:v>-0.62469230903860595</c:v>
                </c:pt>
                <c:pt idx="100">
                  <c:v>0.37975653632442335</c:v>
                </c:pt>
                <c:pt idx="101">
                  <c:v>0.40282420691676274</c:v>
                </c:pt>
                <c:pt idx="102">
                  <c:v>-2.4278965324195857E-2</c:v>
                </c:pt>
                <c:pt idx="103">
                  <c:v>0.63444265640359698</c:v>
                </c:pt>
                <c:pt idx="104">
                  <c:v>-0.2286927500351249</c:v>
                </c:pt>
                <c:pt idx="105">
                  <c:v>-7.6500677269939629E-2</c:v>
                </c:pt>
              </c:numCache>
            </c:numRef>
          </c:yVal>
          <c:smooth val="0"/>
          <c:extLst>
            <c:ext xmlns:c16="http://schemas.microsoft.com/office/drawing/2014/chart" uri="{C3380CC4-5D6E-409C-BE32-E72D297353CC}">
              <c16:uniqueId val="{00000001-74E7-4CDF-AA81-30F2A14DEE0C}"/>
            </c:ext>
          </c:extLst>
        </c:ser>
        <c:dLbls>
          <c:showLegendKey val="0"/>
          <c:showVal val="0"/>
          <c:showCatName val="0"/>
          <c:showSerName val="0"/>
          <c:showPercent val="0"/>
          <c:showBubbleSize val="0"/>
        </c:dLbls>
        <c:axId val="171948288"/>
        <c:axId val="173019136"/>
      </c:scatterChart>
      <c:valAx>
        <c:axId val="171948288"/>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019136"/>
        <c:crossesAt val="0"/>
        <c:crossBetween val="midCat"/>
      </c:valAx>
      <c:valAx>
        <c:axId val="173019136"/>
        <c:scaling>
          <c:orientation val="minMax"/>
          <c:max val="3"/>
          <c:min val="-1"/>
        </c:scaling>
        <c:delete val="0"/>
        <c:axPos val="l"/>
        <c:numFmt formatCode="#,##0.0" sourceLinked="0"/>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1948288"/>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211 up prion no change del'!$J$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211 up prion no change del'!$I$2:$I$106</c:f>
              <c:numCache>
                <c:formatCode>General</c:formatCode>
                <c:ptCount val="105"/>
                <c:pt idx="0">
                  <c:v>537805</c:v>
                </c:pt>
                <c:pt idx="1">
                  <c:v>437412</c:v>
                </c:pt>
                <c:pt idx="2">
                  <c:v>396352</c:v>
                </c:pt>
                <c:pt idx="3">
                  <c:v>320959</c:v>
                </c:pt>
                <c:pt idx="4">
                  <c:v>269363</c:v>
                </c:pt>
                <c:pt idx="5">
                  <c:v>679885</c:v>
                </c:pt>
                <c:pt idx="6">
                  <c:v>812626</c:v>
                </c:pt>
                <c:pt idx="7">
                  <c:v>827581</c:v>
                </c:pt>
                <c:pt idx="8">
                  <c:v>875768</c:v>
                </c:pt>
                <c:pt idx="9">
                  <c:v>915195</c:v>
                </c:pt>
                <c:pt idx="10">
                  <c:v>952829</c:v>
                </c:pt>
                <c:pt idx="11">
                  <c:v>1122564</c:v>
                </c:pt>
                <c:pt idx="12">
                  <c:v>1060692</c:v>
                </c:pt>
                <c:pt idx="13">
                  <c:v>1271720</c:v>
                </c:pt>
                <c:pt idx="14">
                  <c:v>1804705</c:v>
                </c:pt>
                <c:pt idx="15">
                  <c:v>1618937</c:v>
                </c:pt>
                <c:pt idx="16">
                  <c:v>1425264</c:v>
                </c:pt>
                <c:pt idx="17">
                  <c:v>1833179</c:v>
                </c:pt>
                <c:pt idx="18">
                  <c:v>1930671</c:v>
                </c:pt>
                <c:pt idx="19">
                  <c:v>2036124</c:v>
                </c:pt>
                <c:pt idx="20">
                  <c:v>2063256</c:v>
                </c:pt>
                <c:pt idx="21">
                  <c:v>2064506</c:v>
                </c:pt>
                <c:pt idx="22">
                  <c:v>2111653</c:v>
                </c:pt>
                <c:pt idx="23">
                  <c:v>2179455</c:v>
                </c:pt>
                <c:pt idx="24">
                  <c:v>2181317</c:v>
                </c:pt>
                <c:pt idx="25">
                  <c:v>2270076</c:v>
                </c:pt>
                <c:pt idx="26">
                  <c:v>2325135</c:v>
                </c:pt>
                <c:pt idx="27">
                  <c:v>2477148</c:v>
                </c:pt>
                <c:pt idx="28">
                  <c:v>3003376</c:v>
                </c:pt>
                <c:pt idx="29">
                  <c:v>3107018</c:v>
                </c:pt>
                <c:pt idx="30">
                  <c:v>3143683</c:v>
                </c:pt>
                <c:pt idx="31">
                  <c:v>3166522</c:v>
                </c:pt>
                <c:pt idx="32">
                  <c:v>3190905</c:v>
                </c:pt>
                <c:pt idx="33">
                  <c:v>3220432</c:v>
                </c:pt>
                <c:pt idx="34">
                  <c:v>4211845</c:v>
                </c:pt>
                <c:pt idx="35">
                  <c:v>4200656</c:v>
                </c:pt>
                <c:pt idx="36">
                  <c:v>4193775</c:v>
                </c:pt>
                <c:pt idx="37">
                  <c:v>3815884</c:v>
                </c:pt>
                <c:pt idx="38">
                  <c:v>4330304</c:v>
                </c:pt>
                <c:pt idx="39">
                  <c:v>4349554</c:v>
                </c:pt>
                <c:pt idx="40">
                  <c:v>4437589</c:v>
                </c:pt>
                <c:pt idx="41">
                  <c:v>4442626</c:v>
                </c:pt>
                <c:pt idx="42">
                  <c:v>4489390</c:v>
                </c:pt>
                <c:pt idx="43">
                  <c:v>4650873</c:v>
                </c:pt>
                <c:pt idx="44">
                  <c:v>4878693</c:v>
                </c:pt>
                <c:pt idx="45">
                  <c:v>4981596</c:v>
                </c:pt>
                <c:pt idx="46">
                  <c:v>5182686</c:v>
                </c:pt>
                <c:pt idx="47">
                  <c:v>5184745</c:v>
                </c:pt>
                <c:pt idx="48">
                  <c:v>5232896</c:v>
                </c:pt>
                <c:pt idx="49">
                  <c:v>5278265</c:v>
                </c:pt>
                <c:pt idx="50">
                  <c:v>5302674</c:v>
                </c:pt>
                <c:pt idx="51">
                  <c:v>5321861</c:v>
                </c:pt>
                <c:pt idx="52">
                  <c:v>5384326</c:v>
                </c:pt>
                <c:pt idx="53">
                  <c:v>5670296</c:v>
                </c:pt>
                <c:pt idx="54">
                  <c:v>5647688</c:v>
                </c:pt>
                <c:pt idx="55">
                  <c:v>5548618</c:v>
                </c:pt>
                <c:pt idx="56">
                  <c:v>5532325</c:v>
                </c:pt>
                <c:pt idx="57">
                  <c:v>5438774</c:v>
                </c:pt>
                <c:pt idx="58">
                  <c:v>6024100</c:v>
                </c:pt>
                <c:pt idx="59">
                  <c:v>5903827</c:v>
                </c:pt>
                <c:pt idx="60">
                  <c:v>6323542</c:v>
                </c:pt>
                <c:pt idx="61">
                  <c:v>6376523</c:v>
                </c:pt>
                <c:pt idx="62">
                  <c:v>6431196</c:v>
                </c:pt>
                <c:pt idx="63">
                  <c:v>6501983</c:v>
                </c:pt>
                <c:pt idx="64">
                  <c:v>6815748</c:v>
                </c:pt>
                <c:pt idx="65">
                  <c:v>6739813</c:v>
                </c:pt>
                <c:pt idx="66">
                  <c:v>6592697</c:v>
                </c:pt>
                <c:pt idx="67">
                  <c:v>7214063</c:v>
                </c:pt>
                <c:pt idx="68">
                  <c:v>7500334</c:v>
                </c:pt>
                <c:pt idx="69">
                  <c:v>7644685</c:v>
                </c:pt>
                <c:pt idx="70">
                  <c:v>7975853</c:v>
                </c:pt>
                <c:pt idx="71">
                  <c:v>8011570</c:v>
                </c:pt>
                <c:pt idx="72">
                  <c:v>8528847</c:v>
                </c:pt>
                <c:pt idx="73">
                  <c:v>8435070</c:v>
                </c:pt>
                <c:pt idx="74">
                  <c:v>8596323</c:v>
                </c:pt>
                <c:pt idx="75">
                  <c:v>8730914</c:v>
                </c:pt>
                <c:pt idx="76">
                  <c:v>8855324</c:v>
                </c:pt>
                <c:pt idx="77">
                  <c:v>8982950</c:v>
                </c:pt>
                <c:pt idx="78">
                  <c:v>9174627</c:v>
                </c:pt>
                <c:pt idx="79">
                  <c:v>9178000</c:v>
                </c:pt>
                <c:pt idx="80">
                  <c:v>9704201</c:v>
                </c:pt>
                <c:pt idx="81">
                  <c:v>9677723</c:v>
                </c:pt>
                <c:pt idx="82">
                  <c:v>9634863</c:v>
                </c:pt>
                <c:pt idx="83">
                  <c:v>9412259</c:v>
                </c:pt>
                <c:pt idx="84">
                  <c:v>9395848</c:v>
                </c:pt>
                <c:pt idx="85">
                  <c:v>9355323</c:v>
                </c:pt>
                <c:pt idx="86">
                  <c:v>10255237</c:v>
                </c:pt>
                <c:pt idx="87">
                  <c:v>10218993</c:v>
                </c:pt>
                <c:pt idx="88">
                  <c:v>10076907</c:v>
                </c:pt>
                <c:pt idx="89">
                  <c:v>10388512</c:v>
                </c:pt>
                <c:pt idx="90">
                  <c:v>10444976</c:v>
                </c:pt>
                <c:pt idx="91">
                  <c:v>10770289</c:v>
                </c:pt>
                <c:pt idx="92">
                  <c:v>10836346</c:v>
                </c:pt>
                <c:pt idx="93">
                  <c:v>10936729</c:v>
                </c:pt>
                <c:pt idx="94">
                  <c:v>10992956</c:v>
                </c:pt>
                <c:pt idx="95">
                  <c:v>11068803</c:v>
                </c:pt>
                <c:pt idx="96">
                  <c:v>11535514</c:v>
                </c:pt>
                <c:pt idx="97">
                  <c:v>11403740</c:v>
                </c:pt>
                <c:pt idx="98">
                  <c:v>11161429</c:v>
                </c:pt>
                <c:pt idx="99">
                  <c:v>11765468</c:v>
                </c:pt>
                <c:pt idx="100">
                  <c:v>11780059</c:v>
                </c:pt>
                <c:pt idx="101">
                  <c:v>11782442</c:v>
                </c:pt>
                <c:pt idx="102">
                  <c:v>11894913</c:v>
                </c:pt>
                <c:pt idx="103">
                  <c:v>11945880</c:v>
                </c:pt>
                <c:pt idx="104">
                  <c:v>11964526</c:v>
                </c:pt>
              </c:numCache>
            </c:numRef>
          </c:xVal>
          <c:yVal>
            <c:numRef>
              <c:f>'211 up prion no change del'!$J$2:$J$106</c:f>
              <c:numCache>
                <c:formatCode>General</c:formatCode>
                <c:ptCount val="105"/>
                <c:pt idx="0">
                  <c:v>1.4562284228107618</c:v>
                </c:pt>
                <c:pt idx="1">
                  <c:v>1.3060763079538937</c:v>
                </c:pt>
                <c:pt idx="2">
                  <c:v>1.8815364810407613</c:v>
                </c:pt>
                <c:pt idx="3">
                  <c:v>1.0374601162945987</c:v>
                </c:pt>
                <c:pt idx="4">
                  <c:v>1.6621963463884644</c:v>
                </c:pt>
                <c:pt idx="5">
                  <c:v>1.8391572216425376</c:v>
                </c:pt>
                <c:pt idx="6">
                  <c:v>1.166636115258582</c:v>
                </c:pt>
                <c:pt idx="7">
                  <c:v>1.6795255497236863</c:v>
                </c:pt>
                <c:pt idx="8">
                  <c:v>1.1552688312005861</c:v>
                </c:pt>
                <c:pt idx="9">
                  <c:v>1.6369989834459442</c:v>
                </c:pt>
                <c:pt idx="10">
                  <c:v>1.5082108419705502</c:v>
                </c:pt>
                <c:pt idx="11">
                  <c:v>1.2891003098870319</c:v>
                </c:pt>
                <c:pt idx="12">
                  <c:v>1.0621965800876167</c:v>
                </c:pt>
                <c:pt idx="13">
                  <c:v>1.7622185237059025</c:v>
                </c:pt>
                <c:pt idx="14">
                  <c:v>1.5202136581456525</c:v>
                </c:pt>
                <c:pt idx="15">
                  <c:v>1.1250265280173533</c:v>
                </c:pt>
                <c:pt idx="16">
                  <c:v>1.3293249057783616</c:v>
                </c:pt>
                <c:pt idx="17">
                  <c:v>1.0626613508527492</c:v>
                </c:pt>
                <c:pt idx="18">
                  <c:v>1.1669687779564339</c:v>
                </c:pt>
                <c:pt idx="19">
                  <c:v>1.0895223359408746</c:v>
                </c:pt>
                <c:pt idx="20">
                  <c:v>1.0614575735212612</c:v>
                </c:pt>
                <c:pt idx="21">
                  <c:v>1.1491690145137736</c:v>
                </c:pt>
                <c:pt idx="22">
                  <c:v>1.0563407618889156</c:v>
                </c:pt>
                <c:pt idx="23">
                  <c:v>1.8068981903142765</c:v>
                </c:pt>
                <c:pt idx="24">
                  <c:v>1.2729598414175121</c:v>
                </c:pt>
                <c:pt idx="25">
                  <c:v>2.0992642843392715</c:v>
                </c:pt>
                <c:pt idx="26">
                  <c:v>1.1817921817159056</c:v>
                </c:pt>
                <c:pt idx="27">
                  <c:v>1.1054723436732403</c:v>
                </c:pt>
                <c:pt idx="28">
                  <c:v>1.0398045646420782</c:v>
                </c:pt>
                <c:pt idx="29">
                  <c:v>1.0026973576298401</c:v>
                </c:pt>
                <c:pt idx="30">
                  <c:v>1.1573529321973111</c:v>
                </c:pt>
                <c:pt idx="31">
                  <c:v>0.99360235682803522</c:v>
                </c:pt>
                <c:pt idx="32">
                  <c:v>2.4778014953541208</c:v>
                </c:pt>
                <c:pt idx="33">
                  <c:v>0.99032476328826413</c:v>
                </c:pt>
                <c:pt idx="34">
                  <c:v>1.139584419179458</c:v>
                </c:pt>
                <c:pt idx="35">
                  <c:v>0.95762023935585205</c:v>
                </c:pt>
                <c:pt idx="36">
                  <c:v>1.4308001049625572</c:v>
                </c:pt>
                <c:pt idx="37">
                  <c:v>1.1403255134981705</c:v>
                </c:pt>
                <c:pt idx="38">
                  <c:v>1.2378384269999672</c:v>
                </c:pt>
                <c:pt idx="39">
                  <c:v>1.0018147796434078</c:v>
                </c:pt>
                <c:pt idx="40">
                  <c:v>1.3336853305508691</c:v>
                </c:pt>
                <c:pt idx="41">
                  <c:v>1.9224595750778639</c:v>
                </c:pt>
                <c:pt idx="42">
                  <c:v>1.0172343291382562</c:v>
                </c:pt>
                <c:pt idx="43">
                  <c:v>2.1247891192681094</c:v>
                </c:pt>
                <c:pt idx="44">
                  <c:v>1.5331661927709046</c:v>
                </c:pt>
                <c:pt idx="45">
                  <c:v>1.1854914896167807</c:v>
                </c:pt>
                <c:pt idx="46">
                  <c:v>1.0647955694785121</c:v>
                </c:pt>
                <c:pt idx="47">
                  <c:v>1.1263411709904891</c:v>
                </c:pt>
                <c:pt idx="48">
                  <c:v>1.5226685148937769</c:v>
                </c:pt>
                <c:pt idx="49">
                  <c:v>1.3443069522039848</c:v>
                </c:pt>
                <c:pt idx="50">
                  <c:v>1.557300901816207</c:v>
                </c:pt>
                <c:pt idx="51">
                  <c:v>1.5574868835823363</c:v>
                </c:pt>
                <c:pt idx="52">
                  <c:v>1.1444905721421745</c:v>
                </c:pt>
                <c:pt idx="53">
                  <c:v>1.4673764804925944</c:v>
                </c:pt>
                <c:pt idx="54">
                  <c:v>2.2844569590881303</c:v>
                </c:pt>
                <c:pt idx="55">
                  <c:v>0.9841963249478507</c:v>
                </c:pt>
                <c:pt idx="56">
                  <c:v>1.021441485329921</c:v>
                </c:pt>
                <c:pt idx="57">
                  <c:v>1.4349727279458744</c:v>
                </c:pt>
                <c:pt idx="58">
                  <c:v>1.6529016940858348</c:v>
                </c:pt>
                <c:pt idx="59">
                  <c:v>1.0507259618023834</c:v>
                </c:pt>
                <c:pt idx="60">
                  <c:v>1.2584055034332766</c:v>
                </c:pt>
                <c:pt idx="61">
                  <c:v>1.2767966233957464</c:v>
                </c:pt>
                <c:pt idx="62">
                  <c:v>1.1548915877638364</c:v>
                </c:pt>
                <c:pt idx="63">
                  <c:v>1.0251104505858537</c:v>
                </c:pt>
                <c:pt idx="64">
                  <c:v>1.6495298665128633</c:v>
                </c:pt>
                <c:pt idx="65">
                  <c:v>1.066992241690762</c:v>
                </c:pt>
                <c:pt idx="66">
                  <c:v>1.2338415032464205</c:v>
                </c:pt>
                <c:pt idx="67">
                  <c:v>1.0160172262626954</c:v>
                </c:pt>
                <c:pt idx="68">
                  <c:v>0.9718247756790116</c:v>
                </c:pt>
                <c:pt idx="69">
                  <c:v>1.2462370168238366</c:v>
                </c:pt>
                <c:pt idx="70">
                  <c:v>1.5294160355649669</c:v>
                </c:pt>
                <c:pt idx="71">
                  <c:v>0.96161818338780858</c:v>
                </c:pt>
                <c:pt idx="72">
                  <c:v>1.1782640891832341</c:v>
                </c:pt>
                <c:pt idx="73">
                  <c:v>0.98983863626272373</c:v>
                </c:pt>
                <c:pt idx="74">
                  <c:v>1.2950174469945495</c:v>
                </c:pt>
                <c:pt idx="75">
                  <c:v>1.4847147815417503</c:v>
                </c:pt>
                <c:pt idx="76">
                  <c:v>1.0148181746797307</c:v>
                </c:pt>
                <c:pt idx="77">
                  <c:v>1.0013051282593122</c:v>
                </c:pt>
                <c:pt idx="78">
                  <c:v>2.5303902762481623</c:v>
                </c:pt>
                <c:pt idx="79">
                  <c:v>1.0117000996656393</c:v>
                </c:pt>
                <c:pt idx="80">
                  <c:v>1.2359991238054839</c:v>
                </c:pt>
                <c:pt idx="81">
                  <c:v>1.3215478757124397</c:v>
                </c:pt>
                <c:pt idx="82">
                  <c:v>1.3162813619394207</c:v>
                </c:pt>
                <c:pt idx="83">
                  <c:v>0.97140733991501449</c:v>
                </c:pt>
                <c:pt idx="84">
                  <c:v>1.1270741238577477</c:v>
                </c:pt>
                <c:pt idx="85">
                  <c:v>1.3436695554384435</c:v>
                </c:pt>
                <c:pt idx="86">
                  <c:v>1.102854707007981</c:v>
                </c:pt>
                <c:pt idx="87">
                  <c:v>1.4996541832904116</c:v>
                </c:pt>
                <c:pt idx="88">
                  <c:v>1.2193925940824195</c:v>
                </c:pt>
                <c:pt idx="89">
                  <c:v>1.6960983386602508</c:v>
                </c:pt>
                <c:pt idx="90">
                  <c:v>1.2728899185664426</c:v>
                </c:pt>
                <c:pt idx="91">
                  <c:v>1.1810550456893736</c:v>
                </c:pt>
                <c:pt idx="92">
                  <c:v>1.2380743557739509</c:v>
                </c:pt>
                <c:pt idx="93">
                  <c:v>3.2689167499655785</c:v>
                </c:pt>
                <c:pt idx="94">
                  <c:v>1.0082825888857396</c:v>
                </c:pt>
                <c:pt idx="95">
                  <c:v>1.1594861574748747</c:v>
                </c:pt>
                <c:pt idx="96">
                  <c:v>1.1162666349709922</c:v>
                </c:pt>
                <c:pt idx="97">
                  <c:v>1.3198606427134716</c:v>
                </c:pt>
                <c:pt idx="98">
                  <c:v>1.2322700390816363</c:v>
                </c:pt>
                <c:pt idx="99">
                  <c:v>1.3005655177738453</c:v>
                </c:pt>
                <c:pt idx="100">
                  <c:v>1.3686167902418402</c:v>
                </c:pt>
                <c:pt idx="101">
                  <c:v>1.2767100996727454</c:v>
                </c:pt>
                <c:pt idx="102">
                  <c:v>1.3813407703675502</c:v>
                </c:pt>
                <c:pt idx="103">
                  <c:v>1.1218683482086216</c:v>
                </c:pt>
                <c:pt idx="104">
                  <c:v>1.9011797320229811</c:v>
                </c:pt>
              </c:numCache>
            </c:numRef>
          </c:yVal>
          <c:smooth val="0"/>
          <c:extLst>
            <c:ext xmlns:c16="http://schemas.microsoft.com/office/drawing/2014/chart" uri="{C3380CC4-5D6E-409C-BE32-E72D297353CC}">
              <c16:uniqueId val="{00000000-DD54-4FAF-AFC1-E04033F18C39}"/>
            </c:ext>
          </c:extLst>
        </c:ser>
        <c:ser>
          <c:idx val="1"/>
          <c:order val="1"/>
          <c:tx>
            <c:strRef>
              <c:f>'211 up prion no change del'!$K$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211 up prion no change del'!$I$2:$I$106</c:f>
              <c:numCache>
                <c:formatCode>General</c:formatCode>
                <c:ptCount val="105"/>
                <c:pt idx="0">
                  <c:v>537805</c:v>
                </c:pt>
                <c:pt idx="1">
                  <c:v>437412</c:v>
                </c:pt>
                <c:pt idx="2">
                  <c:v>396352</c:v>
                </c:pt>
                <c:pt idx="3">
                  <c:v>320959</c:v>
                </c:pt>
                <c:pt idx="4">
                  <c:v>269363</c:v>
                </c:pt>
                <c:pt idx="5">
                  <c:v>679885</c:v>
                </c:pt>
                <c:pt idx="6">
                  <c:v>812626</c:v>
                </c:pt>
                <c:pt idx="7">
                  <c:v>827581</c:v>
                </c:pt>
                <c:pt idx="8">
                  <c:v>875768</c:v>
                </c:pt>
                <c:pt idx="9">
                  <c:v>915195</c:v>
                </c:pt>
                <c:pt idx="10">
                  <c:v>952829</c:v>
                </c:pt>
                <c:pt idx="11">
                  <c:v>1122564</c:v>
                </c:pt>
                <c:pt idx="12">
                  <c:v>1060692</c:v>
                </c:pt>
                <c:pt idx="13">
                  <c:v>1271720</c:v>
                </c:pt>
                <c:pt idx="14">
                  <c:v>1804705</c:v>
                </c:pt>
                <c:pt idx="15">
                  <c:v>1618937</c:v>
                </c:pt>
                <c:pt idx="16">
                  <c:v>1425264</c:v>
                </c:pt>
                <c:pt idx="17">
                  <c:v>1833179</c:v>
                </c:pt>
                <c:pt idx="18">
                  <c:v>1930671</c:v>
                </c:pt>
                <c:pt idx="19">
                  <c:v>2036124</c:v>
                </c:pt>
                <c:pt idx="20">
                  <c:v>2063256</c:v>
                </c:pt>
                <c:pt idx="21">
                  <c:v>2064506</c:v>
                </c:pt>
                <c:pt idx="22">
                  <c:v>2111653</c:v>
                </c:pt>
                <c:pt idx="23">
                  <c:v>2179455</c:v>
                </c:pt>
                <c:pt idx="24">
                  <c:v>2181317</c:v>
                </c:pt>
                <c:pt idx="25">
                  <c:v>2270076</c:v>
                </c:pt>
                <c:pt idx="26">
                  <c:v>2325135</c:v>
                </c:pt>
                <c:pt idx="27">
                  <c:v>2477148</c:v>
                </c:pt>
                <c:pt idx="28">
                  <c:v>3003376</c:v>
                </c:pt>
                <c:pt idx="29">
                  <c:v>3107018</c:v>
                </c:pt>
                <c:pt idx="30">
                  <c:v>3143683</c:v>
                </c:pt>
                <c:pt idx="31">
                  <c:v>3166522</c:v>
                </c:pt>
                <c:pt idx="32">
                  <c:v>3190905</c:v>
                </c:pt>
                <c:pt idx="33">
                  <c:v>3220432</c:v>
                </c:pt>
                <c:pt idx="34">
                  <c:v>4211845</c:v>
                </c:pt>
                <c:pt idx="35">
                  <c:v>4200656</c:v>
                </c:pt>
                <c:pt idx="36">
                  <c:v>4193775</c:v>
                </c:pt>
                <c:pt idx="37">
                  <c:v>3815884</c:v>
                </c:pt>
                <c:pt idx="38">
                  <c:v>4330304</c:v>
                </c:pt>
                <c:pt idx="39">
                  <c:v>4349554</c:v>
                </c:pt>
                <c:pt idx="40">
                  <c:v>4437589</c:v>
                </c:pt>
                <c:pt idx="41">
                  <c:v>4442626</c:v>
                </c:pt>
                <c:pt idx="42">
                  <c:v>4489390</c:v>
                </c:pt>
                <c:pt idx="43">
                  <c:v>4650873</c:v>
                </c:pt>
                <c:pt idx="44">
                  <c:v>4878693</c:v>
                </c:pt>
                <c:pt idx="45">
                  <c:v>4981596</c:v>
                </c:pt>
                <c:pt idx="46">
                  <c:v>5182686</c:v>
                </c:pt>
                <c:pt idx="47">
                  <c:v>5184745</c:v>
                </c:pt>
                <c:pt idx="48">
                  <c:v>5232896</c:v>
                </c:pt>
                <c:pt idx="49">
                  <c:v>5278265</c:v>
                </c:pt>
                <c:pt idx="50">
                  <c:v>5302674</c:v>
                </c:pt>
                <c:pt idx="51">
                  <c:v>5321861</c:v>
                </c:pt>
                <c:pt idx="52">
                  <c:v>5384326</c:v>
                </c:pt>
                <c:pt idx="53">
                  <c:v>5670296</c:v>
                </c:pt>
                <c:pt idx="54">
                  <c:v>5647688</c:v>
                </c:pt>
                <c:pt idx="55">
                  <c:v>5548618</c:v>
                </c:pt>
                <c:pt idx="56">
                  <c:v>5532325</c:v>
                </c:pt>
                <c:pt idx="57">
                  <c:v>5438774</c:v>
                </c:pt>
                <c:pt idx="58">
                  <c:v>6024100</c:v>
                </c:pt>
                <c:pt idx="59">
                  <c:v>5903827</c:v>
                </c:pt>
                <c:pt idx="60">
                  <c:v>6323542</c:v>
                </c:pt>
                <c:pt idx="61">
                  <c:v>6376523</c:v>
                </c:pt>
                <c:pt idx="62">
                  <c:v>6431196</c:v>
                </c:pt>
                <c:pt idx="63">
                  <c:v>6501983</c:v>
                </c:pt>
                <c:pt idx="64">
                  <c:v>6815748</c:v>
                </c:pt>
                <c:pt idx="65">
                  <c:v>6739813</c:v>
                </c:pt>
                <c:pt idx="66">
                  <c:v>6592697</c:v>
                </c:pt>
                <c:pt idx="67">
                  <c:v>7214063</c:v>
                </c:pt>
                <c:pt idx="68">
                  <c:v>7500334</c:v>
                </c:pt>
                <c:pt idx="69">
                  <c:v>7644685</c:v>
                </c:pt>
                <c:pt idx="70">
                  <c:v>7975853</c:v>
                </c:pt>
                <c:pt idx="71">
                  <c:v>8011570</c:v>
                </c:pt>
                <c:pt idx="72">
                  <c:v>8528847</c:v>
                </c:pt>
                <c:pt idx="73">
                  <c:v>8435070</c:v>
                </c:pt>
                <c:pt idx="74">
                  <c:v>8596323</c:v>
                </c:pt>
                <c:pt idx="75">
                  <c:v>8730914</c:v>
                </c:pt>
                <c:pt idx="76">
                  <c:v>8855324</c:v>
                </c:pt>
                <c:pt idx="77">
                  <c:v>8982950</c:v>
                </c:pt>
                <c:pt idx="78">
                  <c:v>9174627</c:v>
                </c:pt>
                <c:pt idx="79">
                  <c:v>9178000</c:v>
                </c:pt>
                <c:pt idx="80">
                  <c:v>9704201</c:v>
                </c:pt>
                <c:pt idx="81">
                  <c:v>9677723</c:v>
                </c:pt>
                <c:pt idx="82">
                  <c:v>9634863</c:v>
                </c:pt>
                <c:pt idx="83">
                  <c:v>9412259</c:v>
                </c:pt>
                <c:pt idx="84">
                  <c:v>9395848</c:v>
                </c:pt>
                <c:pt idx="85">
                  <c:v>9355323</c:v>
                </c:pt>
                <c:pt idx="86">
                  <c:v>10255237</c:v>
                </c:pt>
                <c:pt idx="87">
                  <c:v>10218993</c:v>
                </c:pt>
                <c:pt idx="88">
                  <c:v>10076907</c:v>
                </c:pt>
                <c:pt idx="89">
                  <c:v>10388512</c:v>
                </c:pt>
                <c:pt idx="90">
                  <c:v>10444976</c:v>
                </c:pt>
                <c:pt idx="91">
                  <c:v>10770289</c:v>
                </c:pt>
                <c:pt idx="92">
                  <c:v>10836346</c:v>
                </c:pt>
                <c:pt idx="93">
                  <c:v>10936729</c:v>
                </c:pt>
                <c:pt idx="94">
                  <c:v>10992956</c:v>
                </c:pt>
                <c:pt idx="95">
                  <c:v>11068803</c:v>
                </c:pt>
                <c:pt idx="96">
                  <c:v>11535514</c:v>
                </c:pt>
                <c:pt idx="97">
                  <c:v>11403740</c:v>
                </c:pt>
                <c:pt idx="98">
                  <c:v>11161429</c:v>
                </c:pt>
                <c:pt idx="99">
                  <c:v>11765468</c:v>
                </c:pt>
                <c:pt idx="100">
                  <c:v>11780059</c:v>
                </c:pt>
                <c:pt idx="101">
                  <c:v>11782442</c:v>
                </c:pt>
                <c:pt idx="102">
                  <c:v>11894913</c:v>
                </c:pt>
                <c:pt idx="103">
                  <c:v>11945880</c:v>
                </c:pt>
                <c:pt idx="104">
                  <c:v>11964526</c:v>
                </c:pt>
              </c:numCache>
            </c:numRef>
          </c:xVal>
          <c:yVal>
            <c:numRef>
              <c:f>'211 up prion no change del'!$K$2:$K$106</c:f>
              <c:numCache>
                <c:formatCode>General</c:formatCode>
                <c:ptCount val="105"/>
                <c:pt idx="0">
                  <c:v>-0.14062297341843422</c:v>
                </c:pt>
                <c:pt idx="1">
                  <c:v>-0.35470302644365681</c:v>
                </c:pt>
                <c:pt idx="2">
                  <c:v>0.32340686333959046</c:v>
                </c:pt>
                <c:pt idx="3">
                  <c:v>-0.71487316732332862</c:v>
                </c:pt>
                <c:pt idx="4">
                  <c:v>0.80673802329579225</c:v>
                </c:pt>
                <c:pt idx="5">
                  <c:v>-2.7102033408894562E-2</c:v>
                </c:pt>
                <c:pt idx="6">
                  <c:v>-0.20842251487014146</c:v>
                </c:pt>
                <c:pt idx="7">
                  <c:v>0.30413573100051289</c:v>
                </c:pt>
                <c:pt idx="8">
                  <c:v>0.67231893263204878</c:v>
                </c:pt>
                <c:pt idx="9">
                  <c:v>-0.63360361022096134</c:v>
                </c:pt>
                <c:pt idx="10">
                  <c:v>-5.9024275613824936E-2</c:v>
                </c:pt>
                <c:pt idx="11">
                  <c:v>0.80108330677833939</c:v>
                </c:pt>
                <c:pt idx="12">
                  <c:v>2.1789631658268135E-2</c:v>
                </c:pt>
                <c:pt idx="13">
                  <c:v>-0.69193041255874255</c:v>
                </c:pt>
                <c:pt idx="14">
                  <c:v>-0.23955070528532393</c:v>
                </c:pt>
                <c:pt idx="15">
                  <c:v>-0.4815831858324523</c:v>
                </c:pt>
                <c:pt idx="16">
                  <c:v>-0.42536371465621453</c:v>
                </c:pt>
                <c:pt idx="17">
                  <c:v>0.21952581320028611</c:v>
                </c:pt>
                <c:pt idx="18">
                  <c:v>-0.3494356189730522</c:v>
                </c:pt>
                <c:pt idx="19">
                  <c:v>-6.1822284630695709E-2</c:v>
                </c:pt>
                <c:pt idx="20">
                  <c:v>0.92387059298094798</c:v>
                </c:pt>
                <c:pt idx="21">
                  <c:v>0.76396341236125842</c:v>
                </c:pt>
                <c:pt idx="22">
                  <c:v>-0.22037449069188039</c:v>
                </c:pt>
                <c:pt idx="23">
                  <c:v>-0.29185639022384258</c:v>
                </c:pt>
                <c:pt idx="24">
                  <c:v>-0.17529901838614667</c:v>
                </c:pt>
                <c:pt idx="25">
                  <c:v>-0.42090884642611687</c:v>
                </c:pt>
                <c:pt idx="26">
                  <c:v>0.79424533367348527</c:v>
                </c:pt>
                <c:pt idx="27">
                  <c:v>1.7844381705603825E-2</c:v>
                </c:pt>
                <c:pt idx="28">
                  <c:v>-0.34091861219615804</c:v>
                </c:pt>
                <c:pt idx="29">
                  <c:v>-0.20714312041588812</c:v>
                </c:pt>
                <c:pt idx="30">
                  <c:v>-0.26249110267621717</c:v>
                </c:pt>
                <c:pt idx="31">
                  <c:v>-0.66470472058068852</c:v>
                </c:pt>
                <c:pt idx="32">
                  <c:v>-0.49294825064072817</c:v>
                </c:pt>
                <c:pt idx="33">
                  <c:v>-0.50516057847233464</c:v>
                </c:pt>
                <c:pt idx="34">
                  <c:v>0.93218123810417197</c:v>
                </c:pt>
                <c:pt idx="35">
                  <c:v>-0.13005335777051119</c:v>
                </c:pt>
                <c:pt idx="36">
                  <c:v>0.77834384853023619</c:v>
                </c:pt>
                <c:pt idx="37">
                  <c:v>-0.58080601704728019</c:v>
                </c:pt>
                <c:pt idx="38">
                  <c:v>-8.3626017449354093E-2</c:v>
                </c:pt>
                <c:pt idx="39">
                  <c:v>-0.8326857158620935</c:v>
                </c:pt>
                <c:pt idx="40">
                  <c:v>-0.53656708439107736</c:v>
                </c:pt>
                <c:pt idx="41">
                  <c:v>-0.51676703051635686</c:v>
                </c:pt>
                <c:pt idx="42">
                  <c:v>-0.25222393573963026</c:v>
                </c:pt>
                <c:pt idx="43">
                  <c:v>-0.21636085763752946</c:v>
                </c:pt>
                <c:pt idx="44">
                  <c:v>0.20389685469866017</c:v>
                </c:pt>
                <c:pt idx="45">
                  <c:v>-0.23264554970892948</c:v>
                </c:pt>
                <c:pt idx="46">
                  <c:v>7.7908754124186547E-2</c:v>
                </c:pt>
                <c:pt idx="47">
                  <c:v>-0.47496117919079478</c:v>
                </c:pt>
                <c:pt idx="48">
                  <c:v>0.70986506502191349</c:v>
                </c:pt>
                <c:pt idx="49">
                  <c:v>-0.29965366286327361</c:v>
                </c:pt>
                <c:pt idx="50">
                  <c:v>0.96899581365997534</c:v>
                </c:pt>
                <c:pt idx="51">
                  <c:v>-0.73971836036122407</c:v>
                </c:pt>
                <c:pt idx="52">
                  <c:v>0.98391576867762609</c:v>
                </c:pt>
                <c:pt idx="53">
                  <c:v>-0.14359178022385249</c:v>
                </c:pt>
                <c:pt idx="54">
                  <c:v>0.68079844383975319</c:v>
                </c:pt>
                <c:pt idx="55">
                  <c:v>-0.81589636473676563</c:v>
                </c:pt>
                <c:pt idx="56">
                  <c:v>0.82322080987144153</c:v>
                </c:pt>
                <c:pt idx="57">
                  <c:v>-0.62920188031782698</c:v>
                </c:pt>
                <c:pt idx="58">
                  <c:v>-0.86088184324991046</c:v>
                </c:pt>
                <c:pt idx="59">
                  <c:v>-0.3163436512001972</c:v>
                </c:pt>
                <c:pt idx="60">
                  <c:v>-4.450128667718678E-2</c:v>
                </c:pt>
                <c:pt idx="61">
                  <c:v>0.20945346386413785</c:v>
                </c:pt>
                <c:pt idx="62">
                  <c:v>0.13888836378899219</c:v>
                </c:pt>
                <c:pt idx="63">
                  <c:v>0.44920029805181033</c:v>
                </c:pt>
                <c:pt idx="64">
                  <c:v>0.40432450418147353</c:v>
                </c:pt>
                <c:pt idx="65">
                  <c:v>3.663403163250805E-2</c:v>
                </c:pt>
                <c:pt idx="66">
                  <c:v>0.84380068660957208</c:v>
                </c:pt>
                <c:pt idx="67">
                  <c:v>0.33770289064583187</c:v>
                </c:pt>
                <c:pt idx="68">
                  <c:v>0.45699895177218608</c:v>
                </c:pt>
                <c:pt idx="69">
                  <c:v>-0.87004753644329502</c:v>
                </c:pt>
                <c:pt idx="70">
                  <c:v>-0.15905091401752405</c:v>
                </c:pt>
                <c:pt idx="71">
                  <c:v>0.39060575572441864</c:v>
                </c:pt>
                <c:pt idx="72">
                  <c:v>-0.44654017329941215</c:v>
                </c:pt>
                <c:pt idx="73">
                  <c:v>-0.18920906313013058</c:v>
                </c:pt>
                <c:pt idx="74">
                  <c:v>6.3709273809107722E-2</c:v>
                </c:pt>
                <c:pt idx="75">
                  <c:v>0.44644795029593043</c:v>
                </c:pt>
                <c:pt idx="76">
                  <c:v>9.3742374285787924E-2</c:v>
                </c:pt>
                <c:pt idx="77">
                  <c:v>0.35492116707552185</c:v>
                </c:pt>
                <c:pt idx="78">
                  <c:v>-0.68056397013589576</c:v>
                </c:pt>
                <c:pt idx="79">
                  <c:v>-0.16645386082795766</c:v>
                </c:pt>
                <c:pt idx="80">
                  <c:v>0.37948847085966514</c:v>
                </c:pt>
                <c:pt idx="81">
                  <c:v>-0.10045738545909495</c:v>
                </c:pt>
                <c:pt idx="82">
                  <c:v>0.22391632170501105</c:v>
                </c:pt>
                <c:pt idx="83">
                  <c:v>-8.9159160253699063E-2</c:v>
                </c:pt>
                <c:pt idx="84">
                  <c:v>-5.9444138862494549E-2</c:v>
                </c:pt>
                <c:pt idx="85">
                  <c:v>1.2869130504420203E-2</c:v>
                </c:pt>
                <c:pt idx="86">
                  <c:v>-0.47214661194997726</c:v>
                </c:pt>
                <c:pt idx="87">
                  <c:v>-0.81137363590238687</c:v>
                </c:pt>
                <c:pt idx="88">
                  <c:v>0.15116888900241054</c:v>
                </c:pt>
                <c:pt idx="89">
                  <c:v>0.56757516583443923</c:v>
                </c:pt>
                <c:pt idx="90">
                  <c:v>0.46547577815843283</c:v>
                </c:pt>
                <c:pt idx="91">
                  <c:v>-0.81840352627225454</c:v>
                </c:pt>
                <c:pt idx="92">
                  <c:v>-0.40654407631120676</c:v>
                </c:pt>
                <c:pt idx="93">
                  <c:v>-0.12486376311664719</c:v>
                </c:pt>
                <c:pt idx="94">
                  <c:v>-0.96693495620121805</c:v>
                </c:pt>
                <c:pt idx="95">
                  <c:v>4.675487166552824E-2</c:v>
                </c:pt>
                <c:pt idx="96">
                  <c:v>0.1867604417580539</c:v>
                </c:pt>
                <c:pt idx="97">
                  <c:v>0.18483738080530301</c:v>
                </c:pt>
                <c:pt idx="98">
                  <c:v>0.48599116829047323</c:v>
                </c:pt>
                <c:pt idx="99">
                  <c:v>-0.68991050847099755</c:v>
                </c:pt>
                <c:pt idx="100">
                  <c:v>0.12330415479040811</c:v>
                </c:pt>
                <c:pt idx="101">
                  <c:v>0.51430405825109515</c:v>
                </c:pt>
                <c:pt idx="102">
                  <c:v>-0.7353430231853475</c:v>
                </c:pt>
                <c:pt idx="103">
                  <c:v>-0.69452290893350888</c:v>
                </c:pt>
                <c:pt idx="104">
                  <c:v>-0.76414426936439173</c:v>
                </c:pt>
              </c:numCache>
            </c:numRef>
          </c:yVal>
          <c:smooth val="0"/>
          <c:extLst>
            <c:ext xmlns:c16="http://schemas.microsoft.com/office/drawing/2014/chart" uri="{C3380CC4-5D6E-409C-BE32-E72D297353CC}">
              <c16:uniqueId val="{00000001-DD54-4FAF-AFC1-E04033F18C39}"/>
            </c:ext>
          </c:extLst>
        </c:ser>
        <c:dLbls>
          <c:showLegendKey val="0"/>
          <c:showVal val="0"/>
          <c:showCatName val="0"/>
          <c:showSerName val="0"/>
          <c:showPercent val="0"/>
          <c:showBubbleSize val="0"/>
        </c:dLbls>
        <c:axId val="173053824"/>
        <c:axId val="173055360"/>
      </c:scatterChart>
      <c:valAx>
        <c:axId val="173053824"/>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055360"/>
        <c:crosses val="autoZero"/>
        <c:crossBetween val="midCat"/>
      </c:valAx>
      <c:valAx>
        <c:axId val="173055360"/>
        <c:scaling>
          <c:orientation val="minMax"/>
          <c:max val="3"/>
          <c:min val="-1"/>
        </c:scaling>
        <c:delete val="0"/>
        <c:axPos val="l"/>
        <c:numFmt formatCode="#,##0" sourceLinked="0"/>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3053824"/>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172 dn del and prion'!$D$88</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round/>
              </a:ln>
              <a:effectLst/>
            </c:spPr>
          </c:errBars>
          <c:xVal>
            <c:numRef>
              <c:f>'172 dn del and prion'!$C$89:$C$174</c:f>
              <c:numCache>
                <c:formatCode>General</c:formatCode>
                <c:ptCount val="86"/>
                <c:pt idx="0">
                  <c:v>673142</c:v>
                </c:pt>
                <c:pt idx="1">
                  <c:v>1083188</c:v>
                </c:pt>
                <c:pt idx="2">
                  <c:v>1100776</c:v>
                </c:pt>
                <c:pt idx="3">
                  <c:v>1195010</c:v>
                </c:pt>
                <c:pt idx="4">
                  <c:v>1459583</c:v>
                </c:pt>
                <c:pt idx="5">
                  <c:v>1682248</c:v>
                </c:pt>
                <c:pt idx="6">
                  <c:v>1700650</c:v>
                </c:pt>
                <c:pt idx="7">
                  <c:v>1895214</c:v>
                </c:pt>
                <c:pt idx="8">
                  <c:v>1901624</c:v>
                </c:pt>
                <c:pt idx="9">
                  <c:v>1972095</c:v>
                </c:pt>
                <c:pt idx="10">
                  <c:v>2254111</c:v>
                </c:pt>
                <c:pt idx="11">
                  <c:v>2462206</c:v>
                </c:pt>
                <c:pt idx="12">
                  <c:v>2745198</c:v>
                </c:pt>
                <c:pt idx="13">
                  <c:v>2794946</c:v>
                </c:pt>
                <c:pt idx="14">
                  <c:v>2908310</c:v>
                </c:pt>
                <c:pt idx="15">
                  <c:v>2913492</c:v>
                </c:pt>
                <c:pt idx="16">
                  <c:v>2965726</c:v>
                </c:pt>
                <c:pt idx="17">
                  <c:v>3067203</c:v>
                </c:pt>
                <c:pt idx="18">
                  <c:v>3150692</c:v>
                </c:pt>
                <c:pt idx="19">
                  <c:v>3187365</c:v>
                </c:pt>
                <c:pt idx="20">
                  <c:v>3198278</c:v>
                </c:pt>
                <c:pt idx="21">
                  <c:v>3294330</c:v>
                </c:pt>
                <c:pt idx="22">
                  <c:v>3533072</c:v>
                </c:pt>
                <c:pt idx="23">
                  <c:v>3551409</c:v>
                </c:pt>
                <c:pt idx="24">
                  <c:v>3576628</c:v>
                </c:pt>
                <c:pt idx="25">
                  <c:v>4099278</c:v>
                </c:pt>
                <c:pt idx="26">
                  <c:v>4346553</c:v>
                </c:pt>
                <c:pt idx="27">
                  <c:v>4484825</c:v>
                </c:pt>
                <c:pt idx="28">
                  <c:v>4519389</c:v>
                </c:pt>
                <c:pt idx="29">
                  <c:v>4526302</c:v>
                </c:pt>
                <c:pt idx="30">
                  <c:v>4638894</c:v>
                </c:pt>
                <c:pt idx="31">
                  <c:v>4641510</c:v>
                </c:pt>
                <c:pt idx="32">
                  <c:v>4776790</c:v>
                </c:pt>
                <c:pt idx="33">
                  <c:v>4956451</c:v>
                </c:pt>
                <c:pt idx="34">
                  <c:v>5005478</c:v>
                </c:pt>
                <c:pt idx="35">
                  <c:v>5272111</c:v>
                </c:pt>
                <c:pt idx="36">
                  <c:v>5432764</c:v>
                </c:pt>
                <c:pt idx="37">
                  <c:v>5491100</c:v>
                </c:pt>
                <c:pt idx="38">
                  <c:v>5533186</c:v>
                </c:pt>
                <c:pt idx="39">
                  <c:v>5776129</c:v>
                </c:pt>
                <c:pt idx="40">
                  <c:v>5826502</c:v>
                </c:pt>
                <c:pt idx="41">
                  <c:v>5908394</c:v>
                </c:pt>
                <c:pt idx="42">
                  <c:v>5956297</c:v>
                </c:pt>
                <c:pt idx="43">
                  <c:v>5972898</c:v>
                </c:pt>
                <c:pt idx="44">
                  <c:v>6357369</c:v>
                </c:pt>
                <c:pt idx="45">
                  <c:v>6358796</c:v>
                </c:pt>
                <c:pt idx="46">
                  <c:v>6418861</c:v>
                </c:pt>
                <c:pt idx="47">
                  <c:v>6810439</c:v>
                </c:pt>
                <c:pt idx="48">
                  <c:v>7129869</c:v>
                </c:pt>
                <c:pt idx="49">
                  <c:v>7209364</c:v>
                </c:pt>
                <c:pt idx="50">
                  <c:v>7535240</c:v>
                </c:pt>
                <c:pt idx="51">
                  <c:v>7563265</c:v>
                </c:pt>
                <c:pt idx="52">
                  <c:v>7768660</c:v>
                </c:pt>
                <c:pt idx="53">
                  <c:v>7808820</c:v>
                </c:pt>
                <c:pt idx="54">
                  <c:v>7811682</c:v>
                </c:pt>
                <c:pt idx="55">
                  <c:v>7905744</c:v>
                </c:pt>
                <c:pt idx="56">
                  <c:v>7990648</c:v>
                </c:pt>
                <c:pt idx="57">
                  <c:v>8028155</c:v>
                </c:pt>
                <c:pt idx="58">
                  <c:v>8263169</c:v>
                </c:pt>
                <c:pt idx="59">
                  <c:v>8425067</c:v>
                </c:pt>
                <c:pt idx="60">
                  <c:v>8624074</c:v>
                </c:pt>
                <c:pt idx="61">
                  <c:v>8765231</c:v>
                </c:pt>
                <c:pt idx="62">
                  <c:v>8777220</c:v>
                </c:pt>
                <c:pt idx="63">
                  <c:v>8781613</c:v>
                </c:pt>
                <c:pt idx="64">
                  <c:v>8856368</c:v>
                </c:pt>
                <c:pt idx="65">
                  <c:v>8882404</c:v>
                </c:pt>
                <c:pt idx="66">
                  <c:v>8949554</c:v>
                </c:pt>
                <c:pt idx="67">
                  <c:v>9056473</c:v>
                </c:pt>
                <c:pt idx="68">
                  <c:v>9071467</c:v>
                </c:pt>
                <c:pt idx="69">
                  <c:v>9383576</c:v>
                </c:pt>
                <c:pt idx="70">
                  <c:v>9743337</c:v>
                </c:pt>
                <c:pt idx="71">
                  <c:v>9751360</c:v>
                </c:pt>
                <c:pt idx="72">
                  <c:v>10158951</c:v>
                </c:pt>
                <c:pt idx="73">
                  <c:v>10217817</c:v>
                </c:pt>
                <c:pt idx="74">
                  <c:v>10263539</c:v>
                </c:pt>
                <c:pt idx="75">
                  <c:v>10535521</c:v>
                </c:pt>
                <c:pt idx="76">
                  <c:v>10537763</c:v>
                </c:pt>
                <c:pt idx="77">
                  <c:v>10554996</c:v>
                </c:pt>
                <c:pt idx="78">
                  <c:v>10715298</c:v>
                </c:pt>
                <c:pt idx="79">
                  <c:v>10765894</c:v>
                </c:pt>
                <c:pt idx="80">
                  <c:v>10899067</c:v>
                </c:pt>
                <c:pt idx="81">
                  <c:v>11043158</c:v>
                </c:pt>
                <c:pt idx="82">
                  <c:v>11245027</c:v>
                </c:pt>
                <c:pt idx="83">
                  <c:v>11317772</c:v>
                </c:pt>
                <c:pt idx="84">
                  <c:v>11529896</c:v>
                </c:pt>
                <c:pt idx="85">
                  <c:v>11575169</c:v>
                </c:pt>
              </c:numCache>
            </c:numRef>
          </c:xVal>
          <c:yVal>
            <c:numRef>
              <c:f>'172 dn del and prion'!$D$89:$D$174</c:f>
              <c:numCache>
                <c:formatCode>General</c:formatCode>
                <c:ptCount val="86"/>
                <c:pt idx="0">
                  <c:v>-1.6959102212891803</c:v>
                </c:pt>
                <c:pt idx="1">
                  <c:v>-4.9799642081940521</c:v>
                </c:pt>
                <c:pt idx="2">
                  <c:v>-2.6837371124986462</c:v>
                </c:pt>
                <c:pt idx="3">
                  <c:v>-4.1011818280191887</c:v>
                </c:pt>
                <c:pt idx="4">
                  <c:v>-4.1873896393844126</c:v>
                </c:pt>
                <c:pt idx="5">
                  <c:v>-5.060647681833875</c:v>
                </c:pt>
                <c:pt idx="6">
                  <c:v>-1.8667306256936487</c:v>
                </c:pt>
                <c:pt idx="7">
                  <c:v>-3.2461196168575408</c:v>
                </c:pt>
                <c:pt idx="8">
                  <c:v>-3.1222866434639327</c:v>
                </c:pt>
                <c:pt idx="9">
                  <c:v>-3.7415177883217625</c:v>
                </c:pt>
                <c:pt idx="10">
                  <c:v>-6.7222504774161917</c:v>
                </c:pt>
                <c:pt idx="11">
                  <c:v>-2.2881772384283159</c:v>
                </c:pt>
                <c:pt idx="12">
                  <c:v>-4.0566526478867262</c:v>
                </c:pt>
                <c:pt idx="13">
                  <c:v>-2.8327314956431944</c:v>
                </c:pt>
                <c:pt idx="14">
                  <c:v>-3.2040172280692474</c:v>
                </c:pt>
                <c:pt idx="15">
                  <c:v>-4.5277612850001292</c:v>
                </c:pt>
                <c:pt idx="16">
                  <c:v>-1.2031578262817535</c:v>
                </c:pt>
                <c:pt idx="17">
                  <c:v>-2.9564244233994823</c:v>
                </c:pt>
                <c:pt idx="18">
                  <c:v>-1.800997258184736</c:v>
                </c:pt>
                <c:pt idx="19">
                  <c:v>-1.6281648694623232</c:v>
                </c:pt>
                <c:pt idx="20">
                  <c:v>-1.9607412037064005</c:v>
                </c:pt>
                <c:pt idx="21">
                  <c:v>-2.6666733855766251</c:v>
                </c:pt>
                <c:pt idx="22">
                  <c:v>-1.6302025959469491</c:v>
                </c:pt>
                <c:pt idx="23">
                  <c:v>-3.3488916857088733</c:v>
                </c:pt>
                <c:pt idx="24">
                  <c:v>-2.873333635407366</c:v>
                </c:pt>
                <c:pt idx="25">
                  <c:v>-2.4790361069619964</c:v>
                </c:pt>
                <c:pt idx="26">
                  <c:v>-2.7282376684852006</c:v>
                </c:pt>
                <c:pt idx="27">
                  <c:v>-1.8909380184618518</c:v>
                </c:pt>
                <c:pt idx="28">
                  <c:v>-2.191473139010109</c:v>
                </c:pt>
                <c:pt idx="29">
                  <c:v>-3.8778656855373663</c:v>
                </c:pt>
                <c:pt idx="30">
                  <c:v>-2.3622819439892386</c:v>
                </c:pt>
                <c:pt idx="31">
                  <c:v>-4.2206192967149203</c:v>
                </c:pt>
                <c:pt idx="32">
                  <c:v>-1.7724001513319401</c:v>
                </c:pt>
                <c:pt idx="33">
                  <c:v>-2.3606367691795502</c:v>
                </c:pt>
                <c:pt idx="34">
                  <c:v>-5.0183265515914801</c:v>
                </c:pt>
                <c:pt idx="35">
                  <c:v>-1.9678308625199394</c:v>
                </c:pt>
                <c:pt idx="36">
                  <c:v>-5.4689761778318973</c:v>
                </c:pt>
                <c:pt idx="37">
                  <c:v>-1.6609099605398145</c:v>
                </c:pt>
                <c:pt idx="38">
                  <c:v>-3.2707000985401948</c:v>
                </c:pt>
                <c:pt idx="39">
                  <c:v>-6.8658178917526609</c:v>
                </c:pt>
                <c:pt idx="40">
                  <c:v>-3.9309781793763525</c:v>
                </c:pt>
                <c:pt idx="41">
                  <c:v>-5.5144967997652179</c:v>
                </c:pt>
                <c:pt idx="42">
                  <c:v>-1.1940625402780436</c:v>
                </c:pt>
                <c:pt idx="43">
                  <c:v>-6.6112026881789987</c:v>
                </c:pt>
                <c:pt idx="44">
                  <c:v>-1.8897361473528853</c:v>
                </c:pt>
                <c:pt idx="45">
                  <c:v>-4.7836686268632986</c:v>
                </c:pt>
                <c:pt idx="46">
                  <c:v>-1.6575953008878539</c:v>
                </c:pt>
                <c:pt idx="47">
                  <c:v>-3.2989844273976576</c:v>
                </c:pt>
                <c:pt idx="48">
                  <c:v>-1.7293113172715711</c:v>
                </c:pt>
                <c:pt idx="49">
                  <c:v>-1.1668072332649257</c:v>
                </c:pt>
                <c:pt idx="50">
                  <c:v>-1.9739034379572897</c:v>
                </c:pt>
                <c:pt idx="51">
                  <c:v>-2.0251639666046852</c:v>
                </c:pt>
                <c:pt idx="52">
                  <c:v>-1.1254175169518434</c:v>
                </c:pt>
                <c:pt idx="53">
                  <c:v>-1.224621413143161</c:v>
                </c:pt>
                <c:pt idx="54">
                  <c:v>-1.8115813940756416</c:v>
                </c:pt>
                <c:pt idx="55">
                  <c:v>-3.6458388490830509</c:v>
                </c:pt>
                <c:pt idx="56">
                  <c:v>-2.3437435651955645</c:v>
                </c:pt>
                <c:pt idx="57">
                  <c:v>-2.1039494369360678</c:v>
                </c:pt>
                <c:pt idx="58">
                  <c:v>-4.8135275436317615</c:v>
                </c:pt>
                <c:pt idx="59">
                  <c:v>-4.142131432378247</c:v>
                </c:pt>
                <c:pt idx="60">
                  <c:v>-3.1279988330774242</c:v>
                </c:pt>
                <c:pt idx="61">
                  <c:v>-8.1074141603182159</c:v>
                </c:pt>
                <c:pt idx="62">
                  <c:v>-2.6625893707902102</c:v>
                </c:pt>
                <c:pt idx="63">
                  <c:v>-1.3582063130615916</c:v>
                </c:pt>
                <c:pt idx="64">
                  <c:v>-4.6300134962016353</c:v>
                </c:pt>
                <c:pt idx="65">
                  <c:v>-2.3325531891926117</c:v>
                </c:pt>
                <c:pt idx="66">
                  <c:v>-2.607468302248924</c:v>
                </c:pt>
                <c:pt idx="67">
                  <c:v>-2.1813091135104936</c:v>
                </c:pt>
                <c:pt idx="68">
                  <c:v>-4.082902488448239</c:v>
                </c:pt>
                <c:pt idx="69">
                  <c:v>-1.9641924951973713</c:v>
                </c:pt>
                <c:pt idx="70">
                  <c:v>-6.7292567735991753</c:v>
                </c:pt>
                <c:pt idx="71">
                  <c:v>-4.6595625710750852</c:v>
                </c:pt>
                <c:pt idx="72">
                  <c:v>-5.1379606368530144</c:v>
                </c:pt>
                <c:pt idx="73">
                  <c:v>-9.2483012850129143</c:v>
                </c:pt>
                <c:pt idx="74">
                  <c:v>-1.8635039271113121</c:v>
                </c:pt>
                <c:pt idx="75">
                  <c:v>-2.8919102048336263</c:v>
                </c:pt>
                <c:pt idx="76">
                  <c:v>-4.4726011362694029</c:v>
                </c:pt>
                <c:pt idx="77">
                  <c:v>-2.0909339925891319</c:v>
                </c:pt>
                <c:pt idx="78">
                  <c:v>-2.2389097749593518</c:v>
                </c:pt>
                <c:pt idx="79">
                  <c:v>-3.7871804210333928</c:v>
                </c:pt>
                <c:pt idx="80">
                  <c:v>-1.2131098404856429</c:v>
                </c:pt>
                <c:pt idx="81">
                  <c:v>-2.8172920496466909</c:v>
                </c:pt>
                <c:pt idx="82">
                  <c:v>-2.9458851494349143</c:v>
                </c:pt>
                <c:pt idx="83">
                  <c:v>-2.5767317302234725</c:v>
                </c:pt>
                <c:pt idx="84">
                  <c:v>-3.6152196489554207</c:v>
                </c:pt>
                <c:pt idx="85">
                  <c:v>-3.3532496065171618</c:v>
                </c:pt>
              </c:numCache>
            </c:numRef>
          </c:yVal>
          <c:smooth val="0"/>
          <c:extLst>
            <c:ext xmlns:c16="http://schemas.microsoft.com/office/drawing/2014/chart" uri="{C3380CC4-5D6E-409C-BE32-E72D297353CC}">
              <c16:uniqueId val="{00000000-0BE6-48E5-855B-02B62B65B97E}"/>
            </c:ext>
          </c:extLst>
        </c:ser>
        <c:ser>
          <c:idx val="1"/>
          <c:order val="1"/>
          <c:tx>
            <c:strRef>
              <c:f>'172 dn del and prion'!$E$88</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C00000"/>
                </a:solidFill>
                <a:round/>
              </a:ln>
              <a:effectLst/>
            </c:spPr>
          </c:errBars>
          <c:xVal>
            <c:numRef>
              <c:f>'172 dn del and prion'!$C$89:$C$174</c:f>
              <c:numCache>
                <c:formatCode>General</c:formatCode>
                <c:ptCount val="86"/>
                <c:pt idx="0">
                  <c:v>673142</c:v>
                </c:pt>
                <c:pt idx="1">
                  <c:v>1083188</c:v>
                </c:pt>
                <c:pt idx="2">
                  <c:v>1100776</c:v>
                </c:pt>
                <c:pt idx="3">
                  <c:v>1195010</c:v>
                </c:pt>
                <c:pt idx="4">
                  <c:v>1459583</c:v>
                </c:pt>
                <c:pt idx="5">
                  <c:v>1682248</c:v>
                </c:pt>
                <c:pt idx="6">
                  <c:v>1700650</c:v>
                </c:pt>
                <c:pt idx="7">
                  <c:v>1895214</c:v>
                </c:pt>
                <c:pt idx="8">
                  <c:v>1901624</c:v>
                </c:pt>
                <c:pt idx="9">
                  <c:v>1972095</c:v>
                </c:pt>
                <c:pt idx="10">
                  <c:v>2254111</c:v>
                </c:pt>
                <c:pt idx="11">
                  <c:v>2462206</c:v>
                </c:pt>
                <c:pt idx="12">
                  <c:v>2745198</c:v>
                </c:pt>
                <c:pt idx="13">
                  <c:v>2794946</c:v>
                </c:pt>
                <c:pt idx="14">
                  <c:v>2908310</c:v>
                </c:pt>
                <c:pt idx="15">
                  <c:v>2913492</c:v>
                </c:pt>
                <c:pt idx="16">
                  <c:v>2965726</c:v>
                </c:pt>
                <c:pt idx="17">
                  <c:v>3067203</c:v>
                </c:pt>
                <c:pt idx="18">
                  <c:v>3150692</c:v>
                </c:pt>
                <c:pt idx="19">
                  <c:v>3187365</c:v>
                </c:pt>
                <c:pt idx="20">
                  <c:v>3198278</c:v>
                </c:pt>
                <c:pt idx="21">
                  <c:v>3294330</c:v>
                </c:pt>
                <c:pt idx="22">
                  <c:v>3533072</c:v>
                </c:pt>
                <c:pt idx="23">
                  <c:v>3551409</c:v>
                </c:pt>
                <c:pt idx="24">
                  <c:v>3576628</c:v>
                </c:pt>
                <c:pt idx="25">
                  <c:v>4099278</c:v>
                </c:pt>
                <c:pt idx="26">
                  <c:v>4346553</c:v>
                </c:pt>
                <c:pt idx="27">
                  <c:v>4484825</c:v>
                </c:pt>
                <c:pt idx="28">
                  <c:v>4519389</c:v>
                </c:pt>
                <c:pt idx="29">
                  <c:v>4526302</c:v>
                </c:pt>
                <c:pt idx="30">
                  <c:v>4638894</c:v>
                </c:pt>
                <c:pt idx="31">
                  <c:v>4641510</c:v>
                </c:pt>
                <c:pt idx="32">
                  <c:v>4776790</c:v>
                </c:pt>
                <c:pt idx="33">
                  <c:v>4956451</c:v>
                </c:pt>
                <c:pt idx="34">
                  <c:v>5005478</c:v>
                </c:pt>
                <c:pt idx="35">
                  <c:v>5272111</c:v>
                </c:pt>
                <c:pt idx="36">
                  <c:v>5432764</c:v>
                </c:pt>
                <c:pt idx="37">
                  <c:v>5491100</c:v>
                </c:pt>
                <c:pt idx="38">
                  <c:v>5533186</c:v>
                </c:pt>
                <c:pt idx="39">
                  <c:v>5776129</c:v>
                </c:pt>
                <c:pt idx="40">
                  <c:v>5826502</c:v>
                </c:pt>
                <c:pt idx="41">
                  <c:v>5908394</c:v>
                </c:pt>
                <c:pt idx="42">
                  <c:v>5956297</c:v>
                </c:pt>
                <c:pt idx="43">
                  <c:v>5972898</c:v>
                </c:pt>
                <c:pt idx="44">
                  <c:v>6357369</c:v>
                </c:pt>
                <c:pt idx="45">
                  <c:v>6358796</c:v>
                </c:pt>
                <c:pt idx="46">
                  <c:v>6418861</c:v>
                </c:pt>
                <c:pt idx="47">
                  <c:v>6810439</c:v>
                </c:pt>
                <c:pt idx="48">
                  <c:v>7129869</c:v>
                </c:pt>
                <c:pt idx="49">
                  <c:v>7209364</c:v>
                </c:pt>
                <c:pt idx="50">
                  <c:v>7535240</c:v>
                </c:pt>
                <c:pt idx="51">
                  <c:v>7563265</c:v>
                </c:pt>
                <c:pt idx="52">
                  <c:v>7768660</c:v>
                </c:pt>
                <c:pt idx="53">
                  <c:v>7808820</c:v>
                </c:pt>
                <c:pt idx="54">
                  <c:v>7811682</c:v>
                </c:pt>
                <c:pt idx="55">
                  <c:v>7905744</c:v>
                </c:pt>
                <c:pt idx="56">
                  <c:v>7990648</c:v>
                </c:pt>
                <c:pt idx="57">
                  <c:v>8028155</c:v>
                </c:pt>
                <c:pt idx="58">
                  <c:v>8263169</c:v>
                </c:pt>
                <c:pt idx="59">
                  <c:v>8425067</c:v>
                </c:pt>
                <c:pt idx="60">
                  <c:v>8624074</c:v>
                </c:pt>
                <c:pt idx="61">
                  <c:v>8765231</c:v>
                </c:pt>
                <c:pt idx="62">
                  <c:v>8777220</c:v>
                </c:pt>
                <c:pt idx="63">
                  <c:v>8781613</c:v>
                </c:pt>
                <c:pt idx="64">
                  <c:v>8856368</c:v>
                </c:pt>
                <c:pt idx="65">
                  <c:v>8882404</c:v>
                </c:pt>
                <c:pt idx="66">
                  <c:v>8949554</c:v>
                </c:pt>
                <c:pt idx="67">
                  <c:v>9056473</c:v>
                </c:pt>
                <c:pt idx="68">
                  <c:v>9071467</c:v>
                </c:pt>
                <c:pt idx="69">
                  <c:v>9383576</c:v>
                </c:pt>
                <c:pt idx="70">
                  <c:v>9743337</c:v>
                </c:pt>
                <c:pt idx="71">
                  <c:v>9751360</c:v>
                </c:pt>
                <c:pt idx="72">
                  <c:v>10158951</c:v>
                </c:pt>
                <c:pt idx="73">
                  <c:v>10217817</c:v>
                </c:pt>
                <c:pt idx="74">
                  <c:v>10263539</c:v>
                </c:pt>
                <c:pt idx="75">
                  <c:v>10535521</c:v>
                </c:pt>
                <c:pt idx="76">
                  <c:v>10537763</c:v>
                </c:pt>
                <c:pt idx="77">
                  <c:v>10554996</c:v>
                </c:pt>
                <c:pt idx="78">
                  <c:v>10715298</c:v>
                </c:pt>
                <c:pt idx="79">
                  <c:v>10765894</c:v>
                </c:pt>
                <c:pt idx="80">
                  <c:v>10899067</c:v>
                </c:pt>
                <c:pt idx="81">
                  <c:v>11043158</c:v>
                </c:pt>
                <c:pt idx="82">
                  <c:v>11245027</c:v>
                </c:pt>
                <c:pt idx="83">
                  <c:v>11317772</c:v>
                </c:pt>
                <c:pt idx="84">
                  <c:v>11529896</c:v>
                </c:pt>
                <c:pt idx="85">
                  <c:v>11575169</c:v>
                </c:pt>
              </c:numCache>
            </c:numRef>
          </c:xVal>
          <c:yVal>
            <c:numRef>
              <c:f>'172 dn del and prion'!$E$89:$E$174</c:f>
              <c:numCache>
                <c:formatCode>General</c:formatCode>
                <c:ptCount val="86"/>
                <c:pt idx="0">
                  <c:v>-2.3642634906601199</c:v>
                </c:pt>
                <c:pt idx="1">
                  <c:v>-2.3728207773279433</c:v>
                </c:pt>
                <c:pt idx="2">
                  <c:v>-2.1155373615855573</c:v>
                </c:pt>
                <c:pt idx="3">
                  <c:v>-2.5635277066385096</c:v>
                </c:pt>
                <c:pt idx="4">
                  <c:v>-1.6188716332440105</c:v>
                </c:pt>
                <c:pt idx="5">
                  <c:v>-1.8040123542500059</c:v>
                </c:pt>
                <c:pt idx="6">
                  <c:v>-2.7526521509308712</c:v>
                </c:pt>
                <c:pt idx="7">
                  <c:v>-1.8329979418393054</c:v>
                </c:pt>
                <c:pt idx="8">
                  <c:v>-1.7466085947841448</c:v>
                </c:pt>
                <c:pt idx="9">
                  <c:v>-1.0413524085454864</c:v>
                </c:pt>
                <c:pt idx="10">
                  <c:v>-4.9046531857456355</c:v>
                </c:pt>
                <c:pt idx="11">
                  <c:v>-2.2131017744541022</c:v>
                </c:pt>
                <c:pt idx="12">
                  <c:v>-1.894172267448476</c:v>
                </c:pt>
                <c:pt idx="13">
                  <c:v>-2.2444789304911437</c:v>
                </c:pt>
                <c:pt idx="14">
                  <c:v>-1.5093579492742004</c:v>
                </c:pt>
                <c:pt idx="15">
                  <c:v>-2.7920977695194313</c:v>
                </c:pt>
                <c:pt idx="16">
                  <c:v>-1.4211066940060679</c:v>
                </c:pt>
                <c:pt idx="17">
                  <c:v>-2.119963756264811</c:v>
                </c:pt>
                <c:pt idx="18">
                  <c:v>-1.3071698678752961</c:v>
                </c:pt>
                <c:pt idx="19">
                  <c:v>-1.3077647994032886</c:v>
                </c:pt>
                <c:pt idx="20">
                  <c:v>-1.763851464860464</c:v>
                </c:pt>
                <c:pt idx="21">
                  <c:v>-2.8634255788429628</c:v>
                </c:pt>
                <c:pt idx="22">
                  <c:v>-1.3205524338631955</c:v>
                </c:pt>
                <c:pt idx="23">
                  <c:v>-1.5688858165159596</c:v>
                </c:pt>
                <c:pt idx="24">
                  <c:v>-2.0998360356332628</c:v>
                </c:pt>
                <c:pt idx="25">
                  <c:v>-2.4502355107548146</c:v>
                </c:pt>
                <c:pt idx="26">
                  <c:v>-1.6241272722419293</c:v>
                </c:pt>
                <c:pt idx="27">
                  <c:v>-1.5598628125461536</c:v>
                </c:pt>
                <c:pt idx="28">
                  <c:v>-4.0950988166875684</c:v>
                </c:pt>
                <c:pt idx="29">
                  <c:v>-1.4539790611149663</c:v>
                </c:pt>
                <c:pt idx="30">
                  <c:v>-1.3579307164435899</c:v>
                </c:pt>
                <c:pt idx="31">
                  <c:v>-1.8525874276428635</c:v>
                </c:pt>
                <c:pt idx="32">
                  <c:v>-1.7757548655656272</c:v>
                </c:pt>
                <c:pt idx="33">
                  <c:v>-1.0799875944133437</c:v>
                </c:pt>
                <c:pt idx="34">
                  <c:v>-2.0082091365569847</c:v>
                </c:pt>
                <c:pt idx="35">
                  <c:v>-1.2844706198778948</c:v>
                </c:pt>
                <c:pt idx="36">
                  <c:v>-2.9372591766733946</c:v>
                </c:pt>
                <c:pt idx="37">
                  <c:v>-1.093467374048763</c:v>
                </c:pt>
                <c:pt idx="38">
                  <c:v>-1.3680731466994767</c:v>
                </c:pt>
                <c:pt idx="39">
                  <c:v>-1.9910238621358796</c:v>
                </c:pt>
                <c:pt idx="40">
                  <c:v>-2.2273128524919144</c:v>
                </c:pt>
                <c:pt idx="41">
                  <c:v>-1.4839637961751926</c:v>
                </c:pt>
                <c:pt idx="42">
                  <c:v>-1.6641975727550318</c:v>
                </c:pt>
                <c:pt idx="43">
                  <c:v>-5.3324518821256071</c:v>
                </c:pt>
                <c:pt idx="44">
                  <c:v>-1.0676151311621955</c:v>
                </c:pt>
                <c:pt idx="45">
                  <c:v>-5.3397653270646206</c:v>
                </c:pt>
                <c:pt idx="46">
                  <c:v>-1.1500447142954375</c:v>
                </c:pt>
                <c:pt idx="47">
                  <c:v>-5.1507337923151715</c:v>
                </c:pt>
                <c:pt idx="48">
                  <c:v>-1.160228299165279</c:v>
                </c:pt>
                <c:pt idx="49">
                  <c:v>-3.1773165586310292</c:v>
                </c:pt>
                <c:pt idx="50">
                  <c:v>-2.2663783323883391</c:v>
                </c:pt>
                <c:pt idx="51">
                  <c:v>-1.7923403227237704</c:v>
                </c:pt>
                <c:pt idx="52">
                  <c:v>-1.4588858340692172</c:v>
                </c:pt>
                <c:pt idx="53">
                  <c:v>-1.2050614933346833</c:v>
                </c:pt>
                <c:pt idx="54">
                  <c:v>-2.2799127761078894</c:v>
                </c:pt>
                <c:pt idx="55">
                  <c:v>-1.9056806734572727</c:v>
                </c:pt>
                <c:pt idx="56">
                  <c:v>-1.2046014229472155</c:v>
                </c:pt>
                <c:pt idx="57">
                  <c:v>-2.1166469329969582</c:v>
                </c:pt>
                <c:pt idx="58">
                  <c:v>-2.7335066747062267</c:v>
                </c:pt>
                <c:pt idx="59">
                  <c:v>-2.6865811579069439</c:v>
                </c:pt>
                <c:pt idx="60">
                  <c:v>-1.2832802125074583</c:v>
                </c:pt>
                <c:pt idx="61">
                  <c:v>-7.7397099302448362</c:v>
                </c:pt>
                <c:pt idx="62">
                  <c:v>-1.1385661900847797</c:v>
                </c:pt>
                <c:pt idx="63">
                  <c:v>-1.0883305056723676</c:v>
                </c:pt>
                <c:pt idx="64">
                  <c:v>-3.8618541702260076</c:v>
                </c:pt>
                <c:pt idx="65">
                  <c:v>-1.4755768107373657</c:v>
                </c:pt>
                <c:pt idx="66">
                  <c:v>-1.1806564285152312</c:v>
                </c:pt>
                <c:pt idx="67">
                  <c:v>-1.4620008289152091</c:v>
                </c:pt>
                <c:pt idx="68">
                  <c:v>-2.8768442439774984</c:v>
                </c:pt>
                <c:pt idx="69">
                  <c:v>-4.5170190877240213</c:v>
                </c:pt>
                <c:pt idx="70">
                  <c:v>-5.0957409626606696</c:v>
                </c:pt>
                <c:pt idx="71">
                  <c:v>-3.4023361475755132</c:v>
                </c:pt>
                <c:pt idx="72">
                  <c:v>-2.6188714749304483</c:v>
                </c:pt>
                <c:pt idx="73">
                  <c:v>-5.3472533500387414</c:v>
                </c:pt>
                <c:pt idx="74">
                  <c:v>-1.1973024165064359</c:v>
                </c:pt>
                <c:pt idx="75">
                  <c:v>-3.0052877999619279</c:v>
                </c:pt>
                <c:pt idx="76">
                  <c:v>-6.1506442531077967</c:v>
                </c:pt>
                <c:pt idx="77">
                  <c:v>-3.0448309825326292</c:v>
                </c:pt>
                <c:pt idx="78">
                  <c:v>-1.8629649842327021</c:v>
                </c:pt>
                <c:pt idx="79">
                  <c:v>-1.1146675579058969</c:v>
                </c:pt>
                <c:pt idx="80">
                  <c:v>-1.2884231363514234</c:v>
                </c:pt>
                <c:pt idx="81">
                  <c:v>-2.0394345883088025</c:v>
                </c:pt>
                <c:pt idx="82">
                  <c:v>-2.8806789659715819</c:v>
                </c:pt>
                <c:pt idx="83">
                  <c:v>-2.136376136933468</c:v>
                </c:pt>
                <c:pt idx="84">
                  <c:v>-1.5658221599499897</c:v>
                </c:pt>
                <c:pt idx="85">
                  <c:v>-1.7774366407366422</c:v>
                </c:pt>
              </c:numCache>
            </c:numRef>
          </c:yVal>
          <c:smooth val="0"/>
          <c:extLst>
            <c:ext xmlns:c16="http://schemas.microsoft.com/office/drawing/2014/chart" uri="{C3380CC4-5D6E-409C-BE32-E72D297353CC}">
              <c16:uniqueId val="{00000001-0BE6-48E5-855B-02B62B65B97E}"/>
            </c:ext>
          </c:extLst>
        </c:ser>
        <c:dLbls>
          <c:showLegendKey val="0"/>
          <c:showVal val="0"/>
          <c:showCatName val="0"/>
          <c:showSerName val="0"/>
          <c:showPercent val="0"/>
          <c:showBubbleSize val="0"/>
        </c:dLbls>
        <c:axId val="173362176"/>
        <c:axId val="173376256"/>
      </c:scatterChart>
      <c:valAx>
        <c:axId val="173362176"/>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376256"/>
        <c:crossesAt val="0"/>
        <c:crossBetween val="midCat"/>
      </c:valAx>
      <c:valAx>
        <c:axId val="173376256"/>
        <c:scaling>
          <c:orientation val="minMax"/>
          <c:max val="0"/>
          <c:min val="-8"/>
        </c:scaling>
        <c:delete val="0"/>
        <c:axPos val="l"/>
        <c:numFmt formatCode="#,##0" sourceLinked="0"/>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3362176"/>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172 dn del and prion'!$D$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172 dn del and prion'!$C$2:$C$87</c:f>
              <c:numCache>
                <c:formatCode>General</c:formatCode>
                <c:ptCount val="86"/>
                <c:pt idx="0">
                  <c:v>22395</c:v>
                </c:pt>
                <c:pt idx="1">
                  <c:v>613330</c:v>
                </c:pt>
                <c:pt idx="2">
                  <c:v>688826</c:v>
                </c:pt>
                <c:pt idx="3">
                  <c:v>704610</c:v>
                </c:pt>
                <c:pt idx="4">
                  <c:v>816289</c:v>
                </c:pt>
                <c:pt idx="5">
                  <c:v>1004140</c:v>
                </c:pt>
                <c:pt idx="6">
                  <c:v>1439316</c:v>
                </c:pt>
                <c:pt idx="7">
                  <c:v>2080984</c:v>
                </c:pt>
                <c:pt idx="8">
                  <c:v>2144893</c:v>
                </c:pt>
                <c:pt idx="9">
                  <c:v>2439070</c:v>
                </c:pt>
                <c:pt idx="10">
                  <c:v>2639232</c:v>
                </c:pt>
                <c:pt idx="11">
                  <c:v>2761792</c:v>
                </c:pt>
                <c:pt idx="12">
                  <c:v>2953307</c:v>
                </c:pt>
                <c:pt idx="13">
                  <c:v>2977568</c:v>
                </c:pt>
                <c:pt idx="14">
                  <c:v>3040131</c:v>
                </c:pt>
                <c:pt idx="15">
                  <c:v>3270717</c:v>
                </c:pt>
                <c:pt idx="16">
                  <c:v>3375280</c:v>
                </c:pt>
                <c:pt idx="17">
                  <c:v>3480192</c:v>
                </c:pt>
                <c:pt idx="18">
                  <c:v>3578639</c:v>
                </c:pt>
                <c:pt idx="19">
                  <c:v>3692087</c:v>
                </c:pt>
                <c:pt idx="20">
                  <c:v>3748152</c:v>
                </c:pt>
                <c:pt idx="21">
                  <c:v>3887814</c:v>
                </c:pt>
                <c:pt idx="22">
                  <c:v>3966744</c:v>
                </c:pt>
                <c:pt idx="23">
                  <c:v>4247100</c:v>
                </c:pt>
                <c:pt idx="24">
                  <c:v>4375137</c:v>
                </c:pt>
                <c:pt idx="25">
                  <c:v>4379710</c:v>
                </c:pt>
                <c:pt idx="26">
                  <c:v>4724962</c:v>
                </c:pt>
                <c:pt idx="27">
                  <c:v>4843495</c:v>
                </c:pt>
                <c:pt idx="28">
                  <c:v>4969941</c:v>
                </c:pt>
                <c:pt idx="29">
                  <c:v>4997607</c:v>
                </c:pt>
                <c:pt idx="30">
                  <c:v>5023998</c:v>
                </c:pt>
                <c:pt idx="31">
                  <c:v>5036392</c:v>
                </c:pt>
                <c:pt idx="32">
                  <c:v>5040778</c:v>
                </c:pt>
                <c:pt idx="33">
                  <c:v>5144804</c:v>
                </c:pt>
                <c:pt idx="34">
                  <c:v>5164457</c:v>
                </c:pt>
                <c:pt idx="35">
                  <c:v>5280745</c:v>
                </c:pt>
                <c:pt idx="36">
                  <c:v>5372938</c:v>
                </c:pt>
                <c:pt idx="37">
                  <c:v>5461281</c:v>
                </c:pt>
                <c:pt idx="38">
                  <c:v>5640475</c:v>
                </c:pt>
                <c:pt idx="39">
                  <c:v>5651486</c:v>
                </c:pt>
                <c:pt idx="40">
                  <c:v>5829616</c:v>
                </c:pt>
                <c:pt idx="41">
                  <c:v>5864624</c:v>
                </c:pt>
                <c:pt idx="42">
                  <c:v>5908663</c:v>
                </c:pt>
                <c:pt idx="43">
                  <c:v>6418529</c:v>
                </c:pt>
                <c:pt idx="44">
                  <c:v>6600446</c:v>
                </c:pt>
                <c:pt idx="45">
                  <c:v>6722613</c:v>
                </c:pt>
                <c:pt idx="46">
                  <c:v>6867057</c:v>
                </c:pt>
                <c:pt idx="47">
                  <c:v>6883326</c:v>
                </c:pt>
                <c:pt idx="48">
                  <c:v>7032564</c:v>
                </c:pt>
                <c:pt idx="49">
                  <c:v>7041951</c:v>
                </c:pt>
                <c:pt idx="50">
                  <c:v>7157421</c:v>
                </c:pt>
                <c:pt idx="51">
                  <c:v>7231292</c:v>
                </c:pt>
                <c:pt idx="52">
                  <c:v>7443812</c:v>
                </c:pt>
                <c:pt idx="53">
                  <c:v>7449253</c:v>
                </c:pt>
                <c:pt idx="54">
                  <c:v>7508222</c:v>
                </c:pt>
                <c:pt idx="55">
                  <c:v>7918159</c:v>
                </c:pt>
                <c:pt idx="56">
                  <c:v>7965799</c:v>
                </c:pt>
                <c:pt idx="57">
                  <c:v>8101470</c:v>
                </c:pt>
                <c:pt idx="58">
                  <c:v>8273882</c:v>
                </c:pt>
                <c:pt idx="59">
                  <c:v>8546192</c:v>
                </c:pt>
                <c:pt idx="60">
                  <c:v>8834520</c:v>
                </c:pt>
                <c:pt idx="61">
                  <c:v>8934221</c:v>
                </c:pt>
                <c:pt idx="62">
                  <c:v>9009116</c:v>
                </c:pt>
                <c:pt idx="63">
                  <c:v>9076430</c:v>
                </c:pt>
                <c:pt idx="64">
                  <c:v>9239951</c:v>
                </c:pt>
                <c:pt idx="65">
                  <c:v>9243293</c:v>
                </c:pt>
                <c:pt idx="66">
                  <c:v>9364985</c:v>
                </c:pt>
                <c:pt idx="67">
                  <c:v>9434806</c:v>
                </c:pt>
                <c:pt idx="68">
                  <c:v>9499695</c:v>
                </c:pt>
                <c:pt idx="69">
                  <c:v>9600050</c:v>
                </c:pt>
                <c:pt idx="70">
                  <c:v>9666600</c:v>
                </c:pt>
                <c:pt idx="71">
                  <c:v>10008759</c:v>
                </c:pt>
                <c:pt idx="72">
                  <c:v>10018076</c:v>
                </c:pt>
                <c:pt idx="73">
                  <c:v>10217407</c:v>
                </c:pt>
                <c:pt idx="74">
                  <c:v>10320867</c:v>
                </c:pt>
                <c:pt idx="75">
                  <c:v>10343311</c:v>
                </c:pt>
                <c:pt idx="76">
                  <c:v>10474694</c:v>
                </c:pt>
                <c:pt idx="77">
                  <c:v>10603927</c:v>
                </c:pt>
                <c:pt idx="78">
                  <c:v>10669944</c:v>
                </c:pt>
                <c:pt idx="79">
                  <c:v>10710160</c:v>
                </c:pt>
                <c:pt idx="80">
                  <c:v>10810524</c:v>
                </c:pt>
                <c:pt idx="81">
                  <c:v>11162381</c:v>
                </c:pt>
                <c:pt idx="82">
                  <c:v>11347613</c:v>
                </c:pt>
                <c:pt idx="83">
                  <c:v>11593199</c:v>
                </c:pt>
                <c:pt idx="84">
                  <c:v>11984566</c:v>
                </c:pt>
                <c:pt idx="85">
                  <c:v>11644274</c:v>
                </c:pt>
              </c:numCache>
            </c:numRef>
          </c:xVal>
          <c:yVal>
            <c:numRef>
              <c:f>'172 dn del and prion'!$D$2:$D$87</c:f>
              <c:numCache>
                <c:formatCode>General</c:formatCode>
                <c:ptCount val="86"/>
                <c:pt idx="0">
                  <c:v>-7.6019000850748286</c:v>
                </c:pt>
                <c:pt idx="1">
                  <c:v>-3.671206020960184</c:v>
                </c:pt>
                <c:pt idx="2">
                  <c:v>-6.4703908003286728</c:v>
                </c:pt>
                <c:pt idx="3">
                  <c:v>-2.1279364341828382</c:v>
                </c:pt>
                <c:pt idx="4">
                  <c:v>-3.3704349279870729</c:v>
                </c:pt>
                <c:pt idx="5">
                  <c:v>-1.251689330677104</c:v>
                </c:pt>
                <c:pt idx="6">
                  <c:v>-3.0046285737584721</c:v>
                </c:pt>
                <c:pt idx="7">
                  <c:v>-1.3832163008988558</c:v>
                </c:pt>
                <c:pt idx="8">
                  <c:v>-4.8210724549722741</c:v>
                </c:pt>
                <c:pt idx="9">
                  <c:v>-4.3520114180137321</c:v>
                </c:pt>
                <c:pt idx="10">
                  <c:v>-4.3063701593712977</c:v>
                </c:pt>
                <c:pt idx="11">
                  <c:v>-1.4507341832859653</c:v>
                </c:pt>
                <c:pt idx="12">
                  <c:v>-4.8024444254200329</c:v>
                </c:pt>
                <c:pt idx="13">
                  <c:v>-2.187064439447381</c:v>
                </c:pt>
                <c:pt idx="14">
                  <c:v>-1.1378465063222696</c:v>
                </c:pt>
                <c:pt idx="15">
                  <c:v>-2.0559422623120107</c:v>
                </c:pt>
                <c:pt idx="16">
                  <c:v>-3.2506790681941768</c:v>
                </c:pt>
                <c:pt idx="17">
                  <c:v>-1.7245974096839829</c:v>
                </c:pt>
                <c:pt idx="18">
                  <c:v>-4.0703385130999896</c:v>
                </c:pt>
                <c:pt idx="19">
                  <c:v>-2.3492700601114409</c:v>
                </c:pt>
                <c:pt idx="20">
                  <c:v>-2.536683268705906</c:v>
                </c:pt>
                <c:pt idx="21">
                  <c:v>-3.7309423464475278</c:v>
                </c:pt>
                <c:pt idx="22">
                  <c:v>-3.5432578814701521</c:v>
                </c:pt>
                <c:pt idx="23">
                  <c:v>-1.7664597201543668</c:v>
                </c:pt>
                <c:pt idx="24">
                  <c:v>-2.3535049535559605</c:v>
                </c:pt>
                <c:pt idx="25">
                  <c:v>-2.8128256567343977</c:v>
                </c:pt>
                <c:pt idx="26">
                  <c:v>-3.1604697862866797</c:v>
                </c:pt>
                <c:pt idx="27">
                  <c:v>-2.5636169808608198</c:v>
                </c:pt>
                <c:pt idx="28">
                  <c:v>-1.1024185164780693</c:v>
                </c:pt>
                <c:pt idx="29">
                  <c:v>-3.3272463916914639</c:v>
                </c:pt>
                <c:pt idx="30">
                  <c:v>-1.6777944154461033</c:v>
                </c:pt>
                <c:pt idx="31">
                  <c:v>-1.2394623496370589</c:v>
                </c:pt>
                <c:pt idx="32">
                  <c:v>-2.949930268912941</c:v>
                </c:pt>
                <c:pt idx="33">
                  <c:v>-2.0578985959141529</c:v>
                </c:pt>
                <c:pt idx="34">
                  <c:v>-1.9345242778238458</c:v>
                </c:pt>
                <c:pt idx="35">
                  <c:v>-2.3299520865864394</c:v>
                </c:pt>
                <c:pt idx="36">
                  <c:v>-2.7066669019652685</c:v>
                </c:pt>
                <c:pt idx="37">
                  <c:v>-3.4400703750766439</c:v>
                </c:pt>
                <c:pt idx="38">
                  <c:v>-1.5024023499136665</c:v>
                </c:pt>
                <c:pt idx="39">
                  <c:v>-2.2874553978348593</c:v>
                </c:pt>
                <c:pt idx="40">
                  <c:v>-2.3851507378072405</c:v>
                </c:pt>
                <c:pt idx="41">
                  <c:v>-1.5681043631451519</c:v>
                </c:pt>
                <c:pt idx="42">
                  <c:v>-2.5455519491810894</c:v>
                </c:pt>
                <c:pt idx="43">
                  <c:v>-1.5589705778993108</c:v>
                </c:pt>
                <c:pt idx="44">
                  <c:v>-2.3282086196491001</c:v>
                </c:pt>
                <c:pt idx="45">
                  <c:v>-1.9136149525447916</c:v>
                </c:pt>
                <c:pt idx="46">
                  <c:v>-1.8093821048274346</c:v>
                </c:pt>
                <c:pt idx="47">
                  <c:v>-1.6857893386785161</c:v>
                </c:pt>
                <c:pt idx="48">
                  <c:v>-4.4326415570982691</c:v>
                </c:pt>
                <c:pt idx="49">
                  <c:v>-1.2661557956196074</c:v>
                </c:pt>
                <c:pt idx="50">
                  <c:v>-4.0873365037334892</c:v>
                </c:pt>
                <c:pt idx="51">
                  <c:v>-4.3013131285918247</c:v>
                </c:pt>
                <c:pt idx="52">
                  <c:v>-3.9355787548320165</c:v>
                </c:pt>
                <c:pt idx="53">
                  <c:v>-3.3050115853445616</c:v>
                </c:pt>
                <c:pt idx="54">
                  <c:v>-1.8163082576537655</c:v>
                </c:pt>
                <c:pt idx="55">
                  <c:v>-4.1341363600741152</c:v>
                </c:pt>
                <c:pt idx="56">
                  <c:v>-3.1756372458069499</c:v>
                </c:pt>
                <c:pt idx="57">
                  <c:v>-2.0722780734226869</c:v>
                </c:pt>
                <c:pt idx="58">
                  <c:v>-1.5082570174827485</c:v>
                </c:pt>
                <c:pt idx="59">
                  <c:v>-1.9840284785477873</c:v>
                </c:pt>
                <c:pt idx="60">
                  <c:v>-3.9965473682991326</c:v>
                </c:pt>
                <c:pt idx="61">
                  <c:v>-4.833098232424228</c:v>
                </c:pt>
                <c:pt idx="62">
                  <c:v>-1.4973242398811051</c:v>
                </c:pt>
                <c:pt idx="63">
                  <c:v>-1.7711664418769231</c:v>
                </c:pt>
                <c:pt idx="64">
                  <c:v>-2.698264868949289</c:v>
                </c:pt>
                <c:pt idx="65">
                  <c:v>-1.3143229081747607</c:v>
                </c:pt>
                <c:pt idx="66">
                  <c:v>-2.1569883374365073</c:v>
                </c:pt>
                <c:pt idx="67">
                  <c:v>-2.6460137652595339</c:v>
                </c:pt>
                <c:pt idx="68">
                  <c:v>-4.4278782239457604</c:v>
                </c:pt>
                <c:pt idx="69">
                  <c:v>-1.9098915866974302</c:v>
                </c:pt>
                <c:pt idx="70">
                  <c:v>-2.5148664625585839</c:v>
                </c:pt>
                <c:pt idx="71">
                  <c:v>-1.478433590453351</c:v>
                </c:pt>
                <c:pt idx="72">
                  <c:v>-2.2930716081766507</c:v>
                </c:pt>
                <c:pt idx="73">
                  <c:v>-3.4028679940851023</c:v>
                </c:pt>
                <c:pt idx="74">
                  <c:v>-1.169659813301746</c:v>
                </c:pt>
                <c:pt idx="75">
                  <c:v>-1.8912315171280361</c:v>
                </c:pt>
                <c:pt idx="76">
                  <c:v>-1.5403277363347567</c:v>
                </c:pt>
                <c:pt idx="77">
                  <c:v>-1.5252138745244399</c:v>
                </c:pt>
                <c:pt idx="78">
                  <c:v>-2.049498064901691</c:v>
                </c:pt>
                <c:pt idx="79">
                  <c:v>-4.0642347846940581</c:v>
                </c:pt>
                <c:pt idx="80">
                  <c:v>-1.7530083274886135</c:v>
                </c:pt>
                <c:pt idx="81">
                  <c:v>-3.6463943887964292</c:v>
                </c:pt>
                <c:pt idx="82">
                  <c:v>-1.9017139932817253</c:v>
                </c:pt>
                <c:pt idx="83">
                  <c:v>-4.2039840614351007</c:v>
                </c:pt>
                <c:pt idx="84">
                  <c:v>-2.504624375158568</c:v>
                </c:pt>
                <c:pt idx="85">
                  <c:v>-3.4328258731370092</c:v>
                </c:pt>
              </c:numCache>
            </c:numRef>
          </c:yVal>
          <c:smooth val="0"/>
          <c:extLst>
            <c:ext xmlns:c16="http://schemas.microsoft.com/office/drawing/2014/chart" uri="{C3380CC4-5D6E-409C-BE32-E72D297353CC}">
              <c16:uniqueId val="{00000000-28F2-42B9-85EF-14FE0D421E74}"/>
            </c:ext>
          </c:extLst>
        </c:ser>
        <c:ser>
          <c:idx val="1"/>
          <c:order val="1"/>
          <c:tx>
            <c:strRef>
              <c:f>'172 dn del and prion'!$E$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172 dn del and prion'!$C$2:$C$87</c:f>
              <c:numCache>
                <c:formatCode>General</c:formatCode>
                <c:ptCount val="86"/>
                <c:pt idx="0">
                  <c:v>22395</c:v>
                </c:pt>
                <c:pt idx="1">
                  <c:v>613330</c:v>
                </c:pt>
                <c:pt idx="2">
                  <c:v>688826</c:v>
                </c:pt>
                <c:pt idx="3">
                  <c:v>704610</c:v>
                </c:pt>
                <c:pt idx="4">
                  <c:v>816289</c:v>
                </c:pt>
                <c:pt idx="5">
                  <c:v>1004140</c:v>
                </c:pt>
                <c:pt idx="6">
                  <c:v>1439316</c:v>
                </c:pt>
                <c:pt idx="7">
                  <c:v>2080984</c:v>
                </c:pt>
                <c:pt idx="8">
                  <c:v>2144893</c:v>
                </c:pt>
                <c:pt idx="9">
                  <c:v>2439070</c:v>
                </c:pt>
                <c:pt idx="10">
                  <c:v>2639232</c:v>
                </c:pt>
                <c:pt idx="11">
                  <c:v>2761792</c:v>
                </c:pt>
                <c:pt idx="12">
                  <c:v>2953307</c:v>
                </c:pt>
                <c:pt idx="13">
                  <c:v>2977568</c:v>
                </c:pt>
                <c:pt idx="14">
                  <c:v>3040131</c:v>
                </c:pt>
                <c:pt idx="15">
                  <c:v>3270717</c:v>
                </c:pt>
                <c:pt idx="16">
                  <c:v>3375280</c:v>
                </c:pt>
                <c:pt idx="17">
                  <c:v>3480192</c:v>
                </c:pt>
                <c:pt idx="18">
                  <c:v>3578639</c:v>
                </c:pt>
                <c:pt idx="19">
                  <c:v>3692087</c:v>
                </c:pt>
                <c:pt idx="20">
                  <c:v>3748152</c:v>
                </c:pt>
                <c:pt idx="21">
                  <c:v>3887814</c:v>
                </c:pt>
                <c:pt idx="22">
                  <c:v>3966744</c:v>
                </c:pt>
                <c:pt idx="23">
                  <c:v>4247100</c:v>
                </c:pt>
                <c:pt idx="24">
                  <c:v>4375137</c:v>
                </c:pt>
                <c:pt idx="25">
                  <c:v>4379710</c:v>
                </c:pt>
                <c:pt idx="26">
                  <c:v>4724962</c:v>
                </c:pt>
                <c:pt idx="27">
                  <c:v>4843495</c:v>
                </c:pt>
                <c:pt idx="28">
                  <c:v>4969941</c:v>
                </c:pt>
                <c:pt idx="29">
                  <c:v>4997607</c:v>
                </c:pt>
                <c:pt idx="30">
                  <c:v>5023998</c:v>
                </c:pt>
                <c:pt idx="31">
                  <c:v>5036392</c:v>
                </c:pt>
                <c:pt idx="32">
                  <c:v>5040778</c:v>
                </c:pt>
                <c:pt idx="33">
                  <c:v>5144804</c:v>
                </c:pt>
                <c:pt idx="34">
                  <c:v>5164457</c:v>
                </c:pt>
                <c:pt idx="35">
                  <c:v>5280745</c:v>
                </c:pt>
                <c:pt idx="36">
                  <c:v>5372938</c:v>
                </c:pt>
                <c:pt idx="37">
                  <c:v>5461281</c:v>
                </c:pt>
                <c:pt idx="38">
                  <c:v>5640475</c:v>
                </c:pt>
                <c:pt idx="39">
                  <c:v>5651486</c:v>
                </c:pt>
                <c:pt idx="40">
                  <c:v>5829616</c:v>
                </c:pt>
                <c:pt idx="41">
                  <c:v>5864624</c:v>
                </c:pt>
                <c:pt idx="42">
                  <c:v>5908663</c:v>
                </c:pt>
                <c:pt idx="43">
                  <c:v>6418529</c:v>
                </c:pt>
                <c:pt idx="44">
                  <c:v>6600446</c:v>
                </c:pt>
                <c:pt idx="45">
                  <c:v>6722613</c:v>
                </c:pt>
                <c:pt idx="46">
                  <c:v>6867057</c:v>
                </c:pt>
                <c:pt idx="47">
                  <c:v>6883326</c:v>
                </c:pt>
                <c:pt idx="48">
                  <c:v>7032564</c:v>
                </c:pt>
                <c:pt idx="49">
                  <c:v>7041951</c:v>
                </c:pt>
                <c:pt idx="50">
                  <c:v>7157421</c:v>
                </c:pt>
                <c:pt idx="51">
                  <c:v>7231292</c:v>
                </c:pt>
                <c:pt idx="52">
                  <c:v>7443812</c:v>
                </c:pt>
                <c:pt idx="53">
                  <c:v>7449253</c:v>
                </c:pt>
                <c:pt idx="54">
                  <c:v>7508222</c:v>
                </c:pt>
                <c:pt idx="55">
                  <c:v>7918159</c:v>
                </c:pt>
                <c:pt idx="56">
                  <c:v>7965799</c:v>
                </c:pt>
                <c:pt idx="57">
                  <c:v>8101470</c:v>
                </c:pt>
                <c:pt idx="58">
                  <c:v>8273882</c:v>
                </c:pt>
                <c:pt idx="59">
                  <c:v>8546192</c:v>
                </c:pt>
                <c:pt idx="60">
                  <c:v>8834520</c:v>
                </c:pt>
                <c:pt idx="61">
                  <c:v>8934221</c:v>
                </c:pt>
                <c:pt idx="62">
                  <c:v>9009116</c:v>
                </c:pt>
                <c:pt idx="63">
                  <c:v>9076430</c:v>
                </c:pt>
                <c:pt idx="64">
                  <c:v>9239951</c:v>
                </c:pt>
                <c:pt idx="65">
                  <c:v>9243293</c:v>
                </c:pt>
                <c:pt idx="66">
                  <c:v>9364985</c:v>
                </c:pt>
                <c:pt idx="67">
                  <c:v>9434806</c:v>
                </c:pt>
                <c:pt idx="68">
                  <c:v>9499695</c:v>
                </c:pt>
                <c:pt idx="69">
                  <c:v>9600050</c:v>
                </c:pt>
                <c:pt idx="70">
                  <c:v>9666600</c:v>
                </c:pt>
                <c:pt idx="71">
                  <c:v>10008759</c:v>
                </c:pt>
                <c:pt idx="72">
                  <c:v>10018076</c:v>
                </c:pt>
                <c:pt idx="73">
                  <c:v>10217407</c:v>
                </c:pt>
                <c:pt idx="74">
                  <c:v>10320867</c:v>
                </c:pt>
                <c:pt idx="75">
                  <c:v>10343311</c:v>
                </c:pt>
                <c:pt idx="76">
                  <c:v>10474694</c:v>
                </c:pt>
                <c:pt idx="77">
                  <c:v>10603927</c:v>
                </c:pt>
                <c:pt idx="78">
                  <c:v>10669944</c:v>
                </c:pt>
                <c:pt idx="79">
                  <c:v>10710160</c:v>
                </c:pt>
                <c:pt idx="80">
                  <c:v>10810524</c:v>
                </c:pt>
                <c:pt idx="81">
                  <c:v>11162381</c:v>
                </c:pt>
                <c:pt idx="82">
                  <c:v>11347613</c:v>
                </c:pt>
                <c:pt idx="83">
                  <c:v>11593199</c:v>
                </c:pt>
                <c:pt idx="84">
                  <c:v>11984566</c:v>
                </c:pt>
                <c:pt idx="85">
                  <c:v>11644274</c:v>
                </c:pt>
              </c:numCache>
            </c:numRef>
          </c:xVal>
          <c:yVal>
            <c:numRef>
              <c:f>'172 dn del and prion'!$E$2:$E$87</c:f>
              <c:numCache>
                <c:formatCode>General</c:formatCode>
                <c:ptCount val="86"/>
                <c:pt idx="0">
                  <c:v>-4.8869245436374644</c:v>
                </c:pt>
                <c:pt idx="1">
                  <c:v>-4.5651117804394552</c:v>
                </c:pt>
                <c:pt idx="2">
                  <c:v>-5.0968093489975015</c:v>
                </c:pt>
                <c:pt idx="3">
                  <c:v>-1.022039468658257</c:v>
                </c:pt>
                <c:pt idx="4">
                  <c:v>-2.4217204724886585</c:v>
                </c:pt>
                <c:pt idx="5">
                  <c:v>-1.2673037820040363</c:v>
                </c:pt>
                <c:pt idx="6">
                  <c:v>-1.666822962354936</c:v>
                </c:pt>
                <c:pt idx="7">
                  <c:v>-1.1338454481792803</c:v>
                </c:pt>
                <c:pt idx="8">
                  <c:v>-3.4711352384393033</c:v>
                </c:pt>
                <c:pt idx="9">
                  <c:v>-3.1234291220878037</c:v>
                </c:pt>
                <c:pt idx="10">
                  <c:v>-2.9001366212699908</c:v>
                </c:pt>
                <c:pt idx="11">
                  <c:v>-1.434628084692261</c:v>
                </c:pt>
                <c:pt idx="12">
                  <c:v>-5.5011212662195241</c:v>
                </c:pt>
                <c:pt idx="13">
                  <c:v>-1.3203226022448198</c:v>
                </c:pt>
                <c:pt idx="14">
                  <c:v>-1.1521676270366559</c:v>
                </c:pt>
                <c:pt idx="15">
                  <c:v>-1.0780320622973252</c:v>
                </c:pt>
                <c:pt idx="16">
                  <c:v>-6.6852625463807076</c:v>
                </c:pt>
                <c:pt idx="17">
                  <c:v>-1.2979643479439771</c:v>
                </c:pt>
                <c:pt idx="18">
                  <c:v>-2.0842863788304311</c:v>
                </c:pt>
                <c:pt idx="19">
                  <c:v>-1.0844490984458399</c:v>
                </c:pt>
                <c:pt idx="20">
                  <c:v>-2.2056866829985236</c:v>
                </c:pt>
                <c:pt idx="21">
                  <c:v>-3.5500822285364984</c:v>
                </c:pt>
                <c:pt idx="22">
                  <c:v>-5.944498414665933</c:v>
                </c:pt>
                <c:pt idx="23">
                  <c:v>-1.5081633288928371</c:v>
                </c:pt>
                <c:pt idx="24">
                  <c:v>-1.897035212441762</c:v>
                </c:pt>
                <c:pt idx="25">
                  <c:v>-1.6095973498026626</c:v>
                </c:pt>
                <c:pt idx="26">
                  <c:v>-3.2852961122106614</c:v>
                </c:pt>
                <c:pt idx="27">
                  <c:v>-1.1701202834451141</c:v>
                </c:pt>
                <c:pt idx="28">
                  <c:v>-2.0742529958471279</c:v>
                </c:pt>
                <c:pt idx="29">
                  <c:v>-3.5007517317114427</c:v>
                </c:pt>
                <c:pt idx="30">
                  <c:v>-1.2173357126053255</c:v>
                </c:pt>
                <c:pt idx="31">
                  <c:v>-1.1853970896621111</c:v>
                </c:pt>
                <c:pt idx="32">
                  <c:v>-1.3548447647344934</c:v>
                </c:pt>
                <c:pt idx="33">
                  <c:v>-1.048662814116657</c:v>
                </c:pt>
                <c:pt idx="34">
                  <c:v>-1.426680744911345</c:v>
                </c:pt>
                <c:pt idx="35">
                  <c:v>-2.2922645083266899</c:v>
                </c:pt>
                <c:pt idx="36">
                  <c:v>-2.1596738850868475</c:v>
                </c:pt>
                <c:pt idx="37">
                  <c:v>-2.8278457622168389</c:v>
                </c:pt>
                <c:pt idx="38">
                  <c:v>-1.3391514362130812</c:v>
                </c:pt>
                <c:pt idx="39">
                  <c:v>-3.4489122908238965</c:v>
                </c:pt>
                <c:pt idx="40">
                  <c:v>-1.3150931061411621</c:v>
                </c:pt>
                <c:pt idx="41">
                  <c:v>-6.2215270345070612</c:v>
                </c:pt>
                <c:pt idx="42">
                  <c:v>-1.2416570266795846</c:v>
                </c:pt>
                <c:pt idx="43">
                  <c:v>-1.1789548816904794</c:v>
                </c:pt>
                <c:pt idx="44">
                  <c:v>-1.2680448089772034</c:v>
                </c:pt>
                <c:pt idx="45">
                  <c:v>-1.4330629808355659</c:v>
                </c:pt>
                <c:pt idx="46">
                  <c:v>-2.8460051258128054</c:v>
                </c:pt>
                <c:pt idx="47">
                  <c:v>-3.3965354589910777</c:v>
                </c:pt>
                <c:pt idx="48">
                  <c:v>-1.9218887318127207</c:v>
                </c:pt>
                <c:pt idx="49">
                  <c:v>-3.5591179543985954</c:v>
                </c:pt>
                <c:pt idx="50">
                  <c:v>-4.6175362049858268</c:v>
                </c:pt>
                <c:pt idx="51">
                  <c:v>-1.1236876020143711</c:v>
                </c:pt>
                <c:pt idx="52">
                  <c:v>-3.9583284488745276</c:v>
                </c:pt>
                <c:pt idx="53">
                  <c:v>-1.1097983215705221</c:v>
                </c:pt>
                <c:pt idx="54">
                  <c:v>-1.0590954451478416</c:v>
                </c:pt>
                <c:pt idx="55">
                  <c:v>-2.7871312238680619</c:v>
                </c:pt>
                <c:pt idx="56">
                  <c:v>-1.0265800578317361</c:v>
                </c:pt>
                <c:pt idx="57">
                  <c:v>-1.6096946788137658</c:v>
                </c:pt>
                <c:pt idx="58">
                  <c:v>-1.5081521303381831</c:v>
                </c:pt>
                <c:pt idx="59">
                  <c:v>-2.6310403394968338</c:v>
                </c:pt>
                <c:pt idx="60">
                  <c:v>-3.0374016395613848</c:v>
                </c:pt>
                <c:pt idx="61">
                  <c:v>-3.0352509851046783</c:v>
                </c:pt>
                <c:pt idx="62">
                  <c:v>-1.4129757610260585</c:v>
                </c:pt>
                <c:pt idx="63">
                  <c:v>-1.6126251829946889</c:v>
                </c:pt>
                <c:pt idx="64">
                  <c:v>-1.3729415478402418</c:v>
                </c:pt>
                <c:pt idx="65">
                  <c:v>-1.9114480500909492</c:v>
                </c:pt>
                <c:pt idx="66">
                  <c:v>-1.8498819155223793</c:v>
                </c:pt>
                <c:pt idx="67">
                  <c:v>-4.9243928419942016</c:v>
                </c:pt>
                <c:pt idx="68">
                  <c:v>-2.3244678197673001</c:v>
                </c:pt>
                <c:pt idx="69">
                  <c:v>-1.7278409738678975</c:v>
                </c:pt>
                <c:pt idx="70">
                  <c:v>-6.1785585026546945</c:v>
                </c:pt>
                <c:pt idx="71">
                  <c:v>-1.6279040857989022</c:v>
                </c:pt>
                <c:pt idx="72">
                  <c:v>-4.678372980415431</c:v>
                </c:pt>
                <c:pt idx="73">
                  <c:v>-2.1382630053738003</c:v>
                </c:pt>
                <c:pt idx="74">
                  <c:v>-1.1855228079177975</c:v>
                </c:pt>
                <c:pt idx="75">
                  <c:v>-2.3591392056232356</c:v>
                </c:pt>
                <c:pt idx="76">
                  <c:v>-1.6788954428812586</c:v>
                </c:pt>
                <c:pt idx="77">
                  <c:v>-1.4185592995643788</c:v>
                </c:pt>
                <c:pt idx="78">
                  <c:v>-2.5420151469421421</c:v>
                </c:pt>
                <c:pt idx="79">
                  <c:v>-2.8634652792355029</c:v>
                </c:pt>
                <c:pt idx="80">
                  <c:v>-1.0732411752029734</c:v>
                </c:pt>
                <c:pt idx="81">
                  <c:v>-2.2043260100764175</c:v>
                </c:pt>
                <c:pt idx="82">
                  <c:v>-3.6683778385254908</c:v>
                </c:pt>
                <c:pt idx="83">
                  <c:v>-1.3710733326961397</c:v>
                </c:pt>
                <c:pt idx="84">
                  <c:v>-2.8520421453541864</c:v>
                </c:pt>
                <c:pt idx="85">
                  <c:v>-1.4980785981921738</c:v>
                </c:pt>
              </c:numCache>
            </c:numRef>
          </c:yVal>
          <c:smooth val="0"/>
          <c:extLst>
            <c:ext xmlns:c16="http://schemas.microsoft.com/office/drawing/2014/chart" uri="{C3380CC4-5D6E-409C-BE32-E72D297353CC}">
              <c16:uniqueId val="{00000001-28F2-42B9-85EF-14FE0D421E74}"/>
            </c:ext>
          </c:extLst>
        </c:ser>
        <c:dLbls>
          <c:showLegendKey val="0"/>
          <c:showVal val="0"/>
          <c:showCatName val="0"/>
          <c:showSerName val="0"/>
          <c:showPercent val="0"/>
          <c:showBubbleSize val="0"/>
        </c:dLbls>
        <c:axId val="173146496"/>
        <c:axId val="173148032"/>
      </c:scatterChart>
      <c:valAx>
        <c:axId val="173146496"/>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148032"/>
        <c:crosses val="autoZero"/>
        <c:crossBetween val="midCat"/>
      </c:valAx>
      <c:valAx>
        <c:axId val="173148032"/>
        <c:scaling>
          <c:orientation val="minMax"/>
          <c:max val="0"/>
          <c:min val="-8"/>
        </c:scaling>
        <c:delete val="0"/>
        <c:axPos val="l"/>
        <c:numFmt formatCode="#,##0" sourceLinked="0"/>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3146496"/>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44 up prion and del'!$I$24</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round/>
              </a:ln>
              <a:effectLst/>
            </c:spPr>
          </c:errBars>
          <c:xVal>
            <c:numRef>
              <c:f>'44 up prion and del'!$H$25:$H$46</c:f>
              <c:numCache>
                <c:formatCode>General</c:formatCode>
                <c:ptCount val="22"/>
                <c:pt idx="0">
                  <c:v>673142</c:v>
                </c:pt>
                <c:pt idx="1">
                  <c:v>854711</c:v>
                </c:pt>
                <c:pt idx="2">
                  <c:v>1996139</c:v>
                </c:pt>
                <c:pt idx="3">
                  <c:v>2522979</c:v>
                </c:pt>
                <c:pt idx="4">
                  <c:v>3231819</c:v>
                </c:pt>
                <c:pt idx="5">
                  <c:v>4969941</c:v>
                </c:pt>
                <c:pt idx="6">
                  <c:v>5120843</c:v>
                </c:pt>
                <c:pt idx="7">
                  <c:v>5804609</c:v>
                </c:pt>
                <c:pt idx="8">
                  <c:v>6296912</c:v>
                </c:pt>
                <c:pt idx="9">
                  <c:v>6303599</c:v>
                </c:pt>
                <c:pt idx="10">
                  <c:v>6511418</c:v>
                </c:pt>
                <c:pt idx="11">
                  <c:v>6724134</c:v>
                </c:pt>
                <c:pt idx="12">
                  <c:v>7113859</c:v>
                </c:pt>
                <c:pt idx="13">
                  <c:v>7490615</c:v>
                </c:pt>
                <c:pt idx="14">
                  <c:v>8718259</c:v>
                </c:pt>
                <c:pt idx="15">
                  <c:v>8833906</c:v>
                </c:pt>
                <c:pt idx="16">
                  <c:v>10448316</c:v>
                </c:pt>
                <c:pt idx="17">
                  <c:v>10601898</c:v>
                </c:pt>
                <c:pt idx="18">
                  <c:v>10933827</c:v>
                </c:pt>
                <c:pt idx="19">
                  <c:v>11625733</c:v>
                </c:pt>
                <c:pt idx="20">
                  <c:v>11569102</c:v>
                </c:pt>
                <c:pt idx="21">
                  <c:v>11713543</c:v>
                </c:pt>
              </c:numCache>
            </c:numRef>
          </c:xVal>
          <c:yVal>
            <c:numRef>
              <c:f>'44 up prion and del'!$I$25:$I$46</c:f>
              <c:numCache>
                <c:formatCode>General</c:formatCode>
                <c:ptCount val="22"/>
                <c:pt idx="0">
                  <c:v>2.0209118895962197</c:v>
                </c:pt>
                <c:pt idx="1">
                  <c:v>1.0327670294060636</c:v>
                </c:pt>
                <c:pt idx="2">
                  <c:v>2.649440277631284</c:v>
                </c:pt>
                <c:pt idx="3">
                  <c:v>2.4231391436861709</c:v>
                </c:pt>
                <c:pt idx="4">
                  <c:v>1.1241716390018694</c:v>
                </c:pt>
                <c:pt idx="5">
                  <c:v>1.556345850604687</c:v>
                </c:pt>
                <c:pt idx="6">
                  <c:v>2.1324032084467945</c:v>
                </c:pt>
                <c:pt idx="7">
                  <c:v>2.4716900355934301</c:v>
                </c:pt>
                <c:pt idx="8">
                  <c:v>1.1215654817585352</c:v>
                </c:pt>
                <c:pt idx="9">
                  <c:v>1.0565772138226315</c:v>
                </c:pt>
                <c:pt idx="10">
                  <c:v>1.0635664551522674</c:v>
                </c:pt>
                <c:pt idx="11">
                  <c:v>1.8354831572634325</c:v>
                </c:pt>
                <c:pt idx="12">
                  <c:v>1.1174419232954094</c:v>
                </c:pt>
                <c:pt idx="13">
                  <c:v>1.4313377901100974</c:v>
                </c:pt>
                <c:pt idx="14">
                  <c:v>1.1863405353321528</c:v>
                </c:pt>
                <c:pt idx="15">
                  <c:v>1.7252321205450978</c:v>
                </c:pt>
                <c:pt idx="16">
                  <c:v>1.5267288768096916</c:v>
                </c:pt>
                <c:pt idx="17">
                  <c:v>1.3652890975650362</c:v>
                </c:pt>
                <c:pt idx="18">
                  <c:v>3.0422528779838403</c:v>
                </c:pt>
                <c:pt idx="19">
                  <c:v>2.6800295581786977</c:v>
                </c:pt>
                <c:pt idx="20">
                  <c:v>2.1626440975410111</c:v>
                </c:pt>
                <c:pt idx="21">
                  <c:v>2.1668594701257859</c:v>
                </c:pt>
              </c:numCache>
            </c:numRef>
          </c:yVal>
          <c:smooth val="0"/>
          <c:extLst>
            <c:ext xmlns:c16="http://schemas.microsoft.com/office/drawing/2014/chart" uri="{C3380CC4-5D6E-409C-BE32-E72D297353CC}">
              <c16:uniqueId val="{00000000-7037-424D-81CC-4AF094F83698}"/>
            </c:ext>
          </c:extLst>
        </c:ser>
        <c:ser>
          <c:idx val="1"/>
          <c:order val="1"/>
          <c:tx>
            <c:strRef>
              <c:f>'44 up prion and del'!$J$24</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C00000"/>
                </a:solidFill>
                <a:round/>
              </a:ln>
              <a:effectLst/>
            </c:spPr>
          </c:errBars>
          <c:xVal>
            <c:numRef>
              <c:f>'44 up prion and del'!$H$25:$H$46</c:f>
              <c:numCache>
                <c:formatCode>General</c:formatCode>
                <c:ptCount val="22"/>
                <c:pt idx="0">
                  <c:v>673142</c:v>
                </c:pt>
                <c:pt idx="1">
                  <c:v>854711</c:v>
                </c:pt>
                <c:pt idx="2">
                  <c:v>1996139</c:v>
                </c:pt>
                <c:pt idx="3">
                  <c:v>2522979</c:v>
                </c:pt>
                <c:pt idx="4">
                  <c:v>3231819</c:v>
                </c:pt>
                <c:pt idx="5">
                  <c:v>4969941</c:v>
                </c:pt>
                <c:pt idx="6">
                  <c:v>5120843</c:v>
                </c:pt>
                <c:pt idx="7">
                  <c:v>5804609</c:v>
                </c:pt>
                <c:pt idx="8">
                  <c:v>6296912</c:v>
                </c:pt>
                <c:pt idx="9">
                  <c:v>6303599</c:v>
                </c:pt>
                <c:pt idx="10">
                  <c:v>6511418</c:v>
                </c:pt>
                <c:pt idx="11">
                  <c:v>6724134</c:v>
                </c:pt>
                <c:pt idx="12">
                  <c:v>7113859</c:v>
                </c:pt>
                <c:pt idx="13">
                  <c:v>7490615</c:v>
                </c:pt>
                <c:pt idx="14">
                  <c:v>8718259</c:v>
                </c:pt>
                <c:pt idx="15">
                  <c:v>8833906</c:v>
                </c:pt>
                <c:pt idx="16">
                  <c:v>10448316</c:v>
                </c:pt>
                <c:pt idx="17">
                  <c:v>10601898</c:v>
                </c:pt>
                <c:pt idx="18">
                  <c:v>10933827</c:v>
                </c:pt>
                <c:pt idx="19">
                  <c:v>11625733</c:v>
                </c:pt>
                <c:pt idx="20">
                  <c:v>11569102</c:v>
                </c:pt>
                <c:pt idx="21">
                  <c:v>11713543</c:v>
                </c:pt>
              </c:numCache>
            </c:numRef>
          </c:xVal>
          <c:yVal>
            <c:numRef>
              <c:f>'44 up prion and del'!$J$25:$J$46</c:f>
              <c:numCache>
                <c:formatCode>General</c:formatCode>
                <c:ptCount val="22"/>
                <c:pt idx="0">
                  <c:v>3.4963664465808431</c:v>
                </c:pt>
                <c:pt idx="1">
                  <c:v>1.8550395342173958</c:v>
                </c:pt>
                <c:pt idx="2">
                  <c:v>2.0171917502746926</c:v>
                </c:pt>
                <c:pt idx="3">
                  <c:v>2.0091543070784921</c:v>
                </c:pt>
                <c:pt idx="4">
                  <c:v>1.5325835445922382</c:v>
                </c:pt>
                <c:pt idx="5">
                  <c:v>1.4299200603378073</c:v>
                </c:pt>
                <c:pt idx="6">
                  <c:v>2.4708635264364869</c:v>
                </c:pt>
                <c:pt idx="7">
                  <c:v>2.1147646497399255</c:v>
                </c:pt>
                <c:pt idx="8">
                  <c:v>1.0239857045635194</c:v>
                </c:pt>
                <c:pt idx="9">
                  <c:v>1.570263262159308</c:v>
                </c:pt>
                <c:pt idx="10">
                  <c:v>1.2623411009828833</c:v>
                </c:pt>
                <c:pt idx="11">
                  <c:v>2.9068038531138884</c:v>
                </c:pt>
                <c:pt idx="12">
                  <c:v>1.0438062696965327</c:v>
                </c:pt>
                <c:pt idx="13">
                  <c:v>1.3542227218199689</c:v>
                </c:pt>
                <c:pt idx="14">
                  <c:v>1.709088645999354</c:v>
                </c:pt>
                <c:pt idx="15">
                  <c:v>2.2654283541298308</c:v>
                </c:pt>
                <c:pt idx="16">
                  <c:v>1.9788508767645623</c:v>
                </c:pt>
                <c:pt idx="17">
                  <c:v>1.0282478711885892</c:v>
                </c:pt>
                <c:pt idx="18">
                  <c:v>3.0146630240524317</c:v>
                </c:pt>
                <c:pt idx="19">
                  <c:v>3.7929951839455325</c:v>
                </c:pt>
                <c:pt idx="20">
                  <c:v>1.0238215533912722</c:v>
                </c:pt>
                <c:pt idx="21">
                  <c:v>2.9368086718049176</c:v>
                </c:pt>
              </c:numCache>
            </c:numRef>
          </c:yVal>
          <c:smooth val="0"/>
          <c:extLst>
            <c:ext xmlns:c16="http://schemas.microsoft.com/office/drawing/2014/chart" uri="{C3380CC4-5D6E-409C-BE32-E72D297353CC}">
              <c16:uniqueId val="{00000001-7037-424D-81CC-4AF094F83698}"/>
            </c:ext>
          </c:extLst>
        </c:ser>
        <c:dLbls>
          <c:showLegendKey val="0"/>
          <c:showVal val="0"/>
          <c:showCatName val="0"/>
          <c:showSerName val="0"/>
          <c:showPercent val="0"/>
          <c:showBubbleSize val="0"/>
        </c:dLbls>
        <c:axId val="173184512"/>
        <c:axId val="173186048"/>
      </c:scatterChart>
      <c:valAx>
        <c:axId val="173184512"/>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186048"/>
        <c:crossesAt val="0"/>
        <c:crossBetween val="midCat"/>
      </c:valAx>
      <c:valAx>
        <c:axId val="173186048"/>
        <c:scaling>
          <c:orientation val="minMax"/>
          <c:max val="3"/>
          <c:min val="0"/>
        </c:scaling>
        <c:delete val="0"/>
        <c:axPos val="l"/>
        <c:numFmt formatCode="#,##0" sourceLinked="0"/>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318451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44 up prion and del'!$I$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44 up prion and del'!$H$2:$H$23</c:f>
              <c:numCache>
                <c:formatCode>General</c:formatCode>
                <c:ptCount val="22"/>
                <c:pt idx="0">
                  <c:v>74020</c:v>
                </c:pt>
                <c:pt idx="1">
                  <c:v>366216</c:v>
                </c:pt>
                <c:pt idx="2">
                  <c:v>1354360</c:v>
                </c:pt>
                <c:pt idx="3">
                  <c:v>1357292</c:v>
                </c:pt>
                <c:pt idx="4">
                  <c:v>2908310</c:v>
                </c:pt>
                <c:pt idx="5">
                  <c:v>3187365</c:v>
                </c:pt>
                <c:pt idx="6">
                  <c:v>3834848</c:v>
                </c:pt>
                <c:pt idx="7">
                  <c:v>5132691</c:v>
                </c:pt>
                <c:pt idx="8">
                  <c:v>5347462</c:v>
                </c:pt>
                <c:pt idx="9">
                  <c:v>6288700</c:v>
                </c:pt>
                <c:pt idx="10">
                  <c:v>6795556</c:v>
                </c:pt>
                <c:pt idx="11">
                  <c:v>7096410</c:v>
                </c:pt>
                <c:pt idx="12">
                  <c:v>7615819</c:v>
                </c:pt>
                <c:pt idx="13">
                  <c:v>8882404</c:v>
                </c:pt>
                <c:pt idx="14">
                  <c:v>9751360</c:v>
                </c:pt>
                <c:pt idx="15">
                  <c:v>9629116</c:v>
                </c:pt>
                <c:pt idx="16">
                  <c:v>9356103</c:v>
                </c:pt>
                <c:pt idx="17">
                  <c:v>10381648</c:v>
                </c:pt>
                <c:pt idx="18">
                  <c:v>10790299</c:v>
                </c:pt>
                <c:pt idx="19">
                  <c:v>10986313</c:v>
                </c:pt>
                <c:pt idx="20">
                  <c:v>11013797</c:v>
                </c:pt>
                <c:pt idx="21">
                  <c:v>11802211</c:v>
                </c:pt>
              </c:numCache>
            </c:numRef>
          </c:xVal>
          <c:yVal>
            <c:numRef>
              <c:f>'44 up prion and del'!$I$2:$I$23</c:f>
              <c:numCache>
                <c:formatCode>General</c:formatCode>
                <c:ptCount val="22"/>
                <c:pt idx="0">
                  <c:v>1.8275071955190834</c:v>
                </c:pt>
                <c:pt idx="1">
                  <c:v>2.3213877939685901</c:v>
                </c:pt>
                <c:pt idx="2">
                  <c:v>1.6397694857346417</c:v>
                </c:pt>
                <c:pt idx="3">
                  <c:v>1.3608039974414736</c:v>
                </c:pt>
                <c:pt idx="4">
                  <c:v>1.1485321732788614</c:v>
                </c:pt>
                <c:pt idx="5">
                  <c:v>1.1957214490409604</c:v>
                </c:pt>
                <c:pt idx="6">
                  <c:v>1.0478044075520341</c:v>
                </c:pt>
                <c:pt idx="7">
                  <c:v>1.121062664018444</c:v>
                </c:pt>
                <c:pt idx="8">
                  <c:v>1.1258406921007433</c:v>
                </c:pt>
                <c:pt idx="9">
                  <c:v>1.0390291633090707</c:v>
                </c:pt>
                <c:pt idx="10">
                  <c:v>1.8909797176214795</c:v>
                </c:pt>
                <c:pt idx="11">
                  <c:v>1.5158557916349156</c:v>
                </c:pt>
                <c:pt idx="12">
                  <c:v>1.1584152075718468</c:v>
                </c:pt>
                <c:pt idx="13">
                  <c:v>1.1655893322011368</c:v>
                </c:pt>
                <c:pt idx="14">
                  <c:v>1.20758526508737</c:v>
                </c:pt>
                <c:pt idx="15">
                  <c:v>2.2645836098539185</c:v>
                </c:pt>
                <c:pt idx="16">
                  <c:v>1.1518494025672628</c:v>
                </c:pt>
                <c:pt idx="17">
                  <c:v>1.0596647802196464</c:v>
                </c:pt>
                <c:pt idx="18">
                  <c:v>1.4032607401220365</c:v>
                </c:pt>
                <c:pt idx="19">
                  <c:v>1.4273692605527999</c:v>
                </c:pt>
                <c:pt idx="20">
                  <c:v>1.1790109507360613</c:v>
                </c:pt>
                <c:pt idx="21">
                  <c:v>1.9011689066275725</c:v>
                </c:pt>
              </c:numCache>
            </c:numRef>
          </c:yVal>
          <c:smooth val="0"/>
          <c:extLst>
            <c:ext xmlns:c16="http://schemas.microsoft.com/office/drawing/2014/chart" uri="{C3380CC4-5D6E-409C-BE32-E72D297353CC}">
              <c16:uniqueId val="{00000000-3FA6-4641-92C0-1D4D0025DD8F}"/>
            </c:ext>
          </c:extLst>
        </c:ser>
        <c:ser>
          <c:idx val="1"/>
          <c:order val="1"/>
          <c:tx>
            <c:strRef>
              <c:f>'44 up prion and del'!$J$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44 up prion and del'!$H$2:$H$23</c:f>
              <c:numCache>
                <c:formatCode>General</c:formatCode>
                <c:ptCount val="22"/>
                <c:pt idx="0">
                  <c:v>74020</c:v>
                </c:pt>
                <c:pt idx="1">
                  <c:v>366216</c:v>
                </c:pt>
                <c:pt idx="2">
                  <c:v>1354360</c:v>
                </c:pt>
                <c:pt idx="3">
                  <c:v>1357292</c:v>
                </c:pt>
                <c:pt idx="4">
                  <c:v>2908310</c:v>
                </c:pt>
                <c:pt idx="5">
                  <c:v>3187365</c:v>
                </c:pt>
                <c:pt idx="6">
                  <c:v>3834848</c:v>
                </c:pt>
                <c:pt idx="7">
                  <c:v>5132691</c:v>
                </c:pt>
                <c:pt idx="8">
                  <c:v>5347462</c:v>
                </c:pt>
                <c:pt idx="9">
                  <c:v>6288700</c:v>
                </c:pt>
                <c:pt idx="10">
                  <c:v>6795556</c:v>
                </c:pt>
                <c:pt idx="11">
                  <c:v>7096410</c:v>
                </c:pt>
                <c:pt idx="12">
                  <c:v>7615819</c:v>
                </c:pt>
                <c:pt idx="13">
                  <c:v>8882404</c:v>
                </c:pt>
                <c:pt idx="14">
                  <c:v>9751360</c:v>
                </c:pt>
                <c:pt idx="15">
                  <c:v>9629116</c:v>
                </c:pt>
                <c:pt idx="16">
                  <c:v>9356103</c:v>
                </c:pt>
                <c:pt idx="17">
                  <c:v>10381648</c:v>
                </c:pt>
                <c:pt idx="18">
                  <c:v>10790299</c:v>
                </c:pt>
                <c:pt idx="19">
                  <c:v>10986313</c:v>
                </c:pt>
                <c:pt idx="20">
                  <c:v>11013797</c:v>
                </c:pt>
                <c:pt idx="21">
                  <c:v>11802211</c:v>
                </c:pt>
              </c:numCache>
            </c:numRef>
          </c:xVal>
          <c:yVal>
            <c:numRef>
              <c:f>'44 up prion and del'!$J$2:$J$23</c:f>
              <c:numCache>
                <c:formatCode>General</c:formatCode>
                <c:ptCount val="22"/>
                <c:pt idx="0">
                  <c:v>1.1829537209103687</c:v>
                </c:pt>
                <c:pt idx="1">
                  <c:v>2.8252030685334391</c:v>
                </c:pt>
                <c:pt idx="2">
                  <c:v>2.1785201968178489</c:v>
                </c:pt>
                <c:pt idx="3">
                  <c:v>2.0358916885319411</c:v>
                </c:pt>
                <c:pt idx="4">
                  <c:v>1.5790114596881422</c:v>
                </c:pt>
                <c:pt idx="5">
                  <c:v>2.1099622955463007</c:v>
                </c:pt>
                <c:pt idx="6">
                  <c:v>1.9291181805386992</c:v>
                </c:pt>
                <c:pt idx="7">
                  <c:v>1.4195826376685372</c:v>
                </c:pt>
                <c:pt idx="8">
                  <c:v>1.4549293956171387</c:v>
                </c:pt>
                <c:pt idx="9">
                  <c:v>1.5366863887821447</c:v>
                </c:pt>
                <c:pt idx="10">
                  <c:v>2.8623910343949817</c:v>
                </c:pt>
                <c:pt idx="11">
                  <c:v>1.268483093128991</c:v>
                </c:pt>
                <c:pt idx="12">
                  <c:v>1.1487269585696194</c:v>
                </c:pt>
                <c:pt idx="13">
                  <c:v>1.0905802992655749</c:v>
                </c:pt>
                <c:pt idx="14">
                  <c:v>1.4272363269562327</c:v>
                </c:pt>
                <c:pt idx="15">
                  <c:v>1.3206298827176919</c:v>
                </c:pt>
                <c:pt idx="16">
                  <c:v>1.0534322299941128</c:v>
                </c:pt>
                <c:pt idx="17">
                  <c:v>1.2295664145145488</c:v>
                </c:pt>
                <c:pt idx="18">
                  <c:v>1.6519334947683231</c:v>
                </c:pt>
                <c:pt idx="19">
                  <c:v>1.2340535246584499</c:v>
                </c:pt>
                <c:pt idx="20">
                  <c:v>1.0846804131859054</c:v>
                </c:pt>
                <c:pt idx="21">
                  <c:v>3.0862354676016333</c:v>
                </c:pt>
              </c:numCache>
            </c:numRef>
          </c:yVal>
          <c:smooth val="0"/>
          <c:extLst>
            <c:ext xmlns:c16="http://schemas.microsoft.com/office/drawing/2014/chart" uri="{C3380CC4-5D6E-409C-BE32-E72D297353CC}">
              <c16:uniqueId val="{00000001-3FA6-4641-92C0-1D4D0025DD8F}"/>
            </c:ext>
          </c:extLst>
        </c:ser>
        <c:dLbls>
          <c:showLegendKey val="0"/>
          <c:showVal val="0"/>
          <c:showCatName val="0"/>
          <c:showSerName val="0"/>
          <c:showPercent val="0"/>
          <c:showBubbleSize val="0"/>
        </c:dLbls>
        <c:axId val="173229184"/>
        <c:axId val="173230720"/>
      </c:scatterChart>
      <c:valAx>
        <c:axId val="173229184"/>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3230720"/>
        <c:crosses val="autoZero"/>
        <c:crossBetween val="midCat"/>
      </c:valAx>
      <c:valAx>
        <c:axId val="173230720"/>
        <c:scaling>
          <c:orientation val="minMax"/>
          <c:max val="3"/>
          <c:min val="0"/>
        </c:scaling>
        <c:delete val="0"/>
        <c:axPos val="l"/>
        <c:numFmt formatCode="#,##0" sourceLinked="0"/>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3229184"/>
        <c:crosses val="autoZero"/>
        <c:crossBetween val="midCat"/>
        <c:majorUnit val="1"/>
        <c:minorUnit val="1"/>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783549191057817"/>
          <c:y val="5.1554930211888984E-2"/>
          <c:w val="0.78890845081710226"/>
          <c:h val="0.86639617964421112"/>
        </c:manualLayout>
      </c:layout>
      <c:barChart>
        <c:barDir val="col"/>
        <c:grouping val="clustered"/>
        <c:varyColors val="0"/>
        <c:ser>
          <c:idx val="0"/>
          <c:order val="0"/>
          <c:tx>
            <c:strRef>
              <c:f>Sheet1!$B$3</c:f>
              <c:strCache>
                <c:ptCount val="1"/>
                <c:pt idx="0">
                  <c:v>1.5</c:v>
                </c:pt>
              </c:strCache>
            </c:strRef>
          </c:tx>
          <c:spPr>
            <a:solidFill>
              <a:schemeClr val="accent1"/>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3:$I$3</c:f>
              <c:numCache>
                <c:formatCode>General</c:formatCode>
                <c:ptCount val="7"/>
              </c:numCache>
            </c:numRef>
          </c:val>
          <c:extLst>
            <c:ext xmlns:c16="http://schemas.microsoft.com/office/drawing/2014/chart" uri="{C3380CC4-5D6E-409C-BE32-E72D297353CC}">
              <c16:uniqueId val="{00000000-0E50-4C76-A176-B4AC6AEE43BA}"/>
            </c:ext>
          </c:extLst>
        </c:ser>
        <c:ser>
          <c:idx val="1"/>
          <c:order val="1"/>
          <c:tx>
            <c:strRef>
              <c:f>Sheet1!$B$4</c:f>
              <c:strCache>
                <c:ptCount val="1"/>
                <c:pt idx="0">
                  <c:v>1</c:v>
                </c:pt>
              </c:strCache>
            </c:strRef>
          </c:tx>
          <c:spPr>
            <a:solidFill>
              <a:schemeClr val="accent2"/>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4:$I$4</c:f>
              <c:numCache>
                <c:formatCode>General</c:formatCode>
                <c:ptCount val="7"/>
              </c:numCache>
            </c:numRef>
          </c:val>
          <c:extLst>
            <c:ext xmlns:c16="http://schemas.microsoft.com/office/drawing/2014/chart" uri="{C3380CC4-5D6E-409C-BE32-E72D297353CC}">
              <c16:uniqueId val="{00000001-0E50-4C76-A176-B4AC6AEE43BA}"/>
            </c:ext>
          </c:extLst>
        </c:ser>
        <c:ser>
          <c:idx val="2"/>
          <c:order val="2"/>
          <c:tx>
            <c:strRef>
              <c:f>Sheet1!$B$5</c:f>
              <c:strCache>
                <c:ptCount val="1"/>
                <c:pt idx="0">
                  <c:v>0.5</c:v>
                </c:pt>
              </c:strCache>
            </c:strRef>
          </c:tx>
          <c:spPr>
            <a:solidFill>
              <a:schemeClr val="accent3"/>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5:$I$5</c:f>
              <c:numCache>
                <c:formatCode>General</c:formatCode>
                <c:ptCount val="7"/>
              </c:numCache>
            </c:numRef>
          </c:val>
          <c:extLst>
            <c:ext xmlns:c16="http://schemas.microsoft.com/office/drawing/2014/chart" uri="{C3380CC4-5D6E-409C-BE32-E72D297353CC}">
              <c16:uniqueId val="{00000002-0E50-4C76-A176-B4AC6AEE43BA}"/>
            </c:ext>
          </c:extLst>
        </c:ser>
        <c:ser>
          <c:idx val="3"/>
          <c:order val="3"/>
          <c:tx>
            <c:strRef>
              <c:f>Sheet1!$B$6</c:f>
              <c:strCache>
                <c:ptCount val="1"/>
                <c:pt idx="0">
                  <c:v>0</c:v>
                </c:pt>
              </c:strCache>
            </c:strRef>
          </c:tx>
          <c:spPr>
            <a:solidFill>
              <a:schemeClr val="accent4"/>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6:$I$6</c:f>
              <c:numCache>
                <c:formatCode>General</c:formatCode>
                <c:ptCount val="7"/>
              </c:numCache>
            </c:numRef>
          </c:val>
          <c:extLst>
            <c:ext xmlns:c16="http://schemas.microsoft.com/office/drawing/2014/chart" uri="{C3380CC4-5D6E-409C-BE32-E72D297353CC}">
              <c16:uniqueId val="{00000003-0E50-4C76-A176-B4AC6AEE43BA}"/>
            </c:ext>
          </c:extLst>
        </c:ser>
        <c:ser>
          <c:idx val="4"/>
          <c:order val="4"/>
          <c:tx>
            <c:strRef>
              <c:f>Sheet1!$B$7</c:f>
              <c:strCache>
                <c:ptCount val="1"/>
                <c:pt idx="0">
                  <c:v>-0.5</c:v>
                </c:pt>
              </c:strCache>
            </c:strRef>
          </c:tx>
          <c:spPr>
            <a:solidFill>
              <a:schemeClr val="accent5"/>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7:$I$7</c:f>
              <c:numCache>
                <c:formatCode>General</c:formatCode>
                <c:ptCount val="7"/>
              </c:numCache>
            </c:numRef>
          </c:val>
          <c:extLst>
            <c:ext xmlns:c16="http://schemas.microsoft.com/office/drawing/2014/chart" uri="{C3380CC4-5D6E-409C-BE32-E72D297353CC}">
              <c16:uniqueId val="{00000004-0E50-4C76-A176-B4AC6AEE43BA}"/>
            </c:ext>
          </c:extLst>
        </c:ser>
        <c:ser>
          <c:idx val="5"/>
          <c:order val="5"/>
          <c:tx>
            <c:strRef>
              <c:f>Sheet1!$B$8</c:f>
              <c:strCache>
                <c:ptCount val="1"/>
                <c:pt idx="0">
                  <c:v>-1</c:v>
                </c:pt>
              </c:strCache>
            </c:strRef>
          </c:tx>
          <c:spPr>
            <a:solidFill>
              <a:schemeClr val="accent6"/>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8:$I$8</c:f>
              <c:numCache>
                <c:formatCode>General</c:formatCode>
                <c:ptCount val="7"/>
              </c:numCache>
            </c:numRef>
          </c:val>
          <c:extLst>
            <c:ext xmlns:c16="http://schemas.microsoft.com/office/drawing/2014/chart" uri="{C3380CC4-5D6E-409C-BE32-E72D297353CC}">
              <c16:uniqueId val="{00000005-0E50-4C76-A176-B4AC6AEE43BA}"/>
            </c:ext>
          </c:extLst>
        </c:ser>
        <c:ser>
          <c:idx val="6"/>
          <c:order val="6"/>
          <c:tx>
            <c:strRef>
              <c:f>Sheet1!$B$9</c:f>
              <c:strCache>
                <c:ptCount val="1"/>
                <c:pt idx="0">
                  <c:v>-1.5</c:v>
                </c:pt>
              </c:strCache>
            </c:strRef>
          </c:tx>
          <c:spPr>
            <a:solidFill>
              <a:schemeClr val="accent1">
                <a:lumMod val="60000"/>
              </a:schemeClr>
            </a:solidFill>
            <a:ln>
              <a:noFill/>
            </a:ln>
            <a:effectLst/>
          </c:spPr>
          <c:invertIfNegative val="0"/>
          <c:cat>
            <c:numRef>
              <c:f>Sheet1!$C$2:$I$2</c:f>
              <c:numCache>
                <c:formatCode>General</c:formatCode>
                <c:ptCount val="7"/>
                <c:pt idx="0">
                  <c:v>-1.5</c:v>
                </c:pt>
                <c:pt idx="1">
                  <c:v>-1</c:v>
                </c:pt>
                <c:pt idx="2">
                  <c:v>-0.5</c:v>
                </c:pt>
                <c:pt idx="3">
                  <c:v>0</c:v>
                </c:pt>
                <c:pt idx="4">
                  <c:v>0.5</c:v>
                </c:pt>
                <c:pt idx="5">
                  <c:v>1</c:v>
                </c:pt>
                <c:pt idx="6">
                  <c:v>1.5</c:v>
                </c:pt>
              </c:numCache>
            </c:numRef>
          </c:cat>
          <c:val>
            <c:numRef>
              <c:f>Sheet1!$C$9:$I$9</c:f>
              <c:numCache>
                <c:formatCode>General</c:formatCode>
                <c:ptCount val="7"/>
              </c:numCache>
            </c:numRef>
          </c:val>
          <c:extLst>
            <c:ext xmlns:c16="http://schemas.microsoft.com/office/drawing/2014/chart" uri="{C3380CC4-5D6E-409C-BE32-E72D297353CC}">
              <c16:uniqueId val="{00000006-0E50-4C76-A176-B4AC6AEE43BA}"/>
            </c:ext>
          </c:extLst>
        </c:ser>
        <c:dLbls>
          <c:showLegendKey val="0"/>
          <c:showVal val="0"/>
          <c:showCatName val="0"/>
          <c:showSerName val="0"/>
          <c:showPercent val="0"/>
          <c:showBubbleSize val="0"/>
        </c:dLbls>
        <c:gapWidth val="219"/>
        <c:overlap val="-27"/>
        <c:axId val="540706264"/>
        <c:axId val="540706592"/>
      </c:barChart>
      <c:catAx>
        <c:axId val="540706264"/>
        <c:scaling>
          <c:orientation val="minMax"/>
        </c:scaling>
        <c:delete val="0"/>
        <c:axPos val="b"/>
        <c:numFmt formatCode="#,##0.0" sourceLinked="0"/>
        <c:majorTickMark val="out"/>
        <c:minorTickMark val="none"/>
        <c:tickLblPos val="low"/>
        <c:spPr>
          <a:noFill/>
          <a:ln w="9525" cap="flat" cmpd="sng" algn="ctr">
            <a:solidFill>
              <a:schemeClr val="tx1">
                <a:lumMod val="95000"/>
                <a:lumOff val="5000"/>
              </a:schemeClr>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40706592"/>
        <c:crossesAt val="-1.5"/>
        <c:auto val="0"/>
        <c:lblAlgn val="ctr"/>
        <c:lblOffset val="100"/>
        <c:noMultiLvlLbl val="0"/>
      </c:catAx>
      <c:valAx>
        <c:axId val="540706592"/>
        <c:scaling>
          <c:orientation val="minMax"/>
          <c:max val="1.5"/>
          <c:min val="-1.5"/>
        </c:scaling>
        <c:delete val="0"/>
        <c:axPos val="l"/>
        <c:numFmt formatCode="#,##0.0" sourceLinked="0"/>
        <c:majorTickMark val="out"/>
        <c:minorTickMark val="none"/>
        <c:tickLblPos val="nextTo"/>
        <c:spPr>
          <a:noFill/>
          <a:ln>
            <a:solidFill>
              <a:schemeClr val="tx1">
                <a:lumMod val="95000"/>
                <a:lumOff val="5000"/>
              </a:schemeClr>
            </a:solidFill>
          </a:ln>
          <a:effectLst/>
        </c:spPr>
        <c:txPr>
          <a:bodyPr rot="-60000000" spcFirstLastPara="1" vertOverflow="ellipsis" vert="horz" wrap="square" anchor="ctr" anchorCtr="1"/>
          <a:lstStyle/>
          <a:p>
            <a:pPr>
              <a:defRPr sz="11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40706264"/>
        <c:crossesAt val="1"/>
        <c:crossBetween val="midCat"/>
        <c:majorUnit val="0.5"/>
        <c:minorUnit val="0.5"/>
      </c:valAx>
      <c:spPr>
        <a:noFill/>
        <a:ln>
          <a:solidFill>
            <a:schemeClr val="tx1"/>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1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2 up prion dn del'!$G$17</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round/>
              </a:ln>
              <a:effectLst/>
            </c:spPr>
          </c:errBars>
          <c:xVal>
            <c:numRef>
              <c:f>'32 up prion dn del'!$F$18:$F$34</c:f>
              <c:numCache>
                <c:formatCode>General</c:formatCode>
                <c:ptCount val="17"/>
                <c:pt idx="0">
                  <c:v>2104333</c:v>
                </c:pt>
                <c:pt idx="1">
                  <c:v>2474455</c:v>
                </c:pt>
                <c:pt idx="2">
                  <c:v>2717602</c:v>
                </c:pt>
                <c:pt idx="3">
                  <c:v>3158467</c:v>
                </c:pt>
                <c:pt idx="4">
                  <c:v>4020624</c:v>
                </c:pt>
                <c:pt idx="5">
                  <c:v>5603496</c:v>
                </c:pt>
                <c:pt idx="6">
                  <c:v>6246746</c:v>
                </c:pt>
                <c:pt idx="7">
                  <c:v>6143383</c:v>
                </c:pt>
                <c:pt idx="8">
                  <c:v>6123797</c:v>
                </c:pt>
                <c:pt idx="9">
                  <c:v>5872655</c:v>
                </c:pt>
                <c:pt idx="10">
                  <c:v>6485353</c:v>
                </c:pt>
                <c:pt idx="11">
                  <c:v>7315661</c:v>
                </c:pt>
                <c:pt idx="12">
                  <c:v>8513449</c:v>
                </c:pt>
                <c:pt idx="13">
                  <c:v>9428997</c:v>
                </c:pt>
                <c:pt idx="14">
                  <c:v>9968756</c:v>
                </c:pt>
                <c:pt idx="15">
                  <c:v>10003382</c:v>
                </c:pt>
                <c:pt idx="16">
                  <c:v>10060672</c:v>
                </c:pt>
              </c:numCache>
            </c:numRef>
          </c:xVal>
          <c:yVal>
            <c:numRef>
              <c:f>'32 up prion dn del'!$G$18:$G$34</c:f>
              <c:numCache>
                <c:formatCode>General</c:formatCode>
                <c:ptCount val="17"/>
                <c:pt idx="0">
                  <c:v>1.6690426762511454</c:v>
                </c:pt>
                <c:pt idx="1">
                  <c:v>1.4219775154487149</c:v>
                </c:pt>
                <c:pt idx="2">
                  <c:v>1.0928337740133898</c:v>
                </c:pt>
                <c:pt idx="3">
                  <c:v>1.0021236607755852</c:v>
                </c:pt>
                <c:pt idx="4">
                  <c:v>1.1046607849804588</c:v>
                </c:pt>
                <c:pt idx="5">
                  <c:v>1.2561132913566411</c:v>
                </c:pt>
                <c:pt idx="6">
                  <c:v>1.7728279151006991</c:v>
                </c:pt>
                <c:pt idx="7">
                  <c:v>1.2221567581000281</c:v>
                </c:pt>
                <c:pt idx="8">
                  <c:v>1.0123962586127768</c:v>
                </c:pt>
                <c:pt idx="9">
                  <c:v>1.0587131690864022</c:v>
                </c:pt>
                <c:pt idx="10">
                  <c:v>1.075944728793266</c:v>
                </c:pt>
                <c:pt idx="11">
                  <c:v>1.7272424513752627</c:v>
                </c:pt>
                <c:pt idx="12">
                  <c:v>1.2172901875676592</c:v>
                </c:pt>
                <c:pt idx="13">
                  <c:v>0.98426308225470738</c:v>
                </c:pt>
                <c:pt idx="14">
                  <c:v>1.0332742252400828</c:v>
                </c:pt>
                <c:pt idx="15">
                  <c:v>1.7641619107222488</c:v>
                </c:pt>
                <c:pt idx="16">
                  <c:v>1.5392125592477732</c:v>
                </c:pt>
              </c:numCache>
            </c:numRef>
          </c:yVal>
          <c:smooth val="0"/>
          <c:extLst>
            <c:ext xmlns:c16="http://schemas.microsoft.com/office/drawing/2014/chart" uri="{C3380CC4-5D6E-409C-BE32-E72D297353CC}">
              <c16:uniqueId val="{00000000-1C5D-46B1-8709-C130084DBC3C}"/>
            </c:ext>
          </c:extLst>
        </c:ser>
        <c:ser>
          <c:idx val="1"/>
          <c:order val="1"/>
          <c:tx>
            <c:strRef>
              <c:f>'32 up prion dn del'!$H$17</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C00000"/>
                </a:solidFill>
                <a:round/>
              </a:ln>
              <a:effectLst/>
            </c:spPr>
          </c:errBars>
          <c:xVal>
            <c:numRef>
              <c:f>'32 up prion dn del'!$F$18:$F$34</c:f>
              <c:numCache>
                <c:formatCode>General</c:formatCode>
                <c:ptCount val="17"/>
                <c:pt idx="0">
                  <c:v>2104333</c:v>
                </c:pt>
                <c:pt idx="1">
                  <c:v>2474455</c:v>
                </c:pt>
                <c:pt idx="2">
                  <c:v>2717602</c:v>
                </c:pt>
                <c:pt idx="3">
                  <c:v>3158467</c:v>
                </c:pt>
                <c:pt idx="4">
                  <c:v>4020624</c:v>
                </c:pt>
                <c:pt idx="5">
                  <c:v>5603496</c:v>
                </c:pt>
                <c:pt idx="6">
                  <c:v>6246746</c:v>
                </c:pt>
                <c:pt idx="7">
                  <c:v>6143383</c:v>
                </c:pt>
                <c:pt idx="8">
                  <c:v>6123797</c:v>
                </c:pt>
                <c:pt idx="9">
                  <c:v>5872655</c:v>
                </c:pt>
                <c:pt idx="10">
                  <c:v>6485353</c:v>
                </c:pt>
                <c:pt idx="11">
                  <c:v>7315661</c:v>
                </c:pt>
                <c:pt idx="12">
                  <c:v>8513449</c:v>
                </c:pt>
                <c:pt idx="13">
                  <c:v>9428997</c:v>
                </c:pt>
                <c:pt idx="14">
                  <c:v>9968756</c:v>
                </c:pt>
                <c:pt idx="15">
                  <c:v>10003382</c:v>
                </c:pt>
                <c:pt idx="16">
                  <c:v>10060672</c:v>
                </c:pt>
              </c:numCache>
            </c:numRef>
          </c:xVal>
          <c:yVal>
            <c:numRef>
              <c:f>'32 up prion dn del'!$H$18:$H$34</c:f>
              <c:numCache>
                <c:formatCode>General</c:formatCode>
                <c:ptCount val="17"/>
                <c:pt idx="0">
                  <c:v>-1.2875060523959043</c:v>
                </c:pt>
                <c:pt idx="1">
                  <c:v>-1.1458648971242793</c:v>
                </c:pt>
                <c:pt idx="2">
                  <c:v>-1.1479686234548998</c:v>
                </c:pt>
                <c:pt idx="3">
                  <c:v>-1.8542714817994792</c:v>
                </c:pt>
                <c:pt idx="4">
                  <c:v>-1.4122723869143654</c:v>
                </c:pt>
                <c:pt idx="5">
                  <c:v>-1.6942720846278583</c:v>
                </c:pt>
                <c:pt idx="6">
                  <c:v>-2.3527041630524557</c:v>
                </c:pt>
                <c:pt idx="7">
                  <c:v>-1.2535198210964553</c:v>
                </c:pt>
                <c:pt idx="8">
                  <c:v>-2.7303995663783001</c:v>
                </c:pt>
                <c:pt idx="9">
                  <c:v>-0.99429051946315106</c:v>
                </c:pt>
                <c:pt idx="10">
                  <c:v>-1.3181599199295317</c:v>
                </c:pt>
                <c:pt idx="11">
                  <c:v>-1.0078982520912219</c:v>
                </c:pt>
                <c:pt idx="12">
                  <c:v>-1.2955503800618802</c:v>
                </c:pt>
                <c:pt idx="13">
                  <c:v>-1.5697622919025505</c:v>
                </c:pt>
                <c:pt idx="14">
                  <c:v>-1.4553539004524034</c:v>
                </c:pt>
                <c:pt idx="15">
                  <c:v>-3.4012096816066402</c:v>
                </c:pt>
                <c:pt idx="16">
                  <c:v>-3.286937765749895</c:v>
                </c:pt>
              </c:numCache>
            </c:numRef>
          </c:yVal>
          <c:smooth val="0"/>
          <c:extLst>
            <c:ext xmlns:c16="http://schemas.microsoft.com/office/drawing/2014/chart" uri="{C3380CC4-5D6E-409C-BE32-E72D297353CC}">
              <c16:uniqueId val="{00000001-1C5D-46B1-8709-C130084DBC3C}"/>
            </c:ext>
          </c:extLst>
        </c:ser>
        <c:dLbls>
          <c:showLegendKey val="0"/>
          <c:showVal val="0"/>
          <c:showCatName val="0"/>
          <c:showSerName val="0"/>
          <c:showPercent val="0"/>
          <c:showBubbleSize val="0"/>
        </c:dLbls>
        <c:axId val="170961152"/>
        <c:axId val="170967040"/>
      </c:scatterChart>
      <c:valAx>
        <c:axId val="170961152"/>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0967040"/>
        <c:crosses val="autoZero"/>
        <c:crossBetween val="midCat"/>
      </c:valAx>
      <c:valAx>
        <c:axId val="170967040"/>
        <c:scaling>
          <c:orientation val="minMax"/>
          <c:max val="2"/>
          <c:min val="-3"/>
        </c:scaling>
        <c:delete val="0"/>
        <c:axPos val="l"/>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noFill/>
                <a:latin typeface="+mn-lt"/>
                <a:ea typeface="+mn-ea"/>
                <a:cs typeface="+mn-cs"/>
              </a:defRPr>
            </a:pPr>
            <a:endParaRPr lang="en-US"/>
          </a:p>
        </c:txPr>
        <c:crossAx val="17096115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2 up prion dn del'!$G$1</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prstDash val="dash"/>
                <a:round/>
              </a:ln>
              <a:effectLst/>
            </c:spPr>
          </c:errBars>
          <c:xVal>
            <c:numRef>
              <c:f>'32 up prion dn del'!$F$2:$F$16</c:f>
              <c:numCache>
                <c:formatCode>General</c:formatCode>
                <c:ptCount val="15"/>
                <c:pt idx="0">
                  <c:v>573319</c:v>
                </c:pt>
                <c:pt idx="1">
                  <c:v>646201</c:v>
                </c:pt>
                <c:pt idx="2">
                  <c:v>1074851</c:v>
                </c:pt>
                <c:pt idx="3">
                  <c:v>1868169</c:v>
                </c:pt>
                <c:pt idx="4">
                  <c:v>2970008</c:v>
                </c:pt>
                <c:pt idx="5">
                  <c:v>4179053</c:v>
                </c:pt>
                <c:pt idx="6">
                  <c:v>4316477</c:v>
                </c:pt>
                <c:pt idx="7">
                  <c:v>6387656</c:v>
                </c:pt>
                <c:pt idx="8">
                  <c:v>7918159</c:v>
                </c:pt>
                <c:pt idx="9">
                  <c:v>8112382</c:v>
                </c:pt>
                <c:pt idx="10">
                  <c:v>9660407</c:v>
                </c:pt>
                <c:pt idx="11">
                  <c:v>9622957</c:v>
                </c:pt>
                <c:pt idx="12">
                  <c:v>11652983</c:v>
                </c:pt>
                <c:pt idx="13">
                  <c:v>11644274</c:v>
                </c:pt>
                <c:pt idx="14">
                  <c:v>11245027</c:v>
                </c:pt>
              </c:numCache>
            </c:numRef>
          </c:xVal>
          <c:yVal>
            <c:numRef>
              <c:f>'32 up prion dn del'!$G$2:$G$16</c:f>
              <c:numCache>
                <c:formatCode>General</c:formatCode>
                <c:ptCount val="15"/>
                <c:pt idx="0">
                  <c:v>1.2208159260261662</c:v>
                </c:pt>
                <c:pt idx="1">
                  <c:v>1.8991275391855371</c:v>
                </c:pt>
                <c:pt idx="2">
                  <c:v>1.3997452112997528</c:v>
                </c:pt>
                <c:pt idx="3">
                  <c:v>1.4526429804618493</c:v>
                </c:pt>
                <c:pt idx="4">
                  <c:v>1.4819755711164491</c:v>
                </c:pt>
                <c:pt idx="5">
                  <c:v>1.861537238589678</c:v>
                </c:pt>
                <c:pt idx="6">
                  <c:v>0.97236361601480703</c:v>
                </c:pt>
                <c:pt idx="7">
                  <c:v>1.2175835729356865</c:v>
                </c:pt>
                <c:pt idx="8">
                  <c:v>1.8627759681882758</c:v>
                </c:pt>
                <c:pt idx="9">
                  <c:v>1.1170531311759346</c:v>
                </c:pt>
                <c:pt idx="10">
                  <c:v>1.2959043941158941</c:v>
                </c:pt>
                <c:pt idx="11">
                  <c:v>1.1884993745364902</c:v>
                </c:pt>
                <c:pt idx="12">
                  <c:v>1.1568592685979222</c:v>
                </c:pt>
                <c:pt idx="13">
                  <c:v>1.2060141932769015</c:v>
                </c:pt>
                <c:pt idx="14">
                  <c:v>1.4435357421380539</c:v>
                </c:pt>
              </c:numCache>
            </c:numRef>
          </c:yVal>
          <c:smooth val="0"/>
          <c:extLst>
            <c:ext xmlns:c16="http://schemas.microsoft.com/office/drawing/2014/chart" uri="{C3380CC4-5D6E-409C-BE32-E72D297353CC}">
              <c16:uniqueId val="{00000000-E7C8-4361-9068-B3C53331F89C}"/>
            </c:ext>
          </c:extLst>
        </c:ser>
        <c:ser>
          <c:idx val="1"/>
          <c:order val="1"/>
          <c:tx>
            <c:strRef>
              <c:f>'32 up prion dn del'!$H$1</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FF0000"/>
                </a:solidFill>
                <a:prstDash val="dash"/>
                <a:round/>
              </a:ln>
              <a:effectLst/>
            </c:spPr>
          </c:errBars>
          <c:xVal>
            <c:numRef>
              <c:f>'32 up prion dn del'!$F$2:$F$16</c:f>
              <c:numCache>
                <c:formatCode>General</c:formatCode>
                <c:ptCount val="15"/>
                <c:pt idx="0">
                  <c:v>573319</c:v>
                </c:pt>
                <c:pt idx="1">
                  <c:v>646201</c:v>
                </c:pt>
                <c:pt idx="2">
                  <c:v>1074851</c:v>
                </c:pt>
                <c:pt idx="3">
                  <c:v>1868169</c:v>
                </c:pt>
                <c:pt idx="4">
                  <c:v>2970008</c:v>
                </c:pt>
                <c:pt idx="5">
                  <c:v>4179053</c:v>
                </c:pt>
                <c:pt idx="6">
                  <c:v>4316477</c:v>
                </c:pt>
                <c:pt idx="7">
                  <c:v>6387656</c:v>
                </c:pt>
                <c:pt idx="8">
                  <c:v>7918159</c:v>
                </c:pt>
                <c:pt idx="9">
                  <c:v>8112382</c:v>
                </c:pt>
                <c:pt idx="10">
                  <c:v>9660407</c:v>
                </c:pt>
                <c:pt idx="11">
                  <c:v>9622957</c:v>
                </c:pt>
                <c:pt idx="12">
                  <c:v>11652983</c:v>
                </c:pt>
                <c:pt idx="13">
                  <c:v>11644274</c:v>
                </c:pt>
                <c:pt idx="14">
                  <c:v>11245027</c:v>
                </c:pt>
              </c:numCache>
            </c:numRef>
          </c:xVal>
          <c:yVal>
            <c:numRef>
              <c:f>'32 up prion dn del'!$H$2:$H$16</c:f>
              <c:numCache>
                <c:formatCode>General</c:formatCode>
                <c:ptCount val="15"/>
                <c:pt idx="0">
                  <c:v>-3.1512698900170455</c:v>
                </c:pt>
                <c:pt idx="1">
                  <c:v>-1.5297517906716247</c:v>
                </c:pt>
                <c:pt idx="2">
                  <c:v>-1.426619971995595</c:v>
                </c:pt>
                <c:pt idx="3">
                  <c:v>-2.6228007762059868</c:v>
                </c:pt>
                <c:pt idx="4">
                  <c:v>-2.4469557908067796</c:v>
                </c:pt>
                <c:pt idx="5">
                  <c:v>-2.0291602779348192</c:v>
                </c:pt>
                <c:pt idx="6">
                  <c:v>-1.1700178409245066</c:v>
                </c:pt>
                <c:pt idx="7">
                  <c:v>-1.7676415480022876</c:v>
                </c:pt>
                <c:pt idx="8">
                  <c:v>-2.1930982685101195</c:v>
                </c:pt>
                <c:pt idx="9">
                  <c:v>-1.3399145494061764</c:v>
                </c:pt>
                <c:pt idx="10">
                  <c:v>-1.0860316199196702</c:v>
                </c:pt>
                <c:pt idx="11">
                  <c:v>-1.189177928663997</c:v>
                </c:pt>
                <c:pt idx="12">
                  <c:v>-1.3569861238591765</c:v>
                </c:pt>
                <c:pt idx="13">
                  <c:v>-7.5338587856870065</c:v>
                </c:pt>
                <c:pt idx="14">
                  <c:v>-1.306991814959156</c:v>
                </c:pt>
              </c:numCache>
            </c:numRef>
          </c:yVal>
          <c:smooth val="0"/>
          <c:extLst>
            <c:ext xmlns:c16="http://schemas.microsoft.com/office/drawing/2014/chart" uri="{C3380CC4-5D6E-409C-BE32-E72D297353CC}">
              <c16:uniqueId val="{00000001-E7C8-4361-9068-B3C53331F89C}"/>
            </c:ext>
          </c:extLst>
        </c:ser>
        <c:dLbls>
          <c:showLegendKey val="0"/>
          <c:showVal val="0"/>
          <c:showCatName val="0"/>
          <c:showSerName val="0"/>
          <c:showPercent val="0"/>
          <c:showBubbleSize val="0"/>
        </c:dLbls>
        <c:axId val="171657472"/>
        <c:axId val="171667456"/>
      </c:scatterChart>
      <c:valAx>
        <c:axId val="171657472"/>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667456"/>
        <c:crosses val="autoZero"/>
        <c:crossBetween val="midCat"/>
      </c:valAx>
      <c:valAx>
        <c:axId val="171667456"/>
        <c:scaling>
          <c:orientation val="minMax"/>
          <c:max val="2"/>
          <c:min val="-3"/>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165747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15 dn prion up del'!$H$10</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round/>
              </a:ln>
              <a:effectLst/>
            </c:spPr>
          </c:errBars>
          <c:xVal>
            <c:numRef>
              <c:f>'15 dn prion up del'!$G$11:$G$17</c:f>
              <c:numCache>
                <c:formatCode>General</c:formatCode>
                <c:ptCount val="7"/>
                <c:pt idx="0">
                  <c:v>1032849</c:v>
                </c:pt>
                <c:pt idx="1">
                  <c:v>2936975</c:v>
                </c:pt>
                <c:pt idx="2">
                  <c:v>5933611</c:v>
                </c:pt>
                <c:pt idx="3">
                  <c:v>7032564</c:v>
                </c:pt>
                <c:pt idx="4">
                  <c:v>7158039</c:v>
                </c:pt>
                <c:pt idx="5">
                  <c:v>8710520</c:v>
                </c:pt>
                <c:pt idx="6">
                  <c:v>11459213</c:v>
                </c:pt>
              </c:numCache>
            </c:numRef>
          </c:xVal>
          <c:yVal>
            <c:numRef>
              <c:f>'15 dn prion up del'!$H$11:$H$17</c:f>
              <c:numCache>
                <c:formatCode>General</c:formatCode>
                <c:ptCount val="7"/>
                <c:pt idx="0">
                  <c:v>-1.1533564455072105</c:v>
                </c:pt>
                <c:pt idx="1">
                  <c:v>-1.8608397474095684</c:v>
                </c:pt>
                <c:pt idx="2">
                  <c:v>-2.1004275934838414</c:v>
                </c:pt>
                <c:pt idx="3">
                  <c:v>-1.1762766670881402</c:v>
                </c:pt>
                <c:pt idx="4">
                  <c:v>-1.1014352773920104</c:v>
                </c:pt>
                <c:pt idx="5">
                  <c:v>-1.428526433081279</c:v>
                </c:pt>
                <c:pt idx="6">
                  <c:v>-2.0370719171657057</c:v>
                </c:pt>
              </c:numCache>
            </c:numRef>
          </c:yVal>
          <c:smooth val="0"/>
          <c:extLst>
            <c:ext xmlns:c16="http://schemas.microsoft.com/office/drawing/2014/chart" uri="{C3380CC4-5D6E-409C-BE32-E72D297353CC}">
              <c16:uniqueId val="{00000000-26C5-494B-9884-7CB0046CB50F}"/>
            </c:ext>
          </c:extLst>
        </c:ser>
        <c:ser>
          <c:idx val="1"/>
          <c:order val="1"/>
          <c:tx>
            <c:strRef>
              <c:f>'15 dn prion up del'!$I$10</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C00000"/>
                </a:solidFill>
                <a:round/>
              </a:ln>
              <a:effectLst/>
            </c:spPr>
          </c:errBars>
          <c:xVal>
            <c:numRef>
              <c:f>'15 dn prion up del'!$G$11:$G$17</c:f>
              <c:numCache>
                <c:formatCode>General</c:formatCode>
                <c:ptCount val="7"/>
                <c:pt idx="0">
                  <c:v>1032849</c:v>
                </c:pt>
                <c:pt idx="1">
                  <c:v>2936975</c:v>
                </c:pt>
                <c:pt idx="2">
                  <c:v>5933611</c:v>
                </c:pt>
                <c:pt idx="3">
                  <c:v>7032564</c:v>
                </c:pt>
                <c:pt idx="4">
                  <c:v>7158039</c:v>
                </c:pt>
                <c:pt idx="5">
                  <c:v>8710520</c:v>
                </c:pt>
                <c:pt idx="6">
                  <c:v>11459213</c:v>
                </c:pt>
              </c:numCache>
            </c:numRef>
          </c:xVal>
          <c:yVal>
            <c:numRef>
              <c:f>'15 dn prion up del'!$I$11:$I$17</c:f>
              <c:numCache>
                <c:formatCode>General</c:formatCode>
                <c:ptCount val="7"/>
                <c:pt idx="0">
                  <c:v>1.4192333993318191</c:v>
                </c:pt>
                <c:pt idx="1">
                  <c:v>1.173488905415851</c:v>
                </c:pt>
                <c:pt idx="2">
                  <c:v>3.276309605073314</c:v>
                </c:pt>
                <c:pt idx="3">
                  <c:v>1.0773484810191085</c:v>
                </c:pt>
                <c:pt idx="4">
                  <c:v>2.860924445770602</c:v>
                </c:pt>
                <c:pt idx="5">
                  <c:v>1.2460182862330689</c:v>
                </c:pt>
                <c:pt idx="6">
                  <c:v>1.1902970544260725</c:v>
                </c:pt>
              </c:numCache>
            </c:numRef>
          </c:yVal>
          <c:smooth val="0"/>
          <c:extLst>
            <c:ext xmlns:c16="http://schemas.microsoft.com/office/drawing/2014/chart" uri="{C3380CC4-5D6E-409C-BE32-E72D297353CC}">
              <c16:uniqueId val="{00000001-26C5-494B-9884-7CB0046CB50F}"/>
            </c:ext>
          </c:extLst>
        </c:ser>
        <c:dLbls>
          <c:showLegendKey val="0"/>
          <c:showVal val="0"/>
          <c:showCatName val="0"/>
          <c:showSerName val="0"/>
          <c:showPercent val="0"/>
          <c:showBubbleSize val="0"/>
        </c:dLbls>
        <c:axId val="196827008"/>
        <c:axId val="196828544"/>
      </c:scatterChart>
      <c:valAx>
        <c:axId val="196827008"/>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96828544"/>
        <c:crosses val="autoZero"/>
        <c:crossBetween val="midCat"/>
      </c:valAx>
      <c:valAx>
        <c:axId val="196828544"/>
        <c:scaling>
          <c:orientation val="minMax"/>
          <c:max val="2"/>
          <c:min val="-2"/>
        </c:scaling>
        <c:delete val="0"/>
        <c:axPos val="l"/>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noFill/>
                <a:latin typeface="+mn-lt"/>
                <a:ea typeface="+mn-ea"/>
                <a:cs typeface="+mn-cs"/>
              </a:defRPr>
            </a:pPr>
            <a:endParaRPr lang="en-US"/>
          </a:p>
        </c:txPr>
        <c:crossAx val="196827008"/>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15 dn prion up del'!$H$1</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prstDash val="dash"/>
                <a:round/>
              </a:ln>
              <a:effectLst/>
            </c:spPr>
          </c:errBars>
          <c:xVal>
            <c:numRef>
              <c:f>'15 dn prion up del'!$G$2:$G$9</c:f>
              <c:numCache>
                <c:formatCode>General</c:formatCode>
                <c:ptCount val="8"/>
                <c:pt idx="0">
                  <c:v>357517</c:v>
                </c:pt>
                <c:pt idx="1">
                  <c:v>357046</c:v>
                </c:pt>
                <c:pt idx="2">
                  <c:v>1030741</c:v>
                </c:pt>
                <c:pt idx="3">
                  <c:v>3094147</c:v>
                </c:pt>
                <c:pt idx="4">
                  <c:v>9507214</c:v>
                </c:pt>
                <c:pt idx="5">
                  <c:v>10988867</c:v>
                </c:pt>
                <c:pt idx="6">
                  <c:v>11579019</c:v>
                </c:pt>
                <c:pt idx="7">
                  <c:v>11396515</c:v>
                </c:pt>
              </c:numCache>
            </c:numRef>
          </c:xVal>
          <c:yVal>
            <c:numRef>
              <c:f>'15 dn prion up del'!$H$2:$H$9</c:f>
              <c:numCache>
                <c:formatCode>General</c:formatCode>
                <c:ptCount val="8"/>
                <c:pt idx="0">
                  <c:v>-2.4287889374527367</c:v>
                </c:pt>
                <c:pt idx="1">
                  <c:v>-2.0298061052765979</c:v>
                </c:pt>
                <c:pt idx="2">
                  <c:v>-1.3761886723446053</c:v>
                </c:pt>
                <c:pt idx="3">
                  <c:v>-1.1115474105484093</c:v>
                </c:pt>
                <c:pt idx="4">
                  <c:v>-1.3349263862608691</c:v>
                </c:pt>
                <c:pt idx="5">
                  <c:v>-1.8378718653581823</c:v>
                </c:pt>
                <c:pt idx="6">
                  <c:v>-1.380583351110833</c:v>
                </c:pt>
                <c:pt idx="7">
                  <c:v>-1.429498832752659</c:v>
                </c:pt>
              </c:numCache>
            </c:numRef>
          </c:yVal>
          <c:smooth val="0"/>
          <c:extLst>
            <c:ext xmlns:c16="http://schemas.microsoft.com/office/drawing/2014/chart" uri="{C3380CC4-5D6E-409C-BE32-E72D297353CC}">
              <c16:uniqueId val="{00000000-3983-4D6F-9A42-FBE17A8A3BC6}"/>
            </c:ext>
          </c:extLst>
        </c:ser>
        <c:ser>
          <c:idx val="1"/>
          <c:order val="1"/>
          <c:tx>
            <c:strRef>
              <c:f>'15 dn prion up del'!$I$1</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FF0000"/>
                </a:solidFill>
                <a:prstDash val="dash"/>
                <a:round/>
              </a:ln>
              <a:effectLst/>
            </c:spPr>
          </c:errBars>
          <c:xVal>
            <c:numRef>
              <c:f>'15 dn prion up del'!$G$2:$G$9</c:f>
              <c:numCache>
                <c:formatCode>General</c:formatCode>
                <c:ptCount val="8"/>
                <c:pt idx="0">
                  <c:v>357517</c:v>
                </c:pt>
                <c:pt idx="1">
                  <c:v>357046</c:v>
                </c:pt>
                <c:pt idx="2">
                  <c:v>1030741</c:v>
                </c:pt>
                <c:pt idx="3">
                  <c:v>3094147</c:v>
                </c:pt>
                <c:pt idx="4">
                  <c:v>9507214</c:v>
                </c:pt>
                <c:pt idx="5">
                  <c:v>10988867</c:v>
                </c:pt>
                <c:pt idx="6">
                  <c:v>11579019</c:v>
                </c:pt>
                <c:pt idx="7">
                  <c:v>11396515</c:v>
                </c:pt>
              </c:numCache>
            </c:numRef>
          </c:xVal>
          <c:yVal>
            <c:numRef>
              <c:f>'15 dn prion up del'!$I$2:$I$9</c:f>
              <c:numCache>
                <c:formatCode>General</c:formatCode>
                <c:ptCount val="8"/>
                <c:pt idx="0">
                  <c:v>1.1715021876779634</c:v>
                </c:pt>
                <c:pt idx="1">
                  <c:v>1.2421634980212943</c:v>
                </c:pt>
                <c:pt idx="2">
                  <c:v>1.2692499288924211</c:v>
                </c:pt>
                <c:pt idx="3">
                  <c:v>1.224954466858881</c:v>
                </c:pt>
                <c:pt idx="4">
                  <c:v>1.7819010585862793</c:v>
                </c:pt>
                <c:pt idx="5">
                  <c:v>1.2796134203940555</c:v>
                </c:pt>
                <c:pt idx="6">
                  <c:v>1.3003894068870332</c:v>
                </c:pt>
                <c:pt idx="7">
                  <c:v>1.0379806175129922</c:v>
                </c:pt>
              </c:numCache>
            </c:numRef>
          </c:yVal>
          <c:smooth val="0"/>
          <c:extLst>
            <c:ext xmlns:c16="http://schemas.microsoft.com/office/drawing/2014/chart" uri="{C3380CC4-5D6E-409C-BE32-E72D297353CC}">
              <c16:uniqueId val="{00000001-3983-4D6F-9A42-FBE17A8A3BC6}"/>
            </c:ext>
          </c:extLst>
        </c:ser>
        <c:dLbls>
          <c:showLegendKey val="0"/>
          <c:showVal val="0"/>
          <c:showCatName val="0"/>
          <c:showSerName val="0"/>
          <c:showPercent val="0"/>
          <c:showBubbleSize val="0"/>
        </c:dLbls>
        <c:axId val="171402752"/>
        <c:axId val="171404288"/>
      </c:scatterChart>
      <c:valAx>
        <c:axId val="171402752"/>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404288"/>
        <c:crosses val="autoZero"/>
        <c:crossBetween val="midCat"/>
      </c:valAx>
      <c:valAx>
        <c:axId val="171404288"/>
        <c:scaling>
          <c:orientation val="minMax"/>
          <c:max val="2"/>
          <c:min val="-2"/>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140275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527 dn del no change prion'!$D$291</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round/>
              </a:ln>
              <a:effectLst/>
            </c:spPr>
          </c:errBars>
          <c:xVal>
            <c:numRef>
              <c:f>'527 dn del no change prion'!$C$292:$C$529</c:f>
              <c:numCache>
                <c:formatCode>General</c:formatCode>
                <c:ptCount val="238"/>
                <c:pt idx="0">
                  <c:v>33448</c:v>
                </c:pt>
                <c:pt idx="1">
                  <c:v>36509</c:v>
                </c:pt>
                <c:pt idx="2">
                  <c:v>75043</c:v>
                </c:pt>
                <c:pt idx="3">
                  <c:v>76427</c:v>
                </c:pt>
                <c:pt idx="4">
                  <c:v>99305</c:v>
                </c:pt>
                <c:pt idx="5">
                  <c:v>114919</c:v>
                </c:pt>
                <c:pt idx="6">
                  <c:v>142367</c:v>
                </c:pt>
                <c:pt idx="7">
                  <c:v>169375</c:v>
                </c:pt>
                <c:pt idx="8">
                  <c:v>186512</c:v>
                </c:pt>
                <c:pt idx="9">
                  <c:v>201467</c:v>
                </c:pt>
                <c:pt idx="10">
                  <c:v>203403</c:v>
                </c:pt>
                <c:pt idx="11">
                  <c:v>290040</c:v>
                </c:pt>
                <c:pt idx="12">
                  <c:v>330181</c:v>
                </c:pt>
                <c:pt idx="13">
                  <c:v>357517</c:v>
                </c:pt>
                <c:pt idx="14">
                  <c:v>366216</c:v>
                </c:pt>
                <c:pt idx="15">
                  <c:v>366906</c:v>
                </c:pt>
                <c:pt idx="16">
                  <c:v>424340</c:v>
                </c:pt>
                <c:pt idx="17">
                  <c:v>476124</c:v>
                </c:pt>
                <c:pt idx="18">
                  <c:v>482781</c:v>
                </c:pt>
                <c:pt idx="19">
                  <c:v>504645</c:v>
                </c:pt>
                <c:pt idx="20">
                  <c:v>558391</c:v>
                </c:pt>
                <c:pt idx="21">
                  <c:v>567401</c:v>
                </c:pt>
                <c:pt idx="22">
                  <c:v>581473</c:v>
                </c:pt>
                <c:pt idx="23">
                  <c:v>757243</c:v>
                </c:pt>
                <c:pt idx="24">
                  <c:v>768094</c:v>
                </c:pt>
                <c:pt idx="25">
                  <c:v>783761</c:v>
                </c:pt>
                <c:pt idx="26">
                  <c:v>793421</c:v>
                </c:pt>
                <c:pt idx="27">
                  <c:v>836488</c:v>
                </c:pt>
                <c:pt idx="28">
                  <c:v>937746</c:v>
                </c:pt>
                <c:pt idx="29">
                  <c:v>957604</c:v>
                </c:pt>
                <c:pt idx="30">
                  <c:v>1032849</c:v>
                </c:pt>
                <c:pt idx="31">
                  <c:v>1116807</c:v>
                </c:pt>
                <c:pt idx="32">
                  <c:v>1150906</c:v>
                </c:pt>
                <c:pt idx="33">
                  <c:v>1199511</c:v>
                </c:pt>
                <c:pt idx="34">
                  <c:v>1284207</c:v>
                </c:pt>
                <c:pt idx="35">
                  <c:v>1307408</c:v>
                </c:pt>
                <c:pt idx="36">
                  <c:v>1404087</c:v>
                </c:pt>
                <c:pt idx="37">
                  <c:v>1498313</c:v>
                </c:pt>
                <c:pt idx="38">
                  <c:v>1548176</c:v>
                </c:pt>
                <c:pt idx="39">
                  <c:v>1723974</c:v>
                </c:pt>
                <c:pt idx="40">
                  <c:v>1742007</c:v>
                </c:pt>
                <c:pt idx="41">
                  <c:v>1744623</c:v>
                </c:pt>
                <c:pt idx="42">
                  <c:v>1747535</c:v>
                </c:pt>
                <c:pt idx="43">
                  <c:v>1771847</c:v>
                </c:pt>
                <c:pt idx="44">
                  <c:v>1906664</c:v>
                </c:pt>
                <c:pt idx="45">
                  <c:v>1927745</c:v>
                </c:pt>
                <c:pt idx="46">
                  <c:v>1929256</c:v>
                </c:pt>
                <c:pt idx="47">
                  <c:v>1996139</c:v>
                </c:pt>
                <c:pt idx="48">
                  <c:v>2018372</c:v>
                </c:pt>
                <c:pt idx="49">
                  <c:v>2025371</c:v>
                </c:pt>
                <c:pt idx="50">
                  <c:v>2104333</c:v>
                </c:pt>
                <c:pt idx="51">
                  <c:v>2232134</c:v>
                </c:pt>
                <c:pt idx="52">
                  <c:v>2514238</c:v>
                </c:pt>
                <c:pt idx="53">
                  <c:v>2594240</c:v>
                </c:pt>
                <c:pt idx="54">
                  <c:v>2627493</c:v>
                </c:pt>
                <c:pt idx="55">
                  <c:v>2652394</c:v>
                </c:pt>
                <c:pt idx="56">
                  <c:v>2661638</c:v>
                </c:pt>
                <c:pt idx="57">
                  <c:v>2684499</c:v>
                </c:pt>
                <c:pt idx="58">
                  <c:v>2762941</c:v>
                </c:pt>
                <c:pt idx="59">
                  <c:v>2845588</c:v>
                </c:pt>
                <c:pt idx="60">
                  <c:v>2936975</c:v>
                </c:pt>
                <c:pt idx="61">
                  <c:v>2944105</c:v>
                </c:pt>
                <c:pt idx="62">
                  <c:v>2993898</c:v>
                </c:pt>
                <c:pt idx="63">
                  <c:v>3045475</c:v>
                </c:pt>
                <c:pt idx="64">
                  <c:v>3064589</c:v>
                </c:pt>
                <c:pt idx="65">
                  <c:v>3102647</c:v>
                </c:pt>
                <c:pt idx="66">
                  <c:v>3127725</c:v>
                </c:pt>
                <c:pt idx="67">
                  <c:v>3256544</c:v>
                </c:pt>
                <c:pt idx="68">
                  <c:v>3479130</c:v>
                </c:pt>
                <c:pt idx="69">
                  <c:v>3481758</c:v>
                </c:pt>
                <c:pt idx="70">
                  <c:v>3492252</c:v>
                </c:pt>
                <c:pt idx="71">
                  <c:v>3549248</c:v>
                </c:pt>
                <c:pt idx="72">
                  <c:v>3569081</c:v>
                </c:pt>
                <c:pt idx="73">
                  <c:v>3576085</c:v>
                </c:pt>
                <c:pt idx="74">
                  <c:v>3834848</c:v>
                </c:pt>
                <c:pt idx="75">
                  <c:v>3880906</c:v>
                </c:pt>
                <c:pt idx="76">
                  <c:v>3887219</c:v>
                </c:pt>
                <c:pt idx="77">
                  <c:v>3895533</c:v>
                </c:pt>
                <c:pt idx="78">
                  <c:v>4020624</c:v>
                </c:pt>
                <c:pt idx="79">
                  <c:v>4109993</c:v>
                </c:pt>
                <c:pt idx="80">
                  <c:v>4137618</c:v>
                </c:pt>
                <c:pt idx="81">
                  <c:v>4179053</c:v>
                </c:pt>
                <c:pt idx="82">
                  <c:v>4182632</c:v>
                </c:pt>
                <c:pt idx="83">
                  <c:v>4294802</c:v>
                </c:pt>
                <c:pt idx="84">
                  <c:v>4296062</c:v>
                </c:pt>
                <c:pt idx="85">
                  <c:v>4361362</c:v>
                </c:pt>
                <c:pt idx="86">
                  <c:v>4383034</c:v>
                </c:pt>
                <c:pt idx="87">
                  <c:v>4387373</c:v>
                </c:pt>
                <c:pt idx="88">
                  <c:v>4393624</c:v>
                </c:pt>
                <c:pt idx="89">
                  <c:v>4401348</c:v>
                </c:pt>
                <c:pt idx="90">
                  <c:v>4659565</c:v>
                </c:pt>
                <c:pt idx="91">
                  <c:v>4701520</c:v>
                </c:pt>
                <c:pt idx="92">
                  <c:v>4806212</c:v>
                </c:pt>
                <c:pt idx="93">
                  <c:v>4838281</c:v>
                </c:pt>
                <c:pt idx="94">
                  <c:v>4865185</c:v>
                </c:pt>
                <c:pt idx="95">
                  <c:v>4886579</c:v>
                </c:pt>
                <c:pt idx="96">
                  <c:v>4934207</c:v>
                </c:pt>
                <c:pt idx="97">
                  <c:v>4943429</c:v>
                </c:pt>
                <c:pt idx="98">
                  <c:v>4952480</c:v>
                </c:pt>
                <c:pt idx="99">
                  <c:v>4977801</c:v>
                </c:pt>
                <c:pt idx="100">
                  <c:v>5017854</c:v>
                </c:pt>
                <c:pt idx="101">
                  <c:v>5059265</c:v>
                </c:pt>
                <c:pt idx="102">
                  <c:v>5071594</c:v>
                </c:pt>
                <c:pt idx="103">
                  <c:v>5106694</c:v>
                </c:pt>
                <c:pt idx="104">
                  <c:v>5110750</c:v>
                </c:pt>
                <c:pt idx="105">
                  <c:v>5192045</c:v>
                </c:pt>
                <c:pt idx="106">
                  <c:v>5211920</c:v>
                </c:pt>
                <c:pt idx="107">
                  <c:v>5249151</c:v>
                </c:pt>
                <c:pt idx="108">
                  <c:v>5334406</c:v>
                </c:pt>
                <c:pt idx="109">
                  <c:v>5415692</c:v>
                </c:pt>
                <c:pt idx="110">
                  <c:v>5421605</c:v>
                </c:pt>
                <c:pt idx="111">
                  <c:v>5509597</c:v>
                </c:pt>
                <c:pt idx="112">
                  <c:v>5615510</c:v>
                </c:pt>
                <c:pt idx="113">
                  <c:v>5720780</c:v>
                </c:pt>
                <c:pt idx="114">
                  <c:v>5725584</c:v>
                </c:pt>
                <c:pt idx="115">
                  <c:v>5728239</c:v>
                </c:pt>
                <c:pt idx="116">
                  <c:v>5788572</c:v>
                </c:pt>
                <c:pt idx="117">
                  <c:v>5798833</c:v>
                </c:pt>
                <c:pt idx="118">
                  <c:v>5823071</c:v>
                </c:pt>
                <c:pt idx="119">
                  <c:v>5869218</c:v>
                </c:pt>
                <c:pt idx="120">
                  <c:v>5872655</c:v>
                </c:pt>
                <c:pt idx="121">
                  <c:v>5907371</c:v>
                </c:pt>
                <c:pt idx="122">
                  <c:v>5989011</c:v>
                </c:pt>
                <c:pt idx="123">
                  <c:v>6126508</c:v>
                </c:pt>
                <c:pt idx="124">
                  <c:v>6181505</c:v>
                </c:pt>
                <c:pt idx="125">
                  <c:v>6288700</c:v>
                </c:pt>
                <c:pt idx="126">
                  <c:v>6387656</c:v>
                </c:pt>
                <c:pt idx="127">
                  <c:v>6412666</c:v>
                </c:pt>
                <c:pt idx="128">
                  <c:v>6444874</c:v>
                </c:pt>
                <c:pt idx="129">
                  <c:v>6472403</c:v>
                </c:pt>
                <c:pt idx="130">
                  <c:v>6584319</c:v>
                </c:pt>
                <c:pt idx="131">
                  <c:v>6620635</c:v>
                </c:pt>
                <c:pt idx="132">
                  <c:v>6764628</c:v>
                </c:pt>
                <c:pt idx="133">
                  <c:v>6912624</c:v>
                </c:pt>
                <c:pt idx="134">
                  <c:v>7010118</c:v>
                </c:pt>
                <c:pt idx="135">
                  <c:v>7063356</c:v>
                </c:pt>
                <c:pt idx="136">
                  <c:v>7158039</c:v>
                </c:pt>
                <c:pt idx="137">
                  <c:v>7267502</c:v>
                </c:pt>
                <c:pt idx="138">
                  <c:v>7414131</c:v>
                </c:pt>
                <c:pt idx="139">
                  <c:v>7415010</c:v>
                </c:pt>
                <c:pt idx="140">
                  <c:v>7448318</c:v>
                </c:pt>
                <c:pt idx="141">
                  <c:v>7526047</c:v>
                </c:pt>
                <c:pt idx="142">
                  <c:v>7615819</c:v>
                </c:pt>
                <c:pt idx="143">
                  <c:v>7700461</c:v>
                </c:pt>
                <c:pt idx="144">
                  <c:v>7746288</c:v>
                </c:pt>
                <c:pt idx="145">
                  <c:v>7760290</c:v>
                </c:pt>
                <c:pt idx="146">
                  <c:v>7881808</c:v>
                </c:pt>
                <c:pt idx="147">
                  <c:v>7949511</c:v>
                </c:pt>
                <c:pt idx="148">
                  <c:v>7957565</c:v>
                </c:pt>
                <c:pt idx="149">
                  <c:v>8039965</c:v>
                </c:pt>
                <c:pt idx="150">
                  <c:v>8064340</c:v>
                </c:pt>
                <c:pt idx="151">
                  <c:v>8118774</c:v>
                </c:pt>
                <c:pt idx="152">
                  <c:v>8176093</c:v>
                </c:pt>
                <c:pt idx="153">
                  <c:v>8179442</c:v>
                </c:pt>
                <c:pt idx="154">
                  <c:v>8257529</c:v>
                </c:pt>
                <c:pt idx="155">
                  <c:v>8275862</c:v>
                </c:pt>
                <c:pt idx="156">
                  <c:v>8446432</c:v>
                </c:pt>
                <c:pt idx="157">
                  <c:v>8469687</c:v>
                </c:pt>
                <c:pt idx="158">
                  <c:v>8513449</c:v>
                </c:pt>
                <c:pt idx="159">
                  <c:v>8549094</c:v>
                </c:pt>
                <c:pt idx="160">
                  <c:v>8600766</c:v>
                </c:pt>
                <c:pt idx="161">
                  <c:v>8603795</c:v>
                </c:pt>
                <c:pt idx="162">
                  <c:v>8620930</c:v>
                </c:pt>
                <c:pt idx="163">
                  <c:v>8630694</c:v>
                </c:pt>
                <c:pt idx="164">
                  <c:v>8646505</c:v>
                </c:pt>
                <c:pt idx="165">
                  <c:v>8691299</c:v>
                </c:pt>
                <c:pt idx="166">
                  <c:v>8780490</c:v>
                </c:pt>
                <c:pt idx="167">
                  <c:v>8801269</c:v>
                </c:pt>
                <c:pt idx="168">
                  <c:v>8830707</c:v>
                </c:pt>
                <c:pt idx="169">
                  <c:v>8974350</c:v>
                </c:pt>
                <c:pt idx="170">
                  <c:v>9024995</c:v>
                </c:pt>
                <c:pt idx="171">
                  <c:v>9035521</c:v>
                </c:pt>
                <c:pt idx="172">
                  <c:v>9049139</c:v>
                </c:pt>
                <c:pt idx="173">
                  <c:v>9112583</c:v>
                </c:pt>
                <c:pt idx="174">
                  <c:v>9210208</c:v>
                </c:pt>
                <c:pt idx="175">
                  <c:v>9216193</c:v>
                </c:pt>
                <c:pt idx="176">
                  <c:v>9259844</c:v>
                </c:pt>
                <c:pt idx="177">
                  <c:v>9260903</c:v>
                </c:pt>
                <c:pt idx="178">
                  <c:v>9271684</c:v>
                </c:pt>
                <c:pt idx="179">
                  <c:v>9313380</c:v>
                </c:pt>
                <c:pt idx="180">
                  <c:v>9335533</c:v>
                </c:pt>
                <c:pt idx="181">
                  <c:v>9360907</c:v>
                </c:pt>
                <c:pt idx="182">
                  <c:v>9428997</c:v>
                </c:pt>
                <c:pt idx="183">
                  <c:v>9507214</c:v>
                </c:pt>
                <c:pt idx="184">
                  <c:v>9520346</c:v>
                </c:pt>
                <c:pt idx="185">
                  <c:v>9535630</c:v>
                </c:pt>
                <c:pt idx="186">
                  <c:v>9577965</c:v>
                </c:pt>
                <c:pt idx="187">
                  <c:v>9595402</c:v>
                </c:pt>
                <c:pt idx="188">
                  <c:v>9665462</c:v>
                </c:pt>
                <c:pt idx="189">
                  <c:v>9713970</c:v>
                </c:pt>
                <c:pt idx="190">
                  <c:v>9733243</c:v>
                </c:pt>
                <c:pt idx="191">
                  <c:v>9818113</c:v>
                </c:pt>
                <c:pt idx="192">
                  <c:v>9963756</c:v>
                </c:pt>
                <c:pt idx="193">
                  <c:v>9968756</c:v>
                </c:pt>
                <c:pt idx="194">
                  <c:v>10066627</c:v>
                </c:pt>
                <c:pt idx="195">
                  <c:v>10085067</c:v>
                </c:pt>
                <c:pt idx="196">
                  <c:v>10128577</c:v>
                </c:pt>
                <c:pt idx="197">
                  <c:v>10135286</c:v>
                </c:pt>
                <c:pt idx="198">
                  <c:v>10193642</c:v>
                </c:pt>
                <c:pt idx="199">
                  <c:v>10212527</c:v>
                </c:pt>
                <c:pt idx="200">
                  <c:v>10291458</c:v>
                </c:pt>
                <c:pt idx="201">
                  <c:v>10297398</c:v>
                </c:pt>
                <c:pt idx="202">
                  <c:v>10300156</c:v>
                </c:pt>
                <c:pt idx="203">
                  <c:v>10337318</c:v>
                </c:pt>
                <c:pt idx="204">
                  <c:v>10479408</c:v>
                </c:pt>
                <c:pt idx="205">
                  <c:v>10527096</c:v>
                </c:pt>
                <c:pt idx="206">
                  <c:v>10668908</c:v>
                </c:pt>
                <c:pt idx="207">
                  <c:v>10712654</c:v>
                </c:pt>
                <c:pt idx="208">
                  <c:v>10774879</c:v>
                </c:pt>
                <c:pt idx="209">
                  <c:v>10790299</c:v>
                </c:pt>
                <c:pt idx="210">
                  <c:v>10793583</c:v>
                </c:pt>
                <c:pt idx="211">
                  <c:v>10866421</c:v>
                </c:pt>
                <c:pt idx="212">
                  <c:v>10873927</c:v>
                </c:pt>
                <c:pt idx="213">
                  <c:v>10880447</c:v>
                </c:pt>
                <c:pt idx="214">
                  <c:v>10933827</c:v>
                </c:pt>
                <c:pt idx="215">
                  <c:v>10943753</c:v>
                </c:pt>
                <c:pt idx="216">
                  <c:v>10986313</c:v>
                </c:pt>
                <c:pt idx="217">
                  <c:v>11013797</c:v>
                </c:pt>
                <c:pt idx="218">
                  <c:v>11018868</c:v>
                </c:pt>
                <c:pt idx="219">
                  <c:v>11026987</c:v>
                </c:pt>
                <c:pt idx="220">
                  <c:v>11097012</c:v>
                </c:pt>
                <c:pt idx="221">
                  <c:v>11399422</c:v>
                </c:pt>
                <c:pt idx="222">
                  <c:v>11426381</c:v>
                </c:pt>
                <c:pt idx="223">
                  <c:v>11508033</c:v>
                </c:pt>
                <c:pt idx="224">
                  <c:v>11555155</c:v>
                </c:pt>
                <c:pt idx="225">
                  <c:v>11555848</c:v>
                </c:pt>
                <c:pt idx="226">
                  <c:v>11610622</c:v>
                </c:pt>
                <c:pt idx="227">
                  <c:v>11625733</c:v>
                </c:pt>
                <c:pt idx="228">
                  <c:v>11683829</c:v>
                </c:pt>
                <c:pt idx="229">
                  <c:v>11771964</c:v>
                </c:pt>
                <c:pt idx="230">
                  <c:v>11777426</c:v>
                </c:pt>
                <c:pt idx="231">
                  <c:v>11872516</c:v>
                </c:pt>
                <c:pt idx="232">
                  <c:v>11901843</c:v>
                </c:pt>
                <c:pt idx="233">
                  <c:v>11944992</c:v>
                </c:pt>
                <c:pt idx="234">
                  <c:v>11991905</c:v>
                </c:pt>
                <c:pt idx="235">
                  <c:v>12032993</c:v>
                </c:pt>
                <c:pt idx="236">
                  <c:v>12040337</c:v>
                </c:pt>
                <c:pt idx="237">
                  <c:v>12047564</c:v>
                </c:pt>
              </c:numCache>
            </c:numRef>
          </c:xVal>
          <c:yVal>
            <c:numRef>
              <c:f>'527 dn del no change prion'!$D$292:$D$529</c:f>
              <c:numCache>
                <c:formatCode>General</c:formatCode>
                <c:ptCount val="238"/>
                <c:pt idx="0">
                  <c:v>0.75218783588044025</c:v>
                </c:pt>
                <c:pt idx="1">
                  <c:v>0.18576613041368542</c:v>
                </c:pt>
                <c:pt idx="2">
                  <c:v>0.64709146057758815</c:v>
                </c:pt>
                <c:pt idx="3">
                  <c:v>8.190506126578935E-2</c:v>
                </c:pt>
                <c:pt idx="4">
                  <c:v>-0.7565479185301317</c:v>
                </c:pt>
                <c:pt idx="5">
                  <c:v>-0.17382701697119468</c:v>
                </c:pt>
                <c:pt idx="6">
                  <c:v>0.16809444797058323</c:v>
                </c:pt>
                <c:pt idx="7">
                  <c:v>0.25197957153001449</c:v>
                </c:pt>
                <c:pt idx="8">
                  <c:v>2.7488229943539402E-2</c:v>
                </c:pt>
                <c:pt idx="9">
                  <c:v>-0.93884839043227664</c:v>
                </c:pt>
                <c:pt idx="10">
                  <c:v>0.45715341334075738</c:v>
                </c:pt>
                <c:pt idx="11">
                  <c:v>0.46963076606452325</c:v>
                </c:pt>
                <c:pt idx="12">
                  <c:v>-0.84029872242662829</c:v>
                </c:pt>
                <c:pt idx="13">
                  <c:v>-1.182260051819032</c:v>
                </c:pt>
                <c:pt idx="14">
                  <c:v>-0.76086009431656676</c:v>
                </c:pt>
                <c:pt idx="15">
                  <c:v>7.9562756427434836E-2</c:v>
                </c:pt>
                <c:pt idx="16">
                  <c:v>5.0210414653147017E-2</c:v>
                </c:pt>
                <c:pt idx="17">
                  <c:v>1.2044915150773896</c:v>
                </c:pt>
                <c:pt idx="18">
                  <c:v>0.46588337668294005</c:v>
                </c:pt>
                <c:pt idx="19">
                  <c:v>-6.5845455765430286E-2</c:v>
                </c:pt>
                <c:pt idx="20">
                  <c:v>0.88414404947954084</c:v>
                </c:pt>
                <c:pt idx="21">
                  <c:v>0.4854960145776353</c:v>
                </c:pt>
                <c:pt idx="22">
                  <c:v>-0.27074786671798856</c:v>
                </c:pt>
                <c:pt idx="23">
                  <c:v>1.1661262762423938</c:v>
                </c:pt>
                <c:pt idx="24">
                  <c:v>1.4616958328372125</c:v>
                </c:pt>
                <c:pt idx="25">
                  <c:v>-0.85107386613166547</c:v>
                </c:pt>
                <c:pt idx="26">
                  <c:v>0.51606195803295285</c:v>
                </c:pt>
                <c:pt idx="27">
                  <c:v>3.5141581643883091E-2</c:v>
                </c:pt>
                <c:pt idx="28">
                  <c:v>0.4641339913886709</c:v>
                </c:pt>
                <c:pt idx="29">
                  <c:v>-0.52474091265842737</c:v>
                </c:pt>
                <c:pt idx="30">
                  <c:v>0.55337942459840472</c:v>
                </c:pt>
                <c:pt idx="31">
                  <c:v>8.9231511012644274E-2</c:v>
                </c:pt>
                <c:pt idx="32">
                  <c:v>-0.26316045254799525</c:v>
                </c:pt>
                <c:pt idx="33">
                  <c:v>9.1587326415741008E-2</c:v>
                </c:pt>
                <c:pt idx="34">
                  <c:v>0.40780429560249803</c:v>
                </c:pt>
                <c:pt idx="35">
                  <c:v>-0.63711678069379485</c:v>
                </c:pt>
                <c:pt idx="36">
                  <c:v>0.53635961422147638</c:v>
                </c:pt>
                <c:pt idx="37">
                  <c:v>-0.9736816208023491</c:v>
                </c:pt>
                <c:pt idx="38">
                  <c:v>0.69497357593761644</c:v>
                </c:pt>
                <c:pt idx="39">
                  <c:v>-0.16094809639870597</c:v>
                </c:pt>
                <c:pt idx="40">
                  <c:v>-9.8914958424622113E-2</c:v>
                </c:pt>
                <c:pt idx="41">
                  <c:v>0.71350052962587152</c:v>
                </c:pt>
                <c:pt idx="42">
                  <c:v>1.1336514188988769</c:v>
                </c:pt>
                <c:pt idx="43">
                  <c:v>-0.23877357331880478</c:v>
                </c:pt>
                <c:pt idx="44">
                  <c:v>-0.50934073703420024</c:v>
                </c:pt>
                <c:pt idx="45">
                  <c:v>0.11185234186905825</c:v>
                </c:pt>
                <c:pt idx="46">
                  <c:v>0.40367961336990743</c:v>
                </c:pt>
                <c:pt idx="47">
                  <c:v>0.31040323562068312</c:v>
                </c:pt>
                <c:pt idx="48">
                  <c:v>0.29103315025311921</c:v>
                </c:pt>
                <c:pt idx="49">
                  <c:v>-0.27495862800376558</c:v>
                </c:pt>
                <c:pt idx="50">
                  <c:v>0.61006584437157796</c:v>
                </c:pt>
                <c:pt idx="51">
                  <c:v>0.27290243962127864</c:v>
                </c:pt>
                <c:pt idx="52">
                  <c:v>0.43173782781841585</c:v>
                </c:pt>
                <c:pt idx="53">
                  <c:v>0.18152109842076392</c:v>
                </c:pt>
                <c:pt idx="54">
                  <c:v>0.75273683740721575</c:v>
                </c:pt>
                <c:pt idx="55">
                  <c:v>0.68027303307276266</c:v>
                </c:pt>
                <c:pt idx="56">
                  <c:v>-0.66351837370384337</c:v>
                </c:pt>
                <c:pt idx="57">
                  <c:v>-0.77978984007624152</c:v>
                </c:pt>
                <c:pt idx="58">
                  <c:v>-0.25010549481212352</c:v>
                </c:pt>
                <c:pt idx="59">
                  <c:v>-0.63880220807970267</c:v>
                </c:pt>
                <c:pt idx="60">
                  <c:v>-0.12168162418805956</c:v>
                </c:pt>
                <c:pt idx="61">
                  <c:v>-0.27054459950603871</c:v>
                </c:pt>
                <c:pt idx="62">
                  <c:v>0.1448523347781045</c:v>
                </c:pt>
                <c:pt idx="63">
                  <c:v>1.0281087467098649</c:v>
                </c:pt>
                <c:pt idx="64">
                  <c:v>0.17384194745894074</c:v>
                </c:pt>
                <c:pt idx="65">
                  <c:v>-0.44230581357351617</c:v>
                </c:pt>
                <c:pt idx="66">
                  <c:v>0.40438452867117652</c:v>
                </c:pt>
                <c:pt idx="67">
                  <c:v>-4.5786831774773884E-2</c:v>
                </c:pt>
                <c:pt idx="68">
                  <c:v>-8.3091793624349791E-2</c:v>
                </c:pt>
                <c:pt idx="69">
                  <c:v>0.33965591353551944</c:v>
                </c:pt>
                <c:pt idx="70">
                  <c:v>-0.36851723014849408</c:v>
                </c:pt>
                <c:pt idx="71">
                  <c:v>0.12870849470467263</c:v>
                </c:pt>
                <c:pt idx="72">
                  <c:v>5.452466092091382E-2</c:v>
                </c:pt>
                <c:pt idx="73">
                  <c:v>-0.27536785030288202</c:v>
                </c:pt>
                <c:pt idx="74">
                  <c:v>-0.35486895570851323</c:v>
                </c:pt>
                <c:pt idx="75">
                  <c:v>1.2622702655146494</c:v>
                </c:pt>
                <c:pt idx="76">
                  <c:v>4.3968338448862034E-2</c:v>
                </c:pt>
                <c:pt idx="77">
                  <c:v>7.5568384716451095E-2</c:v>
                </c:pt>
                <c:pt idx="78">
                  <c:v>0.42124612302754688</c:v>
                </c:pt>
                <c:pt idx="79">
                  <c:v>-4.6959412423256811E-2</c:v>
                </c:pt>
                <c:pt idx="80">
                  <c:v>1.1013032394200686</c:v>
                </c:pt>
                <c:pt idx="81">
                  <c:v>-1.3564135796623083E-2</c:v>
                </c:pt>
                <c:pt idx="82">
                  <c:v>0.18646308197242553</c:v>
                </c:pt>
                <c:pt idx="83">
                  <c:v>0.27639263140054804</c:v>
                </c:pt>
                <c:pt idx="84">
                  <c:v>0.4330081575915703</c:v>
                </c:pt>
                <c:pt idx="85">
                  <c:v>0.44010164070194929</c:v>
                </c:pt>
                <c:pt idx="86">
                  <c:v>-0.46249160067135781</c:v>
                </c:pt>
                <c:pt idx="87">
                  <c:v>-0.42301895331511541</c:v>
                </c:pt>
                <c:pt idx="88">
                  <c:v>-0.11158097746286703</c:v>
                </c:pt>
                <c:pt idx="89">
                  <c:v>1.3631629496836207E-2</c:v>
                </c:pt>
                <c:pt idx="90">
                  <c:v>0.28888860280687545</c:v>
                </c:pt>
                <c:pt idx="91">
                  <c:v>0.24976387869818942</c:v>
                </c:pt>
                <c:pt idx="92">
                  <c:v>0.53109039347885201</c:v>
                </c:pt>
                <c:pt idx="93">
                  <c:v>0.29288004809283003</c:v>
                </c:pt>
                <c:pt idx="94">
                  <c:v>0.1113991875357639</c:v>
                </c:pt>
                <c:pt idx="95">
                  <c:v>0.16729318659042092</c:v>
                </c:pt>
                <c:pt idx="96">
                  <c:v>8.7895866460523886E-2</c:v>
                </c:pt>
                <c:pt idx="97">
                  <c:v>0.49383332191671453</c:v>
                </c:pt>
                <c:pt idx="98">
                  <c:v>0.23812300114992821</c:v>
                </c:pt>
                <c:pt idx="99">
                  <c:v>-0.78144176994355841</c:v>
                </c:pt>
                <c:pt idx="100">
                  <c:v>-2.9763503543540602E-2</c:v>
                </c:pt>
                <c:pt idx="101">
                  <c:v>0.52290426332807272</c:v>
                </c:pt>
                <c:pt idx="102">
                  <c:v>1.6368378935821351</c:v>
                </c:pt>
                <c:pt idx="103">
                  <c:v>-6.4489457671133593E-2</c:v>
                </c:pt>
                <c:pt idx="104">
                  <c:v>0.21325794315347707</c:v>
                </c:pt>
                <c:pt idx="105">
                  <c:v>-0.16670539903156559</c:v>
                </c:pt>
                <c:pt idx="106">
                  <c:v>-0.83081718630056811</c:v>
                </c:pt>
                <c:pt idx="107">
                  <c:v>0.74639854196888533</c:v>
                </c:pt>
                <c:pt idx="108">
                  <c:v>0.42277013928275203</c:v>
                </c:pt>
                <c:pt idx="109">
                  <c:v>7.389462691222469E-2</c:v>
                </c:pt>
                <c:pt idx="110">
                  <c:v>-0.21315290594112327</c:v>
                </c:pt>
                <c:pt idx="111">
                  <c:v>0.90731715929569001</c:v>
                </c:pt>
                <c:pt idx="112">
                  <c:v>6.5279079542895233E-2</c:v>
                </c:pt>
                <c:pt idx="113">
                  <c:v>-2.5710502482158996E-2</c:v>
                </c:pt>
                <c:pt idx="114">
                  <c:v>0.53859703727166863</c:v>
                </c:pt>
                <c:pt idx="115">
                  <c:v>3.0268228665344597E-2</c:v>
                </c:pt>
                <c:pt idx="116">
                  <c:v>0.10591903820425122</c:v>
                </c:pt>
                <c:pt idx="117">
                  <c:v>0.63236202291308652</c:v>
                </c:pt>
                <c:pt idx="118">
                  <c:v>0.33465992108216586</c:v>
                </c:pt>
                <c:pt idx="119">
                  <c:v>0.39926282146252151</c:v>
                </c:pt>
                <c:pt idx="120">
                  <c:v>-4.8560395407505459E-2</c:v>
                </c:pt>
                <c:pt idx="121">
                  <c:v>-0.38385276468879592</c:v>
                </c:pt>
                <c:pt idx="122">
                  <c:v>-0.13736793720051713</c:v>
                </c:pt>
                <c:pt idx="123">
                  <c:v>0.78310140079821688</c:v>
                </c:pt>
                <c:pt idx="124">
                  <c:v>-8.4079163545403138E-2</c:v>
                </c:pt>
                <c:pt idx="125">
                  <c:v>-0.61278875192299676</c:v>
                </c:pt>
                <c:pt idx="126">
                  <c:v>0.2342573385523043</c:v>
                </c:pt>
                <c:pt idx="127">
                  <c:v>-0.48873151926677638</c:v>
                </c:pt>
                <c:pt idx="128">
                  <c:v>-0.13042437193939185</c:v>
                </c:pt>
                <c:pt idx="129">
                  <c:v>1.1101061417534845</c:v>
                </c:pt>
                <c:pt idx="130">
                  <c:v>0.62537176943723161</c:v>
                </c:pt>
                <c:pt idx="131">
                  <c:v>0.25826577516878324</c:v>
                </c:pt>
                <c:pt idx="132">
                  <c:v>0.14736667645690241</c:v>
                </c:pt>
                <c:pt idx="133">
                  <c:v>0.85244036779853416</c:v>
                </c:pt>
                <c:pt idx="134">
                  <c:v>0.50673739861787803</c:v>
                </c:pt>
                <c:pt idx="135">
                  <c:v>1.0377791050604475</c:v>
                </c:pt>
                <c:pt idx="136">
                  <c:v>-0.97445934453825789</c:v>
                </c:pt>
                <c:pt idx="137">
                  <c:v>1.0529355521952273</c:v>
                </c:pt>
                <c:pt idx="138">
                  <c:v>0.11143832904674454</c:v>
                </c:pt>
                <c:pt idx="139">
                  <c:v>0.77252872146264651</c:v>
                </c:pt>
                <c:pt idx="140">
                  <c:v>0.39571083845253524</c:v>
                </c:pt>
                <c:pt idx="141">
                  <c:v>0.29991618503167972</c:v>
                </c:pt>
                <c:pt idx="142">
                  <c:v>0.32226024045009333</c:v>
                </c:pt>
                <c:pt idx="143">
                  <c:v>1.1903490973056525</c:v>
                </c:pt>
                <c:pt idx="144">
                  <c:v>-0.13615219814780594</c:v>
                </c:pt>
                <c:pt idx="145">
                  <c:v>1.2438228962620668</c:v>
                </c:pt>
                <c:pt idx="146">
                  <c:v>0.23600424490222224</c:v>
                </c:pt>
                <c:pt idx="147">
                  <c:v>-0.24155470253658648</c:v>
                </c:pt>
                <c:pt idx="148">
                  <c:v>-0.17433556115444129</c:v>
                </c:pt>
                <c:pt idx="149">
                  <c:v>0.31713513011524025</c:v>
                </c:pt>
                <c:pt idx="150">
                  <c:v>0.88150773845233754</c:v>
                </c:pt>
                <c:pt idx="151">
                  <c:v>2.457202586772516E-2</c:v>
                </c:pt>
                <c:pt idx="152">
                  <c:v>0.65953754446905288</c:v>
                </c:pt>
                <c:pt idx="153">
                  <c:v>0.13741281225290844</c:v>
                </c:pt>
                <c:pt idx="154">
                  <c:v>0.92245610573225745</c:v>
                </c:pt>
                <c:pt idx="155">
                  <c:v>0.62258781721214929</c:v>
                </c:pt>
                <c:pt idx="156">
                  <c:v>0.47061876687035858</c:v>
                </c:pt>
                <c:pt idx="157">
                  <c:v>0.9148339125246594</c:v>
                </c:pt>
                <c:pt idx="158">
                  <c:v>-0.93306072454603473</c:v>
                </c:pt>
                <c:pt idx="159">
                  <c:v>0.51047488711941769</c:v>
                </c:pt>
                <c:pt idx="160">
                  <c:v>-0.84830881174049377</c:v>
                </c:pt>
                <c:pt idx="161">
                  <c:v>-2.0965809025141297E-2</c:v>
                </c:pt>
                <c:pt idx="162">
                  <c:v>1.1742794810860027</c:v>
                </c:pt>
                <c:pt idx="163">
                  <c:v>0.46523916474548171</c:v>
                </c:pt>
                <c:pt idx="164">
                  <c:v>6.2439139847485061E-3</c:v>
                </c:pt>
                <c:pt idx="165">
                  <c:v>-0.7627483643137507</c:v>
                </c:pt>
                <c:pt idx="166">
                  <c:v>-0.1966941716432577</c:v>
                </c:pt>
                <c:pt idx="167">
                  <c:v>0.55277749186386738</c:v>
                </c:pt>
                <c:pt idx="168">
                  <c:v>0.3725389869596345</c:v>
                </c:pt>
                <c:pt idx="169">
                  <c:v>-0.38987484068200529</c:v>
                </c:pt>
                <c:pt idx="170">
                  <c:v>0.18105137937558691</c:v>
                </c:pt>
                <c:pt idx="171">
                  <c:v>-1.62902665002656</c:v>
                </c:pt>
                <c:pt idx="172">
                  <c:v>1.9965999922617082E-2</c:v>
                </c:pt>
                <c:pt idx="173">
                  <c:v>0.91441532066733</c:v>
                </c:pt>
                <c:pt idx="174">
                  <c:v>0.68852853993060348</c:v>
                </c:pt>
                <c:pt idx="175">
                  <c:v>0.24088562765211402</c:v>
                </c:pt>
                <c:pt idx="176">
                  <c:v>-0.1133399400381111</c:v>
                </c:pt>
                <c:pt idx="177">
                  <c:v>0.56972499753625772</c:v>
                </c:pt>
                <c:pt idx="178">
                  <c:v>0.50437603374783302</c:v>
                </c:pt>
                <c:pt idx="179">
                  <c:v>0.65918210963170609</c:v>
                </c:pt>
                <c:pt idx="180">
                  <c:v>0.13855088672801813</c:v>
                </c:pt>
                <c:pt idx="181">
                  <c:v>-9.5515545217055686E-2</c:v>
                </c:pt>
                <c:pt idx="182">
                  <c:v>-5.9296112767487488E-2</c:v>
                </c:pt>
                <c:pt idx="183">
                  <c:v>3.384054335884585E-2</c:v>
                </c:pt>
                <c:pt idx="184">
                  <c:v>0.33906017067853639</c:v>
                </c:pt>
                <c:pt idx="185">
                  <c:v>0.3344990153555048</c:v>
                </c:pt>
                <c:pt idx="186">
                  <c:v>-0.2170092190407848</c:v>
                </c:pt>
                <c:pt idx="187">
                  <c:v>0.74332350801933977</c:v>
                </c:pt>
                <c:pt idx="188">
                  <c:v>0.36942513104357055</c:v>
                </c:pt>
                <c:pt idx="189">
                  <c:v>4.6074795104396098E-2</c:v>
                </c:pt>
                <c:pt idx="190">
                  <c:v>0.67632154502691821</c:v>
                </c:pt>
                <c:pt idx="191">
                  <c:v>0.95556242908801237</c:v>
                </c:pt>
                <c:pt idx="192">
                  <c:v>0.41785400013449242</c:v>
                </c:pt>
                <c:pt idx="193">
                  <c:v>0.19293558610784889</c:v>
                </c:pt>
                <c:pt idx="194">
                  <c:v>-1.2130433428800975</c:v>
                </c:pt>
                <c:pt idx="195">
                  <c:v>0.47096326278435552</c:v>
                </c:pt>
                <c:pt idx="196">
                  <c:v>-9.2967173832907493E-2</c:v>
                </c:pt>
                <c:pt idx="197">
                  <c:v>0.45148165189317518</c:v>
                </c:pt>
                <c:pt idx="198">
                  <c:v>9.9584074286332439E-2</c:v>
                </c:pt>
                <c:pt idx="199">
                  <c:v>0.86976185840285936</c:v>
                </c:pt>
                <c:pt idx="200">
                  <c:v>6.3127135664074463E-2</c:v>
                </c:pt>
                <c:pt idx="201">
                  <c:v>0.65038133718193525</c:v>
                </c:pt>
                <c:pt idx="202">
                  <c:v>0.76088113704754501</c:v>
                </c:pt>
                <c:pt idx="203">
                  <c:v>-0.57605402136373618</c:v>
                </c:pt>
                <c:pt idx="204">
                  <c:v>-0.63037180581202001</c:v>
                </c:pt>
                <c:pt idx="205">
                  <c:v>0.56622286797651411</c:v>
                </c:pt>
                <c:pt idx="206">
                  <c:v>-0.25873766142442989</c:v>
                </c:pt>
                <c:pt idx="207">
                  <c:v>0.77105546291829863</c:v>
                </c:pt>
                <c:pt idx="208">
                  <c:v>0.7193339712806579</c:v>
                </c:pt>
                <c:pt idx="209">
                  <c:v>-0.92127573329312373</c:v>
                </c:pt>
                <c:pt idx="210">
                  <c:v>7.1752952276664936E-2</c:v>
                </c:pt>
                <c:pt idx="211">
                  <c:v>0.46965697950898766</c:v>
                </c:pt>
                <c:pt idx="212">
                  <c:v>0.92835559321747219</c:v>
                </c:pt>
                <c:pt idx="213">
                  <c:v>0.62029318449400617</c:v>
                </c:pt>
                <c:pt idx="214">
                  <c:v>0.85976383606081563</c:v>
                </c:pt>
                <c:pt idx="215">
                  <c:v>0.61215611954272531</c:v>
                </c:pt>
                <c:pt idx="216">
                  <c:v>0.63856958511616224</c:v>
                </c:pt>
                <c:pt idx="217">
                  <c:v>0.12899281281663563</c:v>
                </c:pt>
                <c:pt idx="218">
                  <c:v>-0.10357249082831203</c:v>
                </c:pt>
                <c:pt idx="219">
                  <c:v>0.69339003470692151</c:v>
                </c:pt>
                <c:pt idx="220">
                  <c:v>0.9091479890766897</c:v>
                </c:pt>
                <c:pt idx="221">
                  <c:v>-7.5087608183806998E-2</c:v>
                </c:pt>
                <c:pt idx="222">
                  <c:v>0.31318008413955883</c:v>
                </c:pt>
                <c:pt idx="223">
                  <c:v>0.52628887217306919</c:v>
                </c:pt>
                <c:pt idx="224">
                  <c:v>0.2230293335809648</c:v>
                </c:pt>
                <c:pt idx="225">
                  <c:v>-0.80635755313404289</c:v>
                </c:pt>
                <c:pt idx="226">
                  <c:v>0.43160601319861092</c:v>
                </c:pt>
                <c:pt idx="227">
                  <c:v>0.16535424985419078</c:v>
                </c:pt>
                <c:pt idx="228">
                  <c:v>-2.2754307529211745E-2</c:v>
                </c:pt>
                <c:pt idx="229">
                  <c:v>0.93241292152120114</c:v>
                </c:pt>
                <c:pt idx="230">
                  <c:v>-0.77394909342429596</c:v>
                </c:pt>
                <c:pt idx="231">
                  <c:v>0.13401474722750972</c:v>
                </c:pt>
                <c:pt idx="232">
                  <c:v>3.0953949248556942E-3</c:v>
                </c:pt>
                <c:pt idx="233">
                  <c:v>5.8999637720057709E-2</c:v>
                </c:pt>
                <c:pt idx="234">
                  <c:v>0.2958534839967723</c:v>
                </c:pt>
                <c:pt idx="235">
                  <c:v>0.27539229180783376</c:v>
                </c:pt>
                <c:pt idx="236">
                  <c:v>0.3042591215347219</c:v>
                </c:pt>
                <c:pt idx="237">
                  <c:v>-0.27114568019595009</c:v>
                </c:pt>
              </c:numCache>
            </c:numRef>
          </c:yVal>
          <c:smooth val="0"/>
          <c:extLst>
            <c:ext xmlns:c16="http://schemas.microsoft.com/office/drawing/2014/chart" uri="{C3380CC4-5D6E-409C-BE32-E72D297353CC}">
              <c16:uniqueId val="{00000000-D249-4571-9238-9055A43AFA58}"/>
            </c:ext>
          </c:extLst>
        </c:ser>
        <c:ser>
          <c:idx val="1"/>
          <c:order val="1"/>
          <c:tx>
            <c:strRef>
              <c:f>'527 dn del no change prion'!$E$291</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C00000"/>
                </a:solidFill>
                <a:round/>
              </a:ln>
              <a:effectLst/>
            </c:spPr>
          </c:errBars>
          <c:xVal>
            <c:numRef>
              <c:f>'527 dn del no change prion'!$C$292:$C$529</c:f>
              <c:numCache>
                <c:formatCode>General</c:formatCode>
                <c:ptCount val="238"/>
                <c:pt idx="0">
                  <c:v>33448</c:v>
                </c:pt>
                <c:pt idx="1">
                  <c:v>36509</c:v>
                </c:pt>
                <c:pt idx="2">
                  <c:v>75043</c:v>
                </c:pt>
                <c:pt idx="3">
                  <c:v>76427</c:v>
                </c:pt>
                <c:pt idx="4">
                  <c:v>99305</c:v>
                </c:pt>
                <c:pt idx="5">
                  <c:v>114919</c:v>
                </c:pt>
                <c:pt idx="6">
                  <c:v>142367</c:v>
                </c:pt>
                <c:pt idx="7">
                  <c:v>169375</c:v>
                </c:pt>
                <c:pt idx="8">
                  <c:v>186512</c:v>
                </c:pt>
                <c:pt idx="9">
                  <c:v>201467</c:v>
                </c:pt>
                <c:pt idx="10">
                  <c:v>203403</c:v>
                </c:pt>
                <c:pt idx="11">
                  <c:v>290040</c:v>
                </c:pt>
                <c:pt idx="12">
                  <c:v>330181</c:v>
                </c:pt>
                <c:pt idx="13">
                  <c:v>357517</c:v>
                </c:pt>
                <c:pt idx="14">
                  <c:v>366216</c:v>
                </c:pt>
                <c:pt idx="15">
                  <c:v>366906</c:v>
                </c:pt>
                <c:pt idx="16">
                  <c:v>424340</c:v>
                </c:pt>
                <c:pt idx="17">
                  <c:v>476124</c:v>
                </c:pt>
                <c:pt idx="18">
                  <c:v>482781</c:v>
                </c:pt>
                <c:pt idx="19">
                  <c:v>504645</c:v>
                </c:pt>
                <c:pt idx="20">
                  <c:v>558391</c:v>
                </c:pt>
                <c:pt idx="21">
                  <c:v>567401</c:v>
                </c:pt>
                <c:pt idx="22">
                  <c:v>581473</c:v>
                </c:pt>
                <c:pt idx="23">
                  <c:v>757243</c:v>
                </c:pt>
                <c:pt idx="24">
                  <c:v>768094</c:v>
                </c:pt>
                <c:pt idx="25">
                  <c:v>783761</c:v>
                </c:pt>
                <c:pt idx="26">
                  <c:v>793421</c:v>
                </c:pt>
                <c:pt idx="27">
                  <c:v>836488</c:v>
                </c:pt>
                <c:pt idx="28">
                  <c:v>937746</c:v>
                </c:pt>
                <c:pt idx="29">
                  <c:v>957604</c:v>
                </c:pt>
                <c:pt idx="30">
                  <c:v>1032849</c:v>
                </c:pt>
                <c:pt idx="31">
                  <c:v>1116807</c:v>
                </c:pt>
                <c:pt idx="32">
                  <c:v>1150906</c:v>
                </c:pt>
                <c:pt idx="33">
                  <c:v>1199511</c:v>
                </c:pt>
                <c:pt idx="34">
                  <c:v>1284207</c:v>
                </c:pt>
                <c:pt idx="35">
                  <c:v>1307408</c:v>
                </c:pt>
                <c:pt idx="36">
                  <c:v>1404087</c:v>
                </c:pt>
                <c:pt idx="37">
                  <c:v>1498313</c:v>
                </c:pt>
                <c:pt idx="38">
                  <c:v>1548176</c:v>
                </c:pt>
                <c:pt idx="39">
                  <c:v>1723974</c:v>
                </c:pt>
                <c:pt idx="40">
                  <c:v>1742007</c:v>
                </c:pt>
                <c:pt idx="41">
                  <c:v>1744623</c:v>
                </c:pt>
                <c:pt idx="42">
                  <c:v>1747535</c:v>
                </c:pt>
                <c:pt idx="43">
                  <c:v>1771847</c:v>
                </c:pt>
                <c:pt idx="44">
                  <c:v>1906664</c:v>
                </c:pt>
                <c:pt idx="45">
                  <c:v>1927745</c:v>
                </c:pt>
                <c:pt idx="46">
                  <c:v>1929256</c:v>
                </c:pt>
                <c:pt idx="47">
                  <c:v>1996139</c:v>
                </c:pt>
                <c:pt idx="48">
                  <c:v>2018372</c:v>
                </c:pt>
                <c:pt idx="49">
                  <c:v>2025371</c:v>
                </c:pt>
                <c:pt idx="50">
                  <c:v>2104333</c:v>
                </c:pt>
                <c:pt idx="51">
                  <c:v>2232134</c:v>
                </c:pt>
                <c:pt idx="52">
                  <c:v>2514238</c:v>
                </c:pt>
                <c:pt idx="53">
                  <c:v>2594240</c:v>
                </c:pt>
                <c:pt idx="54">
                  <c:v>2627493</c:v>
                </c:pt>
                <c:pt idx="55">
                  <c:v>2652394</c:v>
                </c:pt>
                <c:pt idx="56">
                  <c:v>2661638</c:v>
                </c:pt>
                <c:pt idx="57">
                  <c:v>2684499</c:v>
                </c:pt>
                <c:pt idx="58">
                  <c:v>2762941</c:v>
                </c:pt>
                <c:pt idx="59">
                  <c:v>2845588</c:v>
                </c:pt>
                <c:pt idx="60">
                  <c:v>2936975</c:v>
                </c:pt>
                <c:pt idx="61">
                  <c:v>2944105</c:v>
                </c:pt>
                <c:pt idx="62">
                  <c:v>2993898</c:v>
                </c:pt>
                <c:pt idx="63">
                  <c:v>3045475</c:v>
                </c:pt>
                <c:pt idx="64">
                  <c:v>3064589</c:v>
                </c:pt>
                <c:pt idx="65">
                  <c:v>3102647</c:v>
                </c:pt>
                <c:pt idx="66">
                  <c:v>3127725</c:v>
                </c:pt>
                <c:pt idx="67">
                  <c:v>3256544</c:v>
                </c:pt>
                <c:pt idx="68">
                  <c:v>3479130</c:v>
                </c:pt>
                <c:pt idx="69">
                  <c:v>3481758</c:v>
                </c:pt>
                <c:pt idx="70">
                  <c:v>3492252</c:v>
                </c:pt>
                <c:pt idx="71">
                  <c:v>3549248</c:v>
                </c:pt>
                <c:pt idx="72">
                  <c:v>3569081</c:v>
                </c:pt>
                <c:pt idx="73">
                  <c:v>3576085</c:v>
                </c:pt>
                <c:pt idx="74">
                  <c:v>3834848</c:v>
                </c:pt>
                <c:pt idx="75">
                  <c:v>3880906</c:v>
                </c:pt>
                <c:pt idx="76">
                  <c:v>3887219</c:v>
                </c:pt>
                <c:pt idx="77">
                  <c:v>3895533</c:v>
                </c:pt>
                <c:pt idx="78">
                  <c:v>4020624</c:v>
                </c:pt>
                <c:pt idx="79">
                  <c:v>4109993</c:v>
                </c:pt>
                <c:pt idx="80">
                  <c:v>4137618</c:v>
                </c:pt>
                <c:pt idx="81">
                  <c:v>4179053</c:v>
                </c:pt>
                <c:pt idx="82">
                  <c:v>4182632</c:v>
                </c:pt>
                <c:pt idx="83">
                  <c:v>4294802</c:v>
                </c:pt>
                <c:pt idx="84">
                  <c:v>4296062</c:v>
                </c:pt>
                <c:pt idx="85">
                  <c:v>4361362</c:v>
                </c:pt>
                <c:pt idx="86">
                  <c:v>4383034</c:v>
                </c:pt>
                <c:pt idx="87">
                  <c:v>4387373</c:v>
                </c:pt>
                <c:pt idx="88">
                  <c:v>4393624</c:v>
                </c:pt>
                <c:pt idx="89">
                  <c:v>4401348</c:v>
                </c:pt>
                <c:pt idx="90">
                  <c:v>4659565</c:v>
                </c:pt>
                <c:pt idx="91">
                  <c:v>4701520</c:v>
                </c:pt>
                <c:pt idx="92">
                  <c:v>4806212</c:v>
                </c:pt>
                <c:pt idx="93">
                  <c:v>4838281</c:v>
                </c:pt>
                <c:pt idx="94">
                  <c:v>4865185</c:v>
                </c:pt>
                <c:pt idx="95">
                  <c:v>4886579</c:v>
                </c:pt>
                <c:pt idx="96">
                  <c:v>4934207</c:v>
                </c:pt>
                <c:pt idx="97">
                  <c:v>4943429</c:v>
                </c:pt>
                <c:pt idx="98">
                  <c:v>4952480</c:v>
                </c:pt>
                <c:pt idx="99">
                  <c:v>4977801</c:v>
                </c:pt>
                <c:pt idx="100">
                  <c:v>5017854</c:v>
                </c:pt>
                <c:pt idx="101">
                  <c:v>5059265</c:v>
                </c:pt>
                <c:pt idx="102">
                  <c:v>5071594</c:v>
                </c:pt>
                <c:pt idx="103">
                  <c:v>5106694</c:v>
                </c:pt>
                <c:pt idx="104">
                  <c:v>5110750</c:v>
                </c:pt>
                <c:pt idx="105">
                  <c:v>5192045</c:v>
                </c:pt>
                <c:pt idx="106">
                  <c:v>5211920</c:v>
                </c:pt>
                <c:pt idx="107">
                  <c:v>5249151</c:v>
                </c:pt>
                <c:pt idx="108">
                  <c:v>5334406</c:v>
                </c:pt>
                <c:pt idx="109">
                  <c:v>5415692</c:v>
                </c:pt>
                <c:pt idx="110">
                  <c:v>5421605</c:v>
                </c:pt>
                <c:pt idx="111">
                  <c:v>5509597</c:v>
                </c:pt>
                <c:pt idx="112">
                  <c:v>5615510</c:v>
                </c:pt>
                <c:pt idx="113">
                  <c:v>5720780</c:v>
                </c:pt>
                <c:pt idx="114">
                  <c:v>5725584</c:v>
                </c:pt>
                <c:pt idx="115">
                  <c:v>5728239</c:v>
                </c:pt>
                <c:pt idx="116">
                  <c:v>5788572</c:v>
                </c:pt>
                <c:pt idx="117">
                  <c:v>5798833</c:v>
                </c:pt>
                <c:pt idx="118">
                  <c:v>5823071</c:v>
                </c:pt>
                <c:pt idx="119">
                  <c:v>5869218</c:v>
                </c:pt>
                <c:pt idx="120">
                  <c:v>5872655</c:v>
                </c:pt>
                <c:pt idx="121">
                  <c:v>5907371</c:v>
                </c:pt>
                <c:pt idx="122">
                  <c:v>5989011</c:v>
                </c:pt>
                <c:pt idx="123">
                  <c:v>6126508</c:v>
                </c:pt>
                <c:pt idx="124">
                  <c:v>6181505</c:v>
                </c:pt>
                <c:pt idx="125">
                  <c:v>6288700</c:v>
                </c:pt>
                <c:pt idx="126">
                  <c:v>6387656</c:v>
                </c:pt>
                <c:pt idx="127">
                  <c:v>6412666</c:v>
                </c:pt>
                <c:pt idx="128">
                  <c:v>6444874</c:v>
                </c:pt>
                <c:pt idx="129">
                  <c:v>6472403</c:v>
                </c:pt>
                <c:pt idx="130">
                  <c:v>6584319</c:v>
                </c:pt>
                <c:pt idx="131">
                  <c:v>6620635</c:v>
                </c:pt>
                <c:pt idx="132">
                  <c:v>6764628</c:v>
                </c:pt>
                <c:pt idx="133">
                  <c:v>6912624</c:v>
                </c:pt>
                <c:pt idx="134">
                  <c:v>7010118</c:v>
                </c:pt>
                <c:pt idx="135">
                  <c:v>7063356</c:v>
                </c:pt>
                <c:pt idx="136">
                  <c:v>7158039</c:v>
                </c:pt>
                <c:pt idx="137">
                  <c:v>7267502</c:v>
                </c:pt>
                <c:pt idx="138">
                  <c:v>7414131</c:v>
                </c:pt>
                <c:pt idx="139">
                  <c:v>7415010</c:v>
                </c:pt>
                <c:pt idx="140">
                  <c:v>7448318</c:v>
                </c:pt>
                <c:pt idx="141">
                  <c:v>7526047</c:v>
                </c:pt>
                <c:pt idx="142">
                  <c:v>7615819</c:v>
                </c:pt>
                <c:pt idx="143">
                  <c:v>7700461</c:v>
                </c:pt>
                <c:pt idx="144">
                  <c:v>7746288</c:v>
                </c:pt>
                <c:pt idx="145">
                  <c:v>7760290</c:v>
                </c:pt>
                <c:pt idx="146">
                  <c:v>7881808</c:v>
                </c:pt>
                <c:pt idx="147">
                  <c:v>7949511</c:v>
                </c:pt>
                <c:pt idx="148">
                  <c:v>7957565</c:v>
                </c:pt>
                <c:pt idx="149">
                  <c:v>8039965</c:v>
                </c:pt>
                <c:pt idx="150">
                  <c:v>8064340</c:v>
                </c:pt>
                <c:pt idx="151">
                  <c:v>8118774</c:v>
                </c:pt>
                <c:pt idx="152">
                  <c:v>8176093</c:v>
                </c:pt>
                <c:pt idx="153">
                  <c:v>8179442</c:v>
                </c:pt>
                <c:pt idx="154">
                  <c:v>8257529</c:v>
                </c:pt>
                <c:pt idx="155">
                  <c:v>8275862</c:v>
                </c:pt>
                <c:pt idx="156">
                  <c:v>8446432</c:v>
                </c:pt>
                <c:pt idx="157">
                  <c:v>8469687</c:v>
                </c:pt>
                <c:pt idx="158">
                  <c:v>8513449</c:v>
                </c:pt>
                <c:pt idx="159">
                  <c:v>8549094</c:v>
                </c:pt>
                <c:pt idx="160">
                  <c:v>8600766</c:v>
                </c:pt>
                <c:pt idx="161">
                  <c:v>8603795</c:v>
                </c:pt>
                <c:pt idx="162">
                  <c:v>8620930</c:v>
                </c:pt>
                <c:pt idx="163">
                  <c:v>8630694</c:v>
                </c:pt>
                <c:pt idx="164">
                  <c:v>8646505</c:v>
                </c:pt>
                <c:pt idx="165">
                  <c:v>8691299</c:v>
                </c:pt>
                <c:pt idx="166">
                  <c:v>8780490</c:v>
                </c:pt>
                <c:pt idx="167">
                  <c:v>8801269</c:v>
                </c:pt>
                <c:pt idx="168">
                  <c:v>8830707</c:v>
                </c:pt>
                <c:pt idx="169">
                  <c:v>8974350</c:v>
                </c:pt>
                <c:pt idx="170">
                  <c:v>9024995</c:v>
                </c:pt>
                <c:pt idx="171">
                  <c:v>9035521</c:v>
                </c:pt>
                <c:pt idx="172">
                  <c:v>9049139</c:v>
                </c:pt>
                <c:pt idx="173">
                  <c:v>9112583</c:v>
                </c:pt>
                <c:pt idx="174">
                  <c:v>9210208</c:v>
                </c:pt>
                <c:pt idx="175">
                  <c:v>9216193</c:v>
                </c:pt>
                <c:pt idx="176">
                  <c:v>9259844</c:v>
                </c:pt>
                <c:pt idx="177">
                  <c:v>9260903</c:v>
                </c:pt>
                <c:pt idx="178">
                  <c:v>9271684</c:v>
                </c:pt>
                <c:pt idx="179">
                  <c:v>9313380</c:v>
                </c:pt>
                <c:pt idx="180">
                  <c:v>9335533</c:v>
                </c:pt>
                <c:pt idx="181">
                  <c:v>9360907</c:v>
                </c:pt>
                <c:pt idx="182">
                  <c:v>9428997</c:v>
                </c:pt>
                <c:pt idx="183">
                  <c:v>9507214</c:v>
                </c:pt>
                <c:pt idx="184">
                  <c:v>9520346</c:v>
                </c:pt>
                <c:pt idx="185">
                  <c:v>9535630</c:v>
                </c:pt>
                <c:pt idx="186">
                  <c:v>9577965</c:v>
                </c:pt>
                <c:pt idx="187">
                  <c:v>9595402</c:v>
                </c:pt>
                <c:pt idx="188">
                  <c:v>9665462</c:v>
                </c:pt>
                <c:pt idx="189">
                  <c:v>9713970</c:v>
                </c:pt>
                <c:pt idx="190">
                  <c:v>9733243</c:v>
                </c:pt>
                <c:pt idx="191">
                  <c:v>9818113</c:v>
                </c:pt>
                <c:pt idx="192">
                  <c:v>9963756</c:v>
                </c:pt>
                <c:pt idx="193">
                  <c:v>9968756</c:v>
                </c:pt>
                <c:pt idx="194">
                  <c:v>10066627</c:v>
                </c:pt>
                <c:pt idx="195">
                  <c:v>10085067</c:v>
                </c:pt>
                <c:pt idx="196">
                  <c:v>10128577</c:v>
                </c:pt>
                <c:pt idx="197">
                  <c:v>10135286</c:v>
                </c:pt>
                <c:pt idx="198">
                  <c:v>10193642</c:v>
                </c:pt>
                <c:pt idx="199">
                  <c:v>10212527</c:v>
                </c:pt>
                <c:pt idx="200">
                  <c:v>10291458</c:v>
                </c:pt>
                <c:pt idx="201">
                  <c:v>10297398</c:v>
                </c:pt>
                <c:pt idx="202">
                  <c:v>10300156</c:v>
                </c:pt>
                <c:pt idx="203">
                  <c:v>10337318</c:v>
                </c:pt>
                <c:pt idx="204">
                  <c:v>10479408</c:v>
                </c:pt>
                <c:pt idx="205">
                  <c:v>10527096</c:v>
                </c:pt>
                <c:pt idx="206">
                  <c:v>10668908</c:v>
                </c:pt>
                <c:pt idx="207">
                  <c:v>10712654</c:v>
                </c:pt>
                <c:pt idx="208">
                  <c:v>10774879</c:v>
                </c:pt>
                <c:pt idx="209">
                  <c:v>10790299</c:v>
                </c:pt>
                <c:pt idx="210">
                  <c:v>10793583</c:v>
                </c:pt>
                <c:pt idx="211">
                  <c:v>10866421</c:v>
                </c:pt>
                <c:pt idx="212">
                  <c:v>10873927</c:v>
                </c:pt>
                <c:pt idx="213">
                  <c:v>10880447</c:v>
                </c:pt>
                <c:pt idx="214">
                  <c:v>10933827</c:v>
                </c:pt>
                <c:pt idx="215">
                  <c:v>10943753</c:v>
                </c:pt>
                <c:pt idx="216">
                  <c:v>10986313</c:v>
                </c:pt>
                <c:pt idx="217">
                  <c:v>11013797</c:v>
                </c:pt>
                <c:pt idx="218">
                  <c:v>11018868</c:v>
                </c:pt>
                <c:pt idx="219">
                  <c:v>11026987</c:v>
                </c:pt>
                <c:pt idx="220">
                  <c:v>11097012</c:v>
                </c:pt>
                <c:pt idx="221">
                  <c:v>11399422</c:v>
                </c:pt>
                <c:pt idx="222">
                  <c:v>11426381</c:v>
                </c:pt>
                <c:pt idx="223">
                  <c:v>11508033</c:v>
                </c:pt>
                <c:pt idx="224">
                  <c:v>11555155</c:v>
                </c:pt>
                <c:pt idx="225">
                  <c:v>11555848</c:v>
                </c:pt>
                <c:pt idx="226">
                  <c:v>11610622</c:v>
                </c:pt>
                <c:pt idx="227">
                  <c:v>11625733</c:v>
                </c:pt>
                <c:pt idx="228">
                  <c:v>11683829</c:v>
                </c:pt>
                <c:pt idx="229">
                  <c:v>11771964</c:v>
                </c:pt>
                <c:pt idx="230">
                  <c:v>11777426</c:v>
                </c:pt>
                <c:pt idx="231">
                  <c:v>11872516</c:v>
                </c:pt>
                <c:pt idx="232">
                  <c:v>11901843</c:v>
                </c:pt>
                <c:pt idx="233">
                  <c:v>11944992</c:v>
                </c:pt>
                <c:pt idx="234">
                  <c:v>11991905</c:v>
                </c:pt>
                <c:pt idx="235">
                  <c:v>12032993</c:v>
                </c:pt>
                <c:pt idx="236">
                  <c:v>12040337</c:v>
                </c:pt>
                <c:pt idx="237">
                  <c:v>12047564</c:v>
                </c:pt>
              </c:numCache>
            </c:numRef>
          </c:xVal>
          <c:yVal>
            <c:numRef>
              <c:f>'527 dn del no change prion'!$E$292:$E$529</c:f>
              <c:numCache>
                <c:formatCode>General</c:formatCode>
                <c:ptCount val="238"/>
                <c:pt idx="0">
                  <c:v>-1.0375340652357803</c:v>
                </c:pt>
                <c:pt idx="1">
                  <c:v>-1.5783699572895293</c:v>
                </c:pt>
                <c:pt idx="2">
                  <c:v>-1.0945774993062349</c:v>
                </c:pt>
                <c:pt idx="3">
                  <c:v>-2.7075912792902894</c:v>
                </c:pt>
                <c:pt idx="4">
                  <c:v>-1.727765251360591</c:v>
                </c:pt>
                <c:pt idx="5">
                  <c:v>-1.3670350636765503</c:v>
                </c:pt>
                <c:pt idx="6">
                  <c:v>-1.1571760632074568</c:v>
                </c:pt>
                <c:pt idx="7">
                  <c:v>-1.6153367868354533</c:v>
                </c:pt>
                <c:pt idx="8">
                  <c:v>-1.653046544680117</c:v>
                </c:pt>
                <c:pt idx="9">
                  <c:v>-0.99241031974615368</c:v>
                </c:pt>
                <c:pt idx="10">
                  <c:v>-1.4281670957710724</c:v>
                </c:pt>
                <c:pt idx="11">
                  <c:v>-1.2697142539762944</c:v>
                </c:pt>
                <c:pt idx="12">
                  <c:v>-1.1311383122173697</c:v>
                </c:pt>
                <c:pt idx="13">
                  <c:v>-1.6871660708644018</c:v>
                </c:pt>
                <c:pt idx="14">
                  <c:v>-1.6208775707582213</c:v>
                </c:pt>
                <c:pt idx="15">
                  <c:v>-2.4730828524113275</c:v>
                </c:pt>
                <c:pt idx="16">
                  <c:v>-3.1777257322399701</c:v>
                </c:pt>
                <c:pt idx="17">
                  <c:v>-1.0867378604453424</c:v>
                </c:pt>
                <c:pt idx="18">
                  <c:v>-1.3747443292734993</c:v>
                </c:pt>
                <c:pt idx="19">
                  <c:v>-1.0659444756502794</c:v>
                </c:pt>
                <c:pt idx="20">
                  <c:v>-2.3308855685649088</c:v>
                </c:pt>
                <c:pt idx="21">
                  <c:v>-1.0561621146083384</c:v>
                </c:pt>
                <c:pt idx="22">
                  <c:v>-1.9679761882331903</c:v>
                </c:pt>
                <c:pt idx="23">
                  <c:v>-1.1390307748381006</c:v>
                </c:pt>
                <c:pt idx="24">
                  <c:v>-1.8798466353619514</c:v>
                </c:pt>
                <c:pt idx="25">
                  <c:v>-0.99643586941838369</c:v>
                </c:pt>
                <c:pt idx="26">
                  <c:v>-1.8968110974859411</c:v>
                </c:pt>
                <c:pt idx="27">
                  <c:v>-1.0396588473152877</c:v>
                </c:pt>
                <c:pt idx="28">
                  <c:v>-1.7871219428831695</c:v>
                </c:pt>
                <c:pt idx="29">
                  <c:v>-1.1939593822295853</c:v>
                </c:pt>
                <c:pt idx="30">
                  <c:v>-1.4090406668831774</c:v>
                </c:pt>
                <c:pt idx="31">
                  <c:v>-1.0306910446119673</c:v>
                </c:pt>
                <c:pt idx="32">
                  <c:v>-2.9493623427066504</c:v>
                </c:pt>
                <c:pt idx="33">
                  <c:v>-1.0469687763443707</c:v>
                </c:pt>
                <c:pt idx="34">
                  <c:v>-1.4673322328114466</c:v>
                </c:pt>
                <c:pt idx="35">
                  <c:v>-1.192106975236132</c:v>
                </c:pt>
                <c:pt idx="36">
                  <c:v>-1.2361095010538232</c:v>
                </c:pt>
                <c:pt idx="37">
                  <c:v>-2.9991393573980187</c:v>
                </c:pt>
                <c:pt idx="38">
                  <c:v>-2.5367691501393246</c:v>
                </c:pt>
                <c:pt idx="39">
                  <c:v>-1.0449442950658476</c:v>
                </c:pt>
                <c:pt idx="40">
                  <c:v>-1.0313845821982788</c:v>
                </c:pt>
                <c:pt idx="41">
                  <c:v>-1.0151527977301364</c:v>
                </c:pt>
                <c:pt idx="42">
                  <c:v>-1.9778510205730087</c:v>
                </c:pt>
                <c:pt idx="43">
                  <c:v>-1.6408546242170927</c:v>
                </c:pt>
                <c:pt idx="44">
                  <c:v>-1.6249614947548126</c:v>
                </c:pt>
                <c:pt idx="45">
                  <c:v>-1.2181243006655249</c:v>
                </c:pt>
                <c:pt idx="46">
                  <c:v>-1.4892554810431327</c:v>
                </c:pt>
                <c:pt idx="47">
                  <c:v>-1.7235901790750228</c:v>
                </c:pt>
                <c:pt idx="48">
                  <c:v>-1.3284262281499164</c:v>
                </c:pt>
                <c:pt idx="49">
                  <c:v>-1.3948736839894524</c:v>
                </c:pt>
                <c:pt idx="50">
                  <c:v>-1.3231221694042357</c:v>
                </c:pt>
                <c:pt idx="51">
                  <c:v>-1.6859007514374615</c:v>
                </c:pt>
                <c:pt idx="52">
                  <c:v>-1.630859981453745</c:v>
                </c:pt>
                <c:pt idx="53">
                  <c:v>-1.5020718439655834</c:v>
                </c:pt>
                <c:pt idx="54">
                  <c:v>-1.4242754076408974</c:v>
                </c:pt>
                <c:pt idx="55">
                  <c:v>-1.0113302605362293</c:v>
                </c:pt>
                <c:pt idx="56">
                  <c:v>-1.1761002114198253</c:v>
                </c:pt>
                <c:pt idx="57">
                  <c:v>-1.0966106340112081</c:v>
                </c:pt>
                <c:pt idx="58">
                  <c:v>-1.1396591985749205</c:v>
                </c:pt>
                <c:pt idx="59">
                  <c:v>-2.7885233656512529</c:v>
                </c:pt>
                <c:pt idx="60">
                  <c:v>-1.2787544062711524</c:v>
                </c:pt>
                <c:pt idx="61">
                  <c:v>-1.4147586190825847</c:v>
                </c:pt>
                <c:pt idx="62">
                  <c:v>-1.2534318826835813</c:v>
                </c:pt>
                <c:pt idx="63">
                  <c:v>-2.4259396451226474</c:v>
                </c:pt>
                <c:pt idx="64">
                  <c:v>-1.2704151077678405</c:v>
                </c:pt>
                <c:pt idx="65">
                  <c:v>-1.2988260776025851</c:v>
                </c:pt>
                <c:pt idx="66">
                  <c:v>-1.4380318297859902</c:v>
                </c:pt>
                <c:pt idx="67">
                  <c:v>-2.0133969256619522</c:v>
                </c:pt>
                <c:pt idx="68">
                  <c:v>-1.7630526308515366</c:v>
                </c:pt>
                <c:pt idx="69">
                  <c:v>-1.4485116082006997</c:v>
                </c:pt>
                <c:pt idx="70">
                  <c:v>-1.0014817929777382</c:v>
                </c:pt>
                <c:pt idx="71">
                  <c:v>-2.1848639585261518</c:v>
                </c:pt>
                <c:pt idx="72">
                  <c:v>-1.3242702805107409</c:v>
                </c:pt>
                <c:pt idx="73">
                  <c:v>-1.4130720182852474</c:v>
                </c:pt>
                <c:pt idx="74">
                  <c:v>-2.1262544619672066</c:v>
                </c:pt>
                <c:pt idx="75">
                  <c:v>-1.0183053994501856</c:v>
                </c:pt>
                <c:pt idx="76">
                  <c:v>-1.1887776343673966</c:v>
                </c:pt>
                <c:pt idx="77">
                  <c:v>-1.2271026704803227</c:v>
                </c:pt>
                <c:pt idx="78">
                  <c:v>-1.8910860672378285</c:v>
                </c:pt>
                <c:pt idx="79">
                  <c:v>-1.4788963454615009</c:v>
                </c:pt>
                <c:pt idx="80">
                  <c:v>-1.0901318825883159</c:v>
                </c:pt>
                <c:pt idx="81">
                  <c:v>-1.976524115412376</c:v>
                </c:pt>
                <c:pt idx="82">
                  <c:v>-1.0978185958951523</c:v>
                </c:pt>
                <c:pt idx="83">
                  <c:v>-1.308134532799343</c:v>
                </c:pt>
                <c:pt idx="84">
                  <c:v>-1.7476171786925976</c:v>
                </c:pt>
                <c:pt idx="85">
                  <c:v>-1.3987948769039424</c:v>
                </c:pt>
                <c:pt idx="86">
                  <c:v>-1.1054980053994203</c:v>
                </c:pt>
                <c:pt idx="87">
                  <c:v>-1.0927750538796823</c:v>
                </c:pt>
                <c:pt idx="88">
                  <c:v>-3.0288410839804016</c:v>
                </c:pt>
                <c:pt idx="89">
                  <c:v>-1.0359728408623485</c:v>
                </c:pt>
                <c:pt idx="90">
                  <c:v>-1.0290608309472986</c:v>
                </c:pt>
                <c:pt idx="91">
                  <c:v>-1.2733787106227092</c:v>
                </c:pt>
                <c:pt idx="92">
                  <c:v>-1.7031693924934008</c:v>
                </c:pt>
                <c:pt idx="93">
                  <c:v>-4.8311364602615976</c:v>
                </c:pt>
                <c:pt idx="94">
                  <c:v>-1.4010990728157846</c:v>
                </c:pt>
                <c:pt idx="95">
                  <c:v>-2.5279988941549481</c:v>
                </c:pt>
                <c:pt idx="96">
                  <c:v>-1.0384823671353427</c:v>
                </c:pt>
                <c:pt idx="97">
                  <c:v>-1.5545741807077937</c:v>
                </c:pt>
                <c:pt idx="98">
                  <c:v>-1.0712233118340189</c:v>
                </c:pt>
                <c:pt idx="99">
                  <c:v>-1.2963046704059844</c:v>
                </c:pt>
                <c:pt idx="100">
                  <c:v>-1.644405215147857</c:v>
                </c:pt>
                <c:pt idx="101">
                  <c:v>-1.2714913244799497</c:v>
                </c:pt>
                <c:pt idx="102">
                  <c:v>-1.7967325152830735</c:v>
                </c:pt>
                <c:pt idx="103">
                  <c:v>-1.7099713778383863</c:v>
                </c:pt>
                <c:pt idx="104">
                  <c:v>-1.2541962037382797</c:v>
                </c:pt>
                <c:pt idx="105">
                  <c:v>-1.798978896805602</c:v>
                </c:pt>
                <c:pt idx="106">
                  <c:v>-1.0134177425069804</c:v>
                </c:pt>
                <c:pt idx="107">
                  <c:v>-1.3605027132429104</c:v>
                </c:pt>
                <c:pt idx="108">
                  <c:v>-1.4651113097072195</c:v>
                </c:pt>
                <c:pt idx="109">
                  <c:v>-1.7476415262453715</c:v>
                </c:pt>
                <c:pt idx="110">
                  <c:v>-2.248836763604134</c:v>
                </c:pt>
                <c:pt idx="111">
                  <c:v>-1.3083097917668121</c:v>
                </c:pt>
                <c:pt idx="112">
                  <c:v>-1.4831802683719648</c:v>
                </c:pt>
                <c:pt idx="113">
                  <c:v>-1.1933292369988071</c:v>
                </c:pt>
                <c:pt idx="114">
                  <c:v>-1.1006015347295108</c:v>
                </c:pt>
                <c:pt idx="115">
                  <c:v>-1.1266148609497169</c:v>
                </c:pt>
                <c:pt idx="116">
                  <c:v>-1.5230214278908869</c:v>
                </c:pt>
                <c:pt idx="117">
                  <c:v>-1.1763368189425871</c:v>
                </c:pt>
                <c:pt idx="118">
                  <c:v>-1.2690608978286682</c:v>
                </c:pt>
                <c:pt idx="119">
                  <c:v>-1.3161227399288107</c:v>
                </c:pt>
                <c:pt idx="120">
                  <c:v>-1.7519640326867423</c:v>
                </c:pt>
                <c:pt idx="121">
                  <c:v>-1.0064707977654124</c:v>
                </c:pt>
                <c:pt idx="122">
                  <c:v>-1.1582591361121657</c:v>
                </c:pt>
                <c:pt idx="123">
                  <c:v>-1.0179400432059775</c:v>
                </c:pt>
                <c:pt idx="124">
                  <c:v>-1.1704958890795418</c:v>
                </c:pt>
                <c:pt idx="125">
                  <c:v>-1.2871638787361528</c:v>
                </c:pt>
                <c:pt idx="126">
                  <c:v>-1.1501872973826741</c:v>
                </c:pt>
                <c:pt idx="127">
                  <c:v>-1.1730938697878692</c:v>
                </c:pt>
                <c:pt idx="128">
                  <c:v>-1.6774073467695969</c:v>
                </c:pt>
                <c:pt idx="129">
                  <c:v>-1.795170333370492</c:v>
                </c:pt>
                <c:pt idx="130">
                  <c:v>-1.9137077046962856</c:v>
                </c:pt>
                <c:pt idx="131">
                  <c:v>-2.0051191280394423</c:v>
                </c:pt>
                <c:pt idx="132">
                  <c:v>-1.3794641828602141</c:v>
                </c:pt>
                <c:pt idx="133">
                  <c:v>-1.457557200166151</c:v>
                </c:pt>
                <c:pt idx="134">
                  <c:v>-1.3385348427576353</c:v>
                </c:pt>
                <c:pt idx="135">
                  <c:v>-1.2925597948931078</c:v>
                </c:pt>
                <c:pt idx="136">
                  <c:v>-1.7756114628251005</c:v>
                </c:pt>
                <c:pt idx="137">
                  <c:v>-1.18837137073483</c:v>
                </c:pt>
                <c:pt idx="138">
                  <c:v>-1.6858187208951705</c:v>
                </c:pt>
                <c:pt idx="139">
                  <c:v>-1.7100579890217309</c:v>
                </c:pt>
                <c:pt idx="140">
                  <c:v>-1.5116968078547122</c:v>
                </c:pt>
                <c:pt idx="141">
                  <c:v>-1.0608298280915198</c:v>
                </c:pt>
                <c:pt idx="142">
                  <c:v>-1.1540550031946668</c:v>
                </c:pt>
                <c:pt idx="143">
                  <c:v>-1.1263545568535989</c:v>
                </c:pt>
                <c:pt idx="144">
                  <c:v>-1.2161950098831249</c:v>
                </c:pt>
                <c:pt idx="145">
                  <c:v>-2.0182497546330316</c:v>
                </c:pt>
                <c:pt idx="146">
                  <c:v>-1.0180995923245566</c:v>
                </c:pt>
                <c:pt idx="147">
                  <c:v>-1.0467484275296057</c:v>
                </c:pt>
                <c:pt idx="148">
                  <c:v>-1.1884217250375206</c:v>
                </c:pt>
                <c:pt idx="149">
                  <c:v>-3.0309338891690083</c:v>
                </c:pt>
                <c:pt idx="150">
                  <c:v>-1.2891003095066456</c:v>
                </c:pt>
                <c:pt idx="151">
                  <c:v>-1.2834702269067126</c:v>
                </c:pt>
                <c:pt idx="152">
                  <c:v>-1.2340031619737548</c:v>
                </c:pt>
                <c:pt idx="153">
                  <c:v>-1.3709253955291814</c:v>
                </c:pt>
                <c:pt idx="154">
                  <c:v>-1.2195039028511114</c:v>
                </c:pt>
                <c:pt idx="155">
                  <c:v>-1.5276332941103365</c:v>
                </c:pt>
                <c:pt idx="156">
                  <c:v>-1.2734884834471552</c:v>
                </c:pt>
                <c:pt idx="157">
                  <c:v>-1.2319555703768625</c:v>
                </c:pt>
                <c:pt idx="158">
                  <c:v>-1.0082562235377033</c:v>
                </c:pt>
                <c:pt idx="159">
                  <c:v>-1.2476770723774184</c:v>
                </c:pt>
                <c:pt idx="160">
                  <c:v>-1.2980907598972353</c:v>
                </c:pt>
                <c:pt idx="161">
                  <c:v>-1.1064733767178039</c:v>
                </c:pt>
                <c:pt idx="162">
                  <c:v>-1.9673328597118598</c:v>
                </c:pt>
                <c:pt idx="163">
                  <c:v>-1.3188073967030438</c:v>
                </c:pt>
                <c:pt idx="164">
                  <c:v>-1.5023381907681008</c:v>
                </c:pt>
                <c:pt idx="165">
                  <c:v>-1.2197817565279929</c:v>
                </c:pt>
                <c:pt idx="166">
                  <c:v>-2.3470263907541353</c:v>
                </c:pt>
                <c:pt idx="167">
                  <c:v>-1.4125929838527298</c:v>
                </c:pt>
                <c:pt idx="168">
                  <c:v>-1.4415766936746297</c:v>
                </c:pt>
                <c:pt idx="169">
                  <c:v>-2.6831725248981191</c:v>
                </c:pt>
                <c:pt idx="170">
                  <c:v>-1.0893421635407987</c:v>
                </c:pt>
                <c:pt idx="171">
                  <c:v>-3.3247150667449548</c:v>
                </c:pt>
                <c:pt idx="172">
                  <c:v>-0.99375984937452888</c:v>
                </c:pt>
                <c:pt idx="173">
                  <c:v>-1.2161164081626108</c:v>
                </c:pt>
                <c:pt idx="174">
                  <c:v>-1.4256273377765725</c:v>
                </c:pt>
                <c:pt idx="175">
                  <c:v>-1.58257204882292</c:v>
                </c:pt>
                <c:pt idx="176">
                  <c:v>-1.0101227282269822</c:v>
                </c:pt>
                <c:pt idx="177">
                  <c:v>-1.1177598929320745</c:v>
                </c:pt>
                <c:pt idx="178">
                  <c:v>-1.6139389016125862</c:v>
                </c:pt>
                <c:pt idx="179">
                  <c:v>-1.1689307647492058</c:v>
                </c:pt>
                <c:pt idx="180">
                  <c:v>-1.1036597150207428</c:v>
                </c:pt>
                <c:pt idx="181">
                  <c:v>-1.381726751371422</c:v>
                </c:pt>
                <c:pt idx="182">
                  <c:v>-1.4778284743606338</c:v>
                </c:pt>
                <c:pt idx="183">
                  <c:v>-1.0938988748785659</c:v>
                </c:pt>
                <c:pt idx="184">
                  <c:v>-1.1615209319459239</c:v>
                </c:pt>
                <c:pt idx="185">
                  <c:v>-1.3038261920490111</c:v>
                </c:pt>
                <c:pt idx="186">
                  <c:v>-2.2742938251170584</c:v>
                </c:pt>
                <c:pt idx="187">
                  <c:v>-1.4708323705939366</c:v>
                </c:pt>
                <c:pt idx="188">
                  <c:v>-1.0058211170704203</c:v>
                </c:pt>
                <c:pt idx="189">
                  <c:v>-1.2168617297093574</c:v>
                </c:pt>
                <c:pt idx="190">
                  <c:v>-1.2599887858314374</c:v>
                </c:pt>
                <c:pt idx="191">
                  <c:v>-1.1483047621833788</c:v>
                </c:pt>
                <c:pt idx="192">
                  <c:v>-1.4386588908582354</c:v>
                </c:pt>
                <c:pt idx="193">
                  <c:v>-1.2016344069624476</c:v>
                </c:pt>
                <c:pt idx="194">
                  <c:v>-1.7640363372694732</c:v>
                </c:pt>
                <c:pt idx="195">
                  <c:v>-1.5233076723573662</c:v>
                </c:pt>
                <c:pt idx="196">
                  <c:v>-1.5958306363211732</c:v>
                </c:pt>
                <c:pt idx="197">
                  <c:v>-1.2575579643919483</c:v>
                </c:pt>
                <c:pt idx="198">
                  <c:v>-1.7984240573425569</c:v>
                </c:pt>
                <c:pt idx="199">
                  <c:v>-2.0659939057226087</c:v>
                </c:pt>
                <c:pt idx="200">
                  <c:v>-1.1338905826231793</c:v>
                </c:pt>
                <c:pt idx="201">
                  <c:v>-1.5687647752991105</c:v>
                </c:pt>
                <c:pt idx="202">
                  <c:v>-1.8725445011860991</c:v>
                </c:pt>
                <c:pt idx="203">
                  <c:v>-1.0412944930439452</c:v>
                </c:pt>
                <c:pt idx="204">
                  <c:v>-1.1495521274064235</c:v>
                </c:pt>
                <c:pt idx="205">
                  <c:v>-1.0426266458305689</c:v>
                </c:pt>
                <c:pt idx="206">
                  <c:v>-2.4578780113992633</c:v>
                </c:pt>
                <c:pt idx="207">
                  <c:v>-1.04080181688776</c:v>
                </c:pt>
                <c:pt idx="208">
                  <c:v>-1.6257083759821249</c:v>
                </c:pt>
                <c:pt idx="209">
                  <c:v>-1.5159438520091604</c:v>
                </c:pt>
                <c:pt idx="210">
                  <c:v>-1.06394011574261</c:v>
                </c:pt>
                <c:pt idx="211">
                  <c:v>-1.2574482234967912</c:v>
                </c:pt>
                <c:pt idx="212">
                  <c:v>-2.1436045727192399</c:v>
                </c:pt>
                <c:pt idx="213">
                  <c:v>-1.1587105855370663</c:v>
                </c:pt>
                <c:pt idx="214">
                  <c:v>-1.7698922943031548</c:v>
                </c:pt>
                <c:pt idx="215">
                  <c:v>-1.5522475599393359</c:v>
                </c:pt>
                <c:pt idx="216">
                  <c:v>-1.2408114996941877</c:v>
                </c:pt>
                <c:pt idx="217">
                  <c:v>-1.8103243186739129</c:v>
                </c:pt>
                <c:pt idx="218">
                  <c:v>-1.6172881381302022</c:v>
                </c:pt>
                <c:pt idx="219">
                  <c:v>-1.1891287331066058</c:v>
                </c:pt>
                <c:pt idx="220">
                  <c:v>-1.3496633364375523</c:v>
                </c:pt>
                <c:pt idx="221">
                  <c:v>-1.4608498616118872</c:v>
                </c:pt>
                <c:pt idx="222">
                  <c:v>-1.6857916649409923</c:v>
                </c:pt>
                <c:pt idx="223">
                  <c:v>-1.2716841040994822</c:v>
                </c:pt>
                <c:pt idx="224">
                  <c:v>-1.2260132794651595</c:v>
                </c:pt>
                <c:pt idx="225">
                  <c:v>-1.0132144456499916</c:v>
                </c:pt>
                <c:pt idx="226">
                  <c:v>-1.0997965465184727</c:v>
                </c:pt>
                <c:pt idx="227">
                  <c:v>-3.8307626616237833</c:v>
                </c:pt>
                <c:pt idx="228">
                  <c:v>-1.4303171095912179</c:v>
                </c:pt>
                <c:pt idx="229">
                  <c:v>-1.1887263947757007</c:v>
                </c:pt>
                <c:pt idx="230">
                  <c:v>-1.430720358908697</c:v>
                </c:pt>
                <c:pt idx="231">
                  <c:v>-1.3010941925916486</c:v>
                </c:pt>
                <c:pt idx="232">
                  <c:v>-1.2779186694582534</c:v>
                </c:pt>
                <c:pt idx="233">
                  <c:v>-0.99009634665013202</c:v>
                </c:pt>
                <c:pt idx="234">
                  <c:v>-1.1962972447506084</c:v>
                </c:pt>
                <c:pt idx="235">
                  <c:v>-1.2801078748204939</c:v>
                </c:pt>
                <c:pt idx="236">
                  <c:v>-1.5319950642789197</c:v>
                </c:pt>
                <c:pt idx="237">
                  <c:v>-4.0093717476818727</c:v>
                </c:pt>
              </c:numCache>
            </c:numRef>
          </c:yVal>
          <c:smooth val="0"/>
          <c:extLst>
            <c:ext xmlns:c16="http://schemas.microsoft.com/office/drawing/2014/chart" uri="{C3380CC4-5D6E-409C-BE32-E72D297353CC}">
              <c16:uniqueId val="{00000001-D249-4571-9238-9055A43AFA58}"/>
            </c:ext>
          </c:extLst>
        </c:ser>
        <c:dLbls>
          <c:showLegendKey val="0"/>
          <c:showVal val="0"/>
          <c:showCatName val="0"/>
          <c:showSerName val="0"/>
          <c:showPercent val="0"/>
          <c:showBubbleSize val="0"/>
        </c:dLbls>
        <c:axId val="171455616"/>
        <c:axId val="171457152"/>
      </c:scatterChart>
      <c:valAx>
        <c:axId val="171455616"/>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457152"/>
        <c:crossesAt val="0"/>
        <c:crossBetween val="midCat"/>
      </c:valAx>
      <c:valAx>
        <c:axId val="171457152"/>
        <c:scaling>
          <c:orientation val="minMax"/>
          <c:max val="1"/>
          <c:min val="-6"/>
        </c:scaling>
        <c:delete val="0"/>
        <c:axPos val="l"/>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1455616"/>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527 dn del no change prion'!$D$1</c:f>
              <c:strCache>
                <c:ptCount val="1"/>
                <c:pt idx="0">
                  <c:v>[SWI+]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00B0F0"/>
                </a:solidFill>
                <a:prstDash val="dash"/>
                <a:round/>
              </a:ln>
              <a:effectLst/>
            </c:spPr>
          </c:errBars>
          <c:xVal>
            <c:numRef>
              <c:f>'527 dn del no change prion'!$C$2:$C$290</c:f>
              <c:numCache>
                <c:formatCode>General</c:formatCode>
                <c:ptCount val="289"/>
                <c:pt idx="0">
                  <c:v>65778</c:v>
                </c:pt>
                <c:pt idx="1">
                  <c:v>74020</c:v>
                </c:pt>
                <c:pt idx="2">
                  <c:v>100225</c:v>
                </c:pt>
                <c:pt idx="3">
                  <c:v>118564</c:v>
                </c:pt>
                <c:pt idx="4">
                  <c:v>142174</c:v>
                </c:pt>
                <c:pt idx="5">
                  <c:v>241065</c:v>
                </c:pt>
                <c:pt idx="6">
                  <c:v>276196</c:v>
                </c:pt>
                <c:pt idx="7">
                  <c:v>291420</c:v>
                </c:pt>
                <c:pt idx="8">
                  <c:v>302084</c:v>
                </c:pt>
                <c:pt idx="9">
                  <c:v>318408</c:v>
                </c:pt>
                <c:pt idx="10">
                  <c:v>318741</c:v>
                </c:pt>
                <c:pt idx="11">
                  <c:v>357046</c:v>
                </c:pt>
                <c:pt idx="12">
                  <c:v>374207</c:v>
                </c:pt>
                <c:pt idx="13">
                  <c:v>393259</c:v>
                </c:pt>
                <c:pt idx="14">
                  <c:v>394706</c:v>
                </c:pt>
                <c:pt idx="15">
                  <c:v>397736</c:v>
                </c:pt>
                <c:pt idx="16">
                  <c:v>398641</c:v>
                </c:pt>
                <c:pt idx="17">
                  <c:v>402752</c:v>
                </c:pt>
                <c:pt idx="18">
                  <c:v>416216</c:v>
                </c:pt>
                <c:pt idx="19">
                  <c:v>422669</c:v>
                </c:pt>
                <c:pt idx="20">
                  <c:v>474584</c:v>
                </c:pt>
                <c:pt idx="21">
                  <c:v>506471</c:v>
                </c:pt>
                <c:pt idx="22">
                  <c:v>509239</c:v>
                </c:pt>
                <c:pt idx="23">
                  <c:v>547186</c:v>
                </c:pt>
                <c:pt idx="24">
                  <c:v>563049</c:v>
                </c:pt>
                <c:pt idx="25">
                  <c:v>602321</c:v>
                </c:pt>
                <c:pt idx="26">
                  <c:v>646201</c:v>
                </c:pt>
                <c:pt idx="27">
                  <c:v>758535</c:v>
                </c:pt>
                <c:pt idx="28">
                  <c:v>763980</c:v>
                </c:pt>
                <c:pt idx="29">
                  <c:v>837367</c:v>
                </c:pt>
                <c:pt idx="30">
                  <c:v>943222</c:v>
                </c:pt>
                <c:pt idx="31">
                  <c:v>1074851</c:v>
                </c:pt>
                <c:pt idx="32">
                  <c:v>1087063</c:v>
                </c:pt>
                <c:pt idx="33">
                  <c:v>1115205</c:v>
                </c:pt>
                <c:pt idx="34">
                  <c:v>1119420</c:v>
                </c:pt>
                <c:pt idx="35">
                  <c:v>1187036</c:v>
                </c:pt>
                <c:pt idx="36">
                  <c:v>1201940</c:v>
                </c:pt>
                <c:pt idx="37">
                  <c:v>1222012</c:v>
                </c:pt>
                <c:pt idx="38">
                  <c:v>1352472</c:v>
                </c:pt>
                <c:pt idx="39">
                  <c:v>1354360</c:v>
                </c:pt>
                <c:pt idx="40">
                  <c:v>1357292</c:v>
                </c:pt>
                <c:pt idx="41">
                  <c:v>1380657</c:v>
                </c:pt>
                <c:pt idx="42">
                  <c:v>1541208</c:v>
                </c:pt>
                <c:pt idx="43">
                  <c:v>1672973</c:v>
                </c:pt>
                <c:pt idx="44">
                  <c:v>1683239</c:v>
                </c:pt>
                <c:pt idx="45">
                  <c:v>1698294</c:v>
                </c:pt>
                <c:pt idx="46">
                  <c:v>1726761</c:v>
                </c:pt>
                <c:pt idx="47">
                  <c:v>1851039</c:v>
                </c:pt>
                <c:pt idx="48">
                  <c:v>1868169</c:v>
                </c:pt>
                <c:pt idx="49">
                  <c:v>1908784</c:v>
                </c:pt>
                <c:pt idx="50">
                  <c:v>1923549</c:v>
                </c:pt>
                <c:pt idx="51">
                  <c:v>1960815</c:v>
                </c:pt>
                <c:pt idx="52">
                  <c:v>1977492</c:v>
                </c:pt>
                <c:pt idx="53">
                  <c:v>2015035</c:v>
                </c:pt>
                <c:pt idx="54">
                  <c:v>2015708</c:v>
                </c:pt>
                <c:pt idx="55">
                  <c:v>2078838</c:v>
                </c:pt>
                <c:pt idx="56">
                  <c:v>2081093</c:v>
                </c:pt>
                <c:pt idx="57">
                  <c:v>2129547</c:v>
                </c:pt>
                <c:pt idx="58">
                  <c:v>2139065</c:v>
                </c:pt>
                <c:pt idx="59">
                  <c:v>2163217</c:v>
                </c:pt>
                <c:pt idx="60">
                  <c:v>2252897</c:v>
                </c:pt>
                <c:pt idx="61">
                  <c:v>2306829</c:v>
                </c:pt>
                <c:pt idx="62">
                  <c:v>2316035</c:v>
                </c:pt>
                <c:pt idx="63">
                  <c:v>2328155</c:v>
                </c:pt>
                <c:pt idx="64">
                  <c:v>2382029</c:v>
                </c:pt>
                <c:pt idx="65">
                  <c:v>2419649</c:v>
                </c:pt>
                <c:pt idx="66">
                  <c:v>2474455</c:v>
                </c:pt>
                <c:pt idx="67">
                  <c:v>2519630</c:v>
                </c:pt>
                <c:pt idx="68">
                  <c:v>2555434</c:v>
                </c:pt>
                <c:pt idx="69">
                  <c:v>2564519</c:v>
                </c:pt>
                <c:pt idx="70">
                  <c:v>2572460</c:v>
                </c:pt>
                <c:pt idx="71">
                  <c:v>2689622</c:v>
                </c:pt>
                <c:pt idx="72">
                  <c:v>2714851</c:v>
                </c:pt>
                <c:pt idx="73">
                  <c:v>2717602</c:v>
                </c:pt>
                <c:pt idx="74">
                  <c:v>2721142</c:v>
                </c:pt>
                <c:pt idx="75">
                  <c:v>2852499</c:v>
                </c:pt>
                <c:pt idx="76">
                  <c:v>2967899</c:v>
                </c:pt>
                <c:pt idx="77">
                  <c:v>2970008</c:v>
                </c:pt>
                <c:pt idx="78">
                  <c:v>2978134</c:v>
                </c:pt>
                <c:pt idx="79">
                  <c:v>2990623</c:v>
                </c:pt>
                <c:pt idx="80">
                  <c:v>3032681</c:v>
                </c:pt>
                <c:pt idx="81">
                  <c:v>3056482</c:v>
                </c:pt>
                <c:pt idx="82">
                  <c:v>3115322</c:v>
                </c:pt>
                <c:pt idx="83">
                  <c:v>3117844</c:v>
                </c:pt>
                <c:pt idx="84">
                  <c:v>3130415</c:v>
                </c:pt>
                <c:pt idx="85">
                  <c:v>3158467</c:v>
                </c:pt>
                <c:pt idx="86">
                  <c:v>3174660</c:v>
                </c:pt>
                <c:pt idx="87">
                  <c:v>3184195</c:v>
                </c:pt>
                <c:pt idx="88">
                  <c:v>3195985</c:v>
                </c:pt>
                <c:pt idx="89">
                  <c:v>3241935</c:v>
                </c:pt>
                <c:pt idx="90">
                  <c:v>3305349</c:v>
                </c:pt>
                <c:pt idx="91">
                  <c:v>3315907</c:v>
                </c:pt>
                <c:pt idx="92">
                  <c:v>3583819</c:v>
                </c:pt>
                <c:pt idx="93">
                  <c:v>3599890</c:v>
                </c:pt>
                <c:pt idx="94">
                  <c:v>3682141</c:v>
                </c:pt>
                <c:pt idx="95">
                  <c:v>3689336</c:v>
                </c:pt>
                <c:pt idx="96">
                  <c:v>3747460</c:v>
                </c:pt>
                <c:pt idx="97">
                  <c:v>3881236</c:v>
                </c:pt>
                <c:pt idx="98">
                  <c:v>3921380</c:v>
                </c:pt>
                <c:pt idx="99">
                  <c:v>4047703</c:v>
                </c:pt>
                <c:pt idx="100">
                  <c:v>4319425</c:v>
                </c:pt>
                <c:pt idx="101">
                  <c:v>4321980</c:v>
                </c:pt>
                <c:pt idx="102">
                  <c:v>4348574</c:v>
                </c:pt>
                <c:pt idx="103">
                  <c:v>4359911</c:v>
                </c:pt>
                <c:pt idx="104">
                  <c:v>4382138</c:v>
                </c:pt>
                <c:pt idx="105">
                  <c:v>4434407</c:v>
                </c:pt>
                <c:pt idx="106">
                  <c:v>4511444</c:v>
                </c:pt>
                <c:pt idx="107">
                  <c:v>4545402</c:v>
                </c:pt>
                <c:pt idx="108">
                  <c:v>4563049</c:v>
                </c:pt>
                <c:pt idx="109">
                  <c:v>4566542</c:v>
                </c:pt>
                <c:pt idx="110">
                  <c:v>4657502</c:v>
                </c:pt>
                <c:pt idx="111">
                  <c:v>4698894</c:v>
                </c:pt>
                <c:pt idx="112">
                  <c:v>4727039</c:v>
                </c:pt>
                <c:pt idx="113">
                  <c:v>4743614</c:v>
                </c:pt>
                <c:pt idx="114">
                  <c:v>4758588</c:v>
                </c:pt>
                <c:pt idx="115">
                  <c:v>4819296</c:v>
                </c:pt>
                <c:pt idx="116">
                  <c:v>4856171</c:v>
                </c:pt>
                <c:pt idx="117">
                  <c:v>4869004</c:v>
                </c:pt>
                <c:pt idx="118">
                  <c:v>4892891</c:v>
                </c:pt>
                <c:pt idx="119">
                  <c:v>4979505</c:v>
                </c:pt>
                <c:pt idx="120">
                  <c:v>5117011</c:v>
                </c:pt>
                <c:pt idx="121">
                  <c:v>5204584</c:v>
                </c:pt>
                <c:pt idx="122">
                  <c:v>5215440</c:v>
                </c:pt>
                <c:pt idx="123">
                  <c:v>5281257</c:v>
                </c:pt>
                <c:pt idx="124">
                  <c:v>5323826</c:v>
                </c:pt>
                <c:pt idx="125">
                  <c:v>5328501</c:v>
                </c:pt>
                <c:pt idx="126">
                  <c:v>5342662</c:v>
                </c:pt>
                <c:pt idx="127">
                  <c:v>5347462</c:v>
                </c:pt>
                <c:pt idx="128">
                  <c:v>5350642</c:v>
                </c:pt>
                <c:pt idx="129">
                  <c:v>5382029</c:v>
                </c:pt>
                <c:pt idx="130">
                  <c:v>5429958</c:v>
                </c:pt>
                <c:pt idx="131">
                  <c:v>5524817</c:v>
                </c:pt>
                <c:pt idx="132">
                  <c:v>5526990</c:v>
                </c:pt>
                <c:pt idx="133">
                  <c:v>5535501</c:v>
                </c:pt>
                <c:pt idx="134">
                  <c:v>5543132</c:v>
                </c:pt>
                <c:pt idx="135">
                  <c:v>5567880</c:v>
                </c:pt>
                <c:pt idx="136">
                  <c:v>5603496</c:v>
                </c:pt>
                <c:pt idx="137">
                  <c:v>5619175</c:v>
                </c:pt>
                <c:pt idx="138">
                  <c:v>5648799</c:v>
                </c:pt>
                <c:pt idx="139">
                  <c:v>5675602</c:v>
                </c:pt>
                <c:pt idx="140">
                  <c:v>5694673</c:v>
                </c:pt>
                <c:pt idx="141">
                  <c:v>5731917</c:v>
                </c:pt>
                <c:pt idx="142">
                  <c:v>5827846</c:v>
                </c:pt>
                <c:pt idx="143">
                  <c:v>5906248</c:v>
                </c:pt>
                <c:pt idx="144">
                  <c:v>6127260</c:v>
                </c:pt>
                <c:pt idx="145">
                  <c:v>6143383</c:v>
                </c:pt>
                <c:pt idx="146">
                  <c:v>6209123</c:v>
                </c:pt>
                <c:pt idx="147">
                  <c:v>6359345</c:v>
                </c:pt>
                <c:pt idx="148">
                  <c:v>6402082</c:v>
                </c:pt>
                <c:pt idx="149">
                  <c:v>6440766</c:v>
                </c:pt>
                <c:pt idx="150">
                  <c:v>6470251</c:v>
                </c:pt>
                <c:pt idx="151">
                  <c:v>6484362</c:v>
                </c:pt>
                <c:pt idx="152">
                  <c:v>6541272</c:v>
                </c:pt>
                <c:pt idx="153">
                  <c:v>6692568</c:v>
                </c:pt>
                <c:pt idx="154">
                  <c:v>6703971</c:v>
                </c:pt>
                <c:pt idx="155">
                  <c:v>6724134</c:v>
                </c:pt>
                <c:pt idx="156">
                  <c:v>6795556</c:v>
                </c:pt>
                <c:pt idx="157">
                  <c:v>6833932</c:v>
                </c:pt>
                <c:pt idx="158">
                  <c:v>6859237</c:v>
                </c:pt>
                <c:pt idx="159">
                  <c:v>6861103</c:v>
                </c:pt>
                <c:pt idx="160">
                  <c:v>6894166</c:v>
                </c:pt>
                <c:pt idx="161">
                  <c:v>6919524</c:v>
                </c:pt>
                <c:pt idx="162">
                  <c:v>6921064</c:v>
                </c:pt>
                <c:pt idx="163">
                  <c:v>6934960</c:v>
                </c:pt>
                <c:pt idx="164">
                  <c:v>7004454</c:v>
                </c:pt>
                <c:pt idx="165">
                  <c:v>7085110</c:v>
                </c:pt>
                <c:pt idx="166">
                  <c:v>7096410</c:v>
                </c:pt>
                <c:pt idx="167">
                  <c:v>7126428</c:v>
                </c:pt>
                <c:pt idx="168">
                  <c:v>7127660</c:v>
                </c:pt>
                <c:pt idx="169">
                  <c:v>7149824</c:v>
                </c:pt>
                <c:pt idx="170">
                  <c:v>7158424</c:v>
                </c:pt>
                <c:pt idx="171">
                  <c:v>7193942</c:v>
                </c:pt>
                <c:pt idx="172">
                  <c:v>7196208</c:v>
                </c:pt>
                <c:pt idx="173">
                  <c:v>7224568</c:v>
                </c:pt>
                <c:pt idx="174">
                  <c:v>7313608</c:v>
                </c:pt>
                <c:pt idx="175">
                  <c:v>7315661</c:v>
                </c:pt>
                <c:pt idx="176">
                  <c:v>7376757</c:v>
                </c:pt>
                <c:pt idx="177">
                  <c:v>7498889</c:v>
                </c:pt>
                <c:pt idx="178">
                  <c:v>7503020</c:v>
                </c:pt>
                <c:pt idx="179">
                  <c:v>7516036</c:v>
                </c:pt>
                <c:pt idx="180">
                  <c:v>7631539</c:v>
                </c:pt>
                <c:pt idx="181">
                  <c:v>7670214</c:v>
                </c:pt>
                <c:pt idx="182">
                  <c:v>7745761</c:v>
                </c:pt>
                <c:pt idx="183">
                  <c:v>7749619</c:v>
                </c:pt>
                <c:pt idx="184">
                  <c:v>7751162</c:v>
                </c:pt>
                <c:pt idx="185">
                  <c:v>7758190</c:v>
                </c:pt>
                <c:pt idx="186">
                  <c:v>7767691</c:v>
                </c:pt>
                <c:pt idx="187">
                  <c:v>7919455</c:v>
                </c:pt>
                <c:pt idx="188">
                  <c:v>7949521</c:v>
                </c:pt>
                <c:pt idx="189">
                  <c:v>7973983</c:v>
                </c:pt>
                <c:pt idx="190">
                  <c:v>8002293</c:v>
                </c:pt>
                <c:pt idx="191">
                  <c:v>8002665</c:v>
                </c:pt>
                <c:pt idx="192">
                  <c:v>8026171</c:v>
                </c:pt>
                <c:pt idx="193">
                  <c:v>8029941</c:v>
                </c:pt>
                <c:pt idx="194">
                  <c:v>8039514</c:v>
                </c:pt>
                <c:pt idx="195">
                  <c:v>8072005</c:v>
                </c:pt>
                <c:pt idx="196">
                  <c:v>8098489</c:v>
                </c:pt>
                <c:pt idx="197">
                  <c:v>8192281</c:v>
                </c:pt>
                <c:pt idx="198">
                  <c:v>8284298</c:v>
                </c:pt>
                <c:pt idx="199">
                  <c:v>8338340</c:v>
                </c:pt>
                <c:pt idx="200">
                  <c:v>8367250</c:v>
                </c:pt>
                <c:pt idx="201">
                  <c:v>8390973</c:v>
                </c:pt>
                <c:pt idx="202">
                  <c:v>8406295</c:v>
                </c:pt>
                <c:pt idx="203">
                  <c:v>8443294</c:v>
                </c:pt>
                <c:pt idx="204">
                  <c:v>8488738</c:v>
                </c:pt>
                <c:pt idx="205">
                  <c:v>8544611</c:v>
                </c:pt>
                <c:pt idx="206">
                  <c:v>8552142</c:v>
                </c:pt>
                <c:pt idx="207">
                  <c:v>8575044</c:v>
                </c:pt>
                <c:pt idx="208">
                  <c:v>8620483</c:v>
                </c:pt>
                <c:pt idx="209">
                  <c:v>8620711</c:v>
                </c:pt>
                <c:pt idx="210">
                  <c:v>8621123</c:v>
                </c:pt>
                <c:pt idx="211">
                  <c:v>8633413</c:v>
                </c:pt>
                <c:pt idx="212">
                  <c:v>8710520</c:v>
                </c:pt>
                <c:pt idx="213">
                  <c:v>8712027</c:v>
                </c:pt>
                <c:pt idx="214">
                  <c:v>8718259</c:v>
                </c:pt>
                <c:pt idx="215">
                  <c:v>8753284</c:v>
                </c:pt>
                <c:pt idx="216">
                  <c:v>8799102</c:v>
                </c:pt>
                <c:pt idx="217">
                  <c:v>8873411</c:v>
                </c:pt>
                <c:pt idx="218">
                  <c:v>9010721</c:v>
                </c:pt>
                <c:pt idx="219">
                  <c:v>9055619</c:v>
                </c:pt>
                <c:pt idx="220">
                  <c:v>9080455</c:v>
                </c:pt>
                <c:pt idx="221">
                  <c:v>9083012</c:v>
                </c:pt>
                <c:pt idx="222">
                  <c:v>9098520</c:v>
                </c:pt>
                <c:pt idx="223">
                  <c:v>9119745</c:v>
                </c:pt>
                <c:pt idx="224">
                  <c:v>9173279</c:v>
                </c:pt>
                <c:pt idx="225">
                  <c:v>9228030</c:v>
                </c:pt>
                <c:pt idx="226">
                  <c:v>9311206</c:v>
                </c:pt>
                <c:pt idx="227">
                  <c:v>9344600</c:v>
                </c:pt>
                <c:pt idx="228">
                  <c:v>9507075</c:v>
                </c:pt>
                <c:pt idx="229">
                  <c:v>9543596</c:v>
                </c:pt>
                <c:pt idx="230">
                  <c:v>9584181</c:v>
                </c:pt>
                <c:pt idx="231">
                  <c:v>9597543</c:v>
                </c:pt>
                <c:pt idx="232">
                  <c:v>9607232</c:v>
                </c:pt>
                <c:pt idx="233">
                  <c:v>9648676</c:v>
                </c:pt>
                <c:pt idx="234">
                  <c:v>9688433</c:v>
                </c:pt>
                <c:pt idx="235">
                  <c:v>9691034</c:v>
                </c:pt>
                <c:pt idx="236">
                  <c:v>9807450</c:v>
                </c:pt>
                <c:pt idx="237">
                  <c:v>9873810</c:v>
                </c:pt>
                <c:pt idx="238">
                  <c:v>9940197</c:v>
                </c:pt>
                <c:pt idx="239">
                  <c:v>9943231</c:v>
                </c:pt>
                <c:pt idx="240">
                  <c:v>9969574</c:v>
                </c:pt>
                <c:pt idx="241">
                  <c:v>10007703</c:v>
                </c:pt>
                <c:pt idx="242">
                  <c:v>10013011</c:v>
                </c:pt>
                <c:pt idx="243">
                  <c:v>10025238</c:v>
                </c:pt>
                <c:pt idx="244">
                  <c:v>10086564</c:v>
                </c:pt>
                <c:pt idx="245">
                  <c:v>10088421</c:v>
                </c:pt>
                <c:pt idx="246">
                  <c:v>10103269</c:v>
                </c:pt>
                <c:pt idx="247">
                  <c:v>10106369</c:v>
                </c:pt>
                <c:pt idx="248">
                  <c:v>10112317</c:v>
                </c:pt>
                <c:pt idx="249">
                  <c:v>10117425</c:v>
                </c:pt>
                <c:pt idx="250">
                  <c:v>10126825</c:v>
                </c:pt>
                <c:pt idx="251">
                  <c:v>10194325</c:v>
                </c:pt>
                <c:pt idx="252">
                  <c:v>10272173</c:v>
                </c:pt>
                <c:pt idx="253">
                  <c:v>10318141</c:v>
                </c:pt>
                <c:pt idx="254">
                  <c:v>10333016</c:v>
                </c:pt>
                <c:pt idx="255">
                  <c:v>10339907</c:v>
                </c:pt>
                <c:pt idx="256">
                  <c:v>10454637</c:v>
                </c:pt>
                <c:pt idx="257">
                  <c:v>10610533</c:v>
                </c:pt>
                <c:pt idx="258">
                  <c:v>10665251</c:v>
                </c:pt>
                <c:pt idx="259">
                  <c:v>10669543</c:v>
                </c:pt>
                <c:pt idx="260">
                  <c:v>10697754</c:v>
                </c:pt>
                <c:pt idx="261">
                  <c:v>10792794</c:v>
                </c:pt>
                <c:pt idx="262">
                  <c:v>10900309</c:v>
                </c:pt>
                <c:pt idx="263">
                  <c:v>10928794</c:v>
                </c:pt>
                <c:pt idx="264">
                  <c:v>10932219</c:v>
                </c:pt>
                <c:pt idx="265">
                  <c:v>11058812</c:v>
                </c:pt>
                <c:pt idx="266">
                  <c:v>11060163</c:v>
                </c:pt>
                <c:pt idx="267">
                  <c:v>11198959</c:v>
                </c:pt>
                <c:pt idx="268">
                  <c:v>11259050</c:v>
                </c:pt>
                <c:pt idx="269">
                  <c:v>11294744</c:v>
                </c:pt>
                <c:pt idx="270">
                  <c:v>11379173</c:v>
                </c:pt>
                <c:pt idx="271">
                  <c:v>11396515</c:v>
                </c:pt>
                <c:pt idx="272">
                  <c:v>11433470</c:v>
                </c:pt>
                <c:pt idx="273">
                  <c:v>11494238</c:v>
                </c:pt>
                <c:pt idx="274">
                  <c:v>11500551</c:v>
                </c:pt>
                <c:pt idx="275">
                  <c:v>11585741</c:v>
                </c:pt>
                <c:pt idx="276">
                  <c:v>11606103</c:v>
                </c:pt>
                <c:pt idx="277">
                  <c:v>11616803</c:v>
                </c:pt>
                <c:pt idx="278">
                  <c:v>11623935</c:v>
                </c:pt>
                <c:pt idx="279">
                  <c:v>11652983</c:v>
                </c:pt>
                <c:pt idx="280">
                  <c:v>11679637</c:v>
                </c:pt>
                <c:pt idx="281">
                  <c:v>11692596</c:v>
                </c:pt>
                <c:pt idx="282">
                  <c:v>11841960</c:v>
                </c:pt>
                <c:pt idx="283">
                  <c:v>11842408</c:v>
                </c:pt>
                <c:pt idx="284">
                  <c:v>11925619</c:v>
                </c:pt>
                <c:pt idx="285">
                  <c:v>11941583</c:v>
                </c:pt>
                <c:pt idx="286">
                  <c:v>11943025</c:v>
                </c:pt>
                <c:pt idx="287">
                  <c:v>11953178</c:v>
                </c:pt>
                <c:pt idx="288">
                  <c:v>12034517</c:v>
                </c:pt>
              </c:numCache>
            </c:numRef>
          </c:xVal>
          <c:yVal>
            <c:numRef>
              <c:f>'527 dn del no change prion'!$D$2:$D$290</c:f>
              <c:numCache>
                <c:formatCode>General</c:formatCode>
                <c:ptCount val="289"/>
                <c:pt idx="0">
                  <c:v>9.4878683201216896E-2</c:v>
                </c:pt>
                <c:pt idx="1">
                  <c:v>-0.73612935697675264</c:v>
                </c:pt>
                <c:pt idx="2">
                  <c:v>0.41231309344729178</c:v>
                </c:pt>
                <c:pt idx="3">
                  <c:v>-0.43128371758340878</c:v>
                </c:pt>
                <c:pt idx="4">
                  <c:v>-0.32691151046395672</c:v>
                </c:pt>
                <c:pt idx="5">
                  <c:v>0.87915753908275784</c:v>
                </c:pt>
                <c:pt idx="6">
                  <c:v>0.37609121416074393</c:v>
                </c:pt>
                <c:pt idx="7">
                  <c:v>-0.90547200667267125</c:v>
                </c:pt>
                <c:pt idx="8">
                  <c:v>-0.28576729697288689</c:v>
                </c:pt>
                <c:pt idx="9">
                  <c:v>3.1715054786039504E-2</c:v>
                </c:pt>
                <c:pt idx="10">
                  <c:v>0.69652983811243008</c:v>
                </c:pt>
                <c:pt idx="11">
                  <c:v>-0.25612629126410047</c:v>
                </c:pt>
                <c:pt idx="12">
                  <c:v>0.95801490460078809</c:v>
                </c:pt>
                <c:pt idx="13">
                  <c:v>0.45925990909613917</c:v>
                </c:pt>
                <c:pt idx="14">
                  <c:v>-0.78977246770516651</c:v>
                </c:pt>
                <c:pt idx="15">
                  <c:v>-2.9606788041527991E-2</c:v>
                </c:pt>
                <c:pt idx="16">
                  <c:v>-0.46273251955276301</c:v>
                </c:pt>
                <c:pt idx="17">
                  <c:v>-1.2281586452403466</c:v>
                </c:pt>
                <c:pt idx="18">
                  <c:v>-0.40068386402896983</c:v>
                </c:pt>
                <c:pt idx="19">
                  <c:v>-1.7557795060133652</c:v>
                </c:pt>
                <c:pt idx="20">
                  <c:v>0.37037375647784765</c:v>
                </c:pt>
                <c:pt idx="21">
                  <c:v>-5.9844963196057151E-2</c:v>
                </c:pt>
                <c:pt idx="22">
                  <c:v>0.54507167293129954</c:v>
                </c:pt>
                <c:pt idx="23">
                  <c:v>0.68345393485729244</c:v>
                </c:pt>
                <c:pt idx="24">
                  <c:v>0.16530704271322724</c:v>
                </c:pt>
                <c:pt idx="25">
                  <c:v>0.83321846020045209</c:v>
                </c:pt>
                <c:pt idx="26">
                  <c:v>-0.34713862436891463</c:v>
                </c:pt>
                <c:pt idx="27">
                  <c:v>0.57060893994931461</c:v>
                </c:pt>
                <c:pt idx="28">
                  <c:v>0.1349828642510002</c:v>
                </c:pt>
                <c:pt idx="29">
                  <c:v>0.75637247627640303</c:v>
                </c:pt>
                <c:pt idx="30">
                  <c:v>0.13044121324743366</c:v>
                </c:pt>
                <c:pt idx="31">
                  <c:v>0.24097153773307969</c:v>
                </c:pt>
                <c:pt idx="32">
                  <c:v>-1.0532989425721451</c:v>
                </c:pt>
                <c:pt idx="33">
                  <c:v>0.70060316684744894</c:v>
                </c:pt>
                <c:pt idx="34">
                  <c:v>0.39290642742255283</c:v>
                </c:pt>
                <c:pt idx="35">
                  <c:v>-1.4681603786255848</c:v>
                </c:pt>
                <c:pt idx="36">
                  <c:v>0.53316940870142571</c:v>
                </c:pt>
                <c:pt idx="37">
                  <c:v>0.67761918287151157</c:v>
                </c:pt>
                <c:pt idx="38">
                  <c:v>5.7274934328147002E-2</c:v>
                </c:pt>
                <c:pt idx="39">
                  <c:v>0.25148346274346817</c:v>
                </c:pt>
                <c:pt idx="40">
                  <c:v>0.18154070827378058</c:v>
                </c:pt>
                <c:pt idx="41">
                  <c:v>-0.75993043721252673</c:v>
                </c:pt>
                <c:pt idx="42">
                  <c:v>0.19572994798542745</c:v>
                </c:pt>
                <c:pt idx="43">
                  <c:v>0.73112549149640471</c:v>
                </c:pt>
                <c:pt idx="44">
                  <c:v>0.1512226620846723</c:v>
                </c:pt>
                <c:pt idx="45">
                  <c:v>0.92614933665568433</c:v>
                </c:pt>
                <c:pt idx="46">
                  <c:v>0.86612677534002802</c:v>
                </c:pt>
                <c:pt idx="47">
                  <c:v>0.31822945389993856</c:v>
                </c:pt>
                <c:pt idx="48">
                  <c:v>-0.57625859721751405</c:v>
                </c:pt>
                <c:pt idx="49">
                  <c:v>-0.24748302476997447</c:v>
                </c:pt>
                <c:pt idx="50">
                  <c:v>0.74728778279250319</c:v>
                </c:pt>
                <c:pt idx="51">
                  <c:v>7.543997970192462E-2</c:v>
                </c:pt>
                <c:pt idx="52">
                  <c:v>0.11852180271497026</c:v>
                </c:pt>
                <c:pt idx="53">
                  <c:v>0.40398240001986169</c:v>
                </c:pt>
                <c:pt idx="54">
                  <c:v>0.81072768358027802</c:v>
                </c:pt>
                <c:pt idx="55">
                  <c:v>-0.14536313352978139</c:v>
                </c:pt>
                <c:pt idx="56">
                  <c:v>-0.78852388371205284</c:v>
                </c:pt>
                <c:pt idx="57">
                  <c:v>0.51654826541562826</c:v>
                </c:pt>
                <c:pt idx="58">
                  <c:v>0.29283783085360554</c:v>
                </c:pt>
                <c:pt idx="59">
                  <c:v>0.63497847395226159</c:v>
                </c:pt>
                <c:pt idx="60">
                  <c:v>-0.73060486474994202</c:v>
                </c:pt>
                <c:pt idx="61">
                  <c:v>0.30478274892716423</c:v>
                </c:pt>
                <c:pt idx="62">
                  <c:v>9.5965817989049948E-2</c:v>
                </c:pt>
                <c:pt idx="63">
                  <c:v>0.80543319291264992</c:v>
                </c:pt>
                <c:pt idx="64">
                  <c:v>-7.2994982467831218E-2</c:v>
                </c:pt>
                <c:pt idx="65">
                  <c:v>8.8270622298934426E-2</c:v>
                </c:pt>
                <c:pt idx="66">
                  <c:v>0.9113517423393358</c:v>
                </c:pt>
                <c:pt idx="67">
                  <c:v>-0.73253289148112233</c:v>
                </c:pt>
                <c:pt idx="68">
                  <c:v>4.4358698336181231E-2</c:v>
                </c:pt>
                <c:pt idx="69">
                  <c:v>-0.42506539447704461</c:v>
                </c:pt>
                <c:pt idx="70">
                  <c:v>0.26657089522814853</c:v>
                </c:pt>
                <c:pt idx="71">
                  <c:v>-4.7686742154334806E-2</c:v>
                </c:pt>
                <c:pt idx="72">
                  <c:v>-0.2440022317485934</c:v>
                </c:pt>
                <c:pt idx="73">
                  <c:v>0.3040492474144994</c:v>
                </c:pt>
                <c:pt idx="74">
                  <c:v>4.7922210154671969E-2</c:v>
                </c:pt>
                <c:pt idx="75">
                  <c:v>0.88673442401817792</c:v>
                </c:pt>
                <c:pt idx="76">
                  <c:v>0.34133391312569528</c:v>
                </c:pt>
                <c:pt idx="77">
                  <c:v>0.31903124498242924</c:v>
                </c:pt>
                <c:pt idx="78">
                  <c:v>-8.5563109588418021E-2</c:v>
                </c:pt>
                <c:pt idx="79">
                  <c:v>3.6039275675655652E-2</c:v>
                </c:pt>
                <c:pt idx="80">
                  <c:v>-0.68300970135931083</c:v>
                </c:pt>
                <c:pt idx="81">
                  <c:v>1.0463240871808308</c:v>
                </c:pt>
                <c:pt idx="82">
                  <c:v>0.65118262533657734</c:v>
                </c:pt>
                <c:pt idx="83">
                  <c:v>-0.3360990295258634</c:v>
                </c:pt>
                <c:pt idx="84">
                  <c:v>0.64768216014945335</c:v>
                </c:pt>
                <c:pt idx="85">
                  <c:v>1.2124282593292532</c:v>
                </c:pt>
                <c:pt idx="86">
                  <c:v>0.23748734254792003</c:v>
                </c:pt>
                <c:pt idx="87">
                  <c:v>0.11749853597135697</c:v>
                </c:pt>
                <c:pt idx="88">
                  <c:v>2.5124592592655072E-2</c:v>
                </c:pt>
                <c:pt idx="89">
                  <c:v>0.20575260915350504</c:v>
                </c:pt>
                <c:pt idx="90">
                  <c:v>0.64956020121945168</c:v>
                </c:pt>
                <c:pt idx="91">
                  <c:v>-0.11098710410014018</c:v>
                </c:pt>
                <c:pt idx="92">
                  <c:v>7.9049932297982059E-2</c:v>
                </c:pt>
                <c:pt idx="93">
                  <c:v>0.38134056958414281</c:v>
                </c:pt>
                <c:pt idx="94">
                  <c:v>-0.56749348138971945</c:v>
                </c:pt>
                <c:pt idx="95">
                  <c:v>0.32635730164547838</c:v>
                </c:pt>
                <c:pt idx="96">
                  <c:v>0.91505019192182624</c:v>
                </c:pt>
                <c:pt idx="97">
                  <c:v>0.45120303710652787</c:v>
                </c:pt>
                <c:pt idx="98">
                  <c:v>-1.6946103554686143</c:v>
                </c:pt>
                <c:pt idx="99">
                  <c:v>-1.1211314756525799</c:v>
                </c:pt>
                <c:pt idx="100">
                  <c:v>0.51214543906999499</c:v>
                </c:pt>
                <c:pt idx="101">
                  <c:v>0.66941612449962629</c:v>
                </c:pt>
                <c:pt idx="102">
                  <c:v>0.38731767082126956</c:v>
                </c:pt>
                <c:pt idx="103">
                  <c:v>0.24748738650582433</c:v>
                </c:pt>
                <c:pt idx="104">
                  <c:v>0.48357883010531832</c:v>
                </c:pt>
                <c:pt idx="105">
                  <c:v>-0.31692446421843312</c:v>
                </c:pt>
                <c:pt idx="106">
                  <c:v>0.89872405372645303</c:v>
                </c:pt>
                <c:pt idx="107">
                  <c:v>-1.2219515736727142</c:v>
                </c:pt>
                <c:pt idx="108">
                  <c:v>0.1811092248458023</c:v>
                </c:pt>
                <c:pt idx="109">
                  <c:v>0.2238901933798817</c:v>
                </c:pt>
                <c:pt idx="110">
                  <c:v>-0.35853536023478638</c:v>
                </c:pt>
                <c:pt idx="111">
                  <c:v>0.13071315963655974</c:v>
                </c:pt>
                <c:pt idx="112">
                  <c:v>0.7800501314720254</c:v>
                </c:pt>
                <c:pt idx="113">
                  <c:v>-0.38566739418829971</c:v>
                </c:pt>
                <c:pt idx="114">
                  <c:v>0.7595074598450966</c:v>
                </c:pt>
                <c:pt idx="115">
                  <c:v>-0.77935944096111232</c:v>
                </c:pt>
                <c:pt idx="116">
                  <c:v>-0.32461459065359399</c:v>
                </c:pt>
                <c:pt idx="117">
                  <c:v>-0.4797139576021287</c:v>
                </c:pt>
                <c:pt idx="118">
                  <c:v>0.55867240728539358</c:v>
                </c:pt>
                <c:pt idx="119">
                  <c:v>0.20859670893860219</c:v>
                </c:pt>
                <c:pt idx="120">
                  <c:v>0.16010259426708612</c:v>
                </c:pt>
                <c:pt idx="121">
                  <c:v>-0.23675054086848768</c:v>
                </c:pt>
                <c:pt idx="122">
                  <c:v>0.83209630690037462</c:v>
                </c:pt>
                <c:pt idx="123">
                  <c:v>-0.38591455612648079</c:v>
                </c:pt>
                <c:pt idx="124">
                  <c:v>-1.0293509617446726</c:v>
                </c:pt>
                <c:pt idx="125">
                  <c:v>0.50568728361080895</c:v>
                </c:pt>
                <c:pt idx="126">
                  <c:v>0.95022362758819612</c:v>
                </c:pt>
                <c:pt idx="127">
                  <c:v>0.71616892791783027</c:v>
                </c:pt>
                <c:pt idx="128">
                  <c:v>1.2533307886581653</c:v>
                </c:pt>
                <c:pt idx="129">
                  <c:v>-0.33738882700873746</c:v>
                </c:pt>
                <c:pt idx="130">
                  <c:v>0.59738008007790355</c:v>
                </c:pt>
                <c:pt idx="131">
                  <c:v>-0.6274554823526679</c:v>
                </c:pt>
                <c:pt idx="132">
                  <c:v>0.47417790519573128</c:v>
                </c:pt>
                <c:pt idx="133">
                  <c:v>1.0026346329684228</c:v>
                </c:pt>
                <c:pt idx="134">
                  <c:v>-2.8193417032027525E-2</c:v>
                </c:pt>
                <c:pt idx="135">
                  <c:v>0.9918328173942087</c:v>
                </c:pt>
                <c:pt idx="136">
                  <c:v>-7.4886931018273373E-2</c:v>
                </c:pt>
                <c:pt idx="137">
                  <c:v>-0.18731290083721536</c:v>
                </c:pt>
                <c:pt idx="138">
                  <c:v>-0.53823596414035357</c:v>
                </c:pt>
                <c:pt idx="139">
                  <c:v>0.29324826699406487</c:v>
                </c:pt>
                <c:pt idx="140">
                  <c:v>-1.0374768075960248</c:v>
                </c:pt>
                <c:pt idx="141">
                  <c:v>-0.9019756132050939</c:v>
                </c:pt>
                <c:pt idx="142">
                  <c:v>1.0673522173893755</c:v>
                </c:pt>
                <c:pt idx="143">
                  <c:v>0.31807687858969785</c:v>
                </c:pt>
                <c:pt idx="144">
                  <c:v>0.48678643551452283</c:v>
                </c:pt>
                <c:pt idx="145">
                  <c:v>-0.17131096378260804</c:v>
                </c:pt>
                <c:pt idx="146">
                  <c:v>0.78010370347202551</c:v>
                </c:pt>
                <c:pt idx="147">
                  <c:v>0.59706505339198235</c:v>
                </c:pt>
                <c:pt idx="148">
                  <c:v>1.0226886946918265</c:v>
                </c:pt>
                <c:pt idx="149">
                  <c:v>0.47325191533313921</c:v>
                </c:pt>
                <c:pt idx="150">
                  <c:v>0.73931867563611875</c:v>
                </c:pt>
                <c:pt idx="151">
                  <c:v>-0.73623768041408566</c:v>
                </c:pt>
                <c:pt idx="152">
                  <c:v>-0.35440953304579809</c:v>
                </c:pt>
                <c:pt idx="153">
                  <c:v>0.64737352522835589</c:v>
                </c:pt>
                <c:pt idx="154">
                  <c:v>1.2135824049674728</c:v>
                </c:pt>
                <c:pt idx="155">
                  <c:v>0.21072395056932658</c:v>
                </c:pt>
                <c:pt idx="156">
                  <c:v>-0.39855398829372191</c:v>
                </c:pt>
                <c:pt idx="157">
                  <c:v>-1.5573431033983551</c:v>
                </c:pt>
                <c:pt idx="158">
                  <c:v>0.63455229647223377</c:v>
                </c:pt>
                <c:pt idx="159">
                  <c:v>0.99395051672095081</c:v>
                </c:pt>
                <c:pt idx="160">
                  <c:v>0.160502545755911</c:v>
                </c:pt>
                <c:pt idx="161">
                  <c:v>-1.3949088078291527</c:v>
                </c:pt>
                <c:pt idx="162">
                  <c:v>-1.0790557772589972E-2</c:v>
                </c:pt>
                <c:pt idx="163">
                  <c:v>-4.8983595075861551E-2</c:v>
                </c:pt>
                <c:pt idx="164">
                  <c:v>0.51115443926552062</c:v>
                </c:pt>
                <c:pt idx="165">
                  <c:v>-0.99007416124892267</c:v>
                </c:pt>
                <c:pt idx="166">
                  <c:v>0.67360278376586913</c:v>
                </c:pt>
                <c:pt idx="167">
                  <c:v>-0.25955121613621868</c:v>
                </c:pt>
                <c:pt idx="168">
                  <c:v>-0.35113699722766728</c:v>
                </c:pt>
                <c:pt idx="169">
                  <c:v>0.54399458452495353</c:v>
                </c:pt>
                <c:pt idx="170">
                  <c:v>0.61934715883394831</c:v>
                </c:pt>
                <c:pt idx="171">
                  <c:v>-0.22920945839377277</c:v>
                </c:pt>
                <c:pt idx="172">
                  <c:v>-0.59668548584893011</c:v>
                </c:pt>
                <c:pt idx="173">
                  <c:v>-0.16931455934389261</c:v>
                </c:pt>
                <c:pt idx="174">
                  <c:v>-0.17594104496425236</c:v>
                </c:pt>
                <c:pt idx="175">
                  <c:v>1.249107740160899</c:v>
                </c:pt>
                <c:pt idx="176">
                  <c:v>0.45082660444248512</c:v>
                </c:pt>
                <c:pt idx="177">
                  <c:v>0.47280297247278863</c:v>
                </c:pt>
                <c:pt idx="178">
                  <c:v>0.64486059610016699</c:v>
                </c:pt>
                <c:pt idx="179">
                  <c:v>0.97609093204683972</c:v>
                </c:pt>
                <c:pt idx="180">
                  <c:v>-0.10485778393124719</c:v>
                </c:pt>
                <c:pt idx="181">
                  <c:v>4.7195326887512351E-2</c:v>
                </c:pt>
                <c:pt idx="182">
                  <c:v>0.7863475235488635</c:v>
                </c:pt>
                <c:pt idx="183">
                  <c:v>0.35863649025370664</c:v>
                </c:pt>
                <c:pt idx="184">
                  <c:v>0.80739053648092896</c:v>
                </c:pt>
                <c:pt idx="185">
                  <c:v>1.1952424458192843</c:v>
                </c:pt>
                <c:pt idx="186">
                  <c:v>-1.1422536014028424</c:v>
                </c:pt>
                <c:pt idx="187">
                  <c:v>0.23009712668734442</c:v>
                </c:pt>
                <c:pt idx="188">
                  <c:v>-1.8108060690794994</c:v>
                </c:pt>
                <c:pt idx="189">
                  <c:v>0.47620928004228552</c:v>
                </c:pt>
                <c:pt idx="190">
                  <c:v>0.14034195601639138</c:v>
                </c:pt>
                <c:pt idx="191">
                  <c:v>0.14012257279181473</c:v>
                </c:pt>
                <c:pt idx="192">
                  <c:v>0.69372807987366414</c:v>
                </c:pt>
                <c:pt idx="193">
                  <c:v>0.42351243230844843</c:v>
                </c:pt>
                <c:pt idx="194">
                  <c:v>0.38547724194833644</c:v>
                </c:pt>
                <c:pt idx="195">
                  <c:v>-0.60785799401613116</c:v>
                </c:pt>
                <c:pt idx="196">
                  <c:v>0.84527766440939311</c:v>
                </c:pt>
                <c:pt idx="197">
                  <c:v>0.4506842900546752</c:v>
                </c:pt>
                <c:pt idx="198">
                  <c:v>-9.4831747793896179E-2</c:v>
                </c:pt>
                <c:pt idx="199">
                  <c:v>3.1359502637710473E-3</c:v>
                </c:pt>
                <c:pt idx="200">
                  <c:v>-0.27619394692026034</c:v>
                </c:pt>
                <c:pt idx="201">
                  <c:v>6.1679466428240209E-2</c:v>
                </c:pt>
                <c:pt idx="202">
                  <c:v>0.18029415949878655</c:v>
                </c:pt>
                <c:pt idx="203">
                  <c:v>0.65548539159073083</c:v>
                </c:pt>
                <c:pt idx="204">
                  <c:v>0.79214450272100934</c:v>
                </c:pt>
                <c:pt idx="205">
                  <c:v>1.4056543762499172</c:v>
                </c:pt>
                <c:pt idx="206">
                  <c:v>0.10983267618259772</c:v>
                </c:pt>
                <c:pt idx="207">
                  <c:v>-0.89337014783401603</c:v>
                </c:pt>
                <c:pt idx="208">
                  <c:v>0.57757457462102679</c:v>
                </c:pt>
                <c:pt idx="209">
                  <c:v>0.62099868651475565</c:v>
                </c:pt>
                <c:pt idx="210">
                  <c:v>-0.39268588406353921</c:v>
                </c:pt>
                <c:pt idx="211">
                  <c:v>0.35773744483219527</c:v>
                </c:pt>
                <c:pt idx="212">
                  <c:v>0.47281717740637152</c:v>
                </c:pt>
                <c:pt idx="213">
                  <c:v>-0.54091437663889697</c:v>
                </c:pt>
                <c:pt idx="214">
                  <c:v>0.55315725167318108</c:v>
                </c:pt>
                <c:pt idx="215">
                  <c:v>0.62142108534059215</c:v>
                </c:pt>
                <c:pt idx="216">
                  <c:v>0.70499890629273898</c:v>
                </c:pt>
                <c:pt idx="217">
                  <c:v>0.75908084116028463</c:v>
                </c:pt>
                <c:pt idx="218">
                  <c:v>0.60040160222751859</c:v>
                </c:pt>
                <c:pt idx="219">
                  <c:v>0.75067321729684722</c:v>
                </c:pt>
                <c:pt idx="220">
                  <c:v>0.3658580656728358</c:v>
                </c:pt>
                <c:pt idx="221">
                  <c:v>0.87115484356261941</c:v>
                </c:pt>
                <c:pt idx="222">
                  <c:v>-5.2793429847911771E-2</c:v>
                </c:pt>
                <c:pt idx="223">
                  <c:v>0.6583805957198311</c:v>
                </c:pt>
                <c:pt idx="224">
                  <c:v>-0.21036176663132505</c:v>
                </c:pt>
                <c:pt idx="225">
                  <c:v>0.4791161022195139</c:v>
                </c:pt>
                <c:pt idx="226">
                  <c:v>0.57681056355122728</c:v>
                </c:pt>
                <c:pt idx="227">
                  <c:v>-0.34977622386562274</c:v>
                </c:pt>
                <c:pt idx="228">
                  <c:v>6.5339738830043877E-3</c:v>
                </c:pt>
                <c:pt idx="229">
                  <c:v>0.24452484288327272</c:v>
                </c:pt>
                <c:pt idx="230">
                  <c:v>-1.0918917640654022</c:v>
                </c:pt>
                <c:pt idx="231">
                  <c:v>-0.23365483575115467</c:v>
                </c:pt>
                <c:pt idx="232">
                  <c:v>0.65047798489452124</c:v>
                </c:pt>
                <c:pt idx="233">
                  <c:v>-0.80797884911958384</c:v>
                </c:pt>
                <c:pt idx="234">
                  <c:v>0.82848390148447881</c:v>
                </c:pt>
                <c:pt idx="235">
                  <c:v>0.68689715018558006</c:v>
                </c:pt>
                <c:pt idx="236">
                  <c:v>0.30270490718854581</c:v>
                </c:pt>
                <c:pt idx="237">
                  <c:v>-0.49525949659863633</c:v>
                </c:pt>
                <c:pt idx="238">
                  <c:v>-0.37902062632526806</c:v>
                </c:pt>
                <c:pt idx="239">
                  <c:v>0.50715099691690124</c:v>
                </c:pt>
                <c:pt idx="240">
                  <c:v>0.33739521717552384</c:v>
                </c:pt>
                <c:pt idx="241">
                  <c:v>0.97592728435523834</c:v>
                </c:pt>
                <c:pt idx="242">
                  <c:v>-2.2349845121436996E-2</c:v>
                </c:pt>
                <c:pt idx="243">
                  <c:v>0.59925164126687425</c:v>
                </c:pt>
                <c:pt idx="244">
                  <c:v>0.4111006212792141</c:v>
                </c:pt>
                <c:pt idx="245">
                  <c:v>-0.29777902774671555</c:v>
                </c:pt>
                <c:pt idx="246">
                  <c:v>-0.14688451871941868</c:v>
                </c:pt>
                <c:pt idx="247">
                  <c:v>0.64877125021887461</c:v>
                </c:pt>
                <c:pt idx="248">
                  <c:v>-0.76873384719660764</c:v>
                </c:pt>
                <c:pt idx="249">
                  <c:v>-0.69784690443862674</c:v>
                </c:pt>
                <c:pt idx="250">
                  <c:v>-0.25213340548562291</c:v>
                </c:pt>
                <c:pt idx="251">
                  <c:v>-0.20379781262786001</c:v>
                </c:pt>
                <c:pt idx="252">
                  <c:v>-0.45073147314157125</c:v>
                </c:pt>
                <c:pt idx="253">
                  <c:v>0.47160261213476401</c:v>
                </c:pt>
                <c:pt idx="254">
                  <c:v>0.41928520689602983</c:v>
                </c:pt>
                <c:pt idx="255">
                  <c:v>-8.969783689835982E-2</c:v>
                </c:pt>
                <c:pt idx="256">
                  <c:v>0.74770730698866916</c:v>
                </c:pt>
                <c:pt idx="257">
                  <c:v>0.2240439718677035</c:v>
                </c:pt>
                <c:pt idx="258">
                  <c:v>-0.72341496538248395</c:v>
                </c:pt>
                <c:pt idx="259">
                  <c:v>0.73120384413878747</c:v>
                </c:pt>
                <c:pt idx="260">
                  <c:v>0.78194892011896666</c:v>
                </c:pt>
                <c:pt idx="261">
                  <c:v>0.27621378392882123</c:v>
                </c:pt>
                <c:pt idx="262">
                  <c:v>0.67725955389139791</c:v>
                </c:pt>
                <c:pt idx="263">
                  <c:v>1.2509673664134595</c:v>
                </c:pt>
                <c:pt idx="264">
                  <c:v>1.3641798917183286E-3</c:v>
                </c:pt>
                <c:pt idx="265">
                  <c:v>0.31275235454053701</c:v>
                </c:pt>
                <c:pt idx="266">
                  <c:v>0.15802551176953175</c:v>
                </c:pt>
                <c:pt idx="267">
                  <c:v>-0.76159520549093918</c:v>
                </c:pt>
                <c:pt idx="268">
                  <c:v>0.73797298007799184</c:v>
                </c:pt>
                <c:pt idx="269">
                  <c:v>0.52045529468079754</c:v>
                </c:pt>
                <c:pt idx="270">
                  <c:v>0.49677633701139029</c:v>
                </c:pt>
                <c:pt idx="271">
                  <c:v>0.17435124524644224</c:v>
                </c:pt>
                <c:pt idx="272">
                  <c:v>0.95263907060634823</c:v>
                </c:pt>
                <c:pt idx="273">
                  <c:v>0.52865919843650733</c:v>
                </c:pt>
                <c:pt idx="274">
                  <c:v>-6.4481197191119777E-2</c:v>
                </c:pt>
                <c:pt idx="275">
                  <c:v>0.18754274585337871</c:v>
                </c:pt>
                <c:pt idx="276">
                  <c:v>0.93661231136485812</c:v>
                </c:pt>
                <c:pt idx="277">
                  <c:v>0.71401317783307161</c:v>
                </c:pt>
                <c:pt idx="278">
                  <c:v>-0.95133585273764498</c:v>
                </c:pt>
                <c:pt idx="279">
                  <c:v>-0.5848708357643384</c:v>
                </c:pt>
                <c:pt idx="280">
                  <c:v>0.29346266655706105</c:v>
                </c:pt>
                <c:pt idx="281">
                  <c:v>0.17717280929097162</c:v>
                </c:pt>
                <c:pt idx="282">
                  <c:v>0.66149475832972171</c:v>
                </c:pt>
                <c:pt idx="283">
                  <c:v>0.39166240952389653</c:v>
                </c:pt>
                <c:pt idx="284">
                  <c:v>0.77452056668518332</c:v>
                </c:pt>
                <c:pt idx="285">
                  <c:v>0.7976594744470763</c:v>
                </c:pt>
                <c:pt idx="286">
                  <c:v>0.4948961923990603</c:v>
                </c:pt>
                <c:pt idx="287">
                  <c:v>-1.1361437424644236</c:v>
                </c:pt>
                <c:pt idx="288">
                  <c:v>1.0873604439060074</c:v>
                </c:pt>
              </c:numCache>
            </c:numRef>
          </c:yVal>
          <c:smooth val="0"/>
          <c:extLst>
            <c:ext xmlns:c16="http://schemas.microsoft.com/office/drawing/2014/chart" uri="{C3380CC4-5D6E-409C-BE32-E72D297353CC}">
              <c16:uniqueId val="{00000000-6D97-47D5-8E62-7E6ADC73E578}"/>
            </c:ext>
          </c:extLst>
        </c:ser>
        <c:ser>
          <c:idx val="1"/>
          <c:order val="1"/>
          <c:tx>
            <c:strRef>
              <c:f>'527 dn del no change prion'!$E$1</c:f>
              <c:strCache>
                <c:ptCount val="1"/>
                <c:pt idx="0">
                  <c:v>swi1 log2FC</c:v>
                </c:pt>
              </c:strCache>
            </c:strRef>
          </c:tx>
          <c:spPr>
            <a:ln w="25400" cap="rnd">
              <a:noFill/>
              <a:round/>
            </a:ln>
            <a:effectLst/>
          </c:spPr>
          <c:marker>
            <c:symbol val="none"/>
          </c:marker>
          <c:errBars>
            <c:errDir val="y"/>
            <c:errBarType val="minus"/>
            <c:errValType val="percentage"/>
            <c:noEndCap val="1"/>
            <c:val val="100"/>
            <c:spPr>
              <a:noFill/>
              <a:ln w="12700" cap="flat" cmpd="sng" algn="ctr">
                <a:solidFill>
                  <a:srgbClr val="FF0000"/>
                </a:solidFill>
                <a:prstDash val="dash"/>
                <a:round/>
              </a:ln>
              <a:effectLst/>
            </c:spPr>
          </c:errBars>
          <c:xVal>
            <c:numRef>
              <c:f>'527 dn del no change prion'!$C$2:$C$290</c:f>
              <c:numCache>
                <c:formatCode>General</c:formatCode>
                <c:ptCount val="289"/>
                <c:pt idx="0">
                  <c:v>65778</c:v>
                </c:pt>
                <c:pt idx="1">
                  <c:v>74020</c:v>
                </c:pt>
                <c:pt idx="2">
                  <c:v>100225</c:v>
                </c:pt>
                <c:pt idx="3">
                  <c:v>118564</c:v>
                </c:pt>
                <c:pt idx="4">
                  <c:v>142174</c:v>
                </c:pt>
                <c:pt idx="5">
                  <c:v>241065</c:v>
                </c:pt>
                <c:pt idx="6">
                  <c:v>276196</c:v>
                </c:pt>
                <c:pt idx="7">
                  <c:v>291420</c:v>
                </c:pt>
                <c:pt idx="8">
                  <c:v>302084</c:v>
                </c:pt>
                <c:pt idx="9">
                  <c:v>318408</c:v>
                </c:pt>
                <c:pt idx="10">
                  <c:v>318741</c:v>
                </c:pt>
                <c:pt idx="11">
                  <c:v>357046</c:v>
                </c:pt>
                <c:pt idx="12">
                  <c:v>374207</c:v>
                </c:pt>
                <c:pt idx="13">
                  <c:v>393259</c:v>
                </c:pt>
                <c:pt idx="14">
                  <c:v>394706</c:v>
                </c:pt>
                <c:pt idx="15">
                  <c:v>397736</c:v>
                </c:pt>
                <c:pt idx="16">
                  <c:v>398641</c:v>
                </c:pt>
                <c:pt idx="17">
                  <c:v>402752</c:v>
                </c:pt>
                <c:pt idx="18">
                  <c:v>416216</c:v>
                </c:pt>
                <c:pt idx="19">
                  <c:v>422669</c:v>
                </c:pt>
                <c:pt idx="20">
                  <c:v>474584</c:v>
                </c:pt>
                <c:pt idx="21">
                  <c:v>506471</c:v>
                </c:pt>
                <c:pt idx="22">
                  <c:v>509239</c:v>
                </c:pt>
                <c:pt idx="23">
                  <c:v>547186</c:v>
                </c:pt>
                <c:pt idx="24">
                  <c:v>563049</c:v>
                </c:pt>
                <c:pt idx="25">
                  <c:v>602321</c:v>
                </c:pt>
                <c:pt idx="26">
                  <c:v>646201</c:v>
                </c:pt>
                <c:pt idx="27">
                  <c:v>758535</c:v>
                </c:pt>
                <c:pt idx="28">
                  <c:v>763980</c:v>
                </c:pt>
                <c:pt idx="29">
                  <c:v>837367</c:v>
                </c:pt>
                <c:pt idx="30">
                  <c:v>943222</c:v>
                </c:pt>
                <c:pt idx="31">
                  <c:v>1074851</c:v>
                </c:pt>
                <c:pt idx="32">
                  <c:v>1087063</c:v>
                </c:pt>
                <c:pt idx="33">
                  <c:v>1115205</c:v>
                </c:pt>
                <c:pt idx="34">
                  <c:v>1119420</c:v>
                </c:pt>
                <c:pt idx="35">
                  <c:v>1187036</c:v>
                </c:pt>
                <c:pt idx="36">
                  <c:v>1201940</c:v>
                </c:pt>
                <c:pt idx="37">
                  <c:v>1222012</c:v>
                </c:pt>
                <c:pt idx="38">
                  <c:v>1352472</c:v>
                </c:pt>
                <c:pt idx="39">
                  <c:v>1354360</c:v>
                </c:pt>
                <c:pt idx="40">
                  <c:v>1357292</c:v>
                </c:pt>
                <c:pt idx="41">
                  <c:v>1380657</c:v>
                </c:pt>
                <c:pt idx="42">
                  <c:v>1541208</c:v>
                </c:pt>
                <c:pt idx="43">
                  <c:v>1672973</c:v>
                </c:pt>
                <c:pt idx="44">
                  <c:v>1683239</c:v>
                </c:pt>
                <c:pt idx="45">
                  <c:v>1698294</c:v>
                </c:pt>
                <c:pt idx="46">
                  <c:v>1726761</c:v>
                </c:pt>
                <c:pt idx="47">
                  <c:v>1851039</c:v>
                </c:pt>
                <c:pt idx="48">
                  <c:v>1868169</c:v>
                </c:pt>
                <c:pt idx="49">
                  <c:v>1908784</c:v>
                </c:pt>
                <c:pt idx="50">
                  <c:v>1923549</c:v>
                </c:pt>
                <c:pt idx="51">
                  <c:v>1960815</c:v>
                </c:pt>
                <c:pt idx="52">
                  <c:v>1977492</c:v>
                </c:pt>
                <c:pt idx="53">
                  <c:v>2015035</c:v>
                </c:pt>
                <c:pt idx="54">
                  <c:v>2015708</c:v>
                </c:pt>
                <c:pt idx="55">
                  <c:v>2078838</c:v>
                </c:pt>
                <c:pt idx="56">
                  <c:v>2081093</c:v>
                </c:pt>
                <c:pt idx="57">
                  <c:v>2129547</c:v>
                </c:pt>
                <c:pt idx="58">
                  <c:v>2139065</c:v>
                </c:pt>
                <c:pt idx="59">
                  <c:v>2163217</c:v>
                </c:pt>
                <c:pt idx="60">
                  <c:v>2252897</c:v>
                </c:pt>
                <c:pt idx="61">
                  <c:v>2306829</c:v>
                </c:pt>
                <c:pt idx="62">
                  <c:v>2316035</c:v>
                </c:pt>
                <c:pt idx="63">
                  <c:v>2328155</c:v>
                </c:pt>
                <c:pt idx="64">
                  <c:v>2382029</c:v>
                </c:pt>
                <c:pt idx="65">
                  <c:v>2419649</c:v>
                </c:pt>
                <c:pt idx="66">
                  <c:v>2474455</c:v>
                </c:pt>
                <c:pt idx="67">
                  <c:v>2519630</c:v>
                </c:pt>
                <c:pt idx="68">
                  <c:v>2555434</c:v>
                </c:pt>
                <c:pt idx="69">
                  <c:v>2564519</c:v>
                </c:pt>
                <c:pt idx="70">
                  <c:v>2572460</c:v>
                </c:pt>
                <c:pt idx="71">
                  <c:v>2689622</c:v>
                </c:pt>
                <c:pt idx="72">
                  <c:v>2714851</c:v>
                </c:pt>
                <c:pt idx="73">
                  <c:v>2717602</c:v>
                </c:pt>
                <c:pt idx="74">
                  <c:v>2721142</c:v>
                </c:pt>
                <c:pt idx="75">
                  <c:v>2852499</c:v>
                </c:pt>
                <c:pt idx="76">
                  <c:v>2967899</c:v>
                </c:pt>
                <c:pt idx="77">
                  <c:v>2970008</c:v>
                </c:pt>
                <c:pt idx="78">
                  <c:v>2978134</c:v>
                </c:pt>
                <c:pt idx="79">
                  <c:v>2990623</c:v>
                </c:pt>
                <c:pt idx="80">
                  <c:v>3032681</c:v>
                </c:pt>
                <c:pt idx="81">
                  <c:v>3056482</c:v>
                </c:pt>
                <c:pt idx="82">
                  <c:v>3115322</c:v>
                </c:pt>
                <c:pt idx="83">
                  <c:v>3117844</c:v>
                </c:pt>
                <c:pt idx="84">
                  <c:v>3130415</c:v>
                </c:pt>
                <c:pt idx="85">
                  <c:v>3158467</c:v>
                </c:pt>
                <c:pt idx="86">
                  <c:v>3174660</c:v>
                </c:pt>
                <c:pt idx="87">
                  <c:v>3184195</c:v>
                </c:pt>
                <c:pt idx="88">
                  <c:v>3195985</c:v>
                </c:pt>
                <c:pt idx="89">
                  <c:v>3241935</c:v>
                </c:pt>
                <c:pt idx="90">
                  <c:v>3305349</c:v>
                </c:pt>
                <c:pt idx="91">
                  <c:v>3315907</c:v>
                </c:pt>
                <c:pt idx="92">
                  <c:v>3583819</c:v>
                </c:pt>
                <c:pt idx="93">
                  <c:v>3599890</c:v>
                </c:pt>
                <c:pt idx="94">
                  <c:v>3682141</c:v>
                </c:pt>
                <c:pt idx="95">
                  <c:v>3689336</c:v>
                </c:pt>
                <c:pt idx="96">
                  <c:v>3747460</c:v>
                </c:pt>
                <c:pt idx="97">
                  <c:v>3881236</c:v>
                </c:pt>
                <c:pt idx="98">
                  <c:v>3921380</c:v>
                </c:pt>
                <c:pt idx="99">
                  <c:v>4047703</c:v>
                </c:pt>
                <c:pt idx="100">
                  <c:v>4319425</c:v>
                </c:pt>
                <c:pt idx="101">
                  <c:v>4321980</c:v>
                </c:pt>
                <c:pt idx="102">
                  <c:v>4348574</c:v>
                </c:pt>
                <c:pt idx="103">
                  <c:v>4359911</c:v>
                </c:pt>
                <c:pt idx="104">
                  <c:v>4382138</c:v>
                </c:pt>
                <c:pt idx="105">
                  <c:v>4434407</c:v>
                </c:pt>
                <c:pt idx="106">
                  <c:v>4511444</c:v>
                </c:pt>
                <c:pt idx="107">
                  <c:v>4545402</c:v>
                </c:pt>
                <c:pt idx="108">
                  <c:v>4563049</c:v>
                </c:pt>
                <c:pt idx="109">
                  <c:v>4566542</c:v>
                </c:pt>
                <c:pt idx="110">
                  <c:v>4657502</c:v>
                </c:pt>
                <c:pt idx="111">
                  <c:v>4698894</c:v>
                </c:pt>
                <c:pt idx="112">
                  <c:v>4727039</c:v>
                </c:pt>
                <c:pt idx="113">
                  <c:v>4743614</c:v>
                </c:pt>
                <c:pt idx="114">
                  <c:v>4758588</c:v>
                </c:pt>
                <c:pt idx="115">
                  <c:v>4819296</c:v>
                </c:pt>
                <c:pt idx="116">
                  <c:v>4856171</c:v>
                </c:pt>
                <c:pt idx="117">
                  <c:v>4869004</c:v>
                </c:pt>
                <c:pt idx="118">
                  <c:v>4892891</c:v>
                </c:pt>
                <c:pt idx="119">
                  <c:v>4979505</c:v>
                </c:pt>
                <c:pt idx="120">
                  <c:v>5117011</c:v>
                </c:pt>
                <c:pt idx="121">
                  <c:v>5204584</c:v>
                </c:pt>
                <c:pt idx="122">
                  <c:v>5215440</c:v>
                </c:pt>
                <c:pt idx="123">
                  <c:v>5281257</c:v>
                </c:pt>
                <c:pt idx="124">
                  <c:v>5323826</c:v>
                </c:pt>
                <c:pt idx="125">
                  <c:v>5328501</c:v>
                </c:pt>
                <c:pt idx="126">
                  <c:v>5342662</c:v>
                </c:pt>
                <c:pt idx="127">
                  <c:v>5347462</c:v>
                </c:pt>
                <c:pt idx="128">
                  <c:v>5350642</c:v>
                </c:pt>
                <c:pt idx="129">
                  <c:v>5382029</c:v>
                </c:pt>
                <c:pt idx="130">
                  <c:v>5429958</c:v>
                </c:pt>
                <c:pt idx="131">
                  <c:v>5524817</c:v>
                </c:pt>
                <c:pt idx="132">
                  <c:v>5526990</c:v>
                </c:pt>
                <c:pt idx="133">
                  <c:v>5535501</c:v>
                </c:pt>
                <c:pt idx="134">
                  <c:v>5543132</c:v>
                </c:pt>
                <c:pt idx="135">
                  <c:v>5567880</c:v>
                </c:pt>
                <c:pt idx="136">
                  <c:v>5603496</c:v>
                </c:pt>
                <c:pt idx="137">
                  <c:v>5619175</c:v>
                </c:pt>
                <c:pt idx="138">
                  <c:v>5648799</c:v>
                </c:pt>
                <c:pt idx="139">
                  <c:v>5675602</c:v>
                </c:pt>
                <c:pt idx="140">
                  <c:v>5694673</c:v>
                </c:pt>
                <c:pt idx="141">
                  <c:v>5731917</c:v>
                </c:pt>
                <c:pt idx="142">
                  <c:v>5827846</c:v>
                </c:pt>
                <c:pt idx="143">
                  <c:v>5906248</c:v>
                </c:pt>
                <c:pt idx="144">
                  <c:v>6127260</c:v>
                </c:pt>
                <c:pt idx="145">
                  <c:v>6143383</c:v>
                </c:pt>
                <c:pt idx="146">
                  <c:v>6209123</c:v>
                </c:pt>
                <c:pt idx="147">
                  <c:v>6359345</c:v>
                </c:pt>
                <c:pt idx="148">
                  <c:v>6402082</c:v>
                </c:pt>
                <c:pt idx="149">
                  <c:v>6440766</c:v>
                </c:pt>
                <c:pt idx="150">
                  <c:v>6470251</c:v>
                </c:pt>
                <c:pt idx="151">
                  <c:v>6484362</c:v>
                </c:pt>
                <c:pt idx="152">
                  <c:v>6541272</c:v>
                </c:pt>
                <c:pt idx="153">
                  <c:v>6692568</c:v>
                </c:pt>
                <c:pt idx="154">
                  <c:v>6703971</c:v>
                </c:pt>
                <c:pt idx="155">
                  <c:v>6724134</c:v>
                </c:pt>
                <c:pt idx="156">
                  <c:v>6795556</c:v>
                </c:pt>
                <c:pt idx="157">
                  <c:v>6833932</c:v>
                </c:pt>
                <c:pt idx="158">
                  <c:v>6859237</c:v>
                </c:pt>
                <c:pt idx="159">
                  <c:v>6861103</c:v>
                </c:pt>
                <c:pt idx="160">
                  <c:v>6894166</c:v>
                </c:pt>
                <c:pt idx="161">
                  <c:v>6919524</c:v>
                </c:pt>
                <c:pt idx="162">
                  <c:v>6921064</c:v>
                </c:pt>
                <c:pt idx="163">
                  <c:v>6934960</c:v>
                </c:pt>
                <c:pt idx="164">
                  <c:v>7004454</c:v>
                </c:pt>
                <c:pt idx="165">
                  <c:v>7085110</c:v>
                </c:pt>
                <c:pt idx="166">
                  <c:v>7096410</c:v>
                </c:pt>
                <c:pt idx="167">
                  <c:v>7126428</c:v>
                </c:pt>
                <c:pt idx="168">
                  <c:v>7127660</c:v>
                </c:pt>
                <c:pt idx="169">
                  <c:v>7149824</c:v>
                </c:pt>
                <c:pt idx="170">
                  <c:v>7158424</c:v>
                </c:pt>
                <c:pt idx="171">
                  <c:v>7193942</c:v>
                </c:pt>
                <c:pt idx="172">
                  <c:v>7196208</c:v>
                </c:pt>
                <c:pt idx="173">
                  <c:v>7224568</c:v>
                </c:pt>
                <c:pt idx="174">
                  <c:v>7313608</c:v>
                </c:pt>
                <c:pt idx="175">
                  <c:v>7315661</c:v>
                </c:pt>
                <c:pt idx="176">
                  <c:v>7376757</c:v>
                </c:pt>
                <c:pt idx="177">
                  <c:v>7498889</c:v>
                </c:pt>
                <c:pt idx="178">
                  <c:v>7503020</c:v>
                </c:pt>
                <c:pt idx="179">
                  <c:v>7516036</c:v>
                </c:pt>
                <c:pt idx="180">
                  <c:v>7631539</c:v>
                </c:pt>
                <c:pt idx="181">
                  <c:v>7670214</c:v>
                </c:pt>
                <c:pt idx="182">
                  <c:v>7745761</c:v>
                </c:pt>
                <c:pt idx="183">
                  <c:v>7749619</c:v>
                </c:pt>
                <c:pt idx="184">
                  <c:v>7751162</c:v>
                </c:pt>
                <c:pt idx="185">
                  <c:v>7758190</c:v>
                </c:pt>
                <c:pt idx="186">
                  <c:v>7767691</c:v>
                </c:pt>
                <c:pt idx="187">
                  <c:v>7919455</c:v>
                </c:pt>
                <c:pt idx="188">
                  <c:v>7949521</c:v>
                </c:pt>
                <c:pt idx="189">
                  <c:v>7973983</c:v>
                </c:pt>
                <c:pt idx="190">
                  <c:v>8002293</c:v>
                </c:pt>
                <c:pt idx="191">
                  <c:v>8002665</c:v>
                </c:pt>
                <c:pt idx="192">
                  <c:v>8026171</c:v>
                </c:pt>
                <c:pt idx="193">
                  <c:v>8029941</c:v>
                </c:pt>
                <c:pt idx="194">
                  <c:v>8039514</c:v>
                </c:pt>
                <c:pt idx="195">
                  <c:v>8072005</c:v>
                </c:pt>
                <c:pt idx="196">
                  <c:v>8098489</c:v>
                </c:pt>
                <c:pt idx="197">
                  <c:v>8192281</c:v>
                </c:pt>
                <c:pt idx="198">
                  <c:v>8284298</c:v>
                </c:pt>
                <c:pt idx="199">
                  <c:v>8338340</c:v>
                </c:pt>
                <c:pt idx="200">
                  <c:v>8367250</c:v>
                </c:pt>
                <c:pt idx="201">
                  <c:v>8390973</c:v>
                </c:pt>
                <c:pt idx="202">
                  <c:v>8406295</c:v>
                </c:pt>
                <c:pt idx="203">
                  <c:v>8443294</c:v>
                </c:pt>
                <c:pt idx="204">
                  <c:v>8488738</c:v>
                </c:pt>
                <c:pt idx="205">
                  <c:v>8544611</c:v>
                </c:pt>
                <c:pt idx="206">
                  <c:v>8552142</c:v>
                </c:pt>
                <c:pt idx="207">
                  <c:v>8575044</c:v>
                </c:pt>
                <c:pt idx="208">
                  <c:v>8620483</c:v>
                </c:pt>
                <c:pt idx="209">
                  <c:v>8620711</c:v>
                </c:pt>
                <c:pt idx="210">
                  <c:v>8621123</c:v>
                </c:pt>
                <c:pt idx="211">
                  <c:v>8633413</c:v>
                </c:pt>
                <c:pt idx="212">
                  <c:v>8710520</c:v>
                </c:pt>
                <c:pt idx="213">
                  <c:v>8712027</c:v>
                </c:pt>
                <c:pt idx="214">
                  <c:v>8718259</c:v>
                </c:pt>
                <c:pt idx="215">
                  <c:v>8753284</c:v>
                </c:pt>
                <c:pt idx="216">
                  <c:v>8799102</c:v>
                </c:pt>
                <c:pt idx="217">
                  <c:v>8873411</c:v>
                </c:pt>
                <c:pt idx="218">
                  <c:v>9010721</c:v>
                </c:pt>
                <c:pt idx="219">
                  <c:v>9055619</c:v>
                </c:pt>
                <c:pt idx="220">
                  <c:v>9080455</c:v>
                </c:pt>
                <c:pt idx="221">
                  <c:v>9083012</c:v>
                </c:pt>
                <c:pt idx="222">
                  <c:v>9098520</c:v>
                </c:pt>
                <c:pt idx="223">
                  <c:v>9119745</c:v>
                </c:pt>
                <c:pt idx="224">
                  <c:v>9173279</c:v>
                </c:pt>
                <c:pt idx="225">
                  <c:v>9228030</c:v>
                </c:pt>
                <c:pt idx="226">
                  <c:v>9311206</c:v>
                </c:pt>
                <c:pt idx="227">
                  <c:v>9344600</c:v>
                </c:pt>
                <c:pt idx="228">
                  <c:v>9507075</c:v>
                </c:pt>
                <c:pt idx="229">
                  <c:v>9543596</c:v>
                </c:pt>
                <c:pt idx="230">
                  <c:v>9584181</c:v>
                </c:pt>
                <c:pt idx="231">
                  <c:v>9597543</c:v>
                </c:pt>
                <c:pt idx="232">
                  <c:v>9607232</c:v>
                </c:pt>
                <c:pt idx="233">
                  <c:v>9648676</c:v>
                </c:pt>
                <c:pt idx="234">
                  <c:v>9688433</c:v>
                </c:pt>
                <c:pt idx="235">
                  <c:v>9691034</c:v>
                </c:pt>
                <c:pt idx="236">
                  <c:v>9807450</c:v>
                </c:pt>
                <c:pt idx="237">
                  <c:v>9873810</c:v>
                </c:pt>
                <c:pt idx="238">
                  <c:v>9940197</c:v>
                </c:pt>
                <c:pt idx="239">
                  <c:v>9943231</c:v>
                </c:pt>
                <c:pt idx="240">
                  <c:v>9969574</c:v>
                </c:pt>
                <c:pt idx="241">
                  <c:v>10007703</c:v>
                </c:pt>
                <c:pt idx="242">
                  <c:v>10013011</c:v>
                </c:pt>
                <c:pt idx="243">
                  <c:v>10025238</c:v>
                </c:pt>
                <c:pt idx="244">
                  <c:v>10086564</c:v>
                </c:pt>
                <c:pt idx="245">
                  <c:v>10088421</c:v>
                </c:pt>
                <c:pt idx="246">
                  <c:v>10103269</c:v>
                </c:pt>
                <c:pt idx="247">
                  <c:v>10106369</c:v>
                </c:pt>
                <c:pt idx="248">
                  <c:v>10112317</c:v>
                </c:pt>
                <c:pt idx="249">
                  <c:v>10117425</c:v>
                </c:pt>
                <c:pt idx="250">
                  <c:v>10126825</c:v>
                </c:pt>
                <c:pt idx="251">
                  <c:v>10194325</c:v>
                </c:pt>
                <c:pt idx="252">
                  <c:v>10272173</c:v>
                </c:pt>
                <c:pt idx="253">
                  <c:v>10318141</c:v>
                </c:pt>
                <c:pt idx="254">
                  <c:v>10333016</c:v>
                </c:pt>
                <c:pt idx="255">
                  <c:v>10339907</c:v>
                </c:pt>
                <c:pt idx="256">
                  <c:v>10454637</c:v>
                </c:pt>
                <c:pt idx="257">
                  <c:v>10610533</c:v>
                </c:pt>
                <c:pt idx="258">
                  <c:v>10665251</c:v>
                </c:pt>
                <c:pt idx="259">
                  <c:v>10669543</c:v>
                </c:pt>
                <c:pt idx="260">
                  <c:v>10697754</c:v>
                </c:pt>
                <c:pt idx="261">
                  <c:v>10792794</c:v>
                </c:pt>
                <c:pt idx="262">
                  <c:v>10900309</c:v>
                </c:pt>
                <c:pt idx="263">
                  <c:v>10928794</c:v>
                </c:pt>
                <c:pt idx="264">
                  <c:v>10932219</c:v>
                </c:pt>
                <c:pt idx="265">
                  <c:v>11058812</c:v>
                </c:pt>
                <c:pt idx="266">
                  <c:v>11060163</c:v>
                </c:pt>
                <c:pt idx="267">
                  <c:v>11198959</c:v>
                </c:pt>
                <c:pt idx="268">
                  <c:v>11259050</c:v>
                </c:pt>
                <c:pt idx="269">
                  <c:v>11294744</c:v>
                </c:pt>
                <c:pt idx="270">
                  <c:v>11379173</c:v>
                </c:pt>
                <c:pt idx="271">
                  <c:v>11396515</c:v>
                </c:pt>
                <c:pt idx="272">
                  <c:v>11433470</c:v>
                </c:pt>
                <c:pt idx="273">
                  <c:v>11494238</c:v>
                </c:pt>
                <c:pt idx="274">
                  <c:v>11500551</c:v>
                </c:pt>
                <c:pt idx="275">
                  <c:v>11585741</c:v>
                </c:pt>
                <c:pt idx="276">
                  <c:v>11606103</c:v>
                </c:pt>
                <c:pt idx="277">
                  <c:v>11616803</c:v>
                </c:pt>
                <c:pt idx="278">
                  <c:v>11623935</c:v>
                </c:pt>
                <c:pt idx="279">
                  <c:v>11652983</c:v>
                </c:pt>
                <c:pt idx="280">
                  <c:v>11679637</c:v>
                </c:pt>
                <c:pt idx="281">
                  <c:v>11692596</c:v>
                </c:pt>
                <c:pt idx="282">
                  <c:v>11841960</c:v>
                </c:pt>
                <c:pt idx="283">
                  <c:v>11842408</c:v>
                </c:pt>
                <c:pt idx="284">
                  <c:v>11925619</c:v>
                </c:pt>
                <c:pt idx="285">
                  <c:v>11941583</c:v>
                </c:pt>
                <c:pt idx="286">
                  <c:v>11943025</c:v>
                </c:pt>
                <c:pt idx="287">
                  <c:v>11953178</c:v>
                </c:pt>
                <c:pt idx="288">
                  <c:v>12034517</c:v>
                </c:pt>
              </c:numCache>
            </c:numRef>
          </c:xVal>
          <c:yVal>
            <c:numRef>
              <c:f>'527 dn del no change prion'!$E$2:$E$290</c:f>
              <c:numCache>
                <c:formatCode>General</c:formatCode>
                <c:ptCount val="289"/>
                <c:pt idx="0">
                  <c:v>-1.1360562119362778</c:v>
                </c:pt>
                <c:pt idx="1">
                  <c:v>-2.3107955907648745</c:v>
                </c:pt>
                <c:pt idx="2">
                  <c:v>-0.99441290587027498</c:v>
                </c:pt>
                <c:pt idx="3">
                  <c:v>-2.0623067863594327</c:v>
                </c:pt>
                <c:pt idx="4">
                  <c:v>-1.543104750354946</c:v>
                </c:pt>
                <c:pt idx="5">
                  <c:v>-1.7211530067923446</c:v>
                </c:pt>
                <c:pt idx="6">
                  <c:v>-1.1831445023411751</c:v>
                </c:pt>
                <c:pt idx="7">
                  <c:v>-1.7052539519764656</c:v>
                </c:pt>
                <c:pt idx="8">
                  <c:v>-1.7735839689333612</c:v>
                </c:pt>
                <c:pt idx="9">
                  <c:v>-1.4008506953733764</c:v>
                </c:pt>
                <c:pt idx="10">
                  <c:v>-2.3671551709787924</c:v>
                </c:pt>
                <c:pt idx="11">
                  <c:v>-1.3315157101713946</c:v>
                </c:pt>
                <c:pt idx="12">
                  <c:v>-1.4493253800024626</c:v>
                </c:pt>
                <c:pt idx="13">
                  <c:v>-1.5785332605831153</c:v>
                </c:pt>
                <c:pt idx="14">
                  <c:v>-1.1634964902011669</c:v>
                </c:pt>
                <c:pt idx="15">
                  <c:v>-1.5213883566727804</c:v>
                </c:pt>
                <c:pt idx="16">
                  <c:v>-1.2128940061344675</c:v>
                </c:pt>
                <c:pt idx="17">
                  <c:v>-1.2027664724698182</c:v>
                </c:pt>
                <c:pt idx="18">
                  <c:v>-2.2200630042669935</c:v>
                </c:pt>
                <c:pt idx="19">
                  <c:v>-3.5091779551434472</c:v>
                </c:pt>
                <c:pt idx="20">
                  <c:v>-1.6061452808011443</c:v>
                </c:pt>
                <c:pt idx="21">
                  <c:v>-2.1745774363417589</c:v>
                </c:pt>
                <c:pt idx="22">
                  <c:v>-1.7862151726580497</c:v>
                </c:pt>
                <c:pt idx="23">
                  <c:v>-1.1791191895855209</c:v>
                </c:pt>
                <c:pt idx="24">
                  <c:v>-1.0529339696204065</c:v>
                </c:pt>
                <c:pt idx="25">
                  <c:v>-1.0357482610884023</c:v>
                </c:pt>
                <c:pt idx="26">
                  <c:v>-1.1277408204703108</c:v>
                </c:pt>
                <c:pt idx="27">
                  <c:v>-1.113723837553892</c:v>
                </c:pt>
                <c:pt idx="28">
                  <c:v>-1.2691729770896085</c:v>
                </c:pt>
                <c:pt idx="29">
                  <c:v>-1.8497042997341797</c:v>
                </c:pt>
                <c:pt idx="30">
                  <c:v>-1.4383927665860134</c:v>
                </c:pt>
                <c:pt idx="31">
                  <c:v>-1.3510187420142614</c:v>
                </c:pt>
                <c:pt idx="32">
                  <c:v>-2.2126166256991375</c:v>
                </c:pt>
                <c:pt idx="33">
                  <c:v>-1.1740317848802391</c:v>
                </c:pt>
                <c:pt idx="34">
                  <c:v>-1.0523453416448563</c:v>
                </c:pt>
                <c:pt idx="35">
                  <c:v>-1.778187857692888</c:v>
                </c:pt>
                <c:pt idx="36">
                  <c:v>-1.044904615922398</c:v>
                </c:pt>
                <c:pt idx="37">
                  <c:v>-1.03427778725658</c:v>
                </c:pt>
                <c:pt idx="38">
                  <c:v>-1.488214300953582</c:v>
                </c:pt>
                <c:pt idx="39">
                  <c:v>-1.4773416977207141</c:v>
                </c:pt>
                <c:pt idx="40">
                  <c:v>-1.4527566496272435</c:v>
                </c:pt>
                <c:pt idx="41">
                  <c:v>-1.631382936598835</c:v>
                </c:pt>
                <c:pt idx="42">
                  <c:v>-1.5484652438962843</c:v>
                </c:pt>
                <c:pt idx="43">
                  <c:v>-1.1236358383516556</c:v>
                </c:pt>
                <c:pt idx="44">
                  <c:v>-1.0953454029612775</c:v>
                </c:pt>
                <c:pt idx="45">
                  <c:v>-1.1615995983303622</c:v>
                </c:pt>
                <c:pt idx="46">
                  <c:v>-1.1047155598903979</c:v>
                </c:pt>
                <c:pt idx="47">
                  <c:v>-2.338402346054266</c:v>
                </c:pt>
                <c:pt idx="48">
                  <c:v>-1.0983858635304449</c:v>
                </c:pt>
                <c:pt idx="49">
                  <c:v>-1.1112715583584751</c:v>
                </c:pt>
                <c:pt idx="50">
                  <c:v>-1.0305914940814114</c:v>
                </c:pt>
                <c:pt idx="51">
                  <c:v>-1.3856387620890984</c:v>
                </c:pt>
                <c:pt idx="52">
                  <c:v>-1.2666419764134285</c:v>
                </c:pt>
                <c:pt idx="53">
                  <c:v>-1.207041386210232</c:v>
                </c:pt>
                <c:pt idx="54">
                  <c:v>-1.2941613106531706</c:v>
                </c:pt>
                <c:pt idx="55">
                  <c:v>-1.4894552725513279</c:v>
                </c:pt>
                <c:pt idx="56">
                  <c:v>-1.1241611077855818</c:v>
                </c:pt>
                <c:pt idx="57">
                  <c:v>-1.0723585756831957</c:v>
                </c:pt>
                <c:pt idx="58">
                  <c:v>-1.359443415431135</c:v>
                </c:pt>
                <c:pt idx="59">
                  <c:v>-1.4768539022406812</c:v>
                </c:pt>
                <c:pt idx="60">
                  <c:v>-1.2675231664869608</c:v>
                </c:pt>
                <c:pt idx="61">
                  <c:v>-1.6372690129436811</c:v>
                </c:pt>
                <c:pt idx="62">
                  <c:v>-2.1127514191058068</c:v>
                </c:pt>
                <c:pt idx="63">
                  <c:v>-1.0530881869414854</c:v>
                </c:pt>
                <c:pt idx="64">
                  <c:v>-1.3400414412653836</c:v>
                </c:pt>
                <c:pt idx="65">
                  <c:v>-1.9483758046717814</c:v>
                </c:pt>
                <c:pt idx="66">
                  <c:v>-1.3701555387640796</c:v>
                </c:pt>
                <c:pt idx="67">
                  <c:v>-2.5362040147974114</c:v>
                </c:pt>
                <c:pt idx="68">
                  <c:v>-1.3409971838126167</c:v>
                </c:pt>
                <c:pt idx="69">
                  <c:v>-3.7461719797344948</c:v>
                </c:pt>
                <c:pt idx="70">
                  <c:v>-1.1025350147283768</c:v>
                </c:pt>
                <c:pt idx="71">
                  <c:v>-1.2638611185290092</c:v>
                </c:pt>
                <c:pt idx="72">
                  <c:v>-1.4215427011983099</c:v>
                </c:pt>
                <c:pt idx="73">
                  <c:v>-1.3911103634261937</c:v>
                </c:pt>
                <c:pt idx="74">
                  <c:v>0</c:v>
                </c:pt>
                <c:pt idx="75">
                  <c:v>-1.453944970198616</c:v>
                </c:pt>
                <c:pt idx="76">
                  <c:v>-1.4579779270228836</c:v>
                </c:pt>
                <c:pt idx="77">
                  <c:v>-2.1194287734871238</c:v>
                </c:pt>
                <c:pt idx="78">
                  <c:v>-1.080990706759176</c:v>
                </c:pt>
                <c:pt idx="79">
                  <c:v>-1.4937924232786675</c:v>
                </c:pt>
                <c:pt idx="80">
                  <c:v>-1.0545792646017211</c:v>
                </c:pt>
                <c:pt idx="81">
                  <c:v>-1.4342152222855731</c:v>
                </c:pt>
                <c:pt idx="82">
                  <c:v>-1.7657146235328596</c:v>
                </c:pt>
                <c:pt idx="83">
                  <c:v>-1.1437396396888868</c:v>
                </c:pt>
                <c:pt idx="84">
                  <c:v>-1.805752122898906</c:v>
                </c:pt>
                <c:pt idx="85">
                  <c:v>-1.0318789511946862</c:v>
                </c:pt>
                <c:pt idx="86">
                  <c:v>-3.0929348816788633</c:v>
                </c:pt>
                <c:pt idx="87">
                  <c:v>-1.0955917801912933</c:v>
                </c:pt>
                <c:pt idx="88">
                  <c:v>-1.0460458975128126</c:v>
                </c:pt>
                <c:pt idx="89">
                  <c:v>-1.1679472113789413</c:v>
                </c:pt>
                <c:pt idx="90">
                  <c:v>-1.7302754618306058</c:v>
                </c:pt>
                <c:pt idx="91">
                  <c:v>-1.196699901434273</c:v>
                </c:pt>
                <c:pt idx="92">
                  <c:v>-1.3574469513015108</c:v>
                </c:pt>
                <c:pt idx="93">
                  <c:v>-1.3585237758504378</c:v>
                </c:pt>
                <c:pt idx="94">
                  <c:v>-1.0203468058645513</c:v>
                </c:pt>
                <c:pt idx="95">
                  <c:v>-1.5199359813702131</c:v>
                </c:pt>
                <c:pt idx="96">
                  <c:v>-1.2511453327572033</c:v>
                </c:pt>
                <c:pt idx="97">
                  <c:v>-1.8600338568538914</c:v>
                </c:pt>
                <c:pt idx="98">
                  <c:v>-1.3452817859275981</c:v>
                </c:pt>
                <c:pt idx="99">
                  <c:v>-1.3273112368369955</c:v>
                </c:pt>
                <c:pt idx="100">
                  <c:v>-1.3072572409754475</c:v>
                </c:pt>
                <c:pt idx="101">
                  <c:v>-1.0250425125183222</c:v>
                </c:pt>
                <c:pt idx="102">
                  <c:v>-1.223304251180122</c:v>
                </c:pt>
                <c:pt idx="103">
                  <c:v>-1.4198708684210177</c:v>
                </c:pt>
                <c:pt idx="104">
                  <c:v>-1.3302332273007931</c:v>
                </c:pt>
                <c:pt idx="105">
                  <c:v>-7.588934068370361</c:v>
                </c:pt>
                <c:pt idx="106">
                  <c:v>-1.3055912277498574</c:v>
                </c:pt>
                <c:pt idx="107">
                  <c:v>-3.5075787839853443</c:v>
                </c:pt>
                <c:pt idx="108">
                  <c:v>-1.0374783198658386</c:v>
                </c:pt>
                <c:pt idx="109">
                  <c:v>-1.0507977399424582</c:v>
                </c:pt>
                <c:pt idx="110">
                  <c:v>-1.7529150815325119</c:v>
                </c:pt>
                <c:pt idx="111">
                  <c:v>-1.0407434524694974</c:v>
                </c:pt>
                <c:pt idx="112">
                  <c:v>-1.5109357370343848</c:v>
                </c:pt>
                <c:pt idx="113">
                  <c:v>-1.6957553779997081</c:v>
                </c:pt>
                <c:pt idx="114">
                  <c:v>-1.4444303496100552</c:v>
                </c:pt>
                <c:pt idx="115">
                  <c:v>-1.3443610091420477</c:v>
                </c:pt>
                <c:pt idx="116">
                  <c:v>-1.4520340108747265</c:v>
                </c:pt>
                <c:pt idx="117">
                  <c:v>-1.0913347527301682</c:v>
                </c:pt>
                <c:pt idx="118">
                  <c:v>-1.1480642151860134</c:v>
                </c:pt>
                <c:pt idx="119">
                  <c:v>-1.3578474719575235</c:v>
                </c:pt>
                <c:pt idx="120">
                  <c:v>-2.0933599731195018</c:v>
                </c:pt>
                <c:pt idx="121">
                  <c:v>-1.1269556336924067</c:v>
                </c:pt>
                <c:pt idx="122">
                  <c:v>-1.2849035962896382</c:v>
                </c:pt>
                <c:pt idx="123">
                  <c:v>-1.1075079569680053</c:v>
                </c:pt>
                <c:pt idx="124">
                  <c:v>-1.1723608012307813</c:v>
                </c:pt>
                <c:pt idx="125">
                  <c:v>-1.4680704718588005</c:v>
                </c:pt>
                <c:pt idx="126">
                  <c:v>-1.6674773944523713</c:v>
                </c:pt>
                <c:pt idx="127">
                  <c:v>-1.1675513010749652</c:v>
                </c:pt>
                <c:pt idx="128">
                  <c:v>-1.6620529172707392</c:v>
                </c:pt>
                <c:pt idx="129">
                  <c:v>-1.0938834580543073</c:v>
                </c:pt>
                <c:pt idx="130">
                  <c:v>-1.6725875608143665</c:v>
                </c:pt>
                <c:pt idx="131">
                  <c:v>-1.9261567513488291</c:v>
                </c:pt>
                <c:pt idx="132">
                  <c:v>-1.6264293473673628</c:v>
                </c:pt>
                <c:pt idx="133">
                  <c:v>-1.3619906326543489</c:v>
                </c:pt>
                <c:pt idx="134">
                  <c:v>-1.4675577419734303</c:v>
                </c:pt>
                <c:pt idx="135">
                  <c:v>-1.2823746331538601</c:v>
                </c:pt>
                <c:pt idx="136">
                  <c:v>-1.6573523606988345</c:v>
                </c:pt>
                <c:pt idx="137">
                  <c:v>-1.0307030900326075</c:v>
                </c:pt>
                <c:pt idx="138">
                  <c:v>-1.7439508304948301</c:v>
                </c:pt>
                <c:pt idx="139">
                  <c:v>-1.1268689067029012</c:v>
                </c:pt>
                <c:pt idx="140">
                  <c:v>-1.6300391159964962</c:v>
                </c:pt>
                <c:pt idx="141">
                  <c:v>-1.079698479884194</c:v>
                </c:pt>
                <c:pt idx="142">
                  <c:v>-1.318754629198527</c:v>
                </c:pt>
                <c:pt idx="143">
                  <c:v>-1.0333004216430079</c:v>
                </c:pt>
                <c:pt idx="144">
                  <c:v>-1.3413236482186499</c:v>
                </c:pt>
                <c:pt idx="145">
                  <c:v>-1.5661328760607145</c:v>
                </c:pt>
                <c:pt idx="146">
                  <c:v>-1.419852122149069</c:v>
                </c:pt>
                <c:pt idx="147">
                  <c:v>-1.8246581216763922</c:v>
                </c:pt>
                <c:pt idx="148">
                  <c:v>-1.7531893022166738</c:v>
                </c:pt>
                <c:pt idx="149">
                  <c:v>-1.3542681445108335</c:v>
                </c:pt>
                <c:pt idx="150">
                  <c:v>-1.4867998865470426</c:v>
                </c:pt>
                <c:pt idx="151">
                  <c:v>-1.6867707825075533</c:v>
                </c:pt>
                <c:pt idx="152">
                  <c:v>-1.1563470082607656</c:v>
                </c:pt>
                <c:pt idx="153">
                  <c:v>-1.2263107224768433</c:v>
                </c:pt>
                <c:pt idx="154">
                  <c:v>-1.4680573656277072</c:v>
                </c:pt>
                <c:pt idx="155">
                  <c:v>-1.2267647304149296</c:v>
                </c:pt>
                <c:pt idx="156">
                  <c:v>-1.3844002443578329</c:v>
                </c:pt>
                <c:pt idx="157">
                  <c:v>-1.7264628748737587</c:v>
                </c:pt>
                <c:pt idx="158">
                  <c:v>-1.430149155997176</c:v>
                </c:pt>
                <c:pt idx="159">
                  <c:v>-1.7164375142697126</c:v>
                </c:pt>
                <c:pt idx="160">
                  <c:v>-1.5732573255323048</c:v>
                </c:pt>
                <c:pt idx="161">
                  <c:v>-1.2967090150121747</c:v>
                </c:pt>
                <c:pt idx="162">
                  <c:v>-1.4923566947768836</c:v>
                </c:pt>
                <c:pt idx="163">
                  <c:v>-1.6742616104874246</c:v>
                </c:pt>
                <c:pt idx="164">
                  <c:v>-1.7405996486034552</c:v>
                </c:pt>
                <c:pt idx="165">
                  <c:v>-1.4182560834946998</c:v>
                </c:pt>
                <c:pt idx="166">
                  <c:v>-1.0606902180160069</c:v>
                </c:pt>
                <c:pt idx="167">
                  <c:v>-1.25969090705335</c:v>
                </c:pt>
                <c:pt idx="168">
                  <c:v>-1.1208029811352551</c:v>
                </c:pt>
                <c:pt idx="169">
                  <c:v>-1.9496943802868536</c:v>
                </c:pt>
                <c:pt idx="170">
                  <c:v>-1.2962989810425731</c:v>
                </c:pt>
                <c:pt idx="171">
                  <c:v>-1.428655735473866</c:v>
                </c:pt>
                <c:pt idx="172">
                  <c:v>-1.8682686820173535</c:v>
                </c:pt>
                <c:pt idx="173">
                  <c:v>-1.1141200226661048</c:v>
                </c:pt>
                <c:pt idx="174">
                  <c:v>-1.2815751283706132</c:v>
                </c:pt>
                <c:pt idx="175">
                  <c:v>-1.3797023799837769</c:v>
                </c:pt>
                <c:pt idx="176">
                  <c:v>-1.3324327415294452</c:v>
                </c:pt>
                <c:pt idx="177">
                  <c:v>-1.4845321770690927</c:v>
                </c:pt>
                <c:pt idx="178">
                  <c:v>-1.7748061245637634</c:v>
                </c:pt>
                <c:pt idx="179">
                  <c:v>-1.1605701305735161</c:v>
                </c:pt>
                <c:pt idx="180">
                  <c:v>-1.7733207446739851</c:v>
                </c:pt>
                <c:pt idx="181">
                  <c:v>-1.9711465031706925</c:v>
                </c:pt>
                <c:pt idx="182">
                  <c:v>-1.2024721488573273</c:v>
                </c:pt>
                <c:pt idx="183">
                  <c:v>-1.2310083635287126</c:v>
                </c:pt>
                <c:pt idx="184">
                  <c:v>-1.4526693038264153</c:v>
                </c:pt>
                <c:pt idx="185">
                  <c:v>-1.6851914636504488</c:v>
                </c:pt>
                <c:pt idx="186">
                  <c:v>-1.417116364399259</c:v>
                </c:pt>
                <c:pt idx="187">
                  <c:v>-1.2462757017014761</c:v>
                </c:pt>
                <c:pt idx="188">
                  <c:v>-4.9290299447365218</c:v>
                </c:pt>
                <c:pt idx="189">
                  <c:v>-1.2973462239144715</c:v>
                </c:pt>
                <c:pt idx="190">
                  <c:v>-1.7737675887473172</c:v>
                </c:pt>
                <c:pt idx="191">
                  <c:v>-1.514907491099424</c:v>
                </c:pt>
                <c:pt idx="192">
                  <c:v>-1.5657010925570827</c:v>
                </c:pt>
                <c:pt idx="193">
                  <c:v>-1.1015121753218715</c:v>
                </c:pt>
                <c:pt idx="194">
                  <c:v>-1.3953784381914482</c:v>
                </c:pt>
                <c:pt idx="195">
                  <c:v>-1.1527436524969468</c:v>
                </c:pt>
                <c:pt idx="196">
                  <c:v>-1.08954074779625</c:v>
                </c:pt>
                <c:pt idx="197">
                  <c:v>-1.2720395499118755</c:v>
                </c:pt>
                <c:pt idx="198">
                  <c:v>-1.1588263690835765</c:v>
                </c:pt>
                <c:pt idx="199">
                  <c:v>-1.1961910784333898</c:v>
                </c:pt>
                <c:pt idx="200">
                  <c:v>-1.075602111900845</c:v>
                </c:pt>
                <c:pt idx="201">
                  <c:v>-1.8177211492616954</c:v>
                </c:pt>
                <c:pt idx="202">
                  <c:v>-1.0484863995050322</c:v>
                </c:pt>
                <c:pt idx="203">
                  <c:v>-1.4547258931175895</c:v>
                </c:pt>
                <c:pt idx="204">
                  <c:v>-3.3417633398498041</c:v>
                </c:pt>
                <c:pt idx="205">
                  <c:v>-1.2831510243261877</c:v>
                </c:pt>
                <c:pt idx="206">
                  <c:v>-2.2680837708570487</c:v>
                </c:pt>
                <c:pt idx="207">
                  <c:v>-1.7766854395229248</c:v>
                </c:pt>
                <c:pt idx="208">
                  <c:v>-1.4083536128809309</c:v>
                </c:pt>
                <c:pt idx="209">
                  <c:v>-1.2348333089069503</c:v>
                </c:pt>
                <c:pt idx="210">
                  <c:v>-2.9472668352239402</c:v>
                </c:pt>
                <c:pt idx="211">
                  <c:v>-1.6019178779381973</c:v>
                </c:pt>
                <c:pt idx="212">
                  <c:v>-1.0096941867404075</c:v>
                </c:pt>
                <c:pt idx="213">
                  <c:v>-1.0520352029518394</c:v>
                </c:pt>
                <c:pt idx="214">
                  <c:v>-1.4334538734403504</c:v>
                </c:pt>
                <c:pt idx="215">
                  <c:v>-1.2860404200315056</c:v>
                </c:pt>
                <c:pt idx="216">
                  <c:v>-1.007057957850245</c:v>
                </c:pt>
                <c:pt idx="217">
                  <c:v>-1.8839502551174065</c:v>
                </c:pt>
                <c:pt idx="218">
                  <c:v>-1.0208983246736976</c:v>
                </c:pt>
                <c:pt idx="219">
                  <c:v>-1.171056901614471</c:v>
                </c:pt>
                <c:pt idx="220">
                  <c:v>-1.2464122606664265</c:v>
                </c:pt>
                <c:pt idx="221">
                  <c:v>-2.0684983523897831</c:v>
                </c:pt>
                <c:pt idx="222">
                  <c:v>-1.3429939708192531</c:v>
                </c:pt>
                <c:pt idx="223">
                  <c:v>-1.6680809957959732</c:v>
                </c:pt>
                <c:pt idx="224">
                  <c:v>-2.3864552505668279</c:v>
                </c:pt>
                <c:pt idx="225">
                  <c:v>-1.8520441370452081</c:v>
                </c:pt>
                <c:pt idx="226">
                  <c:v>-1.5221365357783212</c:v>
                </c:pt>
                <c:pt idx="227">
                  <c:v>-1.1362596138084076</c:v>
                </c:pt>
                <c:pt idx="228">
                  <c:v>-1.3624146269817519</c:v>
                </c:pt>
                <c:pt idx="229">
                  <c:v>-1.4872264985450199</c:v>
                </c:pt>
                <c:pt idx="230">
                  <c:v>-1.6421693291060064</c:v>
                </c:pt>
                <c:pt idx="231">
                  <c:v>-1.9951669341582956</c:v>
                </c:pt>
                <c:pt idx="232">
                  <c:v>-0.99317517310689174</c:v>
                </c:pt>
                <c:pt idx="233">
                  <c:v>-2.5844792081328021</c:v>
                </c:pt>
                <c:pt idx="234">
                  <c:v>-1.0418594409617139</c:v>
                </c:pt>
                <c:pt idx="235">
                  <c:v>-3.2801289473468742</c:v>
                </c:pt>
                <c:pt idx="236">
                  <c:v>-1.1158928077144283</c:v>
                </c:pt>
                <c:pt idx="237">
                  <c:v>-1.2818964605377341</c:v>
                </c:pt>
                <c:pt idx="238">
                  <c:v>-2.1983455940030043</c:v>
                </c:pt>
                <c:pt idx="239">
                  <c:v>-2.7164781529600606</c:v>
                </c:pt>
                <c:pt idx="240">
                  <c:v>-1.6221227643224472</c:v>
                </c:pt>
                <c:pt idx="241">
                  <c:v>-1.1990962142987838</c:v>
                </c:pt>
                <c:pt idx="242">
                  <c:v>-1.1408002210354455</c:v>
                </c:pt>
                <c:pt idx="243">
                  <c:v>-1.1284722725695349</c:v>
                </c:pt>
                <c:pt idx="244">
                  <c:v>-1.57426427961155</c:v>
                </c:pt>
                <c:pt idx="245">
                  <c:v>-1.2331305656310605</c:v>
                </c:pt>
                <c:pt idx="246">
                  <c:v>-1.4778900545428135</c:v>
                </c:pt>
                <c:pt idx="247">
                  <c:v>-2.6504457098485088</c:v>
                </c:pt>
                <c:pt idx="248">
                  <c:v>-1.5749205715531449</c:v>
                </c:pt>
                <c:pt idx="249">
                  <c:v>-1.4072673859860785</c:v>
                </c:pt>
                <c:pt idx="250">
                  <c:v>-1.244030256425503</c:v>
                </c:pt>
                <c:pt idx="251">
                  <c:v>-1.1259531528426632</c:v>
                </c:pt>
                <c:pt idx="252">
                  <c:v>-2.5968991551739049</c:v>
                </c:pt>
                <c:pt idx="253">
                  <c:v>-1.5240186866975287</c:v>
                </c:pt>
                <c:pt idx="254">
                  <c:v>-1.2484186335226664</c:v>
                </c:pt>
                <c:pt idx="255">
                  <c:v>-1.2647590699346989</c:v>
                </c:pt>
                <c:pt idx="256">
                  <c:v>-1.3202763931637438</c:v>
                </c:pt>
                <c:pt idx="257">
                  <c:v>-1.2145631140659039</c:v>
                </c:pt>
                <c:pt idx="258">
                  <c:v>-1.0090423827426527</c:v>
                </c:pt>
                <c:pt idx="259">
                  <c:v>-1.6050270639149136</c:v>
                </c:pt>
                <c:pt idx="260">
                  <c:v>-1.0124938657850742</c:v>
                </c:pt>
                <c:pt idx="261">
                  <c:v>-1.3036416773709119</c:v>
                </c:pt>
                <c:pt idx="262">
                  <c:v>-1.2153595859359931</c:v>
                </c:pt>
                <c:pt idx="263">
                  <c:v>-2.0194820602495711</c:v>
                </c:pt>
                <c:pt idx="264">
                  <c:v>-1.7664295510115289</c:v>
                </c:pt>
                <c:pt idx="265">
                  <c:v>-1.2050768888309333</c:v>
                </c:pt>
                <c:pt idx="266">
                  <c:v>-2.1170219511002082</c:v>
                </c:pt>
                <c:pt idx="267">
                  <c:v>-1.0107172323522671</c:v>
                </c:pt>
                <c:pt idx="268">
                  <c:v>-1.0749604609173862</c:v>
                </c:pt>
                <c:pt idx="269">
                  <c:v>-1.747381724454955</c:v>
                </c:pt>
                <c:pt idx="270">
                  <c:v>-1.7126204334798052</c:v>
                </c:pt>
                <c:pt idx="271">
                  <c:v>-1.2970303577389415</c:v>
                </c:pt>
                <c:pt idx="272">
                  <c:v>-1.56836421043222</c:v>
                </c:pt>
                <c:pt idx="273">
                  <c:v>-1.0943405923983955</c:v>
                </c:pt>
                <c:pt idx="274">
                  <c:v>-1.0527252673607186</c:v>
                </c:pt>
                <c:pt idx="275">
                  <c:v>-1.0144056489589968</c:v>
                </c:pt>
                <c:pt idx="276">
                  <c:v>-2.176428229426179</c:v>
                </c:pt>
                <c:pt idx="277">
                  <c:v>-1.0932090283940059</c:v>
                </c:pt>
                <c:pt idx="278">
                  <c:v>-1.0846299944305546</c:v>
                </c:pt>
                <c:pt idx="279">
                  <c:v>-1.2747418310608061</c:v>
                </c:pt>
                <c:pt idx="280">
                  <c:v>-1.3555240146950007</c:v>
                </c:pt>
                <c:pt idx="281">
                  <c:v>-1.0583944381766426</c:v>
                </c:pt>
                <c:pt idx="282">
                  <c:v>-1.3059979447545373</c:v>
                </c:pt>
                <c:pt idx="283">
                  <c:v>-1.198158861665678</c:v>
                </c:pt>
                <c:pt idx="284">
                  <c:v>-1.4788934541554637</c:v>
                </c:pt>
                <c:pt idx="285">
                  <c:v>-1.6236583666995643</c:v>
                </c:pt>
                <c:pt idx="286">
                  <c:v>-1.11141526389565</c:v>
                </c:pt>
                <c:pt idx="287">
                  <c:v>-3.9575076339399518</c:v>
                </c:pt>
                <c:pt idx="288">
                  <c:v>-1.0300966277143293</c:v>
                </c:pt>
              </c:numCache>
            </c:numRef>
          </c:yVal>
          <c:smooth val="0"/>
          <c:extLst>
            <c:ext xmlns:c16="http://schemas.microsoft.com/office/drawing/2014/chart" uri="{C3380CC4-5D6E-409C-BE32-E72D297353CC}">
              <c16:uniqueId val="{00000001-6D97-47D5-8E62-7E6ADC73E578}"/>
            </c:ext>
          </c:extLst>
        </c:ser>
        <c:dLbls>
          <c:showLegendKey val="0"/>
          <c:showVal val="0"/>
          <c:showCatName val="0"/>
          <c:showSerName val="0"/>
          <c:showPercent val="0"/>
          <c:showBubbleSize val="0"/>
        </c:dLbls>
        <c:axId val="171496192"/>
        <c:axId val="171497728"/>
      </c:scatterChart>
      <c:valAx>
        <c:axId val="171496192"/>
        <c:scaling>
          <c:orientation val="minMax"/>
          <c:max val="12157105"/>
          <c:min val="1"/>
        </c:scaling>
        <c:delete val="0"/>
        <c:axPos val="b"/>
        <c:numFmt formatCode="General" sourceLinked="1"/>
        <c:majorTickMark val="none"/>
        <c:minorTickMark val="none"/>
        <c:tickLblPos val="none"/>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497728"/>
        <c:crosses val="autoZero"/>
        <c:crossBetween val="midCat"/>
      </c:valAx>
      <c:valAx>
        <c:axId val="171497728"/>
        <c:scaling>
          <c:orientation val="minMax"/>
          <c:max val="1"/>
          <c:min val="-6"/>
        </c:scaling>
        <c:delete val="0"/>
        <c:axPos val="l"/>
        <c:numFmt formatCode="General" sourceLinked="1"/>
        <c:majorTickMark val="none"/>
        <c:minorTickMark val="none"/>
        <c:tickLblPos val="nextTo"/>
        <c:spPr>
          <a:noFill/>
          <a:ln w="9525" cap="flat" cmpd="sng" algn="ctr">
            <a:solidFill>
              <a:schemeClr val="bg1">
                <a:lumMod val="7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71496192"/>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18034109387998E-2"/>
          <c:y val="6.646725489744193E-2"/>
          <c:w val="0.89994246312866644"/>
          <c:h val="0.86706549020511614"/>
        </c:manualLayout>
      </c:layout>
      <c:scatterChart>
        <c:scatterStyle val="lineMarker"/>
        <c:varyColors val="0"/>
        <c:ser>
          <c:idx val="0"/>
          <c:order val="0"/>
          <c:tx>
            <c:strRef>
              <c:f>'308 dn prion no change del'!$E$153</c:f>
              <c:strCache>
                <c:ptCount val="1"/>
                <c:pt idx="0">
                  <c:v>[SWI+]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00B0F0"/>
                </a:solidFill>
                <a:round/>
              </a:ln>
              <a:effectLst/>
            </c:spPr>
          </c:errBars>
          <c:xVal>
            <c:numRef>
              <c:f>'308 dn prion no change del'!$D$154:$D$310</c:f>
              <c:numCache>
                <c:formatCode>General</c:formatCode>
                <c:ptCount val="157"/>
                <c:pt idx="0">
                  <c:v>11842147</c:v>
                </c:pt>
                <c:pt idx="1">
                  <c:v>83335</c:v>
                </c:pt>
                <c:pt idx="2">
                  <c:v>80710</c:v>
                </c:pt>
                <c:pt idx="3">
                  <c:v>68716</c:v>
                </c:pt>
                <c:pt idx="4">
                  <c:v>42881</c:v>
                </c:pt>
                <c:pt idx="5">
                  <c:v>24000</c:v>
                </c:pt>
                <c:pt idx="6">
                  <c:v>330589</c:v>
                </c:pt>
                <c:pt idx="7">
                  <c:v>314717</c:v>
                </c:pt>
                <c:pt idx="8">
                  <c:v>255164</c:v>
                </c:pt>
                <c:pt idx="9">
                  <c:v>560725</c:v>
                </c:pt>
                <c:pt idx="10">
                  <c:v>656551</c:v>
                </c:pt>
                <c:pt idx="11">
                  <c:v>659766</c:v>
                </c:pt>
                <c:pt idx="12">
                  <c:v>681099</c:v>
                </c:pt>
                <c:pt idx="13">
                  <c:v>719123</c:v>
                </c:pt>
                <c:pt idx="14">
                  <c:v>729870</c:v>
                </c:pt>
                <c:pt idx="15">
                  <c:v>804133</c:v>
                </c:pt>
                <c:pt idx="16">
                  <c:v>909767</c:v>
                </c:pt>
                <c:pt idx="17">
                  <c:v>932807</c:v>
                </c:pt>
                <c:pt idx="18">
                  <c:v>993002</c:v>
                </c:pt>
                <c:pt idx="19">
                  <c:v>1162977</c:v>
                </c:pt>
                <c:pt idx="20">
                  <c:v>1251537</c:v>
                </c:pt>
                <c:pt idx="21">
                  <c:v>1775135</c:v>
                </c:pt>
                <c:pt idx="22">
                  <c:v>1768473</c:v>
                </c:pt>
                <c:pt idx="23">
                  <c:v>1624534</c:v>
                </c:pt>
                <c:pt idx="24">
                  <c:v>1518086</c:v>
                </c:pt>
                <c:pt idx="25">
                  <c:v>1505848</c:v>
                </c:pt>
                <c:pt idx="26">
                  <c:v>1490893</c:v>
                </c:pt>
                <c:pt idx="27">
                  <c:v>1461312</c:v>
                </c:pt>
                <c:pt idx="28">
                  <c:v>1434468</c:v>
                </c:pt>
                <c:pt idx="29">
                  <c:v>1430662</c:v>
                </c:pt>
                <c:pt idx="30">
                  <c:v>1417287</c:v>
                </c:pt>
                <c:pt idx="31">
                  <c:v>1394259</c:v>
                </c:pt>
                <c:pt idx="32">
                  <c:v>1810242</c:v>
                </c:pt>
                <c:pt idx="33">
                  <c:v>1818564</c:v>
                </c:pt>
                <c:pt idx="34">
                  <c:v>1842692</c:v>
                </c:pt>
                <c:pt idx="35">
                  <c:v>1844185</c:v>
                </c:pt>
                <c:pt idx="36">
                  <c:v>1948120</c:v>
                </c:pt>
                <c:pt idx="37">
                  <c:v>1974310</c:v>
                </c:pt>
                <c:pt idx="38">
                  <c:v>2058576</c:v>
                </c:pt>
                <c:pt idx="39">
                  <c:v>2286315</c:v>
                </c:pt>
                <c:pt idx="40">
                  <c:v>2374423</c:v>
                </c:pt>
                <c:pt idx="41">
                  <c:v>2834996</c:v>
                </c:pt>
                <c:pt idx="42">
                  <c:v>2977000</c:v>
                </c:pt>
                <c:pt idx="43">
                  <c:v>2932001</c:v>
                </c:pt>
                <c:pt idx="44">
                  <c:v>3110012</c:v>
                </c:pt>
                <c:pt idx="45">
                  <c:v>3177196</c:v>
                </c:pt>
                <c:pt idx="46">
                  <c:v>3183658</c:v>
                </c:pt>
                <c:pt idx="47">
                  <c:v>3347101</c:v>
                </c:pt>
                <c:pt idx="48">
                  <c:v>3392585</c:v>
                </c:pt>
                <c:pt idx="49">
                  <c:v>3502101</c:v>
                </c:pt>
                <c:pt idx="50">
                  <c:v>3489676</c:v>
                </c:pt>
                <c:pt idx="51">
                  <c:v>3641366</c:v>
                </c:pt>
                <c:pt idx="52">
                  <c:v>3651103</c:v>
                </c:pt>
                <c:pt idx="53">
                  <c:v>3693155</c:v>
                </c:pt>
                <c:pt idx="54">
                  <c:v>3722258</c:v>
                </c:pt>
                <c:pt idx="55">
                  <c:v>3722421</c:v>
                </c:pt>
                <c:pt idx="56">
                  <c:v>4170538</c:v>
                </c:pt>
                <c:pt idx="57">
                  <c:v>3967741</c:v>
                </c:pt>
                <c:pt idx="58">
                  <c:v>4284671</c:v>
                </c:pt>
                <c:pt idx="59">
                  <c:v>4490384</c:v>
                </c:pt>
                <c:pt idx="60">
                  <c:v>4523213</c:v>
                </c:pt>
                <c:pt idx="61">
                  <c:v>4584883</c:v>
                </c:pt>
                <c:pt idx="62">
                  <c:v>4717026</c:v>
                </c:pt>
                <c:pt idx="63">
                  <c:v>4765047</c:v>
                </c:pt>
                <c:pt idx="64">
                  <c:v>4894392</c:v>
                </c:pt>
                <c:pt idx="65">
                  <c:v>4866309</c:v>
                </c:pt>
                <c:pt idx="66">
                  <c:v>4857908</c:v>
                </c:pt>
                <c:pt idx="67">
                  <c:v>4952819</c:v>
                </c:pt>
                <c:pt idx="68">
                  <c:v>4998820</c:v>
                </c:pt>
                <c:pt idx="69">
                  <c:v>5124599</c:v>
                </c:pt>
                <c:pt idx="70">
                  <c:v>5127315</c:v>
                </c:pt>
                <c:pt idx="71">
                  <c:v>5682992</c:v>
                </c:pt>
                <c:pt idx="72">
                  <c:v>5644615</c:v>
                </c:pt>
                <c:pt idx="73">
                  <c:v>5607564</c:v>
                </c:pt>
                <c:pt idx="74">
                  <c:v>5560154</c:v>
                </c:pt>
                <c:pt idx="75">
                  <c:v>5444332</c:v>
                </c:pt>
                <c:pt idx="76">
                  <c:v>6061486</c:v>
                </c:pt>
                <c:pt idx="77">
                  <c:v>6050166</c:v>
                </c:pt>
                <c:pt idx="78">
                  <c:v>5987446</c:v>
                </c:pt>
                <c:pt idx="79">
                  <c:v>5980428</c:v>
                </c:pt>
                <c:pt idx="80">
                  <c:v>5980280</c:v>
                </c:pt>
                <c:pt idx="81">
                  <c:v>5944127</c:v>
                </c:pt>
                <c:pt idx="82">
                  <c:v>5914556</c:v>
                </c:pt>
                <c:pt idx="83">
                  <c:v>6404776</c:v>
                </c:pt>
                <c:pt idx="84">
                  <c:v>6455011</c:v>
                </c:pt>
                <c:pt idx="85">
                  <c:v>6967592</c:v>
                </c:pt>
                <c:pt idx="86">
                  <c:v>6847930</c:v>
                </c:pt>
                <c:pt idx="87">
                  <c:v>6769891</c:v>
                </c:pt>
                <c:pt idx="88">
                  <c:v>6743129</c:v>
                </c:pt>
                <c:pt idx="89">
                  <c:v>6725842</c:v>
                </c:pt>
                <c:pt idx="90">
                  <c:v>7102435</c:v>
                </c:pt>
                <c:pt idx="91">
                  <c:v>7105042</c:v>
                </c:pt>
                <c:pt idx="92">
                  <c:v>7110762</c:v>
                </c:pt>
                <c:pt idx="93">
                  <c:v>7154647</c:v>
                </c:pt>
                <c:pt idx="94">
                  <c:v>7350714</c:v>
                </c:pt>
                <c:pt idx="95">
                  <c:v>7350584</c:v>
                </c:pt>
                <c:pt idx="96">
                  <c:v>7309090</c:v>
                </c:pt>
                <c:pt idx="97">
                  <c:v>7298159</c:v>
                </c:pt>
                <c:pt idx="98">
                  <c:v>7519169</c:v>
                </c:pt>
                <c:pt idx="99">
                  <c:v>7572758</c:v>
                </c:pt>
                <c:pt idx="100">
                  <c:v>7611695</c:v>
                </c:pt>
                <c:pt idx="101">
                  <c:v>7682659</c:v>
                </c:pt>
                <c:pt idx="102">
                  <c:v>7687986</c:v>
                </c:pt>
                <c:pt idx="103">
                  <c:v>7752825</c:v>
                </c:pt>
                <c:pt idx="104">
                  <c:v>7797752</c:v>
                </c:pt>
                <c:pt idx="105">
                  <c:v>7934111</c:v>
                </c:pt>
                <c:pt idx="106">
                  <c:v>7951226</c:v>
                </c:pt>
                <c:pt idx="107">
                  <c:v>8047681</c:v>
                </c:pt>
                <c:pt idx="108">
                  <c:v>8149777</c:v>
                </c:pt>
                <c:pt idx="109">
                  <c:v>8535720</c:v>
                </c:pt>
                <c:pt idx="110">
                  <c:v>8410328</c:v>
                </c:pt>
                <c:pt idx="111">
                  <c:v>8351471</c:v>
                </c:pt>
                <c:pt idx="112">
                  <c:v>8655417</c:v>
                </c:pt>
                <c:pt idx="113">
                  <c:v>8703551</c:v>
                </c:pt>
                <c:pt idx="114">
                  <c:v>8754974</c:v>
                </c:pt>
                <c:pt idx="115">
                  <c:v>8796107</c:v>
                </c:pt>
                <c:pt idx="116">
                  <c:v>8796625</c:v>
                </c:pt>
                <c:pt idx="117">
                  <c:v>8913245</c:v>
                </c:pt>
                <c:pt idx="118">
                  <c:v>8933364</c:v>
                </c:pt>
                <c:pt idx="119">
                  <c:v>9150233</c:v>
                </c:pt>
                <c:pt idx="120">
                  <c:v>9196496</c:v>
                </c:pt>
                <c:pt idx="121">
                  <c:v>9765630</c:v>
                </c:pt>
                <c:pt idx="122">
                  <c:v>9637782</c:v>
                </c:pt>
                <c:pt idx="123">
                  <c:v>9620087</c:v>
                </c:pt>
                <c:pt idx="124">
                  <c:v>9600456</c:v>
                </c:pt>
                <c:pt idx="125">
                  <c:v>9556593</c:v>
                </c:pt>
                <c:pt idx="126">
                  <c:v>9517911</c:v>
                </c:pt>
                <c:pt idx="127">
                  <c:v>9444062</c:v>
                </c:pt>
                <c:pt idx="128">
                  <c:v>9368754</c:v>
                </c:pt>
                <c:pt idx="129">
                  <c:v>9306534</c:v>
                </c:pt>
                <c:pt idx="130">
                  <c:v>9877258</c:v>
                </c:pt>
                <c:pt idx="131">
                  <c:v>9880644</c:v>
                </c:pt>
                <c:pt idx="132">
                  <c:v>9996772</c:v>
                </c:pt>
                <c:pt idx="133">
                  <c:v>10022428</c:v>
                </c:pt>
                <c:pt idx="134">
                  <c:v>10146107</c:v>
                </c:pt>
                <c:pt idx="135">
                  <c:v>10113756</c:v>
                </c:pt>
                <c:pt idx="136">
                  <c:v>10068791</c:v>
                </c:pt>
                <c:pt idx="137">
                  <c:v>10407981</c:v>
                </c:pt>
                <c:pt idx="138">
                  <c:v>10545264</c:v>
                </c:pt>
                <c:pt idx="139">
                  <c:v>10713413</c:v>
                </c:pt>
                <c:pt idx="140">
                  <c:v>10798838</c:v>
                </c:pt>
                <c:pt idx="141">
                  <c:v>11000117</c:v>
                </c:pt>
                <c:pt idx="142">
                  <c:v>11092410</c:v>
                </c:pt>
                <c:pt idx="143">
                  <c:v>11637771</c:v>
                </c:pt>
                <c:pt idx="144">
                  <c:v>11502380</c:v>
                </c:pt>
                <c:pt idx="145">
                  <c:v>11447671</c:v>
                </c:pt>
                <c:pt idx="146">
                  <c:v>11447284</c:v>
                </c:pt>
                <c:pt idx="147">
                  <c:v>11421831</c:v>
                </c:pt>
                <c:pt idx="148">
                  <c:v>11382974</c:v>
                </c:pt>
                <c:pt idx="149">
                  <c:v>11349429</c:v>
                </c:pt>
                <c:pt idx="150">
                  <c:v>11293030</c:v>
                </c:pt>
                <c:pt idx="151">
                  <c:v>11251892</c:v>
                </c:pt>
                <c:pt idx="152">
                  <c:v>11205885</c:v>
                </c:pt>
                <c:pt idx="153">
                  <c:v>11202971</c:v>
                </c:pt>
                <c:pt idx="154">
                  <c:v>11689047</c:v>
                </c:pt>
                <c:pt idx="155">
                  <c:v>11954315</c:v>
                </c:pt>
                <c:pt idx="156">
                  <c:v>12046169</c:v>
                </c:pt>
              </c:numCache>
            </c:numRef>
          </c:xVal>
          <c:yVal>
            <c:numRef>
              <c:f>'308 dn prion no change del'!$E$154:$E$310</c:f>
              <c:numCache>
                <c:formatCode>General</c:formatCode>
                <c:ptCount val="157"/>
                <c:pt idx="0">
                  <c:v>-1.1216949473330153</c:v>
                </c:pt>
                <c:pt idx="1">
                  <c:v>-1.0594930064965804</c:v>
                </c:pt>
                <c:pt idx="2">
                  <c:v>-2.1241556886553354</c:v>
                </c:pt>
                <c:pt idx="3">
                  <c:v>-1.0886156150560224</c:v>
                </c:pt>
                <c:pt idx="4">
                  <c:v>-1.6358584718014093</c:v>
                </c:pt>
                <c:pt idx="5">
                  <c:v>-2.4891907741229748</c:v>
                </c:pt>
                <c:pt idx="6">
                  <c:v>-1.3000316137543007</c:v>
                </c:pt>
                <c:pt idx="7">
                  <c:v>-1.1843603240634155</c:v>
                </c:pt>
                <c:pt idx="8">
                  <c:v>-1.3268733535775667</c:v>
                </c:pt>
                <c:pt idx="9">
                  <c:v>-1.1016168745627983</c:v>
                </c:pt>
                <c:pt idx="10">
                  <c:v>-1.3157797519750685</c:v>
                </c:pt>
                <c:pt idx="11">
                  <c:v>-1.3235986268851279</c:v>
                </c:pt>
                <c:pt idx="12">
                  <c:v>-1.3355760222340867</c:v>
                </c:pt>
                <c:pt idx="13">
                  <c:v>-1.2005377408425946</c:v>
                </c:pt>
                <c:pt idx="14">
                  <c:v>-2.1356975309361679</c:v>
                </c:pt>
                <c:pt idx="15">
                  <c:v>-1.2396242848423116</c:v>
                </c:pt>
                <c:pt idx="16">
                  <c:v>-1.7011065974574013</c:v>
                </c:pt>
                <c:pt idx="17">
                  <c:v>-1.1770540562579399</c:v>
                </c:pt>
                <c:pt idx="18">
                  <c:v>-1.3495504606544944</c:v>
                </c:pt>
                <c:pt idx="19">
                  <c:v>-1.1733372630129455</c:v>
                </c:pt>
                <c:pt idx="20">
                  <c:v>-1.7740356803597792</c:v>
                </c:pt>
                <c:pt idx="21">
                  <c:v>-1.1694592309345404</c:v>
                </c:pt>
                <c:pt idx="22">
                  <c:v>-1.1841530305307295</c:v>
                </c:pt>
                <c:pt idx="23">
                  <c:v>-1.080842856776977</c:v>
                </c:pt>
                <c:pt idx="24">
                  <c:v>-2.564082478158892</c:v>
                </c:pt>
                <c:pt idx="25">
                  <c:v>-2.1401247902323655</c:v>
                </c:pt>
                <c:pt idx="26">
                  <c:v>-1.487956899846592</c:v>
                </c:pt>
                <c:pt idx="27">
                  <c:v>-1.6664724138043669</c:v>
                </c:pt>
                <c:pt idx="28">
                  <c:v>-2.6692079468988048</c:v>
                </c:pt>
                <c:pt idx="29">
                  <c:v>-1.6431897222335377</c:v>
                </c:pt>
                <c:pt idx="30">
                  <c:v>-3.2947864521903858</c:v>
                </c:pt>
                <c:pt idx="31">
                  <c:v>-1.9689800539595017</c:v>
                </c:pt>
                <c:pt idx="32">
                  <c:v>-1.4619778491968745</c:v>
                </c:pt>
                <c:pt idx="33">
                  <c:v>-1.3036153407740751</c:v>
                </c:pt>
                <c:pt idx="34">
                  <c:v>-1.5626921185690836</c:v>
                </c:pt>
                <c:pt idx="35">
                  <c:v>-1.7495202043987095</c:v>
                </c:pt>
                <c:pt idx="36">
                  <c:v>-3.2849594719099682</c:v>
                </c:pt>
                <c:pt idx="37">
                  <c:v>-2.1383972381450467</c:v>
                </c:pt>
                <c:pt idx="38">
                  <c:v>-1.0907095586131152</c:v>
                </c:pt>
                <c:pt idx="39">
                  <c:v>-1.2985983825670648</c:v>
                </c:pt>
                <c:pt idx="40">
                  <c:v>-2.3568111982783324</c:v>
                </c:pt>
                <c:pt idx="41">
                  <c:v>-1.1184109365016197</c:v>
                </c:pt>
                <c:pt idx="42">
                  <c:v>-3.4251340323221511</c:v>
                </c:pt>
                <c:pt idx="43">
                  <c:v>-1.6777698549732105</c:v>
                </c:pt>
                <c:pt idx="44">
                  <c:v>-1.1070282300979613</c:v>
                </c:pt>
                <c:pt idx="45">
                  <c:v>-1.6349311237458031</c:v>
                </c:pt>
                <c:pt idx="46">
                  <c:v>-2.4517423493299479</c:v>
                </c:pt>
                <c:pt idx="47">
                  <c:v>-1.1317022441579632</c:v>
                </c:pt>
                <c:pt idx="48">
                  <c:v>-1.3171735286313264</c:v>
                </c:pt>
                <c:pt idx="49">
                  <c:v>-1.0745638878034818</c:v>
                </c:pt>
                <c:pt idx="50">
                  <c:v>-2.0236913666739409</c:v>
                </c:pt>
                <c:pt idx="51">
                  <c:v>-1.5493095633572387</c:v>
                </c:pt>
                <c:pt idx="52">
                  <c:v>-2.3130472821913917</c:v>
                </c:pt>
                <c:pt idx="53">
                  <c:v>-1.1965938087557635</c:v>
                </c:pt>
                <c:pt idx="54">
                  <c:v>-2.3326393541799564</c:v>
                </c:pt>
                <c:pt idx="55">
                  <c:v>-2.6453425986774359</c:v>
                </c:pt>
                <c:pt idx="56">
                  <c:v>-1.1629928030106138</c:v>
                </c:pt>
                <c:pt idx="57">
                  <c:v>-1.8580995196923882</c:v>
                </c:pt>
                <c:pt idx="58">
                  <c:v>-1.0918681974032842</c:v>
                </c:pt>
                <c:pt idx="59">
                  <c:v>-1.7079610834646819</c:v>
                </c:pt>
                <c:pt idx="60">
                  <c:v>-2.6869313715796279</c:v>
                </c:pt>
                <c:pt idx="61">
                  <c:v>-1.0564945711206917</c:v>
                </c:pt>
                <c:pt idx="62">
                  <c:v>-1.0777247917180659</c:v>
                </c:pt>
                <c:pt idx="63">
                  <c:v>-1.2441477164142194</c:v>
                </c:pt>
                <c:pt idx="64">
                  <c:v>-3.7615459151958461</c:v>
                </c:pt>
                <c:pt idx="65">
                  <c:v>-2.2321771120209006</c:v>
                </c:pt>
                <c:pt idx="66">
                  <c:v>-1.1553825991640934</c:v>
                </c:pt>
                <c:pt idx="67">
                  <c:v>-1.0605083556395569</c:v>
                </c:pt>
                <c:pt idx="68">
                  <c:v>-1.2208508297933878</c:v>
                </c:pt>
                <c:pt idx="69">
                  <c:v>-3.3524511243535429</c:v>
                </c:pt>
                <c:pt idx="70">
                  <c:v>-2.1857073882293458</c:v>
                </c:pt>
                <c:pt idx="71">
                  <c:v>-1.0726942932714472</c:v>
                </c:pt>
                <c:pt idx="72">
                  <c:v>-2.4743471226952183</c:v>
                </c:pt>
                <c:pt idx="73">
                  <c:v>-1.2761486705637815</c:v>
                </c:pt>
                <c:pt idx="74">
                  <c:v>-1.3582826816941644</c:v>
                </c:pt>
                <c:pt idx="75">
                  <c:v>-2.7778017618583881</c:v>
                </c:pt>
                <c:pt idx="76">
                  <c:v>-1.5713754653253844</c:v>
                </c:pt>
                <c:pt idx="77">
                  <c:v>-1.5052666309966105</c:v>
                </c:pt>
                <c:pt idx="78">
                  <c:v>-1.2864676101339634</c:v>
                </c:pt>
                <c:pt idx="79">
                  <c:v>-1.3510841201155095</c:v>
                </c:pt>
                <c:pt idx="80">
                  <c:v>-1.2263018177838545</c:v>
                </c:pt>
                <c:pt idx="81">
                  <c:v>-1.7572896741928374</c:v>
                </c:pt>
                <c:pt idx="82">
                  <c:v>-2.2593246787631709</c:v>
                </c:pt>
                <c:pt idx="83">
                  <c:v>-1.8313353159078489</c:v>
                </c:pt>
                <c:pt idx="84">
                  <c:v>-1.7918121521532899</c:v>
                </c:pt>
                <c:pt idx="85">
                  <c:v>-1.7451208305700634</c:v>
                </c:pt>
                <c:pt idx="86">
                  <c:v>-1.0564163566596423</c:v>
                </c:pt>
                <c:pt idx="87">
                  <c:v>-1.2224030086611166</c:v>
                </c:pt>
                <c:pt idx="88">
                  <c:v>-1.2455740327609472</c:v>
                </c:pt>
                <c:pt idx="89">
                  <c:v>-1.1699559785849749</c:v>
                </c:pt>
                <c:pt idx="90">
                  <c:v>-1.294880100306705</c:v>
                </c:pt>
                <c:pt idx="91">
                  <c:v>-1.8026110778548714</c:v>
                </c:pt>
                <c:pt idx="92">
                  <c:v>-1.7068404122943699</c:v>
                </c:pt>
                <c:pt idx="93">
                  <c:v>-1.07890188222283</c:v>
                </c:pt>
                <c:pt idx="94">
                  <c:v>-1.7568846106704445</c:v>
                </c:pt>
                <c:pt idx="95">
                  <c:v>-1.5486547199311944</c:v>
                </c:pt>
                <c:pt idx="96">
                  <c:v>-2.010556131277291</c:v>
                </c:pt>
                <c:pt idx="97">
                  <c:v>-1.1598599075361342</c:v>
                </c:pt>
                <c:pt idx="98">
                  <c:v>-1.4661526859224037</c:v>
                </c:pt>
                <c:pt idx="99">
                  <c:v>-1.4372489595105433</c:v>
                </c:pt>
                <c:pt idx="100">
                  <c:v>-1.2875326638080189</c:v>
                </c:pt>
                <c:pt idx="101">
                  <c:v>-2.3413080203902412</c:v>
                </c:pt>
                <c:pt idx="102">
                  <c:v>-1.1601641892773282</c:v>
                </c:pt>
                <c:pt idx="103">
                  <c:v>-1.321818487490287</c:v>
                </c:pt>
                <c:pt idx="104">
                  <c:v>-1.4089731762465594</c:v>
                </c:pt>
                <c:pt idx="105">
                  <c:v>-1.2130700127645149</c:v>
                </c:pt>
                <c:pt idx="106">
                  <c:v>-1.3908214621276778</c:v>
                </c:pt>
                <c:pt idx="107">
                  <c:v>-1.217029318233658</c:v>
                </c:pt>
                <c:pt idx="108">
                  <c:v>-1.2586582098606423</c:v>
                </c:pt>
                <c:pt idx="109">
                  <c:v>-1.0818962500223155</c:v>
                </c:pt>
                <c:pt idx="110">
                  <c:v>-1.2290464586941905</c:v>
                </c:pt>
                <c:pt idx="111">
                  <c:v>-1.4949993332361635</c:v>
                </c:pt>
                <c:pt idx="112">
                  <c:v>-1.7947125520356439</c:v>
                </c:pt>
                <c:pt idx="113">
                  <c:v>-1.5996841302403666</c:v>
                </c:pt>
                <c:pt idx="114">
                  <c:v>-2.4918501014092151</c:v>
                </c:pt>
                <c:pt idx="115">
                  <c:v>-1.6731203407036277</c:v>
                </c:pt>
                <c:pt idx="116">
                  <c:v>-1.8075762080627147</c:v>
                </c:pt>
                <c:pt idx="117">
                  <c:v>-1.6489107746438012</c:v>
                </c:pt>
                <c:pt idx="118">
                  <c:v>-2.1376997599363969</c:v>
                </c:pt>
                <c:pt idx="119">
                  <c:v>-4.1274039425162687</c:v>
                </c:pt>
                <c:pt idx="120">
                  <c:v>-2.2869351314545159</c:v>
                </c:pt>
                <c:pt idx="121">
                  <c:v>-1.3465469946540689</c:v>
                </c:pt>
                <c:pt idx="122">
                  <c:v>-1.4061130658077423</c:v>
                </c:pt>
                <c:pt idx="123">
                  <c:v>-1.852049134709441</c:v>
                </c:pt>
                <c:pt idx="124">
                  <c:v>-2.0119721122209873</c:v>
                </c:pt>
                <c:pt idx="125">
                  <c:v>-1.5360510571465158</c:v>
                </c:pt>
                <c:pt idx="126">
                  <c:v>-3.0759592037356618</c:v>
                </c:pt>
                <c:pt idx="127">
                  <c:v>-1.3614459091001947</c:v>
                </c:pt>
                <c:pt idx="128">
                  <c:v>-1.7805377176863058</c:v>
                </c:pt>
                <c:pt idx="129">
                  <c:v>-1.1152999802057859</c:v>
                </c:pt>
                <c:pt idx="130">
                  <c:v>-1.5912491648896763</c:v>
                </c:pt>
                <c:pt idx="131">
                  <c:v>-2.8095107311665108</c:v>
                </c:pt>
                <c:pt idx="132">
                  <c:v>-1.8239556159742563</c:v>
                </c:pt>
                <c:pt idx="133">
                  <c:v>-2.3206197668759585</c:v>
                </c:pt>
                <c:pt idx="134">
                  <c:v>-1.1265995682280476</c:v>
                </c:pt>
                <c:pt idx="135">
                  <c:v>-1.3019442558303256</c:v>
                </c:pt>
                <c:pt idx="136">
                  <c:v>-2.2756387312734061</c:v>
                </c:pt>
                <c:pt idx="137">
                  <c:v>-1.2500424599354611</c:v>
                </c:pt>
                <c:pt idx="138">
                  <c:v>-1.6651714414473009</c:v>
                </c:pt>
                <c:pt idx="139">
                  <c:v>-1.7918177009679905</c:v>
                </c:pt>
                <c:pt idx="140">
                  <c:v>-1.3756303455889933</c:v>
                </c:pt>
                <c:pt idx="141">
                  <c:v>-2.0689762647965919</c:v>
                </c:pt>
                <c:pt idx="142">
                  <c:v>-1.5899488508934474</c:v>
                </c:pt>
                <c:pt idx="143">
                  <c:v>-1.726265668522061</c:v>
                </c:pt>
                <c:pt idx="144">
                  <c:v>-1.1137315593228194</c:v>
                </c:pt>
                <c:pt idx="145">
                  <c:v>-2.0785956028206023</c:v>
                </c:pt>
                <c:pt idx="146">
                  <c:v>-1.9207401553477625</c:v>
                </c:pt>
                <c:pt idx="147">
                  <c:v>-1.2804982145943993</c:v>
                </c:pt>
                <c:pt idx="148">
                  <c:v>-1.1251358936349916</c:v>
                </c:pt>
                <c:pt idx="149">
                  <c:v>-1.9474025744838037</c:v>
                </c:pt>
                <c:pt idx="150">
                  <c:v>-3.0816634336756192</c:v>
                </c:pt>
                <c:pt idx="151">
                  <c:v>-1.9147141514206556</c:v>
                </c:pt>
                <c:pt idx="152">
                  <c:v>-1.1218324019086556</c:v>
                </c:pt>
                <c:pt idx="153">
                  <c:v>-2.3522837632075055</c:v>
                </c:pt>
                <c:pt idx="154">
                  <c:v>-1.3097643911190431</c:v>
                </c:pt>
                <c:pt idx="155">
                  <c:v>-3.4240637166761392</c:v>
                </c:pt>
                <c:pt idx="156">
                  <c:v>-2.1580881658024165</c:v>
                </c:pt>
              </c:numCache>
            </c:numRef>
          </c:yVal>
          <c:smooth val="0"/>
          <c:extLst>
            <c:ext xmlns:c16="http://schemas.microsoft.com/office/drawing/2014/chart" uri="{C3380CC4-5D6E-409C-BE32-E72D297353CC}">
              <c16:uniqueId val="{00000000-FFA3-42EB-BD71-F0F3C24ED12F}"/>
            </c:ext>
          </c:extLst>
        </c:ser>
        <c:ser>
          <c:idx val="1"/>
          <c:order val="1"/>
          <c:tx>
            <c:strRef>
              <c:f>'308 dn prion no change del'!$F$153</c:f>
              <c:strCache>
                <c:ptCount val="1"/>
                <c:pt idx="0">
                  <c:v>swi1 log2FC</c:v>
                </c:pt>
              </c:strCache>
            </c:strRef>
          </c:tx>
          <c:spPr>
            <a:ln w="25400" cap="rnd">
              <a:noFill/>
              <a:round/>
            </a:ln>
            <a:effectLst/>
          </c:spPr>
          <c:marker>
            <c:symbol val="circle"/>
            <c:size val="6"/>
            <c:spPr>
              <a:noFill/>
              <a:ln w="9525">
                <a:noFill/>
              </a:ln>
              <a:effectLst/>
            </c:spPr>
          </c:marker>
          <c:errBars>
            <c:errDir val="y"/>
            <c:errBarType val="minus"/>
            <c:errValType val="percentage"/>
            <c:noEndCap val="1"/>
            <c:val val="100"/>
            <c:spPr>
              <a:noFill/>
              <a:ln w="12700" cap="flat" cmpd="sng" algn="ctr">
                <a:solidFill>
                  <a:srgbClr val="C00000"/>
                </a:solidFill>
                <a:round/>
              </a:ln>
              <a:effectLst/>
            </c:spPr>
          </c:errBars>
          <c:xVal>
            <c:numRef>
              <c:f>'308 dn prion no change del'!$D$154:$D$310</c:f>
              <c:numCache>
                <c:formatCode>General</c:formatCode>
                <c:ptCount val="157"/>
                <c:pt idx="0">
                  <c:v>11842147</c:v>
                </c:pt>
                <c:pt idx="1">
                  <c:v>83335</c:v>
                </c:pt>
                <c:pt idx="2">
                  <c:v>80710</c:v>
                </c:pt>
                <c:pt idx="3">
                  <c:v>68716</c:v>
                </c:pt>
                <c:pt idx="4">
                  <c:v>42881</c:v>
                </c:pt>
                <c:pt idx="5">
                  <c:v>24000</c:v>
                </c:pt>
                <c:pt idx="6">
                  <c:v>330589</c:v>
                </c:pt>
                <c:pt idx="7">
                  <c:v>314717</c:v>
                </c:pt>
                <c:pt idx="8">
                  <c:v>255164</c:v>
                </c:pt>
                <c:pt idx="9">
                  <c:v>560725</c:v>
                </c:pt>
                <c:pt idx="10">
                  <c:v>656551</c:v>
                </c:pt>
                <c:pt idx="11">
                  <c:v>659766</c:v>
                </c:pt>
                <c:pt idx="12">
                  <c:v>681099</c:v>
                </c:pt>
                <c:pt idx="13">
                  <c:v>719123</c:v>
                </c:pt>
                <c:pt idx="14">
                  <c:v>729870</c:v>
                </c:pt>
                <c:pt idx="15">
                  <c:v>804133</c:v>
                </c:pt>
                <c:pt idx="16">
                  <c:v>909767</c:v>
                </c:pt>
                <c:pt idx="17">
                  <c:v>932807</c:v>
                </c:pt>
                <c:pt idx="18">
                  <c:v>993002</c:v>
                </c:pt>
                <c:pt idx="19">
                  <c:v>1162977</c:v>
                </c:pt>
                <c:pt idx="20">
                  <c:v>1251537</c:v>
                </c:pt>
                <c:pt idx="21">
                  <c:v>1775135</c:v>
                </c:pt>
                <c:pt idx="22">
                  <c:v>1768473</c:v>
                </c:pt>
                <c:pt idx="23">
                  <c:v>1624534</c:v>
                </c:pt>
                <c:pt idx="24">
                  <c:v>1518086</c:v>
                </c:pt>
                <c:pt idx="25">
                  <c:v>1505848</c:v>
                </c:pt>
                <c:pt idx="26">
                  <c:v>1490893</c:v>
                </c:pt>
                <c:pt idx="27">
                  <c:v>1461312</c:v>
                </c:pt>
                <c:pt idx="28">
                  <c:v>1434468</c:v>
                </c:pt>
                <c:pt idx="29">
                  <c:v>1430662</c:v>
                </c:pt>
                <c:pt idx="30">
                  <c:v>1417287</c:v>
                </c:pt>
                <c:pt idx="31">
                  <c:v>1394259</c:v>
                </c:pt>
                <c:pt idx="32">
                  <c:v>1810242</c:v>
                </c:pt>
                <c:pt idx="33">
                  <c:v>1818564</c:v>
                </c:pt>
                <c:pt idx="34">
                  <c:v>1842692</c:v>
                </c:pt>
                <c:pt idx="35">
                  <c:v>1844185</c:v>
                </c:pt>
                <c:pt idx="36">
                  <c:v>1948120</c:v>
                </c:pt>
                <c:pt idx="37">
                  <c:v>1974310</c:v>
                </c:pt>
                <c:pt idx="38">
                  <c:v>2058576</c:v>
                </c:pt>
                <c:pt idx="39">
                  <c:v>2286315</c:v>
                </c:pt>
                <c:pt idx="40">
                  <c:v>2374423</c:v>
                </c:pt>
                <c:pt idx="41">
                  <c:v>2834996</c:v>
                </c:pt>
                <c:pt idx="42">
                  <c:v>2977000</c:v>
                </c:pt>
                <c:pt idx="43">
                  <c:v>2932001</c:v>
                </c:pt>
                <c:pt idx="44">
                  <c:v>3110012</c:v>
                </c:pt>
                <c:pt idx="45">
                  <c:v>3177196</c:v>
                </c:pt>
                <c:pt idx="46">
                  <c:v>3183658</c:v>
                </c:pt>
                <c:pt idx="47">
                  <c:v>3347101</c:v>
                </c:pt>
                <c:pt idx="48">
                  <c:v>3392585</c:v>
                </c:pt>
                <c:pt idx="49">
                  <c:v>3502101</c:v>
                </c:pt>
                <c:pt idx="50">
                  <c:v>3489676</c:v>
                </c:pt>
                <c:pt idx="51">
                  <c:v>3641366</c:v>
                </c:pt>
                <c:pt idx="52">
                  <c:v>3651103</c:v>
                </c:pt>
                <c:pt idx="53">
                  <c:v>3693155</c:v>
                </c:pt>
                <c:pt idx="54">
                  <c:v>3722258</c:v>
                </c:pt>
                <c:pt idx="55">
                  <c:v>3722421</c:v>
                </c:pt>
                <c:pt idx="56">
                  <c:v>4170538</c:v>
                </c:pt>
                <c:pt idx="57">
                  <c:v>3967741</c:v>
                </c:pt>
                <c:pt idx="58">
                  <c:v>4284671</c:v>
                </c:pt>
                <c:pt idx="59">
                  <c:v>4490384</c:v>
                </c:pt>
                <c:pt idx="60">
                  <c:v>4523213</c:v>
                </c:pt>
                <c:pt idx="61">
                  <c:v>4584883</c:v>
                </c:pt>
                <c:pt idx="62">
                  <c:v>4717026</c:v>
                </c:pt>
                <c:pt idx="63">
                  <c:v>4765047</c:v>
                </c:pt>
                <c:pt idx="64">
                  <c:v>4894392</c:v>
                </c:pt>
                <c:pt idx="65">
                  <c:v>4866309</c:v>
                </c:pt>
                <c:pt idx="66">
                  <c:v>4857908</c:v>
                </c:pt>
                <c:pt idx="67">
                  <c:v>4952819</c:v>
                </c:pt>
                <c:pt idx="68">
                  <c:v>4998820</c:v>
                </c:pt>
                <c:pt idx="69">
                  <c:v>5124599</c:v>
                </c:pt>
                <c:pt idx="70">
                  <c:v>5127315</c:v>
                </c:pt>
                <c:pt idx="71">
                  <c:v>5682992</c:v>
                </c:pt>
                <c:pt idx="72">
                  <c:v>5644615</c:v>
                </c:pt>
                <c:pt idx="73">
                  <c:v>5607564</c:v>
                </c:pt>
                <c:pt idx="74">
                  <c:v>5560154</c:v>
                </c:pt>
                <c:pt idx="75">
                  <c:v>5444332</c:v>
                </c:pt>
                <c:pt idx="76">
                  <c:v>6061486</c:v>
                </c:pt>
                <c:pt idx="77">
                  <c:v>6050166</c:v>
                </c:pt>
                <c:pt idx="78">
                  <c:v>5987446</c:v>
                </c:pt>
                <c:pt idx="79">
                  <c:v>5980428</c:v>
                </c:pt>
                <c:pt idx="80">
                  <c:v>5980280</c:v>
                </c:pt>
                <c:pt idx="81">
                  <c:v>5944127</c:v>
                </c:pt>
                <c:pt idx="82">
                  <c:v>5914556</c:v>
                </c:pt>
                <c:pt idx="83">
                  <c:v>6404776</c:v>
                </c:pt>
                <c:pt idx="84">
                  <c:v>6455011</c:v>
                </c:pt>
                <c:pt idx="85">
                  <c:v>6967592</c:v>
                </c:pt>
                <c:pt idx="86">
                  <c:v>6847930</c:v>
                </c:pt>
                <c:pt idx="87">
                  <c:v>6769891</c:v>
                </c:pt>
                <c:pt idx="88">
                  <c:v>6743129</c:v>
                </c:pt>
                <c:pt idx="89">
                  <c:v>6725842</c:v>
                </c:pt>
                <c:pt idx="90">
                  <c:v>7102435</c:v>
                </c:pt>
                <c:pt idx="91">
                  <c:v>7105042</c:v>
                </c:pt>
                <c:pt idx="92">
                  <c:v>7110762</c:v>
                </c:pt>
                <c:pt idx="93">
                  <c:v>7154647</c:v>
                </c:pt>
                <c:pt idx="94">
                  <c:v>7350714</c:v>
                </c:pt>
                <c:pt idx="95">
                  <c:v>7350584</c:v>
                </c:pt>
                <c:pt idx="96">
                  <c:v>7309090</c:v>
                </c:pt>
                <c:pt idx="97">
                  <c:v>7298159</c:v>
                </c:pt>
                <c:pt idx="98">
                  <c:v>7519169</c:v>
                </c:pt>
                <c:pt idx="99">
                  <c:v>7572758</c:v>
                </c:pt>
                <c:pt idx="100">
                  <c:v>7611695</c:v>
                </c:pt>
                <c:pt idx="101">
                  <c:v>7682659</c:v>
                </c:pt>
                <c:pt idx="102">
                  <c:v>7687986</c:v>
                </c:pt>
                <c:pt idx="103">
                  <c:v>7752825</c:v>
                </c:pt>
                <c:pt idx="104">
                  <c:v>7797752</c:v>
                </c:pt>
                <c:pt idx="105">
                  <c:v>7934111</c:v>
                </c:pt>
                <c:pt idx="106">
                  <c:v>7951226</c:v>
                </c:pt>
                <c:pt idx="107">
                  <c:v>8047681</c:v>
                </c:pt>
                <c:pt idx="108">
                  <c:v>8149777</c:v>
                </c:pt>
                <c:pt idx="109">
                  <c:v>8535720</c:v>
                </c:pt>
                <c:pt idx="110">
                  <c:v>8410328</c:v>
                </c:pt>
                <c:pt idx="111">
                  <c:v>8351471</c:v>
                </c:pt>
                <c:pt idx="112">
                  <c:v>8655417</c:v>
                </c:pt>
                <c:pt idx="113">
                  <c:v>8703551</c:v>
                </c:pt>
                <c:pt idx="114">
                  <c:v>8754974</c:v>
                </c:pt>
                <c:pt idx="115">
                  <c:v>8796107</c:v>
                </c:pt>
                <c:pt idx="116">
                  <c:v>8796625</c:v>
                </c:pt>
                <c:pt idx="117">
                  <c:v>8913245</c:v>
                </c:pt>
                <c:pt idx="118">
                  <c:v>8933364</c:v>
                </c:pt>
                <c:pt idx="119">
                  <c:v>9150233</c:v>
                </c:pt>
                <c:pt idx="120">
                  <c:v>9196496</c:v>
                </c:pt>
                <c:pt idx="121">
                  <c:v>9765630</c:v>
                </c:pt>
                <c:pt idx="122">
                  <c:v>9637782</c:v>
                </c:pt>
                <c:pt idx="123">
                  <c:v>9620087</c:v>
                </c:pt>
                <c:pt idx="124">
                  <c:v>9600456</c:v>
                </c:pt>
                <c:pt idx="125">
                  <c:v>9556593</c:v>
                </c:pt>
                <c:pt idx="126">
                  <c:v>9517911</c:v>
                </c:pt>
                <c:pt idx="127">
                  <c:v>9444062</c:v>
                </c:pt>
                <c:pt idx="128">
                  <c:v>9368754</c:v>
                </c:pt>
                <c:pt idx="129">
                  <c:v>9306534</c:v>
                </c:pt>
                <c:pt idx="130">
                  <c:v>9877258</c:v>
                </c:pt>
                <c:pt idx="131">
                  <c:v>9880644</c:v>
                </c:pt>
                <c:pt idx="132">
                  <c:v>9996772</c:v>
                </c:pt>
                <c:pt idx="133">
                  <c:v>10022428</c:v>
                </c:pt>
                <c:pt idx="134">
                  <c:v>10146107</c:v>
                </c:pt>
                <c:pt idx="135">
                  <c:v>10113756</c:v>
                </c:pt>
                <c:pt idx="136">
                  <c:v>10068791</c:v>
                </c:pt>
                <c:pt idx="137">
                  <c:v>10407981</c:v>
                </c:pt>
                <c:pt idx="138">
                  <c:v>10545264</c:v>
                </c:pt>
                <c:pt idx="139">
                  <c:v>10713413</c:v>
                </c:pt>
                <c:pt idx="140">
                  <c:v>10798838</c:v>
                </c:pt>
                <c:pt idx="141">
                  <c:v>11000117</c:v>
                </c:pt>
                <c:pt idx="142">
                  <c:v>11092410</c:v>
                </c:pt>
                <c:pt idx="143">
                  <c:v>11637771</c:v>
                </c:pt>
                <c:pt idx="144">
                  <c:v>11502380</c:v>
                </c:pt>
                <c:pt idx="145">
                  <c:v>11447671</c:v>
                </c:pt>
                <c:pt idx="146">
                  <c:v>11447284</c:v>
                </c:pt>
                <c:pt idx="147">
                  <c:v>11421831</c:v>
                </c:pt>
                <c:pt idx="148">
                  <c:v>11382974</c:v>
                </c:pt>
                <c:pt idx="149">
                  <c:v>11349429</c:v>
                </c:pt>
                <c:pt idx="150">
                  <c:v>11293030</c:v>
                </c:pt>
                <c:pt idx="151">
                  <c:v>11251892</c:v>
                </c:pt>
                <c:pt idx="152">
                  <c:v>11205885</c:v>
                </c:pt>
                <c:pt idx="153">
                  <c:v>11202971</c:v>
                </c:pt>
                <c:pt idx="154">
                  <c:v>11689047</c:v>
                </c:pt>
                <c:pt idx="155">
                  <c:v>11954315</c:v>
                </c:pt>
                <c:pt idx="156">
                  <c:v>12046169</c:v>
                </c:pt>
              </c:numCache>
            </c:numRef>
          </c:xVal>
          <c:yVal>
            <c:numRef>
              <c:f>'308 dn prion no change del'!$F$154:$F$310</c:f>
              <c:numCache>
                <c:formatCode>General</c:formatCode>
                <c:ptCount val="157"/>
                <c:pt idx="0">
                  <c:v>-0.85823076501530748</c:v>
                </c:pt>
                <c:pt idx="1">
                  <c:v>6.0361383079822181E-2</c:v>
                </c:pt>
                <c:pt idx="2">
                  <c:v>-0.6639427363216327</c:v>
                </c:pt>
                <c:pt idx="3">
                  <c:v>-0.40878459980130721</c:v>
                </c:pt>
                <c:pt idx="4">
                  <c:v>-8.9910878578467274E-2</c:v>
                </c:pt>
                <c:pt idx="5">
                  <c:v>-0.61013493134064267</c:v>
                </c:pt>
                <c:pt idx="6">
                  <c:v>5.2680598278956936E-2</c:v>
                </c:pt>
                <c:pt idx="7">
                  <c:v>-0.49614759361578814</c:v>
                </c:pt>
                <c:pt idx="8">
                  <c:v>-0.75316811713907117</c:v>
                </c:pt>
                <c:pt idx="9">
                  <c:v>4.8420993053856019E-2</c:v>
                </c:pt>
                <c:pt idx="10">
                  <c:v>-5.1026294336320228E-2</c:v>
                </c:pt>
                <c:pt idx="11">
                  <c:v>-0.91494128478939474</c:v>
                </c:pt>
                <c:pt idx="12">
                  <c:v>0.69050310995695752</c:v>
                </c:pt>
                <c:pt idx="13">
                  <c:v>-0.21967638544763501</c:v>
                </c:pt>
                <c:pt idx="14">
                  <c:v>0.20253451770531256</c:v>
                </c:pt>
                <c:pt idx="15">
                  <c:v>0.53240537811000321</c:v>
                </c:pt>
                <c:pt idx="16">
                  <c:v>0.10722429214269653</c:v>
                </c:pt>
                <c:pt idx="17">
                  <c:v>0.46358588118491095</c:v>
                </c:pt>
                <c:pt idx="18">
                  <c:v>0.48885735393745422</c:v>
                </c:pt>
                <c:pt idx="19">
                  <c:v>-0.67156995184196244</c:v>
                </c:pt>
                <c:pt idx="20">
                  <c:v>0.72210564720166104</c:v>
                </c:pt>
                <c:pt idx="21">
                  <c:v>8.311247047852649E-2</c:v>
                </c:pt>
                <c:pt idx="22">
                  <c:v>0.33070078144696569</c:v>
                </c:pt>
                <c:pt idx="23">
                  <c:v>0.119607144732803</c:v>
                </c:pt>
                <c:pt idx="24">
                  <c:v>0.44303922410366992</c:v>
                </c:pt>
                <c:pt idx="25">
                  <c:v>-0.54621231235945944</c:v>
                </c:pt>
                <c:pt idx="26">
                  <c:v>0.16543447132189781</c:v>
                </c:pt>
                <c:pt idx="27">
                  <c:v>0.47069049882963493</c:v>
                </c:pt>
                <c:pt idx="28">
                  <c:v>0.67846628748447058</c:v>
                </c:pt>
                <c:pt idx="29">
                  <c:v>7.2840499861284214E-2</c:v>
                </c:pt>
                <c:pt idx="30">
                  <c:v>-0.62312927634019144</c:v>
                </c:pt>
                <c:pt idx="31">
                  <c:v>-0.32730122802030215</c:v>
                </c:pt>
                <c:pt idx="32">
                  <c:v>-0.54155509355718867</c:v>
                </c:pt>
                <c:pt idx="33">
                  <c:v>-0.23823190588095364</c:v>
                </c:pt>
                <c:pt idx="34">
                  <c:v>0.85277719843370203</c:v>
                </c:pt>
                <c:pt idx="35">
                  <c:v>-0.44524392533501844</c:v>
                </c:pt>
                <c:pt idx="36">
                  <c:v>-0.81365635621991828</c:v>
                </c:pt>
                <c:pt idx="37">
                  <c:v>1.8782978293891452E-2</c:v>
                </c:pt>
                <c:pt idx="38">
                  <c:v>-0.54361834741441151</c:v>
                </c:pt>
                <c:pt idx="39">
                  <c:v>-1.9655768753268178E-2</c:v>
                </c:pt>
                <c:pt idx="40">
                  <c:v>-0.66224251445809701</c:v>
                </c:pt>
                <c:pt idx="41">
                  <c:v>9.0392756457878684E-2</c:v>
                </c:pt>
                <c:pt idx="42">
                  <c:v>-0.89862830769675295</c:v>
                </c:pt>
                <c:pt idx="43">
                  <c:v>-0.67366728375874341</c:v>
                </c:pt>
                <c:pt idx="44">
                  <c:v>-3.369568451019591E-2</c:v>
                </c:pt>
                <c:pt idx="45">
                  <c:v>-0.55662389031600878</c:v>
                </c:pt>
                <c:pt idx="46">
                  <c:v>-9.5921854689254279E-2</c:v>
                </c:pt>
                <c:pt idx="47">
                  <c:v>0.37728862243307781</c:v>
                </c:pt>
                <c:pt idx="48">
                  <c:v>0.16470482726165686</c:v>
                </c:pt>
                <c:pt idx="49">
                  <c:v>9.4660404346803714E-2</c:v>
                </c:pt>
                <c:pt idx="50">
                  <c:v>0.69657412442996003</c:v>
                </c:pt>
                <c:pt idx="51">
                  <c:v>-0.34566998423026141</c:v>
                </c:pt>
                <c:pt idx="52">
                  <c:v>-4.4772723045937726E-2</c:v>
                </c:pt>
                <c:pt idx="53">
                  <c:v>-0.69320412774219353</c:v>
                </c:pt>
                <c:pt idx="54">
                  <c:v>-0.8827466610565935</c:v>
                </c:pt>
                <c:pt idx="55">
                  <c:v>-0.85074785277271225</c:v>
                </c:pt>
                <c:pt idx="56">
                  <c:v>0.56167867991917686</c:v>
                </c:pt>
                <c:pt idx="57">
                  <c:v>2.6271690102121565E-2</c:v>
                </c:pt>
                <c:pt idx="58">
                  <c:v>-0.73692398903352141</c:v>
                </c:pt>
                <c:pt idx="59">
                  <c:v>-0.65808326332470812</c:v>
                </c:pt>
                <c:pt idx="60">
                  <c:v>-1.1140793558952441E-2</c:v>
                </c:pt>
                <c:pt idx="61">
                  <c:v>1.7038035365753674E-2</c:v>
                </c:pt>
                <c:pt idx="62">
                  <c:v>0.10232501191144353</c:v>
                </c:pt>
                <c:pt idx="63">
                  <c:v>-0.69100940476882333</c:v>
                </c:pt>
                <c:pt idx="64">
                  <c:v>-0.78695002037387773</c:v>
                </c:pt>
                <c:pt idx="65">
                  <c:v>-0.80565659788567257</c:v>
                </c:pt>
                <c:pt idx="66">
                  <c:v>-5.5194405150798542E-2</c:v>
                </c:pt>
                <c:pt idx="67">
                  <c:v>-0.71008248801608842</c:v>
                </c:pt>
                <c:pt idx="68">
                  <c:v>-0.75047053701763911</c:v>
                </c:pt>
                <c:pt idx="69">
                  <c:v>-0.76759776269105651</c:v>
                </c:pt>
                <c:pt idx="70">
                  <c:v>-0.54271622718497881</c:v>
                </c:pt>
                <c:pt idx="71">
                  <c:v>-7.3783923236390964E-5</c:v>
                </c:pt>
                <c:pt idx="72">
                  <c:v>2.7994342413785907E-2</c:v>
                </c:pt>
                <c:pt idx="73">
                  <c:v>0.41740035888470073</c:v>
                </c:pt>
                <c:pt idx="74">
                  <c:v>-2.5294278451822864E-2</c:v>
                </c:pt>
                <c:pt idx="75">
                  <c:v>-0.65758173198667558</c:v>
                </c:pt>
                <c:pt idx="76">
                  <c:v>-5.9739828162543316E-3</c:v>
                </c:pt>
                <c:pt idx="77">
                  <c:v>-0.74668374659398751</c:v>
                </c:pt>
                <c:pt idx="78">
                  <c:v>-0.29774497512708498</c:v>
                </c:pt>
                <c:pt idx="79">
                  <c:v>-9.3162679355388411E-2</c:v>
                </c:pt>
                <c:pt idx="80">
                  <c:v>-0.32760566664851543</c:v>
                </c:pt>
                <c:pt idx="81">
                  <c:v>-0.14233767627261848</c:v>
                </c:pt>
                <c:pt idx="82">
                  <c:v>-0.41105815389886224</c:v>
                </c:pt>
                <c:pt idx="83">
                  <c:v>-0.85188986010582823</c:v>
                </c:pt>
                <c:pt idx="84">
                  <c:v>-0.92670847716668314</c:v>
                </c:pt>
                <c:pt idx="85">
                  <c:v>-4.2837306592933423E-2</c:v>
                </c:pt>
                <c:pt idx="86">
                  <c:v>0.32655608958937682</c:v>
                </c:pt>
                <c:pt idx="87">
                  <c:v>0.58612797325362864</c:v>
                </c:pt>
                <c:pt idx="88">
                  <c:v>-0.48252212557822233</c:v>
                </c:pt>
                <c:pt idx="89">
                  <c:v>-1.3073190970219516E-3</c:v>
                </c:pt>
                <c:pt idx="90">
                  <c:v>0.58596892994966299</c:v>
                </c:pt>
                <c:pt idx="91">
                  <c:v>0.85383244078304332</c:v>
                </c:pt>
                <c:pt idx="92">
                  <c:v>-0.63798660341874747</c:v>
                </c:pt>
                <c:pt idx="93">
                  <c:v>-0.84210872138620529</c:v>
                </c:pt>
                <c:pt idx="94">
                  <c:v>-0.63750088727197496</c:v>
                </c:pt>
                <c:pt idx="95">
                  <c:v>-0.54083618157552082</c:v>
                </c:pt>
                <c:pt idx="96">
                  <c:v>0.25317949746705376</c:v>
                </c:pt>
                <c:pt idx="97">
                  <c:v>-0.12688206730918408</c:v>
                </c:pt>
                <c:pt idx="98">
                  <c:v>0.47084191595638486</c:v>
                </c:pt>
                <c:pt idx="99">
                  <c:v>-0.22007250526986258</c:v>
                </c:pt>
                <c:pt idx="100">
                  <c:v>0.51507960965978838</c:v>
                </c:pt>
                <c:pt idx="101">
                  <c:v>0.23718461542441363</c:v>
                </c:pt>
                <c:pt idx="102">
                  <c:v>0.30840073971272719</c:v>
                </c:pt>
                <c:pt idx="103">
                  <c:v>-0.87513816948968126</c:v>
                </c:pt>
                <c:pt idx="104">
                  <c:v>-3.4582720881414432E-2</c:v>
                </c:pt>
                <c:pt idx="105">
                  <c:v>-4.801841639990679E-2</c:v>
                </c:pt>
                <c:pt idx="106">
                  <c:v>-3.6581424313059926E-2</c:v>
                </c:pt>
                <c:pt idx="107">
                  <c:v>-0.68907119461019284</c:v>
                </c:pt>
                <c:pt idx="108">
                  <c:v>-0.3763617333045447</c:v>
                </c:pt>
                <c:pt idx="109">
                  <c:v>-0.54228186551738145</c:v>
                </c:pt>
                <c:pt idx="110">
                  <c:v>-0.80218938083793079</c:v>
                </c:pt>
                <c:pt idx="111">
                  <c:v>-0.24590280842111134</c:v>
                </c:pt>
                <c:pt idx="112">
                  <c:v>-0.562496547578621</c:v>
                </c:pt>
                <c:pt idx="113">
                  <c:v>-0.12802769546431231</c:v>
                </c:pt>
                <c:pt idx="114">
                  <c:v>6.3165125951238207E-3</c:v>
                </c:pt>
                <c:pt idx="115">
                  <c:v>0.24634360730107244</c:v>
                </c:pt>
                <c:pt idx="116">
                  <c:v>-5.1125327995346283E-2</c:v>
                </c:pt>
                <c:pt idx="117">
                  <c:v>-0.10625320771653074</c:v>
                </c:pt>
                <c:pt idx="118">
                  <c:v>0.34648723055550257</c:v>
                </c:pt>
                <c:pt idx="119">
                  <c:v>-7.8843929529143694E-2</c:v>
                </c:pt>
                <c:pt idx="120">
                  <c:v>-0.9910543845516423</c:v>
                </c:pt>
                <c:pt idx="121">
                  <c:v>-0.49082137421597816</c:v>
                </c:pt>
                <c:pt idx="122">
                  <c:v>1.3522695885021656E-2</c:v>
                </c:pt>
                <c:pt idx="123">
                  <c:v>-0.72294459723074544</c:v>
                </c:pt>
                <c:pt idx="124">
                  <c:v>-0.67939098083146332</c:v>
                </c:pt>
                <c:pt idx="125">
                  <c:v>6.1424490507230638E-2</c:v>
                </c:pt>
                <c:pt idx="126">
                  <c:v>-0.46547124593961392</c:v>
                </c:pt>
                <c:pt idx="127">
                  <c:v>-0.25833412122036969</c:v>
                </c:pt>
                <c:pt idx="128">
                  <c:v>0.44107741176968307</c:v>
                </c:pt>
                <c:pt idx="129">
                  <c:v>0.15383870302304511</c:v>
                </c:pt>
                <c:pt idx="130">
                  <c:v>-0.38776599318239652</c:v>
                </c:pt>
                <c:pt idx="131">
                  <c:v>-0.23781957705107123</c:v>
                </c:pt>
                <c:pt idx="132">
                  <c:v>-0.75418092370090528</c:v>
                </c:pt>
                <c:pt idx="133">
                  <c:v>-0.26411198112398265</c:v>
                </c:pt>
                <c:pt idx="134">
                  <c:v>-0.34419307570949781</c:v>
                </c:pt>
                <c:pt idx="135">
                  <c:v>4.0500439547217375E-2</c:v>
                </c:pt>
                <c:pt idx="136">
                  <c:v>-0.1189181905264169</c:v>
                </c:pt>
                <c:pt idx="137">
                  <c:v>-0.15515302185547508</c:v>
                </c:pt>
                <c:pt idx="138">
                  <c:v>0.87571629271074025</c:v>
                </c:pt>
                <c:pt idx="139">
                  <c:v>-0.52738546123734575</c:v>
                </c:pt>
                <c:pt idx="140">
                  <c:v>-0.20407939021963234</c:v>
                </c:pt>
                <c:pt idx="141">
                  <c:v>-0.16107995248587703</c:v>
                </c:pt>
                <c:pt idx="142">
                  <c:v>-0.4750909036967576</c:v>
                </c:pt>
                <c:pt idx="143">
                  <c:v>-0.97716531773075888</c:v>
                </c:pt>
                <c:pt idx="144">
                  <c:v>-0.67466473287859252</c:v>
                </c:pt>
                <c:pt idx="145">
                  <c:v>3.7401470889146735E-3</c:v>
                </c:pt>
                <c:pt idx="146">
                  <c:v>-0.13904657586313979</c:v>
                </c:pt>
                <c:pt idx="147">
                  <c:v>0.14945154517076817</c:v>
                </c:pt>
                <c:pt idx="148">
                  <c:v>-0.50931600617038597</c:v>
                </c:pt>
                <c:pt idx="149">
                  <c:v>0.51320825038470841</c:v>
                </c:pt>
                <c:pt idx="150">
                  <c:v>-0.91393802436419369</c:v>
                </c:pt>
                <c:pt idx="151">
                  <c:v>-8.6244289280410599E-2</c:v>
                </c:pt>
                <c:pt idx="152">
                  <c:v>6.1237370202975802E-2</c:v>
                </c:pt>
                <c:pt idx="153">
                  <c:v>0.27649190219696246</c:v>
                </c:pt>
                <c:pt idx="154">
                  <c:v>-0.25792045252983525</c:v>
                </c:pt>
                <c:pt idx="155">
                  <c:v>0.13537976406587679</c:v>
                </c:pt>
                <c:pt idx="156">
                  <c:v>-0.57166062193359823</c:v>
                </c:pt>
              </c:numCache>
            </c:numRef>
          </c:yVal>
          <c:smooth val="0"/>
          <c:extLst>
            <c:ext xmlns:c16="http://schemas.microsoft.com/office/drawing/2014/chart" uri="{C3380CC4-5D6E-409C-BE32-E72D297353CC}">
              <c16:uniqueId val="{00000001-FFA3-42EB-BD71-F0F3C24ED12F}"/>
            </c:ext>
          </c:extLst>
        </c:ser>
        <c:dLbls>
          <c:showLegendKey val="0"/>
          <c:showVal val="0"/>
          <c:showCatName val="0"/>
          <c:showSerName val="0"/>
          <c:showPercent val="0"/>
          <c:showBubbleSize val="0"/>
        </c:dLbls>
        <c:axId val="171610496"/>
        <c:axId val="171612032"/>
      </c:scatterChart>
      <c:valAx>
        <c:axId val="171610496"/>
        <c:scaling>
          <c:orientation val="minMax"/>
          <c:max val="12157105"/>
          <c:min val="1"/>
        </c:scaling>
        <c:delete val="0"/>
        <c:axPos val="b"/>
        <c:numFmt formatCode="General" sourceLinked="1"/>
        <c:majorTickMark val="none"/>
        <c:minorTickMark val="none"/>
        <c:tickLblPos val="none"/>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71612032"/>
        <c:crossesAt val="0"/>
        <c:crossBetween val="midCat"/>
      </c:valAx>
      <c:valAx>
        <c:axId val="171612032"/>
        <c:scaling>
          <c:orientation val="minMax"/>
          <c:max val="1"/>
          <c:min val="-3"/>
        </c:scaling>
        <c:delete val="0"/>
        <c:axPos val="l"/>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bg1"/>
                </a:solidFill>
                <a:latin typeface="+mn-lt"/>
                <a:ea typeface="+mn-ea"/>
                <a:cs typeface="+mn-cs"/>
              </a:defRPr>
            </a:pPr>
            <a:endParaRPr lang="en-US"/>
          </a:p>
        </c:txPr>
        <c:crossAx val="171610496"/>
        <c:crosses val="autoZero"/>
        <c:crossBetween val="midCat"/>
        <c:majorUnit val="2"/>
        <c:minorUnit val="2"/>
      </c:valAx>
      <c:spPr>
        <a:noFill/>
        <a:ln w="25400">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sz="1600"/>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3" Type="http://schemas.openxmlformats.org/officeDocument/2006/relationships/image" Target="../media/image10.png"/><Relationship Id="rId18" Type="http://schemas.openxmlformats.org/officeDocument/2006/relationships/image" Target="../media/image15.png"/><Relationship Id="rId26" Type="http://schemas.openxmlformats.org/officeDocument/2006/relationships/image" Target="../media/image23.png"/><Relationship Id="rId39" Type="http://schemas.openxmlformats.org/officeDocument/2006/relationships/image" Target="../media/image36.png"/><Relationship Id="rId21" Type="http://schemas.openxmlformats.org/officeDocument/2006/relationships/image" Target="../media/image18.png"/><Relationship Id="rId34" Type="http://schemas.openxmlformats.org/officeDocument/2006/relationships/image" Target="../media/image31.png"/><Relationship Id="rId7" Type="http://schemas.openxmlformats.org/officeDocument/2006/relationships/image" Target="../media/image5.png"/><Relationship Id="rId2" Type="http://schemas.microsoft.com/office/2007/relationships/hdphoto" Target="../media/hdphoto1.wdp"/><Relationship Id="rId16" Type="http://schemas.openxmlformats.org/officeDocument/2006/relationships/image" Target="../media/image13.png"/><Relationship Id="rId20" Type="http://schemas.openxmlformats.org/officeDocument/2006/relationships/image" Target="../media/image17.png"/><Relationship Id="rId29" Type="http://schemas.openxmlformats.org/officeDocument/2006/relationships/image" Target="../media/image26.png"/><Relationship Id="rId41" Type="http://schemas.microsoft.com/office/2007/relationships/hdphoto" Target="../media/hdphoto4.wdp"/><Relationship Id="rId1" Type="http://schemas.openxmlformats.org/officeDocument/2006/relationships/image" Target="../media/image1.png"/><Relationship Id="rId6" Type="http://schemas.openxmlformats.org/officeDocument/2006/relationships/image" Target="../media/image4.png"/><Relationship Id="rId11" Type="http://schemas.openxmlformats.org/officeDocument/2006/relationships/image" Target="../media/image8.png"/><Relationship Id="rId24" Type="http://schemas.openxmlformats.org/officeDocument/2006/relationships/image" Target="../media/image21.wmf"/><Relationship Id="rId32" Type="http://schemas.openxmlformats.org/officeDocument/2006/relationships/image" Target="../media/image29.png"/><Relationship Id="rId37" Type="http://schemas.openxmlformats.org/officeDocument/2006/relationships/image" Target="../media/image34.png"/><Relationship Id="rId40" Type="http://schemas.openxmlformats.org/officeDocument/2006/relationships/image" Target="../media/image37.png"/><Relationship Id="rId5" Type="http://schemas.openxmlformats.org/officeDocument/2006/relationships/image" Target="../media/image3.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png"/><Relationship Id="rId36" Type="http://schemas.openxmlformats.org/officeDocument/2006/relationships/image" Target="../media/image33.png"/><Relationship Id="rId10" Type="http://schemas.openxmlformats.org/officeDocument/2006/relationships/image" Target="../media/image7.png"/><Relationship Id="rId19" Type="http://schemas.openxmlformats.org/officeDocument/2006/relationships/image" Target="../media/image16.png"/><Relationship Id="rId31" Type="http://schemas.openxmlformats.org/officeDocument/2006/relationships/image" Target="../media/image28.png"/><Relationship Id="rId4" Type="http://schemas.microsoft.com/office/2007/relationships/hdphoto" Target="../media/hdphoto2.wdp"/><Relationship Id="rId9" Type="http://schemas.openxmlformats.org/officeDocument/2006/relationships/image" Target="../media/image6.png"/><Relationship Id="rId14" Type="http://schemas.openxmlformats.org/officeDocument/2006/relationships/image" Target="../media/image11.png"/><Relationship Id="rId22" Type="http://schemas.openxmlformats.org/officeDocument/2006/relationships/image" Target="../media/image19.png"/><Relationship Id="rId27" Type="http://schemas.openxmlformats.org/officeDocument/2006/relationships/image" Target="../media/image24.png"/><Relationship Id="rId30" Type="http://schemas.openxmlformats.org/officeDocument/2006/relationships/image" Target="../media/image27.png"/><Relationship Id="rId35" Type="http://schemas.openxmlformats.org/officeDocument/2006/relationships/image" Target="../media/image32.png"/><Relationship Id="rId8" Type="http://schemas.microsoft.com/office/2007/relationships/hdphoto" Target="../media/hdphoto3.wdp"/><Relationship Id="rId3" Type="http://schemas.openxmlformats.org/officeDocument/2006/relationships/image" Target="../media/image2.png"/><Relationship Id="rId12" Type="http://schemas.openxmlformats.org/officeDocument/2006/relationships/image" Target="../media/image9.pn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png"/></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77B517-B58D-450D-8D47-0388FB7D04D8}" type="datetimeFigureOut">
              <a:rPr lang="en-US" smtClean="0"/>
              <a:t>10/15/2020</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60DC76D-88A8-453A-A77C-385AAF22DD99}" type="slidenum">
              <a:rPr lang="en-US" smtClean="0"/>
              <a:t>‹#›</a:t>
            </a:fld>
            <a:endParaRPr lang="en-US"/>
          </a:p>
        </p:txBody>
      </p:sp>
    </p:spTree>
    <p:extLst>
      <p:ext uri="{BB962C8B-B14F-4D97-AF65-F5344CB8AC3E}">
        <p14:creationId xmlns:p14="http://schemas.microsoft.com/office/powerpoint/2010/main" val="19255856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9A9EE4E-0807-49BC-B9E7-401F5E10EFA8}" type="slidenum">
              <a:rPr lang="en-US" smtClean="0"/>
              <a:t>3</a:t>
            </a:fld>
            <a:endParaRPr lang="en-US"/>
          </a:p>
        </p:txBody>
      </p:sp>
    </p:spTree>
    <p:extLst>
      <p:ext uri="{BB962C8B-B14F-4D97-AF65-F5344CB8AC3E}">
        <p14:creationId xmlns:p14="http://schemas.microsoft.com/office/powerpoint/2010/main" val="17811546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CECC74E-9D8E-43A3-B4B1-5E92882ED282}" type="datetimeFigureOut">
              <a:rPr lang="en-US" smtClean="0"/>
              <a:t>10/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1070647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ECC74E-9D8E-43A3-B4B1-5E92882ED282}" type="datetimeFigureOut">
              <a:rPr lang="en-US" smtClean="0"/>
              <a:t>10/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8360762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ECC74E-9D8E-43A3-B4B1-5E92882ED282}" type="datetimeFigureOut">
              <a:rPr lang="en-US" smtClean="0"/>
              <a:t>10/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458262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ECC74E-9D8E-43A3-B4B1-5E92882ED282}" type="datetimeFigureOut">
              <a:rPr lang="en-US" smtClean="0"/>
              <a:t>10/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17215548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CECC74E-9D8E-43A3-B4B1-5E92882ED282}" type="datetimeFigureOut">
              <a:rPr lang="en-US" smtClean="0"/>
              <a:t>10/1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9425230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CECC74E-9D8E-43A3-B4B1-5E92882ED282}" type="datetimeFigureOut">
              <a:rPr lang="en-US" smtClean="0"/>
              <a:t>10/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27440267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CECC74E-9D8E-43A3-B4B1-5E92882ED282}" type="datetimeFigureOut">
              <a:rPr lang="en-US" smtClean="0"/>
              <a:t>10/15/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1396132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CECC74E-9D8E-43A3-B4B1-5E92882ED282}" type="datetimeFigureOut">
              <a:rPr lang="en-US" smtClean="0"/>
              <a:t>10/15/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41962002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CECC74E-9D8E-43A3-B4B1-5E92882ED282}" type="datetimeFigureOut">
              <a:rPr lang="en-US" smtClean="0"/>
              <a:t>10/15/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3462265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CECC74E-9D8E-43A3-B4B1-5E92882ED282}" type="datetimeFigureOut">
              <a:rPr lang="en-US" smtClean="0"/>
              <a:t>10/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13031347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CECC74E-9D8E-43A3-B4B1-5E92882ED282}" type="datetimeFigureOut">
              <a:rPr lang="en-US" smtClean="0"/>
              <a:t>10/1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BF7331-740E-46CB-A2C9-895F1C5216C0}" type="slidenum">
              <a:rPr lang="en-US" smtClean="0"/>
              <a:t>‹#›</a:t>
            </a:fld>
            <a:endParaRPr lang="en-US"/>
          </a:p>
        </p:txBody>
      </p:sp>
    </p:spTree>
    <p:extLst>
      <p:ext uri="{BB962C8B-B14F-4D97-AF65-F5344CB8AC3E}">
        <p14:creationId xmlns:p14="http://schemas.microsoft.com/office/powerpoint/2010/main" val="4087884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CECC74E-9D8E-43A3-B4B1-5E92882ED282}" type="datetimeFigureOut">
              <a:rPr lang="en-US" smtClean="0"/>
              <a:t>10/15/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16BF7331-740E-46CB-A2C9-895F1C5216C0}" type="slidenum">
              <a:rPr lang="en-US" smtClean="0"/>
              <a:t>‹#›</a:t>
            </a:fld>
            <a:endParaRPr lang="en-US"/>
          </a:p>
        </p:txBody>
      </p:sp>
    </p:spTree>
    <p:extLst>
      <p:ext uri="{BB962C8B-B14F-4D97-AF65-F5344CB8AC3E}">
        <p14:creationId xmlns:p14="http://schemas.microsoft.com/office/powerpoint/2010/main" val="4697128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6" Type="http://schemas.openxmlformats.org/officeDocument/2006/relationships/oleObject" Target="../embeddings/oleObject11.bin"/><Relationship Id="rId21" Type="http://schemas.openxmlformats.org/officeDocument/2006/relationships/image" Target="../media/image8.png"/><Relationship Id="rId42" Type="http://schemas.openxmlformats.org/officeDocument/2006/relationships/oleObject" Target="../embeddings/oleObject19.bin"/><Relationship Id="rId47" Type="http://schemas.openxmlformats.org/officeDocument/2006/relationships/image" Target="../media/image21.wmf"/><Relationship Id="rId63" Type="http://schemas.openxmlformats.org/officeDocument/2006/relationships/image" Target="../media/image29.png"/><Relationship Id="rId68" Type="http://schemas.openxmlformats.org/officeDocument/2006/relationships/oleObject" Target="../embeddings/oleObject32.bin"/><Relationship Id="rId16" Type="http://schemas.openxmlformats.org/officeDocument/2006/relationships/oleObject" Target="../embeddings/oleObject6.bin"/><Relationship Id="rId11" Type="http://schemas.openxmlformats.org/officeDocument/2006/relationships/oleObject" Target="../embeddings/oleObject4.bin"/><Relationship Id="rId32" Type="http://schemas.openxmlformats.org/officeDocument/2006/relationships/oleObject" Target="../embeddings/oleObject14.bin"/><Relationship Id="rId37" Type="http://schemas.openxmlformats.org/officeDocument/2006/relationships/image" Target="../media/image16.png"/><Relationship Id="rId53" Type="http://schemas.openxmlformats.org/officeDocument/2006/relationships/image" Target="../media/image24.png"/><Relationship Id="rId58" Type="http://schemas.openxmlformats.org/officeDocument/2006/relationships/oleObject" Target="../embeddings/oleObject27.bin"/><Relationship Id="rId74" Type="http://schemas.openxmlformats.org/officeDocument/2006/relationships/oleObject" Target="../embeddings/oleObject35.bin"/><Relationship Id="rId79" Type="http://schemas.openxmlformats.org/officeDocument/2006/relationships/chart" Target="../charts/chart2.xml"/><Relationship Id="rId5" Type="http://schemas.microsoft.com/office/2007/relationships/hdphoto" Target="../media/hdphoto1.wdp"/><Relationship Id="rId61" Type="http://schemas.openxmlformats.org/officeDocument/2006/relationships/image" Target="../media/image28.png"/><Relationship Id="rId82" Type="http://schemas.microsoft.com/office/2007/relationships/hdphoto" Target="../media/hdphoto4.wdp"/><Relationship Id="rId19" Type="http://schemas.openxmlformats.org/officeDocument/2006/relationships/image" Target="../media/image7.png"/><Relationship Id="rId14" Type="http://schemas.openxmlformats.org/officeDocument/2006/relationships/image" Target="../media/image5.png"/><Relationship Id="rId22" Type="http://schemas.openxmlformats.org/officeDocument/2006/relationships/oleObject" Target="../embeddings/oleObject9.bin"/><Relationship Id="rId27" Type="http://schemas.openxmlformats.org/officeDocument/2006/relationships/image" Target="../media/image11.png"/><Relationship Id="rId30" Type="http://schemas.openxmlformats.org/officeDocument/2006/relationships/oleObject" Target="../embeddings/oleObject13.bin"/><Relationship Id="rId35" Type="http://schemas.openxmlformats.org/officeDocument/2006/relationships/image" Target="../media/image15.png"/><Relationship Id="rId43" Type="http://schemas.openxmlformats.org/officeDocument/2006/relationships/image" Target="../media/image19.png"/><Relationship Id="rId48" Type="http://schemas.openxmlformats.org/officeDocument/2006/relationships/oleObject" Target="../embeddings/oleObject22.bin"/><Relationship Id="rId56" Type="http://schemas.openxmlformats.org/officeDocument/2006/relationships/oleObject" Target="../embeddings/oleObject26.bin"/><Relationship Id="rId64" Type="http://schemas.openxmlformats.org/officeDocument/2006/relationships/oleObject" Target="../embeddings/oleObject30.bin"/><Relationship Id="rId69" Type="http://schemas.openxmlformats.org/officeDocument/2006/relationships/image" Target="../media/image32.png"/><Relationship Id="rId77" Type="http://schemas.openxmlformats.org/officeDocument/2006/relationships/image" Target="../media/image36.png"/><Relationship Id="rId8" Type="http://schemas.microsoft.com/office/2007/relationships/hdphoto" Target="../media/hdphoto2.wdp"/><Relationship Id="rId51" Type="http://schemas.openxmlformats.org/officeDocument/2006/relationships/image" Target="../media/image23.png"/><Relationship Id="rId72" Type="http://schemas.openxmlformats.org/officeDocument/2006/relationships/oleObject" Target="../embeddings/oleObject34.bin"/><Relationship Id="rId80" Type="http://schemas.openxmlformats.org/officeDocument/2006/relationships/oleObject" Target="../embeddings/oleObject37.bin"/><Relationship Id="rId3" Type="http://schemas.openxmlformats.org/officeDocument/2006/relationships/oleObject" Target="../embeddings/oleObject1.bin"/><Relationship Id="rId12" Type="http://schemas.openxmlformats.org/officeDocument/2006/relationships/image" Target="../media/image4.png"/><Relationship Id="rId17" Type="http://schemas.openxmlformats.org/officeDocument/2006/relationships/image" Target="../media/image6.png"/><Relationship Id="rId25" Type="http://schemas.openxmlformats.org/officeDocument/2006/relationships/image" Target="../media/image10.png"/><Relationship Id="rId33" Type="http://schemas.openxmlformats.org/officeDocument/2006/relationships/image" Target="../media/image14.png"/><Relationship Id="rId38" Type="http://schemas.openxmlformats.org/officeDocument/2006/relationships/oleObject" Target="../embeddings/oleObject17.bin"/><Relationship Id="rId46" Type="http://schemas.openxmlformats.org/officeDocument/2006/relationships/oleObject" Target="../embeddings/oleObject21.bin"/><Relationship Id="rId59" Type="http://schemas.openxmlformats.org/officeDocument/2006/relationships/image" Target="../media/image27.png"/><Relationship Id="rId67" Type="http://schemas.openxmlformats.org/officeDocument/2006/relationships/image" Target="../media/image31.png"/><Relationship Id="rId20" Type="http://schemas.openxmlformats.org/officeDocument/2006/relationships/oleObject" Target="../embeddings/oleObject8.bin"/><Relationship Id="rId41" Type="http://schemas.openxmlformats.org/officeDocument/2006/relationships/image" Target="../media/image18.png"/><Relationship Id="rId54" Type="http://schemas.openxmlformats.org/officeDocument/2006/relationships/oleObject" Target="../embeddings/oleObject25.bin"/><Relationship Id="rId62" Type="http://schemas.openxmlformats.org/officeDocument/2006/relationships/oleObject" Target="../embeddings/oleObject29.bin"/><Relationship Id="rId70" Type="http://schemas.openxmlformats.org/officeDocument/2006/relationships/oleObject" Target="../embeddings/oleObject33.bin"/><Relationship Id="rId75" Type="http://schemas.openxmlformats.org/officeDocument/2006/relationships/image" Target="../media/image35.png"/><Relationship Id="rId1" Type="http://schemas.openxmlformats.org/officeDocument/2006/relationships/vmlDrawing" Target="../drawings/vmlDrawing1.vml"/><Relationship Id="rId6" Type="http://schemas.openxmlformats.org/officeDocument/2006/relationships/oleObject" Target="../embeddings/oleObject2.bin"/><Relationship Id="rId15" Type="http://schemas.microsoft.com/office/2007/relationships/hdphoto" Target="../media/hdphoto3.wdp"/><Relationship Id="rId23" Type="http://schemas.openxmlformats.org/officeDocument/2006/relationships/image" Target="../media/image9.png"/><Relationship Id="rId28" Type="http://schemas.openxmlformats.org/officeDocument/2006/relationships/oleObject" Target="../embeddings/oleObject12.bin"/><Relationship Id="rId36" Type="http://schemas.openxmlformats.org/officeDocument/2006/relationships/oleObject" Target="../embeddings/oleObject16.bin"/><Relationship Id="rId49" Type="http://schemas.openxmlformats.org/officeDocument/2006/relationships/image" Target="../media/image22.png"/><Relationship Id="rId57" Type="http://schemas.openxmlformats.org/officeDocument/2006/relationships/image" Target="../media/image26.png"/><Relationship Id="rId10" Type="http://schemas.openxmlformats.org/officeDocument/2006/relationships/image" Target="../media/image3.png"/><Relationship Id="rId31" Type="http://schemas.openxmlformats.org/officeDocument/2006/relationships/image" Target="../media/image13.png"/><Relationship Id="rId44" Type="http://schemas.openxmlformats.org/officeDocument/2006/relationships/oleObject" Target="../embeddings/oleObject20.bin"/><Relationship Id="rId52" Type="http://schemas.openxmlformats.org/officeDocument/2006/relationships/oleObject" Target="../embeddings/oleObject24.bin"/><Relationship Id="rId60" Type="http://schemas.openxmlformats.org/officeDocument/2006/relationships/oleObject" Target="../embeddings/oleObject28.bin"/><Relationship Id="rId65" Type="http://schemas.openxmlformats.org/officeDocument/2006/relationships/image" Target="../media/image30.png"/><Relationship Id="rId73" Type="http://schemas.openxmlformats.org/officeDocument/2006/relationships/image" Target="../media/image34.png"/><Relationship Id="rId78" Type="http://schemas.openxmlformats.org/officeDocument/2006/relationships/chart" Target="../charts/chart1.xml"/><Relationship Id="rId81" Type="http://schemas.openxmlformats.org/officeDocument/2006/relationships/image" Target="../media/image37.png"/><Relationship Id="rId4" Type="http://schemas.openxmlformats.org/officeDocument/2006/relationships/image" Target="../media/image1.png"/><Relationship Id="rId9" Type="http://schemas.openxmlformats.org/officeDocument/2006/relationships/oleObject" Target="../embeddings/oleObject3.bin"/><Relationship Id="rId13" Type="http://schemas.openxmlformats.org/officeDocument/2006/relationships/oleObject" Target="../embeddings/oleObject5.bin"/><Relationship Id="rId18" Type="http://schemas.openxmlformats.org/officeDocument/2006/relationships/oleObject" Target="../embeddings/oleObject7.bin"/><Relationship Id="rId39" Type="http://schemas.openxmlformats.org/officeDocument/2006/relationships/image" Target="../media/image17.png"/><Relationship Id="rId34" Type="http://schemas.openxmlformats.org/officeDocument/2006/relationships/oleObject" Target="../embeddings/oleObject15.bin"/><Relationship Id="rId50" Type="http://schemas.openxmlformats.org/officeDocument/2006/relationships/oleObject" Target="../embeddings/oleObject23.bin"/><Relationship Id="rId55" Type="http://schemas.openxmlformats.org/officeDocument/2006/relationships/image" Target="../media/image25.png"/><Relationship Id="rId76" Type="http://schemas.openxmlformats.org/officeDocument/2006/relationships/oleObject" Target="../embeddings/oleObject36.bin"/><Relationship Id="rId7" Type="http://schemas.openxmlformats.org/officeDocument/2006/relationships/image" Target="../media/image2.png"/><Relationship Id="rId71" Type="http://schemas.openxmlformats.org/officeDocument/2006/relationships/image" Target="../media/image33.png"/><Relationship Id="rId2" Type="http://schemas.openxmlformats.org/officeDocument/2006/relationships/slideLayout" Target="../slideLayouts/slideLayout7.xml"/><Relationship Id="rId29" Type="http://schemas.openxmlformats.org/officeDocument/2006/relationships/image" Target="../media/image12.png"/><Relationship Id="rId24" Type="http://schemas.openxmlformats.org/officeDocument/2006/relationships/oleObject" Target="../embeddings/oleObject10.bin"/><Relationship Id="rId40" Type="http://schemas.openxmlformats.org/officeDocument/2006/relationships/oleObject" Target="../embeddings/oleObject18.bin"/><Relationship Id="rId45" Type="http://schemas.openxmlformats.org/officeDocument/2006/relationships/image" Target="../media/image20.png"/><Relationship Id="rId66" Type="http://schemas.openxmlformats.org/officeDocument/2006/relationships/oleObject" Target="../embeddings/oleObject31.bin"/></Relationships>
</file>

<file path=ppt/slides/_rels/slide3.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39.png"/></Relationships>
</file>

<file path=ppt/slides/_rels/slide4.xml.rels><?xml version="1.0" encoding="UTF-8" standalone="yes"?>
<Relationships xmlns="http://schemas.openxmlformats.org/package/2006/relationships"><Relationship Id="rId8" Type="http://schemas.openxmlformats.org/officeDocument/2006/relationships/chart" Target="../charts/chart9.xml"/><Relationship Id="rId13" Type="http://schemas.openxmlformats.org/officeDocument/2006/relationships/chart" Target="../charts/chart14.xml"/><Relationship Id="rId3" Type="http://schemas.openxmlformats.org/officeDocument/2006/relationships/chart" Target="../charts/chart4.xml"/><Relationship Id="rId7" Type="http://schemas.openxmlformats.org/officeDocument/2006/relationships/chart" Target="../charts/chart8.xml"/><Relationship Id="rId12" Type="http://schemas.openxmlformats.org/officeDocument/2006/relationships/chart" Target="../charts/chart13.xml"/><Relationship Id="rId17" Type="http://schemas.openxmlformats.org/officeDocument/2006/relationships/chart" Target="../charts/chart18.xml"/><Relationship Id="rId2" Type="http://schemas.openxmlformats.org/officeDocument/2006/relationships/chart" Target="../charts/chart3.xml"/><Relationship Id="rId16" Type="http://schemas.openxmlformats.org/officeDocument/2006/relationships/chart" Target="../charts/chart17.xml"/><Relationship Id="rId1" Type="http://schemas.openxmlformats.org/officeDocument/2006/relationships/slideLayout" Target="../slideLayouts/slideLayout7.xml"/><Relationship Id="rId6" Type="http://schemas.openxmlformats.org/officeDocument/2006/relationships/chart" Target="../charts/chart7.xml"/><Relationship Id="rId11" Type="http://schemas.openxmlformats.org/officeDocument/2006/relationships/chart" Target="../charts/chart12.xml"/><Relationship Id="rId5" Type="http://schemas.openxmlformats.org/officeDocument/2006/relationships/chart" Target="../charts/chart6.xml"/><Relationship Id="rId15" Type="http://schemas.openxmlformats.org/officeDocument/2006/relationships/chart" Target="../charts/chart16.xml"/><Relationship Id="rId10" Type="http://schemas.openxmlformats.org/officeDocument/2006/relationships/chart" Target="../charts/chart11.xml"/><Relationship Id="rId4" Type="http://schemas.openxmlformats.org/officeDocument/2006/relationships/chart" Target="../charts/chart5.xml"/><Relationship Id="rId9" Type="http://schemas.openxmlformats.org/officeDocument/2006/relationships/chart" Target="../charts/chart10.xml"/><Relationship Id="rId14" Type="http://schemas.openxmlformats.org/officeDocument/2006/relationships/chart" Target="../charts/chart15.xml"/></Relationships>
</file>

<file path=ppt/slides/_rels/slide5.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image" Target="../media/image40.png"/><Relationship Id="rId1" Type="http://schemas.openxmlformats.org/officeDocument/2006/relationships/slideLayout" Target="../slideLayouts/slideLayout7.xml"/><Relationship Id="rId5" Type="http://schemas.openxmlformats.org/officeDocument/2006/relationships/image" Target="../media/image43.png"/><Relationship Id="rId4" Type="http://schemas.openxmlformats.org/officeDocument/2006/relationships/image" Target="../media/image42.png"/></Relationships>
</file>

<file path=ppt/slides/_rels/slide6.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image" Target="../media/image4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71500" y="880735"/>
            <a:ext cx="5715000" cy="1938992"/>
          </a:xfrm>
          <a:prstGeom prst="rect">
            <a:avLst/>
          </a:prstGeom>
        </p:spPr>
        <p:txBody>
          <a:bodyPr wrap="square">
            <a:spAutoFit/>
          </a:bodyPr>
          <a:lstStyle/>
          <a:p>
            <a:pPr>
              <a:lnSpc>
                <a:spcPct val="200000"/>
              </a:lnSpc>
            </a:pPr>
            <a:r>
              <a:rPr lang="en-US" sz="1200" b="1" dirty="0">
                <a:latin typeface="Arial" panose="020B0604020202020204" pitchFamily="34" charset="0"/>
                <a:ea typeface="SimSun" panose="02010600030101010101" pitchFamily="2" charset="-122"/>
                <a:cs typeface="Times New Roman" panose="02020603050405020304" pitchFamily="18" charset="0"/>
              </a:rPr>
              <a:t>Elucidating the regulatory mechanism of Swi1 prion in global transcription and stress responses</a:t>
            </a:r>
            <a:r>
              <a:rPr lang="en-US" sz="1200" b="1" dirty="0">
                <a:solidFill>
                  <a:srgbClr val="000000"/>
                </a:solidFill>
                <a:latin typeface="Arial" panose="020B0604020202020204" pitchFamily="34" charset="0"/>
                <a:ea typeface="SimSun" panose="02010600030101010101" pitchFamily="2" charset="-122"/>
                <a:cs typeface="Times New Roman" panose="02020603050405020304" pitchFamily="18" charset="0"/>
              </a:rPr>
              <a:t> </a:t>
            </a:r>
            <a:endParaRPr lang="en-US" sz="1200" dirty="0">
              <a:latin typeface="Calibri" panose="020F0502020204030204" pitchFamily="34" charset="0"/>
              <a:ea typeface="SimSun" panose="02010600030101010101" pitchFamily="2" charset="-122"/>
              <a:cs typeface="Times New Roman" panose="02020603050405020304" pitchFamily="18" charset="0"/>
            </a:endParaRPr>
          </a:p>
          <a:p>
            <a:pPr algn="just">
              <a:lnSpc>
                <a:spcPct val="200000"/>
              </a:lnSpc>
            </a:pPr>
            <a:endParaRPr lang="en-US" sz="1200" b="1" dirty="0">
              <a:solidFill>
                <a:srgbClr val="000000"/>
              </a:solidFill>
              <a:latin typeface="Arial" panose="020B0604020202020204" pitchFamily="34" charset="0"/>
              <a:ea typeface="SimSun" panose="02010600030101010101" pitchFamily="2" charset="-122"/>
              <a:cs typeface="Times New Roman" panose="02020603050405020304" pitchFamily="18" charset="0"/>
            </a:endParaRPr>
          </a:p>
          <a:p>
            <a:pPr algn="just">
              <a:lnSpc>
                <a:spcPct val="200000"/>
              </a:lnSpc>
            </a:pPr>
            <a:r>
              <a:rPr lang="en-US" sz="1200" b="1" dirty="0">
                <a:solidFill>
                  <a:srgbClr val="000000"/>
                </a:solidFill>
                <a:latin typeface="Arial" panose="020B0604020202020204" pitchFamily="34" charset="0"/>
                <a:ea typeface="SimSun" panose="02010600030101010101" pitchFamily="2" charset="-122"/>
                <a:cs typeface="Times New Roman" panose="02020603050405020304" pitchFamily="18" charset="0"/>
              </a:rPr>
              <a:t>Authors:</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Zhiqiang Du</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1*</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a:t>
            </a:r>
            <a:r>
              <a:rPr lang="en-US" sz="1200" u="sng" dirty="0" err="1">
                <a:solidFill>
                  <a:srgbClr val="000000"/>
                </a:solidFill>
                <a:latin typeface="Arial" panose="020B0604020202020204" pitchFamily="34" charset="0"/>
                <a:ea typeface="SimSun" panose="02010600030101010101" pitchFamily="2" charset="-122"/>
                <a:cs typeface="Times New Roman" panose="02020603050405020304" pitchFamily="18" charset="0"/>
              </a:rPr>
              <a:t>Jeniece</a:t>
            </a:r>
            <a:r>
              <a:rPr lang="en-US" sz="1200" u="sng" dirty="0">
                <a:solidFill>
                  <a:srgbClr val="000000"/>
                </a:solidFill>
                <a:latin typeface="Arial" panose="020B0604020202020204" pitchFamily="34" charset="0"/>
                <a:ea typeface="SimSun" panose="02010600030101010101" pitchFamily="2" charset="-122"/>
                <a:cs typeface="Times New Roman" panose="02020603050405020304" pitchFamily="18" charset="0"/>
              </a:rPr>
              <a:t> Regan</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1</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Elizabeth Bartom</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1</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Wei-Sheng Wu</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2</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Li Zhang</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1,3</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Dustin Kenneth Goncharoff</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1</a:t>
            </a:r>
            <a:r>
              <a:rPr lang="en-US" sz="1200" dirty="0">
                <a:solidFill>
                  <a:srgbClr val="000000"/>
                </a:solidFill>
                <a:latin typeface="Arial" panose="020B0604020202020204" pitchFamily="34" charset="0"/>
                <a:ea typeface="SimSun" panose="02010600030101010101" pitchFamily="2" charset="-122"/>
                <a:cs typeface="Times New Roman" panose="02020603050405020304" pitchFamily="18" charset="0"/>
              </a:rPr>
              <a:t>, Liming Li</a:t>
            </a:r>
            <a:r>
              <a:rPr lang="en-US" sz="1200" baseline="30000" dirty="0">
                <a:solidFill>
                  <a:srgbClr val="000000"/>
                </a:solidFill>
                <a:latin typeface="Arial" panose="020B0604020202020204" pitchFamily="34" charset="0"/>
                <a:ea typeface="SimSun" panose="02010600030101010101" pitchFamily="2" charset="-122"/>
                <a:cs typeface="Times New Roman" panose="02020603050405020304" pitchFamily="18" charset="0"/>
              </a:rPr>
              <a:t>*</a:t>
            </a:r>
            <a:endParaRPr lang="en-US" sz="1200" dirty="0">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2193441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1" name="Text Box 97"/>
          <p:cNvSpPr txBox="1">
            <a:spLocks noChangeArrowheads="1"/>
          </p:cNvSpPr>
          <p:nvPr/>
        </p:nvSpPr>
        <p:spPr bwMode="auto">
          <a:xfrm>
            <a:off x="34334" y="17780"/>
            <a:ext cx="88678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Figure S1</a:t>
            </a:r>
          </a:p>
        </p:txBody>
      </p:sp>
      <p:sp>
        <p:nvSpPr>
          <p:cNvPr id="5137" name="Text Box 27"/>
          <p:cNvSpPr txBox="1">
            <a:spLocks noChangeArrowheads="1"/>
          </p:cNvSpPr>
          <p:nvPr/>
        </p:nvSpPr>
        <p:spPr bwMode="auto">
          <a:xfrm rot="19545752">
            <a:off x="2138472" y="449506"/>
            <a:ext cx="1388522"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CUP1-RNQ1GFP</a:t>
            </a:r>
          </a:p>
        </p:txBody>
      </p:sp>
      <p:sp>
        <p:nvSpPr>
          <p:cNvPr id="5138" name="Text Box 131"/>
          <p:cNvSpPr txBox="1">
            <a:spLocks noChangeArrowheads="1"/>
          </p:cNvSpPr>
          <p:nvPr/>
        </p:nvSpPr>
        <p:spPr bwMode="auto">
          <a:xfrm rot="19545752">
            <a:off x="1333232" y="573737"/>
            <a:ext cx="1143262"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TEF1-NQYFP</a:t>
            </a:r>
          </a:p>
        </p:txBody>
      </p:sp>
      <p:graphicFrame>
        <p:nvGraphicFramePr>
          <p:cNvPr id="5127" name="Object 134"/>
          <p:cNvGraphicFramePr>
            <a:graphicFrameLocks/>
          </p:cNvGraphicFramePr>
          <p:nvPr>
            <p:extLst>
              <p:ext uri="{D42A27DB-BD31-4B8C-83A1-F6EECF244321}">
                <p14:modId xmlns:p14="http://schemas.microsoft.com/office/powerpoint/2010/main" val="3657068127"/>
              </p:ext>
            </p:extLst>
          </p:nvPr>
        </p:nvGraphicFramePr>
        <p:xfrm>
          <a:off x="1928892" y="1053953"/>
          <a:ext cx="457200" cy="457200"/>
        </p:xfrm>
        <a:graphic>
          <a:graphicData uri="http://schemas.openxmlformats.org/presentationml/2006/ole">
            <mc:AlternateContent xmlns:mc="http://schemas.openxmlformats.org/markup-compatibility/2006">
              <mc:Choice xmlns:v="urn:schemas-microsoft-com:vml" Requires="v">
                <p:oleObj spid="_x0000_s5709" name="Image" r:id="rId3" imgW="658091" imgH="627517" progId="Photoshop.Image.7">
                  <p:embed/>
                </p:oleObj>
              </mc:Choice>
              <mc:Fallback>
                <p:oleObj name="Image" r:id="rId3" imgW="658091" imgH="627517" progId="Photoshop.Image.7">
                  <p:embed/>
                  <p:pic>
                    <p:nvPicPr>
                      <p:cNvPr id="5127" name="Object 134"/>
                      <p:cNvPicPr preferRelativeResize="0">
                        <a:picLocks noChangeArrowheads="1"/>
                      </p:cNvPicPr>
                      <p:nvPr/>
                    </p:nvPicPr>
                    <p:blipFill>
                      <a:blip r:embed="rId4">
                        <a:extLst>
                          <a:ext uri="{BEBA8EAE-BF5A-486C-A8C5-ECC9F3942E4B}">
                            <a14:imgProps xmlns:a14="http://schemas.microsoft.com/office/drawing/2010/main">
                              <a14:imgLayer r:embed="rId5">
                                <a14:imgEffect>
                                  <a14:brightnessContrast bright="-24000" contrast="24000"/>
                                </a14:imgEffect>
                              </a14:imgLayer>
                            </a14:imgProps>
                          </a:ext>
                          <a:ext uri="{28A0092B-C50C-407E-A947-70E740481C1C}">
                            <a14:useLocalDpi xmlns:a14="http://schemas.microsoft.com/office/drawing/2010/main" val="0"/>
                          </a:ext>
                        </a:extLst>
                      </a:blip>
                      <a:srcRect/>
                      <a:stretch>
                        <a:fillRect/>
                      </a:stretch>
                    </p:blipFill>
                    <p:spPr bwMode="auto">
                      <a:xfrm>
                        <a:off x="1928892" y="1053953"/>
                        <a:ext cx="4572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129" name="Object 138"/>
          <p:cNvGraphicFramePr>
            <a:graphicFrameLocks/>
          </p:cNvGraphicFramePr>
          <p:nvPr>
            <p:extLst>
              <p:ext uri="{D42A27DB-BD31-4B8C-83A1-F6EECF244321}">
                <p14:modId xmlns:p14="http://schemas.microsoft.com/office/powerpoint/2010/main" val="2458691947"/>
              </p:ext>
            </p:extLst>
          </p:nvPr>
        </p:nvGraphicFramePr>
        <p:xfrm>
          <a:off x="1928892" y="1551758"/>
          <a:ext cx="457200" cy="457200"/>
        </p:xfrm>
        <a:graphic>
          <a:graphicData uri="http://schemas.openxmlformats.org/presentationml/2006/ole">
            <mc:AlternateContent xmlns:mc="http://schemas.openxmlformats.org/markup-compatibility/2006">
              <mc:Choice xmlns:v="urn:schemas-microsoft-com:vml" Requires="v">
                <p:oleObj spid="_x0000_s5710" name="Image" r:id="rId6" imgW="865414" imgH="707078" progId="Photoshop.Image.7">
                  <p:embed/>
                </p:oleObj>
              </mc:Choice>
              <mc:Fallback>
                <p:oleObj name="Image" r:id="rId6" imgW="865414" imgH="707078" progId="Photoshop.Image.7">
                  <p:embed/>
                  <p:pic>
                    <p:nvPicPr>
                      <p:cNvPr id="5129" name="Object 138"/>
                      <p:cNvPicPr preferRelativeResize="0">
                        <a:picLocks noChangeArrowheads="1"/>
                      </p:cNvPicPr>
                      <p:nvPr/>
                    </p:nvPicPr>
                    <p:blipFill>
                      <a:blip r:embed="rId7">
                        <a:extLst>
                          <a:ext uri="{BEBA8EAE-BF5A-486C-A8C5-ECC9F3942E4B}">
                            <a14:imgProps xmlns:a14="http://schemas.microsoft.com/office/drawing/2010/main">
                              <a14:imgLayer r:embed="rId8">
                                <a14:imgEffect>
                                  <a14:brightnessContrast bright="-21000" contrast="33000"/>
                                </a14:imgEffect>
                              </a14:imgLayer>
                            </a14:imgProps>
                          </a:ext>
                          <a:ext uri="{28A0092B-C50C-407E-A947-70E740481C1C}">
                            <a14:useLocalDpi xmlns:a14="http://schemas.microsoft.com/office/drawing/2010/main" val="0"/>
                          </a:ext>
                        </a:extLst>
                      </a:blip>
                      <a:srcRect/>
                      <a:stretch>
                        <a:fillRect/>
                      </a:stretch>
                    </p:blipFill>
                    <p:spPr bwMode="auto">
                      <a:xfrm>
                        <a:off x="1928892" y="1551758"/>
                        <a:ext cx="4572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131" name="Object 155"/>
          <p:cNvGraphicFramePr>
            <a:graphicFrameLocks/>
          </p:cNvGraphicFramePr>
          <p:nvPr/>
        </p:nvGraphicFramePr>
        <p:xfrm>
          <a:off x="1384545" y="1053953"/>
          <a:ext cx="457200" cy="457200"/>
        </p:xfrm>
        <a:graphic>
          <a:graphicData uri="http://schemas.openxmlformats.org/presentationml/2006/ole">
            <mc:AlternateContent xmlns:mc="http://schemas.openxmlformats.org/markup-compatibility/2006">
              <mc:Choice xmlns:v="urn:schemas-microsoft-com:vml" Requires="v">
                <p:oleObj spid="_x0000_s5711" name="Image" r:id="rId9" imgW="914015" imgH="926202" progId="Photoshop.Image.7">
                  <p:embed/>
                </p:oleObj>
              </mc:Choice>
              <mc:Fallback>
                <p:oleObj name="Image" r:id="rId9" imgW="914015" imgH="926202" progId="Photoshop.Image.7">
                  <p:embed/>
                  <p:pic>
                    <p:nvPicPr>
                      <p:cNvPr id="5131" name="Object 155"/>
                      <p:cNvPicPr preferRelativeResize="0">
                        <a:picLocks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1384545" y="1053953"/>
                        <a:ext cx="4572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133" name="Object 161"/>
          <p:cNvGraphicFramePr>
            <a:graphicFrameLocks/>
          </p:cNvGraphicFramePr>
          <p:nvPr/>
        </p:nvGraphicFramePr>
        <p:xfrm>
          <a:off x="1384545" y="1551758"/>
          <a:ext cx="457200" cy="457200"/>
        </p:xfrm>
        <a:graphic>
          <a:graphicData uri="http://schemas.openxmlformats.org/presentationml/2006/ole">
            <mc:AlternateContent xmlns:mc="http://schemas.openxmlformats.org/markup-compatibility/2006">
              <mc:Choice xmlns:v="urn:schemas-microsoft-com:vml" Requires="v">
                <p:oleObj spid="_x0000_s5712" name="Image" r:id="rId11" imgW="1066712" imgH="950736" progId="Photoshop.Image.7">
                  <p:embed/>
                </p:oleObj>
              </mc:Choice>
              <mc:Fallback>
                <p:oleObj name="Image" r:id="rId11" imgW="1066712" imgH="950736" progId="Photoshop.Image.7">
                  <p:embed/>
                  <p:pic>
                    <p:nvPicPr>
                      <p:cNvPr id="5133" name="Object 161"/>
                      <p:cNvPicPr preferRelativeResize="0">
                        <a:picLocks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1384545" y="1551758"/>
                        <a:ext cx="4572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147" name="Object 74"/>
          <p:cNvGraphicFramePr>
            <a:graphicFrameLocks/>
          </p:cNvGraphicFramePr>
          <p:nvPr>
            <p:extLst>
              <p:ext uri="{D42A27DB-BD31-4B8C-83A1-F6EECF244321}">
                <p14:modId xmlns:p14="http://schemas.microsoft.com/office/powerpoint/2010/main" val="3263837122"/>
              </p:ext>
            </p:extLst>
          </p:nvPr>
        </p:nvGraphicFramePr>
        <p:xfrm>
          <a:off x="1928892" y="2048087"/>
          <a:ext cx="457200" cy="457200"/>
        </p:xfrm>
        <a:graphic>
          <a:graphicData uri="http://schemas.openxmlformats.org/presentationml/2006/ole">
            <mc:AlternateContent xmlns:mc="http://schemas.openxmlformats.org/markup-compatibility/2006">
              <mc:Choice xmlns:v="urn:schemas-microsoft-com:vml" Requires="v">
                <p:oleObj spid="_x0000_s5713" name="Image" r:id="rId13" imgW="962925" imgH="1127476" progId="Photoshop.Image.7">
                  <p:embed/>
                </p:oleObj>
              </mc:Choice>
              <mc:Fallback>
                <p:oleObj name="Image" r:id="rId13" imgW="962925" imgH="1127476" progId="Photoshop.Image.7">
                  <p:embed/>
                  <p:pic>
                    <p:nvPicPr>
                      <p:cNvPr id="5147" name="Object 74"/>
                      <p:cNvPicPr preferRelativeResize="0">
                        <a:picLocks noChangeArrowheads="1"/>
                      </p:cNvPicPr>
                      <p:nvPr/>
                    </p:nvPicPr>
                    <p:blipFill>
                      <a:blip r:embed="rId14">
                        <a:extLst>
                          <a:ext uri="{BEBA8EAE-BF5A-486C-A8C5-ECC9F3942E4B}">
                            <a14:imgProps xmlns:a14="http://schemas.microsoft.com/office/drawing/2010/main">
                              <a14:imgLayer r:embed="rId15">
                                <a14:imgEffect>
                                  <a14:brightnessContrast bright="-6000" contrast="18000"/>
                                </a14:imgEffect>
                              </a14:imgLayer>
                            </a14:imgProps>
                          </a:ext>
                          <a:ext uri="{28A0092B-C50C-407E-A947-70E740481C1C}">
                            <a14:useLocalDpi xmlns:a14="http://schemas.microsoft.com/office/drawing/2010/main" val="0"/>
                          </a:ext>
                        </a:extLst>
                      </a:blip>
                      <a:srcRect/>
                      <a:stretch>
                        <a:fillRect/>
                      </a:stretch>
                    </p:blipFill>
                    <p:spPr bwMode="auto">
                      <a:xfrm>
                        <a:off x="1928892"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5156" name="Object 186"/>
          <p:cNvGraphicFramePr>
            <a:graphicFrameLocks/>
          </p:cNvGraphicFramePr>
          <p:nvPr/>
        </p:nvGraphicFramePr>
        <p:xfrm>
          <a:off x="1384545" y="2048087"/>
          <a:ext cx="457200" cy="457200"/>
        </p:xfrm>
        <a:graphic>
          <a:graphicData uri="http://schemas.openxmlformats.org/presentationml/2006/ole">
            <mc:AlternateContent xmlns:mc="http://schemas.openxmlformats.org/markup-compatibility/2006">
              <mc:Choice xmlns:v="urn:schemas-microsoft-com:vml" Requires="v">
                <p:oleObj spid="_x0000_s5714" name="Image" r:id="rId16" imgW="700863" imgH="810427" progId="Photoshop.Image.7">
                  <p:embed/>
                </p:oleObj>
              </mc:Choice>
              <mc:Fallback>
                <p:oleObj name="Image" r:id="rId16" imgW="700863" imgH="810427" progId="Photoshop.Image.7">
                  <p:embed/>
                  <p:pic>
                    <p:nvPicPr>
                      <p:cNvPr id="5156" name="Object 186"/>
                      <p:cNvPicPr preferRelativeResize="0">
                        <a:picLocks noChangeArrowheads="1"/>
                      </p:cNvPicPr>
                      <p:nvPr/>
                    </p:nvPicPr>
                    <p:blipFill>
                      <a:blip r:embed="rId17">
                        <a:lum bright="24000"/>
                        <a:extLst>
                          <a:ext uri="{28A0092B-C50C-407E-A947-70E740481C1C}">
                            <a14:useLocalDpi xmlns:a14="http://schemas.microsoft.com/office/drawing/2010/main" val="0"/>
                          </a:ext>
                        </a:extLst>
                      </a:blip>
                      <a:srcRect/>
                      <a:stretch>
                        <a:fillRect/>
                      </a:stretch>
                    </p:blipFill>
                    <p:spPr bwMode="auto">
                      <a:xfrm>
                        <a:off x="1384545"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5160" name="Text Box 39"/>
          <p:cNvSpPr txBox="1">
            <a:spLocks noChangeArrowheads="1"/>
          </p:cNvSpPr>
          <p:nvPr/>
        </p:nvSpPr>
        <p:spPr bwMode="auto">
          <a:xfrm>
            <a:off x="861770" y="2145871"/>
            <a:ext cx="585417"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i="1" dirty="0">
                <a:latin typeface="Arial" panose="020B0604020202020204" pitchFamily="34" charset="0"/>
                <a:cs typeface="Arial" panose="020B0604020202020204" pitchFamily="34" charset="0"/>
              </a:rPr>
              <a:t>swi1</a:t>
            </a:r>
            <a:r>
              <a:rPr lang="en-US" altLang="en-US" sz="1200" i="1" dirty="0">
                <a:latin typeface="Arial" panose="020B0604020202020204" pitchFamily="34" charset="0"/>
                <a:cs typeface="Arial" panose="020B0604020202020204" pitchFamily="34" charset="0"/>
                <a:sym typeface="Symbol" pitchFamily="18" charset="2"/>
              </a:rPr>
              <a:t></a:t>
            </a:r>
          </a:p>
        </p:txBody>
      </p:sp>
      <p:sp>
        <p:nvSpPr>
          <p:cNvPr id="5143" name="Text Box 40"/>
          <p:cNvSpPr txBox="1">
            <a:spLocks noChangeArrowheads="1"/>
          </p:cNvSpPr>
          <p:nvPr/>
        </p:nvSpPr>
        <p:spPr bwMode="auto">
          <a:xfrm>
            <a:off x="388546" y="1661910"/>
            <a:ext cx="1063112"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i="1" dirty="0">
                <a:latin typeface="Arial" panose="020B0604020202020204" pitchFamily="34" charset="0"/>
                <a:cs typeface="Arial" panose="020B0604020202020204" pitchFamily="34" charset="0"/>
              </a:rPr>
              <a:t>WT </a:t>
            </a:r>
            <a:r>
              <a:rPr lang="en-US" altLang="en-US" sz="1200" i="1" dirty="0" err="1">
                <a:latin typeface="Arial" panose="020B0604020202020204" pitchFamily="34" charset="0"/>
                <a:cs typeface="Arial" panose="020B0604020202020204" pitchFamily="34" charset="0"/>
              </a:rPr>
              <a:t>nonprion</a:t>
            </a:r>
            <a:endParaRPr lang="en-US" altLang="en-US" sz="1200" i="1" dirty="0">
              <a:latin typeface="Arial" panose="020B0604020202020204" pitchFamily="34" charset="0"/>
              <a:cs typeface="Arial" panose="020B0604020202020204" pitchFamily="34" charset="0"/>
            </a:endParaRPr>
          </a:p>
        </p:txBody>
      </p:sp>
      <p:sp>
        <p:nvSpPr>
          <p:cNvPr id="5144" name="Text Box 47"/>
          <p:cNvSpPr txBox="1">
            <a:spLocks noChangeArrowheads="1"/>
          </p:cNvSpPr>
          <p:nvPr/>
        </p:nvSpPr>
        <p:spPr bwMode="auto">
          <a:xfrm>
            <a:off x="820748" y="1176462"/>
            <a:ext cx="62228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a:t>
            </a:r>
            <a:r>
              <a:rPr lang="en-US" altLang="en-US" sz="1200" i="1" dirty="0">
                <a:latin typeface="Arial" panose="020B0604020202020204" pitchFamily="34" charset="0"/>
                <a:cs typeface="Arial" panose="020B0604020202020204" pitchFamily="34" charset="0"/>
              </a:rPr>
              <a:t>SWI</a:t>
            </a:r>
            <a:r>
              <a:rPr lang="en-US" altLang="en-US" sz="1200" i="1" baseline="30000" dirty="0">
                <a:latin typeface="Arial" panose="020B0604020202020204" pitchFamily="34" charset="0"/>
                <a:cs typeface="Arial" panose="020B0604020202020204" pitchFamily="34" charset="0"/>
              </a:rPr>
              <a:t>+</a:t>
            </a:r>
            <a:r>
              <a:rPr lang="en-US" altLang="en-US" sz="1200" dirty="0">
                <a:latin typeface="Arial" panose="020B0604020202020204" pitchFamily="34" charset="0"/>
                <a:cs typeface="Arial" panose="020B0604020202020204" pitchFamily="34" charset="0"/>
              </a:rPr>
              <a:t>]</a:t>
            </a:r>
          </a:p>
        </p:txBody>
      </p:sp>
      <p:graphicFrame>
        <p:nvGraphicFramePr>
          <p:cNvPr id="186" name="Object 121"/>
          <p:cNvGraphicFramePr>
            <a:graphicFrameLocks/>
          </p:cNvGraphicFramePr>
          <p:nvPr>
            <p:extLst>
              <p:ext uri="{D42A27DB-BD31-4B8C-83A1-F6EECF244321}">
                <p14:modId xmlns:p14="http://schemas.microsoft.com/office/powerpoint/2010/main" val="4265297381"/>
              </p:ext>
            </p:extLst>
          </p:nvPr>
        </p:nvGraphicFramePr>
        <p:xfrm>
          <a:off x="5343250" y="1053953"/>
          <a:ext cx="457200" cy="457200"/>
        </p:xfrm>
        <a:graphic>
          <a:graphicData uri="http://schemas.openxmlformats.org/presentationml/2006/ole">
            <mc:AlternateContent xmlns:mc="http://schemas.openxmlformats.org/markup-compatibility/2006">
              <mc:Choice xmlns:v="urn:schemas-microsoft-com:vml" Requires="v">
                <p:oleObj spid="_x0000_s5715" name="Image" r:id="rId18" imgW="228233" imgH="243724" progId="Photoshop.Image.7">
                  <p:embed/>
                </p:oleObj>
              </mc:Choice>
              <mc:Fallback>
                <p:oleObj name="Image" r:id="rId18" imgW="228233" imgH="243724" progId="Photoshop.Image.7">
                  <p:embed/>
                  <p:pic>
                    <p:nvPicPr>
                      <p:cNvPr id="186" name="Object 121"/>
                      <p:cNvPicPr preferRelativeResize="0">
                        <a:picLocks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5343250"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87" name="Object 122"/>
          <p:cNvGraphicFramePr>
            <a:graphicFrameLocks/>
          </p:cNvGraphicFramePr>
          <p:nvPr>
            <p:extLst>
              <p:ext uri="{D42A27DB-BD31-4B8C-83A1-F6EECF244321}">
                <p14:modId xmlns:p14="http://schemas.microsoft.com/office/powerpoint/2010/main" val="223227918"/>
              </p:ext>
            </p:extLst>
          </p:nvPr>
        </p:nvGraphicFramePr>
        <p:xfrm>
          <a:off x="5841492" y="1053953"/>
          <a:ext cx="457200" cy="457200"/>
        </p:xfrm>
        <a:graphic>
          <a:graphicData uri="http://schemas.openxmlformats.org/presentationml/2006/ole">
            <mc:AlternateContent xmlns:mc="http://schemas.openxmlformats.org/markup-compatibility/2006">
              <mc:Choice xmlns:v="urn:schemas-microsoft-com:vml" Requires="v">
                <p:oleObj spid="_x0000_s5716" name="Image" r:id="rId20" imgW="233634" imgH="243724" progId="Photoshop.Image.7">
                  <p:embed/>
                </p:oleObj>
              </mc:Choice>
              <mc:Fallback>
                <p:oleObj name="Image" r:id="rId20" imgW="233634" imgH="243724" progId="Photoshop.Image.7">
                  <p:embed/>
                  <p:pic>
                    <p:nvPicPr>
                      <p:cNvPr id="187" name="Object 122"/>
                      <p:cNvPicPr preferRelativeResize="0">
                        <a:picLocks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5841492"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88" name="Object 123"/>
          <p:cNvGraphicFramePr>
            <a:graphicFrameLocks/>
          </p:cNvGraphicFramePr>
          <p:nvPr>
            <p:extLst>
              <p:ext uri="{D42A27DB-BD31-4B8C-83A1-F6EECF244321}">
                <p14:modId xmlns:p14="http://schemas.microsoft.com/office/powerpoint/2010/main" val="3242940330"/>
              </p:ext>
            </p:extLst>
          </p:nvPr>
        </p:nvGraphicFramePr>
        <p:xfrm>
          <a:off x="5343250" y="1551758"/>
          <a:ext cx="457200" cy="457200"/>
        </p:xfrm>
        <a:graphic>
          <a:graphicData uri="http://schemas.openxmlformats.org/presentationml/2006/ole">
            <mc:AlternateContent xmlns:mc="http://schemas.openxmlformats.org/markup-compatibility/2006">
              <mc:Choice xmlns:v="urn:schemas-microsoft-com:vml" Requires="v">
                <p:oleObj spid="_x0000_s5717" name="Image" r:id="rId22" imgW="218151" imgH="228233" progId="Photoshop.Image.7">
                  <p:embed/>
                </p:oleObj>
              </mc:Choice>
              <mc:Fallback>
                <p:oleObj name="Image" r:id="rId22" imgW="218151" imgH="228233" progId="Photoshop.Image.7">
                  <p:embed/>
                  <p:pic>
                    <p:nvPicPr>
                      <p:cNvPr id="188" name="Object 123"/>
                      <p:cNvPicPr preferRelativeResize="0">
                        <a:picLocks noChangeArrowheads="1"/>
                      </p:cNvPicPr>
                      <p:nvPr/>
                    </p:nvPicPr>
                    <p:blipFill>
                      <a:blip r:embed="rId23">
                        <a:extLst>
                          <a:ext uri="{28A0092B-C50C-407E-A947-70E740481C1C}">
                            <a14:useLocalDpi xmlns:a14="http://schemas.microsoft.com/office/drawing/2010/main" val="0"/>
                          </a:ext>
                        </a:extLst>
                      </a:blip>
                      <a:srcRect/>
                      <a:stretch>
                        <a:fillRect/>
                      </a:stretch>
                    </p:blipFill>
                    <p:spPr bwMode="auto">
                      <a:xfrm>
                        <a:off x="5343250"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89" name="Object 124"/>
          <p:cNvGraphicFramePr>
            <a:graphicFrameLocks/>
          </p:cNvGraphicFramePr>
          <p:nvPr>
            <p:extLst>
              <p:ext uri="{D42A27DB-BD31-4B8C-83A1-F6EECF244321}">
                <p14:modId xmlns:p14="http://schemas.microsoft.com/office/powerpoint/2010/main" val="559277048"/>
              </p:ext>
            </p:extLst>
          </p:nvPr>
        </p:nvGraphicFramePr>
        <p:xfrm>
          <a:off x="5841492" y="1551758"/>
          <a:ext cx="457200" cy="457200"/>
        </p:xfrm>
        <a:graphic>
          <a:graphicData uri="http://schemas.openxmlformats.org/presentationml/2006/ole">
            <mc:AlternateContent xmlns:mc="http://schemas.openxmlformats.org/markup-compatibility/2006">
              <mc:Choice xmlns:v="urn:schemas-microsoft-com:vml" Requires="v">
                <p:oleObj spid="_x0000_s5718" name="Image" r:id="rId24" imgW="218151" imgH="208092" progId="Photoshop.Image.7">
                  <p:embed/>
                </p:oleObj>
              </mc:Choice>
              <mc:Fallback>
                <p:oleObj name="Image" r:id="rId24" imgW="218151" imgH="208092" progId="Photoshop.Image.7">
                  <p:embed/>
                  <p:pic>
                    <p:nvPicPr>
                      <p:cNvPr id="189" name="Object 124"/>
                      <p:cNvPicPr preferRelativeResize="0">
                        <a:picLocks noChangeArrowheads="1"/>
                      </p:cNvPicPr>
                      <p:nvPr/>
                    </p:nvPicPr>
                    <p:blipFill>
                      <a:blip r:embed="rId25">
                        <a:extLst>
                          <a:ext uri="{28A0092B-C50C-407E-A947-70E740481C1C}">
                            <a14:useLocalDpi xmlns:a14="http://schemas.microsoft.com/office/drawing/2010/main" val="0"/>
                          </a:ext>
                        </a:extLst>
                      </a:blip>
                      <a:srcRect/>
                      <a:stretch>
                        <a:fillRect/>
                      </a:stretch>
                    </p:blipFill>
                    <p:spPr bwMode="auto">
                      <a:xfrm>
                        <a:off x="5841492"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90" name="Object 125"/>
          <p:cNvGraphicFramePr>
            <a:graphicFrameLocks/>
          </p:cNvGraphicFramePr>
          <p:nvPr>
            <p:extLst>
              <p:ext uri="{D42A27DB-BD31-4B8C-83A1-F6EECF244321}">
                <p14:modId xmlns:p14="http://schemas.microsoft.com/office/powerpoint/2010/main" val="845421311"/>
              </p:ext>
            </p:extLst>
          </p:nvPr>
        </p:nvGraphicFramePr>
        <p:xfrm>
          <a:off x="5841492" y="2048087"/>
          <a:ext cx="457200" cy="457200"/>
        </p:xfrm>
        <a:graphic>
          <a:graphicData uri="http://schemas.openxmlformats.org/presentationml/2006/ole">
            <mc:AlternateContent xmlns:mc="http://schemas.openxmlformats.org/markup-compatibility/2006">
              <mc:Choice xmlns:v="urn:schemas-microsoft-com:vml" Requires="v">
                <p:oleObj spid="_x0000_s5719" name="Image" r:id="rId26" imgW="228233" imgH="213108" progId="Photoshop.Image.7">
                  <p:embed/>
                </p:oleObj>
              </mc:Choice>
              <mc:Fallback>
                <p:oleObj name="Image" r:id="rId26" imgW="228233" imgH="213108" progId="Photoshop.Image.7">
                  <p:embed/>
                  <p:pic>
                    <p:nvPicPr>
                      <p:cNvPr id="190" name="Object 125"/>
                      <p:cNvPicPr preferRelativeResize="0">
                        <a:picLocks noChangeArrowheads="1"/>
                      </p:cNvPicPr>
                      <p:nvPr/>
                    </p:nvPicPr>
                    <p:blipFill>
                      <a:blip r:embed="rId27">
                        <a:extLst>
                          <a:ext uri="{28A0092B-C50C-407E-A947-70E740481C1C}">
                            <a14:useLocalDpi xmlns:a14="http://schemas.microsoft.com/office/drawing/2010/main" val="0"/>
                          </a:ext>
                        </a:extLst>
                      </a:blip>
                      <a:srcRect/>
                      <a:stretch>
                        <a:fillRect/>
                      </a:stretch>
                    </p:blipFill>
                    <p:spPr bwMode="auto">
                      <a:xfrm>
                        <a:off x="5841492"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91" name="Object 126"/>
          <p:cNvGraphicFramePr>
            <a:graphicFrameLocks/>
          </p:cNvGraphicFramePr>
          <p:nvPr>
            <p:extLst>
              <p:ext uri="{D42A27DB-BD31-4B8C-83A1-F6EECF244321}">
                <p14:modId xmlns:p14="http://schemas.microsoft.com/office/powerpoint/2010/main" val="2873407483"/>
              </p:ext>
            </p:extLst>
          </p:nvPr>
        </p:nvGraphicFramePr>
        <p:xfrm>
          <a:off x="5343250" y="2048087"/>
          <a:ext cx="457200" cy="457200"/>
        </p:xfrm>
        <a:graphic>
          <a:graphicData uri="http://schemas.openxmlformats.org/presentationml/2006/ole">
            <mc:AlternateContent xmlns:mc="http://schemas.openxmlformats.org/markup-compatibility/2006">
              <mc:Choice xmlns:v="urn:schemas-microsoft-com:vml" Requires="v">
                <p:oleObj spid="_x0000_s5720" name="Image" r:id="rId28" imgW="218151" imgH="208092" progId="Photoshop.Image.7">
                  <p:embed/>
                </p:oleObj>
              </mc:Choice>
              <mc:Fallback>
                <p:oleObj name="Image" r:id="rId28" imgW="218151" imgH="208092" progId="Photoshop.Image.7">
                  <p:embed/>
                  <p:pic>
                    <p:nvPicPr>
                      <p:cNvPr id="191" name="Object 126"/>
                      <p:cNvPicPr preferRelativeResize="0">
                        <a:picLocks noChangeArrowheads="1"/>
                      </p:cNvPicPr>
                      <p:nvPr/>
                    </p:nvPicPr>
                    <p:blipFill>
                      <a:blip r:embed="rId29">
                        <a:extLst>
                          <a:ext uri="{28A0092B-C50C-407E-A947-70E740481C1C}">
                            <a14:useLocalDpi xmlns:a14="http://schemas.microsoft.com/office/drawing/2010/main" val="0"/>
                          </a:ext>
                        </a:extLst>
                      </a:blip>
                      <a:srcRect/>
                      <a:stretch>
                        <a:fillRect/>
                      </a:stretch>
                    </p:blipFill>
                    <p:spPr bwMode="auto">
                      <a:xfrm>
                        <a:off x="5343250"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195" name="Text Box 135"/>
          <p:cNvSpPr txBox="1">
            <a:spLocks noChangeArrowheads="1"/>
          </p:cNvSpPr>
          <p:nvPr/>
        </p:nvSpPr>
        <p:spPr bwMode="auto">
          <a:xfrm rot="19545752">
            <a:off x="5359526" y="562375"/>
            <a:ext cx="104008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Calibri" pitchFamily="34" charset="0"/>
              </a:defRPr>
            </a:lvl1pPr>
            <a:lvl2pPr marL="742950" indent="-285750">
              <a:defRPr>
                <a:solidFill>
                  <a:schemeClr val="tx1"/>
                </a:solidFill>
                <a:latin typeface="Calibri" pitchFamily="34" charset="0"/>
              </a:defRPr>
            </a:lvl2pPr>
            <a:lvl3pPr marL="1143000" indent="-228600">
              <a:defRPr>
                <a:solidFill>
                  <a:schemeClr val="tx1"/>
                </a:solidFill>
                <a:latin typeface="Calibri" pitchFamily="34" charset="0"/>
              </a:defRPr>
            </a:lvl3pPr>
            <a:lvl4pPr marL="1600200" indent="-228600">
              <a:defRPr>
                <a:solidFill>
                  <a:schemeClr val="tx1"/>
                </a:solidFill>
                <a:latin typeface="Calibri" pitchFamily="34" charset="0"/>
              </a:defRPr>
            </a:lvl4pPr>
            <a:lvl5pPr marL="2057400" indent="-228600">
              <a:defRPr>
                <a:solidFill>
                  <a:schemeClr val="tx1"/>
                </a:solidFill>
                <a:latin typeface="Calibri" pitchFamily="34" charset="0"/>
              </a:defRPr>
            </a:lvl5pPr>
            <a:lvl6pPr marL="2514600" indent="-228600" eaLnBrk="0" fontAlgn="base" hangingPunct="0">
              <a:spcBef>
                <a:spcPct val="0"/>
              </a:spcBef>
              <a:spcAft>
                <a:spcPct val="0"/>
              </a:spcAft>
              <a:defRPr>
                <a:solidFill>
                  <a:schemeClr val="tx1"/>
                </a:solidFill>
                <a:latin typeface="Calibri" pitchFamily="34" charset="0"/>
              </a:defRPr>
            </a:lvl6pPr>
            <a:lvl7pPr marL="2971800" indent="-228600" eaLnBrk="0" fontAlgn="base" hangingPunct="0">
              <a:spcBef>
                <a:spcPct val="0"/>
              </a:spcBef>
              <a:spcAft>
                <a:spcPct val="0"/>
              </a:spcAft>
              <a:defRPr>
                <a:solidFill>
                  <a:schemeClr val="tx1"/>
                </a:solidFill>
                <a:latin typeface="Calibri" pitchFamily="34" charset="0"/>
              </a:defRPr>
            </a:lvl7pPr>
            <a:lvl8pPr marL="3429000" indent="-228600" eaLnBrk="0" fontAlgn="base" hangingPunct="0">
              <a:spcBef>
                <a:spcPct val="0"/>
              </a:spcBef>
              <a:spcAft>
                <a:spcPct val="0"/>
              </a:spcAft>
              <a:defRPr>
                <a:solidFill>
                  <a:schemeClr val="tx1"/>
                </a:solidFill>
                <a:latin typeface="Calibri" pitchFamily="34" charset="0"/>
              </a:defRPr>
            </a:lvl8pPr>
            <a:lvl9pPr marL="3886200" indent="-228600" eaLnBrk="0" fontAlgn="base" hangingPunct="0">
              <a:spcBef>
                <a:spcPct val="0"/>
              </a:spcBef>
              <a:spcAft>
                <a:spcPct val="0"/>
              </a:spcAft>
              <a:defRPr>
                <a:solidFill>
                  <a:schemeClr val="tx1"/>
                </a:solidFill>
                <a:latin typeface="Calibri" pitchFamily="34" charset="0"/>
              </a:defRPr>
            </a:lvl9pPr>
          </a:lstStyle>
          <a:p>
            <a:pPr eaLnBrk="1" hangingPunct="1"/>
            <a:r>
              <a:rPr lang="en-US" altLang="en-US" sz="1200" dirty="0">
                <a:latin typeface="Arial" panose="020B0604020202020204" pitchFamily="34" charset="0"/>
                <a:cs typeface="Arial" panose="020B0604020202020204" pitchFamily="34" charset="0"/>
              </a:rPr>
              <a:t>before wash</a:t>
            </a:r>
          </a:p>
        </p:txBody>
      </p:sp>
      <p:sp>
        <p:nvSpPr>
          <p:cNvPr id="196" name="Text Box 136"/>
          <p:cNvSpPr txBox="1">
            <a:spLocks noChangeArrowheads="1"/>
          </p:cNvSpPr>
          <p:nvPr/>
        </p:nvSpPr>
        <p:spPr bwMode="auto">
          <a:xfrm rot="19545752">
            <a:off x="5849973" y="597924"/>
            <a:ext cx="89319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defRPr>
                <a:solidFill>
                  <a:schemeClr val="tx1"/>
                </a:solidFill>
                <a:latin typeface="Calibri" pitchFamily="34" charset="0"/>
              </a:defRPr>
            </a:lvl1pPr>
            <a:lvl2pPr marL="742950" indent="-285750">
              <a:defRPr>
                <a:solidFill>
                  <a:schemeClr val="tx1"/>
                </a:solidFill>
                <a:latin typeface="Calibri" pitchFamily="34" charset="0"/>
              </a:defRPr>
            </a:lvl2pPr>
            <a:lvl3pPr marL="1143000" indent="-228600">
              <a:defRPr>
                <a:solidFill>
                  <a:schemeClr val="tx1"/>
                </a:solidFill>
                <a:latin typeface="Calibri" pitchFamily="34" charset="0"/>
              </a:defRPr>
            </a:lvl3pPr>
            <a:lvl4pPr marL="1600200" indent="-228600">
              <a:defRPr>
                <a:solidFill>
                  <a:schemeClr val="tx1"/>
                </a:solidFill>
                <a:latin typeface="Calibri" pitchFamily="34" charset="0"/>
              </a:defRPr>
            </a:lvl4pPr>
            <a:lvl5pPr marL="2057400" indent="-228600">
              <a:defRPr>
                <a:solidFill>
                  <a:schemeClr val="tx1"/>
                </a:solidFill>
                <a:latin typeface="Calibri" pitchFamily="34" charset="0"/>
              </a:defRPr>
            </a:lvl5pPr>
            <a:lvl6pPr marL="2514600" indent="-228600" eaLnBrk="0" fontAlgn="base" hangingPunct="0">
              <a:spcBef>
                <a:spcPct val="0"/>
              </a:spcBef>
              <a:spcAft>
                <a:spcPct val="0"/>
              </a:spcAft>
              <a:defRPr>
                <a:solidFill>
                  <a:schemeClr val="tx1"/>
                </a:solidFill>
                <a:latin typeface="Calibri" pitchFamily="34" charset="0"/>
              </a:defRPr>
            </a:lvl6pPr>
            <a:lvl7pPr marL="2971800" indent="-228600" eaLnBrk="0" fontAlgn="base" hangingPunct="0">
              <a:spcBef>
                <a:spcPct val="0"/>
              </a:spcBef>
              <a:spcAft>
                <a:spcPct val="0"/>
              </a:spcAft>
              <a:defRPr>
                <a:solidFill>
                  <a:schemeClr val="tx1"/>
                </a:solidFill>
                <a:latin typeface="Calibri" pitchFamily="34" charset="0"/>
              </a:defRPr>
            </a:lvl7pPr>
            <a:lvl8pPr marL="3429000" indent="-228600" eaLnBrk="0" fontAlgn="base" hangingPunct="0">
              <a:spcBef>
                <a:spcPct val="0"/>
              </a:spcBef>
              <a:spcAft>
                <a:spcPct val="0"/>
              </a:spcAft>
              <a:defRPr>
                <a:solidFill>
                  <a:schemeClr val="tx1"/>
                </a:solidFill>
                <a:latin typeface="Calibri" pitchFamily="34" charset="0"/>
              </a:defRPr>
            </a:lvl8pPr>
            <a:lvl9pPr marL="3886200" indent="-228600" eaLnBrk="0" fontAlgn="base" hangingPunct="0">
              <a:spcBef>
                <a:spcPct val="0"/>
              </a:spcBef>
              <a:spcAft>
                <a:spcPct val="0"/>
              </a:spcAft>
              <a:defRPr>
                <a:solidFill>
                  <a:schemeClr val="tx1"/>
                </a:solidFill>
                <a:latin typeface="Calibri" pitchFamily="34" charset="0"/>
              </a:defRPr>
            </a:lvl9pPr>
          </a:lstStyle>
          <a:p>
            <a:pPr eaLnBrk="1" hangingPunct="1"/>
            <a:r>
              <a:rPr lang="en-US" altLang="en-US" sz="1200" dirty="0">
                <a:latin typeface="Arial" panose="020B0604020202020204" pitchFamily="34" charset="0"/>
                <a:cs typeface="Arial" panose="020B0604020202020204" pitchFamily="34" charset="0"/>
              </a:rPr>
              <a:t>after wash</a:t>
            </a:r>
          </a:p>
        </p:txBody>
      </p:sp>
      <p:graphicFrame>
        <p:nvGraphicFramePr>
          <p:cNvPr id="79" name="Object 74"/>
          <p:cNvGraphicFramePr>
            <a:graphicFrameLocks/>
          </p:cNvGraphicFramePr>
          <p:nvPr>
            <p:extLst>
              <p:ext uri="{D42A27DB-BD31-4B8C-83A1-F6EECF244321}">
                <p14:modId xmlns:p14="http://schemas.microsoft.com/office/powerpoint/2010/main" val="3149293007"/>
              </p:ext>
            </p:extLst>
          </p:nvPr>
        </p:nvGraphicFramePr>
        <p:xfrm>
          <a:off x="4150822" y="1053953"/>
          <a:ext cx="457200" cy="457200"/>
        </p:xfrm>
        <a:graphic>
          <a:graphicData uri="http://schemas.openxmlformats.org/presentationml/2006/ole">
            <mc:AlternateContent xmlns:mc="http://schemas.openxmlformats.org/markup-compatibility/2006">
              <mc:Choice xmlns:v="urn:schemas-microsoft-com:vml" Requires="v">
                <p:oleObj spid="_x0000_s5721" name="Image" r:id="rId30" imgW="284384" imgH="304569" progId="Photoshop.Image.7">
                  <p:embed/>
                </p:oleObj>
              </mc:Choice>
              <mc:Fallback>
                <p:oleObj name="Image" r:id="rId30" imgW="284384" imgH="304569" progId="Photoshop.Image.7">
                  <p:embed/>
                  <p:pic>
                    <p:nvPicPr>
                      <p:cNvPr id="79" name="Object 74"/>
                      <p:cNvPicPr preferRelativeResize="0">
                        <a:picLocks noChangeArrowheads="1"/>
                      </p:cNvPicPr>
                      <p:nvPr/>
                    </p:nvPicPr>
                    <p:blipFill>
                      <a:blip r:embed="rId31">
                        <a:lum bright="6000"/>
                        <a:extLst>
                          <a:ext uri="{28A0092B-C50C-407E-A947-70E740481C1C}">
                            <a14:useLocalDpi xmlns:a14="http://schemas.microsoft.com/office/drawing/2010/main" val="0"/>
                          </a:ext>
                        </a:extLst>
                      </a:blip>
                      <a:srcRect/>
                      <a:stretch>
                        <a:fillRect/>
                      </a:stretch>
                    </p:blipFill>
                    <p:spPr bwMode="auto">
                      <a:xfrm>
                        <a:off x="4150822"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80" name="Text Box 79"/>
          <p:cNvSpPr txBox="1">
            <a:spLocks noChangeArrowheads="1"/>
          </p:cNvSpPr>
          <p:nvPr/>
        </p:nvSpPr>
        <p:spPr bwMode="auto">
          <a:xfrm rot="19545752">
            <a:off x="4130812" y="589037"/>
            <a:ext cx="8213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glycerol</a:t>
            </a:r>
          </a:p>
        </p:txBody>
      </p:sp>
      <p:graphicFrame>
        <p:nvGraphicFramePr>
          <p:cNvPr id="82" name="Object 83"/>
          <p:cNvGraphicFramePr>
            <a:graphicFrameLocks/>
          </p:cNvGraphicFramePr>
          <p:nvPr>
            <p:extLst>
              <p:ext uri="{D42A27DB-BD31-4B8C-83A1-F6EECF244321}">
                <p14:modId xmlns:p14="http://schemas.microsoft.com/office/powerpoint/2010/main" val="2030283085"/>
              </p:ext>
            </p:extLst>
          </p:nvPr>
        </p:nvGraphicFramePr>
        <p:xfrm>
          <a:off x="3656551" y="1053953"/>
          <a:ext cx="457200" cy="457200"/>
        </p:xfrm>
        <a:graphic>
          <a:graphicData uri="http://schemas.openxmlformats.org/presentationml/2006/ole">
            <mc:AlternateContent xmlns:mc="http://schemas.openxmlformats.org/markup-compatibility/2006">
              <mc:Choice xmlns:v="urn:schemas-microsoft-com:vml" Requires="v">
                <p:oleObj spid="_x0000_s5722" name="Image" r:id="rId32" imgW="279345" imgH="268922" progId="Photoshop.Image.7">
                  <p:embed/>
                </p:oleObj>
              </mc:Choice>
              <mc:Fallback>
                <p:oleObj name="Image" r:id="rId32" imgW="279345" imgH="268922" progId="Photoshop.Image.7">
                  <p:embed/>
                  <p:pic>
                    <p:nvPicPr>
                      <p:cNvPr id="82" name="Object 83"/>
                      <p:cNvPicPr preferRelativeResize="0">
                        <a:picLocks noChangeArrowheads="1"/>
                      </p:cNvPicPr>
                      <p:nvPr/>
                    </p:nvPicPr>
                    <p:blipFill>
                      <a:blip r:embed="rId33">
                        <a:lum bright="6000"/>
                        <a:extLst>
                          <a:ext uri="{28A0092B-C50C-407E-A947-70E740481C1C}">
                            <a14:useLocalDpi xmlns:a14="http://schemas.microsoft.com/office/drawing/2010/main" val="0"/>
                          </a:ext>
                        </a:extLst>
                      </a:blip>
                      <a:srcRect/>
                      <a:stretch>
                        <a:fillRect/>
                      </a:stretch>
                    </p:blipFill>
                    <p:spPr bwMode="auto">
                      <a:xfrm>
                        <a:off x="3656551"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83" name="Text Box 88"/>
          <p:cNvSpPr txBox="1">
            <a:spLocks noChangeArrowheads="1"/>
          </p:cNvSpPr>
          <p:nvPr/>
        </p:nvSpPr>
        <p:spPr bwMode="auto">
          <a:xfrm rot="19545752">
            <a:off x="3660706" y="547134"/>
            <a:ext cx="97026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galactose</a:t>
            </a:r>
          </a:p>
        </p:txBody>
      </p:sp>
      <p:graphicFrame>
        <p:nvGraphicFramePr>
          <p:cNvPr id="91" name="Object 111"/>
          <p:cNvGraphicFramePr>
            <a:graphicFrameLocks/>
          </p:cNvGraphicFramePr>
          <p:nvPr>
            <p:extLst>
              <p:ext uri="{D42A27DB-BD31-4B8C-83A1-F6EECF244321}">
                <p14:modId xmlns:p14="http://schemas.microsoft.com/office/powerpoint/2010/main" val="1381247536"/>
              </p:ext>
            </p:extLst>
          </p:nvPr>
        </p:nvGraphicFramePr>
        <p:xfrm>
          <a:off x="4645093" y="1053953"/>
          <a:ext cx="457200" cy="457200"/>
        </p:xfrm>
        <a:graphic>
          <a:graphicData uri="http://schemas.openxmlformats.org/presentationml/2006/ole">
            <mc:AlternateContent xmlns:mc="http://schemas.openxmlformats.org/markup-compatibility/2006">
              <mc:Choice xmlns:v="urn:schemas-microsoft-com:vml" Requires="v">
                <p:oleObj spid="_x0000_s5723" name="Image" r:id="rId34" imgW="203046" imgH="192948" progId="Photoshop.Image.7">
                  <p:embed/>
                </p:oleObj>
              </mc:Choice>
              <mc:Fallback>
                <p:oleObj name="Image" r:id="rId34" imgW="203046" imgH="192948" progId="Photoshop.Image.7">
                  <p:embed/>
                  <p:pic>
                    <p:nvPicPr>
                      <p:cNvPr id="91" name="Object 111"/>
                      <p:cNvPicPr preferRelativeResize="0">
                        <a:picLocks noChangeArrowheads="1"/>
                      </p:cNvPicPr>
                      <p:nvPr/>
                    </p:nvPicPr>
                    <p:blipFill>
                      <a:blip r:embed="rId35">
                        <a:extLst>
                          <a:ext uri="{28A0092B-C50C-407E-A947-70E740481C1C}">
                            <a14:useLocalDpi xmlns:a14="http://schemas.microsoft.com/office/drawing/2010/main" val="0"/>
                          </a:ext>
                        </a:extLst>
                      </a:blip>
                      <a:srcRect/>
                      <a:stretch>
                        <a:fillRect/>
                      </a:stretch>
                    </p:blipFill>
                    <p:spPr bwMode="auto">
                      <a:xfrm>
                        <a:off x="4645093"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92" name="Text Box 116"/>
          <p:cNvSpPr txBox="1">
            <a:spLocks noChangeArrowheads="1"/>
          </p:cNvSpPr>
          <p:nvPr/>
        </p:nvSpPr>
        <p:spPr bwMode="auto">
          <a:xfrm rot="19545752">
            <a:off x="4664212" y="589037"/>
            <a:ext cx="8213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glucose</a:t>
            </a:r>
          </a:p>
        </p:txBody>
      </p:sp>
      <p:sp>
        <p:nvSpPr>
          <p:cNvPr id="99" name="Text Box 72"/>
          <p:cNvSpPr txBox="1">
            <a:spLocks noChangeArrowheads="1"/>
          </p:cNvSpPr>
          <p:nvPr/>
        </p:nvSpPr>
        <p:spPr bwMode="auto">
          <a:xfrm rot="19545752">
            <a:off x="3210610" y="570200"/>
            <a:ext cx="88827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err="1">
                <a:latin typeface="Arial" panose="020B0604020202020204" pitchFamily="34" charset="0"/>
                <a:cs typeface="Arial" panose="020B0604020202020204" pitchFamily="34" charset="0"/>
              </a:rPr>
              <a:t>raffinose</a:t>
            </a:r>
            <a:endParaRPr lang="en-US" altLang="en-US" sz="1200" dirty="0">
              <a:latin typeface="Arial" panose="020B0604020202020204" pitchFamily="34" charset="0"/>
              <a:cs typeface="Arial" panose="020B0604020202020204" pitchFamily="34" charset="0"/>
            </a:endParaRPr>
          </a:p>
        </p:txBody>
      </p:sp>
      <p:graphicFrame>
        <p:nvGraphicFramePr>
          <p:cNvPr id="100" name="Object 98"/>
          <p:cNvGraphicFramePr>
            <a:graphicFrameLocks/>
          </p:cNvGraphicFramePr>
          <p:nvPr>
            <p:extLst>
              <p:ext uri="{D42A27DB-BD31-4B8C-83A1-F6EECF244321}">
                <p14:modId xmlns:p14="http://schemas.microsoft.com/office/powerpoint/2010/main" val="662782874"/>
              </p:ext>
            </p:extLst>
          </p:nvPr>
        </p:nvGraphicFramePr>
        <p:xfrm>
          <a:off x="3158391" y="1053953"/>
          <a:ext cx="457200" cy="457200"/>
        </p:xfrm>
        <a:graphic>
          <a:graphicData uri="http://schemas.openxmlformats.org/presentationml/2006/ole">
            <mc:AlternateContent xmlns:mc="http://schemas.openxmlformats.org/markup-compatibility/2006">
              <mc:Choice xmlns:v="urn:schemas-microsoft-com:vml" Requires="v">
                <p:oleObj spid="_x0000_s5724" name="Image" r:id="rId36" imgW="319662" imgH="325102" progId="Photoshop.Image.7">
                  <p:embed/>
                </p:oleObj>
              </mc:Choice>
              <mc:Fallback>
                <p:oleObj name="Image" r:id="rId36" imgW="319662" imgH="325102" progId="Photoshop.Image.7">
                  <p:embed/>
                  <p:pic>
                    <p:nvPicPr>
                      <p:cNvPr id="100" name="Object 98"/>
                      <p:cNvPicPr preferRelativeResize="0">
                        <a:picLocks noChangeArrowheads="1"/>
                      </p:cNvPicPr>
                      <p:nvPr/>
                    </p:nvPicPr>
                    <p:blipFill>
                      <a:blip r:embed="rId37">
                        <a:extLst>
                          <a:ext uri="{28A0092B-C50C-407E-A947-70E740481C1C}">
                            <a14:useLocalDpi xmlns:a14="http://schemas.microsoft.com/office/drawing/2010/main" val="0"/>
                          </a:ext>
                        </a:extLst>
                      </a:blip>
                      <a:srcRect/>
                      <a:stretch>
                        <a:fillRect/>
                      </a:stretch>
                    </p:blipFill>
                    <p:spPr bwMode="auto">
                      <a:xfrm>
                        <a:off x="3158391" y="1053953"/>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08" name="Object 76"/>
          <p:cNvGraphicFramePr>
            <a:graphicFrameLocks/>
          </p:cNvGraphicFramePr>
          <p:nvPr>
            <p:extLst>
              <p:ext uri="{D42A27DB-BD31-4B8C-83A1-F6EECF244321}">
                <p14:modId xmlns:p14="http://schemas.microsoft.com/office/powerpoint/2010/main" val="294091172"/>
              </p:ext>
            </p:extLst>
          </p:nvPr>
        </p:nvGraphicFramePr>
        <p:xfrm>
          <a:off x="4150822" y="1551758"/>
          <a:ext cx="457200" cy="457200"/>
        </p:xfrm>
        <a:graphic>
          <a:graphicData uri="http://schemas.openxmlformats.org/presentationml/2006/ole">
            <mc:AlternateContent xmlns:mc="http://schemas.openxmlformats.org/markup-compatibility/2006">
              <mc:Choice xmlns:v="urn:schemas-microsoft-com:vml" Requires="v">
                <p:oleObj spid="_x0000_s5725" name="Image" r:id="rId38" imgW="243724" imgH="223193" progId="Photoshop.Image.7">
                  <p:embed/>
                </p:oleObj>
              </mc:Choice>
              <mc:Fallback>
                <p:oleObj name="Image" r:id="rId38" imgW="243724" imgH="223193" progId="Photoshop.Image.7">
                  <p:embed/>
                  <p:pic>
                    <p:nvPicPr>
                      <p:cNvPr id="108" name="Object 76"/>
                      <p:cNvPicPr preferRelativeResize="0">
                        <a:picLocks noChangeArrowheads="1"/>
                      </p:cNvPicPr>
                      <p:nvPr/>
                    </p:nvPicPr>
                    <p:blipFill>
                      <a:blip r:embed="rId39">
                        <a:extLst>
                          <a:ext uri="{28A0092B-C50C-407E-A947-70E740481C1C}">
                            <a14:useLocalDpi xmlns:a14="http://schemas.microsoft.com/office/drawing/2010/main" val="0"/>
                          </a:ext>
                        </a:extLst>
                      </a:blip>
                      <a:srcRect/>
                      <a:stretch>
                        <a:fillRect/>
                      </a:stretch>
                    </p:blipFill>
                    <p:spPr bwMode="auto">
                      <a:xfrm>
                        <a:off x="4150822"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10" name="Object 85"/>
          <p:cNvGraphicFramePr>
            <a:graphicFrameLocks/>
          </p:cNvGraphicFramePr>
          <p:nvPr>
            <p:extLst>
              <p:ext uri="{D42A27DB-BD31-4B8C-83A1-F6EECF244321}">
                <p14:modId xmlns:p14="http://schemas.microsoft.com/office/powerpoint/2010/main" val="2596261412"/>
              </p:ext>
            </p:extLst>
          </p:nvPr>
        </p:nvGraphicFramePr>
        <p:xfrm>
          <a:off x="3656551" y="1551758"/>
          <a:ext cx="457200" cy="457200"/>
        </p:xfrm>
        <a:graphic>
          <a:graphicData uri="http://schemas.openxmlformats.org/presentationml/2006/ole">
            <mc:AlternateContent xmlns:mc="http://schemas.openxmlformats.org/markup-compatibility/2006">
              <mc:Choice xmlns:v="urn:schemas-microsoft-com:vml" Requires="v">
                <p:oleObj spid="_x0000_s5726" name="Image" r:id="rId40" imgW="203046" imgH="197997" progId="Photoshop.Image.7">
                  <p:embed/>
                </p:oleObj>
              </mc:Choice>
              <mc:Fallback>
                <p:oleObj name="Image" r:id="rId40" imgW="203046" imgH="197997" progId="Photoshop.Image.7">
                  <p:embed/>
                  <p:pic>
                    <p:nvPicPr>
                      <p:cNvPr id="110" name="Object 85"/>
                      <p:cNvPicPr preferRelativeResize="0">
                        <a:picLocks noChangeArrowheads="1"/>
                      </p:cNvPicPr>
                      <p:nvPr/>
                    </p:nvPicPr>
                    <p:blipFill>
                      <a:blip r:embed="rId41">
                        <a:extLst>
                          <a:ext uri="{28A0092B-C50C-407E-A947-70E740481C1C}">
                            <a14:useLocalDpi xmlns:a14="http://schemas.microsoft.com/office/drawing/2010/main" val="0"/>
                          </a:ext>
                        </a:extLst>
                      </a:blip>
                      <a:srcRect/>
                      <a:stretch>
                        <a:fillRect/>
                      </a:stretch>
                    </p:blipFill>
                    <p:spPr bwMode="auto">
                      <a:xfrm>
                        <a:off x="3656551"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16" name="Object 113"/>
          <p:cNvGraphicFramePr>
            <a:graphicFrameLocks/>
          </p:cNvGraphicFramePr>
          <p:nvPr>
            <p:extLst>
              <p:ext uri="{D42A27DB-BD31-4B8C-83A1-F6EECF244321}">
                <p14:modId xmlns:p14="http://schemas.microsoft.com/office/powerpoint/2010/main" val="2351902647"/>
              </p:ext>
            </p:extLst>
          </p:nvPr>
        </p:nvGraphicFramePr>
        <p:xfrm>
          <a:off x="4645093" y="1551758"/>
          <a:ext cx="457200" cy="457200"/>
        </p:xfrm>
        <a:graphic>
          <a:graphicData uri="http://schemas.openxmlformats.org/presentationml/2006/ole">
            <mc:AlternateContent xmlns:mc="http://schemas.openxmlformats.org/markup-compatibility/2006">
              <mc:Choice xmlns:v="urn:schemas-microsoft-com:vml" Requires="v">
                <p:oleObj spid="_x0000_s5727" name="Image" r:id="rId42" imgW="203046" imgH="218151" progId="Photoshop.Image.7">
                  <p:embed/>
                </p:oleObj>
              </mc:Choice>
              <mc:Fallback>
                <p:oleObj name="Image" r:id="rId42" imgW="203046" imgH="218151" progId="Photoshop.Image.7">
                  <p:embed/>
                  <p:pic>
                    <p:nvPicPr>
                      <p:cNvPr id="116" name="Object 113"/>
                      <p:cNvPicPr preferRelativeResize="0">
                        <a:picLocks noChangeArrowheads="1"/>
                      </p:cNvPicPr>
                      <p:nvPr/>
                    </p:nvPicPr>
                    <p:blipFill>
                      <a:blip r:embed="rId43">
                        <a:extLst>
                          <a:ext uri="{28A0092B-C50C-407E-A947-70E740481C1C}">
                            <a14:useLocalDpi xmlns:a14="http://schemas.microsoft.com/office/drawing/2010/main" val="0"/>
                          </a:ext>
                        </a:extLst>
                      </a:blip>
                      <a:srcRect/>
                      <a:stretch>
                        <a:fillRect/>
                      </a:stretch>
                    </p:blipFill>
                    <p:spPr bwMode="auto">
                      <a:xfrm>
                        <a:off x="4645093"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21" name="Object 89"/>
          <p:cNvGraphicFramePr>
            <a:graphicFrameLocks/>
          </p:cNvGraphicFramePr>
          <p:nvPr>
            <p:extLst>
              <p:ext uri="{D42A27DB-BD31-4B8C-83A1-F6EECF244321}">
                <p14:modId xmlns:p14="http://schemas.microsoft.com/office/powerpoint/2010/main" val="800913901"/>
              </p:ext>
            </p:extLst>
          </p:nvPr>
        </p:nvGraphicFramePr>
        <p:xfrm>
          <a:off x="3158391" y="1551758"/>
          <a:ext cx="457200" cy="457200"/>
        </p:xfrm>
        <a:graphic>
          <a:graphicData uri="http://schemas.openxmlformats.org/presentationml/2006/ole">
            <mc:AlternateContent xmlns:mc="http://schemas.openxmlformats.org/markup-compatibility/2006">
              <mc:Choice xmlns:v="urn:schemas-microsoft-com:vml" Requires="v">
                <p:oleObj spid="_x0000_s5728" name="Image" r:id="rId44" imgW="213108" imgH="208092" progId="Photoshop.Image.7">
                  <p:embed/>
                </p:oleObj>
              </mc:Choice>
              <mc:Fallback>
                <p:oleObj name="Image" r:id="rId44" imgW="213108" imgH="208092" progId="Photoshop.Image.7">
                  <p:embed/>
                  <p:pic>
                    <p:nvPicPr>
                      <p:cNvPr id="121" name="Object 89"/>
                      <p:cNvPicPr preferRelativeResize="0">
                        <a:picLocks noChangeArrowheads="1"/>
                      </p:cNvPicPr>
                      <p:nvPr/>
                    </p:nvPicPr>
                    <p:blipFill>
                      <a:blip r:embed="rId45">
                        <a:extLst>
                          <a:ext uri="{28A0092B-C50C-407E-A947-70E740481C1C}">
                            <a14:useLocalDpi xmlns:a14="http://schemas.microsoft.com/office/drawing/2010/main" val="0"/>
                          </a:ext>
                        </a:extLst>
                      </a:blip>
                      <a:srcRect/>
                      <a:stretch>
                        <a:fillRect/>
                      </a:stretch>
                    </p:blipFill>
                    <p:spPr bwMode="auto">
                      <a:xfrm>
                        <a:off x="3158391" y="1551758"/>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62" name="Object 34"/>
          <p:cNvGraphicFramePr>
            <a:graphicFrameLocks/>
          </p:cNvGraphicFramePr>
          <p:nvPr>
            <p:extLst>
              <p:ext uri="{D42A27DB-BD31-4B8C-83A1-F6EECF244321}">
                <p14:modId xmlns:p14="http://schemas.microsoft.com/office/powerpoint/2010/main" val="2407996967"/>
              </p:ext>
            </p:extLst>
          </p:nvPr>
        </p:nvGraphicFramePr>
        <p:xfrm>
          <a:off x="3656551" y="2048087"/>
          <a:ext cx="457200" cy="457200"/>
        </p:xfrm>
        <a:graphic>
          <a:graphicData uri="http://schemas.openxmlformats.org/presentationml/2006/ole">
            <mc:AlternateContent xmlns:mc="http://schemas.openxmlformats.org/markup-compatibility/2006">
              <mc:Choice xmlns:v="urn:schemas-microsoft-com:vml" Requires="v">
                <p:oleObj spid="_x0000_s5729" name="Image" r:id="rId46" imgW="723600" imgH="711000" progId="Photoshop.Image.7">
                  <p:embed/>
                </p:oleObj>
              </mc:Choice>
              <mc:Fallback>
                <p:oleObj name="Image" r:id="rId46" imgW="723600" imgH="711000" progId="Photoshop.Image.7">
                  <p:embed/>
                  <p:pic>
                    <p:nvPicPr>
                      <p:cNvPr id="162" name="Object 34"/>
                      <p:cNvPicPr preferRelativeResize="0">
                        <a:picLocks noChangeArrowheads="1"/>
                      </p:cNvPicPr>
                      <p:nvPr/>
                    </p:nvPicPr>
                    <p:blipFill>
                      <a:blip r:embed="rId47"/>
                      <a:srcRect/>
                      <a:stretch>
                        <a:fillRect/>
                      </a:stretch>
                    </p:blipFill>
                    <p:spPr bwMode="auto">
                      <a:xfrm>
                        <a:off x="3656551"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73" name="Object 62"/>
          <p:cNvGraphicFramePr>
            <a:graphicFrameLocks/>
          </p:cNvGraphicFramePr>
          <p:nvPr>
            <p:extLst>
              <p:ext uri="{D42A27DB-BD31-4B8C-83A1-F6EECF244321}">
                <p14:modId xmlns:p14="http://schemas.microsoft.com/office/powerpoint/2010/main" val="187222575"/>
              </p:ext>
            </p:extLst>
          </p:nvPr>
        </p:nvGraphicFramePr>
        <p:xfrm>
          <a:off x="4645093" y="2048087"/>
          <a:ext cx="457200" cy="457200"/>
        </p:xfrm>
        <a:graphic>
          <a:graphicData uri="http://schemas.openxmlformats.org/presentationml/2006/ole">
            <mc:AlternateContent xmlns:mc="http://schemas.openxmlformats.org/markup-compatibility/2006">
              <mc:Choice xmlns:v="urn:schemas-microsoft-com:vml" Requires="v">
                <p:oleObj spid="_x0000_s5730" name="Image" r:id="rId48" imgW="279345" imgH="314632" progId="Photoshop.Image.7">
                  <p:embed/>
                </p:oleObj>
              </mc:Choice>
              <mc:Fallback>
                <p:oleObj name="Image" r:id="rId48" imgW="279345" imgH="314632" progId="Photoshop.Image.7">
                  <p:embed/>
                  <p:pic>
                    <p:nvPicPr>
                      <p:cNvPr id="173" name="Object 62"/>
                      <p:cNvPicPr preferRelativeResize="0">
                        <a:picLocks noChangeArrowheads="1"/>
                      </p:cNvPicPr>
                      <p:nvPr/>
                    </p:nvPicPr>
                    <p:blipFill>
                      <a:blip r:embed="rId49">
                        <a:extLst>
                          <a:ext uri="{28A0092B-C50C-407E-A947-70E740481C1C}">
                            <a14:useLocalDpi xmlns:a14="http://schemas.microsoft.com/office/drawing/2010/main" val="0"/>
                          </a:ext>
                        </a:extLst>
                      </a:blip>
                      <a:srcRect/>
                      <a:stretch>
                        <a:fillRect/>
                      </a:stretch>
                    </p:blipFill>
                    <p:spPr bwMode="auto">
                      <a:xfrm>
                        <a:off x="4645093"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83" name="Object 118"/>
          <p:cNvGraphicFramePr>
            <a:graphicFrameLocks/>
          </p:cNvGraphicFramePr>
          <p:nvPr>
            <p:extLst>
              <p:ext uri="{D42A27DB-BD31-4B8C-83A1-F6EECF244321}">
                <p14:modId xmlns:p14="http://schemas.microsoft.com/office/powerpoint/2010/main" val="3525183428"/>
              </p:ext>
            </p:extLst>
          </p:nvPr>
        </p:nvGraphicFramePr>
        <p:xfrm>
          <a:off x="3158391" y="2048087"/>
          <a:ext cx="457200" cy="457200"/>
        </p:xfrm>
        <a:graphic>
          <a:graphicData uri="http://schemas.openxmlformats.org/presentationml/2006/ole">
            <mc:AlternateContent xmlns:mc="http://schemas.openxmlformats.org/markup-compatibility/2006">
              <mc:Choice xmlns:v="urn:schemas-microsoft-com:vml" Requires="v">
                <p:oleObj spid="_x0000_s5731" name="Image" r:id="rId50" imgW="238680" imgH="233634" progId="Photoshop.Image.7">
                  <p:embed/>
                </p:oleObj>
              </mc:Choice>
              <mc:Fallback>
                <p:oleObj name="Image" r:id="rId50" imgW="238680" imgH="233634" progId="Photoshop.Image.7">
                  <p:embed/>
                  <p:pic>
                    <p:nvPicPr>
                      <p:cNvPr id="183" name="Object 118"/>
                      <p:cNvPicPr preferRelativeResize="0">
                        <a:picLocks noChangeArrowheads="1"/>
                      </p:cNvPicPr>
                      <p:nvPr/>
                    </p:nvPicPr>
                    <p:blipFill>
                      <a:blip r:embed="rId51">
                        <a:extLst>
                          <a:ext uri="{28A0092B-C50C-407E-A947-70E740481C1C}">
                            <a14:useLocalDpi xmlns:a14="http://schemas.microsoft.com/office/drawing/2010/main" val="0"/>
                          </a:ext>
                        </a:extLst>
                      </a:blip>
                      <a:srcRect/>
                      <a:stretch>
                        <a:fillRect/>
                      </a:stretch>
                    </p:blipFill>
                    <p:spPr bwMode="auto">
                      <a:xfrm>
                        <a:off x="3158391"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84" name="Object 119"/>
          <p:cNvGraphicFramePr>
            <a:graphicFrameLocks/>
          </p:cNvGraphicFramePr>
          <p:nvPr>
            <p:extLst>
              <p:ext uri="{D42A27DB-BD31-4B8C-83A1-F6EECF244321}">
                <p14:modId xmlns:p14="http://schemas.microsoft.com/office/powerpoint/2010/main" val="1966634086"/>
              </p:ext>
            </p:extLst>
          </p:nvPr>
        </p:nvGraphicFramePr>
        <p:xfrm>
          <a:off x="4150822" y="2048087"/>
          <a:ext cx="457200" cy="457200"/>
        </p:xfrm>
        <a:graphic>
          <a:graphicData uri="http://schemas.openxmlformats.org/presentationml/2006/ole">
            <mc:AlternateContent xmlns:mc="http://schemas.openxmlformats.org/markup-compatibility/2006">
              <mc:Choice xmlns:v="urn:schemas-microsoft-com:vml" Requires="v">
                <p:oleObj spid="_x0000_s5732" name="Image" r:id="rId52" imgW="258847" imgH="238680" progId="Photoshop.Image.7">
                  <p:embed/>
                </p:oleObj>
              </mc:Choice>
              <mc:Fallback>
                <p:oleObj name="Image" r:id="rId52" imgW="258847" imgH="238680" progId="Photoshop.Image.7">
                  <p:embed/>
                  <p:pic>
                    <p:nvPicPr>
                      <p:cNvPr id="184" name="Object 119"/>
                      <p:cNvPicPr preferRelativeResize="0">
                        <a:picLocks noChangeArrowheads="1"/>
                      </p:cNvPicPr>
                      <p:nvPr/>
                    </p:nvPicPr>
                    <p:blipFill>
                      <a:blip r:embed="rId53">
                        <a:extLst>
                          <a:ext uri="{28A0092B-C50C-407E-A947-70E740481C1C}">
                            <a14:useLocalDpi xmlns:a14="http://schemas.microsoft.com/office/drawing/2010/main" val="0"/>
                          </a:ext>
                        </a:extLst>
                      </a:blip>
                      <a:srcRect/>
                      <a:stretch>
                        <a:fillRect/>
                      </a:stretch>
                    </p:blipFill>
                    <p:spPr bwMode="auto">
                      <a:xfrm>
                        <a:off x="4150822" y="2048087"/>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cxnSp>
        <p:nvCxnSpPr>
          <p:cNvPr id="6" name="Curved Connector 5"/>
          <p:cNvCxnSpPr>
            <a:stCxn id="5144" idx="1"/>
            <a:endCxn id="5143" idx="1"/>
          </p:cNvCxnSpPr>
          <p:nvPr/>
        </p:nvCxnSpPr>
        <p:spPr>
          <a:xfrm rot="10800000" flipV="1">
            <a:off x="388546" y="1314962"/>
            <a:ext cx="432202" cy="485448"/>
          </a:xfrm>
          <a:prstGeom prst="curvedConnector3">
            <a:avLst>
              <a:gd name="adj1" fmla="val 152892"/>
            </a:avLst>
          </a:prstGeom>
          <a:ln>
            <a:tailEnd type="arrow"/>
          </a:ln>
        </p:spPr>
        <p:style>
          <a:lnRef idx="1">
            <a:schemeClr val="accent1"/>
          </a:lnRef>
          <a:fillRef idx="0">
            <a:schemeClr val="accent1"/>
          </a:fillRef>
          <a:effectRef idx="0">
            <a:schemeClr val="accent1"/>
          </a:effectRef>
          <a:fontRef idx="minor">
            <a:schemeClr val="tx1"/>
          </a:fontRef>
        </p:style>
      </p:cxnSp>
      <p:sp>
        <p:nvSpPr>
          <p:cNvPr id="180" name="Text Box 39"/>
          <p:cNvSpPr txBox="1">
            <a:spLocks noChangeArrowheads="1"/>
          </p:cNvSpPr>
          <p:nvPr/>
        </p:nvSpPr>
        <p:spPr bwMode="auto">
          <a:xfrm>
            <a:off x="1391161" y="2490872"/>
            <a:ext cx="99257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aggregation</a:t>
            </a:r>
            <a:endParaRPr lang="en-US" altLang="en-US" sz="1200" dirty="0">
              <a:latin typeface="Arial" panose="020B0604020202020204" pitchFamily="34" charset="0"/>
              <a:cs typeface="Arial" panose="020B0604020202020204" pitchFamily="34" charset="0"/>
              <a:sym typeface="Symbol" pitchFamily="18" charset="2"/>
            </a:endParaRPr>
          </a:p>
        </p:txBody>
      </p:sp>
      <p:sp>
        <p:nvSpPr>
          <p:cNvPr id="181" name="Text Box 39"/>
          <p:cNvSpPr txBox="1">
            <a:spLocks noChangeArrowheads="1"/>
          </p:cNvSpPr>
          <p:nvPr/>
        </p:nvSpPr>
        <p:spPr bwMode="auto">
          <a:xfrm>
            <a:off x="3282837" y="2507355"/>
            <a:ext cx="161614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carbon source usage</a:t>
            </a:r>
            <a:endParaRPr lang="en-US" altLang="en-US" sz="1200" dirty="0">
              <a:latin typeface="Arial" panose="020B0604020202020204" pitchFamily="34" charset="0"/>
              <a:cs typeface="Arial" panose="020B0604020202020204" pitchFamily="34" charset="0"/>
              <a:sym typeface="Symbol" pitchFamily="18" charset="2"/>
            </a:endParaRPr>
          </a:p>
        </p:txBody>
      </p:sp>
      <p:sp>
        <p:nvSpPr>
          <p:cNvPr id="182" name="Text Box 39"/>
          <p:cNvSpPr txBox="1">
            <a:spLocks noChangeArrowheads="1"/>
          </p:cNvSpPr>
          <p:nvPr/>
        </p:nvSpPr>
        <p:spPr bwMode="auto">
          <a:xfrm>
            <a:off x="5143500" y="2520224"/>
            <a:ext cx="130035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adhesive growth</a:t>
            </a:r>
            <a:endParaRPr lang="en-US" altLang="en-US" sz="1200" dirty="0">
              <a:latin typeface="Arial" panose="020B0604020202020204" pitchFamily="34" charset="0"/>
              <a:cs typeface="Arial" panose="020B0604020202020204" pitchFamily="34" charset="0"/>
              <a:sym typeface="Symbol" pitchFamily="18" charset="2"/>
            </a:endParaRPr>
          </a:p>
        </p:txBody>
      </p:sp>
      <p:sp>
        <p:nvSpPr>
          <p:cNvPr id="197" name="Text Box 88"/>
          <p:cNvSpPr txBox="1">
            <a:spLocks noChangeArrowheads="1"/>
          </p:cNvSpPr>
          <p:nvPr/>
        </p:nvSpPr>
        <p:spPr bwMode="auto">
          <a:xfrm rot="18508032">
            <a:off x="1451323" y="3089909"/>
            <a:ext cx="97026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a:latin typeface="Arial" panose="020B0604020202020204" pitchFamily="34" charset="0"/>
                <a:cs typeface="Arial" panose="020B0604020202020204" pitchFamily="34" charset="0"/>
              </a:rPr>
              <a:t>galactose</a:t>
            </a:r>
          </a:p>
        </p:txBody>
      </p:sp>
      <p:graphicFrame>
        <p:nvGraphicFramePr>
          <p:cNvPr id="138" name="Object 129"/>
          <p:cNvGraphicFramePr>
            <a:graphicFrameLocks/>
          </p:cNvGraphicFramePr>
          <p:nvPr/>
        </p:nvGraphicFramePr>
        <p:xfrm>
          <a:off x="3080303" y="3637465"/>
          <a:ext cx="457200" cy="457200"/>
        </p:xfrm>
        <a:graphic>
          <a:graphicData uri="http://schemas.openxmlformats.org/presentationml/2006/ole">
            <mc:AlternateContent xmlns:mc="http://schemas.openxmlformats.org/markup-compatibility/2006">
              <mc:Choice xmlns:v="urn:schemas-microsoft-com:vml" Requires="v">
                <p:oleObj spid="_x0000_s5733" name="Image" r:id="rId54" imgW="263885" imgH="223193" progId="Photoshop.Image.7">
                  <p:embed/>
                </p:oleObj>
              </mc:Choice>
              <mc:Fallback>
                <p:oleObj name="Image" r:id="rId54" imgW="263885" imgH="223193" progId="Photoshop.Image.7">
                  <p:embed/>
                  <p:pic>
                    <p:nvPicPr>
                      <p:cNvPr id="138" name="Object 129"/>
                      <p:cNvPicPr preferRelativeResize="0">
                        <a:picLocks noChangeArrowheads="1"/>
                      </p:cNvPicPr>
                      <p:nvPr/>
                    </p:nvPicPr>
                    <p:blipFill>
                      <a:blip r:embed="rId55">
                        <a:extLst>
                          <a:ext uri="{28A0092B-C50C-407E-A947-70E740481C1C}">
                            <a14:useLocalDpi xmlns:a14="http://schemas.microsoft.com/office/drawing/2010/main" val="0"/>
                          </a:ext>
                        </a:extLst>
                      </a:blip>
                      <a:srcRect/>
                      <a:stretch>
                        <a:fillRect/>
                      </a:stretch>
                    </p:blipFill>
                    <p:spPr bwMode="auto">
                      <a:xfrm>
                        <a:off x="3080303"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39" name="Object 130"/>
          <p:cNvGraphicFramePr>
            <a:graphicFrameLocks/>
          </p:cNvGraphicFramePr>
          <p:nvPr/>
        </p:nvGraphicFramePr>
        <p:xfrm>
          <a:off x="3576440" y="3637465"/>
          <a:ext cx="457200" cy="457200"/>
        </p:xfrm>
        <a:graphic>
          <a:graphicData uri="http://schemas.openxmlformats.org/presentationml/2006/ole">
            <mc:AlternateContent xmlns:mc="http://schemas.openxmlformats.org/markup-compatibility/2006">
              <mc:Choice xmlns:v="urn:schemas-microsoft-com:vml" Requires="v">
                <p:oleObj spid="_x0000_s5734" name="Image" r:id="rId56" imgW="238680" imgH="218151" progId="Photoshop.Image.7">
                  <p:embed/>
                </p:oleObj>
              </mc:Choice>
              <mc:Fallback>
                <p:oleObj name="Image" r:id="rId56" imgW="238680" imgH="218151" progId="Photoshop.Image.7">
                  <p:embed/>
                  <p:pic>
                    <p:nvPicPr>
                      <p:cNvPr id="139" name="Object 130"/>
                      <p:cNvPicPr preferRelativeResize="0">
                        <a:picLocks noChangeArrowheads="1"/>
                      </p:cNvPicPr>
                      <p:nvPr/>
                    </p:nvPicPr>
                    <p:blipFill>
                      <a:blip r:embed="rId57">
                        <a:extLst>
                          <a:ext uri="{28A0092B-C50C-407E-A947-70E740481C1C}">
                            <a14:useLocalDpi xmlns:a14="http://schemas.microsoft.com/office/drawing/2010/main" val="0"/>
                          </a:ext>
                        </a:extLst>
                      </a:blip>
                      <a:srcRect/>
                      <a:stretch>
                        <a:fillRect/>
                      </a:stretch>
                    </p:blipFill>
                    <p:spPr bwMode="auto">
                      <a:xfrm>
                        <a:off x="3576440"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40" name="Object 131"/>
          <p:cNvGraphicFramePr>
            <a:graphicFrameLocks/>
          </p:cNvGraphicFramePr>
          <p:nvPr/>
        </p:nvGraphicFramePr>
        <p:xfrm>
          <a:off x="3080303" y="4134709"/>
          <a:ext cx="457200" cy="457200"/>
        </p:xfrm>
        <a:graphic>
          <a:graphicData uri="http://schemas.openxmlformats.org/presentationml/2006/ole">
            <mc:AlternateContent xmlns:mc="http://schemas.openxmlformats.org/markup-compatibility/2006">
              <mc:Choice xmlns:v="urn:schemas-microsoft-com:vml" Requires="v">
                <p:oleObj spid="_x0000_s5735" name="Image" r:id="rId58" imgW="192948" imgH="172443" progId="Photoshop.Image.7">
                  <p:embed/>
                </p:oleObj>
              </mc:Choice>
              <mc:Fallback>
                <p:oleObj name="Image" r:id="rId58" imgW="192948" imgH="172443" progId="Photoshop.Image.7">
                  <p:embed/>
                  <p:pic>
                    <p:nvPicPr>
                      <p:cNvPr id="140" name="Object 131"/>
                      <p:cNvPicPr preferRelativeResize="0">
                        <a:picLocks noChangeArrowheads="1"/>
                      </p:cNvPicPr>
                      <p:nvPr/>
                    </p:nvPicPr>
                    <p:blipFill>
                      <a:blip r:embed="rId59">
                        <a:extLst>
                          <a:ext uri="{28A0092B-C50C-407E-A947-70E740481C1C}">
                            <a14:useLocalDpi xmlns:a14="http://schemas.microsoft.com/office/drawing/2010/main" val="0"/>
                          </a:ext>
                        </a:extLst>
                      </a:blip>
                      <a:srcRect/>
                      <a:stretch>
                        <a:fillRect/>
                      </a:stretch>
                    </p:blipFill>
                    <p:spPr bwMode="auto">
                      <a:xfrm>
                        <a:off x="3080303"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41" name="Object 132"/>
          <p:cNvGraphicFramePr>
            <a:graphicFrameLocks/>
          </p:cNvGraphicFramePr>
          <p:nvPr/>
        </p:nvGraphicFramePr>
        <p:xfrm>
          <a:off x="3576440" y="4134709"/>
          <a:ext cx="457200" cy="457200"/>
        </p:xfrm>
        <a:graphic>
          <a:graphicData uri="http://schemas.openxmlformats.org/presentationml/2006/ole">
            <mc:AlternateContent xmlns:mc="http://schemas.openxmlformats.org/markup-compatibility/2006">
              <mc:Choice xmlns:v="urn:schemas-microsoft-com:vml" Requires="v">
                <p:oleObj spid="_x0000_s5736" name="Image" r:id="rId60" imgW="213108" imgH="238680" progId="Photoshop.Image.7">
                  <p:embed/>
                </p:oleObj>
              </mc:Choice>
              <mc:Fallback>
                <p:oleObj name="Image" r:id="rId60" imgW="213108" imgH="238680" progId="Photoshop.Image.7">
                  <p:embed/>
                  <p:pic>
                    <p:nvPicPr>
                      <p:cNvPr id="141" name="Object 132"/>
                      <p:cNvPicPr preferRelativeResize="0">
                        <a:picLocks noChangeArrowheads="1"/>
                      </p:cNvPicPr>
                      <p:nvPr/>
                    </p:nvPicPr>
                    <p:blipFill>
                      <a:blip r:embed="rId61">
                        <a:extLst>
                          <a:ext uri="{28A0092B-C50C-407E-A947-70E740481C1C}">
                            <a14:useLocalDpi xmlns:a14="http://schemas.microsoft.com/office/drawing/2010/main" val="0"/>
                          </a:ext>
                        </a:extLst>
                      </a:blip>
                      <a:srcRect/>
                      <a:stretch>
                        <a:fillRect/>
                      </a:stretch>
                    </p:blipFill>
                    <p:spPr bwMode="auto">
                      <a:xfrm>
                        <a:off x="3576440"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28" name="Object 77"/>
          <p:cNvGraphicFramePr>
            <a:graphicFrameLocks/>
          </p:cNvGraphicFramePr>
          <p:nvPr/>
        </p:nvGraphicFramePr>
        <p:xfrm>
          <a:off x="2021225" y="3637465"/>
          <a:ext cx="457200" cy="457200"/>
        </p:xfrm>
        <a:graphic>
          <a:graphicData uri="http://schemas.openxmlformats.org/presentationml/2006/ole">
            <mc:AlternateContent xmlns:mc="http://schemas.openxmlformats.org/markup-compatibility/2006">
              <mc:Choice xmlns:v="urn:schemas-microsoft-com:vml" Requires="v">
                <p:oleObj spid="_x0000_s5737" name="Image" r:id="rId62" imgW="182510" imgH="187923" progId="Photoshop.Image.7">
                  <p:embed/>
                </p:oleObj>
              </mc:Choice>
              <mc:Fallback>
                <p:oleObj name="Image" r:id="rId62" imgW="182510" imgH="187923" progId="Photoshop.Image.7">
                  <p:embed/>
                  <p:pic>
                    <p:nvPicPr>
                      <p:cNvPr id="128" name="Object 77"/>
                      <p:cNvPicPr preferRelativeResize="0">
                        <a:picLocks noChangeArrowheads="1"/>
                      </p:cNvPicPr>
                      <p:nvPr/>
                    </p:nvPicPr>
                    <p:blipFill>
                      <a:blip r:embed="rId63">
                        <a:extLst>
                          <a:ext uri="{28A0092B-C50C-407E-A947-70E740481C1C}">
                            <a14:useLocalDpi xmlns:a14="http://schemas.microsoft.com/office/drawing/2010/main" val="0"/>
                          </a:ext>
                        </a:extLst>
                      </a:blip>
                      <a:srcRect/>
                      <a:stretch>
                        <a:fillRect/>
                      </a:stretch>
                    </p:blipFill>
                    <p:spPr bwMode="auto">
                      <a:xfrm>
                        <a:off x="2021225"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29" name="Object 78"/>
          <p:cNvGraphicFramePr>
            <a:graphicFrameLocks/>
          </p:cNvGraphicFramePr>
          <p:nvPr/>
        </p:nvGraphicFramePr>
        <p:xfrm>
          <a:off x="2021225" y="4134709"/>
          <a:ext cx="457200" cy="457200"/>
        </p:xfrm>
        <a:graphic>
          <a:graphicData uri="http://schemas.openxmlformats.org/presentationml/2006/ole">
            <mc:AlternateContent xmlns:mc="http://schemas.openxmlformats.org/markup-compatibility/2006">
              <mc:Choice xmlns:v="urn:schemas-microsoft-com:vml" Requires="v">
                <p:oleObj spid="_x0000_s5738" name="Image" r:id="rId64" imgW="182510" imgH="182510" progId="Photoshop.Image.7">
                  <p:embed/>
                </p:oleObj>
              </mc:Choice>
              <mc:Fallback>
                <p:oleObj name="Image" r:id="rId64" imgW="182510" imgH="182510" progId="Photoshop.Image.7">
                  <p:embed/>
                  <p:pic>
                    <p:nvPicPr>
                      <p:cNvPr id="129" name="Object 78"/>
                      <p:cNvPicPr preferRelativeResize="0">
                        <a:picLocks noChangeArrowheads="1"/>
                      </p:cNvPicPr>
                      <p:nvPr/>
                    </p:nvPicPr>
                    <p:blipFill>
                      <a:blip r:embed="rId65">
                        <a:extLst>
                          <a:ext uri="{28A0092B-C50C-407E-A947-70E740481C1C}">
                            <a14:useLocalDpi xmlns:a14="http://schemas.microsoft.com/office/drawing/2010/main" val="0"/>
                          </a:ext>
                        </a:extLst>
                      </a:blip>
                      <a:srcRect/>
                      <a:stretch>
                        <a:fillRect/>
                      </a:stretch>
                    </p:blipFill>
                    <p:spPr bwMode="auto">
                      <a:xfrm>
                        <a:off x="2021225"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30" name="Object 86"/>
          <p:cNvGraphicFramePr>
            <a:graphicFrameLocks/>
          </p:cNvGraphicFramePr>
          <p:nvPr/>
        </p:nvGraphicFramePr>
        <p:xfrm>
          <a:off x="1526954" y="3637465"/>
          <a:ext cx="457200" cy="457200"/>
        </p:xfrm>
        <a:graphic>
          <a:graphicData uri="http://schemas.openxmlformats.org/presentationml/2006/ole">
            <mc:AlternateContent xmlns:mc="http://schemas.openxmlformats.org/markup-compatibility/2006">
              <mc:Choice xmlns:v="urn:schemas-microsoft-com:vml" Requires="v">
                <p:oleObj spid="_x0000_s5739" name="Image" r:id="rId66" imgW="238680" imgH="233634" progId="Photoshop.Image.7">
                  <p:embed/>
                </p:oleObj>
              </mc:Choice>
              <mc:Fallback>
                <p:oleObj name="Image" r:id="rId66" imgW="238680" imgH="233634" progId="Photoshop.Image.7">
                  <p:embed/>
                  <p:pic>
                    <p:nvPicPr>
                      <p:cNvPr id="130" name="Object 86"/>
                      <p:cNvPicPr preferRelativeResize="0">
                        <a:picLocks noChangeArrowheads="1"/>
                      </p:cNvPicPr>
                      <p:nvPr/>
                    </p:nvPicPr>
                    <p:blipFill>
                      <a:blip r:embed="rId67">
                        <a:extLst>
                          <a:ext uri="{28A0092B-C50C-407E-A947-70E740481C1C}">
                            <a14:useLocalDpi xmlns:a14="http://schemas.microsoft.com/office/drawing/2010/main" val="0"/>
                          </a:ext>
                        </a:extLst>
                      </a:blip>
                      <a:srcRect/>
                      <a:stretch>
                        <a:fillRect/>
                      </a:stretch>
                    </p:blipFill>
                    <p:spPr bwMode="auto">
                      <a:xfrm>
                        <a:off x="1526954"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31" name="Object 87"/>
          <p:cNvGraphicFramePr>
            <a:graphicFrameLocks/>
          </p:cNvGraphicFramePr>
          <p:nvPr/>
        </p:nvGraphicFramePr>
        <p:xfrm>
          <a:off x="1526954" y="4134709"/>
          <a:ext cx="457200" cy="457200"/>
        </p:xfrm>
        <a:graphic>
          <a:graphicData uri="http://schemas.openxmlformats.org/presentationml/2006/ole">
            <mc:AlternateContent xmlns:mc="http://schemas.openxmlformats.org/markup-compatibility/2006">
              <mc:Choice xmlns:v="urn:schemas-microsoft-com:vml" Requires="v">
                <p:oleObj spid="_x0000_s5740" name="Image" r:id="rId68" imgW="304569" imgH="284384" progId="Photoshop.Image.7">
                  <p:embed/>
                </p:oleObj>
              </mc:Choice>
              <mc:Fallback>
                <p:oleObj name="Image" r:id="rId68" imgW="304569" imgH="284384" progId="Photoshop.Image.7">
                  <p:embed/>
                  <p:pic>
                    <p:nvPicPr>
                      <p:cNvPr id="131" name="Object 87"/>
                      <p:cNvPicPr preferRelativeResize="0">
                        <a:picLocks noChangeArrowheads="1"/>
                      </p:cNvPicPr>
                      <p:nvPr/>
                    </p:nvPicPr>
                    <p:blipFill>
                      <a:blip r:embed="rId69">
                        <a:extLst>
                          <a:ext uri="{28A0092B-C50C-407E-A947-70E740481C1C}">
                            <a14:useLocalDpi xmlns:a14="http://schemas.microsoft.com/office/drawing/2010/main" val="0"/>
                          </a:ext>
                        </a:extLst>
                      </a:blip>
                      <a:srcRect/>
                      <a:stretch>
                        <a:fillRect/>
                      </a:stretch>
                    </p:blipFill>
                    <p:spPr bwMode="auto">
                      <a:xfrm>
                        <a:off x="1526954"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36" name="Object 114"/>
          <p:cNvGraphicFramePr>
            <a:graphicFrameLocks/>
          </p:cNvGraphicFramePr>
          <p:nvPr/>
        </p:nvGraphicFramePr>
        <p:xfrm>
          <a:off x="2515496" y="3637465"/>
          <a:ext cx="457200" cy="457200"/>
        </p:xfrm>
        <a:graphic>
          <a:graphicData uri="http://schemas.openxmlformats.org/presentationml/2006/ole">
            <mc:AlternateContent xmlns:mc="http://schemas.openxmlformats.org/markup-compatibility/2006">
              <mc:Choice xmlns:v="urn:schemas-microsoft-com:vml" Requires="v">
                <p:oleObj spid="_x0000_s5741" name="Image" r:id="rId70" imgW="208092" imgH="208092" progId="Photoshop.Image.7">
                  <p:embed/>
                </p:oleObj>
              </mc:Choice>
              <mc:Fallback>
                <p:oleObj name="Image" r:id="rId70" imgW="208092" imgH="208092" progId="Photoshop.Image.7">
                  <p:embed/>
                  <p:pic>
                    <p:nvPicPr>
                      <p:cNvPr id="136" name="Object 114"/>
                      <p:cNvPicPr preferRelativeResize="0">
                        <a:picLocks noChangeArrowheads="1"/>
                      </p:cNvPicPr>
                      <p:nvPr/>
                    </p:nvPicPr>
                    <p:blipFill>
                      <a:blip r:embed="rId71">
                        <a:extLst>
                          <a:ext uri="{28A0092B-C50C-407E-A947-70E740481C1C}">
                            <a14:useLocalDpi xmlns:a14="http://schemas.microsoft.com/office/drawing/2010/main" val="0"/>
                          </a:ext>
                        </a:extLst>
                      </a:blip>
                      <a:srcRect/>
                      <a:stretch>
                        <a:fillRect/>
                      </a:stretch>
                    </p:blipFill>
                    <p:spPr bwMode="auto">
                      <a:xfrm>
                        <a:off x="2515496"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37" name="Object 115"/>
          <p:cNvGraphicFramePr>
            <a:graphicFrameLocks/>
          </p:cNvGraphicFramePr>
          <p:nvPr/>
        </p:nvGraphicFramePr>
        <p:xfrm>
          <a:off x="2515496" y="4134709"/>
          <a:ext cx="457200" cy="457200"/>
        </p:xfrm>
        <a:graphic>
          <a:graphicData uri="http://schemas.openxmlformats.org/presentationml/2006/ole">
            <mc:AlternateContent xmlns:mc="http://schemas.openxmlformats.org/markup-compatibility/2006">
              <mc:Choice xmlns:v="urn:schemas-microsoft-com:vml" Requires="v">
                <p:oleObj spid="_x0000_s5742" name="Image" r:id="rId72" imgW="157316" imgH="162368" progId="Photoshop.Image.7">
                  <p:embed/>
                </p:oleObj>
              </mc:Choice>
              <mc:Fallback>
                <p:oleObj name="Image" r:id="rId72" imgW="157316" imgH="162368" progId="Photoshop.Image.7">
                  <p:embed/>
                  <p:pic>
                    <p:nvPicPr>
                      <p:cNvPr id="137" name="Object 115"/>
                      <p:cNvPicPr preferRelativeResize="0">
                        <a:picLocks noChangeArrowheads="1"/>
                      </p:cNvPicPr>
                      <p:nvPr/>
                    </p:nvPicPr>
                    <p:blipFill>
                      <a:blip r:embed="rId73">
                        <a:extLst>
                          <a:ext uri="{28A0092B-C50C-407E-A947-70E740481C1C}">
                            <a14:useLocalDpi xmlns:a14="http://schemas.microsoft.com/office/drawing/2010/main" val="0"/>
                          </a:ext>
                        </a:extLst>
                      </a:blip>
                      <a:srcRect/>
                      <a:stretch>
                        <a:fillRect/>
                      </a:stretch>
                    </p:blipFill>
                    <p:spPr bwMode="auto">
                      <a:xfrm>
                        <a:off x="2515496"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42" name="Object 70"/>
          <p:cNvGraphicFramePr>
            <a:graphicFrameLocks/>
          </p:cNvGraphicFramePr>
          <p:nvPr/>
        </p:nvGraphicFramePr>
        <p:xfrm>
          <a:off x="1028794" y="3637465"/>
          <a:ext cx="457200" cy="457200"/>
        </p:xfrm>
        <a:graphic>
          <a:graphicData uri="http://schemas.openxmlformats.org/presentationml/2006/ole">
            <mc:AlternateContent xmlns:mc="http://schemas.openxmlformats.org/markup-compatibility/2006">
              <mc:Choice xmlns:v="urn:schemas-microsoft-com:vml" Requires="v">
                <p:oleObj spid="_x0000_s5743" name="Image" r:id="rId74" imgW="233634" imgH="223193" progId="Photoshop.Image.7">
                  <p:embed/>
                </p:oleObj>
              </mc:Choice>
              <mc:Fallback>
                <p:oleObj name="Image" r:id="rId74" imgW="233634" imgH="223193" progId="Photoshop.Image.7">
                  <p:embed/>
                  <p:pic>
                    <p:nvPicPr>
                      <p:cNvPr id="142" name="Object 70"/>
                      <p:cNvPicPr preferRelativeResize="0">
                        <a:picLocks noChangeArrowheads="1"/>
                      </p:cNvPicPr>
                      <p:nvPr/>
                    </p:nvPicPr>
                    <p:blipFill>
                      <a:blip r:embed="rId75">
                        <a:extLst>
                          <a:ext uri="{28A0092B-C50C-407E-A947-70E740481C1C}">
                            <a14:useLocalDpi xmlns:a14="http://schemas.microsoft.com/office/drawing/2010/main" val="0"/>
                          </a:ext>
                        </a:extLst>
                      </a:blip>
                      <a:srcRect/>
                      <a:stretch>
                        <a:fillRect/>
                      </a:stretch>
                    </p:blipFill>
                    <p:spPr bwMode="auto">
                      <a:xfrm>
                        <a:off x="1028794" y="3637465"/>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143" name="Object 77"/>
          <p:cNvGraphicFramePr>
            <a:graphicFrameLocks/>
          </p:cNvGraphicFramePr>
          <p:nvPr/>
        </p:nvGraphicFramePr>
        <p:xfrm>
          <a:off x="1028794" y="4134709"/>
          <a:ext cx="457200" cy="457200"/>
        </p:xfrm>
        <a:graphic>
          <a:graphicData uri="http://schemas.openxmlformats.org/presentationml/2006/ole">
            <mc:AlternateContent xmlns:mc="http://schemas.openxmlformats.org/markup-compatibility/2006">
              <mc:Choice xmlns:v="urn:schemas-microsoft-com:vml" Requires="v">
                <p:oleObj spid="_x0000_s5744" name="Image" r:id="rId76" imgW="248766" imgH="238680" progId="Photoshop.Image.7">
                  <p:embed/>
                </p:oleObj>
              </mc:Choice>
              <mc:Fallback>
                <p:oleObj name="Image" r:id="rId76" imgW="248766" imgH="238680" progId="Photoshop.Image.7">
                  <p:embed/>
                  <p:pic>
                    <p:nvPicPr>
                      <p:cNvPr id="143" name="Object 77"/>
                      <p:cNvPicPr preferRelativeResize="0">
                        <a:picLocks noChangeArrowheads="1"/>
                      </p:cNvPicPr>
                      <p:nvPr/>
                    </p:nvPicPr>
                    <p:blipFill>
                      <a:blip r:embed="rId77">
                        <a:extLst>
                          <a:ext uri="{28A0092B-C50C-407E-A947-70E740481C1C}">
                            <a14:useLocalDpi xmlns:a14="http://schemas.microsoft.com/office/drawing/2010/main" val="0"/>
                          </a:ext>
                        </a:extLst>
                      </a:blip>
                      <a:srcRect/>
                      <a:stretch>
                        <a:fillRect/>
                      </a:stretch>
                    </p:blipFill>
                    <p:spPr bwMode="auto">
                      <a:xfrm>
                        <a:off x="1028794" y="4134709"/>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145" name="Text Box 64"/>
          <p:cNvSpPr txBox="1">
            <a:spLocks noChangeArrowheads="1"/>
          </p:cNvSpPr>
          <p:nvPr/>
        </p:nvSpPr>
        <p:spPr bwMode="auto">
          <a:xfrm>
            <a:off x="4371" y="3967894"/>
            <a:ext cx="6633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i="1" dirty="0">
                <a:latin typeface="Arial" panose="020B0604020202020204" pitchFamily="34" charset="0"/>
                <a:cs typeface="Arial" panose="020B0604020202020204" pitchFamily="34" charset="0"/>
              </a:rPr>
              <a:t>swi1∆</a:t>
            </a:r>
          </a:p>
        </p:txBody>
      </p:sp>
      <p:sp>
        <p:nvSpPr>
          <p:cNvPr id="147" name="Text Box 64"/>
          <p:cNvSpPr txBox="1">
            <a:spLocks noChangeArrowheads="1"/>
          </p:cNvSpPr>
          <p:nvPr/>
        </p:nvSpPr>
        <p:spPr bwMode="auto">
          <a:xfrm>
            <a:off x="485085" y="3727566"/>
            <a:ext cx="83800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i="1" dirty="0">
                <a:latin typeface="Arial" panose="020B0604020202020204" pitchFamily="34" charset="0"/>
                <a:cs typeface="Arial" panose="020B0604020202020204" pitchFamily="34" charset="0"/>
              </a:rPr>
              <a:t>SWI1</a:t>
            </a:r>
            <a:endParaRPr lang="en-US" altLang="en-US" sz="1200" i="1" dirty="0">
              <a:latin typeface="Arial" panose="020B0604020202020204" pitchFamily="34" charset="0"/>
              <a:cs typeface="Arial" panose="020B0604020202020204" pitchFamily="34" charset="0"/>
              <a:sym typeface="Symbol" pitchFamily="18" charset="2"/>
            </a:endParaRPr>
          </a:p>
        </p:txBody>
      </p:sp>
      <p:cxnSp>
        <p:nvCxnSpPr>
          <p:cNvPr id="5173" name="Straight Connector 5172"/>
          <p:cNvCxnSpPr/>
          <p:nvPr/>
        </p:nvCxnSpPr>
        <p:spPr>
          <a:xfrm flipV="1">
            <a:off x="532874" y="3751651"/>
            <a:ext cx="0" cy="703976"/>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185" name="Text Box 64"/>
          <p:cNvSpPr txBox="1">
            <a:spLocks noChangeArrowheads="1"/>
          </p:cNvSpPr>
          <p:nvPr/>
        </p:nvSpPr>
        <p:spPr bwMode="auto">
          <a:xfrm>
            <a:off x="477725" y="4224810"/>
            <a:ext cx="71750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vector</a:t>
            </a:r>
            <a:endParaRPr lang="en-US" altLang="en-US" sz="1200" dirty="0">
              <a:latin typeface="Arial" panose="020B0604020202020204" pitchFamily="34" charset="0"/>
              <a:cs typeface="Arial" panose="020B0604020202020204" pitchFamily="34" charset="0"/>
              <a:sym typeface="Symbol" pitchFamily="18" charset="2"/>
            </a:endParaRPr>
          </a:p>
        </p:txBody>
      </p:sp>
      <p:sp>
        <p:nvSpPr>
          <p:cNvPr id="192" name="Text Box 135"/>
          <p:cNvSpPr txBox="1">
            <a:spLocks noChangeArrowheads="1"/>
          </p:cNvSpPr>
          <p:nvPr/>
        </p:nvSpPr>
        <p:spPr bwMode="auto">
          <a:xfrm rot="18508032">
            <a:off x="3016793" y="3105150"/>
            <a:ext cx="104008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Calibri" pitchFamily="34" charset="0"/>
              </a:defRPr>
            </a:lvl1pPr>
            <a:lvl2pPr marL="742950" indent="-285750">
              <a:defRPr>
                <a:solidFill>
                  <a:schemeClr val="tx1"/>
                </a:solidFill>
                <a:latin typeface="Calibri" pitchFamily="34" charset="0"/>
              </a:defRPr>
            </a:lvl2pPr>
            <a:lvl3pPr marL="1143000" indent="-228600">
              <a:defRPr>
                <a:solidFill>
                  <a:schemeClr val="tx1"/>
                </a:solidFill>
                <a:latin typeface="Calibri" pitchFamily="34" charset="0"/>
              </a:defRPr>
            </a:lvl3pPr>
            <a:lvl4pPr marL="1600200" indent="-228600">
              <a:defRPr>
                <a:solidFill>
                  <a:schemeClr val="tx1"/>
                </a:solidFill>
                <a:latin typeface="Calibri" pitchFamily="34" charset="0"/>
              </a:defRPr>
            </a:lvl4pPr>
            <a:lvl5pPr marL="2057400" indent="-228600">
              <a:defRPr>
                <a:solidFill>
                  <a:schemeClr val="tx1"/>
                </a:solidFill>
                <a:latin typeface="Calibri" pitchFamily="34" charset="0"/>
              </a:defRPr>
            </a:lvl5pPr>
            <a:lvl6pPr marL="2514600" indent="-228600" eaLnBrk="0" fontAlgn="base" hangingPunct="0">
              <a:spcBef>
                <a:spcPct val="0"/>
              </a:spcBef>
              <a:spcAft>
                <a:spcPct val="0"/>
              </a:spcAft>
              <a:defRPr>
                <a:solidFill>
                  <a:schemeClr val="tx1"/>
                </a:solidFill>
                <a:latin typeface="Calibri" pitchFamily="34" charset="0"/>
              </a:defRPr>
            </a:lvl6pPr>
            <a:lvl7pPr marL="2971800" indent="-228600" eaLnBrk="0" fontAlgn="base" hangingPunct="0">
              <a:spcBef>
                <a:spcPct val="0"/>
              </a:spcBef>
              <a:spcAft>
                <a:spcPct val="0"/>
              </a:spcAft>
              <a:defRPr>
                <a:solidFill>
                  <a:schemeClr val="tx1"/>
                </a:solidFill>
                <a:latin typeface="Calibri" pitchFamily="34" charset="0"/>
              </a:defRPr>
            </a:lvl7pPr>
            <a:lvl8pPr marL="3429000" indent="-228600" eaLnBrk="0" fontAlgn="base" hangingPunct="0">
              <a:spcBef>
                <a:spcPct val="0"/>
              </a:spcBef>
              <a:spcAft>
                <a:spcPct val="0"/>
              </a:spcAft>
              <a:defRPr>
                <a:solidFill>
                  <a:schemeClr val="tx1"/>
                </a:solidFill>
                <a:latin typeface="Calibri" pitchFamily="34" charset="0"/>
              </a:defRPr>
            </a:lvl8pPr>
            <a:lvl9pPr marL="3886200" indent="-228600" eaLnBrk="0" fontAlgn="base" hangingPunct="0">
              <a:spcBef>
                <a:spcPct val="0"/>
              </a:spcBef>
              <a:spcAft>
                <a:spcPct val="0"/>
              </a:spcAft>
              <a:defRPr>
                <a:solidFill>
                  <a:schemeClr val="tx1"/>
                </a:solidFill>
                <a:latin typeface="Calibri" pitchFamily="34" charset="0"/>
              </a:defRPr>
            </a:lvl9pPr>
          </a:lstStyle>
          <a:p>
            <a:pPr eaLnBrk="1" hangingPunct="1"/>
            <a:r>
              <a:rPr lang="en-US" altLang="en-US" sz="1200" dirty="0">
                <a:latin typeface="Arial" panose="020B0604020202020204" pitchFamily="34" charset="0"/>
                <a:cs typeface="Arial" panose="020B0604020202020204" pitchFamily="34" charset="0"/>
              </a:rPr>
              <a:t>before wash</a:t>
            </a:r>
          </a:p>
        </p:txBody>
      </p:sp>
      <p:sp>
        <p:nvSpPr>
          <p:cNvPr id="193" name="Text Box 136"/>
          <p:cNvSpPr txBox="1">
            <a:spLocks noChangeArrowheads="1"/>
          </p:cNvSpPr>
          <p:nvPr/>
        </p:nvSpPr>
        <p:spPr bwMode="auto">
          <a:xfrm rot="18508032">
            <a:off x="3507240" y="3140699"/>
            <a:ext cx="89319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defRPr>
                <a:solidFill>
                  <a:schemeClr val="tx1"/>
                </a:solidFill>
                <a:latin typeface="Calibri" pitchFamily="34" charset="0"/>
              </a:defRPr>
            </a:lvl1pPr>
            <a:lvl2pPr marL="742950" indent="-285750">
              <a:defRPr>
                <a:solidFill>
                  <a:schemeClr val="tx1"/>
                </a:solidFill>
                <a:latin typeface="Calibri" pitchFamily="34" charset="0"/>
              </a:defRPr>
            </a:lvl2pPr>
            <a:lvl3pPr marL="1143000" indent="-228600">
              <a:defRPr>
                <a:solidFill>
                  <a:schemeClr val="tx1"/>
                </a:solidFill>
                <a:latin typeface="Calibri" pitchFamily="34" charset="0"/>
              </a:defRPr>
            </a:lvl3pPr>
            <a:lvl4pPr marL="1600200" indent="-228600">
              <a:defRPr>
                <a:solidFill>
                  <a:schemeClr val="tx1"/>
                </a:solidFill>
                <a:latin typeface="Calibri" pitchFamily="34" charset="0"/>
              </a:defRPr>
            </a:lvl4pPr>
            <a:lvl5pPr marL="2057400" indent="-228600">
              <a:defRPr>
                <a:solidFill>
                  <a:schemeClr val="tx1"/>
                </a:solidFill>
                <a:latin typeface="Calibri" pitchFamily="34" charset="0"/>
              </a:defRPr>
            </a:lvl5pPr>
            <a:lvl6pPr marL="2514600" indent="-228600" eaLnBrk="0" fontAlgn="base" hangingPunct="0">
              <a:spcBef>
                <a:spcPct val="0"/>
              </a:spcBef>
              <a:spcAft>
                <a:spcPct val="0"/>
              </a:spcAft>
              <a:defRPr>
                <a:solidFill>
                  <a:schemeClr val="tx1"/>
                </a:solidFill>
                <a:latin typeface="Calibri" pitchFamily="34" charset="0"/>
              </a:defRPr>
            </a:lvl6pPr>
            <a:lvl7pPr marL="2971800" indent="-228600" eaLnBrk="0" fontAlgn="base" hangingPunct="0">
              <a:spcBef>
                <a:spcPct val="0"/>
              </a:spcBef>
              <a:spcAft>
                <a:spcPct val="0"/>
              </a:spcAft>
              <a:defRPr>
                <a:solidFill>
                  <a:schemeClr val="tx1"/>
                </a:solidFill>
                <a:latin typeface="Calibri" pitchFamily="34" charset="0"/>
              </a:defRPr>
            </a:lvl7pPr>
            <a:lvl8pPr marL="3429000" indent="-228600" eaLnBrk="0" fontAlgn="base" hangingPunct="0">
              <a:spcBef>
                <a:spcPct val="0"/>
              </a:spcBef>
              <a:spcAft>
                <a:spcPct val="0"/>
              </a:spcAft>
              <a:defRPr>
                <a:solidFill>
                  <a:schemeClr val="tx1"/>
                </a:solidFill>
                <a:latin typeface="Calibri" pitchFamily="34" charset="0"/>
              </a:defRPr>
            </a:lvl8pPr>
            <a:lvl9pPr marL="3886200" indent="-228600" eaLnBrk="0" fontAlgn="base" hangingPunct="0">
              <a:spcBef>
                <a:spcPct val="0"/>
              </a:spcBef>
              <a:spcAft>
                <a:spcPct val="0"/>
              </a:spcAft>
              <a:defRPr>
                <a:solidFill>
                  <a:schemeClr val="tx1"/>
                </a:solidFill>
                <a:latin typeface="Calibri" pitchFamily="34" charset="0"/>
              </a:defRPr>
            </a:lvl9pPr>
          </a:lstStyle>
          <a:p>
            <a:pPr eaLnBrk="1" hangingPunct="1"/>
            <a:r>
              <a:rPr lang="en-US" altLang="en-US" sz="1200" dirty="0">
                <a:latin typeface="Arial" panose="020B0604020202020204" pitchFamily="34" charset="0"/>
                <a:cs typeface="Arial" panose="020B0604020202020204" pitchFamily="34" charset="0"/>
              </a:rPr>
              <a:t>after wash</a:t>
            </a:r>
          </a:p>
        </p:txBody>
      </p:sp>
      <p:sp>
        <p:nvSpPr>
          <p:cNvPr id="194" name="Text Box 79"/>
          <p:cNvSpPr txBox="1">
            <a:spLocks noChangeArrowheads="1"/>
          </p:cNvSpPr>
          <p:nvPr/>
        </p:nvSpPr>
        <p:spPr bwMode="auto">
          <a:xfrm rot="18508032">
            <a:off x="1921429" y="3131812"/>
            <a:ext cx="8213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glycerol</a:t>
            </a:r>
          </a:p>
        </p:txBody>
      </p:sp>
      <p:sp>
        <p:nvSpPr>
          <p:cNvPr id="198" name="Text Box 116"/>
          <p:cNvSpPr txBox="1">
            <a:spLocks noChangeArrowheads="1"/>
          </p:cNvSpPr>
          <p:nvPr/>
        </p:nvSpPr>
        <p:spPr bwMode="auto">
          <a:xfrm rot="18508032">
            <a:off x="2454829" y="3131812"/>
            <a:ext cx="8213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glucose</a:t>
            </a:r>
          </a:p>
        </p:txBody>
      </p:sp>
      <p:sp>
        <p:nvSpPr>
          <p:cNvPr id="199" name="Text Box 72"/>
          <p:cNvSpPr txBox="1">
            <a:spLocks noChangeArrowheads="1"/>
          </p:cNvSpPr>
          <p:nvPr/>
        </p:nvSpPr>
        <p:spPr bwMode="auto">
          <a:xfrm rot="18508032">
            <a:off x="1001227" y="3112975"/>
            <a:ext cx="88827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err="1">
                <a:latin typeface="Arial" panose="020B0604020202020204" pitchFamily="34" charset="0"/>
                <a:cs typeface="Arial" panose="020B0604020202020204" pitchFamily="34" charset="0"/>
              </a:rPr>
              <a:t>raffinose</a:t>
            </a:r>
            <a:endParaRPr lang="en-US" altLang="en-US" sz="1200" dirty="0">
              <a:latin typeface="Arial" panose="020B0604020202020204" pitchFamily="34" charset="0"/>
              <a:cs typeface="Arial" panose="020B0604020202020204" pitchFamily="34" charset="0"/>
            </a:endParaRPr>
          </a:p>
        </p:txBody>
      </p:sp>
      <p:graphicFrame>
        <p:nvGraphicFramePr>
          <p:cNvPr id="3" name="Table 2"/>
          <p:cNvGraphicFramePr>
            <a:graphicFrameLocks noGrp="1"/>
          </p:cNvGraphicFramePr>
          <p:nvPr>
            <p:extLst>
              <p:ext uri="{D42A27DB-BD31-4B8C-83A1-F6EECF244321}">
                <p14:modId xmlns:p14="http://schemas.microsoft.com/office/powerpoint/2010/main" val="3919236212"/>
              </p:ext>
            </p:extLst>
          </p:nvPr>
        </p:nvGraphicFramePr>
        <p:xfrm>
          <a:off x="290637" y="5175454"/>
          <a:ext cx="2405343" cy="1529714"/>
        </p:xfrm>
        <a:graphic>
          <a:graphicData uri="http://schemas.openxmlformats.org/drawingml/2006/table">
            <a:tbl>
              <a:tblPr>
                <a:tableStyleId>{5C22544A-7EE6-4342-B048-85BDC9FD1C3A}</a:tableStyleId>
              </a:tblPr>
              <a:tblGrid>
                <a:gridCol w="1386168">
                  <a:extLst>
                    <a:ext uri="{9D8B030D-6E8A-4147-A177-3AD203B41FA5}">
                      <a16:colId xmlns:a16="http://schemas.microsoft.com/office/drawing/2014/main" val="3783922693"/>
                    </a:ext>
                  </a:extLst>
                </a:gridCol>
                <a:gridCol w="485775">
                  <a:extLst>
                    <a:ext uri="{9D8B030D-6E8A-4147-A177-3AD203B41FA5}">
                      <a16:colId xmlns:a16="http://schemas.microsoft.com/office/drawing/2014/main" val="1147459243"/>
                    </a:ext>
                  </a:extLst>
                </a:gridCol>
                <a:gridCol w="533400">
                  <a:extLst>
                    <a:ext uri="{9D8B030D-6E8A-4147-A177-3AD203B41FA5}">
                      <a16:colId xmlns:a16="http://schemas.microsoft.com/office/drawing/2014/main" val="1577128614"/>
                    </a:ext>
                  </a:extLst>
                </a:gridCol>
              </a:tblGrid>
              <a:tr h="378432">
                <a:tc>
                  <a:txBody>
                    <a:bodyPr/>
                    <a:lstStyle/>
                    <a:p>
                      <a:pPr algn="l" fontAlgn="b"/>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00B0F0"/>
                    </a:solidFill>
                  </a:tcPr>
                </a:tc>
                <a:tc>
                  <a:txBody>
                    <a:bodyPr/>
                    <a:lstStyle/>
                    <a:p>
                      <a:pPr algn="l" fontAlgn="b"/>
                      <a:r>
                        <a:rPr lang="en-US" sz="1000" b="0" u="none" strike="noStrike" dirty="0">
                          <a:solidFill>
                            <a:schemeClr val="tx1"/>
                          </a:solidFill>
                          <a:effectLst/>
                          <a:latin typeface="Arial" panose="020B0604020202020204" pitchFamily="34" charset="0"/>
                          <a:cs typeface="Arial" panose="020B0604020202020204" pitchFamily="34" charset="0"/>
                        </a:rPr>
                        <a:t>total reads (</a:t>
                      </a:r>
                      <a:r>
                        <a:rPr lang="en-US" sz="1000" b="0" u="none" strike="noStrike" dirty="0" err="1">
                          <a:solidFill>
                            <a:schemeClr val="tx1"/>
                          </a:solidFill>
                          <a:effectLst/>
                          <a:latin typeface="Arial" panose="020B0604020202020204" pitchFamily="34" charset="0"/>
                          <a:cs typeface="Arial" panose="020B0604020202020204" pitchFamily="34" charset="0"/>
                        </a:rPr>
                        <a:t>Mr</a:t>
                      </a:r>
                      <a:r>
                        <a:rPr lang="en-US" sz="1000" b="0" u="none" strike="noStrike" dirty="0">
                          <a:solidFill>
                            <a:schemeClr val="tx1"/>
                          </a:solidFill>
                          <a:effectLst/>
                          <a:latin typeface="Arial" panose="020B0604020202020204" pitchFamily="34" charset="0"/>
                          <a:cs typeface="Arial" panose="020B0604020202020204" pitchFamily="34" charset="0"/>
                        </a:rPr>
                        <a:t>)</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00B0F0"/>
                    </a:solidFill>
                  </a:tcPr>
                </a:tc>
                <a:tc>
                  <a:txBody>
                    <a:bodyPr/>
                    <a:lstStyle/>
                    <a:p>
                      <a:pPr algn="l" fontAlgn="b"/>
                      <a:r>
                        <a:rPr lang="en-US" sz="1000" b="0" u="none" strike="noStrike" dirty="0">
                          <a:solidFill>
                            <a:schemeClr val="tx1"/>
                          </a:solidFill>
                          <a:effectLst/>
                          <a:latin typeface="Arial" panose="020B0604020202020204" pitchFamily="34" charset="0"/>
                          <a:cs typeface="Arial" panose="020B0604020202020204" pitchFamily="34" charset="0"/>
                        </a:rPr>
                        <a:t>singly mapped (%)</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00B0F0"/>
                    </a:solidFill>
                  </a:tcPr>
                </a:tc>
                <a:extLst>
                  <a:ext uri="{0D108BD9-81ED-4DB2-BD59-A6C34878D82A}">
                    <a16:rowId xmlns:a16="http://schemas.microsoft.com/office/drawing/2014/main" val="1868547172"/>
                  </a:ext>
                </a:extLst>
              </a:tr>
              <a:tr h="150912">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a:t>
                      </a:r>
                      <a:r>
                        <a:rPr lang="en-US" sz="1000" i="1" u="none" strike="noStrike" dirty="0">
                          <a:solidFill>
                            <a:schemeClr val="tx1"/>
                          </a:solidFill>
                          <a:effectLst/>
                          <a:latin typeface="Arial" panose="020B0604020202020204" pitchFamily="34" charset="0"/>
                          <a:cs typeface="Arial" panose="020B0604020202020204" pitchFamily="34" charset="0"/>
                        </a:rPr>
                        <a:t>SWI</a:t>
                      </a:r>
                      <a:r>
                        <a:rPr lang="en-US" sz="1000" i="1" u="none" strike="noStrike" baseline="30000" dirty="0">
                          <a:solidFill>
                            <a:schemeClr val="tx1"/>
                          </a:solidFill>
                          <a:effectLst/>
                          <a:latin typeface="Arial" panose="020B0604020202020204" pitchFamily="34" charset="0"/>
                          <a:cs typeface="Arial" panose="020B0604020202020204" pitchFamily="34" charset="0"/>
                        </a:rPr>
                        <a:t>+</a:t>
                      </a:r>
                      <a:r>
                        <a:rPr lang="en-US" sz="1000" u="none" strike="noStrike" dirty="0">
                          <a:solidFill>
                            <a:schemeClr val="tx1"/>
                          </a:solidFill>
                          <a:effectLst/>
                          <a:latin typeface="Arial" panose="020B0604020202020204" pitchFamily="34" charset="0"/>
                          <a:cs typeface="Arial" panose="020B0604020202020204" pitchFamily="34" charset="0"/>
                        </a:rPr>
                        <a:t>] sample 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T w="12700" cap="flat" cmpd="sng" algn="ctr">
                      <a:solidFill>
                        <a:schemeClr val="tx1"/>
                      </a:solidFill>
                      <a:prstDash val="solid"/>
                      <a:round/>
                      <a:headEnd type="none" w="med" len="med"/>
                      <a:tailEnd type="none" w="med" len="med"/>
                    </a:lnT>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8.14</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T w="12700" cap="flat" cmpd="sng" algn="ctr">
                      <a:solidFill>
                        <a:schemeClr val="tx1"/>
                      </a:solidFill>
                      <a:prstDash val="solid"/>
                      <a:round/>
                      <a:headEnd type="none" w="med" len="med"/>
                      <a:tailEnd type="none" w="med" len="med"/>
                    </a:lnT>
                    <a:solidFill>
                      <a:schemeClr val="bg1"/>
                    </a:solidFill>
                  </a:tcPr>
                </a:tc>
                <a:tc>
                  <a:txBody>
                    <a:bodyPr/>
                    <a:lstStyle/>
                    <a:p>
                      <a:pPr algn="r" fontAlgn="b"/>
                      <a:r>
                        <a:rPr lang="en-US" sz="1100" b="0" i="0" u="none" strike="noStrike" dirty="0">
                          <a:solidFill>
                            <a:srgbClr val="000000"/>
                          </a:solidFill>
                          <a:effectLst/>
                          <a:latin typeface="Calibri" panose="020F0502020204030204" pitchFamily="34" charset="0"/>
                        </a:rPr>
                        <a:t>98.7</a:t>
                      </a:r>
                    </a:p>
                  </a:txBody>
                  <a:tcPr marL="9525" marR="9525" marT="9525" marB="0" anchor="b">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3053525694"/>
                  </a:ext>
                </a:extLst>
              </a:tr>
              <a:tr h="150912">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a:t>
                      </a:r>
                      <a:r>
                        <a:rPr lang="en-US" sz="1000" i="1" u="none" strike="noStrike" dirty="0">
                          <a:solidFill>
                            <a:schemeClr val="tx1"/>
                          </a:solidFill>
                          <a:effectLst/>
                          <a:latin typeface="Arial" panose="020B0604020202020204" pitchFamily="34" charset="0"/>
                          <a:cs typeface="Arial" panose="020B0604020202020204" pitchFamily="34" charset="0"/>
                        </a:rPr>
                        <a:t>SWI</a:t>
                      </a:r>
                      <a:r>
                        <a:rPr lang="en-US" sz="1000" i="1" u="none" strike="noStrike" baseline="30000" dirty="0">
                          <a:solidFill>
                            <a:schemeClr val="tx1"/>
                          </a:solidFill>
                          <a:effectLst/>
                          <a:latin typeface="Arial" panose="020B0604020202020204" pitchFamily="34" charset="0"/>
                          <a:cs typeface="Arial" panose="020B0604020202020204" pitchFamily="34" charset="0"/>
                        </a:rPr>
                        <a:t>+</a:t>
                      </a:r>
                      <a:r>
                        <a:rPr lang="en-US" sz="1000" u="none" strike="noStrike" dirty="0">
                          <a:solidFill>
                            <a:schemeClr val="tx1"/>
                          </a:solidFill>
                          <a:effectLst/>
                          <a:latin typeface="Arial" panose="020B0604020202020204" pitchFamily="34" charset="0"/>
                          <a:cs typeface="Arial" panose="020B0604020202020204" pitchFamily="34" charset="0"/>
                        </a:rPr>
                        <a:t>] sample 2</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5.2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r" fontAlgn="b"/>
                      <a:r>
                        <a:rPr lang="en-US" sz="1100" b="0" i="0" u="none" strike="noStrike">
                          <a:solidFill>
                            <a:srgbClr val="000000"/>
                          </a:solidFill>
                          <a:effectLst/>
                          <a:latin typeface="Calibri" panose="020F0502020204030204" pitchFamily="34" charset="0"/>
                        </a:rPr>
                        <a:t>98.8</a:t>
                      </a:r>
                    </a:p>
                  </a:txBody>
                  <a:tcPr marL="9525" marR="9525" marT="9525" marB="0" anchor="b">
                    <a:solidFill>
                      <a:schemeClr val="bg1"/>
                    </a:solidFill>
                  </a:tcPr>
                </a:tc>
                <a:extLst>
                  <a:ext uri="{0D108BD9-81ED-4DB2-BD59-A6C34878D82A}">
                    <a16:rowId xmlns:a16="http://schemas.microsoft.com/office/drawing/2014/main" val="2390480127"/>
                  </a:ext>
                </a:extLst>
              </a:tr>
              <a:tr h="150912">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WT </a:t>
                      </a:r>
                      <a:r>
                        <a:rPr lang="en-US" sz="1000" u="none" strike="noStrike" dirty="0" err="1">
                          <a:solidFill>
                            <a:schemeClr val="tx1"/>
                          </a:solidFill>
                          <a:effectLst/>
                          <a:latin typeface="Arial" panose="020B0604020202020204" pitchFamily="34" charset="0"/>
                          <a:cs typeface="Arial" panose="020B0604020202020204" pitchFamily="34" charset="0"/>
                        </a:rPr>
                        <a:t>nonprion</a:t>
                      </a:r>
                      <a:r>
                        <a:rPr lang="en-US" sz="1000" u="none" strike="noStrike" dirty="0">
                          <a:solidFill>
                            <a:schemeClr val="tx1"/>
                          </a:solidFill>
                          <a:effectLst/>
                          <a:latin typeface="Arial" panose="020B0604020202020204" pitchFamily="34" charset="0"/>
                          <a:cs typeface="Arial" panose="020B0604020202020204" pitchFamily="34" charset="0"/>
                        </a:rPr>
                        <a:t> sample 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7.8</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r" fontAlgn="b"/>
                      <a:r>
                        <a:rPr lang="en-US" sz="1100" b="0" i="0" u="none" strike="noStrike">
                          <a:solidFill>
                            <a:srgbClr val="000000"/>
                          </a:solidFill>
                          <a:effectLst/>
                          <a:latin typeface="Calibri" panose="020F0502020204030204" pitchFamily="34" charset="0"/>
                        </a:rPr>
                        <a:t>99.2</a:t>
                      </a:r>
                    </a:p>
                  </a:txBody>
                  <a:tcPr marL="9525" marR="9525" marT="9525" marB="0" anchor="b">
                    <a:solidFill>
                      <a:schemeClr val="bg1"/>
                    </a:solidFill>
                  </a:tcPr>
                </a:tc>
                <a:extLst>
                  <a:ext uri="{0D108BD9-81ED-4DB2-BD59-A6C34878D82A}">
                    <a16:rowId xmlns:a16="http://schemas.microsoft.com/office/drawing/2014/main" val="1069419497"/>
                  </a:ext>
                </a:extLst>
              </a:tr>
              <a:tr h="150912">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u="none" strike="noStrike" dirty="0">
                          <a:solidFill>
                            <a:schemeClr val="tx1"/>
                          </a:solidFill>
                          <a:effectLst/>
                          <a:latin typeface="Arial" panose="020B0604020202020204" pitchFamily="34" charset="0"/>
                          <a:cs typeface="Arial" panose="020B0604020202020204" pitchFamily="34" charset="0"/>
                        </a:rPr>
                        <a:t>WT </a:t>
                      </a:r>
                      <a:r>
                        <a:rPr lang="en-US" sz="1000" u="none" strike="noStrike" dirty="0" err="1">
                          <a:solidFill>
                            <a:schemeClr val="tx1"/>
                          </a:solidFill>
                          <a:effectLst/>
                          <a:latin typeface="Arial" panose="020B0604020202020204" pitchFamily="34" charset="0"/>
                          <a:cs typeface="Arial" panose="020B0604020202020204" pitchFamily="34" charset="0"/>
                        </a:rPr>
                        <a:t>nonprion</a:t>
                      </a:r>
                      <a:r>
                        <a:rPr lang="en-US" sz="1000" u="none" strike="noStrike" dirty="0">
                          <a:solidFill>
                            <a:schemeClr val="tx1"/>
                          </a:solidFill>
                          <a:effectLst/>
                          <a:latin typeface="Arial" panose="020B0604020202020204" pitchFamily="34" charset="0"/>
                          <a:cs typeface="Arial" panose="020B0604020202020204" pitchFamily="34" charset="0"/>
                        </a:rPr>
                        <a:t> sample 2</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6.19</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r" fontAlgn="b"/>
                      <a:r>
                        <a:rPr lang="en-US" sz="1100" b="0" i="0" u="none" strike="noStrike">
                          <a:solidFill>
                            <a:srgbClr val="000000"/>
                          </a:solidFill>
                          <a:effectLst/>
                          <a:latin typeface="Calibri" panose="020F0502020204030204" pitchFamily="34" charset="0"/>
                        </a:rPr>
                        <a:t>99.2</a:t>
                      </a:r>
                    </a:p>
                  </a:txBody>
                  <a:tcPr marL="9525" marR="9525" marT="9525" marB="0" anchor="b">
                    <a:solidFill>
                      <a:schemeClr val="bg1"/>
                    </a:solidFill>
                  </a:tcPr>
                </a:tc>
                <a:extLst>
                  <a:ext uri="{0D108BD9-81ED-4DB2-BD59-A6C34878D82A}">
                    <a16:rowId xmlns:a16="http://schemas.microsoft.com/office/drawing/2014/main" val="2661509453"/>
                  </a:ext>
                </a:extLst>
              </a:tr>
              <a:tr h="150912">
                <a:tc>
                  <a:txBody>
                    <a:bodyPr/>
                    <a:lstStyle/>
                    <a:p>
                      <a:pPr algn="l" fontAlgn="b"/>
                      <a:r>
                        <a:rPr lang="en-US" sz="1000" i="1" u="none" strike="noStrike" dirty="0">
                          <a:solidFill>
                            <a:schemeClr val="tx1"/>
                          </a:solidFill>
                          <a:effectLst/>
                          <a:latin typeface="Arial" panose="020B0604020202020204" pitchFamily="34" charset="0"/>
                          <a:cs typeface="Arial" panose="020B0604020202020204" pitchFamily="34" charset="0"/>
                        </a:rPr>
                        <a:t>swi1</a:t>
                      </a:r>
                      <a:r>
                        <a:rPr lang="en-US" sz="1000" i="1" u="none" strike="noStrike" dirty="0">
                          <a:solidFill>
                            <a:schemeClr val="tx1"/>
                          </a:solidFill>
                          <a:effectLst/>
                          <a:latin typeface="Arial" panose="020B0604020202020204" pitchFamily="34" charset="0"/>
                          <a:cs typeface="Arial" panose="020B0604020202020204" pitchFamily="34" charset="0"/>
                          <a:sym typeface="Symbol" panose="05050102010706020507" pitchFamily="18" charset="2"/>
                        </a:rPr>
                        <a:t> </a:t>
                      </a:r>
                      <a:r>
                        <a:rPr lang="en-US" sz="1000" u="none" strike="noStrike" dirty="0">
                          <a:solidFill>
                            <a:schemeClr val="tx1"/>
                          </a:solidFill>
                          <a:effectLst/>
                          <a:latin typeface="Arial" panose="020B0604020202020204" pitchFamily="34" charset="0"/>
                          <a:cs typeface="Arial" panose="020B0604020202020204" pitchFamily="34" charset="0"/>
                          <a:sym typeface="Symbol" panose="05050102010706020507" pitchFamily="18" charset="2"/>
                        </a:rPr>
                        <a:t>sample 1</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7.67</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solidFill>
                      <a:schemeClr val="bg1"/>
                    </a:solidFill>
                  </a:tcPr>
                </a:tc>
                <a:tc>
                  <a:txBody>
                    <a:bodyPr/>
                    <a:lstStyle/>
                    <a:p>
                      <a:pPr algn="r" fontAlgn="b"/>
                      <a:r>
                        <a:rPr lang="en-US" sz="1100" b="0" i="0" u="none" strike="noStrike">
                          <a:solidFill>
                            <a:srgbClr val="000000"/>
                          </a:solidFill>
                          <a:effectLst/>
                          <a:latin typeface="Calibri" panose="020F0502020204030204" pitchFamily="34" charset="0"/>
                        </a:rPr>
                        <a:t>97.2</a:t>
                      </a:r>
                    </a:p>
                  </a:txBody>
                  <a:tcPr marL="9525" marR="9525" marT="9525" marB="0" anchor="b">
                    <a:solidFill>
                      <a:schemeClr val="bg1"/>
                    </a:solidFill>
                  </a:tcPr>
                </a:tc>
                <a:extLst>
                  <a:ext uri="{0D108BD9-81ED-4DB2-BD59-A6C34878D82A}">
                    <a16:rowId xmlns:a16="http://schemas.microsoft.com/office/drawing/2014/main" val="287857657"/>
                  </a:ext>
                </a:extLst>
              </a:tr>
              <a:tr h="150912">
                <a:tc>
                  <a:txBody>
                    <a:bodyPr/>
                    <a:lstStyle/>
                    <a:p>
                      <a:pPr algn="l" fontAlgn="b"/>
                      <a:r>
                        <a:rPr lang="en-US" sz="1000" i="1" u="none" strike="noStrike" dirty="0">
                          <a:solidFill>
                            <a:schemeClr val="tx1"/>
                          </a:solidFill>
                          <a:effectLst/>
                          <a:latin typeface="Arial" panose="020B0604020202020204" pitchFamily="34" charset="0"/>
                          <a:cs typeface="Arial" panose="020B0604020202020204" pitchFamily="34" charset="0"/>
                        </a:rPr>
                        <a:t>swi1</a:t>
                      </a:r>
                      <a:r>
                        <a:rPr lang="en-US" sz="1000" i="1" u="none" strike="noStrike" dirty="0">
                          <a:solidFill>
                            <a:schemeClr val="tx1"/>
                          </a:solidFill>
                          <a:effectLst/>
                          <a:latin typeface="Arial" panose="020B0604020202020204" pitchFamily="34" charset="0"/>
                          <a:cs typeface="Arial" panose="020B0604020202020204" pitchFamily="34" charset="0"/>
                          <a:sym typeface="Symbol" panose="05050102010706020507" pitchFamily="18" charset="2"/>
                        </a:rPr>
                        <a:t> </a:t>
                      </a:r>
                      <a:r>
                        <a:rPr lang="en-US" sz="1000" u="none" strike="noStrike" dirty="0">
                          <a:solidFill>
                            <a:schemeClr val="tx1"/>
                          </a:solidFill>
                          <a:effectLst/>
                          <a:latin typeface="Arial" panose="020B0604020202020204" pitchFamily="34" charset="0"/>
                          <a:cs typeface="Arial" panose="020B0604020202020204" pitchFamily="34" charset="0"/>
                          <a:sym typeface="Symbol" panose="05050102010706020507" pitchFamily="18" charset="2"/>
                        </a:rPr>
                        <a:t>sample 2</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B w="12700" cap="flat" cmpd="sng" algn="ctr">
                      <a:solidFill>
                        <a:schemeClr val="tx1"/>
                      </a:solidFill>
                      <a:prstDash val="solid"/>
                      <a:round/>
                      <a:headEnd type="none" w="med" len="med"/>
                      <a:tailEnd type="none" w="med" len="med"/>
                    </a:lnB>
                    <a:solidFill>
                      <a:schemeClr val="bg1"/>
                    </a:solidFill>
                  </a:tcPr>
                </a:tc>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17.4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525" marR="9525" marT="9524" marB="0" anchor="b">
                    <a:lnB w="12700" cap="flat" cmpd="sng" algn="ctr">
                      <a:solidFill>
                        <a:schemeClr val="tx1"/>
                      </a:solidFill>
                      <a:prstDash val="solid"/>
                      <a:round/>
                      <a:headEnd type="none" w="med" len="med"/>
                      <a:tailEnd type="none" w="med" len="med"/>
                    </a:lnB>
                    <a:solidFill>
                      <a:schemeClr val="bg1"/>
                    </a:solidFill>
                  </a:tcPr>
                </a:tc>
                <a:tc>
                  <a:txBody>
                    <a:bodyPr/>
                    <a:lstStyle/>
                    <a:p>
                      <a:pPr algn="r" fontAlgn="b"/>
                      <a:r>
                        <a:rPr lang="en-US" sz="1100" b="0" i="0" u="none" strike="noStrike" dirty="0">
                          <a:solidFill>
                            <a:srgbClr val="000000"/>
                          </a:solidFill>
                          <a:effectLst/>
                          <a:latin typeface="Calibri" panose="020F0502020204030204" pitchFamily="34" charset="0"/>
                        </a:rPr>
                        <a:t>98.7</a:t>
                      </a:r>
                    </a:p>
                  </a:txBody>
                  <a:tcPr marL="9525" marR="9525" marT="9525" marB="0" anchor="b">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64977859"/>
                  </a:ext>
                </a:extLst>
              </a:tr>
            </a:tbl>
          </a:graphicData>
        </a:graphic>
      </p:graphicFrame>
      <p:sp>
        <p:nvSpPr>
          <p:cNvPr id="81" name="Text Box 97"/>
          <p:cNvSpPr txBox="1">
            <a:spLocks noChangeArrowheads="1"/>
          </p:cNvSpPr>
          <p:nvPr/>
        </p:nvSpPr>
        <p:spPr bwMode="auto">
          <a:xfrm>
            <a:off x="238126" y="627136"/>
            <a:ext cx="26962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a</a:t>
            </a:r>
          </a:p>
        </p:txBody>
      </p:sp>
      <p:sp>
        <p:nvSpPr>
          <p:cNvPr id="84" name="Text Box 97"/>
          <p:cNvSpPr txBox="1">
            <a:spLocks noChangeArrowheads="1"/>
          </p:cNvSpPr>
          <p:nvPr/>
        </p:nvSpPr>
        <p:spPr bwMode="auto">
          <a:xfrm>
            <a:off x="253534" y="2819357"/>
            <a:ext cx="27924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b</a:t>
            </a:r>
          </a:p>
        </p:txBody>
      </p:sp>
      <p:sp>
        <p:nvSpPr>
          <p:cNvPr id="85" name="Text Box 97"/>
          <p:cNvSpPr txBox="1">
            <a:spLocks noChangeArrowheads="1"/>
          </p:cNvSpPr>
          <p:nvPr/>
        </p:nvSpPr>
        <p:spPr bwMode="auto">
          <a:xfrm>
            <a:off x="238126" y="4843628"/>
            <a:ext cx="27924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d</a:t>
            </a:r>
          </a:p>
        </p:txBody>
      </p:sp>
      <p:graphicFrame>
        <p:nvGraphicFramePr>
          <p:cNvPr id="89" name="Chart 88">
            <a:extLst>
              <a:ext uri="{FF2B5EF4-FFF2-40B4-BE49-F238E27FC236}">
                <a16:creationId xmlns:a16="http://schemas.microsoft.com/office/drawing/2014/main" id="{970ABF97-6537-457E-A5C6-1F778796BE24}"/>
              </a:ext>
            </a:extLst>
          </p:cNvPr>
          <p:cNvGraphicFramePr>
            <a:graphicFrameLocks/>
          </p:cNvGraphicFramePr>
          <p:nvPr>
            <p:extLst>
              <p:ext uri="{D42A27DB-BD31-4B8C-83A1-F6EECF244321}">
                <p14:modId xmlns:p14="http://schemas.microsoft.com/office/powerpoint/2010/main" val="2141455235"/>
              </p:ext>
            </p:extLst>
          </p:nvPr>
        </p:nvGraphicFramePr>
        <p:xfrm>
          <a:off x="3094903" y="5222599"/>
          <a:ext cx="3410632" cy="1600200"/>
        </p:xfrm>
        <a:graphic>
          <a:graphicData uri="http://schemas.openxmlformats.org/drawingml/2006/chart">
            <c:chart xmlns:c="http://schemas.openxmlformats.org/drawingml/2006/chart" xmlns:r="http://schemas.openxmlformats.org/officeDocument/2006/relationships" r:id="rId78"/>
          </a:graphicData>
        </a:graphic>
      </p:graphicFrame>
      <p:sp>
        <p:nvSpPr>
          <p:cNvPr id="90" name="TextBox 89">
            <a:extLst>
              <a:ext uri="{FF2B5EF4-FFF2-40B4-BE49-F238E27FC236}">
                <a16:creationId xmlns:a16="http://schemas.microsoft.com/office/drawing/2014/main" id="{EA6935F0-3C1C-4945-8C78-82ED447C26BE}"/>
              </a:ext>
            </a:extLst>
          </p:cNvPr>
          <p:cNvSpPr txBox="1"/>
          <p:nvPr/>
        </p:nvSpPr>
        <p:spPr>
          <a:xfrm rot="16200000">
            <a:off x="2445046" y="5627510"/>
            <a:ext cx="105349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read number</a:t>
            </a:r>
          </a:p>
        </p:txBody>
      </p:sp>
      <p:sp>
        <p:nvSpPr>
          <p:cNvPr id="96" name="Text Box 97">
            <a:extLst>
              <a:ext uri="{FF2B5EF4-FFF2-40B4-BE49-F238E27FC236}">
                <a16:creationId xmlns:a16="http://schemas.microsoft.com/office/drawing/2014/main" id="{D76EF8A4-87A0-4FF6-AE1A-4F2F6681F8AD}"/>
              </a:ext>
            </a:extLst>
          </p:cNvPr>
          <p:cNvSpPr txBox="1">
            <a:spLocks noChangeArrowheads="1"/>
          </p:cNvSpPr>
          <p:nvPr/>
        </p:nvSpPr>
        <p:spPr bwMode="auto">
          <a:xfrm>
            <a:off x="2852336" y="4874240"/>
            <a:ext cx="26962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e</a:t>
            </a:r>
          </a:p>
        </p:txBody>
      </p:sp>
      <p:grpSp>
        <p:nvGrpSpPr>
          <p:cNvPr id="5" name="Group 4">
            <a:extLst>
              <a:ext uri="{FF2B5EF4-FFF2-40B4-BE49-F238E27FC236}">
                <a16:creationId xmlns:a16="http://schemas.microsoft.com/office/drawing/2014/main" id="{583B9056-3441-4219-A52D-B88B6D008B41}"/>
              </a:ext>
            </a:extLst>
          </p:cNvPr>
          <p:cNvGrpSpPr/>
          <p:nvPr/>
        </p:nvGrpSpPr>
        <p:grpSpPr>
          <a:xfrm>
            <a:off x="4268860" y="2786422"/>
            <a:ext cx="2769857" cy="2353931"/>
            <a:chOff x="4273568" y="2820546"/>
            <a:chExt cx="2769857" cy="2353931"/>
          </a:xfrm>
        </p:grpSpPr>
        <p:graphicFrame>
          <p:nvGraphicFramePr>
            <p:cNvPr id="93" name="Chart 92">
              <a:extLst>
                <a:ext uri="{FF2B5EF4-FFF2-40B4-BE49-F238E27FC236}">
                  <a16:creationId xmlns:a16="http://schemas.microsoft.com/office/drawing/2014/main" id="{D0D3EFBE-08E4-46B8-88C0-8C99690EA685}"/>
                </a:ext>
              </a:extLst>
            </p:cNvPr>
            <p:cNvGraphicFramePr>
              <a:graphicFrameLocks/>
            </p:cNvGraphicFramePr>
            <p:nvPr/>
          </p:nvGraphicFramePr>
          <p:xfrm>
            <a:off x="4506335" y="3017360"/>
            <a:ext cx="2307118" cy="1913283"/>
          </p:xfrm>
          <a:graphic>
            <a:graphicData uri="http://schemas.openxmlformats.org/drawingml/2006/chart">
              <c:chart xmlns:c="http://schemas.openxmlformats.org/drawingml/2006/chart" xmlns:r="http://schemas.openxmlformats.org/officeDocument/2006/relationships" r:id="rId79"/>
            </a:graphicData>
          </a:graphic>
        </p:graphicFrame>
        <p:sp>
          <p:nvSpPr>
            <p:cNvPr id="212" name="Rectangle 211"/>
            <p:cNvSpPr/>
            <p:nvPr/>
          </p:nvSpPr>
          <p:spPr>
            <a:xfrm>
              <a:off x="5670994" y="3149104"/>
              <a:ext cx="1032655" cy="317716"/>
            </a:xfrm>
            <a:prstGeom prst="rect">
              <a:avLst/>
            </a:prstGeom>
          </p:spPr>
          <p:txBody>
            <a:bodyPr wrap="none">
              <a:spAutoFit/>
            </a:bodyPr>
            <a:lstStyle/>
            <a:p>
              <a:pPr algn="ctr" fontAlgn="b">
                <a:lnSpc>
                  <a:spcPct val="150000"/>
                </a:lnSpc>
              </a:pP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1 &amp; 2</a:t>
              </a:r>
              <a:endParaRPr lang="en-US" sz="1200" dirty="0">
                <a:solidFill>
                  <a:srgbClr val="000000"/>
                </a:solidFill>
                <a:latin typeface="Arial" panose="020B0604020202020204" pitchFamily="34" charset="0"/>
                <a:cs typeface="Arial" panose="020B0604020202020204" pitchFamily="34" charset="0"/>
              </a:endParaRPr>
            </a:p>
          </p:txBody>
        </p:sp>
        <p:sp>
          <p:nvSpPr>
            <p:cNvPr id="213" name="Rectangle 212"/>
            <p:cNvSpPr/>
            <p:nvPr/>
          </p:nvSpPr>
          <p:spPr>
            <a:xfrm>
              <a:off x="5251038" y="3490598"/>
              <a:ext cx="758540" cy="317716"/>
            </a:xfrm>
            <a:prstGeom prst="rect">
              <a:avLst/>
            </a:prstGeom>
          </p:spPr>
          <p:txBody>
            <a:bodyPr wrap="none">
              <a:spAutoFit/>
            </a:bodyPr>
            <a:lstStyle/>
            <a:p>
              <a:pPr algn="ctr" fontAlgn="b">
                <a:lnSpc>
                  <a:spcPct val="150000"/>
                </a:lnSpc>
              </a:pP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3</a:t>
              </a:r>
              <a:endParaRPr lang="en-US" sz="1200" dirty="0">
                <a:solidFill>
                  <a:srgbClr val="000000"/>
                </a:solidFill>
                <a:latin typeface="Arial" panose="020B0604020202020204" pitchFamily="34" charset="0"/>
                <a:cs typeface="Arial" panose="020B0604020202020204" pitchFamily="34" charset="0"/>
              </a:endParaRPr>
            </a:p>
          </p:txBody>
        </p:sp>
        <p:sp>
          <p:nvSpPr>
            <p:cNvPr id="214" name="Rectangle 213"/>
            <p:cNvSpPr/>
            <p:nvPr/>
          </p:nvSpPr>
          <p:spPr>
            <a:xfrm>
              <a:off x="5954319" y="3734892"/>
              <a:ext cx="721672" cy="276999"/>
            </a:xfrm>
            <a:prstGeom prst="rect">
              <a:avLst/>
            </a:prstGeom>
          </p:spPr>
          <p:txBody>
            <a:bodyPr wrap="none">
              <a:spAutoFit/>
            </a:bodyPr>
            <a:lstStyle/>
            <a:p>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3</a:t>
              </a:r>
              <a:endParaRPr lang="en-US" sz="1200" dirty="0">
                <a:latin typeface="Arial" panose="020B0604020202020204" pitchFamily="34" charset="0"/>
                <a:cs typeface="Arial" panose="020B0604020202020204" pitchFamily="34" charset="0"/>
              </a:endParaRPr>
            </a:p>
          </p:txBody>
        </p:sp>
        <p:sp>
          <p:nvSpPr>
            <p:cNvPr id="215" name="Rectangle 214"/>
            <p:cNvSpPr/>
            <p:nvPr/>
          </p:nvSpPr>
          <p:spPr>
            <a:xfrm>
              <a:off x="5692665" y="4284844"/>
              <a:ext cx="1039067" cy="276999"/>
            </a:xfrm>
            <a:prstGeom prst="rect">
              <a:avLst/>
            </a:prstGeom>
          </p:spPr>
          <p:txBody>
            <a:bodyPr wrap="none">
              <a:spAutoFit/>
            </a:bodyPr>
            <a:lstStyle/>
            <a:p>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1 &amp; 2</a:t>
              </a:r>
              <a:r>
                <a:rPr lang="en-US" sz="1200" dirty="0">
                  <a:latin typeface="Arial" panose="020B0604020202020204" pitchFamily="34" charset="0"/>
                  <a:cs typeface="Arial" panose="020B0604020202020204" pitchFamily="34" charset="0"/>
                  <a:sym typeface="Symbol"/>
                </a:rPr>
                <a:t> </a:t>
              </a:r>
              <a:endParaRPr lang="en-US" sz="1200" dirty="0">
                <a:latin typeface="Arial" panose="020B0604020202020204" pitchFamily="34" charset="0"/>
                <a:cs typeface="Arial" panose="020B0604020202020204" pitchFamily="34" charset="0"/>
              </a:endParaRPr>
            </a:p>
          </p:txBody>
        </p:sp>
        <p:sp>
          <p:nvSpPr>
            <p:cNvPr id="216" name="Rectangle 215"/>
            <p:cNvSpPr/>
            <p:nvPr/>
          </p:nvSpPr>
          <p:spPr>
            <a:xfrm>
              <a:off x="5014010" y="4897478"/>
              <a:ext cx="2029415" cy="276999"/>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leading </a:t>
              </a:r>
              <a:r>
                <a:rPr lang="en-US" sz="1200" dirty="0" err="1">
                  <a:latin typeface="Arial" panose="020B0604020202020204" pitchFamily="34" charset="0"/>
                  <a:cs typeface="Arial" panose="020B0604020202020204" pitchFamily="34" charset="0"/>
                </a:rPr>
                <a:t>logFC</a:t>
              </a:r>
              <a:r>
                <a:rPr lang="en-US" sz="1200" dirty="0">
                  <a:latin typeface="Arial" panose="020B0604020202020204" pitchFamily="34" charset="0"/>
                  <a:cs typeface="Arial" panose="020B0604020202020204" pitchFamily="34" charset="0"/>
                </a:rPr>
                <a:t> dim 1</a:t>
              </a:r>
            </a:p>
          </p:txBody>
        </p:sp>
        <p:sp>
          <p:nvSpPr>
            <p:cNvPr id="218" name="Rectangle 217"/>
            <p:cNvSpPr/>
            <p:nvPr/>
          </p:nvSpPr>
          <p:spPr>
            <a:xfrm>
              <a:off x="4865961" y="3934555"/>
              <a:ext cx="920445"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wt-1, 2 &amp; 3</a:t>
              </a:r>
            </a:p>
          </p:txBody>
        </p:sp>
        <p:sp>
          <p:nvSpPr>
            <p:cNvPr id="219" name="Rectangle 218"/>
            <p:cNvSpPr/>
            <p:nvPr/>
          </p:nvSpPr>
          <p:spPr>
            <a:xfrm rot="16200000">
              <a:off x="3638459" y="3679927"/>
              <a:ext cx="1547217" cy="276999"/>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leading </a:t>
              </a:r>
              <a:r>
                <a:rPr lang="en-US" sz="1200" dirty="0" err="1">
                  <a:latin typeface="Arial" panose="020B0604020202020204" pitchFamily="34" charset="0"/>
                  <a:cs typeface="Arial" panose="020B0604020202020204" pitchFamily="34" charset="0"/>
                </a:rPr>
                <a:t>logFC</a:t>
              </a:r>
              <a:r>
                <a:rPr lang="en-US" sz="1200" dirty="0">
                  <a:latin typeface="Arial" panose="020B0604020202020204" pitchFamily="34" charset="0"/>
                  <a:cs typeface="Arial" panose="020B0604020202020204" pitchFamily="34" charset="0"/>
                </a:rPr>
                <a:t> dim 2</a:t>
              </a:r>
            </a:p>
          </p:txBody>
        </p:sp>
        <p:sp>
          <p:nvSpPr>
            <p:cNvPr id="86" name="Text Box 97"/>
            <p:cNvSpPr txBox="1">
              <a:spLocks noChangeArrowheads="1"/>
            </p:cNvSpPr>
            <p:nvPr/>
          </p:nvSpPr>
          <p:spPr bwMode="auto">
            <a:xfrm>
              <a:off x="4274998" y="2820546"/>
              <a:ext cx="26962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c</a:t>
              </a:r>
            </a:p>
          </p:txBody>
        </p:sp>
        <p:sp>
          <p:nvSpPr>
            <p:cNvPr id="2" name="Oval 1">
              <a:extLst>
                <a:ext uri="{FF2B5EF4-FFF2-40B4-BE49-F238E27FC236}">
                  <a16:creationId xmlns:a16="http://schemas.microsoft.com/office/drawing/2014/main" id="{9F396349-AC78-47BE-9555-41E944FA41A0}"/>
                </a:ext>
              </a:extLst>
            </p:cNvPr>
            <p:cNvSpPr/>
            <p:nvPr/>
          </p:nvSpPr>
          <p:spPr>
            <a:xfrm>
              <a:off x="5867584" y="3166246"/>
              <a:ext cx="58213" cy="52960"/>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97" name="Oval 96">
              <a:extLst>
                <a:ext uri="{FF2B5EF4-FFF2-40B4-BE49-F238E27FC236}">
                  <a16:creationId xmlns:a16="http://schemas.microsoft.com/office/drawing/2014/main" id="{E4C3AE50-35D8-42A1-8EB7-BABEB717070C}"/>
                </a:ext>
              </a:extLst>
            </p:cNvPr>
            <p:cNvSpPr/>
            <p:nvPr/>
          </p:nvSpPr>
          <p:spPr>
            <a:xfrm>
              <a:off x="5815914" y="3202781"/>
              <a:ext cx="58213" cy="52960"/>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98" name="Oval 97">
              <a:extLst>
                <a:ext uri="{FF2B5EF4-FFF2-40B4-BE49-F238E27FC236}">
                  <a16:creationId xmlns:a16="http://schemas.microsoft.com/office/drawing/2014/main" id="{DCF57DE3-B2B1-497B-8A89-5A27CAA33A79}"/>
                </a:ext>
              </a:extLst>
            </p:cNvPr>
            <p:cNvSpPr/>
            <p:nvPr/>
          </p:nvSpPr>
          <p:spPr>
            <a:xfrm>
              <a:off x="4923131" y="3932593"/>
              <a:ext cx="58213" cy="5296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1" name="Oval 100">
              <a:extLst>
                <a:ext uri="{FF2B5EF4-FFF2-40B4-BE49-F238E27FC236}">
                  <a16:creationId xmlns:a16="http://schemas.microsoft.com/office/drawing/2014/main" id="{1BD02CCF-4B7A-4900-84F2-09E2B271312D}"/>
                </a:ext>
              </a:extLst>
            </p:cNvPr>
            <p:cNvSpPr/>
            <p:nvPr/>
          </p:nvSpPr>
          <p:spPr>
            <a:xfrm>
              <a:off x="4908619" y="3900783"/>
              <a:ext cx="58213" cy="5296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2" name="Oval 101">
              <a:extLst>
                <a:ext uri="{FF2B5EF4-FFF2-40B4-BE49-F238E27FC236}">
                  <a16:creationId xmlns:a16="http://schemas.microsoft.com/office/drawing/2014/main" id="{78678A63-D26A-4889-A014-BFAF19492B70}"/>
                </a:ext>
              </a:extLst>
            </p:cNvPr>
            <p:cNvSpPr/>
            <p:nvPr/>
          </p:nvSpPr>
          <p:spPr>
            <a:xfrm>
              <a:off x="4966832" y="3914667"/>
              <a:ext cx="58213" cy="5296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3" name="Oval 102">
              <a:extLst>
                <a:ext uri="{FF2B5EF4-FFF2-40B4-BE49-F238E27FC236}">
                  <a16:creationId xmlns:a16="http://schemas.microsoft.com/office/drawing/2014/main" id="{3EC9413D-4A35-4EC2-A409-6AD30E985017}"/>
                </a:ext>
              </a:extLst>
            </p:cNvPr>
            <p:cNvSpPr/>
            <p:nvPr/>
          </p:nvSpPr>
          <p:spPr>
            <a:xfrm>
              <a:off x="5081959" y="3758402"/>
              <a:ext cx="58213" cy="52960"/>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4" name="Oval 103">
              <a:extLst>
                <a:ext uri="{FF2B5EF4-FFF2-40B4-BE49-F238E27FC236}">
                  <a16:creationId xmlns:a16="http://schemas.microsoft.com/office/drawing/2014/main" id="{F89DB4C9-1912-4F88-A709-856DF1928FEC}"/>
                </a:ext>
              </a:extLst>
            </p:cNvPr>
            <p:cNvSpPr/>
            <p:nvPr/>
          </p:nvSpPr>
          <p:spPr>
            <a:xfrm>
              <a:off x="5879667" y="4534557"/>
              <a:ext cx="58213" cy="52960"/>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5" name="Oval 104">
              <a:extLst>
                <a:ext uri="{FF2B5EF4-FFF2-40B4-BE49-F238E27FC236}">
                  <a16:creationId xmlns:a16="http://schemas.microsoft.com/office/drawing/2014/main" id="{3459A146-49B5-41D5-B968-0719019667A6}"/>
                </a:ext>
              </a:extLst>
            </p:cNvPr>
            <p:cNvSpPr/>
            <p:nvPr/>
          </p:nvSpPr>
          <p:spPr>
            <a:xfrm>
              <a:off x="5859911" y="4582158"/>
              <a:ext cx="58213" cy="52960"/>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106" name="Oval 105">
              <a:extLst>
                <a:ext uri="{FF2B5EF4-FFF2-40B4-BE49-F238E27FC236}">
                  <a16:creationId xmlns:a16="http://schemas.microsoft.com/office/drawing/2014/main" id="{6DB980EE-B4BC-4980-BF50-0C6D8706E1D5}"/>
                </a:ext>
              </a:extLst>
            </p:cNvPr>
            <p:cNvSpPr/>
            <p:nvPr/>
          </p:nvSpPr>
          <p:spPr>
            <a:xfrm>
              <a:off x="6296019" y="3705442"/>
              <a:ext cx="58213" cy="52960"/>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grpSp>
      <p:sp>
        <p:nvSpPr>
          <p:cNvPr id="94" name="TextBox 93">
            <a:extLst>
              <a:ext uri="{FF2B5EF4-FFF2-40B4-BE49-F238E27FC236}">
                <a16:creationId xmlns:a16="http://schemas.microsoft.com/office/drawing/2014/main" id="{E6FB9CB3-1C58-47B5-9146-C5AFF67C0FB7}"/>
              </a:ext>
            </a:extLst>
          </p:cNvPr>
          <p:cNvSpPr txBox="1"/>
          <p:nvPr/>
        </p:nvSpPr>
        <p:spPr>
          <a:xfrm>
            <a:off x="124560" y="6787917"/>
            <a:ext cx="6611964" cy="2308324"/>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1</a:t>
            </a:r>
            <a:r>
              <a:rPr lang="en-US" sz="1200" dirty="0">
                <a:latin typeface="Arial" panose="020B0604020202020204" pitchFamily="34" charset="0"/>
                <a:cs typeface="Arial" panose="020B0604020202020204" pitchFamily="34" charset="0"/>
              </a:rPr>
              <a:t>. Fidelity of the RNA-seq experiments.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Three </a:t>
            </a:r>
            <a:r>
              <a:rPr lang="en-US" sz="1200" dirty="0" err="1">
                <a:latin typeface="Arial" panose="020B0604020202020204" pitchFamily="34" charset="0"/>
                <a:cs typeface="Arial" panose="020B0604020202020204" pitchFamily="34" charset="0"/>
              </a:rPr>
              <a:t>biorepeats</a:t>
            </a:r>
            <a:r>
              <a:rPr lang="en-US" sz="1200" dirty="0">
                <a:latin typeface="Arial" panose="020B0604020202020204" pitchFamily="34" charset="0"/>
                <a:cs typeface="Arial" panose="020B0604020202020204" pitchFamily="34" charset="0"/>
              </a:rPr>
              <a:t> of isogenic S288C-derived strains after repairing </a:t>
            </a:r>
            <a:r>
              <a:rPr lang="en-US" sz="1200" i="1" dirty="0">
                <a:latin typeface="Arial" panose="020B0604020202020204" pitchFamily="34" charset="0"/>
                <a:cs typeface="Arial" panose="020B0604020202020204" pitchFamily="34" charset="0"/>
              </a:rPr>
              <a:t>FLO8</a:t>
            </a:r>
            <a:r>
              <a:rPr lang="en-US" sz="1200" dirty="0">
                <a:latin typeface="Arial" panose="020B0604020202020204" pitchFamily="34" charset="0"/>
                <a:cs typeface="Arial" panose="020B0604020202020204" pitchFamily="34" charset="0"/>
              </a:rPr>
              <a:t> were verified for the aggregation state of Rnq1 and Swi1 and the ability of using non-glucose  sugars as well as the adhesive growth (see details in Methods</a:t>
            </a:r>
            <a:r>
              <a:rPr lang="en-US" sz="1200" dirty="0" smtClean="0">
                <a:latin typeface="Arial" panose="020B0604020202020204" pitchFamily="34" charset="0"/>
                <a:cs typeface="Arial" panose="020B0604020202020204" pitchFamily="34" charset="0"/>
              </a:rPr>
              <a:t>). Shown are representative images. </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For </a:t>
            </a:r>
            <a:r>
              <a:rPr lang="en-US" sz="1200" i="1" dirty="0">
                <a:latin typeface="Arial" panose="020B0604020202020204" pitchFamily="34" charset="0"/>
                <a:cs typeface="Arial" panose="020B0604020202020204" pitchFamily="34" charset="0"/>
              </a:rPr>
              <a:t>swi1∆</a:t>
            </a:r>
            <a:r>
              <a:rPr lang="en-US" sz="1200" dirty="0">
                <a:latin typeface="Arial" panose="020B0604020202020204" pitchFamily="34" charset="0"/>
                <a:cs typeface="Arial" panose="020B0604020202020204" pitchFamily="34" charset="0"/>
              </a:rPr>
              <a:t>, the strain was transformed with a </a:t>
            </a:r>
            <a:r>
              <a:rPr lang="en-US" sz="1200" i="1" dirty="0">
                <a:latin typeface="Arial" panose="020B0604020202020204" pitchFamily="34" charset="0"/>
                <a:cs typeface="Arial" panose="020B0604020202020204" pitchFamily="34" charset="0"/>
              </a:rPr>
              <a:t>SWI1</a:t>
            </a:r>
            <a:r>
              <a:rPr lang="en-US" sz="1200" dirty="0">
                <a:latin typeface="Arial" panose="020B0604020202020204" pitchFamily="34" charset="0"/>
                <a:cs typeface="Arial" panose="020B0604020202020204" pitchFamily="34" charset="0"/>
              </a:rPr>
              <a:t>-expression plasmid or an empty vector, and the carbon-usage and adhesive growth were tested to see the complementation.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A two-dimensional scaling plot generated with </a:t>
            </a:r>
            <a:r>
              <a:rPr lang="en-US" sz="1200" dirty="0" err="1">
                <a:latin typeface="Arial" panose="020B0604020202020204" pitchFamily="34" charset="0"/>
                <a:cs typeface="Arial" panose="020B0604020202020204" pitchFamily="34" charset="0"/>
              </a:rPr>
              <a:t>edgeR</a:t>
            </a:r>
            <a:r>
              <a:rPr lang="en-US" sz="1200" dirty="0">
                <a:latin typeface="Arial" panose="020B0604020202020204" pitchFamily="34" charset="0"/>
                <a:cs typeface="Arial" panose="020B0604020202020204" pitchFamily="34" charset="0"/>
              </a:rPr>
              <a:t> for the 9 </a:t>
            </a:r>
            <a:r>
              <a:rPr lang="en-US" sz="1200" dirty="0" err="1">
                <a:latin typeface="Arial" panose="020B0604020202020204" pitchFamily="34" charset="0"/>
                <a:cs typeface="Arial" panose="020B0604020202020204" pitchFamily="34" charset="0"/>
              </a:rPr>
              <a:t>biorepeats</a:t>
            </a:r>
            <a:r>
              <a:rPr lang="en-US" sz="1200" dirty="0">
                <a:latin typeface="Arial" panose="020B0604020202020204" pitchFamily="34" charset="0"/>
                <a:cs typeface="Arial" panose="020B0604020202020204" pitchFamily="34" charset="0"/>
              </a:rPr>
              <a:t>. The leading </a:t>
            </a:r>
            <a:r>
              <a:rPr lang="en-US" sz="1200" dirty="0" err="1">
                <a:latin typeface="Arial" panose="020B0604020202020204" pitchFamily="34" charset="0"/>
                <a:cs typeface="Arial" panose="020B0604020202020204" pitchFamily="34" charset="0"/>
              </a:rPr>
              <a:t>logFC</a:t>
            </a:r>
            <a:r>
              <a:rPr lang="en-US" sz="1200" dirty="0">
                <a:latin typeface="Arial" panose="020B0604020202020204" pitchFamily="34" charset="0"/>
                <a:cs typeface="Arial" panose="020B0604020202020204" pitchFamily="34" charset="0"/>
              </a:rPr>
              <a:t> is the average of the absolute </a:t>
            </a:r>
            <a:r>
              <a:rPr lang="en-US" sz="1200" dirty="0" err="1">
                <a:latin typeface="Arial" panose="020B0604020202020204" pitchFamily="34" charset="0"/>
                <a:cs typeface="Arial" panose="020B0604020202020204" pitchFamily="34" charset="0"/>
              </a:rPr>
              <a:t>logFCs</a:t>
            </a:r>
            <a:r>
              <a:rPr lang="en-US" sz="1200" dirty="0">
                <a:latin typeface="Arial" panose="020B0604020202020204" pitchFamily="34" charset="0"/>
                <a:cs typeface="Arial" panose="020B0604020202020204" pitchFamily="34" charset="0"/>
              </a:rPr>
              <a:t> for genes between two samples. The distances on the plot </a:t>
            </a:r>
            <a:r>
              <a:rPr lang="en-US" sz="1200" dirty="0" smtClean="0">
                <a:latin typeface="Arial" panose="020B0604020202020204" pitchFamily="34" charset="0"/>
                <a:cs typeface="Arial" panose="020B0604020202020204" pitchFamily="34" charset="0"/>
              </a:rPr>
              <a:t>represent </a:t>
            </a:r>
            <a:r>
              <a:rPr lang="en-US" sz="1200" dirty="0">
                <a:latin typeface="Arial" panose="020B0604020202020204" pitchFamily="34" charset="0"/>
                <a:cs typeface="Arial" panose="020B0604020202020204" pitchFamily="34" charset="0"/>
              </a:rPr>
              <a:t>the expression differences between the samples.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Numbers of the total and single-mapped RNA-seq reads. </a:t>
            </a:r>
            <a:r>
              <a:rPr lang="en-US" sz="1200" dirty="0" err="1" smtClean="0">
                <a:latin typeface="Arial" panose="020B0604020202020204" pitchFamily="34" charset="0"/>
                <a:cs typeface="Arial" panose="020B0604020202020204" pitchFamily="34" charset="0"/>
              </a:rPr>
              <a:t>Mr</a:t>
            </a:r>
            <a:r>
              <a:rPr lang="en-US" sz="1200" dirty="0" smtClean="0">
                <a:latin typeface="Arial" panose="020B0604020202020204" pitchFamily="34" charset="0"/>
                <a:cs typeface="Arial" panose="020B0604020202020204" pitchFamily="34" charset="0"/>
              </a:rPr>
              <a:t>,  million reads. (</a:t>
            </a:r>
            <a:r>
              <a:rPr lang="en-US" sz="1200" b="1" dirty="0" smtClean="0">
                <a:latin typeface="Arial" panose="020B0604020202020204" pitchFamily="34" charset="0"/>
                <a:cs typeface="Arial" panose="020B0604020202020204" pitchFamily="34" charset="0"/>
              </a:rPr>
              <a:t>e</a:t>
            </a:r>
            <a:r>
              <a:rPr lang="en-US" sz="1200" dirty="0">
                <a:latin typeface="Arial" panose="020B0604020202020204" pitchFamily="34" charset="0"/>
                <a:cs typeface="Arial" panose="020B0604020202020204" pitchFamily="34" charset="0"/>
              </a:rPr>
              <a:t>) The average reads (normalized as RPKM - reads per million divided by the length of the gene) of the three strains were assigned to each chromosome, showing that these strains have no ploidy changes.</a:t>
            </a:r>
          </a:p>
        </p:txBody>
      </p:sp>
      <p:graphicFrame>
        <p:nvGraphicFramePr>
          <p:cNvPr id="95" name="Object 27">
            <a:extLst>
              <a:ext uri="{FF2B5EF4-FFF2-40B4-BE49-F238E27FC236}">
                <a16:creationId xmlns:a16="http://schemas.microsoft.com/office/drawing/2014/main" id="{53C31891-C4E0-4262-AAAA-F5441917B9A0}"/>
              </a:ext>
            </a:extLst>
          </p:cNvPr>
          <p:cNvGraphicFramePr>
            <a:graphicFrameLocks/>
          </p:cNvGraphicFramePr>
          <p:nvPr>
            <p:extLst>
              <p:ext uri="{D42A27DB-BD31-4B8C-83A1-F6EECF244321}">
                <p14:modId xmlns:p14="http://schemas.microsoft.com/office/powerpoint/2010/main" val="1996235248"/>
              </p:ext>
            </p:extLst>
          </p:nvPr>
        </p:nvGraphicFramePr>
        <p:xfrm>
          <a:off x="2441075" y="1054542"/>
          <a:ext cx="457200" cy="457200"/>
        </p:xfrm>
        <a:graphic>
          <a:graphicData uri="http://schemas.openxmlformats.org/presentationml/2006/ole">
            <mc:AlternateContent xmlns:mc="http://schemas.openxmlformats.org/markup-compatibility/2006">
              <mc:Choice xmlns:v="urn:schemas-microsoft-com:vml" Requires="v">
                <p:oleObj spid="_x0000_s5745" name="Image" r:id="rId80" imgW="591163" imgH="530308" progId="Photoshop.Image.7">
                  <p:embed/>
                </p:oleObj>
              </mc:Choice>
              <mc:Fallback>
                <p:oleObj name="Image" r:id="rId80" imgW="591163" imgH="530308" progId="Photoshop.Image.7">
                  <p:embed/>
                  <p:pic>
                    <p:nvPicPr>
                      <p:cNvPr id="3090" name="Object 27">
                        <a:extLst>
                          <a:ext uri="{FF2B5EF4-FFF2-40B4-BE49-F238E27FC236}">
                            <a16:creationId xmlns:a16="http://schemas.microsoft.com/office/drawing/2014/main" id="{8CEE2DD3-444B-4741-B93C-515B6C90CD7D}"/>
                          </a:ext>
                        </a:extLst>
                      </p:cNvPr>
                      <p:cNvPicPr>
                        <a:picLocks noChangeArrowheads="1"/>
                      </p:cNvPicPr>
                      <p:nvPr/>
                    </p:nvPicPr>
                    <p:blipFill>
                      <a:blip r:embed="rId81">
                        <a:extLst>
                          <a:ext uri="{BEBA8EAE-BF5A-486C-A8C5-ECC9F3942E4B}">
                            <a14:imgProps xmlns:a14="http://schemas.microsoft.com/office/drawing/2010/main">
                              <a14:imgLayer r:embed="rId82">
                                <a14:imgEffect>
                                  <a14:brightnessContrast bright="24000" contrast="-15000"/>
                                </a14:imgEffect>
                              </a14:imgLayer>
                            </a14:imgProps>
                          </a:ext>
                          <a:ext uri="{28A0092B-C50C-407E-A947-70E740481C1C}">
                            <a14:useLocalDpi xmlns:a14="http://schemas.microsoft.com/office/drawing/2010/main" val="0"/>
                          </a:ext>
                        </a:extLst>
                      </a:blip>
                      <a:srcRect/>
                      <a:stretch>
                        <a:fillRect/>
                      </a:stretch>
                    </p:blipFill>
                    <p:spPr bwMode="auto">
                      <a:xfrm>
                        <a:off x="2441075" y="1054542"/>
                        <a:ext cx="4572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109" name="Text Box 47">
            <a:extLst>
              <a:ext uri="{FF2B5EF4-FFF2-40B4-BE49-F238E27FC236}">
                <a16:creationId xmlns:a16="http://schemas.microsoft.com/office/drawing/2014/main" id="{AD21E899-1B56-4DB5-95E7-8D0B38804ED6}"/>
              </a:ext>
            </a:extLst>
          </p:cNvPr>
          <p:cNvSpPr txBox="1">
            <a:spLocks noChangeArrowheads="1"/>
          </p:cNvSpPr>
          <p:nvPr/>
        </p:nvSpPr>
        <p:spPr bwMode="auto">
          <a:xfrm>
            <a:off x="2346683" y="1463735"/>
            <a:ext cx="67197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a:t>
            </a:r>
            <a:r>
              <a:rPr lang="en-US" altLang="en-US" sz="1200" i="1" dirty="0">
                <a:latin typeface="Arial" panose="020B0604020202020204" pitchFamily="34" charset="0"/>
                <a:cs typeface="Arial" panose="020B0604020202020204" pitchFamily="34" charset="0"/>
              </a:rPr>
              <a:t>RNQ</a:t>
            </a:r>
            <a:r>
              <a:rPr lang="en-US" altLang="en-US" sz="1200" i="1" baseline="30000" dirty="0">
                <a:latin typeface="Arial" panose="020B0604020202020204" pitchFamily="34" charset="0"/>
                <a:cs typeface="Arial" panose="020B0604020202020204" pitchFamily="34" charset="0"/>
              </a:rPr>
              <a:t>+</a:t>
            </a:r>
            <a:r>
              <a:rPr lang="en-US" altLang="en-US" sz="1200" dirty="0">
                <a:latin typeface="Arial" panose="020B0604020202020204" pitchFamily="34" charset="0"/>
                <a:cs typeface="Arial" panose="020B0604020202020204" pitchFamily="34" charset="0"/>
              </a:rPr>
              <a:t>]</a:t>
            </a:r>
          </a:p>
        </p:txBody>
      </p:sp>
      <p:cxnSp>
        <p:nvCxnSpPr>
          <p:cNvPr id="8" name="Straight Connector 7">
            <a:extLst>
              <a:ext uri="{FF2B5EF4-FFF2-40B4-BE49-F238E27FC236}">
                <a16:creationId xmlns:a16="http://schemas.microsoft.com/office/drawing/2014/main" id="{F34BAB93-1B33-4B73-96C8-8F97289BA887}"/>
              </a:ext>
            </a:extLst>
          </p:cNvPr>
          <p:cNvCxnSpPr/>
          <p:nvPr/>
        </p:nvCxnSpPr>
        <p:spPr>
          <a:xfrm>
            <a:off x="1933382" y="996803"/>
            <a:ext cx="945843" cy="0"/>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587356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 name="TextBox 113">
            <a:extLst>
              <a:ext uri="{FF2B5EF4-FFF2-40B4-BE49-F238E27FC236}">
                <a16:creationId xmlns:a16="http://schemas.microsoft.com/office/drawing/2014/main" id="{CF5D23CC-67A1-4FDB-AD6A-A52B5390EE3E}"/>
              </a:ext>
            </a:extLst>
          </p:cNvPr>
          <p:cNvSpPr txBox="1"/>
          <p:nvPr/>
        </p:nvSpPr>
        <p:spPr>
          <a:xfrm>
            <a:off x="357142" y="4267474"/>
            <a:ext cx="6406120"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2. </a:t>
            </a:r>
            <a:r>
              <a:rPr lang="en-US" sz="1200" dirty="0">
                <a:latin typeface="Arial" panose="020B0604020202020204" pitchFamily="34" charset="0"/>
                <a:cs typeface="Arial" panose="020B0604020202020204" pitchFamily="34" charset="0"/>
              </a:rPr>
              <a:t>Deferentially expressed genes (DEGs) of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swi1∆ </a:t>
            </a:r>
            <a:r>
              <a:rPr lang="en-US" sz="1200" dirty="0">
                <a:latin typeface="Arial" panose="020B0604020202020204" pitchFamily="34" charset="0"/>
                <a:cs typeface="Arial" panose="020B0604020202020204" pitchFamily="34" charset="0"/>
              </a:rPr>
              <a:t>strains compared to the </a:t>
            </a:r>
            <a:r>
              <a:rPr lang="en-US" sz="1200" dirty="0" err="1">
                <a:latin typeface="Arial" panose="020B0604020202020204" pitchFamily="34" charset="0"/>
                <a:cs typeface="Arial" panose="020B0604020202020204" pitchFamily="34" charset="0"/>
              </a:rPr>
              <a:t>nonprion</a:t>
            </a:r>
            <a:r>
              <a:rPr lang="en-US" sz="1200" dirty="0">
                <a:latin typeface="Arial" panose="020B0604020202020204" pitchFamily="34" charset="0"/>
                <a:cs typeface="Arial" panose="020B0604020202020204" pitchFamily="34" charset="0"/>
              </a:rPr>
              <a:t> wild-type strain (</a:t>
            </a:r>
            <a:r>
              <a:rPr lang="en-US" sz="1200" i="1" dirty="0" err="1">
                <a:latin typeface="Arial" panose="020B0604020202020204" pitchFamily="34" charset="0"/>
                <a:cs typeface="Arial" panose="020B0604020202020204" pitchFamily="34" charset="0"/>
              </a:rPr>
              <a:t>wt</a:t>
            </a:r>
            <a:r>
              <a:rPr lang="en-US" sz="1200" dirty="0">
                <a:latin typeface="Arial" panose="020B0604020202020204" pitchFamily="34" charset="0"/>
                <a:cs typeface="Arial" panose="020B0604020202020204" pitchFamily="34" charset="0"/>
              </a:rPr>
              <a:t>). The c</a:t>
            </a:r>
            <a:r>
              <a:rPr lang="en-US" altLang="en-US" sz="1200" dirty="0">
                <a:latin typeface="Arial" panose="020B0604020202020204" pitchFamily="34" charset="0"/>
              </a:rPr>
              <a:t>ut off for DEGs is Adj. p-value&lt;0.001 and |log2 (FC)|&gt;1. </a:t>
            </a:r>
            <a:r>
              <a:rPr lang="en-US" altLang="en-US" sz="1200" i="1" dirty="0">
                <a:latin typeface="Arial" panose="020B0604020202020204" pitchFamily="34" charset="0"/>
              </a:rPr>
              <a:t>FLO1</a:t>
            </a:r>
            <a:r>
              <a:rPr lang="en-US" altLang="en-US" sz="1200" dirty="0">
                <a:latin typeface="Arial" panose="020B0604020202020204" pitchFamily="34" charset="0"/>
              </a:rPr>
              <a:t> and </a:t>
            </a:r>
            <a:r>
              <a:rPr lang="en-US" altLang="en-US" sz="1200" i="1" dirty="0">
                <a:latin typeface="Arial" panose="020B0604020202020204" pitchFamily="34" charset="0"/>
              </a:rPr>
              <a:t>FLO11</a:t>
            </a:r>
            <a:r>
              <a:rPr lang="en-US" altLang="en-US" sz="1200" dirty="0">
                <a:latin typeface="Arial" panose="020B0604020202020204" pitchFamily="34" charset="0"/>
              </a:rPr>
              <a:t>, two genes that have previously shown being inhibited by both</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swi1∆ </a:t>
            </a:r>
            <a:r>
              <a:rPr lang="en-US" sz="1200" dirty="0">
                <a:latin typeface="Arial" panose="020B0604020202020204" pitchFamily="34" charset="0"/>
                <a:cs typeface="Arial" panose="020B0604020202020204" pitchFamily="34" charset="0"/>
              </a:rPr>
              <a:t>are circled. FC, fold change; CPM, counts per million. </a:t>
            </a:r>
          </a:p>
        </p:txBody>
      </p:sp>
      <p:grpSp>
        <p:nvGrpSpPr>
          <p:cNvPr id="9" name="Group 8">
            <a:extLst>
              <a:ext uri="{FF2B5EF4-FFF2-40B4-BE49-F238E27FC236}">
                <a16:creationId xmlns:a16="http://schemas.microsoft.com/office/drawing/2014/main" id="{C452A6D0-AA0C-4095-AC5E-E906B3FD8028}"/>
              </a:ext>
            </a:extLst>
          </p:cNvPr>
          <p:cNvGrpSpPr/>
          <p:nvPr/>
        </p:nvGrpSpPr>
        <p:grpSpPr>
          <a:xfrm>
            <a:off x="59560" y="783969"/>
            <a:ext cx="3265359" cy="3212290"/>
            <a:chOff x="59560" y="783969"/>
            <a:chExt cx="3265359" cy="3212290"/>
          </a:xfrm>
        </p:grpSpPr>
        <p:pic>
          <p:nvPicPr>
            <p:cNvPr id="66628" name="Picture 7"/>
            <p:cNvPicPr preferRelativeResize="0">
              <a:picLocks noChangeArrowheads="1"/>
            </p:cNvPicPr>
            <p:nvPr/>
          </p:nvPicPr>
          <p:blipFill>
            <a:blip r:embed="rId3">
              <a:extLst>
                <a:ext uri="{28A0092B-C50C-407E-A947-70E740481C1C}">
                  <a14:useLocalDpi xmlns:a14="http://schemas.microsoft.com/office/drawing/2010/main" val="0"/>
                </a:ext>
              </a:extLst>
            </a:blip>
            <a:srcRect l="4733" b="4880"/>
            <a:stretch>
              <a:fillRect/>
            </a:stretch>
          </p:blipFill>
          <p:spPr bwMode="auto">
            <a:xfrm>
              <a:off x="357142" y="1049066"/>
              <a:ext cx="2957243" cy="26635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6629" name="TextBox 26"/>
            <p:cNvSpPr txBox="1">
              <a:spLocks noChangeArrowheads="1"/>
            </p:cNvSpPr>
            <p:nvPr/>
          </p:nvSpPr>
          <p:spPr bwMode="auto">
            <a:xfrm rot="10800000">
              <a:off x="192124" y="1287421"/>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2</a:t>
              </a:r>
            </a:p>
          </p:txBody>
        </p:sp>
        <p:sp>
          <p:nvSpPr>
            <p:cNvPr id="66630" name="TextBox 27"/>
            <p:cNvSpPr txBox="1">
              <a:spLocks noChangeArrowheads="1"/>
            </p:cNvSpPr>
            <p:nvPr/>
          </p:nvSpPr>
          <p:spPr bwMode="auto">
            <a:xfrm rot="10800000">
              <a:off x="192124" y="1710768"/>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0</a:t>
              </a:r>
            </a:p>
          </p:txBody>
        </p:sp>
        <p:sp>
          <p:nvSpPr>
            <p:cNvPr id="66631" name="TextBox 28"/>
            <p:cNvSpPr txBox="1">
              <a:spLocks noChangeArrowheads="1"/>
            </p:cNvSpPr>
            <p:nvPr/>
          </p:nvSpPr>
          <p:spPr bwMode="auto">
            <a:xfrm rot="10800000">
              <a:off x="192124" y="2528859"/>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4</a:t>
              </a:r>
            </a:p>
          </p:txBody>
        </p:sp>
        <p:sp>
          <p:nvSpPr>
            <p:cNvPr id="66632" name="TextBox 29"/>
            <p:cNvSpPr txBox="1">
              <a:spLocks noChangeArrowheads="1"/>
            </p:cNvSpPr>
            <p:nvPr/>
          </p:nvSpPr>
          <p:spPr bwMode="auto">
            <a:xfrm rot="10800000">
              <a:off x="192124" y="2935961"/>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6</a:t>
              </a:r>
            </a:p>
          </p:txBody>
        </p:sp>
        <p:sp>
          <p:nvSpPr>
            <p:cNvPr id="66633" name="TextBox 30"/>
            <p:cNvSpPr txBox="1">
              <a:spLocks noChangeArrowheads="1"/>
            </p:cNvSpPr>
            <p:nvPr/>
          </p:nvSpPr>
          <p:spPr bwMode="auto">
            <a:xfrm rot="10800000">
              <a:off x="192124" y="3354202"/>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8</a:t>
              </a:r>
            </a:p>
          </p:txBody>
        </p:sp>
        <p:sp>
          <p:nvSpPr>
            <p:cNvPr id="66634" name="TextBox 31"/>
            <p:cNvSpPr txBox="1">
              <a:spLocks noChangeArrowheads="1"/>
            </p:cNvSpPr>
            <p:nvPr/>
          </p:nvSpPr>
          <p:spPr bwMode="auto">
            <a:xfrm rot="10800000">
              <a:off x="192124" y="2108762"/>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2</a:t>
              </a:r>
            </a:p>
          </p:txBody>
        </p:sp>
        <p:sp>
          <p:nvSpPr>
            <p:cNvPr id="66635" name="TextBox 2"/>
            <p:cNvSpPr txBox="1">
              <a:spLocks noChangeArrowheads="1"/>
            </p:cNvSpPr>
            <p:nvPr/>
          </p:nvSpPr>
          <p:spPr bwMode="auto">
            <a:xfrm>
              <a:off x="500142" y="3592551"/>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0</a:t>
              </a:r>
            </a:p>
          </p:txBody>
        </p:sp>
        <p:sp>
          <p:nvSpPr>
            <p:cNvPr id="66636" name="TextBox 33"/>
            <p:cNvSpPr txBox="1">
              <a:spLocks noChangeArrowheads="1"/>
            </p:cNvSpPr>
            <p:nvPr/>
          </p:nvSpPr>
          <p:spPr bwMode="auto">
            <a:xfrm>
              <a:off x="916395" y="3592551"/>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2</a:t>
              </a:r>
            </a:p>
          </p:txBody>
        </p:sp>
        <p:sp>
          <p:nvSpPr>
            <p:cNvPr id="66637" name="TextBox 34"/>
            <p:cNvSpPr txBox="1">
              <a:spLocks noChangeArrowheads="1"/>
            </p:cNvSpPr>
            <p:nvPr/>
          </p:nvSpPr>
          <p:spPr bwMode="auto">
            <a:xfrm>
              <a:off x="1332647" y="3592551"/>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4</a:t>
              </a:r>
            </a:p>
          </p:txBody>
        </p:sp>
        <p:sp>
          <p:nvSpPr>
            <p:cNvPr id="66638" name="TextBox 35"/>
            <p:cNvSpPr txBox="1">
              <a:spLocks noChangeArrowheads="1"/>
            </p:cNvSpPr>
            <p:nvPr/>
          </p:nvSpPr>
          <p:spPr bwMode="auto">
            <a:xfrm>
              <a:off x="1760926" y="3592551"/>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6</a:t>
              </a:r>
            </a:p>
          </p:txBody>
        </p:sp>
        <p:sp>
          <p:nvSpPr>
            <p:cNvPr id="66639" name="TextBox 36"/>
            <p:cNvSpPr txBox="1">
              <a:spLocks noChangeArrowheads="1"/>
            </p:cNvSpPr>
            <p:nvPr/>
          </p:nvSpPr>
          <p:spPr bwMode="auto">
            <a:xfrm>
              <a:off x="2176252" y="3592551"/>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8</a:t>
              </a:r>
            </a:p>
          </p:txBody>
        </p:sp>
        <p:sp>
          <p:nvSpPr>
            <p:cNvPr id="66640" name="TextBox 37"/>
            <p:cNvSpPr txBox="1">
              <a:spLocks noChangeArrowheads="1"/>
            </p:cNvSpPr>
            <p:nvPr/>
          </p:nvSpPr>
          <p:spPr bwMode="auto">
            <a:xfrm>
              <a:off x="2570303" y="3592551"/>
              <a:ext cx="32573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10</a:t>
              </a:r>
            </a:p>
          </p:txBody>
        </p:sp>
        <p:sp>
          <p:nvSpPr>
            <p:cNvPr id="66641" name="TextBox 38"/>
            <p:cNvSpPr txBox="1">
              <a:spLocks noChangeArrowheads="1"/>
            </p:cNvSpPr>
            <p:nvPr/>
          </p:nvSpPr>
          <p:spPr bwMode="auto">
            <a:xfrm>
              <a:off x="2986557" y="3592551"/>
              <a:ext cx="32573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12</a:t>
              </a:r>
            </a:p>
          </p:txBody>
        </p:sp>
        <p:sp>
          <p:nvSpPr>
            <p:cNvPr id="66642" name="TextBox 59"/>
            <p:cNvSpPr txBox="1">
              <a:spLocks noChangeArrowheads="1"/>
            </p:cNvSpPr>
            <p:nvPr/>
          </p:nvSpPr>
          <p:spPr bwMode="auto">
            <a:xfrm>
              <a:off x="2208010" y="3328635"/>
              <a:ext cx="77777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dirty="0">
                  <a:latin typeface="Arial" panose="020B0604020202020204" pitchFamily="34" charset="0"/>
                  <a:cs typeface="Arial" panose="020B0604020202020204" pitchFamily="34" charset="0"/>
                </a:rPr>
                <a:t>287 genes</a:t>
              </a:r>
            </a:p>
          </p:txBody>
        </p:sp>
        <p:sp>
          <p:nvSpPr>
            <p:cNvPr id="66643" name="TextBox 60"/>
            <p:cNvSpPr txBox="1">
              <a:spLocks noChangeArrowheads="1"/>
            </p:cNvSpPr>
            <p:nvPr/>
          </p:nvSpPr>
          <p:spPr bwMode="auto">
            <a:xfrm>
              <a:off x="2205911" y="3440471"/>
              <a:ext cx="77777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dirty="0">
                  <a:latin typeface="Arial" panose="020B0604020202020204" pitchFamily="34" charset="0"/>
                  <a:cs typeface="Arial" panose="020B0604020202020204" pitchFamily="34" charset="0"/>
                </a:rPr>
                <a:t>495 genes</a:t>
              </a:r>
            </a:p>
          </p:txBody>
        </p:sp>
        <p:sp>
          <p:nvSpPr>
            <p:cNvPr id="66644" name="TextBox 66"/>
            <p:cNvSpPr txBox="1">
              <a:spLocks noChangeArrowheads="1"/>
            </p:cNvSpPr>
            <p:nvPr/>
          </p:nvSpPr>
          <p:spPr bwMode="auto">
            <a:xfrm>
              <a:off x="1424205" y="3719260"/>
              <a:ext cx="111639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log2 (CPM)</a:t>
              </a:r>
            </a:p>
          </p:txBody>
        </p:sp>
        <p:sp>
          <p:nvSpPr>
            <p:cNvPr id="66645" name="TextBox 67"/>
            <p:cNvSpPr txBox="1">
              <a:spLocks noChangeArrowheads="1"/>
            </p:cNvSpPr>
            <p:nvPr/>
          </p:nvSpPr>
          <p:spPr bwMode="auto">
            <a:xfrm rot="16200000">
              <a:off x="-328640" y="2064163"/>
              <a:ext cx="105339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i="1" dirty="0">
                  <a:latin typeface="Arial" panose="020B0604020202020204" pitchFamily="34" charset="0"/>
                  <a:cs typeface="Arial" panose="020B0604020202020204" pitchFamily="34" charset="0"/>
                </a:rPr>
                <a:t>log2 (FC)</a:t>
              </a:r>
            </a:p>
          </p:txBody>
        </p:sp>
        <p:sp>
          <p:nvSpPr>
            <p:cNvPr id="66646" name="Rectangle 4"/>
            <p:cNvSpPr>
              <a:spLocks noChangeArrowheads="1"/>
            </p:cNvSpPr>
            <p:nvPr/>
          </p:nvSpPr>
          <p:spPr bwMode="auto">
            <a:xfrm>
              <a:off x="1597274" y="1023276"/>
              <a:ext cx="51809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SFG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47" name="Rectangle 24"/>
            <p:cNvSpPr>
              <a:spLocks noChangeArrowheads="1"/>
            </p:cNvSpPr>
            <p:nvPr/>
          </p:nvSpPr>
          <p:spPr bwMode="auto">
            <a:xfrm>
              <a:off x="1110371" y="1020215"/>
              <a:ext cx="51007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SPS4</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48" name="Rectangle 25"/>
            <p:cNvSpPr>
              <a:spLocks noChangeArrowheads="1"/>
            </p:cNvSpPr>
            <p:nvPr/>
          </p:nvSpPr>
          <p:spPr bwMode="auto">
            <a:xfrm>
              <a:off x="536815" y="1101237"/>
              <a:ext cx="72968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YPL025C</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49" name="Rectangle 26"/>
            <p:cNvSpPr>
              <a:spLocks noChangeArrowheads="1"/>
            </p:cNvSpPr>
            <p:nvPr/>
          </p:nvSpPr>
          <p:spPr bwMode="auto">
            <a:xfrm>
              <a:off x="1911151" y="1137192"/>
              <a:ext cx="5341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RNR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0" name="Rectangle 27"/>
            <p:cNvSpPr>
              <a:spLocks noChangeArrowheads="1"/>
            </p:cNvSpPr>
            <p:nvPr/>
          </p:nvSpPr>
          <p:spPr bwMode="auto">
            <a:xfrm>
              <a:off x="2546530" y="1152288"/>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HXT3</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1" name="Rectangle 28"/>
            <p:cNvSpPr>
              <a:spLocks noChangeArrowheads="1"/>
            </p:cNvSpPr>
            <p:nvPr/>
          </p:nvSpPr>
          <p:spPr bwMode="auto">
            <a:xfrm>
              <a:off x="2608605" y="1297117"/>
              <a:ext cx="52450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GPP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2" name="Rectangle 29"/>
            <p:cNvSpPr>
              <a:spLocks noChangeArrowheads="1"/>
            </p:cNvSpPr>
            <p:nvPr/>
          </p:nvSpPr>
          <p:spPr bwMode="auto">
            <a:xfrm>
              <a:off x="1489625" y="1187325"/>
              <a:ext cx="52610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NRK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3" name="Rectangle 30"/>
            <p:cNvSpPr>
              <a:spLocks noChangeArrowheads="1"/>
            </p:cNvSpPr>
            <p:nvPr/>
          </p:nvSpPr>
          <p:spPr bwMode="auto">
            <a:xfrm>
              <a:off x="2039553" y="1245368"/>
              <a:ext cx="59663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PDR1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7" name="Rectangle 37"/>
            <p:cNvSpPr>
              <a:spLocks noChangeArrowheads="1"/>
            </p:cNvSpPr>
            <p:nvPr/>
          </p:nvSpPr>
          <p:spPr bwMode="auto">
            <a:xfrm>
              <a:off x="1429326" y="3417397"/>
              <a:ext cx="6030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PHO84</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8" name="Rectangle 38"/>
            <p:cNvSpPr>
              <a:spLocks noChangeArrowheads="1"/>
            </p:cNvSpPr>
            <p:nvPr/>
          </p:nvSpPr>
          <p:spPr bwMode="auto">
            <a:xfrm>
              <a:off x="2612004" y="3087336"/>
              <a:ext cx="57419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FLO1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59" name="Rectangle 39"/>
            <p:cNvSpPr>
              <a:spLocks noChangeArrowheads="1"/>
            </p:cNvSpPr>
            <p:nvPr/>
          </p:nvSpPr>
          <p:spPr bwMode="auto">
            <a:xfrm>
              <a:off x="2266803" y="3010930"/>
              <a:ext cx="5036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FLO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0" name="Rectangle 40"/>
            <p:cNvSpPr>
              <a:spLocks noChangeArrowheads="1"/>
            </p:cNvSpPr>
            <p:nvPr/>
          </p:nvSpPr>
          <p:spPr bwMode="auto">
            <a:xfrm>
              <a:off x="1506177" y="3046656"/>
              <a:ext cx="59663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FMP45</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1" name="Rectangle 41"/>
            <p:cNvSpPr>
              <a:spLocks noChangeArrowheads="1"/>
            </p:cNvSpPr>
            <p:nvPr/>
          </p:nvSpPr>
          <p:spPr bwMode="auto">
            <a:xfrm>
              <a:off x="1049846" y="2973249"/>
              <a:ext cx="51809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POT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2" name="Rectangle 42"/>
            <p:cNvSpPr>
              <a:spLocks noChangeArrowheads="1"/>
            </p:cNvSpPr>
            <p:nvPr/>
          </p:nvSpPr>
          <p:spPr bwMode="auto">
            <a:xfrm>
              <a:off x="2728281" y="2745483"/>
              <a:ext cx="59663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TMA10</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3" name="Rectangle 43"/>
            <p:cNvSpPr>
              <a:spLocks noChangeArrowheads="1"/>
            </p:cNvSpPr>
            <p:nvPr/>
          </p:nvSpPr>
          <p:spPr bwMode="auto">
            <a:xfrm>
              <a:off x="2284255" y="2835572"/>
              <a:ext cx="51969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RTN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4" name="Rectangle 41"/>
            <p:cNvSpPr>
              <a:spLocks noChangeArrowheads="1"/>
            </p:cNvSpPr>
            <p:nvPr/>
          </p:nvSpPr>
          <p:spPr bwMode="auto">
            <a:xfrm>
              <a:off x="573392" y="3394446"/>
              <a:ext cx="4828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RGI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5" name="Rectangle 41"/>
            <p:cNvSpPr>
              <a:spLocks noChangeArrowheads="1"/>
            </p:cNvSpPr>
            <p:nvPr/>
          </p:nvSpPr>
          <p:spPr bwMode="auto">
            <a:xfrm>
              <a:off x="846368" y="3183129"/>
              <a:ext cx="55496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PWR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6" name="Rectangle 41"/>
            <p:cNvSpPr>
              <a:spLocks noChangeArrowheads="1"/>
            </p:cNvSpPr>
            <p:nvPr/>
          </p:nvSpPr>
          <p:spPr bwMode="auto">
            <a:xfrm>
              <a:off x="1530719" y="2935149"/>
              <a:ext cx="49564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SPL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67" name="Rectangle 41"/>
            <p:cNvSpPr>
              <a:spLocks noChangeArrowheads="1"/>
            </p:cNvSpPr>
            <p:nvPr/>
          </p:nvSpPr>
          <p:spPr bwMode="auto">
            <a:xfrm>
              <a:off x="1797664" y="2840290"/>
              <a:ext cx="5341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DDR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70" name="Rectangle 40"/>
            <p:cNvSpPr>
              <a:spLocks noChangeArrowheads="1"/>
            </p:cNvSpPr>
            <p:nvPr/>
          </p:nvSpPr>
          <p:spPr bwMode="auto">
            <a:xfrm>
              <a:off x="1276559" y="3178549"/>
              <a:ext cx="4828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RGI2</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27" name="TextBox 57"/>
            <p:cNvSpPr txBox="1">
              <a:spLocks noChangeArrowheads="1"/>
            </p:cNvSpPr>
            <p:nvPr/>
          </p:nvSpPr>
          <p:spPr bwMode="auto">
            <a:xfrm>
              <a:off x="334587" y="783969"/>
              <a:ext cx="1342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b="1" dirty="0">
                  <a:solidFill>
                    <a:srgbClr val="002060"/>
                  </a:solidFill>
                  <a:latin typeface="Arial" panose="020B0604020202020204" pitchFamily="34" charset="0"/>
                  <a:cs typeface="Arial" panose="020B0604020202020204" pitchFamily="34" charset="0"/>
                </a:rPr>
                <a:t>[</a:t>
              </a:r>
              <a:r>
                <a:rPr lang="en-US" altLang="en-US" sz="1200" b="1" i="1" dirty="0">
                  <a:solidFill>
                    <a:srgbClr val="002060"/>
                  </a:solidFill>
                  <a:latin typeface="Arial" panose="020B0604020202020204" pitchFamily="34" charset="0"/>
                  <a:cs typeface="Arial" panose="020B0604020202020204" pitchFamily="34" charset="0"/>
                </a:rPr>
                <a:t>SWI</a:t>
              </a:r>
              <a:r>
                <a:rPr lang="en-US" altLang="en-US" sz="1200" b="1" i="1" baseline="30000" dirty="0">
                  <a:solidFill>
                    <a:srgbClr val="002060"/>
                  </a:solidFill>
                  <a:latin typeface="Arial" panose="020B0604020202020204" pitchFamily="34" charset="0"/>
                  <a:cs typeface="Arial" panose="020B0604020202020204" pitchFamily="34" charset="0"/>
                </a:rPr>
                <a:t>+</a:t>
              </a:r>
              <a:r>
                <a:rPr lang="en-US" altLang="en-US" sz="1200" b="1" dirty="0">
                  <a:solidFill>
                    <a:srgbClr val="002060"/>
                  </a:solidFill>
                  <a:latin typeface="Arial" panose="020B0604020202020204" pitchFamily="34" charset="0"/>
                  <a:cs typeface="Arial" panose="020B0604020202020204" pitchFamily="34" charset="0"/>
                </a:rPr>
                <a:t>]</a:t>
              </a:r>
              <a:r>
                <a:rPr lang="en-US" altLang="en-US" sz="1200" b="1" i="1" dirty="0">
                  <a:solidFill>
                    <a:srgbClr val="002060"/>
                  </a:solidFill>
                  <a:latin typeface="Arial" panose="020B0604020202020204" pitchFamily="34" charset="0"/>
                  <a:cs typeface="Arial" panose="020B0604020202020204" pitchFamily="34" charset="0"/>
                </a:rPr>
                <a:t> </a:t>
              </a:r>
              <a:r>
                <a:rPr lang="en-US" altLang="en-US" sz="1200" b="1" dirty="0">
                  <a:solidFill>
                    <a:srgbClr val="002060"/>
                  </a:solidFill>
                  <a:latin typeface="Arial" panose="020B0604020202020204" pitchFamily="34" charset="0"/>
                  <a:cs typeface="Arial" panose="020B0604020202020204" pitchFamily="34" charset="0"/>
                </a:rPr>
                <a:t>vs</a:t>
              </a:r>
              <a:r>
                <a:rPr lang="en-US" altLang="en-US" sz="1200" b="1" i="1" dirty="0">
                  <a:solidFill>
                    <a:srgbClr val="002060"/>
                  </a:solidFill>
                  <a:latin typeface="Arial" panose="020B0604020202020204" pitchFamily="34" charset="0"/>
                  <a:cs typeface="Arial" panose="020B0604020202020204" pitchFamily="34" charset="0"/>
                </a:rPr>
                <a:t> </a:t>
              </a:r>
              <a:r>
                <a:rPr lang="en-US" altLang="en-US" sz="1200" b="1" i="1" dirty="0" err="1">
                  <a:solidFill>
                    <a:srgbClr val="002060"/>
                  </a:solidFill>
                  <a:latin typeface="Arial" panose="020B0604020202020204" pitchFamily="34" charset="0"/>
                  <a:cs typeface="Arial" panose="020B0604020202020204" pitchFamily="34" charset="0"/>
                </a:rPr>
                <a:t>wt</a:t>
              </a:r>
              <a:endParaRPr lang="en-US" altLang="en-US" sz="1200" b="1" i="1" dirty="0">
                <a:solidFill>
                  <a:srgbClr val="002060"/>
                </a:solidFill>
                <a:latin typeface="Arial" panose="020B0604020202020204" pitchFamily="34" charset="0"/>
                <a:cs typeface="Arial" panose="020B0604020202020204" pitchFamily="34" charset="0"/>
              </a:endParaRPr>
            </a:p>
          </p:txBody>
        </p:sp>
        <p:sp>
          <p:nvSpPr>
            <p:cNvPr id="2" name="Oval 1"/>
            <p:cNvSpPr/>
            <p:nvPr/>
          </p:nvSpPr>
          <p:spPr>
            <a:xfrm>
              <a:off x="2246394" y="3007919"/>
              <a:ext cx="947036" cy="325638"/>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000" i="1">
                <a:latin typeface="Arial" panose="020B0604020202020204" pitchFamily="34" charset="0"/>
                <a:cs typeface="Arial" panose="020B0604020202020204" pitchFamily="34" charset="0"/>
              </a:endParaRPr>
            </a:p>
          </p:txBody>
        </p:sp>
        <p:sp>
          <p:nvSpPr>
            <p:cNvPr id="224" name="Rectangle 36">
              <a:extLst>
                <a:ext uri="{FF2B5EF4-FFF2-40B4-BE49-F238E27FC236}">
                  <a16:creationId xmlns:a16="http://schemas.microsoft.com/office/drawing/2014/main" id="{EF3DE1DD-4C98-4ADB-BE30-46439B625E8B}"/>
                </a:ext>
              </a:extLst>
            </p:cNvPr>
            <p:cNvSpPr>
              <a:spLocks noChangeArrowheads="1"/>
            </p:cNvSpPr>
            <p:nvPr/>
          </p:nvSpPr>
          <p:spPr bwMode="auto">
            <a:xfrm>
              <a:off x="1108587" y="119443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HXT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225" name="Rectangle 25">
              <a:extLst>
                <a:ext uri="{FF2B5EF4-FFF2-40B4-BE49-F238E27FC236}">
                  <a16:creationId xmlns:a16="http://schemas.microsoft.com/office/drawing/2014/main" id="{158D9FAD-43AF-4E10-91BD-B338EE27818D}"/>
                </a:ext>
              </a:extLst>
            </p:cNvPr>
            <p:cNvSpPr>
              <a:spLocks noChangeArrowheads="1"/>
            </p:cNvSpPr>
            <p:nvPr/>
          </p:nvSpPr>
          <p:spPr bwMode="auto">
            <a:xfrm>
              <a:off x="481212" y="1253924"/>
              <a:ext cx="76014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YDR095C</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226" name="Rectangle 40">
              <a:extLst>
                <a:ext uri="{FF2B5EF4-FFF2-40B4-BE49-F238E27FC236}">
                  <a16:creationId xmlns:a16="http://schemas.microsoft.com/office/drawing/2014/main" id="{1DF81AA0-1B46-405B-A321-BB4CE38A7E8F}"/>
                </a:ext>
              </a:extLst>
            </p:cNvPr>
            <p:cNvSpPr>
              <a:spLocks noChangeArrowheads="1"/>
            </p:cNvSpPr>
            <p:nvPr/>
          </p:nvSpPr>
          <p:spPr bwMode="auto">
            <a:xfrm>
              <a:off x="1610032" y="3180763"/>
              <a:ext cx="73770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
                <a:spcBef>
                  <a:spcPct val="0"/>
                </a:spcBef>
                <a:buFontTx/>
                <a:buNone/>
              </a:pPr>
              <a:r>
                <a:rPr lang="en-US" altLang="en-US" sz="1000" i="1" dirty="0">
                  <a:latin typeface="Arial" panose="020B0604020202020204" pitchFamily="34" charset="0"/>
                  <a:cs typeface="Arial" panose="020B0604020202020204" pitchFamily="34" charset="0"/>
                </a:rPr>
                <a:t>YNL194C</a:t>
              </a:r>
              <a:endParaRPr lang="en-US" altLang="en-US" sz="1000" i="1" dirty="0">
                <a:solidFill>
                  <a:srgbClr val="000000"/>
                </a:solidFill>
                <a:latin typeface="Arial" panose="020B0604020202020204" pitchFamily="34" charset="0"/>
                <a:cs typeface="Arial" panose="020B0604020202020204" pitchFamily="34" charset="0"/>
              </a:endParaRPr>
            </a:p>
          </p:txBody>
        </p:sp>
      </p:grpSp>
      <p:grpSp>
        <p:nvGrpSpPr>
          <p:cNvPr id="8" name="Group 7">
            <a:extLst>
              <a:ext uri="{FF2B5EF4-FFF2-40B4-BE49-F238E27FC236}">
                <a16:creationId xmlns:a16="http://schemas.microsoft.com/office/drawing/2014/main" id="{E787E7B4-F9C6-4286-9CF1-EB1C9AFB9509}"/>
              </a:ext>
            </a:extLst>
          </p:cNvPr>
          <p:cNvGrpSpPr/>
          <p:nvPr/>
        </p:nvGrpSpPr>
        <p:grpSpPr>
          <a:xfrm>
            <a:off x="3364773" y="793588"/>
            <a:ext cx="3330988" cy="3222543"/>
            <a:chOff x="3364773" y="793588"/>
            <a:chExt cx="3330988" cy="3222543"/>
          </a:xfrm>
        </p:grpSpPr>
        <p:sp>
          <p:nvSpPr>
            <p:cNvPr id="66567" name="TextBox 58"/>
            <p:cNvSpPr txBox="1">
              <a:spLocks noChangeArrowheads="1"/>
            </p:cNvSpPr>
            <p:nvPr/>
          </p:nvSpPr>
          <p:spPr bwMode="auto">
            <a:xfrm>
              <a:off x="3727350" y="793588"/>
              <a:ext cx="133345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b="1" i="1" dirty="0">
                  <a:solidFill>
                    <a:srgbClr val="002060"/>
                  </a:solidFill>
                  <a:latin typeface="Arial" panose="020B0604020202020204" pitchFamily="34" charset="0"/>
                  <a:cs typeface="Arial" panose="020B0604020202020204" pitchFamily="34" charset="0"/>
                </a:rPr>
                <a:t>swi1</a:t>
              </a:r>
              <a:r>
                <a:rPr lang="en-US" altLang="en-US" sz="1200" b="1" i="1" dirty="0">
                  <a:solidFill>
                    <a:srgbClr val="002060"/>
                  </a:solidFill>
                  <a:latin typeface="Arial" panose="020B0604020202020204" pitchFamily="34" charset="0"/>
                  <a:cs typeface="Arial" panose="020B0604020202020204" pitchFamily="34" charset="0"/>
                  <a:sym typeface="Symbol" panose="05050102010706020507" pitchFamily="18" charset="2"/>
                </a:rPr>
                <a:t> </a:t>
              </a:r>
              <a:r>
                <a:rPr lang="en-US" altLang="en-US" sz="1200" b="1" dirty="0">
                  <a:solidFill>
                    <a:srgbClr val="002060"/>
                  </a:solidFill>
                  <a:latin typeface="Arial" panose="020B0604020202020204" pitchFamily="34" charset="0"/>
                  <a:cs typeface="Arial" panose="020B0604020202020204" pitchFamily="34" charset="0"/>
                  <a:sym typeface="Symbol" panose="05050102010706020507" pitchFamily="18" charset="2"/>
                </a:rPr>
                <a:t>vs</a:t>
              </a:r>
              <a:r>
                <a:rPr lang="en-US" altLang="en-US" sz="1200" b="1" i="1" dirty="0">
                  <a:solidFill>
                    <a:srgbClr val="002060"/>
                  </a:solidFill>
                  <a:latin typeface="Arial" panose="020B0604020202020204" pitchFamily="34" charset="0"/>
                  <a:cs typeface="Arial" panose="020B0604020202020204" pitchFamily="34" charset="0"/>
                  <a:sym typeface="Symbol" panose="05050102010706020507" pitchFamily="18" charset="2"/>
                </a:rPr>
                <a:t> </a:t>
              </a:r>
              <a:r>
                <a:rPr lang="en-US" altLang="en-US" sz="1200" b="1" i="1" dirty="0" err="1">
                  <a:solidFill>
                    <a:srgbClr val="002060"/>
                  </a:solidFill>
                  <a:latin typeface="Arial" panose="020B0604020202020204" pitchFamily="34" charset="0"/>
                  <a:cs typeface="Arial" panose="020B0604020202020204" pitchFamily="34" charset="0"/>
                  <a:sym typeface="Symbol" panose="05050102010706020507" pitchFamily="18" charset="2"/>
                </a:rPr>
                <a:t>wt</a:t>
              </a:r>
              <a:endParaRPr lang="en-US" altLang="en-US" sz="1200" b="1" dirty="0">
                <a:solidFill>
                  <a:srgbClr val="002060"/>
                </a:solidFill>
                <a:latin typeface="Arial" panose="020B0604020202020204" pitchFamily="34" charset="0"/>
                <a:cs typeface="Arial" panose="020B0604020202020204" pitchFamily="34" charset="0"/>
              </a:endParaRPr>
            </a:p>
          </p:txBody>
        </p:sp>
        <p:pic>
          <p:nvPicPr>
            <p:cNvPr id="66571" name="Picture 6"/>
            <p:cNvPicPr preferRelativeResize="0">
              <a:picLocks noChangeArrowheads="1"/>
            </p:cNvPicPr>
            <p:nvPr/>
          </p:nvPicPr>
          <p:blipFill>
            <a:blip r:embed="rId4">
              <a:extLst>
                <a:ext uri="{28A0092B-C50C-407E-A947-70E740481C1C}">
                  <a14:useLocalDpi xmlns:a14="http://schemas.microsoft.com/office/drawing/2010/main" val="0"/>
                </a:ext>
              </a:extLst>
            </a:blip>
            <a:srcRect l="4733" b="4880"/>
            <a:stretch>
              <a:fillRect/>
            </a:stretch>
          </p:blipFill>
          <p:spPr bwMode="auto">
            <a:xfrm>
              <a:off x="3695283" y="1067205"/>
              <a:ext cx="2928602" cy="26611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6572" name="TextBox 18"/>
            <p:cNvSpPr txBox="1">
              <a:spLocks noChangeArrowheads="1"/>
            </p:cNvSpPr>
            <p:nvPr/>
          </p:nvSpPr>
          <p:spPr bwMode="auto">
            <a:xfrm rot="10800000">
              <a:off x="3532754" y="1006862"/>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dirty="0">
                  <a:latin typeface="Arial" panose="020B0604020202020204" pitchFamily="34" charset="0"/>
                  <a:cs typeface="Arial" panose="020B0604020202020204" pitchFamily="34" charset="0"/>
                </a:rPr>
                <a:t>6</a:t>
              </a:r>
            </a:p>
          </p:txBody>
        </p:sp>
        <p:sp>
          <p:nvSpPr>
            <p:cNvPr id="66573" name="TextBox 19"/>
            <p:cNvSpPr txBox="1">
              <a:spLocks noChangeArrowheads="1"/>
            </p:cNvSpPr>
            <p:nvPr/>
          </p:nvSpPr>
          <p:spPr bwMode="auto">
            <a:xfrm rot="10800000">
              <a:off x="3532754" y="1342130"/>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4</a:t>
              </a:r>
            </a:p>
          </p:txBody>
        </p:sp>
        <p:sp>
          <p:nvSpPr>
            <p:cNvPr id="66574" name="TextBox 20"/>
            <p:cNvSpPr txBox="1">
              <a:spLocks noChangeArrowheads="1"/>
            </p:cNvSpPr>
            <p:nvPr/>
          </p:nvSpPr>
          <p:spPr bwMode="auto">
            <a:xfrm rot="10800000">
              <a:off x="3532754" y="1697145"/>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2</a:t>
              </a:r>
            </a:p>
          </p:txBody>
        </p:sp>
        <p:sp>
          <p:nvSpPr>
            <p:cNvPr id="66575" name="TextBox 21"/>
            <p:cNvSpPr txBox="1">
              <a:spLocks noChangeArrowheads="1"/>
            </p:cNvSpPr>
            <p:nvPr/>
          </p:nvSpPr>
          <p:spPr bwMode="auto">
            <a:xfrm rot="10800000">
              <a:off x="3532754" y="2040871"/>
              <a:ext cx="338554" cy="162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0</a:t>
              </a:r>
            </a:p>
          </p:txBody>
        </p:sp>
        <p:sp>
          <p:nvSpPr>
            <p:cNvPr id="66576" name="TextBox 22"/>
            <p:cNvSpPr txBox="1">
              <a:spLocks noChangeArrowheads="1"/>
            </p:cNvSpPr>
            <p:nvPr/>
          </p:nvSpPr>
          <p:spPr bwMode="auto">
            <a:xfrm rot="10800000">
              <a:off x="3532754" y="2728414"/>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4</a:t>
              </a:r>
            </a:p>
          </p:txBody>
        </p:sp>
        <p:sp>
          <p:nvSpPr>
            <p:cNvPr id="66577" name="TextBox 23"/>
            <p:cNvSpPr txBox="1">
              <a:spLocks noChangeArrowheads="1"/>
            </p:cNvSpPr>
            <p:nvPr/>
          </p:nvSpPr>
          <p:spPr bwMode="auto">
            <a:xfrm rot="10800000">
              <a:off x="3532754" y="3062423"/>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6</a:t>
              </a:r>
            </a:p>
          </p:txBody>
        </p:sp>
        <p:sp>
          <p:nvSpPr>
            <p:cNvPr id="66578" name="TextBox 24"/>
            <p:cNvSpPr txBox="1">
              <a:spLocks noChangeArrowheads="1"/>
            </p:cNvSpPr>
            <p:nvPr/>
          </p:nvSpPr>
          <p:spPr bwMode="auto">
            <a:xfrm rot="10800000">
              <a:off x="3532754" y="3419005"/>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8</a:t>
              </a:r>
            </a:p>
          </p:txBody>
        </p:sp>
        <p:sp>
          <p:nvSpPr>
            <p:cNvPr id="66579" name="TextBox 25"/>
            <p:cNvSpPr txBox="1">
              <a:spLocks noChangeArrowheads="1"/>
            </p:cNvSpPr>
            <p:nvPr/>
          </p:nvSpPr>
          <p:spPr bwMode="auto">
            <a:xfrm rot="10800000">
              <a:off x="3532754" y="2391121"/>
              <a:ext cx="338554" cy="20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2</a:t>
              </a:r>
            </a:p>
          </p:txBody>
        </p:sp>
        <p:sp>
          <p:nvSpPr>
            <p:cNvPr id="66586" name="TextBox 61"/>
            <p:cNvSpPr txBox="1">
              <a:spLocks noChangeArrowheads="1"/>
            </p:cNvSpPr>
            <p:nvPr/>
          </p:nvSpPr>
          <p:spPr bwMode="auto">
            <a:xfrm>
              <a:off x="5529404" y="3334429"/>
              <a:ext cx="78178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dirty="0">
                  <a:latin typeface="Arial" panose="020B0604020202020204" pitchFamily="34" charset="0"/>
                  <a:cs typeface="Arial" panose="020B0604020202020204" pitchFamily="34" charset="0"/>
                </a:rPr>
                <a:t>397 genes</a:t>
              </a:r>
            </a:p>
          </p:txBody>
        </p:sp>
        <p:sp>
          <p:nvSpPr>
            <p:cNvPr id="66588" name="TextBox 68"/>
            <p:cNvSpPr txBox="1">
              <a:spLocks noChangeArrowheads="1"/>
            </p:cNvSpPr>
            <p:nvPr/>
          </p:nvSpPr>
          <p:spPr bwMode="auto">
            <a:xfrm>
              <a:off x="4727335" y="3739132"/>
              <a:ext cx="104377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log2 (CPM)</a:t>
              </a:r>
            </a:p>
          </p:txBody>
        </p:sp>
        <p:sp>
          <p:nvSpPr>
            <p:cNvPr id="66589" name="TextBox 69"/>
            <p:cNvSpPr txBox="1">
              <a:spLocks noChangeArrowheads="1"/>
            </p:cNvSpPr>
            <p:nvPr/>
          </p:nvSpPr>
          <p:spPr bwMode="auto">
            <a:xfrm rot="16200000">
              <a:off x="2995500" y="2117820"/>
              <a:ext cx="101554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200" dirty="0">
                  <a:latin typeface="Arial" panose="020B0604020202020204" pitchFamily="34" charset="0"/>
                  <a:cs typeface="Arial" panose="020B0604020202020204" pitchFamily="34" charset="0"/>
                </a:rPr>
                <a:t>log2 (FC)</a:t>
              </a:r>
            </a:p>
          </p:txBody>
        </p:sp>
        <p:sp>
          <p:nvSpPr>
            <p:cNvPr id="66590" name="TextBox 47"/>
            <p:cNvSpPr txBox="1">
              <a:spLocks noChangeArrowheads="1"/>
            </p:cNvSpPr>
            <p:nvPr/>
          </p:nvSpPr>
          <p:spPr bwMode="auto">
            <a:xfrm>
              <a:off x="6173485" y="1704491"/>
              <a:ext cx="5036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LEU1</a:t>
              </a:r>
            </a:p>
          </p:txBody>
        </p:sp>
        <p:sp>
          <p:nvSpPr>
            <p:cNvPr id="66591" name="TextBox 48"/>
            <p:cNvSpPr txBox="1">
              <a:spLocks noChangeArrowheads="1"/>
            </p:cNvSpPr>
            <p:nvPr/>
          </p:nvSpPr>
          <p:spPr bwMode="auto">
            <a:xfrm>
              <a:off x="5874590" y="1510067"/>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HXT3</a:t>
              </a:r>
            </a:p>
          </p:txBody>
        </p:sp>
        <p:sp>
          <p:nvSpPr>
            <p:cNvPr id="66592" name="TextBox 49"/>
            <p:cNvSpPr txBox="1">
              <a:spLocks noChangeArrowheads="1"/>
            </p:cNvSpPr>
            <p:nvPr/>
          </p:nvSpPr>
          <p:spPr bwMode="auto">
            <a:xfrm>
              <a:off x="5590904" y="1822017"/>
              <a:ext cx="52610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MET6</a:t>
              </a:r>
            </a:p>
          </p:txBody>
        </p:sp>
        <p:sp>
          <p:nvSpPr>
            <p:cNvPr id="66593" name="TextBox 50"/>
            <p:cNvSpPr txBox="1">
              <a:spLocks noChangeArrowheads="1"/>
            </p:cNvSpPr>
            <p:nvPr/>
          </p:nvSpPr>
          <p:spPr bwMode="auto">
            <a:xfrm>
              <a:off x="5481442" y="1516806"/>
              <a:ext cx="53251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OAC1</a:t>
              </a:r>
            </a:p>
          </p:txBody>
        </p:sp>
        <p:sp>
          <p:nvSpPr>
            <p:cNvPr id="66594" name="TextBox 51"/>
            <p:cNvSpPr txBox="1">
              <a:spLocks noChangeArrowheads="1"/>
            </p:cNvSpPr>
            <p:nvPr/>
          </p:nvSpPr>
          <p:spPr bwMode="auto">
            <a:xfrm>
              <a:off x="5344879" y="1394744"/>
              <a:ext cx="5036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a:latin typeface="Arial" panose="020B0604020202020204" pitchFamily="34" charset="0"/>
                  <a:cs typeface="Arial" panose="020B0604020202020204" pitchFamily="34" charset="0"/>
                </a:rPr>
                <a:t>STE2</a:t>
              </a:r>
            </a:p>
          </p:txBody>
        </p:sp>
        <p:sp>
          <p:nvSpPr>
            <p:cNvPr id="66595" name="TextBox 52"/>
            <p:cNvSpPr txBox="1">
              <a:spLocks noChangeArrowheads="1"/>
            </p:cNvSpPr>
            <p:nvPr/>
          </p:nvSpPr>
          <p:spPr bwMode="auto">
            <a:xfrm>
              <a:off x="5443483" y="1276131"/>
              <a:ext cx="5405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PRM5</a:t>
              </a:r>
            </a:p>
          </p:txBody>
        </p:sp>
        <p:sp>
          <p:nvSpPr>
            <p:cNvPr id="66596" name="TextBox 53"/>
            <p:cNvSpPr txBox="1">
              <a:spLocks noChangeArrowheads="1"/>
            </p:cNvSpPr>
            <p:nvPr/>
          </p:nvSpPr>
          <p:spPr bwMode="auto">
            <a:xfrm>
              <a:off x="5249224" y="1167279"/>
              <a:ext cx="52610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MFA2</a:t>
              </a:r>
            </a:p>
          </p:txBody>
        </p:sp>
        <p:sp>
          <p:nvSpPr>
            <p:cNvPr id="66597" name="TextBox 54"/>
            <p:cNvSpPr txBox="1">
              <a:spLocks noChangeArrowheads="1"/>
            </p:cNvSpPr>
            <p:nvPr/>
          </p:nvSpPr>
          <p:spPr bwMode="auto">
            <a:xfrm>
              <a:off x="5080351" y="1046663"/>
              <a:ext cx="57419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STE18</a:t>
              </a:r>
            </a:p>
          </p:txBody>
        </p:sp>
        <p:sp>
          <p:nvSpPr>
            <p:cNvPr id="66598" name="TextBox 55"/>
            <p:cNvSpPr txBox="1">
              <a:spLocks noChangeArrowheads="1"/>
            </p:cNvSpPr>
            <p:nvPr/>
          </p:nvSpPr>
          <p:spPr bwMode="auto">
            <a:xfrm>
              <a:off x="5038868" y="1288172"/>
              <a:ext cx="52610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MFA1</a:t>
              </a:r>
            </a:p>
          </p:txBody>
        </p:sp>
        <p:sp>
          <p:nvSpPr>
            <p:cNvPr id="66599" name="TextBox 56"/>
            <p:cNvSpPr txBox="1">
              <a:spLocks noChangeArrowheads="1"/>
            </p:cNvSpPr>
            <p:nvPr/>
          </p:nvSpPr>
          <p:spPr bwMode="auto">
            <a:xfrm>
              <a:off x="3816743" y="1105323"/>
              <a:ext cx="58862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AAD15</a:t>
              </a:r>
            </a:p>
          </p:txBody>
        </p:sp>
        <p:sp>
          <p:nvSpPr>
            <p:cNvPr id="66600" name="TextBox 57"/>
            <p:cNvSpPr txBox="1">
              <a:spLocks noChangeArrowheads="1"/>
            </p:cNvSpPr>
            <p:nvPr/>
          </p:nvSpPr>
          <p:spPr bwMode="auto">
            <a:xfrm>
              <a:off x="3759211" y="1279697"/>
              <a:ext cx="46198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THI5</a:t>
              </a:r>
            </a:p>
          </p:txBody>
        </p:sp>
        <p:sp>
          <p:nvSpPr>
            <p:cNvPr id="66601" name="TextBox 58"/>
            <p:cNvSpPr txBox="1">
              <a:spLocks noChangeArrowheads="1"/>
            </p:cNvSpPr>
            <p:nvPr/>
          </p:nvSpPr>
          <p:spPr bwMode="auto">
            <a:xfrm>
              <a:off x="4013583" y="1240183"/>
              <a:ext cx="53251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THI12</a:t>
              </a:r>
            </a:p>
          </p:txBody>
        </p:sp>
        <p:sp>
          <p:nvSpPr>
            <p:cNvPr id="66603" name="TextBox 60"/>
            <p:cNvSpPr txBox="1">
              <a:spLocks noChangeArrowheads="1"/>
            </p:cNvSpPr>
            <p:nvPr/>
          </p:nvSpPr>
          <p:spPr bwMode="auto">
            <a:xfrm>
              <a:off x="4856654" y="3303791"/>
              <a:ext cx="4828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IME4</a:t>
              </a:r>
            </a:p>
          </p:txBody>
        </p:sp>
        <p:sp>
          <p:nvSpPr>
            <p:cNvPr id="66604" name="TextBox 61"/>
            <p:cNvSpPr txBox="1">
              <a:spLocks noChangeArrowheads="1"/>
            </p:cNvSpPr>
            <p:nvPr/>
          </p:nvSpPr>
          <p:spPr bwMode="auto">
            <a:xfrm>
              <a:off x="5367449" y="3170363"/>
              <a:ext cx="46198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TIR1</a:t>
              </a:r>
            </a:p>
          </p:txBody>
        </p:sp>
        <p:sp>
          <p:nvSpPr>
            <p:cNvPr id="66605" name="TextBox 62"/>
            <p:cNvSpPr txBox="1">
              <a:spLocks noChangeArrowheads="1"/>
            </p:cNvSpPr>
            <p:nvPr/>
          </p:nvSpPr>
          <p:spPr bwMode="auto">
            <a:xfrm>
              <a:off x="4444100" y="3152736"/>
              <a:ext cx="5405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HMS1</a:t>
              </a:r>
            </a:p>
          </p:txBody>
        </p:sp>
        <p:sp>
          <p:nvSpPr>
            <p:cNvPr id="66606" name="TextBox 63"/>
            <p:cNvSpPr txBox="1">
              <a:spLocks noChangeArrowheads="1"/>
            </p:cNvSpPr>
            <p:nvPr/>
          </p:nvSpPr>
          <p:spPr bwMode="auto">
            <a:xfrm>
              <a:off x="5922741" y="3189573"/>
              <a:ext cx="52450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YGP1</a:t>
              </a:r>
            </a:p>
          </p:txBody>
        </p:sp>
        <p:sp>
          <p:nvSpPr>
            <p:cNvPr id="66607" name="TextBox 64"/>
            <p:cNvSpPr txBox="1">
              <a:spLocks noChangeArrowheads="1"/>
            </p:cNvSpPr>
            <p:nvPr/>
          </p:nvSpPr>
          <p:spPr bwMode="auto">
            <a:xfrm>
              <a:off x="6037078" y="3076339"/>
              <a:ext cx="58862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HSP12</a:t>
              </a:r>
            </a:p>
          </p:txBody>
        </p:sp>
        <p:sp>
          <p:nvSpPr>
            <p:cNvPr id="66608" name="TextBox 65"/>
            <p:cNvSpPr txBox="1">
              <a:spLocks noChangeArrowheads="1"/>
            </p:cNvSpPr>
            <p:nvPr/>
          </p:nvSpPr>
          <p:spPr bwMode="auto">
            <a:xfrm>
              <a:off x="5734693" y="2940037"/>
              <a:ext cx="57419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FLO11</a:t>
              </a:r>
            </a:p>
          </p:txBody>
        </p:sp>
        <p:sp>
          <p:nvSpPr>
            <p:cNvPr id="66609" name="TextBox 66"/>
            <p:cNvSpPr txBox="1">
              <a:spLocks noChangeArrowheads="1"/>
            </p:cNvSpPr>
            <p:nvPr/>
          </p:nvSpPr>
          <p:spPr bwMode="auto">
            <a:xfrm>
              <a:off x="5623780" y="3062125"/>
              <a:ext cx="5036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FLO1</a:t>
              </a:r>
            </a:p>
          </p:txBody>
        </p:sp>
        <p:sp>
          <p:nvSpPr>
            <p:cNvPr id="66612" name="TextBox 69"/>
            <p:cNvSpPr txBox="1">
              <a:spLocks noChangeArrowheads="1"/>
            </p:cNvSpPr>
            <p:nvPr/>
          </p:nvSpPr>
          <p:spPr bwMode="auto">
            <a:xfrm>
              <a:off x="4847504" y="3166926"/>
              <a:ext cx="54053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QDR2</a:t>
              </a:r>
            </a:p>
          </p:txBody>
        </p:sp>
        <p:sp>
          <p:nvSpPr>
            <p:cNvPr id="66613" name="TextBox 70"/>
            <p:cNvSpPr txBox="1">
              <a:spLocks noChangeArrowheads="1"/>
            </p:cNvSpPr>
            <p:nvPr/>
          </p:nvSpPr>
          <p:spPr bwMode="auto">
            <a:xfrm>
              <a:off x="4769192" y="3025558"/>
              <a:ext cx="6030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ARO10</a:t>
              </a:r>
            </a:p>
          </p:txBody>
        </p:sp>
        <p:sp>
          <p:nvSpPr>
            <p:cNvPr id="66615" name="TextBox 72"/>
            <p:cNvSpPr txBox="1">
              <a:spLocks noChangeArrowheads="1"/>
            </p:cNvSpPr>
            <p:nvPr/>
          </p:nvSpPr>
          <p:spPr bwMode="auto">
            <a:xfrm>
              <a:off x="5006180" y="2914770"/>
              <a:ext cx="73770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YNL194C</a:t>
              </a:r>
            </a:p>
          </p:txBody>
        </p:sp>
        <p:sp>
          <p:nvSpPr>
            <p:cNvPr id="66617" name="TextBox 74"/>
            <p:cNvSpPr txBox="1">
              <a:spLocks noChangeArrowheads="1"/>
            </p:cNvSpPr>
            <p:nvPr/>
          </p:nvSpPr>
          <p:spPr bwMode="auto">
            <a:xfrm>
              <a:off x="4538046" y="2895550"/>
              <a:ext cx="52610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DAN1</a:t>
              </a:r>
            </a:p>
          </p:txBody>
        </p:sp>
        <p:sp>
          <p:nvSpPr>
            <p:cNvPr id="66618" name="TextBox 76"/>
            <p:cNvSpPr txBox="1">
              <a:spLocks noChangeArrowheads="1"/>
            </p:cNvSpPr>
            <p:nvPr/>
          </p:nvSpPr>
          <p:spPr bwMode="auto">
            <a:xfrm>
              <a:off x="5093368" y="1505512"/>
              <a:ext cx="49564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AXL1</a:t>
              </a:r>
            </a:p>
          </p:txBody>
        </p:sp>
        <p:sp>
          <p:nvSpPr>
            <p:cNvPr id="66620" name="Rectangle 78"/>
            <p:cNvSpPr>
              <a:spLocks noChangeArrowheads="1"/>
            </p:cNvSpPr>
            <p:nvPr/>
          </p:nvSpPr>
          <p:spPr bwMode="auto">
            <a:xfrm>
              <a:off x="4396430" y="1304756"/>
              <a:ext cx="5036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fontAlgn="b" hangingPunct="1">
                <a:spcBef>
                  <a:spcPct val="0"/>
                </a:spcBef>
                <a:buFontTx/>
                <a:buNone/>
              </a:pPr>
              <a:r>
                <a:rPr lang="en-US" altLang="en-US" sz="1000" i="1" dirty="0">
                  <a:latin typeface="Arial" panose="020B0604020202020204" pitchFamily="34" charset="0"/>
                  <a:cs typeface="Arial" panose="020B0604020202020204" pitchFamily="34" charset="0"/>
                </a:rPr>
                <a:t>SUL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23" name="Rectangle 81"/>
            <p:cNvSpPr>
              <a:spLocks noChangeArrowheads="1"/>
            </p:cNvSpPr>
            <p:nvPr/>
          </p:nvSpPr>
          <p:spPr bwMode="auto">
            <a:xfrm>
              <a:off x="4739951" y="1355574"/>
              <a:ext cx="49725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fontAlgn="b" hangingPunct="1">
                <a:spcBef>
                  <a:spcPct val="0"/>
                </a:spcBef>
                <a:buFontTx/>
                <a:buNone/>
              </a:pPr>
              <a:r>
                <a:rPr lang="en-US" altLang="en-US" sz="1000" i="1" dirty="0">
                  <a:latin typeface="Arial" panose="020B0604020202020204" pitchFamily="34" charset="0"/>
                  <a:cs typeface="Arial" panose="020B0604020202020204" pitchFamily="34" charset="0"/>
                </a:rPr>
                <a:t>NEJ1</a:t>
              </a:r>
              <a:endParaRPr lang="en-US" altLang="en-US" sz="1000" i="1" dirty="0">
                <a:solidFill>
                  <a:srgbClr val="000000"/>
                </a:solidFill>
                <a:latin typeface="Arial" panose="020B0604020202020204" pitchFamily="34" charset="0"/>
                <a:cs typeface="Arial" panose="020B0604020202020204" pitchFamily="34" charset="0"/>
              </a:endParaRPr>
            </a:p>
          </p:txBody>
        </p:sp>
        <p:sp>
          <p:nvSpPr>
            <p:cNvPr id="66625" name="TextBox 73"/>
            <p:cNvSpPr txBox="1">
              <a:spLocks noChangeArrowheads="1"/>
            </p:cNvSpPr>
            <p:nvPr/>
          </p:nvSpPr>
          <p:spPr bwMode="auto">
            <a:xfrm>
              <a:off x="3885282" y="3386752"/>
              <a:ext cx="9172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YDR210W-B</a:t>
              </a:r>
            </a:p>
          </p:txBody>
        </p:sp>
        <p:sp>
          <p:nvSpPr>
            <p:cNvPr id="117" name="Oval 116"/>
            <p:cNvSpPr/>
            <p:nvPr/>
          </p:nvSpPr>
          <p:spPr>
            <a:xfrm>
              <a:off x="5671372" y="3024070"/>
              <a:ext cx="455506" cy="26355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000" i="1">
                <a:latin typeface="Arial" panose="020B0604020202020204" pitchFamily="34" charset="0"/>
                <a:cs typeface="Arial" panose="020B0604020202020204" pitchFamily="34" charset="0"/>
              </a:endParaRPr>
            </a:p>
          </p:txBody>
        </p:sp>
        <p:sp>
          <p:nvSpPr>
            <p:cNvPr id="229" name="TextBox 60">
              <a:extLst>
                <a:ext uri="{FF2B5EF4-FFF2-40B4-BE49-F238E27FC236}">
                  <a16:creationId xmlns:a16="http://schemas.microsoft.com/office/drawing/2014/main" id="{DCC64CAF-C881-45E8-A9E6-85EFCDDEBC14}"/>
                </a:ext>
              </a:extLst>
            </p:cNvPr>
            <p:cNvSpPr txBox="1">
              <a:spLocks noChangeArrowheads="1"/>
            </p:cNvSpPr>
            <p:nvPr/>
          </p:nvSpPr>
          <p:spPr bwMode="auto">
            <a:xfrm>
              <a:off x="4485003" y="3274578"/>
              <a:ext cx="49725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SWI1</a:t>
              </a:r>
            </a:p>
          </p:txBody>
        </p:sp>
        <p:sp>
          <p:nvSpPr>
            <p:cNvPr id="7" name="Rectangle 6">
              <a:extLst>
                <a:ext uri="{FF2B5EF4-FFF2-40B4-BE49-F238E27FC236}">
                  <a16:creationId xmlns:a16="http://schemas.microsoft.com/office/drawing/2014/main" id="{6C6D09E4-6CB4-49A1-B9C7-8BFF583B0ED3}"/>
                </a:ext>
              </a:extLst>
            </p:cNvPr>
            <p:cNvSpPr/>
            <p:nvPr/>
          </p:nvSpPr>
          <p:spPr>
            <a:xfrm>
              <a:off x="4351964" y="1166244"/>
              <a:ext cx="760144" cy="246221"/>
            </a:xfrm>
            <a:prstGeom prst="rect">
              <a:avLst/>
            </a:prstGeom>
          </p:spPr>
          <p:txBody>
            <a:bodyPr wrap="none">
              <a:spAutoFit/>
            </a:bodyPr>
            <a:lstStyle/>
            <a:p>
              <a:r>
                <a:rPr lang="en-US" sz="1000" i="1" dirty="0">
                  <a:latin typeface="Arial" panose="020B0604020202020204" pitchFamily="34" charset="0"/>
                  <a:cs typeface="Arial" panose="020B0604020202020204" pitchFamily="34" charset="0"/>
                </a:rPr>
                <a:t>YJR087W</a:t>
              </a:r>
            </a:p>
          </p:txBody>
        </p:sp>
        <p:sp>
          <p:nvSpPr>
            <p:cNvPr id="66569" name="TextBox 45"/>
            <p:cNvSpPr txBox="1">
              <a:spLocks noChangeArrowheads="1"/>
            </p:cNvSpPr>
            <p:nvPr/>
          </p:nvSpPr>
          <p:spPr bwMode="auto">
            <a:xfrm>
              <a:off x="6362427" y="3600600"/>
              <a:ext cx="33333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12</a:t>
              </a:r>
            </a:p>
          </p:txBody>
        </p:sp>
        <p:sp>
          <p:nvSpPr>
            <p:cNvPr id="66580" name="TextBox 39"/>
            <p:cNvSpPr txBox="1">
              <a:spLocks noChangeArrowheads="1"/>
            </p:cNvSpPr>
            <p:nvPr/>
          </p:nvSpPr>
          <p:spPr bwMode="auto">
            <a:xfrm>
              <a:off x="3920821" y="3600600"/>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0</a:t>
              </a:r>
            </a:p>
          </p:txBody>
        </p:sp>
        <p:sp>
          <p:nvSpPr>
            <p:cNvPr id="66581" name="TextBox 40"/>
            <p:cNvSpPr txBox="1">
              <a:spLocks noChangeArrowheads="1"/>
            </p:cNvSpPr>
            <p:nvPr/>
          </p:nvSpPr>
          <p:spPr bwMode="auto">
            <a:xfrm>
              <a:off x="4335552" y="3600600"/>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2</a:t>
              </a:r>
            </a:p>
          </p:txBody>
        </p:sp>
        <p:sp>
          <p:nvSpPr>
            <p:cNvPr id="66582" name="TextBox 41"/>
            <p:cNvSpPr txBox="1">
              <a:spLocks noChangeArrowheads="1"/>
            </p:cNvSpPr>
            <p:nvPr/>
          </p:nvSpPr>
          <p:spPr bwMode="auto">
            <a:xfrm>
              <a:off x="4748667" y="3600600"/>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4</a:t>
              </a:r>
            </a:p>
          </p:txBody>
        </p:sp>
        <p:sp>
          <p:nvSpPr>
            <p:cNvPr id="66583" name="TextBox 42"/>
            <p:cNvSpPr txBox="1">
              <a:spLocks noChangeArrowheads="1"/>
            </p:cNvSpPr>
            <p:nvPr/>
          </p:nvSpPr>
          <p:spPr bwMode="auto">
            <a:xfrm>
              <a:off x="5161780" y="3600600"/>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6</a:t>
              </a:r>
            </a:p>
          </p:txBody>
        </p:sp>
        <p:sp>
          <p:nvSpPr>
            <p:cNvPr id="66584" name="TextBox 43"/>
            <p:cNvSpPr txBox="1">
              <a:spLocks noChangeArrowheads="1"/>
            </p:cNvSpPr>
            <p:nvPr/>
          </p:nvSpPr>
          <p:spPr bwMode="auto">
            <a:xfrm>
              <a:off x="5572587" y="3600600"/>
              <a:ext cx="25519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8</a:t>
              </a:r>
            </a:p>
          </p:txBody>
        </p:sp>
        <p:sp>
          <p:nvSpPr>
            <p:cNvPr id="66585" name="TextBox 44"/>
            <p:cNvSpPr txBox="1">
              <a:spLocks noChangeArrowheads="1"/>
            </p:cNvSpPr>
            <p:nvPr/>
          </p:nvSpPr>
          <p:spPr bwMode="auto">
            <a:xfrm>
              <a:off x="5952510" y="3600600"/>
              <a:ext cx="32573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a:latin typeface="Arial" panose="020B0604020202020204" pitchFamily="34" charset="0"/>
                  <a:cs typeface="Arial" panose="020B0604020202020204" pitchFamily="34" charset="0"/>
                </a:rPr>
                <a:t>10</a:t>
              </a:r>
            </a:p>
          </p:txBody>
        </p:sp>
        <p:sp>
          <p:nvSpPr>
            <p:cNvPr id="66587" name="TextBox 62"/>
            <p:cNvSpPr txBox="1">
              <a:spLocks noChangeArrowheads="1"/>
            </p:cNvSpPr>
            <p:nvPr/>
          </p:nvSpPr>
          <p:spPr bwMode="auto">
            <a:xfrm>
              <a:off x="5529403" y="3443251"/>
              <a:ext cx="78065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dirty="0">
                  <a:latin typeface="Arial" panose="020B0604020202020204" pitchFamily="34" charset="0"/>
                  <a:cs typeface="Arial" panose="020B0604020202020204" pitchFamily="34" charset="0"/>
                </a:rPr>
                <a:t>731 genes</a:t>
              </a:r>
            </a:p>
          </p:txBody>
        </p:sp>
        <p:sp>
          <p:nvSpPr>
            <p:cNvPr id="66602" name="TextBox 59"/>
            <p:cNvSpPr txBox="1">
              <a:spLocks noChangeArrowheads="1"/>
            </p:cNvSpPr>
            <p:nvPr/>
          </p:nvSpPr>
          <p:spPr bwMode="auto">
            <a:xfrm>
              <a:off x="4856125" y="3457090"/>
              <a:ext cx="6030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eaLnBrk="1" hangingPunct="1">
                <a:spcBef>
                  <a:spcPct val="0"/>
                </a:spcBef>
                <a:buFontTx/>
                <a:buNone/>
              </a:pPr>
              <a:r>
                <a:rPr lang="en-US" altLang="en-US" sz="1000" i="1" dirty="0">
                  <a:latin typeface="Arial" panose="020B0604020202020204" pitchFamily="34" charset="0"/>
                  <a:cs typeface="Arial" panose="020B0604020202020204" pitchFamily="34" charset="0"/>
                </a:rPr>
                <a:t>PHO84</a:t>
              </a:r>
            </a:p>
          </p:txBody>
        </p:sp>
      </p:grpSp>
      <p:sp>
        <p:nvSpPr>
          <p:cNvPr id="101" name="TextBox 100">
            <a:extLst>
              <a:ext uri="{FF2B5EF4-FFF2-40B4-BE49-F238E27FC236}">
                <a16:creationId xmlns:a16="http://schemas.microsoft.com/office/drawing/2014/main" id="{2FA2A83D-8645-43CE-B151-8EFA86487AFA}"/>
              </a:ext>
            </a:extLst>
          </p:cNvPr>
          <p:cNvSpPr txBox="1"/>
          <p:nvPr/>
        </p:nvSpPr>
        <p:spPr>
          <a:xfrm>
            <a:off x="137781" y="82876"/>
            <a:ext cx="88678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igure S2</a:t>
            </a:r>
          </a:p>
        </p:txBody>
      </p:sp>
    </p:spTree>
    <p:extLst>
      <p:ext uri="{BB962C8B-B14F-4D97-AF65-F5344CB8AC3E}">
        <p14:creationId xmlns:p14="http://schemas.microsoft.com/office/powerpoint/2010/main" val="13244126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BED8D89-F8FE-485C-BE99-2FFA02D2152B}"/>
              </a:ext>
            </a:extLst>
          </p:cNvPr>
          <p:cNvGrpSpPr/>
          <p:nvPr/>
        </p:nvGrpSpPr>
        <p:grpSpPr>
          <a:xfrm>
            <a:off x="9812" y="495300"/>
            <a:ext cx="6856027" cy="6819900"/>
            <a:chOff x="9812" y="495300"/>
            <a:chExt cx="6856027" cy="7728092"/>
          </a:xfrm>
        </p:grpSpPr>
        <p:sp>
          <p:nvSpPr>
            <p:cNvPr id="3" name="Rectangle 2">
              <a:extLst>
                <a:ext uri="{FF2B5EF4-FFF2-40B4-BE49-F238E27FC236}">
                  <a16:creationId xmlns:a16="http://schemas.microsoft.com/office/drawing/2014/main" id="{9D00E160-1C31-430D-9E30-0B37A90B5AE7}"/>
                </a:ext>
              </a:extLst>
            </p:cNvPr>
            <p:cNvSpPr/>
            <p:nvPr/>
          </p:nvSpPr>
          <p:spPr>
            <a:xfrm rot="16200000">
              <a:off x="-230959" y="4102567"/>
              <a:ext cx="758541" cy="276999"/>
            </a:xfrm>
            <a:prstGeom prst="rect">
              <a:avLst/>
            </a:prstGeom>
          </p:spPr>
          <p:txBody>
            <a:bodyPr wrap="none">
              <a:spAutoFit/>
            </a:bodyPr>
            <a:lstStyle/>
            <a:p>
              <a:r>
                <a:rPr lang="en-US" sz="1200" b="1" dirty="0">
                  <a:solidFill>
                    <a:srgbClr val="000000"/>
                  </a:solidFill>
                  <a:latin typeface="Arial" panose="020B0604020202020204" pitchFamily="34" charset="0"/>
                  <a:cs typeface="Arial" panose="020B0604020202020204" pitchFamily="34" charset="0"/>
                </a:rPr>
                <a:t>Log2FC</a:t>
              </a:r>
              <a:endParaRPr lang="en-US" sz="1200" b="1" dirty="0">
                <a:latin typeface="Arial" panose="020B0604020202020204" pitchFamily="34" charset="0"/>
                <a:cs typeface="Arial" panose="020B0604020202020204" pitchFamily="34" charset="0"/>
              </a:endParaRPr>
            </a:p>
          </p:txBody>
        </p:sp>
        <p:grpSp>
          <p:nvGrpSpPr>
            <p:cNvPr id="4" name="Group 3">
              <a:extLst>
                <a:ext uri="{FF2B5EF4-FFF2-40B4-BE49-F238E27FC236}">
                  <a16:creationId xmlns:a16="http://schemas.microsoft.com/office/drawing/2014/main" id="{50D4C389-4CA9-429D-83DE-97C288C6BF61}"/>
                </a:ext>
              </a:extLst>
            </p:cNvPr>
            <p:cNvGrpSpPr/>
            <p:nvPr/>
          </p:nvGrpSpPr>
          <p:grpSpPr>
            <a:xfrm>
              <a:off x="152400" y="495300"/>
              <a:ext cx="4597555" cy="977345"/>
              <a:chOff x="309498" y="748486"/>
              <a:chExt cx="6949440" cy="676656"/>
            </a:xfrm>
          </p:grpSpPr>
          <p:graphicFrame>
            <p:nvGraphicFramePr>
              <p:cNvPr id="69" name="Chart 68">
                <a:extLst>
                  <a:ext uri="{FF2B5EF4-FFF2-40B4-BE49-F238E27FC236}">
                    <a16:creationId xmlns:a16="http://schemas.microsoft.com/office/drawing/2014/main" id="{815E3BC1-3477-4892-BE2C-863D34DAF7E3}"/>
                  </a:ext>
                </a:extLst>
              </p:cNvPr>
              <p:cNvGraphicFramePr>
                <a:graphicFrameLocks/>
              </p:cNvGraphicFramePr>
              <p:nvPr>
                <p:extLst>
                  <p:ext uri="{D42A27DB-BD31-4B8C-83A1-F6EECF244321}">
                    <p14:modId xmlns:p14="http://schemas.microsoft.com/office/powerpoint/2010/main" val="2553905133"/>
                  </p:ext>
                </p:extLst>
              </p:nvPr>
            </p:nvGraphicFramePr>
            <p:xfrm>
              <a:off x="309498" y="748486"/>
              <a:ext cx="6949440" cy="67665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0" name="Chart 69">
                <a:extLst>
                  <a:ext uri="{FF2B5EF4-FFF2-40B4-BE49-F238E27FC236}">
                    <a16:creationId xmlns:a16="http://schemas.microsoft.com/office/drawing/2014/main" id="{EE5B626C-EA7E-4FB5-9C31-EB3A2BE3A447}"/>
                  </a:ext>
                </a:extLst>
              </p:cNvPr>
              <p:cNvGraphicFramePr>
                <a:graphicFrameLocks/>
              </p:cNvGraphicFramePr>
              <p:nvPr>
                <p:extLst>
                  <p:ext uri="{D42A27DB-BD31-4B8C-83A1-F6EECF244321}">
                    <p14:modId xmlns:p14="http://schemas.microsoft.com/office/powerpoint/2010/main" val="4128586704"/>
                  </p:ext>
                </p:extLst>
              </p:nvPr>
            </p:nvGraphicFramePr>
            <p:xfrm>
              <a:off x="309498" y="748486"/>
              <a:ext cx="6949440" cy="676656"/>
            </p:xfrm>
            <a:graphic>
              <a:graphicData uri="http://schemas.openxmlformats.org/drawingml/2006/chart">
                <c:chart xmlns:c="http://schemas.openxmlformats.org/drawingml/2006/chart" xmlns:r="http://schemas.openxmlformats.org/officeDocument/2006/relationships" r:id="rId3"/>
              </a:graphicData>
            </a:graphic>
          </p:graphicFrame>
        </p:grpSp>
        <p:grpSp>
          <p:nvGrpSpPr>
            <p:cNvPr id="5" name="Group 4">
              <a:extLst>
                <a:ext uri="{FF2B5EF4-FFF2-40B4-BE49-F238E27FC236}">
                  <a16:creationId xmlns:a16="http://schemas.microsoft.com/office/drawing/2014/main" id="{E1FF7954-9791-452B-9C7F-DCAC20569624}"/>
                </a:ext>
              </a:extLst>
            </p:cNvPr>
            <p:cNvGrpSpPr/>
            <p:nvPr/>
          </p:nvGrpSpPr>
          <p:grpSpPr>
            <a:xfrm>
              <a:off x="152400" y="1527634"/>
              <a:ext cx="4597555" cy="888495"/>
              <a:chOff x="172268" y="4258293"/>
              <a:chExt cx="6949440" cy="676656"/>
            </a:xfrm>
          </p:grpSpPr>
          <p:graphicFrame>
            <p:nvGraphicFramePr>
              <p:cNvPr id="67" name="Chart 66">
                <a:extLst>
                  <a:ext uri="{FF2B5EF4-FFF2-40B4-BE49-F238E27FC236}">
                    <a16:creationId xmlns:a16="http://schemas.microsoft.com/office/drawing/2014/main" id="{6A5170DD-F564-4AEC-9E0B-545928A29485}"/>
                  </a:ext>
                </a:extLst>
              </p:cNvPr>
              <p:cNvGraphicFramePr>
                <a:graphicFrameLocks/>
              </p:cNvGraphicFramePr>
              <p:nvPr>
                <p:extLst>
                  <p:ext uri="{D42A27DB-BD31-4B8C-83A1-F6EECF244321}">
                    <p14:modId xmlns:p14="http://schemas.microsoft.com/office/powerpoint/2010/main" val="2403221989"/>
                  </p:ext>
                </p:extLst>
              </p:nvPr>
            </p:nvGraphicFramePr>
            <p:xfrm>
              <a:off x="172268" y="4258293"/>
              <a:ext cx="6949440" cy="67665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8" name="Chart 67">
                <a:extLst>
                  <a:ext uri="{FF2B5EF4-FFF2-40B4-BE49-F238E27FC236}">
                    <a16:creationId xmlns:a16="http://schemas.microsoft.com/office/drawing/2014/main" id="{E742463F-8D0A-49D4-8805-D4C285F00BB0}"/>
                  </a:ext>
                </a:extLst>
              </p:cNvPr>
              <p:cNvGraphicFramePr>
                <a:graphicFrameLocks/>
              </p:cNvGraphicFramePr>
              <p:nvPr>
                <p:extLst>
                  <p:ext uri="{D42A27DB-BD31-4B8C-83A1-F6EECF244321}">
                    <p14:modId xmlns:p14="http://schemas.microsoft.com/office/powerpoint/2010/main" val="3662281959"/>
                  </p:ext>
                </p:extLst>
              </p:nvPr>
            </p:nvGraphicFramePr>
            <p:xfrm>
              <a:off x="172268" y="4258293"/>
              <a:ext cx="6949440" cy="676656"/>
            </p:xfrm>
            <a:graphic>
              <a:graphicData uri="http://schemas.openxmlformats.org/drawingml/2006/chart">
                <c:chart xmlns:c="http://schemas.openxmlformats.org/drawingml/2006/chart" xmlns:r="http://schemas.openxmlformats.org/officeDocument/2006/relationships" r:id="rId5"/>
              </a:graphicData>
            </a:graphic>
          </p:graphicFrame>
        </p:grpSp>
        <p:grpSp>
          <p:nvGrpSpPr>
            <p:cNvPr id="6" name="Group 5">
              <a:extLst>
                <a:ext uri="{FF2B5EF4-FFF2-40B4-BE49-F238E27FC236}">
                  <a16:creationId xmlns:a16="http://schemas.microsoft.com/office/drawing/2014/main" id="{BF30B19E-D92B-40A4-B958-B66A04B81843}"/>
                </a:ext>
              </a:extLst>
            </p:cNvPr>
            <p:cNvGrpSpPr/>
            <p:nvPr/>
          </p:nvGrpSpPr>
          <p:grpSpPr>
            <a:xfrm>
              <a:off x="152400" y="2413967"/>
              <a:ext cx="4597555" cy="888495"/>
              <a:chOff x="627911" y="993399"/>
              <a:chExt cx="6949440" cy="676656"/>
            </a:xfrm>
          </p:grpSpPr>
          <p:graphicFrame>
            <p:nvGraphicFramePr>
              <p:cNvPr id="65" name="Chart 64">
                <a:extLst>
                  <a:ext uri="{FF2B5EF4-FFF2-40B4-BE49-F238E27FC236}">
                    <a16:creationId xmlns:a16="http://schemas.microsoft.com/office/drawing/2014/main" id="{042615C5-AFBF-4157-8D17-E519A0A0B17E}"/>
                  </a:ext>
                </a:extLst>
              </p:cNvPr>
              <p:cNvGraphicFramePr>
                <a:graphicFrameLocks/>
              </p:cNvGraphicFramePr>
              <p:nvPr>
                <p:extLst>
                  <p:ext uri="{D42A27DB-BD31-4B8C-83A1-F6EECF244321}">
                    <p14:modId xmlns:p14="http://schemas.microsoft.com/office/powerpoint/2010/main" val="2518045591"/>
                  </p:ext>
                </p:extLst>
              </p:nvPr>
            </p:nvGraphicFramePr>
            <p:xfrm>
              <a:off x="627911" y="993399"/>
              <a:ext cx="6949440" cy="676656"/>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66" name="Chart 65">
                <a:extLst>
                  <a:ext uri="{FF2B5EF4-FFF2-40B4-BE49-F238E27FC236}">
                    <a16:creationId xmlns:a16="http://schemas.microsoft.com/office/drawing/2014/main" id="{CA367181-D25A-4670-A930-EDF4C2328DA9}"/>
                  </a:ext>
                </a:extLst>
              </p:cNvPr>
              <p:cNvGraphicFramePr>
                <a:graphicFrameLocks/>
              </p:cNvGraphicFramePr>
              <p:nvPr>
                <p:extLst>
                  <p:ext uri="{D42A27DB-BD31-4B8C-83A1-F6EECF244321}">
                    <p14:modId xmlns:p14="http://schemas.microsoft.com/office/powerpoint/2010/main" val="1162800085"/>
                  </p:ext>
                </p:extLst>
              </p:nvPr>
            </p:nvGraphicFramePr>
            <p:xfrm>
              <a:off x="627911" y="993399"/>
              <a:ext cx="6949440" cy="676656"/>
            </p:xfrm>
            <a:graphic>
              <a:graphicData uri="http://schemas.openxmlformats.org/drawingml/2006/chart">
                <c:chart xmlns:c="http://schemas.openxmlformats.org/drawingml/2006/chart" xmlns:r="http://schemas.openxmlformats.org/officeDocument/2006/relationships" r:id="rId7"/>
              </a:graphicData>
            </a:graphic>
          </p:graphicFrame>
        </p:grpSp>
        <p:grpSp>
          <p:nvGrpSpPr>
            <p:cNvPr id="7" name="Group 6">
              <a:extLst>
                <a:ext uri="{FF2B5EF4-FFF2-40B4-BE49-F238E27FC236}">
                  <a16:creationId xmlns:a16="http://schemas.microsoft.com/office/drawing/2014/main" id="{F653569C-9B38-492A-A12A-FF2A17D01530}"/>
                </a:ext>
              </a:extLst>
            </p:cNvPr>
            <p:cNvGrpSpPr/>
            <p:nvPr/>
          </p:nvGrpSpPr>
          <p:grpSpPr>
            <a:xfrm>
              <a:off x="152400" y="3376501"/>
              <a:ext cx="4597555" cy="888495"/>
              <a:chOff x="0" y="1061070"/>
              <a:chExt cx="6949440" cy="676656"/>
            </a:xfrm>
          </p:grpSpPr>
          <p:graphicFrame>
            <p:nvGraphicFramePr>
              <p:cNvPr id="63" name="Chart 62">
                <a:extLst>
                  <a:ext uri="{FF2B5EF4-FFF2-40B4-BE49-F238E27FC236}">
                    <a16:creationId xmlns:a16="http://schemas.microsoft.com/office/drawing/2014/main" id="{DAA22791-9F36-4E7B-B1AB-E5AF5F055250}"/>
                  </a:ext>
                </a:extLst>
              </p:cNvPr>
              <p:cNvGraphicFramePr>
                <a:graphicFrameLocks/>
              </p:cNvGraphicFramePr>
              <p:nvPr>
                <p:extLst>
                  <p:ext uri="{D42A27DB-BD31-4B8C-83A1-F6EECF244321}">
                    <p14:modId xmlns:p14="http://schemas.microsoft.com/office/powerpoint/2010/main" val="193272056"/>
                  </p:ext>
                </p:extLst>
              </p:nvPr>
            </p:nvGraphicFramePr>
            <p:xfrm>
              <a:off x="0" y="1061070"/>
              <a:ext cx="6949440" cy="676656"/>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64" name="Chart 63">
                <a:extLst>
                  <a:ext uri="{FF2B5EF4-FFF2-40B4-BE49-F238E27FC236}">
                    <a16:creationId xmlns:a16="http://schemas.microsoft.com/office/drawing/2014/main" id="{55BE6F7A-CEEC-412C-9EEB-B9C2066EC1D2}"/>
                  </a:ext>
                </a:extLst>
              </p:cNvPr>
              <p:cNvGraphicFramePr>
                <a:graphicFrameLocks/>
              </p:cNvGraphicFramePr>
              <p:nvPr>
                <p:extLst>
                  <p:ext uri="{D42A27DB-BD31-4B8C-83A1-F6EECF244321}">
                    <p14:modId xmlns:p14="http://schemas.microsoft.com/office/powerpoint/2010/main" val="2471849320"/>
                  </p:ext>
                </p:extLst>
              </p:nvPr>
            </p:nvGraphicFramePr>
            <p:xfrm>
              <a:off x="0" y="1061070"/>
              <a:ext cx="6949440" cy="676656"/>
            </p:xfrm>
            <a:graphic>
              <a:graphicData uri="http://schemas.openxmlformats.org/drawingml/2006/chart">
                <c:chart xmlns:c="http://schemas.openxmlformats.org/drawingml/2006/chart" xmlns:r="http://schemas.openxmlformats.org/officeDocument/2006/relationships" r:id="rId9"/>
              </a:graphicData>
            </a:graphic>
          </p:graphicFrame>
        </p:grpSp>
        <p:grpSp>
          <p:nvGrpSpPr>
            <p:cNvPr id="8" name="Group 7">
              <a:extLst>
                <a:ext uri="{FF2B5EF4-FFF2-40B4-BE49-F238E27FC236}">
                  <a16:creationId xmlns:a16="http://schemas.microsoft.com/office/drawing/2014/main" id="{48E3186B-7839-4DBC-BCF3-FC08C243272B}"/>
                </a:ext>
              </a:extLst>
            </p:cNvPr>
            <p:cNvGrpSpPr/>
            <p:nvPr/>
          </p:nvGrpSpPr>
          <p:grpSpPr>
            <a:xfrm>
              <a:off x="152400" y="4243785"/>
              <a:ext cx="4597555" cy="888495"/>
              <a:chOff x="818020" y="182072"/>
              <a:chExt cx="6949440" cy="676656"/>
            </a:xfrm>
          </p:grpSpPr>
          <p:graphicFrame>
            <p:nvGraphicFramePr>
              <p:cNvPr id="61" name="Chart 60">
                <a:extLst>
                  <a:ext uri="{FF2B5EF4-FFF2-40B4-BE49-F238E27FC236}">
                    <a16:creationId xmlns:a16="http://schemas.microsoft.com/office/drawing/2014/main" id="{647C28FA-710A-40A0-9D41-E90E88DFA9A7}"/>
                  </a:ext>
                </a:extLst>
              </p:cNvPr>
              <p:cNvGraphicFramePr>
                <a:graphicFrameLocks/>
              </p:cNvGraphicFramePr>
              <p:nvPr>
                <p:extLst>
                  <p:ext uri="{D42A27DB-BD31-4B8C-83A1-F6EECF244321}">
                    <p14:modId xmlns:p14="http://schemas.microsoft.com/office/powerpoint/2010/main" val="2195719879"/>
                  </p:ext>
                </p:extLst>
              </p:nvPr>
            </p:nvGraphicFramePr>
            <p:xfrm>
              <a:off x="818020" y="182072"/>
              <a:ext cx="6949440" cy="676656"/>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62" name="Chart 61">
                <a:extLst>
                  <a:ext uri="{FF2B5EF4-FFF2-40B4-BE49-F238E27FC236}">
                    <a16:creationId xmlns:a16="http://schemas.microsoft.com/office/drawing/2014/main" id="{2734DA6F-B93A-4084-A1EA-40BEB4CE7FFE}"/>
                  </a:ext>
                </a:extLst>
              </p:cNvPr>
              <p:cNvGraphicFramePr>
                <a:graphicFrameLocks/>
              </p:cNvGraphicFramePr>
              <p:nvPr>
                <p:extLst>
                  <p:ext uri="{D42A27DB-BD31-4B8C-83A1-F6EECF244321}">
                    <p14:modId xmlns:p14="http://schemas.microsoft.com/office/powerpoint/2010/main" val="4224117510"/>
                  </p:ext>
                </p:extLst>
              </p:nvPr>
            </p:nvGraphicFramePr>
            <p:xfrm>
              <a:off x="818020" y="182072"/>
              <a:ext cx="6949440" cy="676656"/>
            </p:xfrm>
            <a:graphic>
              <a:graphicData uri="http://schemas.openxmlformats.org/drawingml/2006/chart">
                <c:chart xmlns:c="http://schemas.openxmlformats.org/drawingml/2006/chart" xmlns:r="http://schemas.openxmlformats.org/officeDocument/2006/relationships" r:id="rId11"/>
              </a:graphicData>
            </a:graphic>
          </p:graphicFrame>
        </p:grpSp>
        <p:grpSp>
          <p:nvGrpSpPr>
            <p:cNvPr id="9" name="Group 8">
              <a:extLst>
                <a:ext uri="{FF2B5EF4-FFF2-40B4-BE49-F238E27FC236}">
                  <a16:creationId xmlns:a16="http://schemas.microsoft.com/office/drawing/2014/main" id="{DAACF6E4-2B30-4279-ACB0-BD94490B7A91}"/>
                </a:ext>
              </a:extLst>
            </p:cNvPr>
            <p:cNvGrpSpPr/>
            <p:nvPr/>
          </p:nvGrpSpPr>
          <p:grpSpPr>
            <a:xfrm>
              <a:off x="152400" y="5187269"/>
              <a:ext cx="4597555" cy="888495"/>
              <a:chOff x="0" y="1229039"/>
              <a:chExt cx="6949440" cy="676656"/>
            </a:xfrm>
          </p:grpSpPr>
          <p:graphicFrame>
            <p:nvGraphicFramePr>
              <p:cNvPr id="59" name="Chart 58">
                <a:extLst>
                  <a:ext uri="{FF2B5EF4-FFF2-40B4-BE49-F238E27FC236}">
                    <a16:creationId xmlns:a16="http://schemas.microsoft.com/office/drawing/2014/main" id="{88F08958-A7F3-4941-B255-D05E2CF804F1}"/>
                  </a:ext>
                </a:extLst>
              </p:cNvPr>
              <p:cNvGraphicFramePr>
                <a:graphicFrameLocks/>
              </p:cNvGraphicFramePr>
              <p:nvPr>
                <p:extLst>
                  <p:ext uri="{D42A27DB-BD31-4B8C-83A1-F6EECF244321}">
                    <p14:modId xmlns:p14="http://schemas.microsoft.com/office/powerpoint/2010/main" val="631179211"/>
                  </p:ext>
                </p:extLst>
              </p:nvPr>
            </p:nvGraphicFramePr>
            <p:xfrm>
              <a:off x="0" y="1229039"/>
              <a:ext cx="6949440" cy="676656"/>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60" name="Chart 59">
                <a:extLst>
                  <a:ext uri="{FF2B5EF4-FFF2-40B4-BE49-F238E27FC236}">
                    <a16:creationId xmlns:a16="http://schemas.microsoft.com/office/drawing/2014/main" id="{9527041C-1B61-4207-97D8-860906084525}"/>
                  </a:ext>
                </a:extLst>
              </p:cNvPr>
              <p:cNvGraphicFramePr>
                <a:graphicFrameLocks/>
              </p:cNvGraphicFramePr>
              <p:nvPr>
                <p:extLst>
                  <p:ext uri="{D42A27DB-BD31-4B8C-83A1-F6EECF244321}">
                    <p14:modId xmlns:p14="http://schemas.microsoft.com/office/powerpoint/2010/main" val="590534955"/>
                  </p:ext>
                </p:extLst>
              </p:nvPr>
            </p:nvGraphicFramePr>
            <p:xfrm>
              <a:off x="0" y="1229039"/>
              <a:ext cx="6949440" cy="676656"/>
            </p:xfrm>
            <a:graphic>
              <a:graphicData uri="http://schemas.openxmlformats.org/drawingml/2006/chart">
                <c:chart xmlns:c="http://schemas.openxmlformats.org/drawingml/2006/chart" xmlns:r="http://schemas.openxmlformats.org/officeDocument/2006/relationships" r:id="rId13"/>
              </a:graphicData>
            </a:graphic>
          </p:graphicFrame>
        </p:grpSp>
        <p:grpSp>
          <p:nvGrpSpPr>
            <p:cNvPr id="10" name="Group 9">
              <a:extLst>
                <a:ext uri="{FF2B5EF4-FFF2-40B4-BE49-F238E27FC236}">
                  <a16:creationId xmlns:a16="http://schemas.microsoft.com/office/drawing/2014/main" id="{E2C47479-7110-4619-A9F4-3C453304B829}"/>
                </a:ext>
              </a:extLst>
            </p:cNvPr>
            <p:cNvGrpSpPr/>
            <p:nvPr/>
          </p:nvGrpSpPr>
          <p:grpSpPr>
            <a:xfrm>
              <a:off x="152400" y="6111702"/>
              <a:ext cx="4597555" cy="888495"/>
              <a:chOff x="36576" y="217385"/>
              <a:chExt cx="6949440" cy="676656"/>
            </a:xfrm>
          </p:grpSpPr>
          <p:graphicFrame>
            <p:nvGraphicFramePr>
              <p:cNvPr id="57" name="Chart 56">
                <a:extLst>
                  <a:ext uri="{FF2B5EF4-FFF2-40B4-BE49-F238E27FC236}">
                    <a16:creationId xmlns:a16="http://schemas.microsoft.com/office/drawing/2014/main" id="{88D04668-B1DA-46B1-A4ED-77BFAACDD5AE}"/>
                  </a:ext>
                </a:extLst>
              </p:cNvPr>
              <p:cNvGraphicFramePr>
                <a:graphicFrameLocks/>
              </p:cNvGraphicFramePr>
              <p:nvPr>
                <p:extLst>
                  <p:ext uri="{D42A27DB-BD31-4B8C-83A1-F6EECF244321}">
                    <p14:modId xmlns:p14="http://schemas.microsoft.com/office/powerpoint/2010/main" val="3778716149"/>
                  </p:ext>
                </p:extLst>
              </p:nvPr>
            </p:nvGraphicFramePr>
            <p:xfrm>
              <a:off x="36576" y="217385"/>
              <a:ext cx="6949440" cy="676656"/>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58" name="Chart 57">
                <a:extLst>
                  <a:ext uri="{FF2B5EF4-FFF2-40B4-BE49-F238E27FC236}">
                    <a16:creationId xmlns:a16="http://schemas.microsoft.com/office/drawing/2014/main" id="{8D9528C4-4E8C-406A-B7F3-4722DAE5E09B}"/>
                  </a:ext>
                </a:extLst>
              </p:cNvPr>
              <p:cNvGraphicFramePr>
                <a:graphicFrameLocks/>
              </p:cNvGraphicFramePr>
              <p:nvPr>
                <p:extLst>
                  <p:ext uri="{D42A27DB-BD31-4B8C-83A1-F6EECF244321}">
                    <p14:modId xmlns:p14="http://schemas.microsoft.com/office/powerpoint/2010/main" val="2247690950"/>
                  </p:ext>
                </p:extLst>
              </p:nvPr>
            </p:nvGraphicFramePr>
            <p:xfrm>
              <a:off x="36576" y="217385"/>
              <a:ext cx="6949440" cy="676656"/>
            </p:xfrm>
            <a:graphic>
              <a:graphicData uri="http://schemas.openxmlformats.org/drawingml/2006/chart">
                <c:chart xmlns:c="http://schemas.openxmlformats.org/drawingml/2006/chart" xmlns:r="http://schemas.openxmlformats.org/officeDocument/2006/relationships" r:id="rId15"/>
              </a:graphicData>
            </a:graphic>
          </p:graphicFrame>
        </p:grpSp>
        <p:grpSp>
          <p:nvGrpSpPr>
            <p:cNvPr id="11" name="Group 10">
              <a:extLst>
                <a:ext uri="{FF2B5EF4-FFF2-40B4-BE49-F238E27FC236}">
                  <a16:creationId xmlns:a16="http://schemas.microsoft.com/office/drawing/2014/main" id="{6A55D013-87E1-4121-B0E7-4220741BD037}"/>
                </a:ext>
              </a:extLst>
            </p:cNvPr>
            <p:cNvGrpSpPr/>
            <p:nvPr/>
          </p:nvGrpSpPr>
          <p:grpSpPr>
            <a:xfrm>
              <a:off x="152400" y="7055182"/>
              <a:ext cx="4597555" cy="888495"/>
              <a:chOff x="0" y="810730"/>
              <a:chExt cx="6949440" cy="676656"/>
            </a:xfrm>
          </p:grpSpPr>
          <p:graphicFrame>
            <p:nvGraphicFramePr>
              <p:cNvPr id="55" name="Chart 54">
                <a:extLst>
                  <a:ext uri="{FF2B5EF4-FFF2-40B4-BE49-F238E27FC236}">
                    <a16:creationId xmlns:a16="http://schemas.microsoft.com/office/drawing/2014/main" id="{4F7C1E90-BE39-4308-B076-E99F1C633836}"/>
                  </a:ext>
                </a:extLst>
              </p:cNvPr>
              <p:cNvGraphicFramePr>
                <a:graphicFrameLocks/>
              </p:cNvGraphicFramePr>
              <p:nvPr>
                <p:extLst>
                  <p:ext uri="{D42A27DB-BD31-4B8C-83A1-F6EECF244321}">
                    <p14:modId xmlns:p14="http://schemas.microsoft.com/office/powerpoint/2010/main" val="3380571531"/>
                  </p:ext>
                </p:extLst>
              </p:nvPr>
            </p:nvGraphicFramePr>
            <p:xfrm>
              <a:off x="0" y="810730"/>
              <a:ext cx="6949440" cy="676656"/>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56" name="Chart 55">
                <a:extLst>
                  <a:ext uri="{FF2B5EF4-FFF2-40B4-BE49-F238E27FC236}">
                    <a16:creationId xmlns:a16="http://schemas.microsoft.com/office/drawing/2014/main" id="{10647AA8-1C87-472D-ACD0-5E4E24767C0D}"/>
                  </a:ext>
                </a:extLst>
              </p:cNvPr>
              <p:cNvGraphicFramePr>
                <a:graphicFrameLocks/>
              </p:cNvGraphicFramePr>
              <p:nvPr>
                <p:extLst>
                  <p:ext uri="{D42A27DB-BD31-4B8C-83A1-F6EECF244321}">
                    <p14:modId xmlns:p14="http://schemas.microsoft.com/office/powerpoint/2010/main" val="1582114132"/>
                  </p:ext>
                </p:extLst>
              </p:nvPr>
            </p:nvGraphicFramePr>
            <p:xfrm>
              <a:off x="0" y="810730"/>
              <a:ext cx="6949440" cy="676656"/>
            </p:xfrm>
            <a:graphic>
              <a:graphicData uri="http://schemas.openxmlformats.org/drawingml/2006/chart">
                <c:chart xmlns:c="http://schemas.openxmlformats.org/drawingml/2006/chart" xmlns:r="http://schemas.openxmlformats.org/officeDocument/2006/relationships" r:id="rId17"/>
              </a:graphicData>
            </a:graphic>
          </p:graphicFrame>
        </p:grpSp>
        <p:sp>
          <p:nvSpPr>
            <p:cNvPr id="21" name="TextBox 20">
              <a:extLst>
                <a:ext uri="{FF2B5EF4-FFF2-40B4-BE49-F238E27FC236}">
                  <a16:creationId xmlns:a16="http://schemas.microsoft.com/office/drawing/2014/main" id="{76BA3E8D-5CFF-4F2A-8095-6EE90103F24F}"/>
                </a:ext>
              </a:extLst>
            </p:cNvPr>
            <p:cNvSpPr txBox="1"/>
            <p:nvPr/>
          </p:nvSpPr>
          <p:spPr>
            <a:xfrm>
              <a:off x="563296" y="7946394"/>
              <a:ext cx="227948"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I</a:t>
              </a:r>
            </a:p>
          </p:txBody>
        </p:sp>
        <p:sp>
          <p:nvSpPr>
            <p:cNvPr id="22" name="TextBox 21">
              <a:extLst>
                <a:ext uri="{FF2B5EF4-FFF2-40B4-BE49-F238E27FC236}">
                  <a16:creationId xmlns:a16="http://schemas.microsoft.com/office/drawing/2014/main" id="{9A595C46-E773-4D3E-A25D-014650F89698}"/>
                </a:ext>
              </a:extLst>
            </p:cNvPr>
            <p:cNvSpPr txBox="1"/>
            <p:nvPr/>
          </p:nvSpPr>
          <p:spPr>
            <a:xfrm>
              <a:off x="736868" y="7946394"/>
              <a:ext cx="271228"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II</a:t>
              </a:r>
            </a:p>
          </p:txBody>
        </p:sp>
        <p:sp>
          <p:nvSpPr>
            <p:cNvPr id="23" name="TextBox 22">
              <a:extLst>
                <a:ext uri="{FF2B5EF4-FFF2-40B4-BE49-F238E27FC236}">
                  <a16:creationId xmlns:a16="http://schemas.microsoft.com/office/drawing/2014/main" id="{68518702-8FF1-43A1-9596-21E0023B661F}"/>
                </a:ext>
              </a:extLst>
            </p:cNvPr>
            <p:cNvSpPr txBox="1"/>
            <p:nvPr/>
          </p:nvSpPr>
          <p:spPr>
            <a:xfrm>
              <a:off x="912413" y="7946394"/>
              <a:ext cx="31451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III</a:t>
              </a:r>
            </a:p>
          </p:txBody>
        </p:sp>
        <p:sp>
          <p:nvSpPr>
            <p:cNvPr id="24" name="TextBox 23">
              <a:extLst>
                <a:ext uri="{FF2B5EF4-FFF2-40B4-BE49-F238E27FC236}">
                  <a16:creationId xmlns:a16="http://schemas.microsoft.com/office/drawing/2014/main" id="{0F6124F9-860E-4E4F-BE8D-89CFF5A7F280}"/>
                </a:ext>
              </a:extLst>
            </p:cNvPr>
            <p:cNvSpPr txBox="1"/>
            <p:nvPr/>
          </p:nvSpPr>
          <p:spPr>
            <a:xfrm>
              <a:off x="1235692" y="7946394"/>
              <a:ext cx="33054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IV</a:t>
              </a:r>
            </a:p>
          </p:txBody>
        </p:sp>
        <p:sp>
          <p:nvSpPr>
            <p:cNvPr id="25" name="TextBox 24">
              <a:extLst>
                <a:ext uri="{FF2B5EF4-FFF2-40B4-BE49-F238E27FC236}">
                  <a16:creationId xmlns:a16="http://schemas.microsoft.com/office/drawing/2014/main" id="{73BF5BC8-7D33-42F0-B177-916284A13452}"/>
                </a:ext>
              </a:extLst>
            </p:cNvPr>
            <p:cNvSpPr txBox="1"/>
            <p:nvPr/>
          </p:nvSpPr>
          <p:spPr>
            <a:xfrm>
              <a:off x="1579586" y="7946394"/>
              <a:ext cx="287258"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V</a:t>
              </a:r>
            </a:p>
          </p:txBody>
        </p:sp>
        <p:sp>
          <p:nvSpPr>
            <p:cNvPr id="26" name="TextBox 25">
              <a:extLst>
                <a:ext uri="{FF2B5EF4-FFF2-40B4-BE49-F238E27FC236}">
                  <a16:creationId xmlns:a16="http://schemas.microsoft.com/office/drawing/2014/main" id="{042D28F1-58D2-4291-A1AF-6A7B1F157A64}"/>
                </a:ext>
              </a:extLst>
            </p:cNvPr>
            <p:cNvSpPr txBox="1"/>
            <p:nvPr/>
          </p:nvSpPr>
          <p:spPr>
            <a:xfrm>
              <a:off x="1713734" y="7946394"/>
              <a:ext cx="33054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VI</a:t>
              </a:r>
            </a:p>
          </p:txBody>
        </p:sp>
        <p:sp>
          <p:nvSpPr>
            <p:cNvPr id="27" name="TextBox 26">
              <a:extLst>
                <a:ext uri="{FF2B5EF4-FFF2-40B4-BE49-F238E27FC236}">
                  <a16:creationId xmlns:a16="http://schemas.microsoft.com/office/drawing/2014/main" id="{570A8171-316D-4CFC-832C-BF2F6E8FE675}"/>
                </a:ext>
              </a:extLst>
            </p:cNvPr>
            <p:cNvSpPr txBox="1"/>
            <p:nvPr/>
          </p:nvSpPr>
          <p:spPr>
            <a:xfrm>
              <a:off x="1935198" y="7946394"/>
              <a:ext cx="37382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VII</a:t>
              </a:r>
            </a:p>
          </p:txBody>
        </p:sp>
        <p:sp>
          <p:nvSpPr>
            <p:cNvPr id="28" name="TextBox 27">
              <a:extLst>
                <a:ext uri="{FF2B5EF4-FFF2-40B4-BE49-F238E27FC236}">
                  <a16:creationId xmlns:a16="http://schemas.microsoft.com/office/drawing/2014/main" id="{C7D0FBCA-3382-46D9-B336-C48CAFBBE720}"/>
                </a:ext>
              </a:extLst>
            </p:cNvPr>
            <p:cNvSpPr txBox="1"/>
            <p:nvPr/>
          </p:nvSpPr>
          <p:spPr>
            <a:xfrm>
              <a:off x="2190311" y="7946394"/>
              <a:ext cx="417102"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VIII</a:t>
              </a:r>
            </a:p>
          </p:txBody>
        </p:sp>
        <p:sp>
          <p:nvSpPr>
            <p:cNvPr id="29" name="TextBox 28">
              <a:extLst>
                <a:ext uri="{FF2B5EF4-FFF2-40B4-BE49-F238E27FC236}">
                  <a16:creationId xmlns:a16="http://schemas.microsoft.com/office/drawing/2014/main" id="{34AE5CD8-3BCB-493A-A3D3-2EE381B74A61}"/>
                </a:ext>
              </a:extLst>
            </p:cNvPr>
            <p:cNvSpPr txBox="1"/>
            <p:nvPr/>
          </p:nvSpPr>
          <p:spPr>
            <a:xfrm>
              <a:off x="2384454" y="7946394"/>
              <a:ext cx="33054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IX</a:t>
              </a:r>
            </a:p>
          </p:txBody>
        </p:sp>
        <p:sp>
          <p:nvSpPr>
            <p:cNvPr id="30" name="TextBox 29">
              <a:extLst>
                <a:ext uri="{FF2B5EF4-FFF2-40B4-BE49-F238E27FC236}">
                  <a16:creationId xmlns:a16="http://schemas.microsoft.com/office/drawing/2014/main" id="{631B91EB-611C-4ADD-BD94-BC750F684AB5}"/>
                </a:ext>
              </a:extLst>
            </p:cNvPr>
            <p:cNvSpPr txBox="1"/>
            <p:nvPr/>
          </p:nvSpPr>
          <p:spPr>
            <a:xfrm>
              <a:off x="2597712" y="7946394"/>
              <a:ext cx="287258"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a:t>
              </a:r>
            </a:p>
          </p:txBody>
        </p:sp>
        <p:sp>
          <p:nvSpPr>
            <p:cNvPr id="31" name="TextBox 30">
              <a:extLst>
                <a:ext uri="{FF2B5EF4-FFF2-40B4-BE49-F238E27FC236}">
                  <a16:creationId xmlns:a16="http://schemas.microsoft.com/office/drawing/2014/main" id="{96E556B3-83ED-4378-805E-50600B9AADAC}"/>
                </a:ext>
              </a:extLst>
            </p:cNvPr>
            <p:cNvSpPr txBox="1"/>
            <p:nvPr/>
          </p:nvSpPr>
          <p:spPr>
            <a:xfrm>
              <a:off x="2826590" y="7946394"/>
              <a:ext cx="33054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I</a:t>
              </a:r>
            </a:p>
          </p:txBody>
        </p:sp>
        <p:sp>
          <p:nvSpPr>
            <p:cNvPr id="32" name="TextBox 31">
              <a:extLst>
                <a:ext uri="{FF2B5EF4-FFF2-40B4-BE49-F238E27FC236}">
                  <a16:creationId xmlns:a16="http://schemas.microsoft.com/office/drawing/2014/main" id="{0FBA3278-0ADB-43B5-8F4B-5E7E3B00ACF4}"/>
                </a:ext>
              </a:extLst>
            </p:cNvPr>
            <p:cNvSpPr txBox="1"/>
            <p:nvPr/>
          </p:nvSpPr>
          <p:spPr>
            <a:xfrm>
              <a:off x="3103914" y="7946394"/>
              <a:ext cx="37382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II</a:t>
              </a:r>
            </a:p>
          </p:txBody>
        </p:sp>
        <p:sp>
          <p:nvSpPr>
            <p:cNvPr id="33" name="TextBox 32">
              <a:extLst>
                <a:ext uri="{FF2B5EF4-FFF2-40B4-BE49-F238E27FC236}">
                  <a16:creationId xmlns:a16="http://schemas.microsoft.com/office/drawing/2014/main" id="{6CFDE7DA-2B3D-4995-A2C8-04A51775CCFF}"/>
                </a:ext>
              </a:extLst>
            </p:cNvPr>
            <p:cNvSpPr txBox="1"/>
            <p:nvPr/>
          </p:nvSpPr>
          <p:spPr>
            <a:xfrm>
              <a:off x="3430293" y="7946394"/>
              <a:ext cx="417102"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III</a:t>
              </a:r>
            </a:p>
          </p:txBody>
        </p:sp>
        <p:sp>
          <p:nvSpPr>
            <p:cNvPr id="34" name="TextBox 33">
              <a:extLst>
                <a:ext uri="{FF2B5EF4-FFF2-40B4-BE49-F238E27FC236}">
                  <a16:creationId xmlns:a16="http://schemas.microsoft.com/office/drawing/2014/main" id="{29DDA70D-3712-434C-B46F-117D472AA65D}"/>
                </a:ext>
              </a:extLst>
            </p:cNvPr>
            <p:cNvSpPr txBox="1"/>
            <p:nvPr/>
          </p:nvSpPr>
          <p:spPr>
            <a:xfrm>
              <a:off x="3706644" y="7946394"/>
              <a:ext cx="433132"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IV</a:t>
              </a:r>
            </a:p>
          </p:txBody>
        </p:sp>
        <p:sp>
          <p:nvSpPr>
            <p:cNvPr id="35" name="TextBox 34">
              <a:extLst>
                <a:ext uri="{FF2B5EF4-FFF2-40B4-BE49-F238E27FC236}">
                  <a16:creationId xmlns:a16="http://schemas.microsoft.com/office/drawing/2014/main" id="{3023B631-F2DD-46CE-97FC-627AA579BCC2}"/>
                </a:ext>
              </a:extLst>
            </p:cNvPr>
            <p:cNvSpPr txBox="1"/>
            <p:nvPr/>
          </p:nvSpPr>
          <p:spPr>
            <a:xfrm>
              <a:off x="4034171" y="7946394"/>
              <a:ext cx="389850"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V</a:t>
              </a:r>
            </a:p>
          </p:txBody>
        </p:sp>
        <p:sp>
          <p:nvSpPr>
            <p:cNvPr id="36" name="TextBox 35">
              <a:extLst>
                <a:ext uri="{FF2B5EF4-FFF2-40B4-BE49-F238E27FC236}">
                  <a16:creationId xmlns:a16="http://schemas.microsoft.com/office/drawing/2014/main" id="{EDA2FF62-2B3F-43FA-A480-25FBFB9688C8}"/>
                </a:ext>
              </a:extLst>
            </p:cNvPr>
            <p:cNvSpPr txBox="1"/>
            <p:nvPr/>
          </p:nvSpPr>
          <p:spPr>
            <a:xfrm>
              <a:off x="4306563" y="7946394"/>
              <a:ext cx="433132"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XVI</a:t>
              </a:r>
            </a:p>
          </p:txBody>
        </p:sp>
        <p:sp>
          <p:nvSpPr>
            <p:cNvPr id="37" name="TextBox 36">
              <a:extLst>
                <a:ext uri="{FF2B5EF4-FFF2-40B4-BE49-F238E27FC236}">
                  <a16:creationId xmlns:a16="http://schemas.microsoft.com/office/drawing/2014/main" id="{B9973541-9F6B-4E79-A875-1E259F4A1512}"/>
                </a:ext>
              </a:extLst>
            </p:cNvPr>
            <p:cNvSpPr txBox="1"/>
            <p:nvPr/>
          </p:nvSpPr>
          <p:spPr>
            <a:xfrm>
              <a:off x="4577438" y="7946394"/>
              <a:ext cx="356188" cy="276998"/>
            </a:xfrm>
            <a:prstGeom prst="rect">
              <a:avLst/>
            </a:prstGeom>
            <a:noFill/>
          </p:spPr>
          <p:txBody>
            <a:bodyPr wrap="none" rtlCol="0">
              <a:spAutoFit/>
            </a:bodyPr>
            <a:lstStyle/>
            <a:p>
              <a:pPr eaLnBrk="1" fontAlgn="auto" hangingPunct="1">
                <a:spcBef>
                  <a:spcPts val="0"/>
                </a:spcBef>
                <a:spcAft>
                  <a:spcPts val="0"/>
                </a:spcAft>
              </a:pPr>
              <a:r>
                <a:rPr lang="en-US" sz="1200" dirty="0">
                  <a:solidFill>
                    <a:prstClr val="black"/>
                  </a:solidFill>
                  <a:latin typeface="Arial" panose="020B0604020202020204" pitchFamily="34" charset="0"/>
                  <a:cs typeface="Arial" panose="020B0604020202020204" pitchFamily="34" charset="0"/>
                </a:rPr>
                <a:t>Mt</a:t>
              </a:r>
            </a:p>
          </p:txBody>
        </p:sp>
        <p:cxnSp>
          <p:nvCxnSpPr>
            <p:cNvPr id="38" name="Straight Connector 37">
              <a:extLst>
                <a:ext uri="{FF2B5EF4-FFF2-40B4-BE49-F238E27FC236}">
                  <a16:creationId xmlns:a16="http://schemas.microsoft.com/office/drawing/2014/main" id="{0BDA98AD-86B2-4890-8848-EFB848685E90}"/>
                </a:ext>
              </a:extLst>
            </p:cNvPr>
            <p:cNvCxnSpPr/>
            <p:nvPr/>
          </p:nvCxnSpPr>
          <p:spPr>
            <a:xfrm>
              <a:off x="540238" y="7979001"/>
              <a:ext cx="4134130" cy="0"/>
            </a:xfrm>
            <a:prstGeom prst="line">
              <a:avLst/>
            </a:prstGeom>
            <a:noFill/>
            <a:ln w="25400" cap="flat" cmpd="sng" algn="ctr">
              <a:solidFill>
                <a:srgbClr val="FF0000"/>
              </a:solidFill>
              <a:prstDash val="solid"/>
              <a:miter lim="800000"/>
            </a:ln>
            <a:effectLst/>
          </p:spPr>
        </p:cxnSp>
        <p:cxnSp>
          <p:nvCxnSpPr>
            <p:cNvPr id="39" name="Straight Connector 38">
              <a:extLst>
                <a:ext uri="{FF2B5EF4-FFF2-40B4-BE49-F238E27FC236}">
                  <a16:creationId xmlns:a16="http://schemas.microsoft.com/office/drawing/2014/main" id="{CF3E30E0-2B18-4595-9248-AE9CB94DB890}"/>
                </a:ext>
              </a:extLst>
            </p:cNvPr>
            <p:cNvCxnSpPr/>
            <p:nvPr/>
          </p:nvCxnSpPr>
          <p:spPr>
            <a:xfrm>
              <a:off x="682307"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0" name="Straight Connector 39">
              <a:extLst>
                <a:ext uri="{FF2B5EF4-FFF2-40B4-BE49-F238E27FC236}">
                  <a16:creationId xmlns:a16="http://schemas.microsoft.com/office/drawing/2014/main" id="{D291A4BA-7EB9-426F-8D82-E908490AA2DF}"/>
                </a:ext>
              </a:extLst>
            </p:cNvPr>
            <p:cNvCxnSpPr/>
            <p:nvPr/>
          </p:nvCxnSpPr>
          <p:spPr>
            <a:xfrm>
              <a:off x="943886"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1" name="Straight Connector 40">
              <a:extLst>
                <a:ext uri="{FF2B5EF4-FFF2-40B4-BE49-F238E27FC236}">
                  <a16:creationId xmlns:a16="http://schemas.microsoft.com/office/drawing/2014/main" id="{FA337323-BDBC-438C-A274-BBA4D1DF7849}"/>
                </a:ext>
              </a:extLst>
            </p:cNvPr>
            <p:cNvCxnSpPr/>
            <p:nvPr/>
          </p:nvCxnSpPr>
          <p:spPr>
            <a:xfrm>
              <a:off x="1057511"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2" name="Straight Connector 41">
              <a:extLst>
                <a:ext uri="{FF2B5EF4-FFF2-40B4-BE49-F238E27FC236}">
                  <a16:creationId xmlns:a16="http://schemas.microsoft.com/office/drawing/2014/main" id="{E0D09294-2638-4D75-9D25-A68BBAA79E18}"/>
                </a:ext>
              </a:extLst>
            </p:cNvPr>
            <p:cNvCxnSpPr/>
            <p:nvPr/>
          </p:nvCxnSpPr>
          <p:spPr>
            <a:xfrm>
              <a:off x="1568834"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3" name="Straight Connector 42">
              <a:extLst>
                <a:ext uri="{FF2B5EF4-FFF2-40B4-BE49-F238E27FC236}">
                  <a16:creationId xmlns:a16="http://schemas.microsoft.com/office/drawing/2014/main" id="{B943A93D-81B6-412C-B357-9852AD71731A}"/>
                </a:ext>
              </a:extLst>
            </p:cNvPr>
            <p:cNvCxnSpPr/>
            <p:nvPr/>
          </p:nvCxnSpPr>
          <p:spPr>
            <a:xfrm>
              <a:off x="1760580"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4" name="Straight Connector 43">
              <a:extLst>
                <a:ext uri="{FF2B5EF4-FFF2-40B4-BE49-F238E27FC236}">
                  <a16:creationId xmlns:a16="http://schemas.microsoft.com/office/drawing/2014/main" id="{045EC395-4CE9-4DFB-9C6B-535B05B22B64}"/>
                </a:ext>
              </a:extLst>
            </p:cNvPr>
            <p:cNvCxnSpPr/>
            <p:nvPr/>
          </p:nvCxnSpPr>
          <p:spPr>
            <a:xfrm>
              <a:off x="1852904"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5" name="Straight Connector 44">
              <a:extLst>
                <a:ext uri="{FF2B5EF4-FFF2-40B4-BE49-F238E27FC236}">
                  <a16:creationId xmlns:a16="http://schemas.microsoft.com/office/drawing/2014/main" id="{E92D4A44-EA26-4D1A-B05F-76DFBB5D088B}"/>
                </a:ext>
              </a:extLst>
            </p:cNvPr>
            <p:cNvCxnSpPr/>
            <p:nvPr/>
          </p:nvCxnSpPr>
          <p:spPr>
            <a:xfrm>
              <a:off x="2222193"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6" name="Straight Connector 45">
              <a:extLst>
                <a:ext uri="{FF2B5EF4-FFF2-40B4-BE49-F238E27FC236}">
                  <a16:creationId xmlns:a16="http://schemas.microsoft.com/office/drawing/2014/main" id="{BE70D79A-8597-415B-A816-3ECF97013D09}"/>
                </a:ext>
              </a:extLst>
            </p:cNvPr>
            <p:cNvCxnSpPr/>
            <p:nvPr/>
          </p:nvCxnSpPr>
          <p:spPr>
            <a:xfrm>
              <a:off x="2413938"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7" name="Straight Connector 46">
              <a:extLst>
                <a:ext uri="{FF2B5EF4-FFF2-40B4-BE49-F238E27FC236}">
                  <a16:creationId xmlns:a16="http://schemas.microsoft.com/office/drawing/2014/main" id="{58216ED1-584B-4949-B222-CF633D48D5C8}"/>
                </a:ext>
              </a:extLst>
            </p:cNvPr>
            <p:cNvCxnSpPr/>
            <p:nvPr/>
          </p:nvCxnSpPr>
          <p:spPr>
            <a:xfrm>
              <a:off x="2804532"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8" name="Straight Connector 47">
              <a:extLst>
                <a:ext uri="{FF2B5EF4-FFF2-40B4-BE49-F238E27FC236}">
                  <a16:creationId xmlns:a16="http://schemas.microsoft.com/office/drawing/2014/main" id="{5F145EA2-0A84-4EE2-BC6A-9EF8E30409A5}"/>
                </a:ext>
              </a:extLst>
            </p:cNvPr>
            <p:cNvCxnSpPr/>
            <p:nvPr/>
          </p:nvCxnSpPr>
          <p:spPr>
            <a:xfrm>
              <a:off x="2548871"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49" name="Straight Connector 48">
              <a:extLst>
                <a:ext uri="{FF2B5EF4-FFF2-40B4-BE49-F238E27FC236}">
                  <a16:creationId xmlns:a16="http://schemas.microsoft.com/office/drawing/2014/main" id="{BBFD9E50-ABCC-4DEA-ADC6-FEC73B169352}"/>
                </a:ext>
              </a:extLst>
            </p:cNvPr>
            <p:cNvCxnSpPr/>
            <p:nvPr/>
          </p:nvCxnSpPr>
          <p:spPr>
            <a:xfrm>
              <a:off x="3386871"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50" name="Straight Connector 49">
              <a:extLst>
                <a:ext uri="{FF2B5EF4-FFF2-40B4-BE49-F238E27FC236}">
                  <a16:creationId xmlns:a16="http://schemas.microsoft.com/office/drawing/2014/main" id="{D05EC7D3-E339-4ECD-8B52-A1CB39534486}"/>
                </a:ext>
              </a:extLst>
            </p:cNvPr>
            <p:cNvCxnSpPr/>
            <p:nvPr/>
          </p:nvCxnSpPr>
          <p:spPr>
            <a:xfrm>
              <a:off x="3031787"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51" name="Straight Connector 50">
              <a:extLst>
                <a:ext uri="{FF2B5EF4-FFF2-40B4-BE49-F238E27FC236}">
                  <a16:creationId xmlns:a16="http://schemas.microsoft.com/office/drawing/2014/main" id="{27B22A7C-B70D-42C8-8749-44646F5BFE47}"/>
                </a:ext>
              </a:extLst>
            </p:cNvPr>
            <p:cNvCxnSpPr/>
            <p:nvPr/>
          </p:nvCxnSpPr>
          <p:spPr>
            <a:xfrm>
              <a:off x="3699347"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52" name="Straight Connector 51">
              <a:extLst>
                <a:ext uri="{FF2B5EF4-FFF2-40B4-BE49-F238E27FC236}">
                  <a16:creationId xmlns:a16="http://schemas.microsoft.com/office/drawing/2014/main" id="{D645EF89-290E-40FB-BCF2-0E6E98CF343C}"/>
                </a:ext>
              </a:extLst>
            </p:cNvPr>
            <p:cNvCxnSpPr/>
            <p:nvPr/>
          </p:nvCxnSpPr>
          <p:spPr>
            <a:xfrm>
              <a:off x="3962109"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53" name="Straight Connector 52">
              <a:extLst>
                <a:ext uri="{FF2B5EF4-FFF2-40B4-BE49-F238E27FC236}">
                  <a16:creationId xmlns:a16="http://schemas.microsoft.com/office/drawing/2014/main" id="{F65DA431-B207-4916-98D9-A0CA8A124DA8}"/>
                </a:ext>
              </a:extLst>
            </p:cNvPr>
            <p:cNvCxnSpPr/>
            <p:nvPr/>
          </p:nvCxnSpPr>
          <p:spPr>
            <a:xfrm>
              <a:off x="4324296" y="682629"/>
              <a:ext cx="0" cy="6954694"/>
            </a:xfrm>
            <a:prstGeom prst="line">
              <a:avLst/>
            </a:prstGeom>
            <a:noFill/>
            <a:ln w="22225" cap="flat" cmpd="sng" algn="ctr">
              <a:solidFill>
                <a:sysClr val="window" lastClr="FFFFFF">
                  <a:lumMod val="75000"/>
                </a:sysClr>
              </a:solidFill>
              <a:prstDash val="sysDot"/>
              <a:miter lim="800000"/>
            </a:ln>
            <a:effectLst/>
          </p:spPr>
        </p:cxnSp>
        <p:cxnSp>
          <p:nvCxnSpPr>
            <p:cNvPr id="54" name="Straight Connector 53">
              <a:extLst>
                <a:ext uri="{FF2B5EF4-FFF2-40B4-BE49-F238E27FC236}">
                  <a16:creationId xmlns:a16="http://schemas.microsoft.com/office/drawing/2014/main" id="{4AFA95B3-A658-469F-89F7-6DD0DD2177D2}"/>
                </a:ext>
              </a:extLst>
            </p:cNvPr>
            <p:cNvCxnSpPr/>
            <p:nvPr/>
          </p:nvCxnSpPr>
          <p:spPr>
            <a:xfrm>
              <a:off x="4636771" y="682629"/>
              <a:ext cx="0" cy="6954694"/>
            </a:xfrm>
            <a:prstGeom prst="line">
              <a:avLst/>
            </a:prstGeom>
            <a:noFill/>
            <a:ln w="22225" cap="flat" cmpd="sng" algn="ctr">
              <a:solidFill>
                <a:sysClr val="window" lastClr="FFFFFF">
                  <a:lumMod val="75000"/>
                </a:sysClr>
              </a:solidFill>
              <a:prstDash val="sysDot"/>
              <a:miter lim="800000"/>
            </a:ln>
            <a:effectLst/>
          </p:spPr>
        </p:cxnSp>
        <p:sp>
          <p:nvSpPr>
            <p:cNvPr id="13" name="TextBox 12">
              <a:extLst>
                <a:ext uri="{FF2B5EF4-FFF2-40B4-BE49-F238E27FC236}">
                  <a16:creationId xmlns:a16="http://schemas.microsoft.com/office/drawing/2014/main" id="{B91E7136-A754-4A2C-8C62-7ED1F8B2DEB5}"/>
                </a:ext>
              </a:extLst>
            </p:cNvPr>
            <p:cNvSpPr txBox="1"/>
            <p:nvPr/>
          </p:nvSpPr>
          <p:spPr>
            <a:xfrm>
              <a:off x="4650167" y="706485"/>
              <a:ext cx="146546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2 </a:t>
              </a:r>
              <a:r>
                <a:rPr lang="en-US" sz="1200" dirty="0">
                  <a:latin typeface="Arial" panose="020B0604020202020204" pitchFamily="34" charset="0"/>
                  <a:cs typeface="Arial" panose="020B0604020202020204" pitchFamily="34" charset="0"/>
                  <a:sym typeface="Symbol"/>
                </a:rPr>
                <a:t></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sym typeface="Symbol"/>
                </a:rPr>
                <a:t></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a:t>
              </a:r>
              <a:endParaRPr lang="en-US" sz="1200" i="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CB7DD5B5-C7DC-454A-9E08-99F23DB18B36}"/>
                </a:ext>
              </a:extLst>
            </p:cNvPr>
            <p:cNvSpPr txBox="1"/>
            <p:nvPr/>
          </p:nvSpPr>
          <p:spPr>
            <a:xfrm>
              <a:off x="4650167" y="1764984"/>
              <a:ext cx="146546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 </a:t>
              </a:r>
              <a:r>
                <a:rPr lang="en-US" sz="1200" dirty="0">
                  <a:latin typeface="Arial" panose="020B0604020202020204" pitchFamily="34" charset="0"/>
                  <a:cs typeface="Arial" panose="020B0604020202020204" pitchFamily="34" charset="0"/>
                  <a:sym typeface="Symbol"/>
                </a:rPr>
                <a:t></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sym typeface="Symbol"/>
                </a:rPr>
                <a:t></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a:t>
              </a:r>
              <a:endParaRPr lang="en-US" sz="1200" i="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BBFDC6CD-1BD7-4D74-B0CD-E8928E901692}"/>
                </a:ext>
              </a:extLst>
            </p:cNvPr>
            <p:cNvSpPr txBox="1"/>
            <p:nvPr/>
          </p:nvSpPr>
          <p:spPr>
            <a:xfrm>
              <a:off x="4650167" y="2429359"/>
              <a:ext cx="221567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27 no change [</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sym typeface="Symbol"/>
                </a:rPr>
                <a:t></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a:t>
              </a:r>
              <a:endParaRPr lang="en-US" sz="1200" i="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C3380011-31A6-4BCB-A798-199D5774CFFC}"/>
                </a:ext>
              </a:extLst>
            </p:cNvPr>
            <p:cNvSpPr txBox="1"/>
            <p:nvPr/>
          </p:nvSpPr>
          <p:spPr>
            <a:xfrm>
              <a:off x="4650168" y="3475971"/>
              <a:ext cx="221567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08 </a:t>
              </a:r>
              <a:r>
                <a:rPr lang="en-US" sz="1200" dirty="0">
                  <a:latin typeface="Arial" panose="020B0604020202020204" pitchFamily="34" charset="0"/>
                  <a:cs typeface="Arial" panose="020B0604020202020204" pitchFamily="34" charset="0"/>
                  <a:sym typeface="Symbol"/>
                </a:rPr>
                <a:t></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no change </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a:t>
              </a:r>
              <a:endParaRPr lang="en-US" sz="1200" i="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3E279453-5EF3-496D-99F9-45BFD854F783}"/>
                </a:ext>
              </a:extLst>
            </p:cNvPr>
            <p:cNvSpPr txBox="1"/>
            <p:nvPr/>
          </p:nvSpPr>
          <p:spPr>
            <a:xfrm>
              <a:off x="4650167" y="4772669"/>
              <a:ext cx="1455462"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338 </a:t>
              </a:r>
              <a:r>
                <a:rPr lang="en-US" sz="1200" dirty="0">
                  <a:latin typeface="Arial" panose="020B0604020202020204" pitchFamily="34" charset="0"/>
                  <a:cs typeface="Arial" panose="020B0604020202020204" pitchFamily="34" charset="0"/>
                  <a:sym typeface="Symbol"/>
                </a:rPr>
                <a:t>no change </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sym typeface="Symbol"/>
                </a:rPr>
                <a:t> </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 </a:t>
              </a:r>
              <a:endParaRPr lang="en-US" sz="1200" i="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E51C2210-5235-45B1-8CFC-CDC2C4291877}"/>
                </a:ext>
              </a:extLst>
            </p:cNvPr>
            <p:cNvSpPr txBox="1"/>
            <p:nvPr/>
          </p:nvSpPr>
          <p:spPr>
            <a:xfrm>
              <a:off x="4650167" y="5622007"/>
              <a:ext cx="2204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11 </a:t>
              </a:r>
              <a:r>
                <a:rPr lang="en-US" sz="1200" dirty="0">
                  <a:latin typeface="Arial" panose="020B0604020202020204" pitchFamily="34" charset="0"/>
                  <a:cs typeface="Arial" panose="020B0604020202020204" pitchFamily="34" charset="0"/>
                  <a:sym typeface="Symbol"/>
                </a:rPr>
                <a:t></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SWI</a:t>
              </a:r>
              <a:r>
                <a:rPr lang="en-US" sz="1200" i="1"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no change </a:t>
              </a:r>
              <a:r>
                <a:rPr lang="en-US" sz="1200" i="1" dirty="0">
                  <a:latin typeface="Arial" panose="020B0604020202020204" pitchFamily="34" charset="0"/>
                  <a:cs typeface="Arial" panose="020B0604020202020204" pitchFamily="34" charset="0"/>
                </a:rPr>
                <a:t>swi1</a:t>
              </a:r>
              <a:r>
                <a:rPr lang="en-US" sz="1200" i="1" dirty="0">
                  <a:latin typeface="Arial" panose="020B0604020202020204" pitchFamily="34" charset="0"/>
                  <a:cs typeface="Arial" panose="020B0604020202020204" pitchFamily="34" charset="0"/>
                  <a:sym typeface="Symbol"/>
                </a:rPr>
                <a:t></a:t>
              </a:r>
              <a:endParaRPr lang="en-US" sz="1200" i="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FBE51BA7-2D14-4541-842F-F3B60E8F6821}"/>
                </a:ext>
              </a:extLst>
            </p:cNvPr>
            <p:cNvSpPr txBox="1"/>
            <p:nvPr/>
          </p:nvSpPr>
          <p:spPr>
            <a:xfrm>
              <a:off x="4650167" y="5999770"/>
              <a:ext cx="87395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72 </a:t>
              </a:r>
              <a:r>
                <a:rPr lang="en-US" sz="1200" dirty="0">
                  <a:latin typeface="Arial" panose="020B0604020202020204" pitchFamily="34" charset="0"/>
                  <a:cs typeface="Arial" panose="020B0604020202020204" pitchFamily="34" charset="0"/>
                  <a:sym typeface="Symbol"/>
                </a:rPr>
                <a:t>both</a:t>
              </a:r>
              <a:endParaRPr lang="en-US" sz="1200" i="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14010076-D521-4153-AC15-CF2814D5A38F}"/>
                </a:ext>
              </a:extLst>
            </p:cNvPr>
            <p:cNvSpPr txBox="1"/>
            <p:nvPr/>
          </p:nvSpPr>
          <p:spPr>
            <a:xfrm>
              <a:off x="4650167" y="7643510"/>
              <a:ext cx="7889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44 </a:t>
              </a:r>
              <a:r>
                <a:rPr lang="en-US" sz="1200" dirty="0">
                  <a:latin typeface="Arial" panose="020B0604020202020204" pitchFamily="34" charset="0"/>
                  <a:cs typeface="Arial" panose="020B0604020202020204" pitchFamily="34" charset="0"/>
                  <a:sym typeface="Symbol"/>
                </a:rPr>
                <a:t>both</a:t>
              </a:r>
              <a:endParaRPr lang="en-US" sz="1200" i="1" dirty="0">
                <a:latin typeface="Arial" panose="020B0604020202020204" pitchFamily="34" charset="0"/>
                <a:cs typeface="Arial" panose="020B0604020202020204" pitchFamily="34" charset="0"/>
              </a:endParaRPr>
            </a:p>
          </p:txBody>
        </p:sp>
      </p:grpSp>
      <p:sp>
        <p:nvSpPr>
          <p:cNvPr id="71" name="TextBox 70">
            <a:extLst>
              <a:ext uri="{FF2B5EF4-FFF2-40B4-BE49-F238E27FC236}">
                <a16:creationId xmlns:a16="http://schemas.microsoft.com/office/drawing/2014/main" id="{F75CB7C9-B2B2-4C73-A4DE-CEC16334D342}"/>
              </a:ext>
            </a:extLst>
          </p:cNvPr>
          <p:cNvSpPr txBox="1"/>
          <p:nvPr/>
        </p:nvSpPr>
        <p:spPr>
          <a:xfrm>
            <a:off x="137781" y="82876"/>
            <a:ext cx="827471"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Figure S3</a:t>
            </a:r>
          </a:p>
        </p:txBody>
      </p:sp>
      <p:sp>
        <p:nvSpPr>
          <p:cNvPr id="72" name="TextBox 71">
            <a:extLst>
              <a:ext uri="{FF2B5EF4-FFF2-40B4-BE49-F238E27FC236}">
                <a16:creationId xmlns:a16="http://schemas.microsoft.com/office/drawing/2014/main" id="{93A10C23-F332-4DE0-B0C7-44C4DC47F3EC}"/>
              </a:ext>
            </a:extLst>
          </p:cNvPr>
          <p:cNvSpPr txBox="1"/>
          <p:nvPr/>
        </p:nvSpPr>
        <p:spPr>
          <a:xfrm>
            <a:off x="275418" y="7484490"/>
            <a:ext cx="6404632"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3. </a:t>
            </a:r>
            <a:r>
              <a:rPr lang="en-US" sz="1200" dirty="0">
                <a:latin typeface="Arial" panose="020B0604020202020204" pitchFamily="34" charset="0"/>
                <a:cs typeface="Arial" panose="020B0604020202020204" pitchFamily="34" charset="0"/>
              </a:rPr>
              <a:t>Distribution of individual DEGs on each chromosome of the genome. DEGs from the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swi1∆</a:t>
            </a:r>
            <a:r>
              <a:rPr lang="en-US" sz="1200" dirty="0">
                <a:latin typeface="Arial" panose="020B0604020202020204" pitchFamily="34" charset="0"/>
                <a:cs typeface="Arial" panose="020B0604020202020204" pitchFamily="34" charset="0"/>
              </a:rPr>
              <a:t> strains were divided into 8 categories based on their regulatory patterns and were coordinated to their positions in the genome. The log2FC of each DEG is shown as blue (for the prion) or red (for the deletion) bars (Note, a solid line means a gene location on one strand, and a dotted line means a gene location on the opposite strand). </a:t>
            </a:r>
          </a:p>
        </p:txBody>
      </p:sp>
    </p:spTree>
    <p:extLst>
      <p:ext uri="{BB962C8B-B14F-4D97-AF65-F5344CB8AC3E}">
        <p14:creationId xmlns:p14="http://schemas.microsoft.com/office/powerpoint/2010/main" val="20920029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774653F8-D3D3-4FEF-AE1C-470054ACA90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0274" y="488962"/>
            <a:ext cx="3081886" cy="2830686"/>
          </a:xfrm>
          <a:prstGeom prst="rect">
            <a:avLst/>
          </a:prstGeom>
        </p:spPr>
      </p:pic>
      <p:pic>
        <p:nvPicPr>
          <p:cNvPr id="10" name="Picture 9" descr="A picture containing map, text&#10;&#10;Description automatically generated">
            <a:extLst>
              <a:ext uri="{FF2B5EF4-FFF2-40B4-BE49-F238E27FC236}">
                <a16:creationId xmlns:a16="http://schemas.microsoft.com/office/drawing/2014/main" id="{07184924-0406-4D2E-8C96-1C815A789DC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06433" y="389968"/>
            <a:ext cx="3626721" cy="2940078"/>
          </a:xfrm>
          <a:prstGeom prst="rect">
            <a:avLst/>
          </a:prstGeom>
        </p:spPr>
      </p:pic>
      <p:pic>
        <p:nvPicPr>
          <p:cNvPr id="16" name="Picture 15">
            <a:extLst>
              <a:ext uri="{FF2B5EF4-FFF2-40B4-BE49-F238E27FC236}">
                <a16:creationId xmlns:a16="http://schemas.microsoft.com/office/drawing/2014/main" id="{01437FF4-95D1-444F-BC2F-156209CD8A7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71474" y="3770316"/>
            <a:ext cx="2975627" cy="3126292"/>
          </a:xfrm>
          <a:prstGeom prst="rect">
            <a:avLst/>
          </a:prstGeom>
        </p:spPr>
      </p:pic>
      <p:pic>
        <p:nvPicPr>
          <p:cNvPr id="18" name="Picture 17" descr="A picture containing text&#10;&#10;Description automatically generated">
            <a:extLst>
              <a:ext uri="{FF2B5EF4-FFF2-40B4-BE49-F238E27FC236}">
                <a16:creationId xmlns:a16="http://schemas.microsoft.com/office/drawing/2014/main" id="{3FE8591D-0772-4A26-854D-EB951BC3E78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56478" y="3802038"/>
            <a:ext cx="3226828" cy="2728434"/>
          </a:xfrm>
          <a:prstGeom prst="rect">
            <a:avLst/>
          </a:prstGeom>
        </p:spPr>
      </p:pic>
      <p:sp>
        <p:nvSpPr>
          <p:cNvPr id="12" name="TextBox 11">
            <a:extLst>
              <a:ext uri="{FF2B5EF4-FFF2-40B4-BE49-F238E27FC236}">
                <a16:creationId xmlns:a16="http://schemas.microsoft.com/office/drawing/2014/main" id="{E9BA771A-EC1B-4DEB-AA3D-65ACE9347FFA}"/>
              </a:ext>
            </a:extLst>
          </p:cNvPr>
          <p:cNvSpPr txBox="1"/>
          <p:nvPr/>
        </p:nvSpPr>
        <p:spPr>
          <a:xfrm>
            <a:off x="137781" y="82876"/>
            <a:ext cx="88678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igure S4</a:t>
            </a:r>
          </a:p>
        </p:txBody>
      </p:sp>
      <p:sp>
        <p:nvSpPr>
          <p:cNvPr id="13" name="Text Box 97">
            <a:extLst>
              <a:ext uri="{FF2B5EF4-FFF2-40B4-BE49-F238E27FC236}">
                <a16:creationId xmlns:a16="http://schemas.microsoft.com/office/drawing/2014/main" id="{A7E524D0-47BD-4C78-9342-E68712EDCE55}"/>
              </a:ext>
            </a:extLst>
          </p:cNvPr>
          <p:cNvSpPr txBox="1">
            <a:spLocks noChangeArrowheads="1"/>
          </p:cNvSpPr>
          <p:nvPr/>
        </p:nvSpPr>
        <p:spPr bwMode="auto">
          <a:xfrm>
            <a:off x="254452" y="353692"/>
            <a:ext cx="26962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itchFamily="34" charset="0"/>
              </a:rPr>
              <a:t>a</a:t>
            </a:r>
          </a:p>
        </p:txBody>
      </p:sp>
      <p:sp>
        <p:nvSpPr>
          <p:cNvPr id="14" name="Text Box 97">
            <a:extLst>
              <a:ext uri="{FF2B5EF4-FFF2-40B4-BE49-F238E27FC236}">
                <a16:creationId xmlns:a16="http://schemas.microsoft.com/office/drawing/2014/main" id="{80650B4B-9D3D-48D8-9F88-480E3B89A626}"/>
              </a:ext>
            </a:extLst>
          </p:cNvPr>
          <p:cNvSpPr txBox="1">
            <a:spLocks noChangeArrowheads="1"/>
          </p:cNvSpPr>
          <p:nvPr/>
        </p:nvSpPr>
        <p:spPr bwMode="auto">
          <a:xfrm>
            <a:off x="3188701" y="389968"/>
            <a:ext cx="27924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itchFamily="34" charset="0"/>
              </a:rPr>
              <a:t>b</a:t>
            </a:r>
          </a:p>
        </p:txBody>
      </p:sp>
      <p:sp>
        <p:nvSpPr>
          <p:cNvPr id="15" name="Text Box 97">
            <a:extLst>
              <a:ext uri="{FF2B5EF4-FFF2-40B4-BE49-F238E27FC236}">
                <a16:creationId xmlns:a16="http://schemas.microsoft.com/office/drawing/2014/main" id="{73A8B27A-3E2B-4B46-AAE6-2800F5E29C14}"/>
              </a:ext>
            </a:extLst>
          </p:cNvPr>
          <p:cNvSpPr txBox="1">
            <a:spLocks noChangeArrowheads="1"/>
          </p:cNvSpPr>
          <p:nvPr/>
        </p:nvSpPr>
        <p:spPr bwMode="auto">
          <a:xfrm>
            <a:off x="219637" y="3585142"/>
            <a:ext cx="26962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itchFamily="34" charset="0"/>
              </a:rPr>
              <a:t>c</a:t>
            </a:r>
          </a:p>
        </p:txBody>
      </p:sp>
      <p:sp>
        <p:nvSpPr>
          <p:cNvPr id="20" name="Text Box 97">
            <a:extLst>
              <a:ext uri="{FF2B5EF4-FFF2-40B4-BE49-F238E27FC236}">
                <a16:creationId xmlns:a16="http://schemas.microsoft.com/office/drawing/2014/main" id="{D65644ED-CEF3-4768-9DB8-19D55FE12896}"/>
              </a:ext>
            </a:extLst>
          </p:cNvPr>
          <p:cNvSpPr txBox="1">
            <a:spLocks noChangeArrowheads="1"/>
          </p:cNvSpPr>
          <p:nvPr/>
        </p:nvSpPr>
        <p:spPr bwMode="auto">
          <a:xfrm>
            <a:off x="3153886" y="3621418"/>
            <a:ext cx="27924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itchFamily="34" charset="0"/>
              </a:rPr>
              <a:t>d</a:t>
            </a:r>
          </a:p>
        </p:txBody>
      </p:sp>
      <p:sp>
        <p:nvSpPr>
          <p:cNvPr id="22" name="TextBox 21">
            <a:extLst>
              <a:ext uri="{FF2B5EF4-FFF2-40B4-BE49-F238E27FC236}">
                <a16:creationId xmlns:a16="http://schemas.microsoft.com/office/drawing/2014/main" id="{F8F12907-3856-4BDC-9344-85326EC575CD}"/>
              </a:ext>
            </a:extLst>
          </p:cNvPr>
          <p:cNvSpPr txBox="1"/>
          <p:nvPr/>
        </p:nvSpPr>
        <p:spPr>
          <a:xfrm>
            <a:off x="219637" y="6918286"/>
            <a:ext cx="6563669" cy="193899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4. </a:t>
            </a:r>
            <a:r>
              <a:rPr lang="en-US" sz="1200" dirty="0">
                <a:latin typeface="Arial" panose="020B0604020202020204" pitchFamily="34" charset="0"/>
                <a:cs typeface="Arial" panose="020B0604020202020204" pitchFamily="34" charset="0"/>
              </a:rPr>
              <a:t>The TF / targets regulatory network for TFs activated or repressed in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cells.  This was done by YEASTRACT, and the interactive image was drawn with a force-directed layout that is provided by the platform.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Seven TF genes activated in prion cells (serving as activators) versus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activated DEGs.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Seven TF genes activated in prion cells (serving as inhibitors) versus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inhibited DEGs.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Fifteen TF genes repressed in prion cells (serving as activators) versus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inhibited DEGs.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Fifteen TF genes repressed in prion cells (serving as inhibitors) versus [</a:t>
            </a:r>
            <a:r>
              <a:rPr lang="en-US" sz="1200" i="1" dirty="0">
                <a:latin typeface="Arial" panose="020B0604020202020204" pitchFamily="34" charset="0"/>
                <a:cs typeface="Arial" panose="020B0604020202020204" pitchFamily="34" charset="0"/>
              </a:rPr>
              <a:t>SWI</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activated DEGs. The analysis is based on expression and DNA-binding data. All TF genes are in blue dots and targets are in yellow dots. Black line, DNA-binding evidence; dotted green line , activation; dotted red line, inhibition;  dotted brown line, can be activation or inhibition.</a:t>
            </a:r>
          </a:p>
        </p:txBody>
      </p:sp>
    </p:spTree>
    <p:extLst>
      <p:ext uri="{BB962C8B-B14F-4D97-AF65-F5344CB8AC3E}">
        <p14:creationId xmlns:p14="http://schemas.microsoft.com/office/powerpoint/2010/main" val="20767109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text on a white background&#10;&#10;Description automatically generated">
            <a:extLst>
              <a:ext uri="{FF2B5EF4-FFF2-40B4-BE49-F238E27FC236}">
                <a16:creationId xmlns:a16="http://schemas.microsoft.com/office/drawing/2014/main" id="{6352938E-9ED6-4CE3-8820-5D3092786100}"/>
              </a:ext>
            </a:extLst>
          </p:cNvPr>
          <p:cNvPicPr preferRelativeResize="0">
            <a:picLocks/>
          </p:cNvPicPr>
          <p:nvPr/>
        </p:nvPicPr>
        <p:blipFill rotWithShape="1">
          <a:blip r:embed="rId2">
            <a:extLst>
              <a:ext uri="{28A0092B-C50C-407E-A947-70E740481C1C}">
                <a14:useLocalDpi xmlns:a14="http://schemas.microsoft.com/office/drawing/2010/main" val="0"/>
              </a:ext>
            </a:extLst>
          </a:blip>
          <a:srcRect t="9961" r="74268" b="7017"/>
          <a:stretch/>
        </p:blipFill>
        <p:spPr>
          <a:xfrm>
            <a:off x="128007" y="303984"/>
            <a:ext cx="2524790" cy="7380668"/>
          </a:xfrm>
          <a:prstGeom prst="rect">
            <a:avLst/>
          </a:prstGeom>
        </p:spPr>
      </p:pic>
      <p:sp>
        <p:nvSpPr>
          <p:cNvPr id="8" name="Rectangle 7">
            <a:extLst>
              <a:ext uri="{FF2B5EF4-FFF2-40B4-BE49-F238E27FC236}">
                <a16:creationId xmlns:a16="http://schemas.microsoft.com/office/drawing/2014/main" id="{33120C9B-D710-41CE-900C-FA9C3D93A097}"/>
              </a:ext>
            </a:extLst>
          </p:cNvPr>
          <p:cNvSpPr/>
          <p:nvPr/>
        </p:nvSpPr>
        <p:spPr>
          <a:xfrm>
            <a:off x="2595647" y="257315"/>
            <a:ext cx="3895060" cy="7530267"/>
          </a:xfrm>
          <a:prstGeom prst="rect">
            <a:avLst/>
          </a:prstGeom>
        </p:spPr>
        <p:txBody>
          <a:bodyPr wrap="square">
            <a:spAutoFit/>
          </a:bodyPr>
          <a:lstStyle/>
          <a:p>
            <a:pPr>
              <a:lnSpc>
                <a:spcPts val="1000"/>
              </a:lnSpc>
            </a:pPr>
            <a:r>
              <a:rPr lang="en-US" sz="1000" dirty="0">
                <a:solidFill>
                  <a:srgbClr val="0070C0"/>
                </a:solidFill>
                <a:latin typeface="Arial" panose="020B0604020202020204" pitchFamily="34" charset="0"/>
                <a:cs typeface="Arial" panose="020B0604020202020204" pitchFamily="34" charset="0"/>
              </a:rPr>
              <a:t>response to external stimulus</a:t>
            </a:r>
          </a:p>
          <a:p>
            <a:pPr>
              <a:lnSpc>
                <a:spcPts val="1000"/>
              </a:lnSpc>
            </a:pPr>
            <a:r>
              <a:rPr lang="en-US" sz="1000" dirty="0">
                <a:solidFill>
                  <a:srgbClr val="0070C0"/>
                </a:solidFill>
                <a:latin typeface="Arial" panose="020B0604020202020204" pitchFamily="34" charset="0"/>
                <a:cs typeface="Arial" panose="020B0604020202020204" pitchFamily="34" charset="0"/>
              </a:rPr>
              <a:t>oligosaccharide me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small molecule ca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response to inorganic substance</a:t>
            </a:r>
          </a:p>
          <a:p>
            <a:pPr>
              <a:lnSpc>
                <a:spcPts val="1000"/>
              </a:lnSpc>
            </a:pPr>
            <a:r>
              <a:rPr lang="en-US" sz="1000" dirty="0">
                <a:solidFill>
                  <a:srgbClr val="0070C0"/>
                </a:solidFill>
                <a:latin typeface="Arial" panose="020B0604020202020204" pitchFamily="34" charset="0"/>
                <a:cs typeface="Arial" panose="020B0604020202020204" pitchFamily="34" charset="0"/>
              </a:rPr>
              <a:t>glycogen me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antibiotic me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energy derivation by oxidation of organic compounds</a:t>
            </a:r>
          </a:p>
          <a:p>
            <a:pPr>
              <a:lnSpc>
                <a:spcPts val="1000"/>
              </a:lnSpc>
            </a:pPr>
            <a:r>
              <a:rPr lang="en-US" sz="1000" dirty="0">
                <a:solidFill>
                  <a:srgbClr val="0070C0"/>
                </a:solidFill>
                <a:latin typeface="Arial" panose="020B0604020202020204" pitchFamily="34" charset="0"/>
                <a:cs typeface="Arial" panose="020B0604020202020204" pitchFamily="34" charset="0"/>
              </a:rPr>
              <a:t>oxidation-reduction process</a:t>
            </a:r>
          </a:p>
          <a:p>
            <a:pPr>
              <a:lnSpc>
                <a:spcPts val="1000"/>
              </a:lnSpc>
            </a:pPr>
            <a:r>
              <a:rPr lang="en-US" sz="1000" dirty="0">
                <a:solidFill>
                  <a:srgbClr val="0070C0"/>
                </a:solidFill>
                <a:latin typeface="Arial" panose="020B0604020202020204" pitchFamily="34" charset="0"/>
                <a:cs typeface="Arial" panose="020B0604020202020204" pitchFamily="34" charset="0"/>
              </a:rPr>
              <a:t>membrane raft</a:t>
            </a:r>
          </a:p>
          <a:p>
            <a:pPr>
              <a:lnSpc>
                <a:spcPts val="1000"/>
              </a:lnSpc>
            </a:pPr>
            <a:r>
              <a:rPr lang="en-US" sz="1000" dirty="0">
                <a:solidFill>
                  <a:srgbClr val="0070C0"/>
                </a:solidFill>
                <a:latin typeface="Arial" panose="020B0604020202020204" pitchFamily="34" charset="0"/>
                <a:cs typeface="Arial" panose="020B0604020202020204" pitchFamily="34" charset="0"/>
              </a:rPr>
              <a:t>positive regulation of ion transport</a:t>
            </a:r>
          </a:p>
          <a:p>
            <a:pPr>
              <a:lnSpc>
                <a:spcPts val="1000"/>
              </a:lnSpc>
            </a:pPr>
            <a:r>
              <a:rPr lang="en-US" sz="1000" dirty="0">
                <a:solidFill>
                  <a:srgbClr val="0070C0"/>
                </a:solidFill>
                <a:latin typeface="Arial" panose="020B0604020202020204" pitchFamily="34" charset="0"/>
                <a:cs typeface="Arial" panose="020B0604020202020204" pitchFamily="34" charset="0"/>
              </a:rPr>
              <a:t>NADP me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monocarboxylic acid transport</a:t>
            </a:r>
          </a:p>
          <a:p>
            <a:pPr>
              <a:lnSpc>
                <a:spcPts val="1000"/>
              </a:lnSpc>
            </a:pPr>
            <a:r>
              <a:rPr lang="en-US" sz="1000" dirty="0">
                <a:solidFill>
                  <a:srgbClr val="0070C0"/>
                </a:solidFill>
                <a:latin typeface="Arial" panose="020B0604020202020204" pitchFamily="34" charset="0"/>
                <a:cs typeface="Arial" panose="020B0604020202020204" pitchFamily="34" charset="0"/>
              </a:rPr>
              <a:t>negative regulation of hydrolase activity</a:t>
            </a:r>
          </a:p>
          <a:p>
            <a:pPr>
              <a:lnSpc>
                <a:spcPts val="1000"/>
              </a:lnSpc>
            </a:pPr>
            <a:r>
              <a:rPr lang="en-US" sz="1000" dirty="0">
                <a:solidFill>
                  <a:srgbClr val="0070C0"/>
                </a:solidFill>
                <a:latin typeface="Arial" panose="020B0604020202020204" pitchFamily="34" charset="0"/>
                <a:cs typeface="Arial" panose="020B0604020202020204" pitchFamily="34" charset="0"/>
              </a:rPr>
              <a:t>transaminase activity</a:t>
            </a:r>
          </a:p>
          <a:p>
            <a:pPr>
              <a:lnSpc>
                <a:spcPts val="1000"/>
              </a:lnSpc>
            </a:pPr>
            <a:r>
              <a:rPr lang="en-US" sz="1000" dirty="0">
                <a:solidFill>
                  <a:srgbClr val="0070C0"/>
                </a:solidFill>
                <a:latin typeface="Arial" panose="020B0604020202020204" pitchFamily="34" charset="0"/>
                <a:cs typeface="Arial" panose="020B0604020202020204" pitchFamily="34" charset="0"/>
              </a:rPr>
              <a:t>amino-acid betaine metabolic process</a:t>
            </a:r>
          </a:p>
          <a:p>
            <a:pPr>
              <a:lnSpc>
                <a:spcPts val="1000"/>
              </a:lnSpc>
            </a:pPr>
            <a:r>
              <a:rPr lang="en-US" sz="1000" dirty="0">
                <a:solidFill>
                  <a:srgbClr val="0070C0"/>
                </a:solidFill>
                <a:latin typeface="Arial" panose="020B0604020202020204" pitchFamily="34" charset="0"/>
                <a:cs typeface="Arial" panose="020B0604020202020204" pitchFamily="34" charset="0"/>
              </a:rPr>
              <a:t>UDP-glucosyltransferase activity</a:t>
            </a:r>
          </a:p>
          <a:p>
            <a:pPr>
              <a:lnSpc>
                <a:spcPts val="1000"/>
              </a:lnSpc>
            </a:pPr>
            <a:r>
              <a:rPr lang="en-US" sz="1000" dirty="0">
                <a:solidFill>
                  <a:srgbClr val="0070C0"/>
                </a:solidFill>
                <a:latin typeface="Arial" panose="020B0604020202020204" pitchFamily="34" charset="0"/>
                <a:cs typeface="Arial" panose="020B0604020202020204" pitchFamily="34" charset="0"/>
              </a:rPr>
              <a:t>channel activity</a:t>
            </a:r>
          </a:p>
          <a:p>
            <a:pPr>
              <a:lnSpc>
                <a:spcPts val="1000"/>
              </a:lnSpc>
            </a:pPr>
            <a:r>
              <a:rPr lang="en-US" sz="1000" dirty="0">
                <a:solidFill>
                  <a:srgbClr val="0070C0"/>
                </a:solidFill>
                <a:latin typeface="Arial" panose="020B0604020202020204" pitchFamily="34" charset="0"/>
                <a:cs typeface="Arial" panose="020B0604020202020204" pitchFamily="34" charset="0"/>
              </a:rPr>
              <a:t>response to drug</a:t>
            </a:r>
          </a:p>
          <a:p>
            <a:pPr>
              <a:lnSpc>
                <a:spcPts val="1000"/>
              </a:lnSpc>
            </a:pPr>
            <a:r>
              <a:rPr lang="en-US" sz="1000" dirty="0">
                <a:solidFill>
                  <a:srgbClr val="0070C0"/>
                </a:solidFill>
                <a:latin typeface="Arial" panose="020B0604020202020204" pitchFamily="34" charset="0"/>
                <a:cs typeface="Arial" panose="020B0604020202020204" pitchFamily="34" charset="0"/>
              </a:rPr>
              <a:t>glutamate metabolic process</a:t>
            </a:r>
          </a:p>
          <a:p>
            <a:pPr>
              <a:lnSpc>
                <a:spcPts val="1000"/>
              </a:lnSpc>
            </a:pPr>
            <a:r>
              <a:rPr lang="en-US" sz="1000" dirty="0">
                <a:solidFill>
                  <a:srgbClr val="FFC000"/>
                </a:solidFill>
                <a:latin typeface="Arial" panose="020B0604020202020204" pitchFamily="34" charset="0"/>
                <a:cs typeface="Arial" panose="020B0604020202020204" pitchFamily="34" charset="0"/>
              </a:rPr>
              <a:t>drug metabolic process</a:t>
            </a:r>
          </a:p>
          <a:p>
            <a:pPr>
              <a:lnSpc>
                <a:spcPts val="1000"/>
              </a:lnSpc>
            </a:pPr>
            <a:r>
              <a:rPr lang="en-US" sz="1000" dirty="0">
                <a:solidFill>
                  <a:srgbClr val="FFC000"/>
                </a:solidFill>
                <a:latin typeface="Arial" panose="020B0604020202020204" pitchFamily="34" charset="0"/>
                <a:cs typeface="Arial" panose="020B0604020202020204" pitchFamily="34" charset="0"/>
              </a:rPr>
              <a:t>plasma membrane</a:t>
            </a:r>
          </a:p>
          <a:p>
            <a:pPr>
              <a:lnSpc>
                <a:spcPts val="1000"/>
              </a:lnSpc>
            </a:pPr>
            <a:r>
              <a:rPr lang="en-US" sz="1000" dirty="0">
                <a:solidFill>
                  <a:srgbClr val="FFC000"/>
                </a:solidFill>
                <a:latin typeface="Arial" panose="020B0604020202020204" pitchFamily="34" charset="0"/>
                <a:cs typeface="Arial" panose="020B0604020202020204" pitchFamily="34" charset="0"/>
              </a:rPr>
              <a:t>cofactor binding</a:t>
            </a:r>
          </a:p>
          <a:p>
            <a:pPr>
              <a:lnSpc>
                <a:spcPts val="1000"/>
              </a:lnSpc>
            </a:pPr>
            <a:r>
              <a:rPr lang="en-US" sz="1000" dirty="0">
                <a:solidFill>
                  <a:srgbClr val="FFC000"/>
                </a:solidFill>
                <a:latin typeface="Arial" panose="020B0604020202020204" pitchFamily="34" charset="0"/>
                <a:cs typeface="Arial" panose="020B0604020202020204" pitchFamily="34" charset="0"/>
              </a:rPr>
              <a:t>secondary active transmembrane transporter activity</a:t>
            </a:r>
          </a:p>
          <a:p>
            <a:pPr>
              <a:lnSpc>
                <a:spcPts val="1000"/>
              </a:lnSpc>
            </a:pPr>
            <a:r>
              <a:rPr lang="en-US" sz="1000" dirty="0">
                <a:solidFill>
                  <a:srgbClr val="FFC000"/>
                </a:solidFill>
                <a:latin typeface="Arial" panose="020B0604020202020204" pitchFamily="34" charset="0"/>
                <a:cs typeface="Arial" panose="020B0604020202020204" pitchFamily="34" charset="0"/>
              </a:rPr>
              <a:t>carbohydrate metabolic process</a:t>
            </a:r>
          </a:p>
          <a:p>
            <a:pPr>
              <a:lnSpc>
                <a:spcPts val="1000"/>
              </a:lnSpc>
            </a:pPr>
            <a:r>
              <a:rPr lang="en-US" sz="1000" dirty="0">
                <a:solidFill>
                  <a:srgbClr val="FFC000"/>
                </a:solidFill>
                <a:latin typeface="Arial" panose="020B0604020202020204" pitchFamily="34" charset="0"/>
                <a:cs typeface="Arial" panose="020B0604020202020204" pitchFamily="34" charset="0"/>
              </a:rPr>
              <a:t>carboxylic acid metabolic process</a:t>
            </a:r>
          </a:p>
          <a:p>
            <a:pPr>
              <a:lnSpc>
                <a:spcPts val="1000"/>
              </a:lnSpc>
            </a:pPr>
            <a:r>
              <a:rPr lang="en-US" sz="1000" dirty="0">
                <a:solidFill>
                  <a:srgbClr val="7030A0"/>
                </a:solidFill>
                <a:latin typeface="Arial" panose="020B0604020202020204" pitchFamily="34" charset="0"/>
                <a:cs typeface="Arial" panose="020B0604020202020204" pitchFamily="34" charset="0"/>
              </a:rPr>
              <a:t>glutamine family amino acid metabolic process</a:t>
            </a:r>
          </a:p>
          <a:p>
            <a:pPr>
              <a:lnSpc>
                <a:spcPts val="1000"/>
              </a:lnSpc>
            </a:pPr>
            <a:r>
              <a:rPr lang="en-US" sz="1000" dirty="0">
                <a:solidFill>
                  <a:srgbClr val="7030A0"/>
                </a:solidFill>
                <a:latin typeface="Arial" panose="020B0604020202020204" pitchFamily="34" charset="0"/>
                <a:cs typeface="Arial" panose="020B0604020202020204" pitchFamily="34" charset="0"/>
              </a:rPr>
              <a:t>nuclear DNA-directed RNA polymerase complex</a:t>
            </a:r>
          </a:p>
          <a:p>
            <a:pPr>
              <a:lnSpc>
                <a:spcPts val="1000"/>
              </a:lnSpc>
            </a:pPr>
            <a:r>
              <a:rPr lang="en-US" sz="1000" dirty="0">
                <a:solidFill>
                  <a:srgbClr val="9D4B07"/>
                </a:solidFill>
                <a:latin typeface="Arial" panose="020B0604020202020204" pitchFamily="34" charset="0"/>
                <a:cs typeface="Arial" panose="020B0604020202020204" pitchFamily="34" charset="0"/>
              </a:rPr>
              <a:t>arginine metabolic process</a:t>
            </a:r>
          </a:p>
          <a:p>
            <a:pPr>
              <a:lnSpc>
                <a:spcPts val="1000"/>
              </a:lnSpc>
            </a:pPr>
            <a:r>
              <a:rPr lang="en-US" sz="1000" dirty="0">
                <a:solidFill>
                  <a:srgbClr val="FF0000"/>
                </a:solidFill>
                <a:latin typeface="Arial" panose="020B0604020202020204" pitchFamily="34" charset="0"/>
                <a:cs typeface="Arial" panose="020B0604020202020204" pitchFamily="34" charset="0"/>
              </a:rPr>
              <a:t>multi-organism process</a:t>
            </a:r>
          </a:p>
          <a:p>
            <a:pPr>
              <a:lnSpc>
                <a:spcPts val="1000"/>
              </a:lnSpc>
            </a:pPr>
            <a:r>
              <a:rPr lang="en-US" sz="1000" dirty="0">
                <a:solidFill>
                  <a:srgbClr val="FF0000"/>
                </a:solidFill>
                <a:latin typeface="Arial" panose="020B0604020202020204" pitchFamily="34" charset="0"/>
                <a:cs typeface="Arial" panose="020B0604020202020204" pitchFamily="34" charset="0"/>
              </a:rPr>
              <a:t>amine-lyase activity</a:t>
            </a:r>
          </a:p>
          <a:p>
            <a:pPr>
              <a:lnSpc>
                <a:spcPts val="1000"/>
              </a:lnSpc>
            </a:pPr>
            <a:r>
              <a:rPr lang="en-US" sz="1000" dirty="0">
                <a:solidFill>
                  <a:srgbClr val="FF0000"/>
                </a:solidFill>
                <a:latin typeface="Arial" panose="020B0604020202020204" pitchFamily="34" charset="0"/>
                <a:cs typeface="Arial" panose="020B0604020202020204" pitchFamily="34" charset="0"/>
              </a:rPr>
              <a:t>iron coordination entity transport</a:t>
            </a:r>
          </a:p>
          <a:p>
            <a:pPr>
              <a:lnSpc>
                <a:spcPts val="1000"/>
              </a:lnSpc>
            </a:pPr>
            <a:r>
              <a:rPr lang="en-US" sz="1000" dirty="0">
                <a:solidFill>
                  <a:srgbClr val="FF0000"/>
                </a:solidFill>
                <a:latin typeface="Arial" panose="020B0604020202020204" pitchFamily="34" charset="0"/>
                <a:cs typeface="Arial" panose="020B0604020202020204" pitchFamily="34" charset="0"/>
              </a:rPr>
              <a:t>heterotrimeric G-protein complex</a:t>
            </a:r>
          </a:p>
          <a:p>
            <a:pPr>
              <a:lnSpc>
                <a:spcPts val="1000"/>
              </a:lnSpc>
            </a:pPr>
            <a:r>
              <a:rPr lang="en-US" sz="1000" dirty="0">
                <a:solidFill>
                  <a:srgbClr val="FF0000"/>
                </a:solidFill>
                <a:latin typeface="Arial" panose="020B0604020202020204" pitchFamily="34" charset="0"/>
                <a:cs typeface="Arial" panose="020B0604020202020204" pitchFamily="34" charset="0"/>
              </a:rPr>
              <a:t>toxin metabolic process</a:t>
            </a:r>
          </a:p>
          <a:p>
            <a:pPr>
              <a:lnSpc>
                <a:spcPts val="1000"/>
              </a:lnSpc>
            </a:pPr>
            <a:r>
              <a:rPr lang="en-US" sz="1000" dirty="0">
                <a:solidFill>
                  <a:srgbClr val="FF0000"/>
                </a:solidFill>
                <a:latin typeface="Arial" panose="020B0604020202020204" pitchFamily="34" charset="0"/>
                <a:cs typeface="Arial" panose="020B0604020202020204" pitchFamily="34" charset="0"/>
              </a:rPr>
              <a:t>galactose catabolic process via UDP-galactose</a:t>
            </a:r>
          </a:p>
          <a:p>
            <a:pPr>
              <a:lnSpc>
                <a:spcPts val="1000"/>
              </a:lnSpc>
            </a:pPr>
            <a:r>
              <a:rPr lang="en-US" sz="1000" dirty="0">
                <a:latin typeface="Arial" panose="020B0604020202020204" pitchFamily="34" charset="0"/>
                <a:cs typeface="Arial" panose="020B0604020202020204" pitchFamily="34" charset="0"/>
              </a:rPr>
              <a:t>rRNA modification</a:t>
            </a:r>
          </a:p>
          <a:p>
            <a:pPr>
              <a:lnSpc>
                <a:spcPts val="1000"/>
              </a:lnSpc>
            </a:pPr>
            <a:r>
              <a:rPr lang="en-US" sz="1000" dirty="0">
                <a:latin typeface="Arial" panose="020B0604020202020204" pitchFamily="34" charset="0"/>
                <a:cs typeface="Arial" panose="020B0604020202020204" pitchFamily="34" charset="0"/>
              </a:rPr>
              <a:t>snoRNA binding</a:t>
            </a:r>
          </a:p>
          <a:p>
            <a:pPr>
              <a:lnSpc>
                <a:spcPts val="1000"/>
              </a:lnSpc>
            </a:pPr>
            <a:r>
              <a:rPr lang="en-US" sz="1000" dirty="0" err="1">
                <a:latin typeface="Arial" panose="020B0604020202020204" pitchFamily="34" charset="0"/>
                <a:cs typeface="Arial" panose="020B0604020202020204" pitchFamily="34" charset="0"/>
              </a:rPr>
              <a:t>preribosome</a:t>
            </a:r>
            <a:r>
              <a:rPr lang="en-US" sz="1000" dirty="0">
                <a:latin typeface="Arial" panose="020B0604020202020204" pitchFamily="34" charset="0"/>
                <a:cs typeface="Arial" panose="020B0604020202020204" pitchFamily="34" charset="0"/>
              </a:rPr>
              <a:t>, small subunit precursor</a:t>
            </a:r>
          </a:p>
          <a:p>
            <a:pPr>
              <a:lnSpc>
                <a:spcPts val="1000"/>
              </a:lnSpc>
            </a:pPr>
            <a:r>
              <a:rPr lang="en-US" sz="1000" dirty="0">
                <a:latin typeface="Arial" panose="020B0604020202020204" pitchFamily="34" charset="0"/>
                <a:cs typeface="Arial" panose="020B0604020202020204" pitchFamily="34" charset="0"/>
              </a:rPr>
              <a:t>ribosome assembly</a:t>
            </a:r>
          </a:p>
          <a:p>
            <a:pPr>
              <a:lnSpc>
                <a:spcPts val="1000"/>
              </a:lnSpc>
            </a:pPr>
            <a:r>
              <a:rPr lang="en-US" sz="1000" dirty="0">
                <a:latin typeface="Arial" panose="020B0604020202020204" pitchFamily="34" charset="0"/>
                <a:cs typeface="Arial" panose="020B0604020202020204" pitchFamily="34" charset="0"/>
              </a:rPr>
              <a:t>cytosolic small ribosomal subunit</a:t>
            </a:r>
          </a:p>
          <a:p>
            <a:pPr>
              <a:lnSpc>
                <a:spcPts val="1000"/>
              </a:lnSpc>
            </a:pPr>
            <a:r>
              <a:rPr lang="en-US" sz="1000" dirty="0">
                <a:latin typeface="Arial" panose="020B0604020202020204" pitchFamily="34" charset="0"/>
                <a:cs typeface="Arial" panose="020B0604020202020204" pitchFamily="34" charset="0"/>
              </a:rPr>
              <a:t>cytosolic ribosome</a:t>
            </a:r>
          </a:p>
          <a:p>
            <a:pPr>
              <a:lnSpc>
                <a:spcPts val="1000"/>
              </a:lnSpc>
            </a:pPr>
            <a:r>
              <a:rPr lang="en-US" sz="1000" dirty="0">
                <a:latin typeface="Arial" panose="020B0604020202020204" pitchFamily="34" charset="0"/>
                <a:cs typeface="Arial" panose="020B0604020202020204" pitchFamily="34" charset="0"/>
              </a:rPr>
              <a:t>rRNA-containing ribonucleoprotein complex export from nucleus</a:t>
            </a:r>
          </a:p>
          <a:p>
            <a:pPr>
              <a:lnSpc>
                <a:spcPts val="1000"/>
              </a:lnSpc>
            </a:pPr>
            <a:r>
              <a:rPr lang="en-US" sz="1000" dirty="0">
                <a:latin typeface="Arial" panose="020B0604020202020204" pitchFamily="34" charset="0"/>
                <a:cs typeface="Arial" panose="020B0604020202020204" pitchFamily="34" charset="0"/>
              </a:rPr>
              <a:t>rRNA binding</a:t>
            </a:r>
          </a:p>
          <a:p>
            <a:pPr>
              <a:lnSpc>
                <a:spcPts val="1000"/>
              </a:lnSpc>
            </a:pPr>
            <a:r>
              <a:rPr lang="en-US" sz="1000" dirty="0">
                <a:latin typeface="Arial" panose="020B0604020202020204" pitchFamily="34" charset="0"/>
                <a:cs typeface="Arial" panose="020B0604020202020204" pitchFamily="34" charset="0"/>
              </a:rPr>
              <a:t>ribosomal large subunit biogenesis</a:t>
            </a:r>
          </a:p>
          <a:p>
            <a:pPr>
              <a:lnSpc>
                <a:spcPts val="1000"/>
              </a:lnSpc>
            </a:pPr>
            <a:r>
              <a:rPr lang="en-US" sz="1000" dirty="0">
                <a:latin typeface="Arial" panose="020B0604020202020204" pitchFamily="34" charset="0"/>
                <a:cs typeface="Arial" panose="020B0604020202020204" pitchFamily="34" charset="0"/>
              </a:rPr>
              <a:t>ribonucleoprotein complex binding</a:t>
            </a:r>
          </a:p>
          <a:p>
            <a:pPr>
              <a:lnSpc>
                <a:spcPts val="1000"/>
              </a:lnSpc>
            </a:pPr>
            <a:r>
              <a:rPr lang="en-US" sz="1000" dirty="0">
                <a:latin typeface="Arial" panose="020B0604020202020204" pitchFamily="34" charset="0"/>
                <a:cs typeface="Arial" panose="020B0604020202020204" pitchFamily="34" charset="0"/>
              </a:rPr>
              <a:t>box H/ACA </a:t>
            </a:r>
            <a:r>
              <a:rPr lang="en-US" sz="1000" dirty="0" err="1">
                <a:latin typeface="Arial" panose="020B0604020202020204" pitchFamily="34" charset="0"/>
                <a:cs typeface="Arial" panose="020B0604020202020204" pitchFamily="34" charset="0"/>
              </a:rPr>
              <a:t>snoRNP</a:t>
            </a:r>
            <a:r>
              <a:rPr lang="en-US" sz="1000" dirty="0">
                <a:latin typeface="Arial" panose="020B0604020202020204" pitchFamily="34" charset="0"/>
                <a:cs typeface="Arial" panose="020B0604020202020204" pitchFamily="34" charset="0"/>
              </a:rPr>
              <a:t> complex</a:t>
            </a:r>
          </a:p>
          <a:p>
            <a:pPr>
              <a:lnSpc>
                <a:spcPts val="1000"/>
              </a:lnSpc>
            </a:pPr>
            <a:r>
              <a:rPr lang="en-US" sz="1000" dirty="0">
                <a:latin typeface="Arial" panose="020B0604020202020204" pitchFamily="34" charset="0"/>
                <a:cs typeface="Arial" panose="020B0604020202020204" pitchFamily="34" charset="0"/>
              </a:rPr>
              <a:t>Pwp2p-containing subcomplex of 90S </a:t>
            </a:r>
            <a:r>
              <a:rPr lang="en-US" sz="1000" dirty="0" err="1">
                <a:latin typeface="Arial" panose="020B0604020202020204" pitchFamily="34" charset="0"/>
                <a:cs typeface="Arial" panose="020B0604020202020204" pitchFamily="34" charset="0"/>
              </a:rPr>
              <a:t>preribosome</a:t>
            </a:r>
            <a:endParaRPr lang="en-US" sz="1000" dirty="0">
              <a:latin typeface="Arial" panose="020B0604020202020204" pitchFamily="34" charset="0"/>
              <a:cs typeface="Arial" panose="020B0604020202020204" pitchFamily="34" charset="0"/>
            </a:endParaRPr>
          </a:p>
          <a:p>
            <a:pPr>
              <a:lnSpc>
                <a:spcPts val="1000"/>
              </a:lnSpc>
            </a:pPr>
            <a:r>
              <a:rPr lang="en-US" sz="1000" dirty="0">
                <a:latin typeface="Arial" panose="020B0604020202020204" pitchFamily="34" charset="0"/>
                <a:cs typeface="Arial" panose="020B0604020202020204" pitchFamily="34" charset="0"/>
              </a:rPr>
              <a:t>5S rRNA binding</a:t>
            </a:r>
          </a:p>
          <a:p>
            <a:pPr>
              <a:lnSpc>
                <a:spcPts val="1000"/>
              </a:lnSpc>
            </a:pPr>
            <a:r>
              <a:rPr lang="en-US" sz="1000" dirty="0">
                <a:latin typeface="Arial" panose="020B0604020202020204" pitchFamily="34" charset="0"/>
                <a:cs typeface="Arial" panose="020B0604020202020204" pitchFamily="34" charset="0"/>
              </a:rPr>
              <a:t>'de novo' </a:t>
            </a:r>
            <a:r>
              <a:rPr lang="en-US" sz="1000" dirty="0" err="1">
                <a:latin typeface="Arial" panose="020B0604020202020204" pitchFamily="34" charset="0"/>
                <a:cs typeface="Arial" panose="020B0604020202020204" pitchFamily="34" charset="0"/>
              </a:rPr>
              <a:t>cotranslational</a:t>
            </a:r>
            <a:r>
              <a:rPr lang="en-US" sz="1000" dirty="0">
                <a:latin typeface="Arial" panose="020B0604020202020204" pitchFamily="34" charset="0"/>
                <a:cs typeface="Arial" panose="020B0604020202020204" pitchFamily="34" charset="0"/>
              </a:rPr>
              <a:t> protein folding</a:t>
            </a:r>
          </a:p>
          <a:p>
            <a:pPr>
              <a:lnSpc>
                <a:spcPts val="1000"/>
              </a:lnSpc>
            </a:pPr>
            <a:r>
              <a:rPr lang="en-US" sz="1000" dirty="0">
                <a:latin typeface="Arial" panose="020B0604020202020204" pitchFamily="34" charset="0"/>
                <a:cs typeface="Arial" panose="020B0604020202020204" pitchFamily="34" charset="0"/>
              </a:rPr>
              <a:t>mRNA binding</a:t>
            </a:r>
          </a:p>
          <a:p>
            <a:pPr>
              <a:lnSpc>
                <a:spcPts val="1000"/>
              </a:lnSpc>
            </a:pPr>
            <a:r>
              <a:rPr lang="en-US" sz="1000" dirty="0">
                <a:latin typeface="Arial" panose="020B0604020202020204" pitchFamily="34" charset="0"/>
                <a:cs typeface="Arial" panose="020B0604020202020204" pitchFamily="34" charset="0"/>
              </a:rPr>
              <a:t>assembly of large subunit precursor of </a:t>
            </a:r>
            <a:r>
              <a:rPr lang="en-US" sz="1000" dirty="0" err="1">
                <a:latin typeface="Arial" panose="020B0604020202020204" pitchFamily="34" charset="0"/>
                <a:cs typeface="Arial" panose="020B0604020202020204" pitchFamily="34" charset="0"/>
              </a:rPr>
              <a:t>preribosome</a:t>
            </a:r>
            <a:endParaRPr lang="en-US" sz="1000" dirty="0">
              <a:latin typeface="Arial" panose="020B0604020202020204" pitchFamily="34" charset="0"/>
              <a:cs typeface="Arial" panose="020B0604020202020204" pitchFamily="34" charset="0"/>
            </a:endParaRPr>
          </a:p>
          <a:p>
            <a:pPr>
              <a:lnSpc>
                <a:spcPts val="1000"/>
              </a:lnSpc>
            </a:pPr>
            <a:r>
              <a:rPr lang="en-US" sz="1000" dirty="0">
                <a:latin typeface="Arial" panose="020B0604020202020204" pitchFamily="34" charset="0"/>
                <a:cs typeface="Arial" panose="020B0604020202020204" pitchFamily="34" charset="0"/>
              </a:rPr>
              <a:t>catalytic activity, acting on RNA</a:t>
            </a:r>
          </a:p>
          <a:p>
            <a:pPr>
              <a:lnSpc>
                <a:spcPts val="1000"/>
              </a:lnSpc>
            </a:pPr>
            <a:r>
              <a:rPr lang="en-US" sz="1000" dirty="0">
                <a:latin typeface="Arial" panose="020B0604020202020204" pitchFamily="34" charset="0"/>
                <a:cs typeface="Arial" panose="020B0604020202020204" pitchFamily="34" charset="0"/>
              </a:rPr>
              <a:t>tRNA methyltransferase activity</a:t>
            </a:r>
          </a:p>
          <a:p>
            <a:pPr>
              <a:lnSpc>
                <a:spcPts val="1000"/>
              </a:lnSpc>
            </a:pPr>
            <a:r>
              <a:rPr lang="en-US" sz="1000" dirty="0">
                <a:latin typeface="Arial" panose="020B0604020202020204" pitchFamily="34" charset="0"/>
                <a:cs typeface="Arial" panose="020B0604020202020204" pitchFamily="34" charset="0"/>
              </a:rPr>
              <a:t>box C/D </a:t>
            </a:r>
            <a:r>
              <a:rPr lang="en-US" sz="1000" dirty="0" err="1">
                <a:latin typeface="Arial" panose="020B0604020202020204" pitchFamily="34" charset="0"/>
                <a:cs typeface="Arial" panose="020B0604020202020204" pitchFamily="34" charset="0"/>
              </a:rPr>
              <a:t>snoRNP</a:t>
            </a:r>
            <a:r>
              <a:rPr lang="en-US" sz="1000" dirty="0">
                <a:latin typeface="Arial" panose="020B0604020202020204" pitchFamily="34" charset="0"/>
                <a:cs typeface="Arial" panose="020B0604020202020204" pitchFamily="34" charset="0"/>
              </a:rPr>
              <a:t> complex</a:t>
            </a:r>
          </a:p>
          <a:p>
            <a:pPr>
              <a:lnSpc>
                <a:spcPts val="1000"/>
              </a:lnSpc>
            </a:pPr>
            <a:r>
              <a:rPr lang="en-US" sz="1000" dirty="0" err="1">
                <a:latin typeface="Arial" panose="020B0604020202020204" pitchFamily="34" charset="0"/>
                <a:cs typeface="Arial" panose="020B0604020202020204" pitchFamily="34" charset="0"/>
              </a:rPr>
              <a:t>endonucleolytic</a:t>
            </a:r>
            <a:r>
              <a:rPr lang="en-US" sz="1000" dirty="0">
                <a:latin typeface="Arial" panose="020B0604020202020204" pitchFamily="34" charset="0"/>
                <a:cs typeface="Arial" panose="020B0604020202020204" pitchFamily="34" charset="0"/>
              </a:rPr>
              <a:t> cleavage to generate mature 3'-end of SSU-rRNA </a:t>
            </a:r>
          </a:p>
          <a:p>
            <a:pPr>
              <a:lnSpc>
                <a:spcPts val="1000"/>
              </a:lnSpc>
            </a:pPr>
            <a:r>
              <a:rPr lang="en-US" sz="1000" dirty="0">
                <a:solidFill>
                  <a:srgbClr val="00B050"/>
                </a:solidFill>
                <a:latin typeface="Arial" panose="020B0604020202020204" pitchFamily="34" charset="0"/>
                <a:cs typeface="Arial" panose="020B0604020202020204" pitchFamily="34" charset="0"/>
              </a:rPr>
              <a:t>ribosome biogenesis</a:t>
            </a:r>
          </a:p>
          <a:p>
            <a:pPr>
              <a:lnSpc>
                <a:spcPts val="1000"/>
              </a:lnSpc>
            </a:pPr>
            <a:r>
              <a:rPr lang="en-US" sz="1000" dirty="0">
                <a:solidFill>
                  <a:srgbClr val="00B050"/>
                </a:solidFill>
                <a:latin typeface="Arial" panose="020B0604020202020204" pitchFamily="34" charset="0"/>
                <a:cs typeface="Arial" panose="020B0604020202020204" pitchFamily="34" charset="0"/>
              </a:rPr>
              <a:t>nucleolar part</a:t>
            </a:r>
          </a:p>
          <a:p>
            <a:pPr>
              <a:lnSpc>
                <a:spcPts val="1000"/>
              </a:lnSpc>
            </a:pPr>
            <a:r>
              <a:rPr lang="en-US" sz="1000" dirty="0">
                <a:solidFill>
                  <a:srgbClr val="00B0F0"/>
                </a:solidFill>
                <a:latin typeface="Arial" panose="020B0604020202020204" pitchFamily="34" charset="0"/>
                <a:cs typeface="Arial" panose="020B0604020202020204" pitchFamily="34" charset="0"/>
              </a:rPr>
              <a:t>fungal-type cell wall</a:t>
            </a:r>
          </a:p>
          <a:p>
            <a:pPr>
              <a:lnSpc>
                <a:spcPts val="1000"/>
              </a:lnSpc>
            </a:pPr>
            <a:r>
              <a:rPr lang="en-US" sz="1000" dirty="0">
                <a:solidFill>
                  <a:srgbClr val="F715DC"/>
                </a:solidFill>
                <a:latin typeface="Arial" panose="020B0604020202020204" pitchFamily="34" charset="0"/>
                <a:cs typeface="Arial" panose="020B0604020202020204" pitchFamily="34" charset="0"/>
              </a:rPr>
              <a:t>anchored component of membrane</a:t>
            </a:r>
          </a:p>
        </p:txBody>
      </p:sp>
      <p:sp>
        <p:nvSpPr>
          <p:cNvPr id="9" name="TextBox 8">
            <a:extLst>
              <a:ext uri="{FF2B5EF4-FFF2-40B4-BE49-F238E27FC236}">
                <a16:creationId xmlns:a16="http://schemas.microsoft.com/office/drawing/2014/main" id="{65F771DD-1B32-414C-A4E5-6B3A1745097E}"/>
              </a:ext>
            </a:extLst>
          </p:cNvPr>
          <p:cNvSpPr txBox="1"/>
          <p:nvPr/>
        </p:nvSpPr>
        <p:spPr>
          <a:xfrm rot="18954579">
            <a:off x="1039951" y="7823151"/>
            <a:ext cx="71526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sym typeface="Symbol" panose="05050102010706020507" pitchFamily="18" charset="2"/>
              </a:rPr>
              <a:t>[</a:t>
            </a:r>
            <a:r>
              <a:rPr lang="en-US" sz="1200" i="1" dirty="0">
                <a:latin typeface="Arial" panose="020B0604020202020204" pitchFamily="34" charset="0"/>
                <a:cs typeface="Arial" panose="020B0604020202020204" pitchFamily="34" charset="0"/>
                <a:sym typeface="Symbol" panose="05050102010706020507" pitchFamily="18" charset="2"/>
              </a:rPr>
              <a:t>SWI</a:t>
            </a:r>
            <a:r>
              <a:rPr lang="en-US" sz="1200" i="1" baseline="30000" dirty="0">
                <a:latin typeface="Arial" panose="020B0604020202020204" pitchFamily="34" charset="0"/>
                <a:cs typeface="Arial" panose="020B0604020202020204" pitchFamily="34" charset="0"/>
                <a:sym typeface="Symbol" panose="05050102010706020507" pitchFamily="18" charset="2"/>
              </a:rPr>
              <a:t>+</a:t>
            </a:r>
            <a:r>
              <a:rPr lang="en-US" sz="1200" dirty="0">
                <a:latin typeface="Arial" panose="020B0604020202020204" pitchFamily="34" charset="0"/>
                <a:cs typeface="Arial" panose="020B0604020202020204" pitchFamily="34" charset="0"/>
                <a:sym typeface="Symbol" panose="05050102010706020507" pitchFamily="18" charset="2"/>
              </a:rPr>
              <a:t>]</a:t>
            </a:r>
            <a:endParaRPr lang="en-US" sz="12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0D84C29B-36DB-49C3-892E-A9810B04608D}"/>
              </a:ext>
            </a:extLst>
          </p:cNvPr>
          <p:cNvSpPr txBox="1"/>
          <p:nvPr/>
        </p:nvSpPr>
        <p:spPr>
          <a:xfrm rot="18954579">
            <a:off x="1528958" y="7789727"/>
            <a:ext cx="67839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sym typeface="Symbol" panose="05050102010706020507" pitchFamily="18" charset="2"/>
              </a:rPr>
              <a:t></a:t>
            </a:r>
            <a:r>
              <a:rPr lang="en-US" sz="1200" i="1" dirty="0">
                <a:latin typeface="Arial" panose="020B0604020202020204" pitchFamily="34" charset="0"/>
                <a:cs typeface="Arial" panose="020B0604020202020204" pitchFamily="34" charset="0"/>
                <a:sym typeface="Symbol" panose="05050102010706020507" pitchFamily="18" charset="2"/>
              </a:rPr>
              <a:t>swi1∆</a:t>
            </a:r>
            <a:endParaRPr lang="en-US" sz="1200" i="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7F3BB455-BE03-4326-9993-7E1399E2AD2E}"/>
              </a:ext>
            </a:extLst>
          </p:cNvPr>
          <p:cNvSpPr txBox="1"/>
          <p:nvPr/>
        </p:nvSpPr>
        <p:spPr>
          <a:xfrm rot="18954579">
            <a:off x="1941934" y="7823151"/>
            <a:ext cx="71526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sym typeface="Symbol" panose="05050102010706020507" pitchFamily="18" charset="2"/>
              </a:rPr>
              <a:t>[</a:t>
            </a:r>
            <a:r>
              <a:rPr lang="en-US" sz="1200" i="1" dirty="0">
                <a:latin typeface="Arial" panose="020B0604020202020204" pitchFamily="34" charset="0"/>
                <a:cs typeface="Arial" panose="020B0604020202020204" pitchFamily="34" charset="0"/>
                <a:sym typeface="Symbol" panose="05050102010706020507" pitchFamily="18" charset="2"/>
              </a:rPr>
              <a:t>SWI</a:t>
            </a:r>
            <a:r>
              <a:rPr lang="en-US" sz="1200" i="1" baseline="30000" dirty="0">
                <a:latin typeface="Arial" panose="020B0604020202020204" pitchFamily="34" charset="0"/>
                <a:cs typeface="Arial" panose="020B0604020202020204" pitchFamily="34" charset="0"/>
                <a:sym typeface="Symbol" panose="05050102010706020507" pitchFamily="18" charset="2"/>
              </a:rPr>
              <a:t>+</a:t>
            </a:r>
            <a:r>
              <a:rPr lang="en-US" sz="1200" dirty="0">
                <a:latin typeface="Arial" panose="020B0604020202020204" pitchFamily="34" charset="0"/>
                <a:cs typeface="Arial" panose="020B0604020202020204" pitchFamily="34" charset="0"/>
                <a:sym typeface="Symbol" panose="05050102010706020507" pitchFamily="18" charset="2"/>
              </a:rPr>
              <a:t>]</a:t>
            </a:r>
            <a:endParaRPr lang="en-US" sz="12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BF31904-A262-44C0-A3B0-3B485E7FC4DE}"/>
              </a:ext>
            </a:extLst>
          </p:cNvPr>
          <p:cNvSpPr txBox="1"/>
          <p:nvPr/>
        </p:nvSpPr>
        <p:spPr>
          <a:xfrm rot="18954579">
            <a:off x="677192" y="7789726"/>
            <a:ext cx="67839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sym typeface="Symbol" panose="05050102010706020507" pitchFamily="18" charset="2"/>
              </a:rPr>
              <a:t></a:t>
            </a:r>
            <a:r>
              <a:rPr lang="en-US" sz="1200" i="1" dirty="0">
                <a:latin typeface="Arial" panose="020B0604020202020204" pitchFamily="34" charset="0"/>
                <a:cs typeface="Arial" panose="020B0604020202020204" pitchFamily="34" charset="0"/>
                <a:sym typeface="Symbol" panose="05050102010706020507" pitchFamily="18" charset="2"/>
              </a:rPr>
              <a:t>swi1∆</a:t>
            </a:r>
            <a:endParaRPr lang="en-US" sz="1200" i="1" dirty="0">
              <a:latin typeface="Arial" panose="020B0604020202020204" pitchFamily="34" charset="0"/>
              <a:cs typeface="Arial" panose="020B0604020202020204" pitchFamily="34" charset="0"/>
            </a:endParaRPr>
          </a:p>
        </p:txBody>
      </p:sp>
      <p:grpSp>
        <p:nvGrpSpPr>
          <p:cNvPr id="13" name="Group 12">
            <a:extLst>
              <a:ext uri="{FF2B5EF4-FFF2-40B4-BE49-F238E27FC236}">
                <a16:creationId xmlns:a16="http://schemas.microsoft.com/office/drawing/2014/main" id="{93354719-228A-48AE-AFFB-A77923471BEB}"/>
              </a:ext>
            </a:extLst>
          </p:cNvPr>
          <p:cNvGrpSpPr/>
          <p:nvPr/>
        </p:nvGrpSpPr>
        <p:grpSpPr>
          <a:xfrm>
            <a:off x="4812228" y="303984"/>
            <a:ext cx="1809902" cy="269254"/>
            <a:chOff x="-1856495" y="6736319"/>
            <a:chExt cx="1809902" cy="686794"/>
          </a:xfrm>
        </p:grpSpPr>
        <p:pic>
          <p:nvPicPr>
            <p:cNvPr id="14" name="Picture 13" descr="A screenshot of a cell phone&#10;&#10;Description automatically generated">
              <a:extLst>
                <a:ext uri="{FF2B5EF4-FFF2-40B4-BE49-F238E27FC236}">
                  <a16:creationId xmlns:a16="http://schemas.microsoft.com/office/drawing/2014/main" id="{783134F8-112A-4D1A-B497-780BE5988543}"/>
                </a:ext>
              </a:extLst>
            </p:cNvPr>
            <p:cNvPicPr>
              <a:picLocks noChangeAspect="1"/>
            </p:cNvPicPr>
            <p:nvPr/>
          </p:nvPicPr>
          <p:blipFill rotWithShape="1">
            <a:blip r:embed="rId3">
              <a:extLst>
                <a:ext uri="{28A0092B-C50C-407E-A947-70E740481C1C}">
                  <a14:useLocalDpi xmlns:a14="http://schemas.microsoft.com/office/drawing/2010/main" val="0"/>
                </a:ext>
              </a:extLst>
            </a:blip>
            <a:srcRect l="73741" t="5839" r="2166" b="87531"/>
            <a:stretch/>
          </p:blipFill>
          <p:spPr>
            <a:xfrm>
              <a:off x="-1747434" y="6820619"/>
              <a:ext cx="862529" cy="345099"/>
            </a:xfrm>
            <a:prstGeom prst="rect">
              <a:avLst/>
            </a:prstGeom>
          </p:spPr>
        </p:pic>
        <p:grpSp>
          <p:nvGrpSpPr>
            <p:cNvPr id="15" name="Group 14">
              <a:extLst>
                <a:ext uri="{FF2B5EF4-FFF2-40B4-BE49-F238E27FC236}">
                  <a16:creationId xmlns:a16="http://schemas.microsoft.com/office/drawing/2014/main" id="{23F00894-1A1F-4542-9144-805DCA65B462}"/>
                </a:ext>
              </a:extLst>
            </p:cNvPr>
            <p:cNvGrpSpPr/>
            <p:nvPr/>
          </p:nvGrpSpPr>
          <p:grpSpPr>
            <a:xfrm>
              <a:off x="-1725839" y="7161363"/>
              <a:ext cx="822080" cy="44588"/>
              <a:chOff x="-2462516" y="7380493"/>
              <a:chExt cx="2022870" cy="47366"/>
            </a:xfrm>
          </p:grpSpPr>
          <p:cxnSp>
            <p:nvCxnSpPr>
              <p:cNvPr id="22" name="Straight Connector 21">
                <a:extLst>
                  <a:ext uri="{FF2B5EF4-FFF2-40B4-BE49-F238E27FC236}">
                    <a16:creationId xmlns:a16="http://schemas.microsoft.com/office/drawing/2014/main" id="{7D8BB7AE-8CFE-4D3F-B0DE-040E955DDE53}"/>
                  </a:ext>
                </a:extLst>
              </p:cNvPr>
              <p:cNvCxnSpPr/>
              <p:nvPr/>
            </p:nvCxnSpPr>
            <p:spPr>
              <a:xfrm>
                <a:off x="-2462516" y="7380493"/>
                <a:ext cx="0" cy="473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D4A9D6FC-E402-45D1-BADB-A837575760C5}"/>
                  </a:ext>
                </a:extLst>
              </p:cNvPr>
              <p:cNvCxnSpPr/>
              <p:nvPr/>
            </p:nvCxnSpPr>
            <p:spPr>
              <a:xfrm>
                <a:off x="-2161974" y="7380493"/>
                <a:ext cx="0" cy="473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07B72EF3-29F7-437E-A65D-5767659D6158}"/>
                  </a:ext>
                </a:extLst>
              </p:cNvPr>
              <p:cNvCxnSpPr/>
              <p:nvPr/>
            </p:nvCxnSpPr>
            <p:spPr>
              <a:xfrm>
                <a:off x="-1858822" y="7380493"/>
                <a:ext cx="0" cy="473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22520782-C954-4AE3-BD9E-95D5AC58DA0F}"/>
                  </a:ext>
                </a:extLst>
              </p:cNvPr>
              <p:cNvCxnSpPr/>
              <p:nvPr/>
            </p:nvCxnSpPr>
            <p:spPr>
              <a:xfrm>
                <a:off x="-1447994" y="7380493"/>
                <a:ext cx="0" cy="473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38494420-6DD1-43F6-B33D-4CBCA63A7C83}"/>
                  </a:ext>
                </a:extLst>
              </p:cNvPr>
              <p:cNvCxnSpPr/>
              <p:nvPr/>
            </p:nvCxnSpPr>
            <p:spPr>
              <a:xfrm>
                <a:off x="-439646" y="7380493"/>
                <a:ext cx="0" cy="473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 name="TextBox 15">
              <a:extLst>
                <a:ext uri="{FF2B5EF4-FFF2-40B4-BE49-F238E27FC236}">
                  <a16:creationId xmlns:a16="http://schemas.microsoft.com/office/drawing/2014/main" id="{43C279E9-CA64-4C66-A610-1E9D14DC1A3C}"/>
                </a:ext>
              </a:extLst>
            </p:cNvPr>
            <p:cNvSpPr txBox="1"/>
            <p:nvPr/>
          </p:nvSpPr>
          <p:spPr>
            <a:xfrm>
              <a:off x="-1856495" y="7161503"/>
              <a:ext cx="2632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0</a:t>
              </a:r>
            </a:p>
          </p:txBody>
        </p:sp>
        <p:sp>
          <p:nvSpPr>
            <p:cNvPr id="17" name="TextBox 16">
              <a:extLst>
                <a:ext uri="{FF2B5EF4-FFF2-40B4-BE49-F238E27FC236}">
                  <a16:creationId xmlns:a16="http://schemas.microsoft.com/office/drawing/2014/main" id="{28F610B6-C260-411C-9D75-F944CC424BE0}"/>
                </a:ext>
              </a:extLst>
            </p:cNvPr>
            <p:cNvSpPr txBox="1"/>
            <p:nvPr/>
          </p:nvSpPr>
          <p:spPr>
            <a:xfrm>
              <a:off x="-1731271" y="7160279"/>
              <a:ext cx="29867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a:t>
              </a:r>
            </a:p>
          </p:txBody>
        </p:sp>
        <p:sp>
          <p:nvSpPr>
            <p:cNvPr id="18" name="TextBox 17">
              <a:extLst>
                <a:ext uri="{FF2B5EF4-FFF2-40B4-BE49-F238E27FC236}">
                  <a16:creationId xmlns:a16="http://schemas.microsoft.com/office/drawing/2014/main" id="{85116683-099D-473D-8AAB-489671DFFD3E}"/>
                </a:ext>
              </a:extLst>
            </p:cNvPr>
            <p:cNvSpPr txBox="1"/>
            <p:nvPr/>
          </p:nvSpPr>
          <p:spPr>
            <a:xfrm>
              <a:off x="-1600200" y="7161503"/>
              <a:ext cx="29867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6</a:t>
              </a:r>
            </a:p>
          </p:txBody>
        </p:sp>
        <p:sp>
          <p:nvSpPr>
            <p:cNvPr id="19" name="TextBox 18">
              <a:extLst>
                <a:ext uri="{FF2B5EF4-FFF2-40B4-BE49-F238E27FC236}">
                  <a16:creationId xmlns:a16="http://schemas.microsoft.com/office/drawing/2014/main" id="{40854AA0-F9B2-4A23-953B-F15321C07A1A}"/>
                </a:ext>
              </a:extLst>
            </p:cNvPr>
            <p:cNvSpPr txBox="1"/>
            <p:nvPr/>
          </p:nvSpPr>
          <p:spPr>
            <a:xfrm>
              <a:off x="-1477204" y="7161503"/>
              <a:ext cx="341653"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0</a:t>
              </a:r>
            </a:p>
          </p:txBody>
        </p:sp>
        <p:sp>
          <p:nvSpPr>
            <p:cNvPr id="20" name="TextBox 19">
              <a:extLst>
                <a:ext uri="{FF2B5EF4-FFF2-40B4-BE49-F238E27FC236}">
                  <a16:creationId xmlns:a16="http://schemas.microsoft.com/office/drawing/2014/main" id="{0C612E20-28BE-44FF-BEB1-362D982849BB}"/>
                </a:ext>
              </a:extLst>
            </p:cNvPr>
            <p:cNvSpPr txBox="1"/>
            <p:nvPr/>
          </p:nvSpPr>
          <p:spPr>
            <a:xfrm>
              <a:off x="-1067625" y="7161503"/>
              <a:ext cx="36342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21" name="TextBox 20">
              <a:extLst>
                <a:ext uri="{FF2B5EF4-FFF2-40B4-BE49-F238E27FC236}">
                  <a16:creationId xmlns:a16="http://schemas.microsoft.com/office/drawing/2014/main" id="{A1BF4487-B0E3-4BB7-B7D2-FDF9D31F60C4}"/>
                </a:ext>
              </a:extLst>
            </p:cNvPr>
            <p:cNvSpPr txBox="1"/>
            <p:nvPr/>
          </p:nvSpPr>
          <p:spPr>
            <a:xfrm>
              <a:off x="-885911" y="6736319"/>
              <a:ext cx="839318" cy="567753"/>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log10(P)</a:t>
              </a:r>
            </a:p>
          </p:txBody>
        </p:sp>
      </p:grpSp>
      <p:sp>
        <p:nvSpPr>
          <p:cNvPr id="27" name="Text Box 97">
            <a:extLst>
              <a:ext uri="{FF2B5EF4-FFF2-40B4-BE49-F238E27FC236}">
                <a16:creationId xmlns:a16="http://schemas.microsoft.com/office/drawing/2014/main" id="{33DE09D8-3E42-4D51-A236-F125BDE55E72}"/>
              </a:ext>
            </a:extLst>
          </p:cNvPr>
          <p:cNvSpPr txBox="1">
            <a:spLocks noChangeArrowheads="1"/>
          </p:cNvSpPr>
          <p:nvPr/>
        </p:nvSpPr>
        <p:spPr bwMode="auto">
          <a:xfrm>
            <a:off x="31656" y="26985"/>
            <a:ext cx="88678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Font typeface="Arial" pitchFamily="34" charset="0"/>
              <a:buChar char="•"/>
              <a:defRPr>
                <a:solidFill>
                  <a:schemeClr val="tx1"/>
                </a:solidFill>
                <a:latin typeface="Calibri" pitchFamily="34" charset="0"/>
              </a:defRPr>
            </a:lvl1pPr>
            <a:lvl2pPr marL="742950" indent="-285750">
              <a:spcBef>
                <a:spcPct val="20000"/>
              </a:spcBef>
              <a:buFont typeface="Arial" pitchFamily="34" charset="0"/>
              <a:buChar char="–"/>
              <a:defRPr sz="1600">
                <a:solidFill>
                  <a:schemeClr val="tx1"/>
                </a:solidFill>
                <a:latin typeface="Calibri" pitchFamily="34" charset="0"/>
              </a:defRPr>
            </a:lvl2pPr>
            <a:lvl3pPr marL="1143000" indent="-228600">
              <a:spcBef>
                <a:spcPct val="20000"/>
              </a:spcBef>
              <a:buFont typeface="Arial" pitchFamily="34" charset="0"/>
              <a:buChar char="•"/>
              <a:defRPr sz="1400">
                <a:solidFill>
                  <a:schemeClr val="tx1"/>
                </a:solidFill>
                <a:latin typeface="Calibri" pitchFamily="34" charset="0"/>
              </a:defRPr>
            </a:lvl3pPr>
            <a:lvl4pPr marL="1600200" indent="-228600">
              <a:spcBef>
                <a:spcPct val="20000"/>
              </a:spcBef>
              <a:buFont typeface="Arial" pitchFamily="34" charset="0"/>
              <a:buChar char="–"/>
              <a:defRPr sz="1100">
                <a:solidFill>
                  <a:schemeClr val="tx1"/>
                </a:solidFill>
                <a:latin typeface="Calibri" pitchFamily="34" charset="0"/>
              </a:defRPr>
            </a:lvl4pPr>
            <a:lvl5pPr marL="2057400" indent="-228600">
              <a:spcBef>
                <a:spcPct val="20000"/>
              </a:spcBef>
              <a:buFont typeface="Arial" pitchFamily="34" charset="0"/>
              <a:buChar char="»"/>
              <a:defRPr sz="11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1100">
                <a:solidFill>
                  <a:schemeClr val="tx1"/>
                </a:solidFill>
                <a:latin typeface="Calibri" pitchFamily="34" charset="0"/>
              </a:defRPr>
            </a:lvl9pPr>
          </a:lstStyle>
          <a:p>
            <a:pPr eaLnBrk="1" hangingPunct="1">
              <a:spcBef>
                <a:spcPct val="0"/>
              </a:spcBef>
              <a:buFontTx/>
              <a:buNone/>
            </a:pPr>
            <a:r>
              <a:rPr lang="en-US" altLang="en-US" sz="1200" b="1" dirty="0">
                <a:latin typeface="Arial" panose="020B0604020202020204" pitchFamily="34" charset="0"/>
                <a:cs typeface="Arial" panose="020B0604020202020204" pitchFamily="34" charset="0"/>
              </a:rPr>
              <a:t>Figure S5</a:t>
            </a:r>
          </a:p>
        </p:txBody>
      </p:sp>
      <p:sp>
        <p:nvSpPr>
          <p:cNvPr id="29" name="TextBox 28">
            <a:extLst>
              <a:ext uri="{FF2B5EF4-FFF2-40B4-BE49-F238E27FC236}">
                <a16:creationId xmlns:a16="http://schemas.microsoft.com/office/drawing/2014/main" id="{33A44924-5890-4C03-AFB0-9D30F07A2F9F}"/>
              </a:ext>
            </a:extLst>
          </p:cNvPr>
          <p:cNvSpPr txBox="1"/>
          <p:nvPr/>
        </p:nvSpPr>
        <p:spPr>
          <a:xfrm>
            <a:off x="184245" y="8229744"/>
            <a:ext cx="6404632"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5. </a:t>
            </a:r>
            <a:r>
              <a:rPr lang="en-US" sz="1200" dirty="0">
                <a:latin typeface="Arial" panose="020B0604020202020204" pitchFamily="34" charset="0"/>
                <a:cs typeface="Arial" panose="020B0604020202020204" pitchFamily="34" charset="0"/>
              </a:rPr>
              <a:t>Enrichment of top 100 GO terms for DEGs in biological process (BP), molecular function (MF) and cellular component (CC). The cutoff of the enrichment is p value &lt; 0.001 (see methods for details). The color highlights in the GO term description denote different regulatory patterns of the DEGs.</a:t>
            </a:r>
          </a:p>
        </p:txBody>
      </p:sp>
    </p:spTree>
    <p:extLst>
      <p:ext uri="{BB962C8B-B14F-4D97-AF65-F5344CB8AC3E}">
        <p14:creationId xmlns:p14="http://schemas.microsoft.com/office/powerpoint/2010/main" val="1693613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738</TotalTime>
  <Words>1214</Words>
  <Application>Microsoft Office PowerPoint</Application>
  <PresentationFormat>Letter Paper (8.5x11 in)</PresentationFormat>
  <Paragraphs>260</Paragraphs>
  <Slides>6</Slides>
  <Notes>1</Notes>
  <HiddenSlides>0</HiddenSlides>
  <MMClips>0</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5" baseType="lpstr">
      <vt:lpstr>MS PGothic</vt:lpstr>
      <vt:lpstr>SimSun</vt:lpstr>
      <vt:lpstr>Arial</vt:lpstr>
      <vt:lpstr>Calibri</vt:lpstr>
      <vt:lpstr>Calibri Light</vt:lpstr>
      <vt:lpstr>Symbol</vt:lpstr>
      <vt:lpstr>Times New Roman</vt:lpstr>
      <vt:lpstr>Office Theme</vt:lpstr>
      <vt:lpstr>Imag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iqiang Du</dc:creator>
  <cp:lastModifiedBy>Zhiqiang Du</cp:lastModifiedBy>
  <cp:revision>149</cp:revision>
  <dcterms:created xsi:type="dcterms:W3CDTF">2019-06-05T18:19:21Z</dcterms:created>
  <dcterms:modified xsi:type="dcterms:W3CDTF">2020-10-15T17:09:08Z</dcterms:modified>
</cp:coreProperties>
</file>